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28">
          <p15:clr>
            <a:srgbClr val="A4A3A4"/>
          </p15:clr>
        </p15:guide>
        <p15:guide id="2" orient="horz" pos="3696">
          <p15:clr>
            <a:srgbClr val="A4A3A4"/>
          </p15:clr>
        </p15:guide>
        <p15:guide id="3" pos="542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F2D1CDE-5BC7-428F-AB81-9BE2A88B4CDA}" v="1" dt="2024-05-08T17:07:48.45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3" d="100"/>
          <a:sy n="103" d="100"/>
        </p:scale>
        <p:origin x="114" y="150"/>
      </p:cViewPr>
      <p:guideLst>
        <p:guide orient="horz" pos="528"/>
        <p:guide orient="horz" pos="3696"/>
        <p:guide pos="54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hsan, Nagib" userId="f82f2968-c393-4d3d-98a9-d593c132ac8f" providerId="ADAL" clId="{4F2D1CDE-5BC7-428F-AB81-9BE2A88B4CDA}"/>
    <pc:docChg chg="custSel modSld">
      <pc:chgData name="Ahsan, Nagib" userId="f82f2968-c393-4d3d-98a9-d593c132ac8f" providerId="ADAL" clId="{4F2D1CDE-5BC7-428F-AB81-9BE2A88B4CDA}" dt="2024-05-08T17:12:11.612" v="3" actId="113"/>
      <pc:docMkLst>
        <pc:docMk/>
      </pc:docMkLst>
      <pc:sldChg chg="addSp delSp modSp mod">
        <pc:chgData name="Ahsan, Nagib" userId="f82f2968-c393-4d3d-98a9-d593c132ac8f" providerId="ADAL" clId="{4F2D1CDE-5BC7-428F-AB81-9BE2A88B4CDA}" dt="2024-05-08T17:12:11.612" v="3" actId="113"/>
        <pc:sldMkLst>
          <pc:docMk/>
          <pc:sldMk cId="632489354" sldId="259"/>
        </pc:sldMkLst>
        <pc:spChg chg="mod">
          <ac:chgData name="Ahsan, Nagib" userId="f82f2968-c393-4d3d-98a9-d593c132ac8f" providerId="ADAL" clId="{4F2D1CDE-5BC7-428F-AB81-9BE2A88B4CDA}" dt="2024-05-08T17:12:11.612" v="3" actId="113"/>
          <ac:spMkLst>
            <pc:docMk/>
            <pc:sldMk cId="632489354" sldId="259"/>
            <ac:spMk id="26" creationId="{A8CCA134-C174-461A-BBCE-9B99DF7D610E}"/>
          </ac:spMkLst>
        </pc:spChg>
        <pc:spChg chg="mod">
          <ac:chgData name="Ahsan, Nagib" userId="f82f2968-c393-4d3d-98a9-d593c132ac8f" providerId="ADAL" clId="{4F2D1CDE-5BC7-428F-AB81-9BE2A88B4CDA}" dt="2024-05-08T17:07:48.458" v="1"/>
          <ac:spMkLst>
            <pc:docMk/>
            <pc:sldMk cId="632489354" sldId="259"/>
            <ac:spMk id="29" creationId="{06753338-E75E-F7E1-1787-B51680162EB4}"/>
          </ac:spMkLst>
        </pc:spChg>
        <pc:spChg chg="mod">
          <ac:chgData name="Ahsan, Nagib" userId="f82f2968-c393-4d3d-98a9-d593c132ac8f" providerId="ADAL" clId="{4F2D1CDE-5BC7-428F-AB81-9BE2A88B4CDA}" dt="2024-05-08T17:07:48.458" v="1"/>
          <ac:spMkLst>
            <pc:docMk/>
            <pc:sldMk cId="632489354" sldId="259"/>
            <ac:spMk id="31" creationId="{1B526F88-A1F6-A23E-542A-1B03462E69BF}"/>
          </ac:spMkLst>
        </pc:spChg>
        <pc:spChg chg="mod">
          <ac:chgData name="Ahsan, Nagib" userId="f82f2968-c393-4d3d-98a9-d593c132ac8f" providerId="ADAL" clId="{4F2D1CDE-5BC7-428F-AB81-9BE2A88B4CDA}" dt="2024-05-08T17:07:48.458" v="1"/>
          <ac:spMkLst>
            <pc:docMk/>
            <pc:sldMk cId="632489354" sldId="259"/>
            <ac:spMk id="32" creationId="{84B181C8-03E2-D183-54CA-0F3707B3534D}"/>
          </ac:spMkLst>
        </pc:spChg>
        <pc:spChg chg="mod">
          <ac:chgData name="Ahsan, Nagib" userId="f82f2968-c393-4d3d-98a9-d593c132ac8f" providerId="ADAL" clId="{4F2D1CDE-5BC7-428F-AB81-9BE2A88B4CDA}" dt="2024-05-08T17:07:48.458" v="1"/>
          <ac:spMkLst>
            <pc:docMk/>
            <pc:sldMk cId="632489354" sldId="259"/>
            <ac:spMk id="35" creationId="{4759BDAA-4B7B-092C-4910-8B6171A36117}"/>
          </ac:spMkLst>
        </pc:spChg>
        <pc:spChg chg="mod">
          <ac:chgData name="Ahsan, Nagib" userId="f82f2968-c393-4d3d-98a9-d593c132ac8f" providerId="ADAL" clId="{4F2D1CDE-5BC7-428F-AB81-9BE2A88B4CDA}" dt="2024-05-08T17:07:48.458" v="1"/>
          <ac:spMkLst>
            <pc:docMk/>
            <pc:sldMk cId="632489354" sldId="259"/>
            <ac:spMk id="37" creationId="{CAD16A45-935C-EB94-2F6D-5D3C00F8D64C}"/>
          </ac:spMkLst>
        </pc:spChg>
        <pc:spChg chg="mod">
          <ac:chgData name="Ahsan, Nagib" userId="f82f2968-c393-4d3d-98a9-d593c132ac8f" providerId="ADAL" clId="{4F2D1CDE-5BC7-428F-AB81-9BE2A88B4CDA}" dt="2024-05-08T17:07:48.458" v="1"/>
          <ac:spMkLst>
            <pc:docMk/>
            <pc:sldMk cId="632489354" sldId="259"/>
            <ac:spMk id="39" creationId="{F833744B-4390-6C69-BFC4-E361ECA4CAFB}"/>
          </ac:spMkLst>
        </pc:spChg>
        <pc:spChg chg="mod">
          <ac:chgData name="Ahsan, Nagib" userId="f82f2968-c393-4d3d-98a9-d593c132ac8f" providerId="ADAL" clId="{4F2D1CDE-5BC7-428F-AB81-9BE2A88B4CDA}" dt="2024-05-08T17:07:48.458" v="1"/>
          <ac:spMkLst>
            <pc:docMk/>
            <pc:sldMk cId="632489354" sldId="259"/>
            <ac:spMk id="41" creationId="{D819C7B6-12F9-F028-C95B-1B3BC8745528}"/>
          </ac:spMkLst>
        </pc:spChg>
        <pc:spChg chg="add mod">
          <ac:chgData name="Ahsan, Nagib" userId="f82f2968-c393-4d3d-98a9-d593c132ac8f" providerId="ADAL" clId="{4F2D1CDE-5BC7-428F-AB81-9BE2A88B4CDA}" dt="2024-05-08T17:07:48.458" v="1"/>
          <ac:spMkLst>
            <pc:docMk/>
            <pc:sldMk cId="632489354" sldId="259"/>
            <ac:spMk id="43" creationId="{A1FA5050-ADEA-440F-C889-D47B013E8EBC}"/>
          </ac:spMkLst>
        </pc:spChg>
        <pc:spChg chg="add mod">
          <ac:chgData name="Ahsan, Nagib" userId="f82f2968-c393-4d3d-98a9-d593c132ac8f" providerId="ADAL" clId="{4F2D1CDE-5BC7-428F-AB81-9BE2A88B4CDA}" dt="2024-05-08T17:07:48.458" v="1"/>
          <ac:spMkLst>
            <pc:docMk/>
            <pc:sldMk cId="632489354" sldId="259"/>
            <ac:spMk id="44" creationId="{0E5D2D74-DD1E-5D7F-6505-978213BD5B61}"/>
          </ac:spMkLst>
        </pc:spChg>
        <pc:grpChg chg="del">
          <ac:chgData name="Ahsan, Nagib" userId="f82f2968-c393-4d3d-98a9-d593c132ac8f" providerId="ADAL" clId="{4F2D1CDE-5BC7-428F-AB81-9BE2A88B4CDA}" dt="2024-05-08T17:07:46.442" v="0" actId="478"/>
          <ac:grpSpMkLst>
            <pc:docMk/>
            <pc:sldMk cId="632489354" sldId="259"/>
            <ac:grpSpMk id="2" creationId="{B4907D4E-3BF1-42C5-9F8D-1C2079A624CD}"/>
          </ac:grpSpMkLst>
        </pc:grpChg>
        <pc:grpChg chg="add mod">
          <ac:chgData name="Ahsan, Nagib" userId="f82f2968-c393-4d3d-98a9-d593c132ac8f" providerId="ADAL" clId="{4F2D1CDE-5BC7-428F-AB81-9BE2A88B4CDA}" dt="2024-05-08T17:07:48.458" v="1"/>
          <ac:grpSpMkLst>
            <pc:docMk/>
            <pc:sldMk cId="632489354" sldId="259"/>
            <ac:grpSpMk id="27" creationId="{506BC05B-A3BB-4E84-4553-4EE3A45E78BA}"/>
          </ac:grpSpMkLst>
        </pc:grpChg>
        <pc:grpChg chg="add mod">
          <ac:chgData name="Ahsan, Nagib" userId="f82f2968-c393-4d3d-98a9-d593c132ac8f" providerId="ADAL" clId="{4F2D1CDE-5BC7-428F-AB81-9BE2A88B4CDA}" dt="2024-05-08T17:07:48.458" v="1"/>
          <ac:grpSpMkLst>
            <pc:docMk/>
            <pc:sldMk cId="632489354" sldId="259"/>
            <ac:grpSpMk id="33" creationId="{56E730D4-007A-9B9C-9A82-E85A90E9D485}"/>
          </ac:grpSpMkLst>
        </pc:grpChg>
        <pc:picChg chg="mod">
          <ac:chgData name="Ahsan, Nagib" userId="f82f2968-c393-4d3d-98a9-d593c132ac8f" providerId="ADAL" clId="{4F2D1CDE-5BC7-428F-AB81-9BE2A88B4CDA}" dt="2024-05-08T17:07:48.458" v="1"/>
          <ac:picMkLst>
            <pc:docMk/>
            <pc:sldMk cId="632489354" sldId="259"/>
            <ac:picMk id="28" creationId="{28589C5B-4E34-1B54-AF5B-F1CC83673E71}"/>
          </ac:picMkLst>
        </pc:picChg>
        <pc:picChg chg="mod">
          <ac:chgData name="Ahsan, Nagib" userId="f82f2968-c393-4d3d-98a9-d593c132ac8f" providerId="ADAL" clId="{4F2D1CDE-5BC7-428F-AB81-9BE2A88B4CDA}" dt="2024-05-08T17:07:48.458" v="1"/>
          <ac:picMkLst>
            <pc:docMk/>
            <pc:sldMk cId="632489354" sldId="259"/>
            <ac:picMk id="34" creationId="{12DA888A-1C6B-C064-017C-B7363A93A3AC}"/>
          </ac:picMkLst>
        </pc:picChg>
        <pc:cxnChg chg="mod">
          <ac:chgData name="Ahsan, Nagib" userId="f82f2968-c393-4d3d-98a9-d593c132ac8f" providerId="ADAL" clId="{4F2D1CDE-5BC7-428F-AB81-9BE2A88B4CDA}" dt="2024-05-08T17:07:48.458" v="1"/>
          <ac:cxnSpMkLst>
            <pc:docMk/>
            <pc:sldMk cId="632489354" sldId="259"/>
            <ac:cxnSpMk id="30" creationId="{4CF2DC9E-6E69-0099-6BE4-630EF266C781}"/>
          </ac:cxnSpMkLst>
        </pc:cxnChg>
        <pc:cxnChg chg="mod">
          <ac:chgData name="Ahsan, Nagib" userId="f82f2968-c393-4d3d-98a9-d593c132ac8f" providerId="ADAL" clId="{4F2D1CDE-5BC7-428F-AB81-9BE2A88B4CDA}" dt="2024-05-08T17:07:48.458" v="1"/>
          <ac:cxnSpMkLst>
            <pc:docMk/>
            <pc:sldMk cId="632489354" sldId="259"/>
            <ac:cxnSpMk id="36" creationId="{3E828C32-DEC5-6C4B-A8F6-5BE90D733A0E}"/>
          </ac:cxnSpMkLst>
        </pc:cxnChg>
        <pc:cxnChg chg="mod">
          <ac:chgData name="Ahsan, Nagib" userId="f82f2968-c393-4d3d-98a9-d593c132ac8f" providerId="ADAL" clId="{4F2D1CDE-5BC7-428F-AB81-9BE2A88B4CDA}" dt="2024-05-08T17:07:48.458" v="1"/>
          <ac:cxnSpMkLst>
            <pc:docMk/>
            <pc:sldMk cId="632489354" sldId="259"/>
            <ac:cxnSpMk id="38" creationId="{2FA94706-4976-37E5-662A-F4E6D0B31D98}"/>
          </ac:cxnSpMkLst>
        </pc:cxnChg>
        <pc:cxnChg chg="mod">
          <ac:chgData name="Ahsan, Nagib" userId="f82f2968-c393-4d3d-98a9-d593c132ac8f" providerId="ADAL" clId="{4F2D1CDE-5BC7-428F-AB81-9BE2A88B4CDA}" dt="2024-05-08T17:07:48.458" v="1"/>
          <ac:cxnSpMkLst>
            <pc:docMk/>
            <pc:sldMk cId="632489354" sldId="259"/>
            <ac:cxnSpMk id="40" creationId="{9813E249-830D-D71D-5198-91A6C92F8EF1}"/>
          </ac:cxnSpMkLst>
        </pc:cxnChg>
        <pc:cxnChg chg="mod">
          <ac:chgData name="Ahsan, Nagib" userId="f82f2968-c393-4d3d-98a9-d593c132ac8f" providerId="ADAL" clId="{4F2D1CDE-5BC7-428F-AB81-9BE2A88B4CDA}" dt="2024-05-08T17:07:48.458" v="1"/>
          <ac:cxnSpMkLst>
            <pc:docMk/>
            <pc:sldMk cId="632489354" sldId="259"/>
            <ac:cxnSpMk id="42" creationId="{EE88E8F6-CD4F-EDB3-99F9-56CFE4B9F9E7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83ACF-4911-4D65-8F79-E754423A0647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F4000-C134-4943-84CF-A6DDDEEA7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791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83ACF-4911-4D65-8F79-E754423A0647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F4000-C134-4943-84CF-A6DDDEEA7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783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83ACF-4911-4D65-8F79-E754423A0647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F4000-C134-4943-84CF-A6DDDEEA7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482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83ACF-4911-4D65-8F79-E754423A0647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F4000-C134-4943-84CF-A6DDDEEA7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409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83ACF-4911-4D65-8F79-E754423A0647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F4000-C134-4943-84CF-A6DDDEEA7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722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83ACF-4911-4D65-8F79-E754423A0647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F4000-C134-4943-84CF-A6DDDEEA7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4925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83ACF-4911-4D65-8F79-E754423A0647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F4000-C134-4943-84CF-A6DDDEEA7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529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83ACF-4911-4D65-8F79-E754423A0647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F4000-C134-4943-84CF-A6DDDEEA7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291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83ACF-4911-4D65-8F79-E754423A0647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F4000-C134-4943-84CF-A6DDDEEA7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619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83ACF-4911-4D65-8F79-E754423A0647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F4000-C134-4943-84CF-A6DDDEEA7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728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83ACF-4911-4D65-8F79-E754423A0647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F4000-C134-4943-84CF-A6DDDEEA7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9078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683ACF-4911-4D65-8F79-E754423A0647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BF4000-C134-4943-84CF-A6DDDEEA74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871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jpe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emf"/><Relationship Id="rId5" Type="http://schemas.openxmlformats.org/officeDocument/2006/relationships/image" Target="../media/image8.emf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381000" y="304800"/>
            <a:ext cx="8198601" cy="5565577"/>
            <a:chOff x="381000" y="682823"/>
            <a:chExt cx="8198601" cy="5565577"/>
          </a:xfrm>
        </p:grpSpPr>
        <p:pic>
          <p:nvPicPr>
            <p:cNvPr id="12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3400" y="3276791"/>
              <a:ext cx="8005916" cy="29716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" name="Picture 4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4943" y="1008046"/>
              <a:ext cx="3064695" cy="18459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6" name="TextBox 1"/>
            <p:cNvSpPr txBox="1">
              <a:spLocks noChangeArrowheads="1"/>
            </p:cNvSpPr>
            <p:nvPr/>
          </p:nvSpPr>
          <p:spPr bwMode="auto">
            <a:xfrm>
              <a:off x="457200" y="685800"/>
              <a:ext cx="38308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400" b="1" dirty="0">
                  <a:latin typeface="Arial" charset="0"/>
                </a:rPr>
                <a:t>A</a:t>
              </a:r>
            </a:p>
          </p:txBody>
        </p:sp>
        <p:sp>
          <p:nvSpPr>
            <p:cNvPr id="17" name="TextBox 175"/>
            <p:cNvSpPr txBox="1">
              <a:spLocks noChangeArrowheads="1"/>
            </p:cNvSpPr>
            <p:nvPr/>
          </p:nvSpPr>
          <p:spPr bwMode="auto">
            <a:xfrm>
              <a:off x="381000" y="3182769"/>
              <a:ext cx="38308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itchFamily="18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400" b="1" dirty="0">
                  <a:latin typeface="Arial" charset="0"/>
                </a:rPr>
                <a:t>D</a:t>
              </a:r>
            </a:p>
          </p:txBody>
        </p:sp>
        <p:grpSp>
          <p:nvGrpSpPr>
            <p:cNvPr id="3" name="Group 2"/>
            <p:cNvGrpSpPr/>
            <p:nvPr/>
          </p:nvGrpSpPr>
          <p:grpSpPr>
            <a:xfrm>
              <a:off x="5791200" y="682823"/>
              <a:ext cx="2788401" cy="2094634"/>
              <a:chOff x="3988906" y="635670"/>
              <a:chExt cx="2788401" cy="2094634"/>
            </a:xfrm>
          </p:grpSpPr>
          <p:pic>
            <p:nvPicPr>
              <p:cNvPr id="14" name="Picture 227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095789" y="871026"/>
                <a:ext cx="2681518" cy="18592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8" name="TextBox 176"/>
              <p:cNvSpPr txBox="1">
                <a:spLocks noChangeArrowheads="1"/>
              </p:cNvSpPr>
              <p:nvPr/>
            </p:nvSpPr>
            <p:spPr bwMode="auto">
              <a:xfrm>
                <a:off x="3988906" y="635670"/>
                <a:ext cx="383087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US" altLang="en-US" sz="1400" b="1" dirty="0">
                    <a:latin typeface="Arial" charset="0"/>
                  </a:rPr>
                  <a:t>C</a:t>
                </a:r>
              </a:p>
            </p:txBody>
          </p:sp>
        </p:grpSp>
        <p:grpSp>
          <p:nvGrpSpPr>
            <p:cNvPr id="2" name="Group 1"/>
            <p:cNvGrpSpPr/>
            <p:nvPr/>
          </p:nvGrpSpPr>
          <p:grpSpPr>
            <a:xfrm>
              <a:off x="3859934" y="685800"/>
              <a:ext cx="1689653" cy="2112827"/>
              <a:chOff x="6920947" y="613971"/>
              <a:chExt cx="1689653" cy="2112827"/>
            </a:xfrm>
          </p:grpSpPr>
          <p:pic>
            <p:nvPicPr>
              <p:cNvPr id="15" name="Picture 228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989733" y="1173911"/>
                <a:ext cx="1620867" cy="15528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9" name="TextBox 177"/>
              <p:cNvSpPr txBox="1">
                <a:spLocks noChangeArrowheads="1"/>
              </p:cNvSpPr>
              <p:nvPr/>
            </p:nvSpPr>
            <p:spPr bwMode="auto">
              <a:xfrm>
                <a:off x="6920947" y="613971"/>
                <a:ext cx="383087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itchFamily="18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US" altLang="en-US" sz="1400" b="1" dirty="0">
                    <a:latin typeface="Arial" charset="0"/>
                  </a:rPr>
                  <a:t>B</a:t>
                </a:r>
              </a:p>
            </p:txBody>
          </p:sp>
        </p:grpSp>
      </p:grpSp>
      <p:sp>
        <p:nvSpPr>
          <p:cNvPr id="6" name="TextBox 5"/>
          <p:cNvSpPr txBox="1"/>
          <p:nvPr/>
        </p:nvSpPr>
        <p:spPr>
          <a:xfrm>
            <a:off x="7081982" y="76200"/>
            <a:ext cx="2057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Supplemental Figure S1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232017C5-5096-4A37-96B7-0C427E41E073}"/>
              </a:ext>
            </a:extLst>
          </p:cNvPr>
          <p:cNvSpPr/>
          <p:nvPr/>
        </p:nvSpPr>
        <p:spPr>
          <a:xfrm>
            <a:off x="116758" y="5867400"/>
            <a:ext cx="8839200" cy="8585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S1.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ysiochemical Properties of the 2.1K (2095) synthetic peptides used in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KiC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ssay for identification of potential CSS kinases clients. </a:t>
            </a:r>
            <a:r>
              <a:rPr lang="en-US" sz="1100" i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Group distribution of synthetic peptides based on hydrophobicity. B and C, Subcellular localization of the 2.1K peptide library corresponding proteins. C, Percentage of </a:t>
            </a:r>
            <a:r>
              <a:rPr lang="en-US" sz="1100" i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vivo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osphosites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the 2.1K peptides.  D, Distribution of five different hydrophobic groups of peptides in each peptide pool used in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KiC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ssay.  </a:t>
            </a:r>
            <a:endParaRPr lang="en-US" sz="11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10012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C68CFEF-2751-4724-9CE6-6DAB47AD22F2}"/>
              </a:ext>
            </a:extLst>
          </p:cNvPr>
          <p:cNvSpPr txBox="1"/>
          <p:nvPr/>
        </p:nvSpPr>
        <p:spPr>
          <a:xfrm>
            <a:off x="7081982" y="76200"/>
            <a:ext cx="2057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Supplemental Figure S2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B3B629E3-B5F4-4CD8-8F10-E16903687A17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12738" y="457200"/>
            <a:ext cx="8602662" cy="5022850"/>
            <a:chOff x="197" y="1781"/>
            <a:chExt cx="5419" cy="3164"/>
          </a:xfrm>
        </p:grpSpPr>
        <p:sp>
          <p:nvSpPr>
            <p:cNvPr id="4" name="AutoShape 3">
              <a:extLst>
                <a:ext uri="{FF2B5EF4-FFF2-40B4-BE49-F238E27FC236}">
                  <a16:creationId xmlns:a16="http://schemas.microsoft.com/office/drawing/2014/main" id="{76FA6B9D-D924-4D95-AD8A-D7A271A52E8F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97" y="1781"/>
              <a:ext cx="5419" cy="31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" name="Rectangle 5">
              <a:extLst>
                <a:ext uri="{FF2B5EF4-FFF2-40B4-BE49-F238E27FC236}">
                  <a16:creationId xmlns:a16="http://schemas.microsoft.com/office/drawing/2014/main" id="{ACBC5DDF-C2E7-41A4-A878-6C2CF28260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9" y="2652"/>
              <a:ext cx="40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KiC Assay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" name="Freeform 6">
              <a:extLst>
                <a:ext uri="{FF2B5EF4-FFF2-40B4-BE49-F238E27FC236}">
                  <a16:creationId xmlns:a16="http://schemas.microsoft.com/office/drawing/2014/main" id="{55CD96F7-EA2A-44EC-8A7F-C60269160512}"/>
                </a:ext>
              </a:extLst>
            </p:cNvPr>
            <p:cNvSpPr>
              <a:spLocks/>
            </p:cNvSpPr>
            <p:nvPr/>
          </p:nvSpPr>
          <p:spPr bwMode="auto">
            <a:xfrm>
              <a:off x="3302" y="4296"/>
              <a:ext cx="268" cy="80"/>
            </a:xfrm>
            <a:custGeom>
              <a:avLst/>
              <a:gdLst>
                <a:gd name="T0" fmla="*/ 0 w 268"/>
                <a:gd name="T1" fmla="*/ 59 h 80"/>
                <a:gd name="T2" fmla="*/ 262 w 268"/>
                <a:gd name="T3" fmla="*/ 0 h 80"/>
                <a:gd name="T4" fmla="*/ 268 w 268"/>
                <a:gd name="T5" fmla="*/ 20 h 80"/>
                <a:gd name="T6" fmla="*/ 6 w 268"/>
                <a:gd name="T7" fmla="*/ 80 h 80"/>
                <a:gd name="T8" fmla="*/ 0 w 268"/>
                <a:gd name="T9" fmla="*/ 59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8" h="80">
                  <a:moveTo>
                    <a:pt x="0" y="59"/>
                  </a:moveTo>
                  <a:lnTo>
                    <a:pt x="262" y="0"/>
                  </a:lnTo>
                  <a:lnTo>
                    <a:pt x="268" y="20"/>
                  </a:lnTo>
                  <a:lnTo>
                    <a:pt x="6" y="80"/>
                  </a:lnTo>
                  <a:lnTo>
                    <a:pt x="0" y="59"/>
                  </a:lnTo>
                  <a:close/>
                </a:path>
              </a:pathLst>
            </a:custGeom>
            <a:solidFill>
              <a:srgbClr val="C0000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" name="Freeform 7">
              <a:extLst>
                <a:ext uri="{FF2B5EF4-FFF2-40B4-BE49-F238E27FC236}">
                  <a16:creationId xmlns:a16="http://schemas.microsoft.com/office/drawing/2014/main" id="{C17D4111-972C-4674-99D9-B325DE2775B0}"/>
                </a:ext>
              </a:extLst>
            </p:cNvPr>
            <p:cNvSpPr>
              <a:spLocks/>
            </p:cNvSpPr>
            <p:nvPr/>
          </p:nvSpPr>
          <p:spPr bwMode="auto">
            <a:xfrm>
              <a:off x="3302" y="4296"/>
              <a:ext cx="268" cy="80"/>
            </a:xfrm>
            <a:custGeom>
              <a:avLst/>
              <a:gdLst>
                <a:gd name="T0" fmla="*/ 0 w 268"/>
                <a:gd name="T1" fmla="*/ 59 h 80"/>
                <a:gd name="T2" fmla="*/ 262 w 268"/>
                <a:gd name="T3" fmla="*/ 0 h 80"/>
                <a:gd name="T4" fmla="*/ 268 w 268"/>
                <a:gd name="T5" fmla="*/ 20 h 80"/>
                <a:gd name="T6" fmla="*/ 6 w 268"/>
                <a:gd name="T7" fmla="*/ 80 h 80"/>
                <a:gd name="T8" fmla="*/ 0 w 268"/>
                <a:gd name="T9" fmla="*/ 59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8" h="80">
                  <a:moveTo>
                    <a:pt x="0" y="59"/>
                  </a:moveTo>
                  <a:lnTo>
                    <a:pt x="262" y="0"/>
                  </a:lnTo>
                  <a:lnTo>
                    <a:pt x="268" y="20"/>
                  </a:lnTo>
                  <a:lnTo>
                    <a:pt x="6" y="80"/>
                  </a:lnTo>
                  <a:lnTo>
                    <a:pt x="0" y="59"/>
                  </a:lnTo>
                  <a:close/>
                </a:path>
              </a:pathLst>
            </a:custGeom>
            <a:noFill/>
            <a:ln w="1588" cap="flat">
              <a:solidFill>
                <a:srgbClr val="C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Freeform 8">
              <a:extLst>
                <a:ext uri="{FF2B5EF4-FFF2-40B4-BE49-F238E27FC236}">
                  <a16:creationId xmlns:a16="http://schemas.microsoft.com/office/drawing/2014/main" id="{8E6A5960-04C4-46C8-B30C-F8E1CB17F6BD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4177"/>
              <a:ext cx="337" cy="97"/>
            </a:xfrm>
            <a:custGeom>
              <a:avLst/>
              <a:gdLst>
                <a:gd name="T0" fmla="*/ 1907 w 2164"/>
                <a:gd name="T1" fmla="*/ 151 h 620"/>
                <a:gd name="T2" fmla="*/ 1462 w 2164"/>
                <a:gd name="T3" fmla="*/ 140 h 620"/>
                <a:gd name="T4" fmla="*/ 1277 w 2164"/>
                <a:gd name="T5" fmla="*/ 177 h 620"/>
                <a:gd name="T6" fmla="*/ 1210 w 2164"/>
                <a:gd name="T7" fmla="*/ 209 h 620"/>
                <a:gd name="T8" fmla="*/ 1140 w 2164"/>
                <a:gd name="T9" fmla="*/ 259 h 620"/>
                <a:gd name="T10" fmla="*/ 1006 w 2164"/>
                <a:gd name="T11" fmla="*/ 388 h 620"/>
                <a:gd name="T12" fmla="*/ 868 w 2164"/>
                <a:gd name="T13" fmla="*/ 524 h 620"/>
                <a:gd name="T14" fmla="*/ 777 w 2164"/>
                <a:gd name="T15" fmla="*/ 586 h 620"/>
                <a:gd name="T16" fmla="*/ 681 w 2164"/>
                <a:gd name="T17" fmla="*/ 616 h 620"/>
                <a:gd name="T18" fmla="*/ 587 w 2164"/>
                <a:gd name="T19" fmla="*/ 618 h 620"/>
                <a:gd name="T20" fmla="*/ 493 w 2164"/>
                <a:gd name="T21" fmla="*/ 599 h 620"/>
                <a:gd name="T22" fmla="*/ 325 w 2164"/>
                <a:gd name="T23" fmla="*/ 528 h 620"/>
                <a:gd name="T24" fmla="*/ 123 w 2164"/>
                <a:gd name="T25" fmla="*/ 407 h 620"/>
                <a:gd name="T26" fmla="*/ 53 w 2164"/>
                <a:gd name="T27" fmla="*/ 373 h 620"/>
                <a:gd name="T28" fmla="*/ 22 w 2164"/>
                <a:gd name="T29" fmla="*/ 276 h 620"/>
                <a:gd name="T30" fmla="*/ 145 w 2164"/>
                <a:gd name="T31" fmla="*/ 250 h 620"/>
                <a:gd name="T32" fmla="*/ 138 w 2164"/>
                <a:gd name="T33" fmla="*/ 394 h 620"/>
                <a:gd name="T34" fmla="*/ 65 w 2164"/>
                <a:gd name="T35" fmla="*/ 373 h 620"/>
                <a:gd name="T36" fmla="*/ 157 w 2164"/>
                <a:gd name="T37" fmla="*/ 343 h 620"/>
                <a:gd name="T38" fmla="*/ 166 w 2164"/>
                <a:gd name="T39" fmla="*/ 270 h 620"/>
                <a:gd name="T40" fmla="*/ 265 w 2164"/>
                <a:gd name="T41" fmla="*/ 328 h 620"/>
                <a:gd name="T42" fmla="*/ 472 w 2164"/>
                <a:gd name="T43" fmla="*/ 442 h 620"/>
                <a:gd name="T44" fmla="*/ 539 w 2164"/>
                <a:gd name="T45" fmla="*/ 468 h 620"/>
                <a:gd name="T46" fmla="*/ 599 w 2164"/>
                <a:gd name="T47" fmla="*/ 481 h 620"/>
                <a:gd name="T48" fmla="*/ 647 w 2164"/>
                <a:gd name="T49" fmla="*/ 485 h 620"/>
                <a:gd name="T50" fmla="*/ 700 w 2164"/>
                <a:gd name="T51" fmla="*/ 468 h 620"/>
                <a:gd name="T52" fmla="*/ 823 w 2164"/>
                <a:gd name="T53" fmla="*/ 369 h 620"/>
                <a:gd name="T54" fmla="*/ 1037 w 2164"/>
                <a:gd name="T55" fmla="*/ 158 h 620"/>
                <a:gd name="T56" fmla="*/ 1128 w 2164"/>
                <a:gd name="T57" fmla="*/ 93 h 620"/>
                <a:gd name="T58" fmla="*/ 1227 w 2164"/>
                <a:gd name="T59" fmla="*/ 48 h 620"/>
                <a:gd name="T60" fmla="*/ 1446 w 2164"/>
                <a:gd name="T61" fmla="*/ 5 h 620"/>
                <a:gd name="T62" fmla="*/ 1686 w 2164"/>
                <a:gd name="T63" fmla="*/ 0 h 620"/>
                <a:gd name="T64" fmla="*/ 2164 w 2164"/>
                <a:gd name="T65" fmla="*/ 41 h 6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2164" h="620">
                  <a:moveTo>
                    <a:pt x="2148" y="177"/>
                  </a:moveTo>
                  <a:lnTo>
                    <a:pt x="1907" y="151"/>
                  </a:lnTo>
                  <a:lnTo>
                    <a:pt x="1674" y="136"/>
                  </a:lnTo>
                  <a:lnTo>
                    <a:pt x="1462" y="140"/>
                  </a:lnTo>
                  <a:lnTo>
                    <a:pt x="1477" y="140"/>
                  </a:lnTo>
                  <a:lnTo>
                    <a:pt x="1277" y="177"/>
                  </a:lnTo>
                  <a:lnTo>
                    <a:pt x="1296" y="171"/>
                  </a:lnTo>
                  <a:lnTo>
                    <a:pt x="1210" y="209"/>
                  </a:lnTo>
                  <a:lnTo>
                    <a:pt x="1222" y="203"/>
                  </a:lnTo>
                  <a:lnTo>
                    <a:pt x="1140" y="259"/>
                  </a:lnTo>
                  <a:lnTo>
                    <a:pt x="1150" y="250"/>
                  </a:lnTo>
                  <a:lnTo>
                    <a:pt x="1006" y="388"/>
                  </a:lnTo>
                  <a:lnTo>
                    <a:pt x="941" y="457"/>
                  </a:lnTo>
                  <a:lnTo>
                    <a:pt x="868" y="524"/>
                  </a:lnTo>
                  <a:lnTo>
                    <a:pt x="794" y="577"/>
                  </a:lnTo>
                  <a:cubicBezTo>
                    <a:pt x="789" y="580"/>
                    <a:pt x="782" y="584"/>
                    <a:pt x="777" y="586"/>
                  </a:cubicBezTo>
                  <a:lnTo>
                    <a:pt x="707" y="612"/>
                  </a:lnTo>
                  <a:cubicBezTo>
                    <a:pt x="698" y="616"/>
                    <a:pt x="688" y="616"/>
                    <a:pt x="681" y="616"/>
                  </a:cubicBezTo>
                  <a:lnTo>
                    <a:pt x="606" y="618"/>
                  </a:lnTo>
                  <a:cubicBezTo>
                    <a:pt x="599" y="620"/>
                    <a:pt x="592" y="618"/>
                    <a:pt x="587" y="618"/>
                  </a:cubicBezTo>
                  <a:lnTo>
                    <a:pt x="508" y="603"/>
                  </a:lnTo>
                  <a:cubicBezTo>
                    <a:pt x="503" y="601"/>
                    <a:pt x="498" y="601"/>
                    <a:pt x="493" y="599"/>
                  </a:cubicBezTo>
                  <a:lnTo>
                    <a:pt x="412" y="569"/>
                  </a:lnTo>
                  <a:lnTo>
                    <a:pt x="325" y="528"/>
                  </a:lnTo>
                  <a:lnTo>
                    <a:pt x="181" y="442"/>
                  </a:lnTo>
                  <a:lnTo>
                    <a:pt x="123" y="407"/>
                  </a:lnTo>
                  <a:lnTo>
                    <a:pt x="87" y="388"/>
                  </a:lnTo>
                  <a:lnTo>
                    <a:pt x="53" y="373"/>
                  </a:lnTo>
                  <a:cubicBezTo>
                    <a:pt x="15" y="356"/>
                    <a:pt x="0" y="315"/>
                    <a:pt x="20" y="280"/>
                  </a:cubicBezTo>
                  <a:lnTo>
                    <a:pt x="22" y="276"/>
                  </a:lnTo>
                  <a:cubicBezTo>
                    <a:pt x="39" y="246"/>
                    <a:pt x="77" y="231"/>
                    <a:pt x="116" y="242"/>
                  </a:cubicBezTo>
                  <a:lnTo>
                    <a:pt x="145" y="250"/>
                  </a:lnTo>
                  <a:lnTo>
                    <a:pt x="188" y="263"/>
                  </a:lnTo>
                  <a:lnTo>
                    <a:pt x="138" y="394"/>
                  </a:lnTo>
                  <a:lnTo>
                    <a:pt x="94" y="382"/>
                  </a:lnTo>
                  <a:lnTo>
                    <a:pt x="65" y="373"/>
                  </a:lnTo>
                  <a:lnTo>
                    <a:pt x="159" y="338"/>
                  </a:lnTo>
                  <a:lnTo>
                    <a:pt x="157" y="343"/>
                  </a:lnTo>
                  <a:lnTo>
                    <a:pt x="123" y="250"/>
                  </a:lnTo>
                  <a:lnTo>
                    <a:pt x="166" y="270"/>
                  </a:lnTo>
                  <a:lnTo>
                    <a:pt x="212" y="293"/>
                  </a:lnTo>
                  <a:lnTo>
                    <a:pt x="265" y="328"/>
                  </a:lnTo>
                  <a:lnTo>
                    <a:pt x="400" y="405"/>
                  </a:lnTo>
                  <a:lnTo>
                    <a:pt x="472" y="442"/>
                  </a:lnTo>
                  <a:lnTo>
                    <a:pt x="553" y="472"/>
                  </a:lnTo>
                  <a:lnTo>
                    <a:pt x="539" y="468"/>
                  </a:lnTo>
                  <a:lnTo>
                    <a:pt x="618" y="483"/>
                  </a:lnTo>
                  <a:lnTo>
                    <a:pt x="599" y="481"/>
                  </a:lnTo>
                  <a:lnTo>
                    <a:pt x="674" y="478"/>
                  </a:lnTo>
                  <a:lnTo>
                    <a:pt x="647" y="485"/>
                  </a:lnTo>
                  <a:lnTo>
                    <a:pt x="717" y="459"/>
                  </a:lnTo>
                  <a:lnTo>
                    <a:pt x="700" y="468"/>
                  </a:lnTo>
                  <a:lnTo>
                    <a:pt x="758" y="427"/>
                  </a:lnTo>
                  <a:lnTo>
                    <a:pt x="823" y="369"/>
                  </a:lnTo>
                  <a:lnTo>
                    <a:pt x="893" y="295"/>
                  </a:lnTo>
                  <a:lnTo>
                    <a:pt x="1037" y="158"/>
                  </a:lnTo>
                  <a:cubicBezTo>
                    <a:pt x="1039" y="153"/>
                    <a:pt x="1044" y="151"/>
                    <a:pt x="1046" y="149"/>
                  </a:cubicBezTo>
                  <a:lnTo>
                    <a:pt x="1128" y="93"/>
                  </a:lnTo>
                  <a:cubicBezTo>
                    <a:pt x="1133" y="91"/>
                    <a:pt x="1135" y="89"/>
                    <a:pt x="1140" y="87"/>
                  </a:cubicBezTo>
                  <a:lnTo>
                    <a:pt x="1227" y="48"/>
                  </a:lnTo>
                  <a:cubicBezTo>
                    <a:pt x="1234" y="46"/>
                    <a:pt x="1239" y="44"/>
                    <a:pt x="1246" y="41"/>
                  </a:cubicBezTo>
                  <a:lnTo>
                    <a:pt x="1446" y="5"/>
                  </a:lnTo>
                  <a:cubicBezTo>
                    <a:pt x="1450" y="5"/>
                    <a:pt x="1455" y="5"/>
                    <a:pt x="1460" y="3"/>
                  </a:cubicBezTo>
                  <a:lnTo>
                    <a:pt x="1686" y="0"/>
                  </a:lnTo>
                  <a:lnTo>
                    <a:pt x="1924" y="16"/>
                  </a:lnTo>
                  <a:lnTo>
                    <a:pt x="2164" y="41"/>
                  </a:lnTo>
                  <a:lnTo>
                    <a:pt x="2148" y="177"/>
                  </a:lnTo>
                  <a:close/>
                </a:path>
              </a:pathLst>
            </a:custGeom>
            <a:solidFill>
              <a:srgbClr val="8EB4E3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Freeform 9">
              <a:extLst>
                <a:ext uri="{FF2B5EF4-FFF2-40B4-BE49-F238E27FC236}">
                  <a16:creationId xmlns:a16="http://schemas.microsoft.com/office/drawing/2014/main" id="{D7584B0D-01FF-4CFB-A7CC-D98457F587E1}"/>
                </a:ext>
              </a:extLst>
            </p:cNvPr>
            <p:cNvSpPr>
              <a:spLocks/>
            </p:cNvSpPr>
            <p:nvPr/>
          </p:nvSpPr>
          <p:spPr bwMode="auto">
            <a:xfrm>
              <a:off x="3161" y="4177"/>
              <a:ext cx="337" cy="97"/>
            </a:xfrm>
            <a:custGeom>
              <a:avLst/>
              <a:gdLst>
                <a:gd name="T0" fmla="*/ 1907 w 2164"/>
                <a:gd name="T1" fmla="*/ 151 h 620"/>
                <a:gd name="T2" fmla="*/ 1462 w 2164"/>
                <a:gd name="T3" fmla="*/ 140 h 620"/>
                <a:gd name="T4" fmla="*/ 1277 w 2164"/>
                <a:gd name="T5" fmla="*/ 177 h 620"/>
                <a:gd name="T6" fmla="*/ 1210 w 2164"/>
                <a:gd name="T7" fmla="*/ 209 h 620"/>
                <a:gd name="T8" fmla="*/ 1140 w 2164"/>
                <a:gd name="T9" fmla="*/ 259 h 620"/>
                <a:gd name="T10" fmla="*/ 1006 w 2164"/>
                <a:gd name="T11" fmla="*/ 388 h 620"/>
                <a:gd name="T12" fmla="*/ 868 w 2164"/>
                <a:gd name="T13" fmla="*/ 524 h 620"/>
                <a:gd name="T14" fmla="*/ 777 w 2164"/>
                <a:gd name="T15" fmla="*/ 586 h 620"/>
                <a:gd name="T16" fmla="*/ 681 w 2164"/>
                <a:gd name="T17" fmla="*/ 616 h 620"/>
                <a:gd name="T18" fmla="*/ 587 w 2164"/>
                <a:gd name="T19" fmla="*/ 618 h 620"/>
                <a:gd name="T20" fmla="*/ 493 w 2164"/>
                <a:gd name="T21" fmla="*/ 599 h 620"/>
                <a:gd name="T22" fmla="*/ 325 w 2164"/>
                <a:gd name="T23" fmla="*/ 528 h 620"/>
                <a:gd name="T24" fmla="*/ 123 w 2164"/>
                <a:gd name="T25" fmla="*/ 407 h 620"/>
                <a:gd name="T26" fmla="*/ 53 w 2164"/>
                <a:gd name="T27" fmla="*/ 373 h 620"/>
                <a:gd name="T28" fmla="*/ 22 w 2164"/>
                <a:gd name="T29" fmla="*/ 276 h 620"/>
                <a:gd name="T30" fmla="*/ 145 w 2164"/>
                <a:gd name="T31" fmla="*/ 250 h 620"/>
                <a:gd name="T32" fmla="*/ 138 w 2164"/>
                <a:gd name="T33" fmla="*/ 394 h 620"/>
                <a:gd name="T34" fmla="*/ 65 w 2164"/>
                <a:gd name="T35" fmla="*/ 373 h 620"/>
                <a:gd name="T36" fmla="*/ 157 w 2164"/>
                <a:gd name="T37" fmla="*/ 343 h 620"/>
                <a:gd name="T38" fmla="*/ 166 w 2164"/>
                <a:gd name="T39" fmla="*/ 270 h 620"/>
                <a:gd name="T40" fmla="*/ 265 w 2164"/>
                <a:gd name="T41" fmla="*/ 328 h 620"/>
                <a:gd name="T42" fmla="*/ 472 w 2164"/>
                <a:gd name="T43" fmla="*/ 442 h 620"/>
                <a:gd name="T44" fmla="*/ 539 w 2164"/>
                <a:gd name="T45" fmla="*/ 468 h 620"/>
                <a:gd name="T46" fmla="*/ 599 w 2164"/>
                <a:gd name="T47" fmla="*/ 481 h 620"/>
                <a:gd name="T48" fmla="*/ 647 w 2164"/>
                <a:gd name="T49" fmla="*/ 485 h 620"/>
                <a:gd name="T50" fmla="*/ 700 w 2164"/>
                <a:gd name="T51" fmla="*/ 468 h 620"/>
                <a:gd name="T52" fmla="*/ 823 w 2164"/>
                <a:gd name="T53" fmla="*/ 369 h 620"/>
                <a:gd name="T54" fmla="*/ 1037 w 2164"/>
                <a:gd name="T55" fmla="*/ 158 h 620"/>
                <a:gd name="T56" fmla="*/ 1128 w 2164"/>
                <a:gd name="T57" fmla="*/ 93 h 620"/>
                <a:gd name="T58" fmla="*/ 1227 w 2164"/>
                <a:gd name="T59" fmla="*/ 48 h 620"/>
                <a:gd name="T60" fmla="*/ 1446 w 2164"/>
                <a:gd name="T61" fmla="*/ 5 h 620"/>
                <a:gd name="T62" fmla="*/ 1686 w 2164"/>
                <a:gd name="T63" fmla="*/ 0 h 620"/>
                <a:gd name="T64" fmla="*/ 2164 w 2164"/>
                <a:gd name="T65" fmla="*/ 41 h 6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2164" h="620">
                  <a:moveTo>
                    <a:pt x="2148" y="177"/>
                  </a:moveTo>
                  <a:lnTo>
                    <a:pt x="1907" y="151"/>
                  </a:lnTo>
                  <a:lnTo>
                    <a:pt x="1674" y="136"/>
                  </a:lnTo>
                  <a:lnTo>
                    <a:pt x="1462" y="140"/>
                  </a:lnTo>
                  <a:lnTo>
                    <a:pt x="1477" y="140"/>
                  </a:lnTo>
                  <a:lnTo>
                    <a:pt x="1277" y="177"/>
                  </a:lnTo>
                  <a:lnTo>
                    <a:pt x="1296" y="171"/>
                  </a:lnTo>
                  <a:lnTo>
                    <a:pt x="1210" y="209"/>
                  </a:lnTo>
                  <a:lnTo>
                    <a:pt x="1222" y="203"/>
                  </a:lnTo>
                  <a:lnTo>
                    <a:pt x="1140" y="259"/>
                  </a:lnTo>
                  <a:lnTo>
                    <a:pt x="1150" y="250"/>
                  </a:lnTo>
                  <a:lnTo>
                    <a:pt x="1006" y="388"/>
                  </a:lnTo>
                  <a:lnTo>
                    <a:pt x="941" y="457"/>
                  </a:lnTo>
                  <a:lnTo>
                    <a:pt x="868" y="524"/>
                  </a:lnTo>
                  <a:lnTo>
                    <a:pt x="794" y="577"/>
                  </a:lnTo>
                  <a:cubicBezTo>
                    <a:pt x="789" y="580"/>
                    <a:pt x="782" y="584"/>
                    <a:pt x="777" y="586"/>
                  </a:cubicBezTo>
                  <a:lnTo>
                    <a:pt x="707" y="612"/>
                  </a:lnTo>
                  <a:cubicBezTo>
                    <a:pt x="698" y="616"/>
                    <a:pt x="688" y="616"/>
                    <a:pt x="681" y="616"/>
                  </a:cubicBezTo>
                  <a:lnTo>
                    <a:pt x="606" y="618"/>
                  </a:lnTo>
                  <a:cubicBezTo>
                    <a:pt x="599" y="620"/>
                    <a:pt x="592" y="618"/>
                    <a:pt x="587" y="618"/>
                  </a:cubicBezTo>
                  <a:lnTo>
                    <a:pt x="508" y="603"/>
                  </a:lnTo>
                  <a:cubicBezTo>
                    <a:pt x="503" y="601"/>
                    <a:pt x="498" y="601"/>
                    <a:pt x="493" y="599"/>
                  </a:cubicBezTo>
                  <a:lnTo>
                    <a:pt x="412" y="569"/>
                  </a:lnTo>
                  <a:lnTo>
                    <a:pt x="325" y="528"/>
                  </a:lnTo>
                  <a:lnTo>
                    <a:pt x="181" y="442"/>
                  </a:lnTo>
                  <a:lnTo>
                    <a:pt x="123" y="407"/>
                  </a:lnTo>
                  <a:lnTo>
                    <a:pt x="87" y="388"/>
                  </a:lnTo>
                  <a:lnTo>
                    <a:pt x="53" y="373"/>
                  </a:lnTo>
                  <a:cubicBezTo>
                    <a:pt x="15" y="356"/>
                    <a:pt x="0" y="315"/>
                    <a:pt x="20" y="280"/>
                  </a:cubicBezTo>
                  <a:lnTo>
                    <a:pt x="22" y="276"/>
                  </a:lnTo>
                  <a:cubicBezTo>
                    <a:pt x="39" y="246"/>
                    <a:pt x="77" y="231"/>
                    <a:pt x="116" y="242"/>
                  </a:cubicBezTo>
                  <a:lnTo>
                    <a:pt x="145" y="250"/>
                  </a:lnTo>
                  <a:lnTo>
                    <a:pt x="188" y="263"/>
                  </a:lnTo>
                  <a:lnTo>
                    <a:pt x="138" y="394"/>
                  </a:lnTo>
                  <a:lnTo>
                    <a:pt x="94" y="382"/>
                  </a:lnTo>
                  <a:lnTo>
                    <a:pt x="65" y="373"/>
                  </a:lnTo>
                  <a:lnTo>
                    <a:pt x="159" y="338"/>
                  </a:lnTo>
                  <a:lnTo>
                    <a:pt x="157" y="343"/>
                  </a:lnTo>
                  <a:lnTo>
                    <a:pt x="123" y="250"/>
                  </a:lnTo>
                  <a:lnTo>
                    <a:pt x="166" y="270"/>
                  </a:lnTo>
                  <a:lnTo>
                    <a:pt x="212" y="293"/>
                  </a:lnTo>
                  <a:lnTo>
                    <a:pt x="265" y="328"/>
                  </a:lnTo>
                  <a:lnTo>
                    <a:pt x="400" y="405"/>
                  </a:lnTo>
                  <a:lnTo>
                    <a:pt x="472" y="442"/>
                  </a:lnTo>
                  <a:lnTo>
                    <a:pt x="553" y="472"/>
                  </a:lnTo>
                  <a:lnTo>
                    <a:pt x="539" y="468"/>
                  </a:lnTo>
                  <a:lnTo>
                    <a:pt x="618" y="483"/>
                  </a:lnTo>
                  <a:lnTo>
                    <a:pt x="599" y="481"/>
                  </a:lnTo>
                  <a:lnTo>
                    <a:pt x="674" y="478"/>
                  </a:lnTo>
                  <a:lnTo>
                    <a:pt x="647" y="485"/>
                  </a:lnTo>
                  <a:lnTo>
                    <a:pt x="717" y="459"/>
                  </a:lnTo>
                  <a:lnTo>
                    <a:pt x="700" y="468"/>
                  </a:lnTo>
                  <a:lnTo>
                    <a:pt x="758" y="427"/>
                  </a:lnTo>
                  <a:lnTo>
                    <a:pt x="823" y="369"/>
                  </a:lnTo>
                  <a:lnTo>
                    <a:pt x="893" y="295"/>
                  </a:lnTo>
                  <a:lnTo>
                    <a:pt x="1037" y="158"/>
                  </a:lnTo>
                  <a:cubicBezTo>
                    <a:pt x="1039" y="153"/>
                    <a:pt x="1044" y="151"/>
                    <a:pt x="1046" y="149"/>
                  </a:cubicBezTo>
                  <a:lnTo>
                    <a:pt x="1128" y="93"/>
                  </a:lnTo>
                  <a:cubicBezTo>
                    <a:pt x="1133" y="91"/>
                    <a:pt x="1135" y="89"/>
                    <a:pt x="1140" y="87"/>
                  </a:cubicBezTo>
                  <a:lnTo>
                    <a:pt x="1227" y="48"/>
                  </a:lnTo>
                  <a:cubicBezTo>
                    <a:pt x="1234" y="46"/>
                    <a:pt x="1239" y="44"/>
                    <a:pt x="1246" y="41"/>
                  </a:cubicBezTo>
                  <a:lnTo>
                    <a:pt x="1446" y="5"/>
                  </a:lnTo>
                  <a:cubicBezTo>
                    <a:pt x="1450" y="5"/>
                    <a:pt x="1455" y="5"/>
                    <a:pt x="1460" y="3"/>
                  </a:cubicBezTo>
                  <a:lnTo>
                    <a:pt x="1686" y="0"/>
                  </a:lnTo>
                  <a:lnTo>
                    <a:pt x="1924" y="16"/>
                  </a:lnTo>
                  <a:lnTo>
                    <a:pt x="2164" y="41"/>
                  </a:lnTo>
                  <a:lnTo>
                    <a:pt x="2148" y="177"/>
                  </a:lnTo>
                  <a:close/>
                </a:path>
              </a:pathLst>
            </a:custGeom>
            <a:noFill/>
            <a:ln w="1588" cap="flat">
              <a:solidFill>
                <a:srgbClr val="8EB4E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Freeform 10">
              <a:extLst>
                <a:ext uri="{FF2B5EF4-FFF2-40B4-BE49-F238E27FC236}">
                  <a16:creationId xmlns:a16="http://schemas.microsoft.com/office/drawing/2014/main" id="{68C20AD8-97F0-46E2-A637-537246FA7AB3}"/>
                </a:ext>
              </a:extLst>
            </p:cNvPr>
            <p:cNvSpPr>
              <a:spLocks/>
            </p:cNvSpPr>
            <p:nvPr/>
          </p:nvSpPr>
          <p:spPr bwMode="auto">
            <a:xfrm>
              <a:off x="3236" y="4053"/>
              <a:ext cx="268" cy="51"/>
            </a:xfrm>
            <a:custGeom>
              <a:avLst/>
              <a:gdLst>
                <a:gd name="T0" fmla="*/ 4 w 268"/>
                <a:gd name="T1" fmla="*/ 0 h 51"/>
                <a:gd name="T2" fmla="*/ 268 w 268"/>
                <a:gd name="T3" fmla="*/ 29 h 51"/>
                <a:gd name="T4" fmla="*/ 264 w 268"/>
                <a:gd name="T5" fmla="*/ 51 h 51"/>
                <a:gd name="T6" fmla="*/ 0 w 268"/>
                <a:gd name="T7" fmla="*/ 21 h 51"/>
                <a:gd name="T8" fmla="*/ 4 w 268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8" h="51">
                  <a:moveTo>
                    <a:pt x="4" y="0"/>
                  </a:moveTo>
                  <a:lnTo>
                    <a:pt x="268" y="29"/>
                  </a:lnTo>
                  <a:lnTo>
                    <a:pt x="264" y="51"/>
                  </a:lnTo>
                  <a:lnTo>
                    <a:pt x="0" y="21"/>
                  </a:lnTo>
                  <a:lnTo>
                    <a:pt x="4" y="0"/>
                  </a:lnTo>
                  <a:close/>
                </a:path>
              </a:pathLst>
            </a:custGeom>
            <a:solidFill>
              <a:srgbClr val="948A54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Freeform 11">
              <a:extLst>
                <a:ext uri="{FF2B5EF4-FFF2-40B4-BE49-F238E27FC236}">
                  <a16:creationId xmlns:a16="http://schemas.microsoft.com/office/drawing/2014/main" id="{9FBC2BBE-9842-4CF2-8A41-0C34FC485226}"/>
                </a:ext>
              </a:extLst>
            </p:cNvPr>
            <p:cNvSpPr>
              <a:spLocks/>
            </p:cNvSpPr>
            <p:nvPr/>
          </p:nvSpPr>
          <p:spPr bwMode="auto">
            <a:xfrm>
              <a:off x="3236" y="4053"/>
              <a:ext cx="268" cy="51"/>
            </a:xfrm>
            <a:custGeom>
              <a:avLst/>
              <a:gdLst>
                <a:gd name="T0" fmla="*/ 4 w 268"/>
                <a:gd name="T1" fmla="*/ 0 h 51"/>
                <a:gd name="T2" fmla="*/ 268 w 268"/>
                <a:gd name="T3" fmla="*/ 29 h 51"/>
                <a:gd name="T4" fmla="*/ 264 w 268"/>
                <a:gd name="T5" fmla="*/ 51 h 51"/>
                <a:gd name="T6" fmla="*/ 0 w 268"/>
                <a:gd name="T7" fmla="*/ 21 h 51"/>
                <a:gd name="T8" fmla="*/ 4 w 268"/>
                <a:gd name="T9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8" h="51">
                  <a:moveTo>
                    <a:pt x="4" y="0"/>
                  </a:moveTo>
                  <a:lnTo>
                    <a:pt x="268" y="29"/>
                  </a:lnTo>
                  <a:lnTo>
                    <a:pt x="264" y="51"/>
                  </a:lnTo>
                  <a:lnTo>
                    <a:pt x="0" y="21"/>
                  </a:lnTo>
                  <a:lnTo>
                    <a:pt x="4" y="0"/>
                  </a:lnTo>
                  <a:close/>
                </a:path>
              </a:pathLst>
            </a:custGeom>
            <a:noFill/>
            <a:ln w="1588" cap="flat">
              <a:solidFill>
                <a:srgbClr val="948A5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Freeform 12">
              <a:extLst>
                <a:ext uri="{FF2B5EF4-FFF2-40B4-BE49-F238E27FC236}">
                  <a16:creationId xmlns:a16="http://schemas.microsoft.com/office/drawing/2014/main" id="{50632935-62BE-4F79-BE55-E91361CBA518}"/>
                </a:ext>
              </a:extLst>
            </p:cNvPr>
            <p:cNvSpPr>
              <a:spLocks/>
            </p:cNvSpPr>
            <p:nvPr/>
          </p:nvSpPr>
          <p:spPr bwMode="auto">
            <a:xfrm>
              <a:off x="3567" y="4098"/>
              <a:ext cx="212" cy="165"/>
            </a:xfrm>
            <a:custGeom>
              <a:avLst/>
              <a:gdLst>
                <a:gd name="T0" fmla="*/ 0 w 212"/>
                <a:gd name="T1" fmla="*/ 148 h 165"/>
                <a:gd name="T2" fmla="*/ 197 w 212"/>
                <a:gd name="T3" fmla="*/ 0 h 165"/>
                <a:gd name="T4" fmla="*/ 212 w 212"/>
                <a:gd name="T5" fmla="*/ 17 h 165"/>
                <a:gd name="T6" fmla="*/ 15 w 212"/>
                <a:gd name="T7" fmla="*/ 165 h 165"/>
                <a:gd name="T8" fmla="*/ 0 w 212"/>
                <a:gd name="T9" fmla="*/ 148 h 1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2" h="165">
                  <a:moveTo>
                    <a:pt x="0" y="148"/>
                  </a:moveTo>
                  <a:lnTo>
                    <a:pt x="197" y="0"/>
                  </a:lnTo>
                  <a:lnTo>
                    <a:pt x="212" y="17"/>
                  </a:lnTo>
                  <a:lnTo>
                    <a:pt x="15" y="165"/>
                  </a:lnTo>
                  <a:lnTo>
                    <a:pt x="0" y="148"/>
                  </a:lnTo>
                  <a:close/>
                </a:path>
              </a:pathLst>
            </a:custGeom>
            <a:solidFill>
              <a:srgbClr val="00206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Freeform 13">
              <a:extLst>
                <a:ext uri="{FF2B5EF4-FFF2-40B4-BE49-F238E27FC236}">
                  <a16:creationId xmlns:a16="http://schemas.microsoft.com/office/drawing/2014/main" id="{9460392D-60C5-4A05-A7E0-842A528A79CE}"/>
                </a:ext>
              </a:extLst>
            </p:cNvPr>
            <p:cNvSpPr>
              <a:spLocks/>
            </p:cNvSpPr>
            <p:nvPr/>
          </p:nvSpPr>
          <p:spPr bwMode="auto">
            <a:xfrm>
              <a:off x="3567" y="4098"/>
              <a:ext cx="212" cy="165"/>
            </a:xfrm>
            <a:custGeom>
              <a:avLst/>
              <a:gdLst>
                <a:gd name="T0" fmla="*/ 0 w 212"/>
                <a:gd name="T1" fmla="*/ 148 h 165"/>
                <a:gd name="T2" fmla="*/ 197 w 212"/>
                <a:gd name="T3" fmla="*/ 0 h 165"/>
                <a:gd name="T4" fmla="*/ 212 w 212"/>
                <a:gd name="T5" fmla="*/ 17 h 165"/>
                <a:gd name="T6" fmla="*/ 15 w 212"/>
                <a:gd name="T7" fmla="*/ 165 h 165"/>
                <a:gd name="T8" fmla="*/ 0 w 212"/>
                <a:gd name="T9" fmla="*/ 148 h 1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2" h="165">
                  <a:moveTo>
                    <a:pt x="0" y="148"/>
                  </a:moveTo>
                  <a:lnTo>
                    <a:pt x="197" y="0"/>
                  </a:lnTo>
                  <a:lnTo>
                    <a:pt x="212" y="17"/>
                  </a:lnTo>
                  <a:lnTo>
                    <a:pt x="15" y="165"/>
                  </a:lnTo>
                  <a:lnTo>
                    <a:pt x="0" y="148"/>
                  </a:lnTo>
                  <a:close/>
                </a:path>
              </a:pathLst>
            </a:custGeom>
            <a:noFill/>
            <a:ln w="1588" cap="flat">
              <a:solidFill>
                <a:srgbClr val="00206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Freeform 14">
              <a:extLst>
                <a:ext uri="{FF2B5EF4-FFF2-40B4-BE49-F238E27FC236}">
                  <a16:creationId xmlns:a16="http://schemas.microsoft.com/office/drawing/2014/main" id="{2D29E8CA-60C7-42D7-B282-CDE3B0F92E3D}"/>
                </a:ext>
              </a:extLst>
            </p:cNvPr>
            <p:cNvSpPr>
              <a:spLocks/>
            </p:cNvSpPr>
            <p:nvPr/>
          </p:nvSpPr>
          <p:spPr bwMode="auto">
            <a:xfrm>
              <a:off x="3381" y="3928"/>
              <a:ext cx="302" cy="103"/>
            </a:xfrm>
            <a:custGeom>
              <a:avLst/>
              <a:gdLst>
                <a:gd name="T0" fmla="*/ 238 w 1940"/>
                <a:gd name="T1" fmla="*/ 508 h 660"/>
                <a:gd name="T2" fmla="*/ 633 w 1940"/>
                <a:gd name="T3" fmla="*/ 517 h 660"/>
                <a:gd name="T4" fmla="*/ 791 w 1940"/>
                <a:gd name="T5" fmla="*/ 480 h 660"/>
                <a:gd name="T6" fmla="*/ 851 w 1940"/>
                <a:gd name="T7" fmla="*/ 447 h 660"/>
                <a:gd name="T8" fmla="*/ 904 w 1940"/>
                <a:gd name="T9" fmla="*/ 395 h 660"/>
                <a:gd name="T10" fmla="*/ 1089 w 1940"/>
                <a:gd name="T11" fmla="*/ 179 h 660"/>
                <a:gd name="T12" fmla="*/ 1157 w 1940"/>
                <a:gd name="T13" fmla="*/ 103 h 660"/>
                <a:gd name="T14" fmla="*/ 1234 w 1940"/>
                <a:gd name="T15" fmla="*/ 42 h 660"/>
                <a:gd name="T16" fmla="*/ 1325 w 1940"/>
                <a:gd name="T17" fmla="*/ 7 h 660"/>
                <a:gd name="T18" fmla="*/ 1419 w 1940"/>
                <a:gd name="T19" fmla="*/ 5 h 660"/>
                <a:gd name="T20" fmla="*/ 1503 w 1940"/>
                <a:gd name="T21" fmla="*/ 27 h 660"/>
                <a:gd name="T22" fmla="*/ 1652 w 1940"/>
                <a:gd name="T23" fmla="*/ 105 h 660"/>
                <a:gd name="T24" fmla="*/ 1832 w 1940"/>
                <a:gd name="T25" fmla="*/ 231 h 660"/>
                <a:gd name="T26" fmla="*/ 1897 w 1940"/>
                <a:gd name="T27" fmla="*/ 273 h 660"/>
                <a:gd name="T28" fmla="*/ 1921 w 1940"/>
                <a:gd name="T29" fmla="*/ 366 h 660"/>
                <a:gd name="T30" fmla="*/ 1794 w 1940"/>
                <a:gd name="T31" fmla="*/ 386 h 660"/>
                <a:gd name="T32" fmla="*/ 1818 w 1940"/>
                <a:gd name="T33" fmla="*/ 247 h 660"/>
                <a:gd name="T34" fmla="*/ 1888 w 1940"/>
                <a:gd name="T35" fmla="*/ 273 h 660"/>
                <a:gd name="T36" fmla="*/ 1787 w 1940"/>
                <a:gd name="T37" fmla="*/ 299 h 660"/>
                <a:gd name="T38" fmla="*/ 1777 w 1940"/>
                <a:gd name="T39" fmla="*/ 366 h 660"/>
                <a:gd name="T40" fmla="*/ 1688 w 1940"/>
                <a:gd name="T41" fmla="*/ 308 h 660"/>
                <a:gd name="T42" fmla="*/ 1505 w 1940"/>
                <a:gd name="T43" fmla="*/ 183 h 660"/>
                <a:gd name="T44" fmla="*/ 1448 w 1940"/>
                <a:gd name="T45" fmla="*/ 155 h 660"/>
                <a:gd name="T46" fmla="*/ 1404 w 1940"/>
                <a:gd name="T47" fmla="*/ 140 h 660"/>
                <a:gd name="T48" fmla="*/ 1366 w 1940"/>
                <a:gd name="T49" fmla="*/ 138 h 660"/>
                <a:gd name="T50" fmla="*/ 1320 w 1940"/>
                <a:gd name="T51" fmla="*/ 155 h 660"/>
                <a:gd name="T52" fmla="*/ 1270 w 1940"/>
                <a:gd name="T53" fmla="*/ 197 h 660"/>
                <a:gd name="T54" fmla="*/ 1150 w 1940"/>
                <a:gd name="T55" fmla="*/ 340 h 660"/>
                <a:gd name="T56" fmla="*/ 943 w 1940"/>
                <a:gd name="T57" fmla="*/ 556 h 660"/>
                <a:gd name="T58" fmla="*/ 847 w 1940"/>
                <a:gd name="T59" fmla="*/ 608 h 660"/>
                <a:gd name="T60" fmla="*/ 652 w 1940"/>
                <a:gd name="T61" fmla="*/ 656 h 660"/>
                <a:gd name="T62" fmla="*/ 431 w 1940"/>
                <a:gd name="T63" fmla="*/ 660 h 660"/>
                <a:gd name="T64" fmla="*/ 0 w 1940"/>
                <a:gd name="T65" fmla="*/ 617 h 6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940" h="660">
                  <a:moveTo>
                    <a:pt x="22" y="480"/>
                  </a:moveTo>
                  <a:lnTo>
                    <a:pt x="238" y="508"/>
                  </a:lnTo>
                  <a:lnTo>
                    <a:pt x="443" y="523"/>
                  </a:lnTo>
                  <a:lnTo>
                    <a:pt x="633" y="517"/>
                  </a:lnTo>
                  <a:lnTo>
                    <a:pt x="616" y="519"/>
                  </a:lnTo>
                  <a:lnTo>
                    <a:pt x="791" y="480"/>
                  </a:lnTo>
                  <a:lnTo>
                    <a:pt x="772" y="488"/>
                  </a:lnTo>
                  <a:lnTo>
                    <a:pt x="851" y="447"/>
                  </a:lnTo>
                  <a:lnTo>
                    <a:pt x="835" y="456"/>
                  </a:lnTo>
                  <a:lnTo>
                    <a:pt x="904" y="395"/>
                  </a:lnTo>
                  <a:lnTo>
                    <a:pt x="1027" y="255"/>
                  </a:lnTo>
                  <a:lnTo>
                    <a:pt x="1089" y="179"/>
                  </a:lnTo>
                  <a:lnTo>
                    <a:pt x="1147" y="112"/>
                  </a:lnTo>
                  <a:cubicBezTo>
                    <a:pt x="1150" y="107"/>
                    <a:pt x="1152" y="105"/>
                    <a:pt x="1157" y="103"/>
                  </a:cubicBezTo>
                  <a:lnTo>
                    <a:pt x="1217" y="53"/>
                  </a:lnTo>
                  <a:cubicBezTo>
                    <a:pt x="1222" y="48"/>
                    <a:pt x="1226" y="44"/>
                    <a:pt x="1234" y="42"/>
                  </a:cubicBezTo>
                  <a:lnTo>
                    <a:pt x="1296" y="14"/>
                  </a:lnTo>
                  <a:cubicBezTo>
                    <a:pt x="1306" y="9"/>
                    <a:pt x="1315" y="7"/>
                    <a:pt x="1325" y="7"/>
                  </a:cubicBezTo>
                  <a:lnTo>
                    <a:pt x="1392" y="3"/>
                  </a:lnTo>
                  <a:cubicBezTo>
                    <a:pt x="1402" y="0"/>
                    <a:pt x="1409" y="3"/>
                    <a:pt x="1419" y="5"/>
                  </a:cubicBezTo>
                  <a:lnTo>
                    <a:pt x="1489" y="22"/>
                  </a:lnTo>
                  <a:cubicBezTo>
                    <a:pt x="1493" y="22"/>
                    <a:pt x="1498" y="24"/>
                    <a:pt x="1503" y="27"/>
                  </a:cubicBezTo>
                  <a:lnTo>
                    <a:pt x="1575" y="59"/>
                  </a:lnTo>
                  <a:lnTo>
                    <a:pt x="1652" y="105"/>
                  </a:lnTo>
                  <a:lnTo>
                    <a:pt x="1782" y="197"/>
                  </a:lnTo>
                  <a:lnTo>
                    <a:pt x="1832" y="231"/>
                  </a:lnTo>
                  <a:lnTo>
                    <a:pt x="1866" y="255"/>
                  </a:lnTo>
                  <a:lnTo>
                    <a:pt x="1897" y="273"/>
                  </a:lnTo>
                  <a:cubicBezTo>
                    <a:pt x="1931" y="290"/>
                    <a:pt x="1940" y="329"/>
                    <a:pt x="1924" y="362"/>
                  </a:cubicBezTo>
                  <a:lnTo>
                    <a:pt x="1921" y="366"/>
                  </a:lnTo>
                  <a:cubicBezTo>
                    <a:pt x="1902" y="401"/>
                    <a:pt x="1856" y="414"/>
                    <a:pt x="1818" y="397"/>
                  </a:cubicBezTo>
                  <a:lnTo>
                    <a:pt x="1794" y="386"/>
                  </a:lnTo>
                  <a:lnTo>
                    <a:pt x="1763" y="375"/>
                  </a:lnTo>
                  <a:lnTo>
                    <a:pt x="1818" y="247"/>
                  </a:lnTo>
                  <a:lnTo>
                    <a:pt x="1864" y="262"/>
                  </a:lnTo>
                  <a:lnTo>
                    <a:pt x="1888" y="273"/>
                  </a:lnTo>
                  <a:lnTo>
                    <a:pt x="1784" y="303"/>
                  </a:lnTo>
                  <a:lnTo>
                    <a:pt x="1787" y="299"/>
                  </a:lnTo>
                  <a:lnTo>
                    <a:pt x="1813" y="388"/>
                  </a:lnTo>
                  <a:lnTo>
                    <a:pt x="1777" y="366"/>
                  </a:lnTo>
                  <a:lnTo>
                    <a:pt x="1739" y="342"/>
                  </a:lnTo>
                  <a:lnTo>
                    <a:pt x="1688" y="308"/>
                  </a:lnTo>
                  <a:lnTo>
                    <a:pt x="1568" y="220"/>
                  </a:lnTo>
                  <a:lnTo>
                    <a:pt x="1505" y="183"/>
                  </a:lnTo>
                  <a:lnTo>
                    <a:pt x="1433" y="151"/>
                  </a:lnTo>
                  <a:lnTo>
                    <a:pt x="1448" y="155"/>
                  </a:lnTo>
                  <a:lnTo>
                    <a:pt x="1378" y="138"/>
                  </a:lnTo>
                  <a:lnTo>
                    <a:pt x="1404" y="140"/>
                  </a:lnTo>
                  <a:lnTo>
                    <a:pt x="1337" y="144"/>
                  </a:lnTo>
                  <a:lnTo>
                    <a:pt x="1366" y="138"/>
                  </a:lnTo>
                  <a:lnTo>
                    <a:pt x="1303" y="166"/>
                  </a:lnTo>
                  <a:lnTo>
                    <a:pt x="1320" y="155"/>
                  </a:lnTo>
                  <a:lnTo>
                    <a:pt x="1260" y="205"/>
                  </a:lnTo>
                  <a:lnTo>
                    <a:pt x="1270" y="197"/>
                  </a:lnTo>
                  <a:lnTo>
                    <a:pt x="1212" y="264"/>
                  </a:lnTo>
                  <a:lnTo>
                    <a:pt x="1150" y="340"/>
                  </a:lnTo>
                  <a:lnTo>
                    <a:pt x="1013" y="495"/>
                  </a:lnTo>
                  <a:lnTo>
                    <a:pt x="943" y="556"/>
                  </a:lnTo>
                  <a:cubicBezTo>
                    <a:pt x="938" y="560"/>
                    <a:pt x="933" y="565"/>
                    <a:pt x="926" y="567"/>
                  </a:cubicBezTo>
                  <a:lnTo>
                    <a:pt x="847" y="608"/>
                  </a:lnTo>
                  <a:cubicBezTo>
                    <a:pt x="842" y="613"/>
                    <a:pt x="835" y="615"/>
                    <a:pt x="827" y="617"/>
                  </a:cubicBezTo>
                  <a:lnTo>
                    <a:pt x="652" y="656"/>
                  </a:lnTo>
                  <a:cubicBezTo>
                    <a:pt x="647" y="656"/>
                    <a:pt x="642" y="656"/>
                    <a:pt x="635" y="656"/>
                  </a:cubicBezTo>
                  <a:lnTo>
                    <a:pt x="431" y="660"/>
                  </a:lnTo>
                  <a:lnTo>
                    <a:pt x="217" y="645"/>
                  </a:lnTo>
                  <a:lnTo>
                    <a:pt x="0" y="617"/>
                  </a:lnTo>
                  <a:lnTo>
                    <a:pt x="22" y="480"/>
                  </a:lnTo>
                  <a:close/>
                </a:path>
              </a:pathLst>
            </a:custGeom>
            <a:solidFill>
              <a:srgbClr val="FFC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Freeform 15">
              <a:extLst>
                <a:ext uri="{FF2B5EF4-FFF2-40B4-BE49-F238E27FC236}">
                  <a16:creationId xmlns:a16="http://schemas.microsoft.com/office/drawing/2014/main" id="{7F239338-9C61-4CEB-909E-084FBC78C760}"/>
                </a:ext>
              </a:extLst>
            </p:cNvPr>
            <p:cNvSpPr>
              <a:spLocks/>
            </p:cNvSpPr>
            <p:nvPr/>
          </p:nvSpPr>
          <p:spPr bwMode="auto">
            <a:xfrm>
              <a:off x="3381" y="3928"/>
              <a:ext cx="301" cy="103"/>
            </a:xfrm>
            <a:custGeom>
              <a:avLst/>
              <a:gdLst>
                <a:gd name="T0" fmla="*/ 238 w 1940"/>
                <a:gd name="T1" fmla="*/ 508 h 660"/>
                <a:gd name="T2" fmla="*/ 633 w 1940"/>
                <a:gd name="T3" fmla="*/ 517 h 660"/>
                <a:gd name="T4" fmla="*/ 791 w 1940"/>
                <a:gd name="T5" fmla="*/ 480 h 660"/>
                <a:gd name="T6" fmla="*/ 851 w 1940"/>
                <a:gd name="T7" fmla="*/ 447 h 660"/>
                <a:gd name="T8" fmla="*/ 904 w 1940"/>
                <a:gd name="T9" fmla="*/ 395 h 660"/>
                <a:gd name="T10" fmla="*/ 1089 w 1940"/>
                <a:gd name="T11" fmla="*/ 179 h 660"/>
                <a:gd name="T12" fmla="*/ 1157 w 1940"/>
                <a:gd name="T13" fmla="*/ 103 h 660"/>
                <a:gd name="T14" fmla="*/ 1234 w 1940"/>
                <a:gd name="T15" fmla="*/ 42 h 660"/>
                <a:gd name="T16" fmla="*/ 1325 w 1940"/>
                <a:gd name="T17" fmla="*/ 7 h 660"/>
                <a:gd name="T18" fmla="*/ 1419 w 1940"/>
                <a:gd name="T19" fmla="*/ 5 h 660"/>
                <a:gd name="T20" fmla="*/ 1503 w 1940"/>
                <a:gd name="T21" fmla="*/ 27 h 660"/>
                <a:gd name="T22" fmla="*/ 1652 w 1940"/>
                <a:gd name="T23" fmla="*/ 105 h 660"/>
                <a:gd name="T24" fmla="*/ 1832 w 1940"/>
                <a:gd name="T25" fmla="*/ 231 h 660"/>
                <a:gd name="T26" fmla="*/ 1897 w 1940"/>
                <a:gd name="T27" fmla="*/ 273 h 660"/>
                <a:gd name="T28" fmla="*/ 1921 w 1940"/>
                <a:gd name="T29" fmla="*/ 366 h 660"/>
                <a:gd name="T30" fmla="*/ 1794 w 1940"/>
                <a:gd name="T31" fmla="*/ 386 h 660"/>
                <a:gd name="T32" fmla="*/ 1818 w 1940"/>
                <a:gd name="T33" fmla="*/ 247 h 660"/>
                <a:gd name="T34" fmla="*/ 1888 w 1940"/>
                <a:gd name="T35" fmla="*/ 273 h 660"/>
                <a:gd name="T36" fmla="*/ 1787 w 1940"/>
                <a:gd name="T37" fmla="*/ 299 h 660"/>
                <a:gd name="T38" fmla="*/ 1777 w 1940"/>
                <a:gd name="T39" fmla="*/ 366 h 660"/>
                <a:gd name="T40" fmla="*/ 1688 w 1940"/>
                <a:gd name="T41" fmla="*/ 308 h 660"/>
                <a:gd name="T42" fmla="*/ 1505 w 1940"/>
                <a:gd name="T43" fmla="*/ 183 h 660"/>
                <a:gd name="T44" fmla="*/ 1448 w 1940"/>
                <a:gd name="T45" fmla="*/ 155 h 660"/>
                <a:gd name="T46" fmla="*/ 1404 w 1940"/>
                <a:gd name="T47" fmla="*/ 140 h 660"/>
                <a:gd name="T48" fmla="*/ 1366 w 1940"/>
                <a:gd name="T49" fmla="*/ 138 h 660"/>
                <a:gd name="T50" fmla="*/ 1320 w 1940"/>
                <a:gd name="T51" fmla="*/ 155 h 660"/>
                <a:gd name="T52" fmla="*/ 1270 w 1940"/>
                <a:gd name="T53" fmla="*/ 197 h 660"/>
                <a:gd name="T54" fmla="*/ 1150 w 1940"/>
                <a:gd name="T55" fmla="*/ 340 h 660"/>
                <a:gd name="T56" fmla="*/ 943 w 1940"/>
                <a:gd name="T57" fmla="*/ 556 h 660"/>
                <a:gd name="T58" fmla="*/ 847 w 1940"/>
                <a:gd name="T59" fmla="*/ 608 h 660"/>
                <a:gd name="T60" fmla="*/ 652 w 1940"/>
                <a:gd name="T61" fmla="*/ 656 h 660"/>
                <a:gd name="T62" fmla="*/ 431 w 1940"/>
                <a:gd name="T63" fmla="*/ 660 h 660"/>
                <a:gd name="T64" fmla="*/ 0 w 1940"/>
                <a:gd name="T65" fmla="*/ 617 h 6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940" h="660">
                  <a:moveTo>
                    <a:pt x="22" y="480"/>
                  </a:moveTo>
                  <a:lnTo>
                    <a:pt x="238" y="508"/>
                  </a:lnTo>
                  <a:lnTo>
                    <a:pt x="443" y="523"/>
                  </a:lnTo>
                  <a:lnTo>
                    <a:pt x="633" y="517"/>
                  </a:lnTo>
                  <a:lnTo>
                    <a:pt x="616" y="519"/>
                  </a:lnTo>
                  <a:lnTo>
                    <a:pt x="791" y="480"/>
                  </a:lnTo>
                  <a:lnTo>
                    <a:pt x="772" y="488"/>
                  </a:lnTo>
                  <a:lnTo>
                    <a:pt x="851" y="447"/>
                  </a:lnTo>
                  <a:lnTo>
                    <a:pt x="835" y="456"/>
                  </a:lnTo>
                  <a:lnTo>
                    <a:pt x="904" y="395"/>
                  </a:lnTo>
                  <a:lnTo>
                    <a:pt x="1027" y="255"/>
                  </a:lnTo>
                  <a:lnTo>
                    <a:pt x="1089" y="179"/>
                  </a:lnTo>
                  <a:lnTo>
                    <a:pt x="1147" y="112"/>
                  </a:lnTo>
                  <a:cubicBezTo>
                    <a:pt x="1150" y="107"/>
                    <a:pt x="1152" y="105"/>
                    <a:pt x="1157" y="103"/>
                  </a:cubicBezTo>
                  <a:lnTo>
                    <a:pt x="1217" y="53"/>
                  </a:lnTo>
                  <a:cubicBezTo>
                    <a:pt x="1222" y="48"/>
                    <a:pt x="1226" y="44"/>
                    <a:pt x="1234" y="42"/>
                  </a:cubicBezTo>
                  <a:lnTo>
                    <a:pt x="1296" y="14"/>
                  </a:lnTo>
                  <a:cubicBezTo>
                    <a:pt x="1306" y="9"/>
                    <a:pt x="1315" y="7"/>
                    <a:pt x="1325" y="7"/>
                  </a:cubicBezTo>
                  <a:lnTo>
                    <a:pt x="1392" y="3"/>
                  </a:lnTo>
                  <a:cubicBezTo>
                    <a:pt x="1402" y="0"/>
                    <a:pt x="1409" y="3"/>
                    <a:pt x="1419" y="5"/>
                  </a:cubicBezTo>
                  <a:lnTo>
                    <a:pt x="1489" y="22"/>
                  </a:lnTo>
                  <a:cubicBezTo>
                    <a:pt x="1493" y="22"/>
                    <a:pt x="1498" y="24"/>
                    <a:pt x="1503" y="27"/>
                  </a:cubicBezTo>
                  <a:lnTo>
                    <a:pt x="1575" y="59"/>
                  </a:lnTo>
                  <a:lnTo>
                    <a:pt x="1652" y="105"/>
                  </a:lnTo>
                  <a:lnTo>
                    <a:pt x="1782" y="197"/>
                  </a:lnTo>
                  <a:lnTo>
                    <a:pt x="1832" y="231"/>
                  </a:lnTo>
                  <a:lnTo>
                    <a:pt x="1866" y="255"/>
                  </a:lnTo>
                  <a:lnTo>
                    <a:pt x="1897" y="273"/>
                  </a:lnTo>
                  <a:cubicBezTo>
                    <a:pt x="1931" y="290"/>
                    <a:pt x="1940" y="329"/>
                    <a:pt x="1924" y="362"/>
                  </a:cubicBezTo>
                  <a:lnTo>
                    <a:pt x="1921" y="366"/>
                  </a:lnTo>
                  <a:cubicBezTo>
                    <a:pt x="1902" y="401"/>
                    <a:pt x="1856" y="414"/>
                    <a:pt x="1818" y="397"/>
                  </a:cubicBezTo>
                  <a:lnTo>
                    <a:pt x="1794" y="386"/>
                  </a:lnTo>
                  <a:lnTo>
                    <a:pt x="1763" y="375"/>
                  </a:lnTo>
                  <a:lnTo>
                    <a:pt x="1818" y="247"/>
                  </a:lnTo>
                  <a:lnTo>
                    <a:pt x="1864" y="262"/>
                  </a:lnTo>
                  <a:lnTo>
                    <a:pt x="1888" y="273"/>
                  </a:lnTo>
                  <a:lnTo>
                    <a:pt x="1784" y="303"/>
                  </a:lnTo>
                  <a:lnTo>
                    <a:pt x="1787" y="299"/>
                  </a:lnTo>
                  <a:lnTo>
                    <a:pt x="1813" y="388"/>
                  </a:lnTo>
                  <a:lnTo>
                    <a:pt x="1777" y="366"/>
                  </a:lnTo>
                  <a:lnTo>
                    <a:pt x="1739" y="342"/>
                  </a:lnTo>
                  <a:lnTo>
                    <a:pt x="1688" y="308"/>
                  </a:lnTo>
                  <a:lnTo>
                    <a:pt x="1568" y="220"/>
                  </a:lnTo>
                  <a:lnTo>
                    <a:pt x="1505" y="183"/>
                  </a:lnTo>
                  <a:lnTo>
                    <a:pt x="1433" y="151"/>
                  </a:lnTo>
                  <a:lnTo>
                    <a:pt x="1448" y="155"/>
                  </a:lnTo>
                  <a:lnTo>
                    <a:pt x="1378" y="138"/>
                  </a:lnTo>
                  <a:lnTo>
                    <a:pt x="1404" y="140"/>
                  </a:lnTo>
                  <a:lnTo>
                    <a:pt x="1337" y="144"/>
                  </a:lnTo>
                  <a:lnTo>
                    <a:pt x="1366" y="138"/>
                  </a:lnTo>
                  <a:lnTo>
                    <a:pt x="1303" y="166"/>
                  </a:lnTo>
                  <a:lnTo>
                    <a:pt x="1320" y="155"/>
                  </a:lnTo>
                  <a:lnTo>
                    <a:pt x="1260" y="205"/>
                  </a:lnTo>
                  <a:lnTo>
                    <a:pt x="1270" y="197"/>
                  </a:lnTo>
                  <a:lnTo>
                    <a:pt x="1212" y="264"/>
                  </a:lnTo>
                  <a:lnTo>
                    <a:pt x="1150" y="340"/>
                  </a:lnTo>
                  <a:lnTo>
                    <a:pt x="1013" y="495"/>
                  </a:lnTo>
                  <a:lnTo>
                    <a:pt x="943" y="556"/>
                  </a:lnTo>
                  <a:cubicBezTo>
                    <a:pt x="938" y="560"/>
                    <a:pt x="933" y="565"/>
                    <a:pt x="926" y="567"/>
                  </a:cubicBezTo>
                  <a:lnTo>
                    <a:pt x="847" y="608"/>
                  </a:lnTo>
                  <a:cubicBezTo>
                    <a:pt x="842" y="613"/>
                    <a:pt x="835" y="615"/>
                    <a:pt x="827" y="617"/>
                  </a:cubicBezTo>
                  <a:lnTo>
                    <a:pt x="652" y="656"/>
                  </a:lnTo>
                  <a:cubicBezTo>
                    <a:pt x="647" y="656"/>
                    <a:pt x="642" y="656"/>
                    <a:pt x="635" y="656"/>
                  </a:cubicBezTo>
                  <a:lnTo>
                    <a:pt x="431" y="660"/>
                  </a:lnTo>
                  <a:lnTo>
                    <a:pt x="217" y="645"/>
                  </a:lnTo>
                  <a:lnTo>
                    <a:pt x="0" y="617"/>
                  </a:lnTo>
                  <a:lnTo>
                    <a:pt x="22" y="480"/>
                  </a:lnTo>
                  <a:close/>
                </a:path>
              </a:pathLst>
            </a:custGeom>
            <a:noFill/>
            <a:ln w="1588" cap="flat">
              <a:solidFill>
                <a:srgbClr val="FFC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Freeform 16">
              <a:extLst>
                <a:ext uri="{FF2B5EF4-FFF2-40B4-BE49-F238E27FC236}">
                  <a16:creationId xmlns:a16="http://schemas.microsoft.com/office/drawing/2014/main" id="{4F3A66C4-E7D8-447B-A0C3-842BD4A607C2}"/>
                </a:ext>
              </a:extLst>
            </p:cNvPr>
            <p:cNvSpPr>
              <a:spLocks/>
            </p:cNvSpPr>
            <p:nvPr/>
          </p:nvSpPr>
          <p:spPr bwMode="auto">
            <a:xfrm>
              <a:off x="3597" y="3850"/>
              <a:ext cx="8" cy="86"/>
            </a:xfrm>
            <a:custGeom>
              <a:avLst/>
              <a:gdLst>
                <a:gd name="T0" fmla="*/ 8 w 8"/>
                <a:gd name="T1" fmla="*/ 0 h 86"/>
                <a:gd name="T2" fmla="*/ 8 w 8"/>
                <a:gd name="T3" fmla="*/ 86 h 86"/>
                <a:gd name="T4" fmla="*/ 0 w 8"/>
                <a:gd name="T5" fmla="*/ 86 h 86"/>
                <a:gd name="T6" fmla="*/ 2 w 8"/>
                <a:gd name="T7" fmla="*/ 0 h 86"/>
                <a:gd name="T8" fmla="*/ 8 w 8"/>
                <a:gd name="T9" fmla="*/ 0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" h="86">
                  <a:moveTo>
                    <a:pt x="8" y="0"/>
                  </a:moveTo>
                  <a:lnTo>
                    <a:pt x="8" y="86"/>
                  </a:lnTo>
                  <a:lnTo>
                    <a:pt x="0" y="86"/>
                  </a:lnTo>
                  <a:lnTo>
                    <a:pt x="2" y="0"/>
                  </a:lnTo>
                  <a:lnTo>
                    <a:pt x="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Freeform 17">
              <a:extLst>
                <a:ext uri="{FF2B5EF4-FFF2-40B4-BE49-F238E27FC236}">
                  <a16:creationId xmlns:a16="http://schemas.microsoft.com/office/drawing/2014/main" id="{36287E7E-68A2-4EB1-A3CD-FF15BDBA0A1A}"/>
                </a:ext>
              </a:extLst>
            </p:cNvPr>
            <p:cNvSpPr>
              <a:spLocks/>
            </p:cNvSpPr>
            <p:nvPr/>
          </p:nvSpPr>
          <p:spPr bwMode="auto">
            <a:xfrm>
              <a:off x="3597" y="3850"/>
              <a:ext cx="8" cy="86"/>
            </a:xfrm>
            <a:custGeom>
              <a:avLst/>
              <a:gdLst>
                <a:gd name="T0" fmla="*/ 8 w 8"/>
                <a:gd name="T1" fmla="*/ 0 h 86"/>
                <a:gd name="T2" fmla="*/ 8 w 8"/>
                <a:gd name="T3" fmla="*/ 86 h 86"/>
                <a:gd name="T4" fmla="*/ 0 w 8"/>
                <a:gd name="T5" fmla="*/ 86 h 86"/>
                <a:gd name="T6" fmla="*/ 2 w 8"/>
                <a:gd name="T7" fmla="*/ 0 h 86"/>
                <a:gd name="T8" fmla="*/ 8 w 8"/>
                <a:gd name="T9" fmla="*/ 0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" h="86">
                  <a:moveTo>
                    <a:pt x="8" y="0"/>
                  </a:moveTo>
                  <a:lnTo>
                    <a:pt x="8" y="86"/>
                  </a:lnTo>
                  <a:lnTo>
                    <a:pt x="0" y="86"/>
                  </a:lnTo>
                  <a:lnTo>
                    <a:pt x="2" y="0"/>
                  </a:lnTo>
                  <a:lnTo>
                    <a:pt x="8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Rectangle 18">
              <a:extLst>
                <a:ext uri="{FF2B5EF4-FFF2-40B4-BE49-F238E27FC236}">
                  <a16:creationId xmlns:a16="http://schemas.microsoft.com/office/drawing/2014/main" id="{EEA25855-58CB-49CC-9755-A4028D934E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8" y="3765"/>
              <a:ext cx="7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p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Freeform 19">
              <a:extLst>
                <a:ext uri="{FF2B5EF4-FFF2-40B4-BE49-F238E27FC236}">
                  <a16:creationId xmlns:a16="http://schemas.microsoft.com/office/drawing/2014/main" id="{99BDF22F-ABD0-41BB-9783-C8B84015E7B2}"/>
                </a:ext>
              </a:extLst>
            </p:cNvPr>
            <p:cNvSpPr>
              <a:spLocks/>
            </p:cNvSpPr>
            <p:nvPr/>
          </p:nvSpPr>
          <p:spPr bwMode="auto">
            <a:xfrm>
              <a:off x="3298" y="3979"/>
              <a:ext cx="7" cy="87"/>
            </a:xfrm>
            <a:custGeom>
              <a:avLst/>
              <a:gdLst>
                <a:gd name="T0" fmla="*/ 7 w 7"/>
                <a:gd name="T1" fmla="*/ 1 h 87"/>
                <a:gd name="T2" fmla="*/ 6 w 7"/>
                <a:gd name="T3" fmla="*/ 87 h 87"/>
                <a:gd name="T4" fmla="*/ 0 w 7"/>
                <a:gd name="T5" fmla="*/ 86 h 87"/>
                <a:gd name="T6" fmla="*/ 1 w 7"/>
                <a:gd name="T7" fmla="*/ 0 h 87"/>
                <a:gd name="T8" fmla="*/ 7 w 7"/>
                <a:gd name="T9" fmla="*/ 1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" h="87">
                  <a:moveTo>
                    <a:pt x="7" y="1"/>
                  </a:moveTo>
                  <a:lnTo>
                    <a:pt x="6" y="87"/>
                  </a:lnTo>
                  <a:lnTo>
                    <a:pt x="0" y="86"/>
                  </a:lnTo>
                  <a:lnTo>
                    <a:pt x="1" y="0"/>
                  </a:lnTo>
                  <a:lnTo>
                    <a:pt x="7" y="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Freeform 20">
              <a:extLst>
                <a:ext uri="{FF2B5EF4-FFF2-40B4-BE49-F238E27FC236}">
                  <a16:creationId xmlns:a16="http://schemas.microsoft.com/office/drawing/2014/main" id="{9AC1078B-A796-4A0C-817D-816A08896E6E}"/>
                </a:ext>
              </a:extLst>
            </p:cNvPr>
            <p:cNvSpPr>
              <a:spLocks/>
            </p:cNvSpPr>
            <p:nvPr/>
          </p:nvSpPr>
          <p:spPr bwMode="auto">
            <a:xfrm>
              <a:off x="3298" y="3979"/>
              <a:ext cx="7" cy="87"/>
            </a:xfrm>
            <a:custGeom>
              <a:avLst/>
              <a:gdLst>
                <a:gd name="T0" fmla="*/ 7 w 7"/>
                <a:gd name="T1" fmla="*/ 1 h 87"/>
                <a:gd name="T2" fmla="*/ 6 w 7"/>
                <a:gd name="T3" fmla="*/ 87 h 87"/>
                <a:gd name="T4" fmla="*/ 0 w 7"/>
                <a:gd name="T5" fmla="*/ 86 h 87"/>
                <a:gd name="T6" fmla="*/ 1 w 7"/>
                <a:gd name="T7" fmla="*/ 0 h 87"/>
                <a:gd name="T8" fmla="*/ 7 w 7"/>
                <a:gd name="T9" fmla="*/ 1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" h="87">
                  <a:moveTo>
                    <a:pt x="7" y="1"/>
                  </a:moveTo>
                  <a:lnTo>
                    <a:pt x="6" y="87"/>
                  </a:lnTo>
                  <a:lnTo>
                    <a:pt x="0" y="86"/>
                  </a:lnTo>
                  <a:lnTo>
                    <a:pt x="1" y="0"/>
                  </a:lnTo>
                  <a:lnTo>
                    <a:pt x="7" y="1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Rectangle 21">
              <a:extLst>
                <a:ext uri="{FF2B5EF4-FFF2-40B4-BE49-F238E27FC236}">
                  <a16:creationId xmlns:a16="http://schemas.microsoft.com/office/drawing/2014/main" id="{6E3412ED-DA1D-4FAB-B16D-AA2BB70A3E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7" y="3896"/>
              <a:ext cx="7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p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Freeform 22">
              <a:extLst>
                <a:ext uri="{FF2B5EF4-FFF2-40B4-BE49-F238E27FC236}">
                  <a16:creationId xmlns:a16="http://schemas.microsoft.com/office/drawing/2014/main" id="{9ABBB1D8-BC39-4CA2-B683-13873CFB1D41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4" y="4044"/>
              <a:ext cx="8" cy="87"/>
            </a:xfrm>
            <a:custGeom>
              <a:avLst/>
              <a:gdLst>
                <a:gd name="T0" fmla="*/ 8 w 8"/>
                <a:gd name="T1" fmla="*/ 0 h 87"/>
                <a:gd name="T2" fmla="*/ 6 w 8"/>
                <a:gd name="T3" fmla="*/ 87 h 87"/>
                <a:gd name="T4" fmla="*/ 0 w 8"/>
                <a:gd name="T5" fmla="*/ 87 h 87"/>
                <a:gd name="T6" fmla="*/ 0 w 8"/>
                <a:gd name="T7" fmla="*/ 0 h 87"/>
                <a:gd name="T8" fmla="*/ 8 w 8"/>
                <a:gd name="T9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" h="87">
                  <a:moveTo>
                    <a:pt x="8" y="0"/>
                  </a:moveTo>
                  <a:lnTo>
                    <a:pt x="6" y="87"/>
                  </a:lnTo>
                  <a:lnTo>
                    <a:pt x="0" y="87"/>
                  </a:lnTo>
                  <a:lnTo>
                    <a:pt x="0" y="0"/>
                  </a:lnTo>
                  <a:lnTo>
                    <a:pt x="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Freeform 23">
              <a:extLst>
                <a:ext uri="{FF2B5EF4-FFF2-40B4-BE49-F238E27FC236}">
                  <a16:creationId xmlns:a16="http://schemas.microsoft.com/office/drawing/2014/main" id="{C5D45744-708D-4EF8-930A-4C0A60837010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4" y="4044"/>
              <a:ext cx="8" cy="87"/>
            </a:xfrm>
            <a:custGeom>
              <a:avLst/>
              <a:gdLst>
                <a:gd name="T0" fmla="*/ 8 w 8"/>
                <a:gd name="T1" fmla="*/ 0 h 87"/>
                <a:gd name="T2" fmla="*/ 6 w 8"/>
                <a:gd name="T3" fmla="*/ 87 h 87"/>
                <a:gd name="T4" fmla="*/ 0 w 8"/>
                <a:gd name="T5" fmla="*/ 87 h 87"/>
                <a:gd name="T6" fmla="*/ 0 w 8"/>
                <a:gd name="T7" fmla="*/ 0 h 87"/>
                <a:gd name="T8" fmla="*/ 8 w 8"/>
                <a:gd name="T9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" h="87">
                  <a:moveTo>
                    <a:pt x="8" y="0"/>
                  </a:moveTo>
                  <a:lnTo>
                    <a:pt x="6" y="87"/>
                  </a:lnTo>
                  <a:lnTo>
                    <a:pt x="0" y="87"/>
                  </a:lnTo>
                  <a:lnTo>
                    <a:pt x="0" y="0"/>
                  </a:lnTo>
                  <a:lnTo>
                    <a:pt x="8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" name="Rectangle 24">
              <a:extLst>
                <a:ext uri="{FF2B5EF4-FFF2-40B4-BE49-F238E27FC236}">
                  <a16:creationId xmlns:a16="http://schemas.microsoft.com/office/drawing/2014/main" id="{9EF8C1D7-E8F4-4760-BD87-77A1CCD498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3" y="3959"/>
              <a:ext cx="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p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Freeform 25">
              <a:extLst>
                <a:ext uri="{FF2B5EF4-FFF2-40B4-BE49-F238E27FC236}">
                  <a16:creationId xmlns:a16="http://schemas.microsoft.com/office/drawing/2014/main" id="{BCF1DFD5-10AA-409A-94AA-A071AECAD8D6}"/>
                </a:ext>
              </a:extLst>
            </p:cNvPr>
            <p:cNvSpPr>
              <a:spLocks/>
            </p:cNvSpPr>
            <p:nvPr/>
          </p:nvSpPr>
          <p:spPr bwMode="auto">
            <a:xfrm>
              <a:off x="3195" y="4141"/>
              <a:ext cx="9" cy="87"/>
            </a:xfrm>
            <a:custGeom>
              <a:avLst/>
              <a:gdLst>
                <a:gd name="T0" fmla="*/ 9 w 9"/>
                <a:gd name="T1" fmla="*/ 0 h 87"/>
                <a:gd name="T2" fmla="*/ 7 w 9"/>
                <a:gd name="T3" fmla="*/ 87 h 87"/>
                <a:gd name="T4" fmla="*/ 0 w 9"/>
                <a:gd name="T5" fmla="*/ 87 h 87"/>
                <a:gd name="T6" fmla="*/ 2 w 9"/>
                <a:gd name="T7" fmla="*/ 0 h 87"/>
                <a:gd name="T8" fmla="*/ 9 w 9"/>
                <a:gd name="T9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9" h="87">
                  <a:moveTo>
                    <a:pt x="9" y="0"/>
                  </a:moveTo>
                  <a:lnTo>
                    <a:pt x="7" y="87"/>
                  </a:lnTo>
                  <a:lnTo>
                    <a:pt x="0" y="87"/>
                  </a:lnTo>
                  <a:lnTo>
                    <a:pt x="2" y="0"/>
                  </a:lnTo>
                  <a:lnTo>
                    <a:pt x="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Freeform 26">
              <a:extLst>
                <a:ext uri="{FF2B5EF4-FFF2-40B4-BE49-F238E27FC236}">
                  <a16:creationId xmlns:a16="http://schemas.microsoft.com/office/drawing/2014/main" id="{732F0C66-22B2-4FFA-BF47-DA74633AA048}"/>
                </a:ext>
              </a:extLst>
            </p:cNvPr>
            <p:cNvSpPr>
              <a:spLocks/>
            </p:cNvSpPr>
            <p:nvPr/>
          </p:nvSpPr>
          <p:spPr bwMode="auto">
            <a:xfrm>
              <a:off x="3195" y="4141"/>
              <a:ext cx="9" cy="87"/>
            </a:xfrm>
            <a:custGeom>
              <a:avLst/>
              <a:gdLst>
                <a:gd name="T0" fmla="*/ 9 w 9"/>
                <a:gd name="T1" fmla="*/ 0 h 87"/>
                <a:gd name="T2" fmla="*/ 7 w 9"/>
                <a:gd name="T3" fmla="*/ 87 h 87"/>
                <a:gd name="T4" fmla="*/ 0 w 9"/>
                <a:gd name="T5" fmla="*/ 87 h 87"/>
                <a:gd name="T6" fmla="*/ 2 w 9"/>
                <a:gd name="T7" fmla="*/ 0 h 87"/>
                <a:gd name="T8" fmla="*/ 9 w 9"/>
                <a:gd name="T9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9" h="87">
                  <a:moveTo>
                    <a:pt x="9" y="0"/>
                  </a:moveTo>
                  <a:lnTo>
                    <a:pt x="7" y="87"/>
                  </a:lnTo>
                  <a:lnTo>
                    <a:pt x="0" y="87"/>
                  </a:lnTo>
                  <a:lnTo>
                    <a:pt x="2" y="0"/>
                  </a:lnTo>
                  <a:lnTo>
                    <a:pt x="9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Rectangle 27">
              <a:extLst>
                <a:ext uri="{FF2B5EF4-FFF2-40B4-BE49-F238E27FC236}">
                  <a16:creationId xmlns:a16="http://schemas.microsoft.com/office/drawing/2014/main" id="{E524B30D-B258-4E15-9544-0F718813D2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7" y="4057"/>
              <a:ext cx="7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p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Freeform 28">
              <a:extLst>
                <a:ext uri="{FF2B5EF4-FFF2-40B4-BE49-F238E27FC236}">
                  <a16:creationId xmlns:a16="http://schemas.microsoft.com/office/drawing/2014/main" id="{5D51F605-A488-468C-8609-095A713C5809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2" y="4217"/>
              <a:ext cx="7" cy="85"/>
            </a:xfrm>
            <a:custGeom>
              <a:avLst/>
              <a:gdLst>
                <a:gd name="T0" fmla="*/ 7 w 7"/>
                <a:gd name="T1" fmla="*/ 0 h 85"/>
                <a:gd name="T2" fmla="*/ 6 w 7"/>
                <a:gd name="T3" fmla="*/ 85 h 85"/>
                <a:gd name="T4" fmla="*/ 0 w 7"/>
                <a:gd name="T5" fmla="*/ 85 h 85"/>
                <a:gd name="T6" fmla="*/ 1 w 7"/>
                <a:gd name="T7" fmla="*/ 0 h 85"/>
                <a:gd name="T8" fmla="*/ 7 w 7"/>
                <a:gd name="T9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" h="85">
                  <a:moveTo>
                    <a:pt x="7" y="0"/>
                  </a:moveTo>
                  <a:lnTo>
                    <a:pt x="6" y="85"/>
                  </a:lnTo>
                  <a:lnTo>
                    <a:pt x="0" y="85"/>
                  </a:lnTo>
                  <a:lnTo>
                    <a:pt x="1" y="0"/>
                  </a:lnTo>
                  <a:lnTo>
                    <a:pt x="7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Freeform 29">
              <a:extLst>
                <a:ext uri="{FF2B5EF4-FFF2-40B4-BE49-F238E27FC236}">
                  <a16:creationId xmlns:a16="http://schemas.microsoft.com/office/drawing/2014/main" id="{D98F337E-59A1-4326-9047-D7620B4D7651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2" y="4217"/>
              <a:ext cx="7" cy="85"/>
            </a:xfrm>
            <a:custGeom>
              <a:avLst/>
              <a:gdLst>
                <a:gd name="T0" fmla="*/ 7 w 7"/>
                <a:gd name="T1" fmla="*/ 0 h 85"/>
                <a:gd name="T2" fmla="*/ 6 w 7"/>
                <a:gd name="T3" fmla="*/ 85 h 85"/>
                <a:gd name="T4" fmla="*/ 0 w 7"/>
                <a:gd name="T5" fmla="*/ 85 h 85"/>
                <a:gd name="T6" fmla="*/ 1 w 7"/>
                <a:gd name="T7" fmla="*/ 0 h 85"/>
                <a:gd name="T8" fmla="*/ 7 w 7"/>
                <a:gd name="T9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" h="85">
                  <a:moveTo>
                    <a:pt x="7" y="0"/>
                  </a:moveTo>
                  <a:lnTo>
                    <a:pt x="6" y="85"/>
                  </a:lnTo>
                  <a:lnTo>
                    <a:pt x="0" y="85"/>
                  </a:lnTo>
                  <a:lnTo>
                    <a:pt x="1" y="0"/>
                  </a:lnTo>
                  <a:lnTo>
                    <a:pt x="7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Rectangle 30">
              <a:extLst>
                <a:ext uri="{FF2B5EF4-FFF2-40B4-BE49-F238E27FC236}">
                  <a16:creationId xmlns:a16="http://schemas.microsoft.com/office/drawing/2014/main" id="{E121D6BA-8CDF-48D0-BDCC-1FC16D4488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2" y="4130"/>
              <a:ext cx="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</a:rPr>
                <a:t>p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31">
              <a:extLst>
                <a:ext uri="{FF2B5EF4-FFF2-40B4-BE49-F238E27FC236}">
                  <a16:creationId xmlns:a16="http://schemas.microsoft.com/office/drawing/2014/main" id="{575BC65B-AF6E-42A8-BD80-6331983056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6" y="4800"/>
              <a:ext cx="1342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dentification of phosphopeptides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32" name="Group 140">
              <a:extLst>
                <a:ext uri="{FF2B5EF4-FFF2-40B4-BE49-F238E27FC236}">
                  <a16:creationId xmlns:a16="http://schemas.microsoft.com/office/drawing/2014/main" id="{F06D4DC5-65FB-4BAD-93E8-86820C87F47D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20" y="3777"/>
              <a:ext cx="2611" cy="979"/>
              <a:chOff x="420" y="3777"/>
              <a:chExt cx="2611" cy="979"/>
            </a:xfrm>
          </p:grpSpPr>
          <p:pic>
            <p:nvPicPr>
              <p:cNvPr id="132" name="Picture 32">
                <a:extLst>
                  <a:ext uri="{FF2B5EF4-FFF2-40B4-BE49-F238E27FC236}">
                    <a16:creationId xmlns:a16="http://schemas.microsoft.com/office/drawing/2014/main" id="{27E7BE67-986F-4C3A-9CFD-A689DE2A3BE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0" y="3785"/>
                <a:ext cx="2611" cy="9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133" name="Group 121">
                <a:extLst>
                  <a:ext uri="{FF2B5EF4-FFF2-40B4-BE49-F238E27FC236}">
                    <a16:creationId xmlns:a16="http://schemas.microsoft.com/office/drawing/2014/main" id="{5A731DFA-E93A-4883-A410-17B87F45240D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2058" y="3778"/>
                <a:ext cx="907" cy="244"/>
                <a:chOff x="2058" y="3778"/>
                <a:chExt cx="907" cy="244"/>
              </a:xfrm>
            </p:grpSpPr>
            <p:sp>
              <p:nvSpPr>
                <p:cNvPr id="152" name="Rectangle 33">
                  <a:extLst>
                    <a:ext uri="{FF2B5EF4-FFF2-40B4-BE49-F238E27FC236}">
                      <a16:creationId xmlns:a16="http://schemas.microsoft.com/office/drawing/2014/main" id="{9C5F0E9B-3233-44C6-9453-696A59294E3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07" y="3861"/>
                  <a:ext cx="60" cy="6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L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3" name="Rectangle 34">
                  <a:extLst>
                    <a:ext uri="{FF2B5EF4-FFF2-40B4-BE49-F238E27FC236}">
                      <a16:creationId xmlns:a16="http://schemas.microsoft.com/office/drawing/2014/main" id="{58997263-E972-4F7F-86DB-AEDDF8FF7EA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58" y="3853"/>
                  <a:ext cx="2" cy="68"/>
                </a:xfrm>
                <a:prstGeom prst="rect">
                  <a:avLst/>
                </a:pr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4" name="Freeform 35">
                  <a:extLst>
                    <a:ext uri="{FF2B5EF4-FFF2-40B4-BE49-F238E27FC236}">
                      <a16:creationId xmlns:a16="http://schemas.microsoft.com/office/drawing/2014/main" id="{864D5BC6-7D11-4BE8-B58A-561A1194706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91" y="3915"/>
                  <a:ext cx="30" cy="25"/>
                </a:xfrm>
                <a:custGeom>
                  <a:avLst/>
                  <a:gdLst>
                    <a:gd name="T0" fmla="*/ 30 w 30"/>
                    <a:gd name="T1" fmla="*/ 2 h 25"/>
                    <a:gd name="T2" fmla="*/ 2 w 30"/>
                    <a:gd name="T3" fmla="*/ 25 h 25"/>
                    <a:gd name="T4" fmla="*/ 0 w 30"/>
                    <a:gd name="T5" fmla="*/ 23 h 25"/>
                    <a:gd name="T6" fmla="*/ 28 w 30"/>
                    <a:gd name="T7" fmla="*/ 0 h 25"/>
                    <a:gd name="T8" fmla="*/ 30 w 30"/>
                    <a:gd name="T9" fmla="*/ 2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5">
                      <a:moveTo>
                        <a:pt x="30" y="2"/>
                      </a:moveTo>
                      <a:lnTo>
                        <a:pt x="2" y="25"/>
                      </a:lnTo>
                      <a:lnTo>
                        <a:pt x="0" y="23"/>
                      </a:lnTo>
                      <a:lnTo>
                        <a:pt x="28" y="0"/>
                      </a:lnTo>
                      <a:lnTo>
                        <a:pt x="30" y="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5" name="Rectangle 36">
                  <a:extLst>
                    <a:ext uri="{FF2B5EF4-FFF2-40B4-BE49-F238E27FC236}">
                      <a16:creationId xmlns:a16="http://schemas.microsoft.com/office/drawing/2014/main" id="{979144AA-0F76-4952-B64C-94E8893F961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53" y="3861"/>
                  <a:ext cx="60" cy="6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K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6" name="Rectangle 37">
                  <a:extLst>
                    <a:ext uri="{FF2B5EF4-FFF2-40B4-BE49-F238E27FC236}">
                      <a16:creationId xmlns:a16="http://schemas.microsoft.com/office/drawing/2014/main" id="{3759041D-BB12-4B12-9C28-FFD85BBB96B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18" y="3850"/>
                  <a:ext cx="3" cy="69"/>
                </a:xfrm>
                <a:prstGeom prst="rect">
                  <a:avLst/>
                </a:pr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7" name="Freeform 38">
                  <a:extLst>
                    <a:ext uri="{FF2B5EF4-FFF2-40B4-BE49-F238E27FC236}">
                      <a16:creationId xmlns:a16="http://schemas.microsoft.com/office/drawing/2014/main" id="{969F65D0-BA59-45D6-A5E9-3E04318B8BA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319" y="3824"/>
                  <a:ext cx="30" cy="25"/>
                </a:xfrm>
                <a:custGeom>
                  <a:avLst/>
                  <a:gdLst>
                    <a:gd name="T0" fmla="*/ 0 w 30"/>
                    <a:gd name="T1" fmla="*/ 23 h 25"/>
                    <a:gd name="T2" fmla="*/ 28 w 30"/>
                    <a:gd name="T3" fmla="*/ 0 h 25"/>
                    <a:gd name="T4" fmla="*/ 30 w 30"/>
                    <a:gd name="T5" fmla="*/ 3 h 25"/>
                    <a:gd name="T6" fmla="*/ 1 w 30"/>
                    <a:gd name="T7" fmla="*/ 25 h 25"/>
                    <a:gd name="T8" fmla="*/ 0 w 30"/>
                    <a:gd name="T9" fmla="*/ 23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5">
                      <a:moveTo>
                        <a:pt x="0" y="23"/>
                      </a:moveTo>
                      <a:lnTo>
                        <a:pt x="28" y="0"/>
                      </a:lnTo>
                      <a:lnTo>
                        <a:pt x="30" y="3"/>
                      </a:lnTo>
                      <a:lnTo>
                        <a:pt x="1" y="25"/>
                      </a:lnTo>
                      <a:lnTo>
                        <a:pt x="0" y="23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8" name="Rectangle 39">
                  <a:extLst>
                    <a:ext uri="{FF2B5EF4-FFF2-40B4-BE49-F238E27FC236}">
                      <a16:creationId xmlns:a16="http://schemas.microsoft.com/office/drawing/2014/main" id="{04C3D471-E816-4487-846B-0D4E0B78FD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78" y="3853"/>
                  <a:ext cx="3" cy="68"/>
                </a:xfrm>
                <a:prstGeom prst="rect">
                  <a:avLst/>
                </a:pr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9" name="Freeform 40">
                  <a:extLst>
                    <a:ext uri="{FF2B5EF4-FFF2-40B4-BE49-F238E27FC236}">
                      <a16:creationId xmlns:a16="http://schemas.microsoft.com/office/drawing/2014/main" id="{9878722C-1D00-49FD-90C5-1B08B1FAAC7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379" y="3827"/>
                  <a:ext cx="29" cy="25"/>
                </a:xfrm>
                <a:custGeom>
                  <a:avLst/>
                  <a:gdLst>
                    <a:gd name="T0" fmla="*/ 0 w 29"/>
                    <a:gd name="T1" fmla="*/ 23 h 25"/>
                    <a:gd name="T2" fmla="*/ 28 w 29"/>
                    <a:gd name="T3" fmla="*/ 0 h 25"/>
                    <a:gd name="T4" fmla="*/ 29 w 29"/>
                    <a:gd name="T5" fmla="*/ 2 h 25"/>
                    <a:gd name="T6" fmla="*/ 2 w 29"/>
                    <a:gd name="T7" fmla="*/ 25 h 25"/>
                    <a:gd name="T8" fmla="*/ 0 w 29"/>
                    <a:gd name="T9" fmla="*/ 23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29" h="25">
                      <a:moveTo>
                        <a:pt x="0" y="23"/>
                      </a:moveTo>
                      <a:lnTo>
                        <a:pt x="28" y="0"/>
                      </a:lnTo>
                      <a:lnTo>
                        <a:pt x="29" y="2"/>
                      </a:lnTo>
                      <a:lnTo>
                        <a:pt x="2" y="25"/>
                      </a:lnTo>
                      <a:lnTo>
                        <a:pt x="0" y="23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0" name="Rectangle 41">
                  <a:extLst>
                    <a:ext uri="{FF2B5EF4-FFF2-40B4-BE49-F238E27FC236}">
                      <a16:creationId xmlns:a16="http://schemas.microsoft.com/office/drawing/2014/main" id="{E0D3C096-3991-4398-AC4A-DA3232C243A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79" y="3861"/>
                  <a:ext cx="61" cy="6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E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1" name="Rectangle 42">
                  <a:extLst>
                    <a:ext uri="{FF2B5EF4-FFF2-40B4-BE49-F238E27FC236}">
                      <a16:creationId xmlns:a16="http://schemas.microsoft.com/office/drawing/2014/main" id="{EE5C0A74-1914-4BF5-9F20-77F3A3858A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39" y="3850"/>
                  <a:ext cx="2" cy="68"/>
                </a:xfrm>
                <a:prstGeom prst="rect">
                  <a:avLst/>
                </a:pr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2" name="Freeform 43">
                  <a:extLst>
                    <a:ext uri="{FF2B5EF4-FFF2-40B4-BE49-F238E27FC236}">
                      <a16:creationId xmlns:a16="http://schemas.microsoft.com/office/drawing/2014/main" id="{717B0B16-B115-41C2-9394-07C700E358A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439" y="3824"/>
                  <a:ext cx="30" cy="26"/>
                </a:xfrm>
                <a:custGeom>
                  <a:avLst/>
                  <a:gdLst>
                    <a:gd name="T0" fmla="*/ 0 w 30"/>
                    <a:gd name="T1" fmla="*/ 24 h 26"/>
                    <a:gd name="T2" fmla="*/ 29 w 30"/>
                    <a:gd name="T3" fmla="*/ 0 h 26"/>
                    <a:gd name="T4" fmla="*/ 30 w 30"/>
                    <a:gd name="T5" fmla="*/ 3 h 26"/>
                    <a:gd name="T6" fmla="*/ 2 w 30"/>
                    <a:gd name="T7" fmla="*/ 26 h 26"/>
                    <a:gd name="T8" fmla="*/ 0 w 30"/>
                    <a:gd name="T9" fmla="*/ 24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6">
                      <a:moveTo>
                        <a:pt x="0" y="24"/>
                      </a:moveTo>
                      <a:lnTo>
                        <a:pt x="29" y="0"/>
                      </a:lnTo>
                      <a:lnTo>
                        <a:pt x="30" y="3"/>
                      </a:lnTo>
                      <a:lnTo>
                        <a:pt x="2" y="26"/>
                      </a:lnTo>
                      <a:lnTo>
                        <a:pt x="0" y="24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3" name="Rectangle 44">
                  <a:extLst>
                    <a:ext uri="{FF2B5EF4-FFF2-40B4-BE49-F238E27FC236}">
                      <a16:creationId xmlns:a16="http://schemas.microsoft.com/office/drawing/2014/main" id="{591B0E08-E61E-42D2-B017-B4196088B60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33" y="3862"/>
                  <a:ext cx="61" cy="6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N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4" name="Rectangle 45">
                  <a:extLst>
                    <a:ext uri="{FF2B5EF4-FFF2-40B4-BE49-F238E27FC236}">
                      <a16:creationId xmlns:a16="http://schemas.microsoft.com/office/drawing/2014/main" id="{AE6CBE4A-D48E-493F-80E6-434DDA4B8BE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04" y="3853"/>
                  <a:ext cx="3" cy="68"/>
                </a:xfrm>
                <a:prstGeom prst="rect">
                  <a:avLst/>
                </a:pr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5" name="Freeform 46">
                  <a:extLst>
                    <a:ext uri="{FF2B5EF4-FFF2-40B4-BE49-F238E27FC236}">
                      <a16:creationId xmlns:a16="http://schemas.microsoft.com/office/drawing/2014/main" id="{F99FC90E-8E8E-4BD0-8392-64D2EC9E806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505" y="3830"/>
                  <a:ext cx="30" cy="25"/>
                </a:xfrm>
                <a:custGeom>
                  <a:avLst/>
                  <a:gdLst>
                    <a:gd name="T0" fmla="*/ 0 w 30"/>
                    <a:gd name="T1" fmla="*/ 23 h 25"/>
                    <a:gd name="T2" fmla="*/ 28 w 30"/>
                    <a:gd name="T3" fmla="*/ 0 h 25"/>
                    <a:gd name="T4" fmla="*/ 30 w 30"/>
                    <a:gd name="T5" fmla="*/ 2 h 25"/>
                    <a:gd name="T6" fmla="*/ 2 w 30"/>
                    <a:gd name="T7" fmla="*/ 25 h 25"/>
                    <a:gd name="T8" fmla="*/ 0 w 30"/>
                    <a:gd name="T9" fmla="*/ 23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5">
                      <a:moveTo>
                        <a:pt x="0" y="23"/>
                      </a:moveTo>
                      <a:lnTo>
                        <a:pt x="28" y="0"/>
                      </a:lnTo>
                      <a:lnTo>
                        <a:pt x="30" y="2"/>
                      </a:lnTo>
                      <a:lnTo>
                        <a:pt x="2" y="25"/>
                      </a:lnTo>
                      <a:lnTo>
                        <a:pt x="0" y="23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6" name="Rectangle 47">
                  <a:extLst>
                    <a:ext uri="{FF2B5EF4-FFF2-40B4-BE49-F238E27FC236}">
                      <a16:creationId xmlns:a16="http://schemas.microsoft.com/office/drawing/2014/main" id="{FDEAC6F9-711D-4AD9-814A-42A4FB79385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95" y="3862"/>
                  <a:ext cx="61" cy="6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t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7" name="Rectangle 48">
                  <a:extLst>
                    <a:ext uri="{FF2B5EF4-FFF2-40B4-BE49-F238E27FC236}">
                      <a16:creationId xmlns:a16="http://schemas.microsoft.com/office/drawing/2014/main" id="{AD37FE66-E68C-4851-8DE7-AF93922C287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65" y="3850"/>
                  <a:ext cx="3" cy="68"/>
                </a:xfrm>
                <a:prstGeom prst="rect">
                  <a:avLst/>
                </a:pr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8" name="Freeform 49">
                  <a:extLst>
                    <a:ext uri="{FF2B5EF4-FFF2-40B4-BE49-F238E27FC236}">
                      <a16:creationId xmlns:a16="http://schemas.microsoft.com/office/drawing/2014/main" id="{588908CC-2EB7-4476-974A-901CE1E69B2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565" y="3824"/>
                  <a:ext cx="30" cy="26"/>
                </a:xfrm>
                <a:custGeom>
                  <a:avLst/>
                  <a:gdLst>
                    <a:gd name="T0" fmla="*/ 0 w 30"/>
                    <a:gd name="T1" fmla="*/ 24 h 26"/>
                    <a:gd name="T2" fmla="*/ 28 w 30"/>
                    <a:gd name="T3" fmla="*/ 0 h 26"/>
                    <a:gd name="T4" fmla="*/ 30 w 30"/>
                    <a:gd name="T5" fmla="*/ 3 h 26"/>
                    <a:gd name="T6" fmla="*/ 2 w 30"/>
                    <a:gd name="T7" fmla="*/ 26 h 26"/>
                    <a:gd name="T8" fmla="*/ 0 w 30"/>
                    <a:gd name="T9" fmla="*/ 24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6">
                      <a:moveTo>
                        <a:pt x="0" y="24"/>
                      </a:moveTo>
                      <a:lnTo>
                        <a:pt x="28" y="0"/>
                      </a:lnTo>
                      <a:lnTo>
                        <a:pt x="30" y="3"/>
                      </a:lnTo>
                      <a:lnTo>
                        <a:pt x="2" y="26"/>
                      </a:lnTo>
                      <a:lnTo>
                        <a:pt x="0" y="24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9" name="Rectangle 50">
                  <a:extLst>
                    <a:ext uri="{FF2B5EF4-FFF2-40B4-BE49-F238E27FC236}">
                      <a16:creationId xmlns:a16="http://schemas.microsoft.com/office/drawing/2014/main" id="{B56333AC-0B37-4AD6-9E18-D08AD34F44C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58" y="3862"/>
                  <a:ext cx="60" cy="6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L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0" name="Rectangle 51">
                  <a:extLst>
                    <a:ext uri="{FF2B5EF4-FFF2-40B4-BE49-F238E27FC236}">
                      <a16:creationId xmlns:a16="http://schemas.microsoft.com/office/drawing/2014/main" id="{F5ACAD24-BF34-4BF4-8DE6-347630A9A80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25" y="3862"/>
                  <a:ext cx="60" cy="6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L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1" name="Rectangle 52">
                  <a:extLst>
                    <a:ext uri="{FF2B5EF4-FFF2-40B4-BE49-F238E27FC236}">
                      <a16:creationId xmlns:a16="http://schemas.microsoft.com/office/drawing/2014/main" id="{5FD3CE0D-0586-4504-A255-7DF8EEDA696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79" y="3862"/>
                  <a:ext cx="61" cy="6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D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2" name="Rectangle 53">
                  <a:extLst>
                    <a:ext uri="{FF2B5EF4-FFF2-40B4-BE49-F238E27FC236}">
                      <a16:creationId xmlns:a16="http://schemas.microsoft.com/office/drawing/2014/main" id="{A6DD951E-46AF-45CC-8FAE-10F03678C09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46" y="3862"/>
                  <a:ext cx="60" cy="6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G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3" name="Rectangle 54">
                  <a:extLst>
                    <a:ext uri="{FF2B5EF4-FFF2-40B4-BE49-F238E27FC236}">
                      <a16:creationId xmlns:a16="http://schemas.microsoft.com/office/drawing/2014/main" id="{CD3CE672-D202-4AF5-BA62-34F9DC2D459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04" y="3862"/>
                  <a:ext cx="60" cy="6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S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4" name="Rectangle 55">
                  <a:extLst>
                    <a:ext uri="{FF2B5EF4-FFF2-40B4-BE49-F238E27FC236}">
                      <a16:creationId xmlns:a16="http://schemas.microsoft.com/office/drawing/2014/main" id="{96CE2F02-D17A-4947-9488-21C0FCB0FFE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59" y="3862"/>
                  <a:ext cx="60" cy="6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P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5" name="Rectangle 56">
                  <a:extLst>
                    <a:ext uri="{FF2B5EF4-FFF2-40B4-BE49-F238E27FC236}">
                      <a16:creationId xmlns:a16="http://schemas.microsoft.com/office/drawing/2014/main" id="{19B1EFFE-01B0-4019-8F0B-4885FC1AEC1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15" y="3861"/>
                  <a:ext cx="60" cy="6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L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6" name="Rectangle 57">
                  <a:extLst>
                    <a:ext uri="{FF2B5EF4-FFF2-40B4-BE49-F238E27FC236}">
                      <a16:creationId xmlns:a16="http://schemas.microsoft.com/office/drawing/2014/main" id="{6A233C9B-D442-46D7-882C-FE09C9010AA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92" y="3855"/>
                  <a:ext cx="2" cy="69"/>
                </a:xfrm>
                <a:prstGeom prst="rect">
                  <a:avLst/>
                </a:pr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7" name="Rectangle 58">
                  <a:extLst>
                    <a:ext uri="{FF2B5EF4-FFF2-40B4-BE49-F238E27FC236}">
                      <a16:creationId xmlns:a16="http://schemas.microsoft.com/office/drawing/2014/main" id="{0EBE7196-E0CD-48EE-B2EF-DF11D451D90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43" y="3943"/>
                  <a:ext cx="60" cy="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b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8" name="Rectangle 59">
                  <a:extLst>
                    <a:ext uri="{FF2B5EF4-FFF2-40B4-BE49-F238E27FC236}">
                      <a16:creationId xmlns:a16="http://schemas.microsoft.com/office/drawing/2014/main" id="{F4EB2611-0153-4818-871E-3082376DDF9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70" y="3962"/>
                  <a:ext cx="60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3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9" name="Rectangle 60">
                  <a:extLst>
                    <a:ext uri="{FF2B5EF4-FFF2-40B4-BE49-F238E27FC236}">
                      <a16:creationId xmlns:a16="http://schemas.microsoft.com/office/drawing/2014/main" id="{FA687AFC-82B0-415A-A0EC-BAD2DE573F8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06" y="3944"/>
                  <a:ext cx="60" cy="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b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0" name="Rectangle 61">
                  <a:extLst>
                    <a:ext uri="{FF2B5EF4-FFF2-40B4-BE49-F238E27FC236}">
                      <a16:creationId xmlns:a16="http://schemas.microsoft.com/office/drawing/2014/main" id="{DFC47E89-861B-41DF-90A6-E5475D2E742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33" y="3964"/>
                  <a:ext cx="60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4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1" name="Rectangle 62">
                  <a:extLst>
                    <a:ext uri="{FF2B5EF4-FFF2-40B4-BE49-F238E27FC236}">
                      <a16:creationId xmlns:a16="http://schemas.microsoft.com/office/drawing/2014/main" id="{ECC01F11-AAD4-4E03-A316-1A6CA762D53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92" y="3944"/>
                  <a:ext cx="61" cy="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b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2" name="Rectangle 63">
                  <a:extLst>
                    <a:ext uri="{FF2B5EF4-FFF2-40B4-BE49-F238E27FC236}">
                      <a16:creationId xmlns:a16="http://schemas.microsoft.com/office/drawing/2014/main" id="{CECD66A9-647F-4966-85FF-BDAA3DF0EB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20" y="3964"/>
                  <a:ext cx="61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7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3" name="Rectangle 64">
                  <a:extLst>
                    <a:ext uri="{FF2B5EF4-FFF2-40B4-BE49-F238E27FC236}">
                      <a16:creationId xmlns:a16="http://schemas.microsoft.com/office/drawing/2014/main" id="{37F1F7BD-269B-45ED-8D24-E2187104FA5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71" y="3778"/>
                  <a:ext cx="60" cy="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y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4" name="Rectangle 65">
                  <a:extLst>
                    <a:ext uri="{FF2B5EF4-FFF2-40B4-BE49-F238E27FC236}">
                      <a16:creationId xmlns:a16="http://schemas.microsoft.com/office/drawing/2014/main" id="{30F24FD5-4B9D-4EAC-B122-37823087633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99" y="3798"/>
                  <a:ext cx="38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2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5" name="Rectangle 66">
                  <a:extLst>
                    <a:ext uri="{FF2B5EF4-FFF2-40B4-BE49-F238E27FC236}">
                      <a16:creationId xmlns:a16="http://schemas.microsoft.com/office/drawing/2014/main" id="{F2614885-E8E5-40FF-88F5-0CB6F4078AC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09" y="3778"/>
                  <a:ext cx="61" cy="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y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6" name="Rectangle 67">
                  <a:extLst>
                    <a:ext uri="{FF2B5EF4-FFF2-40B4-BE49-F238E27FC236}">
                      <a16:creationId xmlns:a16="http://schemas.microsoft.com/office/drawing/2014/main" id="{AA30065D-5B4F-4ED7-B938-CB3C95AC3EA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37" y="3798"/>
                  <a:ext cx="61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3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7" name="Rectangle 68">
                  <a:extLst>
                    <a:ext uri="{FF2B5EF4-FFF2-40B4-BE49-F238E27FC236}">
                      <a16:creationId xmlns:a16="http://schemas.microsoft.com/office/drawing/2014/main" id="{54CB8C30-CF29-43E1-AECD-E5FB8F22D0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54" y="3778"/>
                  <a:ext cx="61" cy="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y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8" name="Rectangle 69">
                  <a:extLst>
                    <a:ext uri="{FF2B5EF4-FFF2-40B4-BE49-F238E27FC236}">
                      <a16:creationId xmlns:a16="http://schemas.microsoft.com/office/drawing/2014/main" id="{D0F1C255-BF98-4B35-9BFF-4FD86483993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82" y="3798"/>
                  <a:ext cx="61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4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9" name="Rectangle 70">
                  <a:extLst>
                    <a:ext uri="{FF2B5EF4-FFF2-40B4-BE49-F238E27FC236}">
                      <a16:creationId xmlns:a16="http://schemas.microsoft.com/office/drawing/2014/main" id="{07A3EABB-301C-4D70-BD0D-1586ED4B2F6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01" y="3778"/>
                  <a:ext cx="60" cy="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y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0" name="Rectangle 71">
                  <a:extLst>
                    <a:ext uri="{FF2B5EF4-FFF2-40B4-BE49-F238E27FC236}">
                      <a16:creationId xmlns:a16="http://schemas.microsoft.com/office/drawing/2014/main" id="{D7A55A72-F8D6-4611-B285-36F563903C5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28" y="3798"/>
                  <a:ext cx="38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5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1" name="Rectangle 72">
                  <a:extLst>
                    <a:ext uri="{FF2B5EF4-FFF2-40B4-BE49-F238E27FC236}">
                      <a16:creationId xmlns:a16="http://schemas.microsoft.com/office/drawing/2014/main" id="{F916494E-6263-47A0-9056-B6CF6EA1CDF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34" y="3778"/>
                  <a:ext cx="60" cy="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y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2" name="Rectangle 73">
                  <a:extLst>
                    <a:ext uri="{FF2B5EF4-FFF2-40B4-BE49-F238E27FC236}">
                      <a16:creationId xmlns:a16="http://schemas.microsoft.com/office/drawing/2014/main" id="{2791E0FA-3F15-49C3-A820-6D34156C3D8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61" y="3798"/>
                  <a:ext cx="60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6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3" name="Rectangle 74">
                  <a:extLst>
                    <a:ext uri="{FF2B5EF4-FFF2-40B4-BE49-F238E27FC236}">
                      <a16:creationId xmlns:a16="http://schemas.microsoft.com/office/drawing/2014/main" id="{71DD1242-3E53-497C-8FB5-E0792DF574D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79" y="3778"/>
                  <a:ext cx="60" cy="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y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4" name="Rectangle 75">
                  <a:extLst>
                    <a:ext uri="{FF2B5EF4-FFF2-40B4-BE49-F238E27FC236}">
                      <a16:creationId xmlns:a16="http://schemas.microsoft.com/office/drawing/2014/main" id="{73212386-7A6C-4CC6-9618-615A5431BF1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06" y="3798"/>
                  <a:ext cx="60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7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5" name="Freeform 76">
                  <a:extLst>
                    <a:ext uri="{FF2B5EF4-FFF2-40B4-BE49-F238E27FC236}">
                      <a16:creationId xmlns:a16="http://schemas.microsoft.com/office/drawing/2014/main" id="{BF88A855-7EED-47D5-9855-2981D188312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351" y="3917"/>
                  <a:ext cx="30" cy="25"/>
                </a:xfrm>
                <a:custGeom>
                  <a:avLst/>
                  <a:gdLst>
                    <a:gd name="T0" fmla="*/ 30 w 30"/>
                    <a:gd name="T1" fmla="*/ 3 h 25"/>
                    <a:gd name="T2" fmla="*/ 2 w 30"/>
                    <a:gd name="T3" fmla="*/ 25 h 25"/>
                    <a:gd name="T4" fmla="*/ 0 w 30"/>
                    <a:gd name="T5" fmla="*/ 23 h 25"/>
                    <a:gd name="T6" fmla="*/ 28 w 30"/>
                    <a:gd name="T7" fmla="*/ 0 h 25"/>
                    <a:gd name="T8" fmla="*/ 30 w 30"/>
                    <a:gd name="T9" fmla="*/ 3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5">
                      <a:moveTo>
                        <a:pt x="30" y="3"/>
                      </a:moveTo>
                      <a:lnTo>
                        <a:pt x="2" y="25"/>
                      </a:lnTo>
                      <a:lnTo>
                        <a:pt x="0" y="23"/>
                      </a:lnTo>
                      <a:lnTo>
                        <a:pt x="28" y="0"/>
                      </a:lnTo>
                      <a:lnTo>
                        <a:pt x="30" y="3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96" name="Freeform 77">
                  <a:extLst>
                    <a:ext uri="{FF2B5EF4-FFF2-40B4-BE49-F238E27FC236}">
                      <a16:creationId xmlns:a16="http://schemas.microsoft.com/office/drawing/2014/main" id="{24B8706F-2ED2-4552-9F12-4A64CDCF54E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412" y="3915"/>
                  <a:ext cx="29" cy="25"/>
                </a:xfrm>
                <a:custGeom>
                  <a:avLst/>
                  <a:gdLst>
                    <a:gd name="T0" fmla="*/ 29 w 29"/>
                    <a:gd name="T1" fmla="*/ 2 h 25"/>
                    <a:gd name="T2" fmla="*/ 2 w 29"/>
                    <a:gd name="T3" fmla="*/ 25 h 25"/>
                    <a:gd name="T4" fmla="*/ 0 w 29"/>
                    <a:gd name="T5" fmla="*/ 23 h 25"/>
                    <a:gd name="T6" fmla="*/ 28 w 29"/>
                    <a:gd name="T7" fmla="*/ 0 h 25"/>
                    <a:gd name="T8" fmla="*/ 29 w 29"/>
                    <a:gd name="T9" fmla="*/ 2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29" h="25">
                      <a:moveTo>
                        <a:pt x="29" y="2"/>
                      </a:moveTo>
                      <a:lnTo>
                        <a:pt x="2" y="25"/>
                      </a:lnTo>
                      <a:lnTo>
                        <a:pt x="0" y="23"/>
                      </a:lnTo>
                      <a:lnTo>
                        <a:pt x="28" y="0"/>
                      </a:lnTo>
                      <a:lnTo>
                        <a:pt x="29" y="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97" name="Rectangle 78">
                  <a:extLst>
                    <a:ext uri="{FF2B5EF4-FFF2-40B4-BE49-F238E27FC236}">
                      <a16:creationId xmlns:a16="http://schemas.microsoft.com/office/drawing/2014/main" id="{A86059E5-A608-4508-8BD5-F3098F8CE69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66" y="3943"/>
                  <a:ext cx="60" cy="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b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8" name="Rectangle 79">
                  <a:extLst>
                    <a:ext uri="{FF2B5EF4-FFF2-40B4-BE49-F238E27FC236}">
                      <a16:creationId xmlns:a16="http://schemas.microsoft.com/office/drawing/2014/main" id="{C47CCB0C-42AF-4E08-BF00-F334BA8ABE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93" y="3962"/>
                  <a:ext cx="60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5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9" name="Rectangle 80">
                  <a:extLst>
                    <a:ext uri="{FF2B5EF4-FFF2-40B4-BE49-F238E27FC236}">
                      <a16:creationId xmlns:a16="http://schemas.microsoft.com/office/drawing/2014/main" id="{0EB645DF-508A-40E8-9491-FD89494903B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26" y="3943"/>
                  <a:ext cx="61" cy="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b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0" name="Rectangle 81">
                  <a:extLst>
                    <a:ext uri="{FF2B5EF4-FFF2-40B4-BE49-F238E27FC236}">
                      <a16:creationId xmlns:a16="http://schemas.microsoft.com/office/drawing/2014/main" id="{5FEC00DA-F11C-43EB-ADAC-0A7179B1017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54" y="3961"/>
                  <a:ext cx="61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6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1" name="Rectangle 82">
                  <a:extLst>
                    <a:ext uri="{FF2B5EF4-FFF2-40B4-BE49-F238E27FC236}">
                      <a16:creationId xmlns:a16="http://schemas.microsoft.com/office/drawing/2014/main" id="{D24D6EF7-841C-4C6B-93F3-F2405B1863D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22" y="3853"/>
                  <a:ext cx="3" cy="68"/>
                </a:xfrm>
                <a:prstGeom prst="rect">
                  <a:avLst/>
                </a:pr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2" name="Freeform 83">
                  <a:extLst>
                    <a:ext uri="{FF2B5EF4-FFF2-40B4-BE49-F238E27FC236}">
                      <a16:creationId xmlns:a16="http://schemas.microsoft.com/office/drawing/2014/main" id="{81D75D46-5FFD-481A-9317-321CDE1E609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623" y="3827"/>
                  <a:ext cx="30" cy="26"/>
                </a:xfrm>
                <a:custGeom>
                  <a:avLst/>
                  <a:gdLst>
                    <a:gd name="T0" fmla="*/ 0 w 30"/>
                    <a:gd name="T1" fmla="*/ 23 h 26"/>
                    <a:gd name="T2" fmla="*/ 28 w 30"/>
                    <a:gd name="T3" fmla="*/ 0 h 26"/>
                    <a:gd name="T4" fmla="*/ 30 w 30"/>
                    <a:gd name="T5" fmla="*/ 2 h 26"/>
                    <a:gd name="T6" fmla="*/ 2 w 30"/>
                    <a:gd name="T7" fmla="*/ 26 h 26"/>
                    <a:gd name="T8" fmla="*/ 0 w 30"/>
                    <a:gd name="T9" fmla="*/ 23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6">
                      <a:moveTo>
                        <a:pt x="0" y="23"/>
                      </a:moveTo>
                      <a:lnTo>
                        <a:pt x="28" y="0"/>
                      </a:lnTo>
                      <a:lnTo>
                        <a:pt x="30" y="2"/>
                      </a:lnTo>
                      <a:lnTo>
                        <a:pt x="2" y="26"/>
                      </a:lnTo>
                      <a:lnTo>
                        <a:pt x="0" y="23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3" name="Freeform 84">
                  <a:extLst>
                    <a:ext uri="{FF2B5EF4-FFF2-40B4-BE49-F238E27FC236}">
                      <a16:creationId xmlns:a16="http://schemas.microsoft.com/office/drawing/2014/main" id="{76FE6D46-847C-4A33-BBF6-F44461FFAFF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538" y="3920"/>
                  <a:ext cx="30" cy="26"/>
                </a:xfrm>
                <a:custGeom>
                  <a:avLst/>
                  <a:gdLst>
                    <a:gd name="T0" fmla="*/ 30 w 30"/>
                    <a:gd name="T1" fmla="*/ 2 h 26"/>
                    <a:gd name="T2" fmla="*/ 2 w 30"/>
                    <a:gd name="T3" fmla="*/ 26 h 26"/>
                    <a:gd name="T4" fmla="*/ 0 w 30"/>
                    <a:gd name="T5" fmla="*/ 23 h 26"/>
                    <a:gd name="T6" fmla="*/ 28 w 30"/>
                    <a:gd name="T7" fmla="*/ 0 h 26"/>
                    <a:gd name="T8" fmla="*/ 30 w 30"/>
                    <a:gd name="T9" fmla="*/ 2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6">
                      <a:moveTo>
                        <a:pt x="30" y="2"/>
                      </a:moveTo>
                      <a:lnTo>
                        <a:pt x="2" y="26"/>
                      </a:lnTo>
                      <a:lnTo>
                        <a:pt x="0" y="23"/>
                      </a:lnTo>
                      <a:lnTo>
                        <a:pt x="28" y="0"/>
                      </a:lnTo>
                      <a:lnTo>
                        <a:pt x="30" y="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4" name="Freeform 85">
                  <a:extLst>
                    <a:ext uri="{FF2B5EF4-FFF2-40B4-BE49-F238E27FC236}">
                      <a16:creationId xmlns:a16="http://schemas.microsoft.com/office/drawing/2014/main" id="{174662D7-88AD-47EB-BF40-C6CFF8E9F76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596" y="3923"/>
                  <a:ext cx="30" cy="25"/>
                </a:xfrm>
                <a:custGeom>
                  <a:avLst/>
                  <a:gdLst>
                    <a:gd name="T0" fmla="*/ 30 w 30"/>
                    <a:gd name="T1" fmla="*/ 2 h 25"/>
                    <a:gd name="T2" fmla="*/ 1 w 30"/>
                    <a:gd name="T3" fmla="*/ 25 h 25"/>
                    <a:gd name="T4" fmla="*/ 0 w 30"/>
                    <a:gd name="T5" fmla="*/ 23 h 25"/>
                    <a:gd name="T6" fmla="*/ 28 w 30"/>
                    <a:gd name="T7" fmla="*/ 0 h 25"/>
                    <a:gd name="T8" fmla="*/ 30 w 30"/>
                    <a:gd name="T9" fmla="*/ 2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5">
                      <a:moveTo>
                        <a:pt x="30" y="2"/>
                      </a:moveTo>
                      <a:lnTo>
                        <a:pt x="1" y="25"/>
                      </a:lnTo>
                      <a:lnTo>
                        <a:pt x="0" y="23"/>
                      </a:lnTo>
                      <a:lnTo>
                        <a:pt x="28" y="0"/>
                      </a:lnTo>
                      <a:lnTo>
                        <a:pt x="30" y="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5" name="Rectangle 86">
                  <a:extLst>
                    <a:ext uri="{FF2B5EF4-FFF2-40B4-BE49-F238E27FC236}">
                      <a16:creationId xmlns:a16="http://schemas.microsoft.com/office/drawing/2014/main" id="{8B8A48AB-BD6C-4C02-9734-965A0CF280C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86" y="3855"/>
                  <a:ext cx="2" cy="69"/>
                </a:xfrm>
                <a:prstGeom prst="rect">
                  <a:avLst/>
                </a:pr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6" name="Freeform 87">
                  <a:extLst>
                    <a:ext uri="{FF2B5EF4-FFF2-40B4-BE49-F238E27FC236}">
                      <a16:creationId xmlns:a16="http://schemas.microsoft.com/office/drawing/2014/main" id="{BB85C531-985F-44E8-B75C-FBD75E34248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686" y="3830"/>
                  <a:ext cx="30" cy="25"/>
                </a:xfrm>
                <a:custGeom>
                  <a:avLst/>
                  <a:gdLst>
                    <a:gd name="T0" fmla="*/ 0 w 30"/>
                    <a:gd name="T1" fmla="*/ 23 h 25"/>
                    <a:gd name="T2" fmla="*/ 28 w 30"/>
                    <a:gd name="T3" fmla="*/ 0 h 25"/>
                    <a:gd name="T4" fmla="*/ 30 w 30"/>
                    <a:gd name="T5" fmla="*/ 2 h 25"/>
                    <a:gd name="T6" fmla="*/ 2 w 30"/>
                    <a:gd name="T7" fmla="*/ 25 h 25"/>
                    <a:gd name="T8" fmla="*/ 0 w 30"/>
                    <a:gd name="T9" fmla="*/ 23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5">
                      <a:moveTo>
                        <a:pt x="0" y="23"/>
                      </a:moveTo>
                      <a:lnTo>
                        <a:pt x="28" y="0"/>
                      </a:lnTo>
                      <a:lnTo>
                        <a:pt x="30" y="2"/>
                      </a:lnTo>
                      <a:lnTo>
                        <a:pt x="2" y="25"/>
                      </a:lnTo>
                      <a:lnTo>
                        <a:pt x="0" y="23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7" name="Freeform 88">
                  <a:extLst>
                    <a:ext uri="{FF2B5EF4-FFF2-40B4-BE49-F238E27FC236}">
                      <a16:creationId xmlns:a16="http://schemas.microsoft.com/office/drawing/2014/main" id="{42E60537-17B9-40E8-AFB2-1DD062C1737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659" y="3926"/>
                  <a:ext cx="30" cy="25"/>
                </a:xfrm>
                <a:custGeom>
                  <a:avLst/>
                  <a:gdLst>
                    <a:gd name="T0" fmla="*/ 30 w 30"/>
                    <a:gd name="T1" fmla="*/ 2 h 25"/>
                    <a:gd name="T2" fmla="*/ 2 w 30"/>
                    <a:gd name="T3" fmla="*/ 25 h 25"/>
                    <a:gd name="T4" fmla="*/ 0 w 30"/>
                    <a:gd name="T5" fmla="*/ 23 h 25"/>
                    <a:gd name="T6" fmla="*/ 28 w 30"/>
                    <a:gd name="T7" fmla="*/ 0 h 25"/>
                    <a:gd name="T8" fmla="*/ 30 w 30"/>
                    <a:gd name="T9" fmla="*/ 2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5">
                      <a:moveTo>
                        <a:pt x="30" y="2"/>
                      </a:moveTo>
                      <a:lnTo>
                        <a:pt x="2" y="25"/>
                      </a:lnTo>
                      <a:lnTo>
                        <a:pt x="0" y="23"/>
                      </a:lnTo>
                      <a:lnTo>
                        <a:pt x="28" y="0"/>
                      </a:lnTo>
                      <a:lnTo>
                        <a:pt x="30" y="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8" name="Freeform 89">
                  <a:extLst>
                    <a:ext uri="{FF2B5EF4-FFF2-40B4-BE49-F238E27FC236}">
                      <a16:creationId xmlns:a16="http://schemas.microsoft.com/office/drawing/2014/main" id="{7DF483AF-A50D-48CE-9A46-F7AD6E71ED5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31" y="3920"/>
                  <a:ext cx="30" cy="26"/>
                </a:xfrm>
                <a:custGeom>
                  <a:avLst/>
                  <a:gdLst>
                    <a:gd name="T0" fmla="*/ 30 w 30"/>
                    <a:gd name="T1" fmla="*/ 2 h 26"/>
                    <a:gd name="T2" fmla="*/ 1 w 30"/>
                    <a:gd name="T3" fmla="*/ 26 h 26"/>
                    <a:gd name="T4" fmla="*/ 0 w 30"/>
                    <a:gd name="T5" fmla="*/ 23 h 26"/>
                    <a:gd name="T6" fmla="*/ 28 w 30"/>
                    <a:gd name="T7" fmla="*/ 0 h 26"/>
                    <a:gd name="T8" fmla="*/ 30 w 30"/>
                    <a:gd name="T9" fmla="*/ 2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6">
                      <a:moveTo>
                        <a:pt x="30" y="2"/>
                      </a:moveTo>
                      <a:lnTo>
                        <a:pt x="1" y="26"/>
                      </a:lnTo>
                      <a:lnTo>
                        <a:pt x="0" y="23"/>
                      </a:lnTo>
                      <a:lnTo>
                        <a:pt x="28" y="0"/>
                      </a:lnTo>
                      <a:lnTo>
                        <a:pt x="30" y="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9" name="Rectangle 90">
                  <a:extLst>
                    <a:ext uri="{FF2B5EF4-FFF2-40B4-BE49-F238E27FC236}">
                      <a16:creationId xmlns:a16="http://schemas.microsoft.com/office/drawing/2014/main" id="{D88034E5-563E-4682-B429-1B43E773D01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21" y="3779"/>
                  <a:ext cx="61" cy="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y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0" name="Rectangle 91">
                  <a:extLst>
                    <a:ext uri="{FF2B5EF4-FFF2-40B4-BE49-F238E27FC236}">
                      <a16:creationId xmlns:a16="http://schemas.microsoft.com/office/drawing/2014/main" id="{9A35D65E-58CE-4C93-B280-D568B71CF1B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49" y="3798"/>
                  <a:ext cx="61" cy="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8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1" name="Rectangle 92">
                  <a:extLst>
                    <a:ext uri="{FF2B5EF4-FFF2-40B4-BE49-F238E27FC236}">
                      <a16:creationId xmlns:a16="http://schemas.microsoft.com/office/drawing/2014/main" id="{FE4D5C95-AF66-4053-819E-DED9F5E2AA2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61" y="3779"/>
                  <a:ext cx="60" cy="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y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2" name="Rectangle 93">
                  <a:extLst>
                    <a:ext uri="{FF2B5EF4-FFF2-40B4-BE49-F238E27FC236}">
                      <a16:creationId xmlns:a16="http://schemas.microsoft.com/office/drawing/2014/main" id="{7A2D4156-6D2F-4D25-9996-28575E0C466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88" y="3798"/>
                  <a:ext cx="60" cy="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9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3" name="Rectangle 94">
                  <a:extLst>
                    <a:ext uri="{FF2B5EF4-FFF2-40B4-BE49-F238E27FC236}">
                      <a16:creationId xmlns:a16="http://schemas.microsoft.com/office/drawing/2014/main" id="{F0BB13C8-F205-4B87-9A34-D8292D74FEF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91" y="3779"/>
                  <a:ext cx="61" cy="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y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4" name="Rectangle 95">
                  <a:extLst>
                    <a:ext uri="{FF2B5EF4-FFF2-40B4-BE49-F238E27FC236}">
                      <a16:creationId xmlns:a16="http://schemas.microsoft.com/office/drawing/2014/main" id="{8C851960-18FC-4370-A56B-729256BFBD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19" y="3798"/>
                  <a:ext cx="80" cy="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10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5" name="Rectangle 96">
                  <a:extLst>
                    <a:ext uri="{FF2B5EF4-FFF2-40B4-BE49-F238E27FC236}">
                      <a16:creationId xmlns:a16="http://schemas.microsoft.com/office/drawing/2014/main" id="{BD017B8C-937E-44E4-88D5-DE78E408626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08" y="3953"/>
                  <a:ext cx="60" cy="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b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6" name="Rectangle 97">
                  <a:extLst>
                    <a:ext uri="{FF2B5EF4-FFF2-40B4-BE49-F238E27FC236}">
                      <a16:creationId xmlns:a16="http://schemas.microsoft.com/office/drawing/2014/main" id="{8590E36D-3462-4593-9F92-BEF798FC33F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35" y="3972"/>
                  <a:ext cx="60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9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7" name="Rectangle 98">
                  <a:extLst>
                    <a:ext uri="{FF2B5EF4-FFF2-40B4-BE49-F238E27FC236}">
                      <a16:creationId xmlns:a16="http://schemas.microsoft.com/office/drawing/2014/main" id="{9350D0F0-63F5-48A7-B302-A8999EC192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65" y="3957"/>
                  <a:ext cx="60" cy="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b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8" name="Rectangle 99">
                  <a:extLst>
                    <a:ext uri="{FF2B5EF4-FFF2-40B4-BE49-F238E27FC236}">
                      <a16:creationId xmlns:a16="http://schemas.microsoft.com/office/drawing/2014/main" id="{618B5015-7C6C-4F99-95AD-E4FBFECC375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93" y="3976"/>
                  <a:ext cx="80" cy="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10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9" name="Rectangle 100">
                  <a:extLst>
                    <a:ext uri="{FF2B5EF4-FFF2-40B4-BE49-F238E27FC236}">
                      <a16:creationId xmlns:a16="http://schemas.microsoft.com/office/drawing/2014/main" id="{00599D5E-BEA3-49A9-A5F0-97B75A40D95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36" y="3957"/>
                  <a:ext cx="61" cy="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b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0" name="Rectangle 101">
                  <a:extLst>
                    <a:ext uri="{FF2B5EF4-FFF2-40B4-BE49-F238E27FC236}">
                      <a16:creationId xmlns:a16="http://schemas.microsoft.com/office/drawing/2014/main" id="{2FFA1B78-1D58-4B1B-B943-B71AFD1590D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64" y="3976"/>
                  <a:ext cx="80" cy="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11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1" name="Rectangle 102">
                  <a:extLst>
                    <a:ext uri="{FF2B5EF4-FFF2-40B4-BE49-F238E27FC236}">
                      <a16:creationId xmlns:a16="http://schemas.microsoft.com/office/drawing/2014/main" id="{0CB09004-8089-436C-80BA-F0A059354C1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58" y="3860"/>
                  <a:ext cx="60" cy="6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D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2" name="Rectangle 103">
                  <a:extLst>
                    <a:ext uri="{FF2B5EF4-FFF2-40B4-BE49-F238E27FC236}">
                      <a16:creationId xmlns:a16="http://schemas.microsoft.com/office/drawing/2014/main" id="{8F2D443E-53E6-4B05-BAAF-90299744DD8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08" y="3860"/>
                  <a:ext cx="61" cy="6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A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3" name="Rectangle 104">
                  <a:extLst>
                    <a:ext uri="{FF2B5EF4-FFF2-40B4-BE49-F238E27FC236}">
                      <a16:creationId xmlns:a16="http://schemas.microsoft.com/office/drawing/2014/main" id="{2E08FDD4-9974-4D5C-AF8F-7B2B4D1FF39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55" y="3860"/>
                  <a:ext cx="60" cy="6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6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P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4" name="Rectangle 105">
                  <a:extLst>
                    <a:ext uri="{FF2B5EF4-FFF2-40B4-BE49-F238E27FC236}">
                      <a16:creationId xmlns:a16="http://schemas.microsoft.com/office/drawing/2014/main" id="{51E3B378-66B0-487D-9A92-9CC77EB1868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04" y="3859"/>
                  <a:ext cx="61" cy="6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1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R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5" name="Rectangle 106">
                  <a:extLst>
                    <a:ext uri="{FF2B5EF4-FFF2-40B4-BE49-F238E27FC236}">
                      <a16:creationId xmlns:a16="http://schemas.microsoft.com/office/drawing/2014/main" id="{E7D6DB2A-2874-4AE5-8FB6-F70F068B756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38" y="3861"/>
                  <a:ext cx="2" cy="68"/>
                </a:xfrm>
                <a:prstGeom prst="rect">
                  <a:avLst/>
                </a:pr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26" name="Freeform 107">
                  <a:extLst>
                    <a:ext uri="{FF2B5EF4-FFF2-40B4-BE49-F238E27FC236}">
                      <a16:creationId xmlns:a16="http://schemas.microsoft.com/office/drawing/2014/main" id="{73AB607E-5692-4455-89AA-93207030ECE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738" y="3835"/>
                  <a:ext cx="30" cy="26"/>
                </a:xfrm>
                <a:custGeom>
                  <a:avLst/>
                  <a:gdLst>
                    <a:gd name="T0" fmla="*/ 0 w 30"/>
                    <a:gd name="T1" fmla="*/ 24 h 26"/>
                    <a:gd name="T2" fmla="*/ 28 w 30"/>
                    <a:gd name="T3" fmla="*/ 0 h 26"/>
                    <a:gd name="T4" fmla="*/ 30 w 30"/>
                    <a:gd name="T5" fmla="*/ 2 h 26"/>
                    <a:gd name="T6" fmla="*/ 2 w 30"/>
                    <a:gd name="T7" fmla="*/ 26 h 26"/>
                    <a:gd name="T8" fmla="*/ 0 w 30"/>
                    <a:gd name="T9" fmla="*/ 24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6">
                      <a:moveTo>
                        <a:pt x="0" y="24"/>
                      </a:moveTo>
                      <a:lnTo>
                        <a:pt x="28" y="0"/>
                      </a:lnTo>
                      <a:lnTo>
                        <a:pt x="30" y="2"/>
                      </a:lnTo>
                      <a:lnTo>
                        <a:pt x="2" y="26"/>
                      </a:lnTo>
                      <a:lnTo>
                        <a:pt x="0" y="24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27" name="Freeform 108">
                  <a:extLst>
                    <a:ext uri="{FF2B5EF4-FFF2-40B4-BE49-F238E27FC236}">
                      <a16:creationId xmlns:a16="http://schemas.microsoft.com/office/drawing/2014/main" id="{A7D20B1A-6FC5-4731-9AD1-AFB9C2E2219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711" y="3931"/>
                  <a:ext cx="30" cy="26"/>
                </a:xfrm>
                <a:custGeom>
                  <a:avLst/>
                  <a:gdLst>
                    <a:gd name="T0" fmla="*/ 30 w 30"/>
                    <a:gd name="T1" fmla="*/ 2 h 26"/>
                    <a:gd name="T2" fmla="*/ 2 w 30"/>
                    <a:gd name="T3" fmla="*/ 26 h 26"/>
                    <a:gd name="T4" fmla="*/ 0 w 30"/>
                    <a:gd name="T5" fmla="*/ 23 h 26"/>
                    <a:gd name="T6" fmla="*/ 28 w 30"/>
                    <a:gd name="T7" fmla="*/ 0 h 26"/>
                    <a:gd name="T8" fmla="*/ 30 w 30"/>
                    <a:gd name="T9" fmla="*/ 2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6">
                      <a:moveTo>
                        <a:pt x="30" y="2"/>
                      </a:moveTo>
                      <a:lnTo>
                        <a:pt x="2" y="26"/>
                      </a:lnTo>
                      <a:lnTo>
                        <a:pt x="0" y="23"/>
                      </a:lnTo>
                      <a:lnTo>
                        <a:pt x="28" y="0"/>
                      </a:lnTo>
                      <a:lnTo>
                        <a:pt x="30" y="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28" name="Rectangle 109">
                  <a:extLst>
                    <a:ext uri="{FF2B5EF4-FFF2-40B4-BE49-F238E27FC236}">
                      <a16:creationId xmlns:a16="http://schemas.microsoft.com/office/drawing/2014/main" id="{C5DEB4A5-1085-4B4F-B959-7D28278A808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93" y="3858"/>
                  <a:ext cx="2" cy="69"/>
                </a:xfrm>
                <a:prstGeom prst="rect">
                  <a:avLst/>
                </a:pr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29" name="Freeform 110">
                  <a:extLst>
                    <a:ext uri="{FF2B5EF4-FFF2-40B4-BE49-F238E27FC236}">
                      <a16:creationId xmlns:a16="http://schemas.microsoft.com/office/drawing/2014/main" id="{AD75BA81-96E9-4EF0-8135-9FD8CDA5B7F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793" y="3833"/>
                  <a:ext cx="30" cy="25"/>
                </a:xfrm>
                <a:custGeom>
                  <a:avLst/>
                  <a:gdLst>
                    <a:gd name="T0" fmla="*/ 0 w 30"/>
                    <a:gd name="T1" fmla="*/ 23 h 25"/>
                    <a:gd name="T2" fmla="*/ 28 w 30"/>
                    <a:gd name="T3" fmla="*/ 0 h 25"/>
                    <a:gd name="T4" fmla="*/ 30 w 30"/>
                    <a:gd name="T5" fmla="*/ 2 h 25"/>
                    <a:gd name="T6" fmla="*/ 2 w 30"/>
                    <a:gd name="T7" fmla="*/ 25 h 25"/>
                    <a:gd name="T8" fmla="*/ 0 w 30"/>
                    <a:gd name="T9" fmla="*/ 23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5">
                      <a:moveTo>
                        <a:pt x="0" y="23"/>
                      </a:moveTo>
                      <a:lnTo>
                        <a:pt x="28" y="0"/>
                      </a:lnTo>
                      <a:lnTo>
                        <a:pt x="30" y="2"/>
                      </a:lnTo>
                      <a:lnTo>
                        <a:pt x="2" y="25"/>
                      </a:lnTo>
                      <a:lnTo>
                        <a:pt x="0" y="23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30" name="Rectangle 111">
                  <a:extLst>
                    <a:ext uri="{FF2B5EF4-FFF2-40B4-BE49-F238E27FC236}">
                      <a16:creationId xmlns:a16="http://schemas.microsoft.com/office/drawing/2014/main" id="{19CE1A1C-E887-4382-BF9D-B8285E2F05E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45" y="3858"/>
                  <a:ext cx="2" cy="69"/>
                </a:xfrm>
                <a:prstGeom prst="rect">
                  <a:avLst/>
                </a:pr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31" name="Freeform 112">
                  <a:extLst>
                    <a:ext uri="{FF2B5EF4-FFF2-40B4-BE49-F238E27FC236}">
                      <a16:creationId xmlns:a16="http://schemas.microsoft.com/office/drawing/2014/main" id="{5CC738E6-5130-4DFE-8A9C-70066F9DB57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845" y="3833"/>
                  <a:ext cx="30" cy="25"/>
                </a:xfrm>
                <a:custGeom>
                  <a:avLst/>
                  <a:gdLst>
                    <a:gd name="T0" fmla="*/ 0 w 30"/>
                    <a:gd name="T1" fmla="*/ 23 h 25"/>
                    <a:gd name="T2" fmla="*/ 28 w 30"/>
                    <a:gd name="T3" fmla="*/ 0 h 25"/>
                    <a:gd name="T4" fmla="*/ 30 w 30"/>
                    <a:gd name="T5" fmla="*/ 2 h 25"/>
                    <a:gd name="T6" fmla="*/ 2 w 30"/>
                    <a:gd name="T7" fmla="*/ 25 h 25"/>
                    <a:gd name="T8" fmla="*/ 0 w 30"/>
                    <a:gd name="T9" fmla="*/ 23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5">
                      <a:moveTo>
                        <a:pt x="0" y="23"/>
                      </a:moveTo>
                      <a:lnTo>
                        <a:pt x="28" y="0"/>
                      </a:lnTo>
                      <a:lnTo>
                        <a:pt x="30" y="2"/>
                      </a:lnTo>
                      <a:lnTo>
                        <a:pt x="2" y="25"/>
                      </a:lnTo>
                      <a:lnTo>
                        <a:pt x="0" y="23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32" name="Freeform 113">
                  <a:extLst>
                    <a:ext uri="{FF2B5EF4-FFF2-40B4-BE49-F238E27FC236}">
                      <a16:creationId xmlns:a16="http://schemas.microsoft.com/office/drawing/2014/main" id="{F6E279AC-A223-4B3C-B309-A90916CD01A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818" y="3928"/>
                  <a:ext cx="30" cy="26"/>
                </a:xfrm>
                <a:custGeom>
                  <a:avLst/>
                  <a:gdLst>
                    <a:gd name="T0" fmla="*/ 30 w 30"/>
                    <a:gd name="T1" fmla="*/ 3 h 26"/>
                    <a:gd name="T2" fmla="*/ 2 w 30"/>
                    <a:gd name="T3" fmla="*/ 26 h 26"/>
                    <a:gd name="T4" fmla="*/ 0 w 30"/>
                    <a:gd name="T5" fmla="*/ 24 h 26"/>
                    <a:gd name="T6" fmla="*/ 28 w 30"/>
                    <a:gd name="T7" fmla="*/ 0 h 26"/>
                    <a:gd name="T8" fmla="*/ 30 w 30"/>
                    <a:gd name="T9" fmla="*/ 3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6">
                      <a:moveTo>
                        <a:pt x="30" y="3"/>
                      </a:moveTo>
                      <a:lnTo>
                        <a:pt x="2" y="26"/>
                      </a:lnTo>
                      <a:lnTo>
                        <a:pt x="0" y="24"/>
                      </a:lnTo>
                      <a:lnTo>
                        <a:pt x="28" y="0"/>
                      </a:lnTo>
                      <a:lnTo>
                        <a:pt x="30" y="3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33" name="Freeform 114">
                  <a:extLst>
                    <a:ext uri="{FF2B5EF4-FFF2-40B4-BE49-F238E27FC236}">
                      <a16:creationId xmlns:a16="http://schemas.microsoft.com/office/drawing/2014/main" id="{EA4217FB-8A3F-42B9-A25D-40B5A0FCCDD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65" y="3923"/>
                  <a:ext cx="30" cy="25"/>
                </a:xfrm>
                <a:custGeom>
                  <a:avLst/>
                  <a:gdLst>
                    <a:gd name="T0" fmla="*/ 30 w 30"/>
                    <a:gd name="T1" fmla="*/ 2 h 25"/>
                    <a:gd name="T2" fmla="*/ 2 w 30"/>
                    <a:gd name="T3" fmla="*/ 25 h 25"/>
                    <a:gd name="T4" fmla="*/ 0 w 30"/>
                    <a:gd name="T5" fmla="*/ 23 h 25"/>
                    <a:gd name="T6" fmla="*/ 28 w 30"/>
                    <a:gd name="T7" fmla="*/ 0 h 25"/>
                    <a:gd name="T8" fmla="*/ 30 w 30"/>
                    <a:gd name="T9" fmla="*/ 2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0" h="25">
                      <a:moveTo>
                        <a:pt x="30" y="2"/>
                      </a:moveTo>
                      <a:lnTo>
                        <a:pt x="2" y="25"/>
                      </a:lnTo>
                      <a:lnTo>
                        <a:pt x="0" y="23"/>
                      </a:lnTo>
                      <a:lnTo>
                        <a:pt x="28" y="0"/>
                      </a:lnTo>
                      <a:lnTo>
                        <a:pt x="30" y="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34" name="Rectangle 115">
                  <a:extLst>
                    <a:ext uri="{FF2B5EF4-FFF2-40B4-BE49-F238E27FC236}">
                      <a16:creationId xmlns:a16="http://schemas.microsoft.com/office/drawing/2014/main" id="{761747D1-57A5-4362-A082-BF1ECFAC6B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24" y="3779"/>
                  <a:ext cx="60" cy="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y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5" name="Rectangle 116">
                  <a:extLst>
                    <a:ext uri="{FF2B5EF4-FFF2-40B4-BE49-F238E27FC236}">
                      <a16:creationId xmlns:a16="http://schemas.microsoft.com/office/drawing/2014/main" id="{27572C2F-03AA-452E-B289-F4498558A9C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51" y="3798"/>
                  <a:ext cx="79" cy="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11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6" name="Rectangle 117">
                  <a:extLst>
                    <a:ext uri="{FF2B5EF4-FFF2-40B4-BE49-F238E27FC236}">
                      <a16:creationId xmlns:a16="http://schemas.microsoft.com/office/drawing/2014/main" id="{BCE75B06-3D87-46FF-B581-0A91FC614CE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05" y="3957"/>
                  <a:ext cx="60" cy="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b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7" name="Rectangle 118">
                  <a:extLst>
                    <a:ext uri="{FF2B5EF4-FFF2-40B4-BE49-F238E27FC236}">
                      <a16:creationId xmlns:a16="http://schemas.microsoft.com/office/drawing/2014/main" id="{7B22E67C-FB2B-4129-8103-4A909250ACA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33" y="3976"/>
                  <a:ext cx="80" cy="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12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8" name="Rectangle 119">
                  <a:extLst>
                    <a:ext uri="{FF2B5EF4-FFF2-40B4-BE49-F238E27FC236}">
                      <a16:creationId xmlns:a16="http://schemas.microsoft.com/office/drawing/2014/main" id="{19CB55F0-806C-44AD-BF86-4DB9215A44A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08" y="3957"/>
                  <a:ext cx="61" cy="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b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9" name="Rectangle 120">
                  <a:extLst>
                    <a:ext uri="{FF2B5EF4-FFF2-40B4-BE49-F238E27FC236}">
                      <a16:creationId xmlns:a16="http://schemas.microsoft.com/office/drawing/2014/main" id="{B09AE1EE-C63D-4A74-A14C-58CAB30BC76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36" y="3976"/>
                  <a:ext cx="80" cy="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4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ourier New" panose="02070309020205020404" pitchFamily="49" charset="0"/>
                    </a:rPr>
                    <a:t>14 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sp>
            <p:nvSpPr>
              <p:cNvPr id="134" name="Freeform 122">
                <a:extLst>
                  <a:ext uri="{FF2B5EF4-FFF2-40B4-BE49-F238E27FC236}">
                    <a16:creationId xmlns:a16="http://schemas.microsoft.com/office/drawing/2014/main" id="{FBC20F9C-0C31-41F5-A8B2-C4909FB65E1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486" y="3777"/>
                <a:ext cx="78" cy="77"/>
              </a:xfrm>
              <a:custGeom>
                <a:avLst/>
                <a:gdLst>
                  <a:gd name="T0" fmla="*/ 65 w 78"/>
                  <a:gd name="T1" fmla="*/ 0 h 77"/>
                  <a:gd name="T2" fmla="*/ 26 w 78"/>
                  <a:gd name="T3" fmla="*/ 39 h 77"/>
                  <a:gd name="T4" fmla="*/ 38 w 78"/>
                  <a:gd name="T5" fmla="*/ 52 h 77"/>
                  <a:gd name="T6" fmla="*/ 78 w 78"/>
                  <a:gd name="T7" fmla="*/ 12 h 77"/>
                  <a:gd name="T8" fmla="*/ 65 w 78"/>
                  <a:gd name="T9" fmla="*/ 0 h 77"/>
                  <a:gd name="T10" fmla="*/ 19 w 78"/>
                  <a:gd name="T11" fmla="*/ 20 h 77"/>
                  <a:gd name="T12" fmla="*/ 0 w 78"/>
                  <a:gd name="T13" fmla="*/ 77 h 77"/>
                  <a:gd name="T14" fmla="*/ 58 w 78"/>
                  <a:gd name="T15" fmla="*/ 58 h 77"/>
                  <a:gd name="T16" fmla="*/ 19 w 78"/>
                  <a:gd name="T17" fmla="*/ 20 h 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78" h="77">
                    <a:moveTo>
                      <a:pt x="65" y="0"/>
                    </a:moveTo>
                    <a:lnTo>
                      <a:pt x="26" y="39"/>
                    </a:lnTo>
                    <a:lnTo>
                      <a:pt x="38" y="52"/>
                    </a:lnTo>
                    <a:lnTo>
                      <a:pt x="78" y="12"/>
                    </a:lnTo>
                    <a:lnTo>
                      <a:pt x="65" y="0"/>
                    </a:lnTo>
                    <a:close/>
                    <a:moveTo>
                      <a:pt x="19" y="20"/>
                    </a:moveTo>
                    <a:lnTo>
                      <a:pt x="0" y="77"/>
                    </a:lnTo>
                    <a:lnTo>
                      <a:pt x="58" y="58"/>
                    </a:lnTo>
                    <a:lnTo>
                      <a:pt x="19" y="20"/>
                    </a:lnTo>
                    <a:close/>
                  </a:path>
                </a:pathLst>
              </a:custGeom>
              <a:solidFill>
                <a:srgbClr val="7F7F7F"/>
              </a:solidFill>
              <a:ln w="0" cap="flat">
                <a:solidFill>
                  <a:srgbClr val="7F7F7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" name="Freeform 123">
                <a:extLst>
                  <a:ext uri="{FF2B5EF4-FFF2-40B4-BE49-F238E27FC236}">
                    <a16:creationId xmlns:a16="http://schemas.microsoft.com/office/drawing/2014/main" id="{A45611E7-CEDA-424E-92F9-0F5542F666E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920" y="4311"/>
                <a:ext cx="59" cy="53"/>
              </a:xfrm>
              <a:custGeom>
                <a:avLst/>
                <a:gdLst>
                  <a:gd name="T0" fmla="*/ 8 w 995"/>
                  <a:gd name="T1" fmla="*/ 360 h 898"/>
                  <a:gd name="T2" fmla="*/ 2 w 995"/>
                  <a:gd name="T3" fmla="*/ 342 h 898"/>
                  <a:gd name="T4" fmla="*/ 17 w 995"/>
                  <a:gd name="T5" fmla="*/ 330 h 898"/>
                  <a:gd name="T6" fmla="*/ 384 w 995"/>
                  <a:gd name="T7" fmla="*/ 330 h 898"/>
                  <a:gd name="T8" fmla="*/ 369 w 995"/>
                  <a:gd name="T9" fmla="*/ 341 h 898"/>
                  <a:gd name="T10" fmla="*/ 482 w 995"/>
                  <a:gd name="T11" fmla="*/ 11 h 898"/>
                  <a:gd name="T12" fmla="*/ 497 w 995"/>
                  <a:gd name="T13" fmla="*/ 0 h 898"/>
                  <a:gd name="T14" fmla="*/ 513 w 995"/>
                  <a:gd name="T15" fmla="*/ 11 h 898"/>
                  <a:gd name="T16" fmla="*/ 626 w 995"/>
                  <a:gd name="T17" fmla="*/ 341 h 898"/>
                  <a:gd name="T18" fmla="*/ 611 w 995"/>
                  <a:gd name="T19" fmla="*/ 330 h 898"/>
                  <a:gd name="T20" fmla="*/ 977 w 995"/>
                  <a:gd name="T21" fmla="*/ 330 h 898"/>
                  <a:gd name="T22" fmla="*/ 993 w 995"/>
                  <a:gd name="T23" fmla="*/ 342 h 898"/>
                  <a:gd name="T24" fmla="*/ 987 w 995"/>
                  <a:gd name="T25" fmla="*/ 360 h 898"/>
                  <a:gd name="T26" fmla="*/ 690 w 995"/>
                  <a:gd name="T27" fmla="*/ 564 h 898"/>
                  <a:gd name="T28" fmla="*/ 696 w 995"/>
                  <a:gd name="T29" fmla="*/ 545 h 898"/>
                  <a:gd name="T30" fmla="*/ 809 w 995"/>
                  <a:gd name="T31" fmla="*/ 875 h 898"/>
                  <a:gd name="T32" fmla="*/ 804 w 995"/>
                  <a:gd name="T33" fmla="*/ 893 h 898"/>
                  <a:gd name="T34" fmla="*/ 785 w 995"/>
                  <a:gd name="T35" fmla="*/ 894 h 898"/>
                  <a:gd name="T36" fmla="*/ 488 w 995"/>
                  <a:gd name="T37" fmla="*/ 690 h 898"/>
                  <a:gd name="T38" fmla="*/ 507 w 995"/>
                  <a:gd name="T39" fmla="*/ 690 h 898"/>
                  <a:gd name="T40" fmla="*/ 210 w 995"/>
                  <a:gd name="T41" fmla="*/ 894 h 898"/>
                  <a:gd name="T42" fmla="*/ 191 w 995"/>
                  <a:gd name="T43" fmla="*/ 893 h 898"/>
                  <a:gd name="T44" fmla="*/ 186 w 995"/>
                  <a:gd name="T45" fmla="*/ 875 h 898"/>
                  <a:gd name="T46" fmla="*/ 299 w 995"/>
                  <a:gd name="T47" fmla="*/ 545 h 898"/>
                  <a:gd name="T48" fmla="*/ 305 w 995"/>
                  <a:gd name="T49" fmla="*/ 564 h 898"/>
                  <a:gd name="T50" fmla="*/ 8 w 995"/>
                  <a:gd name="T51" fmla="*/ 360 h 898"/>
                  <a:gd name="T52" fmla="*/ 323 w 995"/>
                  <a:gd name="T53" fmla="*/ 537 h 898"/>
                  <a:gd name="T54" fmla="*/ 329 w 995"/>
                  <a:gd name="T55" fmla="*/ 556 h 898"/>
                  <a:gd name="T56" fmla="*/ 216 w 995"/>
                  <a:gd name="T57" fmla="*/ 886 h 898"/>
                  <a:gd name="T58" fmla="*/ 192 w 995"/>
                  <a:gd name="T59" fmla="*/ 867 h 898"/>
                  <a:gd name="T60" fmla="*/ 488 w 995"/>
                  <a:gd name="T61" fmla="*/ 663 h 898"/>
                  <a:gd name="T62" fmla="*/ 507 w 995"/>
                  <a:gd name="T63" fmla="*/ 663 h 898"/>
                  <a:gd name="T64" fmla="*/ 803 w 995"/>
                  <a:gd name="T65" fmla="*/ 867 h 898"/>
                  <a:gd name="T66" fmla="*/ 779 w 995"/>
                  <a:gd name="T67" fmla="*/ 886 h 898"/>
                  <a:gd name="T68" fmla="*/ 666 w 995"/>
                  <a:gd name="T69" fmla="*/ 556 h 898"/>
                  <a:gd name="T70" fmla="*/ 672 w 995"/>
                  <a:gd name="T71" fmla="*/ 537 h 898"/>
                  <a:gd name="T72" fmla="*/ 968 w 995"/>
                  <a:gd name="T73" fmla="*/ 333 h 898"/>
                  <a:gd name="T74" fmla="*/ 977 w 995"/>
                  <a:gd name="T75" fmla="*/ 362 h 898"/>
                  <a:gd name="T76" fmla="*/ 611 w 995"/>
                  <a:gd name="T77" fmla="*/ 362 h 898"/>
                  <a:gd name="T78" fmla="*/ 596 w 995"/>
                  <a:gd name="T79" fmla="*/ 352 h 898"/>
                  <a:gd name="T80" fmla="*/ 482 w 995"/>
                  <a:gd name="T81" fmla="*/ 22 h 898"/>
                  <a:gd name="T82" fmla="*/ 513 w 995"/>
                  <a:gd name="T83" fmla="*/ 22 h 898"/>
                  <a:gd name="T84" fmla="*/ 399 w 995"/>
                  <a:gd name="T85" fmla="*/ 352 h 898"/>
                  <a:gd name="T86" fmla="*/ 384 w 995"/>
                  <a:gd name="T87" fmla="*/ 362 h 898"/>
                  <a:gd name="T88" fmla="*/ 17 w 995"/>
                  <a:gd name="T89" fmla="*/ 362 h 898"/>
                  <a:gd name="T90" fmla="*/ 27 w 995"/>
                  <a:gd name="T91" fmla="*/ 333 h 898"/>
                  <a:gd name="T92" fmla="*/ 323 w 995"/>
                  <a:gd name="T93" fmla="*/ 537 h 8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</a:cxnLst>
                <a:rect l="0" t="0" r="r" b="b"/>
                <a:pathLst>
                  <a:path w="995" h="898">
                    <a:moveTo>
                      <a:pt x="8" y="360"/>
                    </a:moveTo>
                    <a:cubicBezTo>
                      <a:pt x="3" y="356"/>
                      <a:pt x="0" y="348"/>
                      <a:pt x="2" y="342"/>
                    </a:cubicBezTo>
                    <a:cubicBezTo>
                      <a:pt x="4" y="335"/>
                      <a:pt x="10" y="330"/>
                      <a:pt x="17" y="330"/>
                    </a:cubicBezTo>
                    <a:lnTo>
                      <a:pt x="384" y="330"/>
                    </a:lnTo>
                    <a:lnTo>
                      <a:pt x="369" y="341"/>
                    </a:lnTo>
                    <a:lnTo>
                      <a:pt x="482" y="11"/>
                    </a:lnTo>
                    <a:cubicBezTo>
                      <a:pt x="485" y="5"/>
                      <a:pt x="491" y="0"/>
                      <a:pt x="497" y="0"/>
                    </a:cubicBezTo>
                    <a:cubicBezTo>
                      <a:pt x="504" y="0"/>
                      <a:pt x="510" y="5"/>
                      <a:pt x="513" y="11"/>
                    </a:cubicBezTo>
                    <a:lnTo>
                      <a:pt x="626" y="341"/>
                    </a:lnTo>
                    <a:lnTo>
                      <a:pt x="611" y="330"/>
                    </a:lnTo>
                    <a:lnTo>
                      <a:pt x="977" y="330"/>
                    </a:lnTo>
                    <a:cubicBezTo>
                      <a:pt x="984" y="330"/>
                      <a:pt x="991" y="335"/>
                      <a:pt x="993" y="342"/>
                    </a:cubicBezTo>
                    <a:cubicBezTo>
                      <a:pt x="995" y="348"/>
                      <a:pt x="992" y="356"/>
                      <a:pt x="987" y="360"/>
                    </a:cubicBezTo>
                    <a:lnTo>
                      <a:pt x="690" y="564"/>
                    </a:lnTo>
                    <a:lnTo>
                      <a:pt x="696" y="545"/>
                    </a:lnTo>
                    <a:lnTo>
                      <a:pt x="809" y="875"/>
                    </a:lnTo>
                    <a:cubicBezTo>
                      <a:pt x="812" y="882"/>
                      <a:pt x="809" y="889"/>
                      <a:pt x="804" y="893"/>
                    </a:cubicBezTo>
                    <a:cubicBezTo>
                      <a:pt x="798" y="897"/>
                      <a:pt x="791" y="898"/>
                      <a:pt x="785" y="894"/>
                    </a:cubicBezTo>
                    <a:lnTo>
                      <a:pt x="488" y="690"/>
                    </a:lnTo>
                    <a:lnTo>
                      <a:pt x="507" y="690"/>
                    </a:lnTo>
                    <a:lnTo>
                      <a:pt x="210" y="894"/>
                    </a:lnTo>
                    <a:cubicBezTo>
                      <a:pt x="204" y="898"/>
                      <a:pt x="197" y="897"/>
                      <a:pt x="191" y="893"/>
                    </a:cubicBezTo>
                    <a:cubicBezTo>
                      <a:pt x="186" y="889"/>
                      <a:pt x="183" y="882"/>
                      <a:pt x="186" y="875"/>
                    </a:cubicBezTo>
                    <a:lnTo>
                      <a:pt x="299" y="545"/>
                    </a:lnTo>
                    <a:lnTo>
                      <a:pt x="305" y="564"/>
                    </a:lnTo>
                    <a:lnTo>
                      <a:pt x="8" y="360"/>
                    </a:lnTo>
                    <a:close/>
                    <a:moveTo>
                      <a:pt x="323" y="537"/>
                    </a:moveTo>
                    <a:cubicBezTo>
                      <a:pt x="329" y="541"/>
                      <a:pt x="332" y="549"/>
                      <a:pt x="329" y="556"/>
                    </a:cubicBezTo>
                    <a:lnTo>
                      <a:pt x="216" y="886"/>
                    </a:lnTo>
                    <a:lnTo>
                      <a:pt x="192" y="867"/>
                    </a:lnTo>
                    <a:lnTo>
                      <a:pt x="488" y="663"/>
                    </a:lnTo>
                    <a:cubicBezTo>
                      <a:pt x="494" y="660"/>
                      <a:pt x="501" y="660"/>
                      <a:pt x="507" y="663"/>
                    </a:cubicBezTo>
                    <a:lnTo>
                      <a:pt x="803" y="867"/>
                    </a:lnTo>
                    <a:lnTo>
                      <a:pt x="779" y="886"/>
                    </a:lnTo>
                    <a:lnTo>
                      <a:pt x="666" y="556"/>
                    </a:lnTo>
                    <a:cubicBezTo>
                      <a:pt x="663" y="549"/>
                      <a:pt x="666" y="541"/>
                      <a:pt x="672" y="537"/>
                    </a:cubicBezTo>
                    <a:lnTo>
                      <a:pt x="968" y="333"/>
                    </a:lnTo>
                    <a:lnTo>
                      <a:pt x="977" y="362"/>
                    </a:lnTo>
                    <a:lnTo>
                      <a:pt x="611" y="362"/>
                    </a:lnTo>
                    <a:cubicBezTo>
                      <a:pt x="604" y="362"/>
                      <a:pt x="598" y="358"/>
                      <a:pt x="596" y="352"/>
                    </a:cubicBezTo>
                    <a:lnTo>
                      <a:pt x="482" y="22"/>
                    </a:lnTo>
                    <a:lnTo>
                      <a:pt x="513" y="22"/>
                    </a:lnTo>
                    <a:lnTo>
                      <a:pt x="399" y="352"/>
                    </a:lnTo>
                    <a:cubicBezTo>
                      <a:pt x="397" y="358"/>
                      <a:pt x="391" y="362"/>
                      <a:pt x="384" y="362"/>
                    </a:cubicBezTo>
                    <a:lnTo>
                      <a:pt x="17" y="362"/>
                    </a:lnTo>
                    <a:lnTo>
                      <a:pt x="27" y="333"/>
                    </a:lnTo>
                    <a:lnTo>
                      <a:pt x="323" y="537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" name="Rectangle 124">
                <a:extLst>
                  <a:ext uri="{FF2B5EF4-FFF2-40B4-BE49-F238E27FC236}">
                    <a16:creationId xmlns:a16="http://schemas.microsoft.com/office/drawing/2014/main" id="{3D63DD99-C738-4E4C-B86D-CD04F81A8E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" y="3812"/>
                <a:ext cx="81" cy="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RT: 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7" name="Rectangle 125">
                <a:extLst>
                  <a:ext uri="{FF2B5EF4-FFF2-40B4-BE49-F238E27FC236}">
                    <a16:creationId xmlns:a16="http://schemas.microsoft.com/office/drawing/2014/main" id="{FB7C60DC-5E60-4AFF-AAB3-81FA196165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2" y="3812"/>
                <a:ext cx="110" cy="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29.8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8" name="Rectangle 126">
                <a:extLst>
                  <a:ext uri="{FF2B5EF4-FFF2-40B4-BE49-F238E27FC236}">
                    <a16:creationId xmlns:a16="http://schemas.microsoft.com/office/drawing/2014/main" id="{5A4A7CFF-39A9-4881-A34B-CEC15B33BF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" y="3860"/>
                <a:ext cx="194" cy="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Charge: +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9" name="Rectangle 127">
                <a:extLst>
                  <a:ext uri="{FF2B5EF4-FFF2-40B4-BE49-F238E27FC236}">
                    <a16:creationId xmlns:a16="http://schemas.microsoft.com/office/drawing/2014/main" id="{CBD153E6-3ADB-4710-A3BF-B7653AA28A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" y="3907"/>
                <a:ext cx="112" cy="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XCorr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0" name="Rectangle 128">
                <a:extLst>
                  <a:ext uri="{FF2B5EF4-FFF2-40B4-BE49-F238E27FC236}">
                    <a16:creationId xmlns:a16="http://schemas.microsoft.com/office/drawing/2014/main" id="{964C89D1-6019-4B64-ADA0-E7FF53B6AC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1" y="3907"/>
                <a:ext cx="41" cy="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: 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1" name="Rectangle 129">
                <a:extLst>
                  <a:ext uri="{FF2B5EF4-FFF2-40B4-BE49-F238E27FC236}">
                    <a16:creationId xmlns:a16="http://schemas.microsoft.com/office/drawing/2014/main" id="{A2DB75C3-F1A2-43BD-A961-308FCE9DD3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1" y="3907"/>
                <a:ext cx="90" cy="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3.5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2" name="Rectangle 130">
                <a:extLst>
                  <a:ext uri="{FF2B5EF4-FFF2-40B4-BE49-F238E27FC236}">
                    <a16:creationId xmlns:a16="http://schemas.microsoft.com/office/drawing/2014/main" id="{3DEA582C-F36D-42A9-A6A4-B70952ECC0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" y="3956"/>
                <a:ext cx="81" cy="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pRS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3" name="Rectangle 131">
                <a:extLst>
                  <a:ext uri="{FF2B5EF4-FFF2-40B4-BE49-F238E27FC236}">
                    <a16:creationId xmlns:a16="http://schemas.microsoft.com/office/drawing/2014/main" id="{87397AB4-E3C3-438C-BE20-6DDA29AC77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1" y="3956"/>
                <a:ext cx="128" cy="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score: 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4" name="Rectangle 132">
                <a:extLst>
                  <a:ext uri="{FF2B5EF4-FFF2-40B4-BE49-F238E27FC236}">
                    <a16:creationId xmlns:a16="http://schemas.microsoft.com/office/drawing/2014/main" id="{E555AD17-A0D5-41E1-8A56-E024EDF7AC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7" y="3956"/>
                <a:ext cx="60" cy="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6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5" name="Rectangle 133">
                <a:extLst>
                  <a:ext uri="{FF2B5EF4-FFF2-40B4-BE49-F238E27FC236}">
                    <a16:creationId xmlns:a16="http://schemas.microsoft.com/office/drawing/2014/main" id="{61E8CA77-81D4-4B66-B4B2-A11007A415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" y="4002"/>
                <a:ext cx="104" cy="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m/z: 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6" name="Rectangle 134">
                <a:extLst>
                  <a:ext uri="{FF2B5EF4-FFF2-40B4-BE49-F238E27FC236}">
                    <a16:creationId xmlns:a16="http://schemas.microsoft.com/office/drawing/2014/main" id="{08FC5C1F-CF83-4267-99AE-A5F4A4ABE7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4" y="4002"/>
                <a:ext cx="171" cy="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909.955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7" name="Rectangle 135">
                <a:extLst>
                  <a:ext uri="{FF2B5EF4-FFF2-40B4-BE49-F238E27FC236}">
                    <a16:creationId xmlns:a16="http://schemas.microsoft.com/office/drawing/2014/main" id="{ADBCD8EB-D2DE-46E2-9312-681DFE16C4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" y="4051"/>
                <a:ext cx="261" cy="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Matched ions: 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8" name="Rectangle 136">
                <a:extLst>
                  <a:ext uri="{FF2B5EF4-FFF2-40B4-BE49-F238E27FC236}">
                    <a16:creationId xmlns:a16="http://schemas.microsoft.com/office/drawing/2014/main" id="{08498E19-FAD8-4601-B4A4-45F81BBAD5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0" y="4051"/>
                <a:ext cx="116" cy="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22/4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9" name="Rectangle 137">
                <a:extLst>
                  <a:ext uri="{FF2B5EF4-FFF2-40B4-BE49-F238E27FC236}">
                    <a16:creationId xmlns:a16="http://schemas.microsoft.com/office/drawing/2014/main" id="{13C0CF42-93A1-4B32-B739-CFF00C864C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" y="4097"/>
                <a:ext cx="81" cy="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pRS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0" name="Rectangle 138">
                <a:extLst>
                  <a:ext uri="{FF2B5EF4-FFF2-40B4-BE49-F238E27FC236}">
                    <a16:creationId xmlns:a16="http://schemas.microsoft.com/office/drawing/2014/main" id="{00A6C93F-A246-48B2-A04A-14C19F214E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1" y="4097"/>
                <a:ext cx="215" cy="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probability: 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1" name="Rectangle 139">
                <a:extLst>
                  <a:ext uri="{FF2B5EF4-FFF2-40B4-BE49-F238E27FC236}">
                    <a16:creationId xmlns:a16="http://schemas.microsoft.com/office/drawing/2014/main" id="{35C5F793-45A2-4295-8E8D-80110353EC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4" y="4097"/>
                <a:ext cx="119" cy="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</a:rPr>
                  <a:t>97.6%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33" name="Freeform 141">
              <a:extLst>
                <a:ext uri="{FF2B5EF4-FFF2-40B4-BE49-F238E27FC236}">
                  <a16:creationId xmlns:a16="http://schemas.microsoft.com/office/drawing/2014/main" id="{29B6FABE-8E12-48B1-866C-CB120CCDF389}"/>
                </a:ext>
              </a:extLst>
            </p:cNvPr>
            <p:cNvSpPr>
              <a:spLocks/>
            </p:cNvSpPr>
            <p:nvPr/>
          </p:nvSpPr>
          <p:spPr bwMode="auto">
            <a:xfrm>
              <a:off x="2414" y="2546"/>
              <a:ext cx="498" cy="312"/>
            </a:xfrm>
            <a:custGeom>
              <a:avLst/>
              <a:gdLst>
                <a:gd name="T0" fmla="*/ 0 w 498"/>
                <a:gd name="T1" fmla="*/ 78 h 312"/>
                <a:gd name="T2" fmla="*/ 342 w 498"/>
                <a:gd name="T3" fmla="*/ 78 h 312"/>
                <a:gd name="T4" fmla="*/ 342 w 498"/>
                <a:gd name="T5" fmla="*/ 0 h 312"/>
                <a:gd name="T6" fmla="*/ 498 w 498"/>
                <a:gd name="T7" fmla="*/ 156 h 312"/>
                <a:gd name="T8" fmla="*/ 342 w 498"/>
                <a:gd name="T9" fmla="*/ 312 h 312"/>
                <a:gd name="T10" fmla="*/ 342 w 498"/>
                <a:gd name="T11" fmla="*/ 234 h 312"/>
                <a:gd name="T12" fmla="*/ 0 w 498"/>
                <a:gd name="T13" fmla="*/ 234 h 312"/>
                <a:gd name="T14" fmla="*/ 0 w 498"/>
                <a:gd name="T15" fmla="*/ 78 h 3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98" h="312">
                  <a:moveTo>
                    <a:pt x="0" y="78"/>
                  </a:moveTo>
                  <a:lnTo>
                    <a:pt x="342" y="78"/>
                  </a:lnTo>
                  <a:lnTo>
                    <a:pt x="342" y="0"/>
                  </a:lnTo>
                  <a:lnTo>
                    <a:pt x="498" y="156"/>
                  </a:lnTo>
                  <a:lnTo>
                    <a:pt x="342" y="312"/>
                  </a:lnTo>
                  <a:lnTo>
                    <a:pt x="342" y="234"/>
                  </a:lnTo>
                  <a:lnTo>
                    <a:pt x="0" y="234"/>
                  </a:lnTo>
                  <a:lnTo>
                    <a:pt x="0" y="78"/>
                  </a:lnTo>
                  <a:close/>
                </a:path>
              </a:pathLst>
            </a:custGeom>
            <a:solidFill>
              <a:srgbClr val="F2F2F2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4" name="Freeform 142">
              <a:extLst>
                <a:ext uri="{FF2B5EF4-FFF2-40B4-BE49-F238E27FC236}">
                  <a16:creationId xmlns:a16="http://schemas.microsoft.com/office/drawing/2014/main" id="{DE533852-1089-49EF-A97F-35D4C493606D}"/>
                </a:ext>
              </a:extLst>
            </p:cNvPr>
            <p:cNvSpPr>
              <a:spLocks/>
            </p:cNvSpPr>
            <p:nvPr/>
          </p:nvSpPr>
          <p:spPr bwMode="auto">
            <a:xfrm>
              <a:off x="2414" y="2546"/>
              <a:ext cx="498" cy="312"/>
            </a:xfrm>
            <a:custGeom>
              <a:avLst/>
              <a:gdLst>
                <a:gd name="T0" fmla="*/ 0 w 498"/>
                <a:gd name="T1" fmla="*/ 78 h 312"/>
                <a:gd name="T2" fmla="*/ 342 w 498"/>
                <a:gd name="T3" fmla="*/ 78 h 312"/>
                <a:gd name="T4" fmla="*/ 342 w 498"/>
                <a:gd name="T5" fmla="*/ 0 h 312"/>
                <a:gd name="T6" fmla="*/ 498 w 498"/>
                <a:gd name="T7" fmla="*/ 156 h 312"/>
                <a:gd name="T8" fmla="*/ 342 w 498"/>
                <a:gd name="T9" fmla="*/ 312 h 312"/>
                <a:gd name="T10" fmla="*/ 342 w 498"/>
                <a:gd name="T11" fmla="*/ 234 h 312"/>
                <a:gd name="T12" fmla="*/ 0 w 498"/>
                <a:gd name="T13" fmla="*/ 234 h 312"/>
                <a:gd name="T14" fmla="*/ 0 w 498"/>
                <a:gd name="T15" fmla="*/ 78 h 3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98" h="312">
                  <a:moveTo>
                    <a:pt x="0" y="78"/>
                  </a:moveTo>
                  <a:lnTo>
                    <a:pt x="342" y="78"/>
                  </a:lnTo>
                  <a:lnTo>
                    <a:pt x="342" y="0"/>
                  </a:lnTo>
                  <a:lnTo>
                    <a:pt x="498" y="156"/>
                  </a:lnTo>
                  <a:lnTo>
                    <a:pt x="342" y="312"/>
                  </a:lnTo>
                  <a:lnTo>
                    <a:pt x="342" y="234"/>
                  </a:lnTo>
                  <a:lnTo>
                    <a:pt x="0" y="234"/>
                  </a:lnTo>
                  <a:lnTo>
                    <a:pt x="0" y="78"/>
                  </a:lnTo>
                  <a:close/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5" name="Rectangle 143">
              <a:extLst>
                <a:ext uri="{FF2B5EF4-FFF2-40B4-BE49-F238E27FC236}">
                  <a16:creationId xmlns:a16="http://schemas.microsoft.com/office/drawing/2014/main" id="{FA42B749-577C-41EF-A176-E7B7B9AE56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5" y="2664"/>
              <a:ext cx="41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S analysi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Freeform 144">
              <a:extLst>
                <a:ext uri="{FF2B5EF4-FFF2-40B4-BE49-F238E27FC236}">
                  <a16:creationId xmlns:a16="http://schemas.microsoft.com/office/drawing/2014/main" id="{238F77D5-1CF8-4E91-AF80-3C7122B0C396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7" y="4172"/>
              <a:ext cx="653" cy="311"/>
            </a:xfrm>
            <a:custGeom>
              <a:avLst/>
              <a:gdLst>
                <a:gd name="T0" fmla="*/ 653 w 653"/>
                <a:gd name="T1" fmla="*/ 78 h 311"/>
                <a:gd name="T2" fmla="*/ 155 w 653"/>
                <a:gd name="T3" fmla="*/ 78 h 311"/>
                <a:gd name="T4" fmla="*/ 155 w 653"/>
                <a:gd name="T5" fmla="*/ 0 h 311"/>
                <a:gd name="T6" fmla="*/ 0 w 653"/>
                <a:gd name="T7" fmla="*/ 156 h 311"/>
                <a:gd name="T8" fmla="*/ 155 w 653"/>
                <a:gd name="T9" fmla="*/ 311 h 311"/>
                <a:gd name="T10" fmla="*/ 155 w 653"/>
                <a:gd name="T11" fmla="*/ 234 h 311"/>
                <a:gd name="T12" fmla="*/ 653 w 653"/>
                <a:gd name="T13" fmla="*/ 234 h 311"/>
                <a:gd name="T14" fmla="*/ 653 w 653"/>
                <a:gd name="T15" fmla="*/ 78 h 3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53" h="311">
                  <a:moveTo>
                    <a:pt x="653" y="78"/>
                  </a:moveTo>
                  <a:lnTo>
                    <a:pt x="155" y="78"/>
                  </a:lnTo>
                  <a:lnTo>
                    <a:pt x="155" y="0"/>
                  </a:lnTo>
                  <a:lnTo>
                    <a:pt x="0" y="156"/>
                  </a:lnTo>
                  <a:lnTo>
                    <a:pt x="155" y="311"/>
                  </a:lnTo>
                  <a:lnTo>
                    <a:pt x="155" y="234"/>
                  </a:lnTo>
                  <a:lnTo>
                    <a:pt x="653" y="234"/>
                  </a:lnTo>
                  <a:lnTo>
                    <a:pt x="653" y="78"/>
                  </a:lnTo>
                  <a:close/>
                </a:path>
              </a:pathLst>
            </a:custGeom>
            <a:solidFill>
              <a:srgbClr val="F2F2F2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7" name="Freeform 145">
              <a:extLst>
                <a:ext uri="{FF2B5EF4-FFF2-40B4-BE49-F238E27FC236}">
                  <a16:creationId xmlns:a16="http://schemas.microsoft.com/office/drawing/2014/main" id="{D1F7D360-332C-4054-8BC1-081B6EF34F61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7" y="4172"/>
              <a:ext cx="653" cy="311"/>
            </a:xfrm>
            <a:custGeom>
              <a:avLst/>
              <a:gdLst>
                <a:gd name="T0" fmla="*/ 653 w 653"/>
                <a:gd name="T1" fmla="*/ 78 h 311"/>
                <a:gd name="T2" fmla="*/ 155 w 653"/>
                <a:gd name="T3" fmla="*/ 78 h 311"/>
                <a:gd name="T4" fmla="*/ 155 w 653"/>
                <a:gd name="T5" fmla="*/ 0 h 311"/>
                <a:gd name="T6" fmla="*/ 0 w 653"/>
                <a:gd name="T7" fmla="*/ 156 h 311"/>
                <a:gd name="T8" fmla="*/ 155 w 653"/>
                <a:gd name="T9" fmla="*/ 311 h 311"/>
                <a:gd name="T10" fmla="*/ 155 w 653"/>
                <a:gd name="T11" fmla="*/ 234 h 311"/>
                <a:gd name="T12" fmla="*/ 653 w 653"/>
                <a:gd name="T13" fmla="*/ 234 h 311"/>
                <a:gd name="T14" fmla="*/ 653 w 653"/>
                <a:gd name="T15" fmla="*/ 78 h 3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53" h="311">
                  <a:moveTo>
                    <a:pt x="653" y="78"/>
                  </a:moveTo>
                  <a:lnTo>
                    <a:pt x="155" y="78"/>
                  </a:lnTo>
                  <a:lnTo>
                    <a:pt x="155" y="0"/>
                  </a:lnTo>
                  <a:lnTo>
                    <a:pt x="0" y="156"/>
                  </a:lnTo>
                  <a:lnTo>
                    <a:pt x="155" y="311"/>
                  </a:lnTo>
                  <a:lnTo>
                    <a:pt x="155" y="234"/>
                  </a:lnTo>
                  <a:lnTo>
                    <a:pt x="653" y="234"/>
                  </a:lnTo>
                  <a:lnTo>
                    <a:pt x="653" y="78"/>
                  </a:lnTo>
                  <a:close/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" name="Rectangle 146">
              <a:extLst>
                <a:ext uri="{FF2B5EF4-FFF2-40B4-BE49-F238E27FC236}">
                  <a16:creationId xmlns:a16="http://schemas.microsoft.com/office/drawing/2014/main" id="{801C4BFF-32B9-4279-9D59-CD7A1CAF3B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0" y="4287"/>
              <a:ext cx="432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RS score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Freeform 147">
              <a:extLst>
                <a:ext uri="{FF2B5EF4-FFF2-40B4-BE49-F238E27FC236}">
                  <a16:creationId xmlns:a16="http://schemas.microsoft.com/office/drawing/2014/main" id="{BF15BCE9-4589-4E92-8A66-10CDE2856FF6}"/>
                </a:ext>
              </a:extLst>
            </p:cNvPr>
            <p:cNvSpPr>
              <a:spLocks/>
            </p:cNvSpPr>
            <p:nvPr/>
          </p:nvSpPr>
          <p:spPr bwMode="auto">
            <a:xfrm>
              <a:off x="4899" y="3325"/>
              <a:ext cx="280" cy="280"/>
            </a:xfrm>
            <a:custGeom>
              <a:avLst/>
              <a:gdLst>
                <a:gd name="T0" fmla="*/ 0 w 280"/>
                <a:gd name="T1" fmla="*/ 140 h 280"/>
                <a:gd name="T2" fmla="*/ 70 w 280"/>
                <a:gd name="T3" fmla="*/ 140 h 280"/>
                <a:gd name="T4" fmla="*/ 70 w 280"/>
                <a:gd name="T5" fmla="*/ 0 h 280"/>
                <a:gd name="T6" fmla="*/ 210 w 280"/>
                <a:gd name="T7" fmla="*/ 0 h 280"/>
                <a:gd name="T8" fmla="*/ 210 w 280"/>
                <a:gd name="T9" fmla="*/ 140 h 280"/>
                <a:gd name="T10" fmla="*/ 280 w 280"/>
                <a:gd name="T11" fmla="*/ 140 h 280"/>
                <a:gd name="T12" fmla="*/ 140 w 280"/>
                <a:gd name="T13" fmla="*/ 280 h 280"/>
                <a:gd name="T14" fmla="*/ 0 w 280"/>
                <a:gd name="T15" fmla="*/ 14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80" h="280">
                  <a:moveTo>
                    <a:pt x="0" y="140"/>
                  </a:moveTo>
                  <a:lnTo>
                    <a:pt x="70" y="140"/>
                  </a:lnTo>
                  <a:lnTo>
                    <a:pt x="70" y="0"/>
                  </a:lnTo>
                  <a:lnTo>
                    <a:pt x="210" y="0"/>
                  </a:lnTo>
                  <a:lnTo>
                    <a:pt x="210" y="140"/>
                  </a:lnTo>
                  <a:lnTo>
                    <a:pt x="280" y="140"/>
                  </a:lnTo>
                  <a:lnTo>
                    <a:pt x="140" y="280"/>
                  </a:lnTo>
                  <a:lnTo>
                    <a:pt x="0" y="140"/>
                  </a:lnTo>
                  <a:close/>
                </a:path>
              </a:pathLst>
            </a:custGeom>
            <a:solidFill>
              <a:srgbClr val="F2F2F2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" name="Freeform 148">
              <a:extLst>
                <a:ext uri="{FF2B5EF4-FFF2-40B4-BE49-F238E27FC236}">
                  <a16:creationId xmlns:a16="http://schemas.microsoft.com/office/drawing/2014/main" id="{081FEA3B-CA44-4199-9881-896193D1CB3C}"/>
                </a:ext>
              </a:extLst>
            </p:cNvPr>
            <p:cNvSpPr>
              <a:spLocks/>
            </p:cNvSpPr>
            <p:nvPr/>
          </p:nvSpPr>
          <p:spPr bwMode="auto">
            <a:xfrm>
              <a:off x="4899" y="3325"/>
              <a:ext cx="280" cy="280"/>
            </a:xfrm>
            <a:custGeom>
              <a:avLst/>
              <a:gdLst>
                <a:gd name="T0" fmla="*/ 0 w 280"/>
                <a:gd name="T1" fmla="*/ 140 h 280"/>
                <a:gd name="T2" fmla="*/ 70 w 280"/>
                <a:gd name="T3" fmla="*/ 140 h 280"/>
                <a:gd name="T4" fmla="*/ 70 w 280"/>
                <a:gd name="T5" fmla="*/ 0 h 280"/>
                <a:gd name="T6" fmla="*/ 210 w 280"/>
                <a:gd name="T7" fmla="*/ 0 h 280"/>
                <a:gd name="T8" fmla="*/ 210 w 280"/>
                <a:gd name="T9" fmla="*/ 140 h 280"/>
                <a:gd name="T10" fmla="*/ 280 w 280"/>
                <a:gd name="T11" fmla="*/ 140 h 280"/>
                <a:gd name="T12" fmla="*/ 140 w 280"/>
                <a:gd name="T13" fmla="*/ 280 h 280"/>
                <a:gd name="T14" fmla="*/ 0 w 280"/>
                <a:gd name="T15" fmla="*/ 14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80" h="280">
                  <a:moveTo>
                    <a:pt x="0" y="140"/>
                  </a:moveTo>
                  <a:lnTo>
                    <a:pt x="70" y="140"/>
                  </a:lnTo>
                  <a:lnTo>
                    <a:pt x="70" y="0"/>
                  </a:lnTo>
                  <a:lnTo>
                    <a:pt x="210" y="0"/>
                  </a:lnTo>
                  <a:lnTo>
                    <a:pt x="210" y="140"/>
                  </a:lnTo>
                  <a:lnTo>
                    <a:pt x="280" y="140"/>
                  </a:lnTo>
                  <a:lnTo>
                    <a:pt x="140" y="280"/>
                  </a:lnTo>
                  <a:lnTo>
                    <a:pt x="0" y="140"/>
                  </a:lnTo>
                  <a:close/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41" name="Picture 149">
              <a:extLst>
                <a:ext uri="{FF2B5EF4-FFF2-40B4-BE49-F238E27FC236}">
                  <a16:creationId xmlns:a16="http://schemas.microsoft.com/office/drawing/2014/main" id="{97E66140-A148-476F-8747-00EA3FF8597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45" y="1955"/>
              <a:ext cx="965" cy="12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2" name="Rectangle 150">
              <a:extLst>
                <a:ext uri="{FF2B5EF4-FFF2-40B4-BE49-F238E27FC236}">
                  <a16:creationId xmlns:a16="http://schemas.microsoft.com/office/drawing/2014/main" id="{9A13447E-905A-45EA-9DF0-518A69A51F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5" y="3174"/>
              <a:ext cx="860" cy="1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TQ XL Orbitrap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pic>
          <p:nvPicPr>
            <p:cNvPr id="43" name="Picture 151">
              <a:extLst>
                <a:ext uri="{FF2B5EF4-FFF2-40B4-BE49-F238E27FC236}">
                  <a16:creationId xmlns:a16="http://schemas.microsoft.com/office/drawing/2014/main" id="{96120E7C-9728-4FEB-BFAF-C1ACCB9F965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35" y="1955"/>
              <a:ext cx="1623" cy="12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4" name="Rectangle 152">
              <a:extLst>
                <a:ext uri="{FF2B5EF4-FFF2-40B4-BE49-F238E27FC236}">
                  <a16:creationId xmlns:a16="http://schemas.microsoft.com/office/drawing/2014/main" id="{8031D37A-5349-4D7B-9657-2BC58BA06F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2" y="1830"/>
              <a:ext cx="2677" cy="1490"/>
            </a:xfrm>
            <a:prstGeom prst="rect">
              <a:avLst/>
            </a:prstGeom>
            <a:noFill/>
            <a:ln w="6350" cap="flat">
              <a:solidFill>
                <a:srgbClr val="A6A6A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45" name="Picture 153">
              <a:extLst>
                <a:ext uri="{FF2B5EF4-FFF2-40B4-BE49-F238E27FC236}">
                  <a16:creationId xmlns:a16="http://schemas.microsoft.com/office/drawing/2014/main" id="{A545E0B9-B2A3-428B-B2DC-1EB946E57B7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36" y="2592"/>
              <a:ext cx="297" cy="4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6" name="Picture 154">
              <a:extLst>
                <a:ext uri="{FF2B5EF4-FFF2-40B4-BE49-F238E27FC236}">
                  <a16:creationId xmlns:a16="http://schemas.microsoft.com/office/drawing/2014/main" id="{6C31CCB7-B828-4BD8-A7BC-D8CDF9B11D7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93" y="2641"/>
              <a:ext cx="436" cy="6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7" name="Freeform 155">
              <a:extLst>
                <a:ext uri="{FF2B5EF4-FFF2-40B4-BE49-F238E27FC236}">
                  <a16:creationId xmlns:a16="http://schemas.microsoft.com/office/drawing/2014/main" id="{FEE629E0-7FA0-4C20-861F-D1ED0A0A0458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6" y="2396"/>
              <a:ext cx="119" cy="128"/>
            </a:xfrm>
            <a:custGeom>
              <a:avLst/>
              <a:gdLst>
                <a:gd name="T0" fmla="*/ 223 w 1528"/>
                <a:gd name="T1" fmla="*/ 1320 h 1648"/>
                <a:gd name="T2" fmla="*/ 362 w 1528"/>
                <a:gd name="T3" fmla="*/ 404 h 1648"/>
                <a:gd name="T4" fmla="*/ 362 w 1528"/>
                <a:gd name="T5" fmla="*/ 404 h 1648"/>
                <a:gd name="T6" fmla="*/ 904 w 1528"/>
                <a:gd name="T7" fmla="*/ 0 h 1648"/>
                <a:gd name="T8" fmla="*/ 1306 w 1528"/>
                <a:gd name="T9" fmla="*/ 510 h 1648"/>
                <a:gd name="T10" fmla="*/ 1167 w 1528"/>
                <a:gd name="T11" fmla="*/ 1425 h 1648"/>
                <a:gd name="T12" fmla="*/ 1167 w 1528"/>
                <a:gd name="T13" fmla="*/ 1425 h 1648"/>
                <a:gd name="T14" fmla="*/ 223 w 1528"/>
                <a:gd name="T15" fmla="*/ 1320 h 1648"/>
                <a:gd name="T16" fmla="*/ 223 w 1528"/>
                <a:gd name="T17" fmla="*/ 1320 h 16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528" h="1648">
                  <a:moveTo>
                    <a:pt x="223" y="1320"/>
                  </a:moveTo>
                  <a:cubicBezTo>
                    <a:pt x="0" y="1037"/>
                    <a:pt x="63" y="628"/>
                    <a:pt x="362" y="404"/>
                  </a:cubicBezTo>
                  <a:cubicBezTo>
                    <a:pt x="362" y="404"/>
                    <a:pt x="362" y="404"/>
                    <a:pt x="362" y="404"/>
                  </a:cubicBezTo>
                  <a:cubicBezTo>
                    <a:pt x="542" y="270"/>
                    <a:pt x="724" y="135"/>
                    <a:pt x="904" y="0"/>
                  </a:cubicBezTo>
                  <a:cubicBezTo>
                    <a:pt x="1038" y="170"/>
                    <a:pt x="1172" y="340"/>
                    <a:pt x="1306" y="510"/>
                  </a:cubicBezTo>
                  <a:cubicBezTo>
                    <a:pt x="1528" y="792"/>
                    <a:pt x="1466" y="1202"/>
                    <a:pt x="1167" y="1425"/>
                  </a:cubicBezTo>
                  <a:cubicBezTo>
                    <a:pt x="1167" y="1425"/>
                    <a:pt x="1167" y="1425"/>
                    <a:pt x="1167" y="1425"/>
                  </a:cubicBezTo>
                  <a:cubicBezTo>
                    <a:pt x="867" y="1648"/>
                    <a:pt x="445" y="1602"/>
                    <a:pt x="223" y="1320"/>
                  </a:cubicBezTo>
                  <a:cubicBezTo>
                    <a:pt x="223" y="1320"/>
                    <a:pt x="223" y="1320"/>
                    <a:pt x="223" y="1320"/>
                  </a:cubicBezTo>
                </a:path>
              </a:pathLst>
            </a:cu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" name="Freeform 156">
              <a:extLst>
                <a:ext uri="{FF2B5EF4-FFF2-40B4-BE49-F238E27FC236}">
                  <a16:creationId xmlns:a16="http://schemas.microsoft.com/office/drawing/2014/main" id="{954C0F14-5E8C-4422-9D19-29C94902678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6" y="2395"/>
              <a:ext cx="119" cy="129"/>
            </a:xfrm>
            <a:custGeom>
              <a:avLst/>
              <a:gdLst>
                <a:gd name="T0" fmla="*/ 17 w 119"/>
                <a:gd name="T1" fmla="*/ 103 h 129"/>
                <a:gd name="T2" fmla="*/ 28 w 119"/>
                <a:gd name="T3" fmla="*/ 32 h 129"/>
                <a:gd name="T4" fmla="*/ 28 w 119"/>
                <a:gd name="T5" fmla="*/ 32 h 129"/>
                <a:gd name="T6" fmla="*/ 70 w 119"/>
                <a:gd name="T7" fmla="*/ 0 h 129"/>
                <a:gd name="T8" fmla="*/ 102 w 119"/>
                <a:gd name="T9" fmla="*/ 40 h 129"/>
                <a:gd name="T10" fmla="*/ 91 w 119"/>
                <a:gd name="T11" fmla="*/ 111 h 129"/>
                <a:gd name="T12" fmla="*/ 91 w 119"/>
                <a:gd name="T13" fmla="*/ 111 h 129"/>
                <a:gd name="T14" fmla="*/ 17 w 119"/>
                <a:gd name="T15" fmla="*/ 103 h 129"/>
                <a:gd name="T16" fmla="*/ 17 w 119"/>
                <a:gd name="T17" fmla="*/ 103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19" h="129">
                  <a:moveTo>
                    <a:pt x="17" y="103"/>
                  </a:moveTo>
                  <a:cubicBezTo>
                    <a:pt x="0" y="81"/>
                    <a:pt x="5" y="49"/>
                    <a:pt x="28" y="32"/>
                  </a:cubicBezTo>
                  <a:cubicBezTo>
                    <a:pt x="28" y="32"/>
                    <a:pt x="28" y="32"/>
                    <a:pt x="28" y="32"/>
                  </a:cubicBezTo>
                  <a:cubicBezTo>
                    <a:pt x="42" y="22"/>
                    <a:pt x="56" y="11"/>
                    <a:pt x="70" y="0"/>
                  </a:cubicBezTo>
                  <a:cubicBezTo>
                    <a:pt x="81" y="14"/>
                    <a:pt x="91" y="27"/>
                    <a:pt x="102" y="40"/>
                  </a:cubicBezTo>
                  <a:cubicBezTo>
                    <a:pt x="119" y="62"/>
                    <a:pt x="114" y="94"/>
                    <a:pt x="91" y="111"/>
                  </a:cubicBezTo>
                  <a:cubicBezTo>
                    <a:pt x="91" y="111"/>
                    <a:pt x="91" y="111"/>
                    <a:pt x="91" y="111"/>
                  </a:cubicBezTo>
                  <a:cubicBezTo>
                    <a:pt x="68" y="129"/>
                    <a:pt x="35" y="125"/>
                    <a:pt x="17" y="103"/>
                  </a:cubicBezTo>
                  <a:cubicBezTo>
                    <a:pt x="17" y="103"/>
                    <a:pt x="17" y="103"/>
                    <a:pt x="17" y="103"/>
                  </a:cubicBezTo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" name="Freeform 157">
              <a:extLst>
                <a:ext uri="{FF2B5EF4-FFF2-40B4-BE49-F238E27FC236}">
                  <a16:creationId xmlns:a16="http://schemas.microsoft.com/office/drawing/2014/main" id="{C5E4D718-7D64-40BB-9F0B-5BD1BC9F2EB9}"/>
                </a:ext>
              </a:extLst>
            </p:cNvPr>
            <p:cNvSpPr>
              <a:spLocks/>
            </p:cNvSpPr>
            <p:nvPr/>
          </p:nvSpPr>
          <p:spPr bwMode="auto">
            <a:xfrm>
              <a:off x="947" y="2547"/>
              <a:ext cx="947" cy="155"/>
            </a:xfrm>
            <a:custGeom>
              <a:avLst/>
              <a:gdLst>
                <a:gd name="T0" fmla="*/ 12140 w 12168"/>
                <a:gd name="T1" fmla="*/ 212 h 2000"/>
                <a:gd name="T2" fmla="*/ 11942 w 12168"/>
                <a:gd name="T3" fmla="*/ 566 h 2000"/>
                <a:gd name="T4" fmla="*/ 11776 w 12168"/>
                <a:gd name="T5" fmla="*/ 724 h 2000"/>
                <a:gd name="T6" fmla="*/ 11356 w 12168"/>
                <a:gd name="T7" fmla="*/ 939 h 2000"/>
                <a:gd name="T8" fmla="*/ 11096 w 12168"/>
                <a:gd name="T9" fmla="*/ 997 h 2000"/>
                <a:gd name="T10" fmla="*/ 6975 w 12168"/>
                <a:gd name="T11" fmla="*/ 1035 h 2000"/>
                <a:gd name="T12" fmla="*/ 6744 w 12168"/>
                <a:gd name="T13" fmla="*/ 1093 h 2000"/>
                <a:gd name="T14" fmla="*/ 6333 w 12168"/>
                <a:gd name="T15" fmla="*/ 1300 h 2000"/>
                <a:gd name="T16" fmla="*/ 6181 w 12168"/>
                <a:gd name="T17" fmla="*/ 1435 h 2000"/>
                <a:gd name="T18" fmla="*/ 5992 w 12168"/>
                <a:gd name="T19" fmla="*/ 1785 h 2000"/>
                <a:gd name="T20" fmla="*/ 5926 w 12168"/>
                <a:gd name="T21" fmla="*/ 2000 h 2000"/>
                <a:gd name="T22" fmla="*/ 5865 w 12168"/>
                <a:gd name="T23" fmla="*/ 1785 h 2000"/>
                <a:gd name="T24" fmla="*/ 5676 w 12168"/>
                <a:gd name="T25" fmla="*/ 1435 h 2000"/>
                <a:gd name="T26" fmla="*/ 5529 w 12168"/>
                <a:gd name="T27" fmla="*/ 1300 h 2000"/>
                <a:gd name="T28" fmla="*/ 5118 w 12168"/>
                <a:gd name="T29" fmla="*/ 1093 h 2000"/>
                <a:gd name="T30" fmla="*/ 4887 w 12168"/>
                <a:gd name="T31" fmla="*/ 1035 h 2000"/>
                <a:gd name="T32" fmla="*/ 1078 w 12168"/>
                <a:gd name="T33" fmla="*/ 997 h 2000"/>
                <a:gd name="T34" fmla="*/ 818 w 12168"/>
                <a:gd name="T35" fmla="*/ 939 h 2000"/>
                <a:gd name="T36" fmla="*/ 397 w 12168"/>
                <a:gd name="T37" fmla="*/ 724 h 2000"/>
                <a:gd name="T38" fmla="*/ 227 w 12168"/>
                <a:gd name="T39" fmla="*/ 566 h 2000"/>
                <a:gd name="T40" fmla="*/ 29 w 12168"/>
                <a:gd name="T41" fmla="*/ 212 h 2000"/>
                <a:gd name="T42" fmla="*/ 71 w 12168"/>
                <a:gd name="T43" fmla="*/ 0 h 2000"/>
                <a:gd name="T44" fmla="*/ 175 w 12168"/>
                <a:gd name="T45" fmla="*/ 377 h 2000"/>
                <a:gd name="T46" fmla="*/ 284 w 12168"/>
                <a:gd name="T47" fmla="*/ 531 h 2000"/>
                <a:gd name="T48" fmla="*/ 634 w 12168"/>
                <a:gd name="T49" fmla="*/ 793 h 2000"/>
                <a:gd name="T50" fmla="*/ 846 w 12168"/>
                <a:gd name="T51" fmla="*/ 881 h 2000"/>
                <a:gd name="T52" fmla="*/ 1338 w 12168"/>
                <a:gd name="T53" fmla="*/ 954 h 2000"/>
                <a:gd name="T54" fmla="*/ 4901 w 12168"/>
                <a:gd name="T55" fmla="*/ 977 h 2000"/>
                <a:gd name="T56" fmla="*/ 5373 w 12168"/>
                <a:gd name="T57" fmla="*/ 1127 h 2000"/>
                <a:gd name="T58" fmla="*/ 5581 w 12168"/>
                <a:gd name="T59" fmla="*/ 1254 h 2000"/>
                <a:gd name="T60" fmla="*/ 5855 w 12168"/>
                <a:gd name="T61" fmla="*/ 1577 h 2000"/>
                <a:gd name="T62" fmla="*/ 5936 w 12168"/>
                <a:gd name="T63" fmla="*/ 1774 h 2000"/>
                <a:gd name="T64" fmla="*/ 5921 w 12168"/>
                <a:gd name="T65" fmla="*/ 1774 h 2000"/>
                <a:gd name="T66" fmla="*/ 6002 w 12168"/>
                <a:gd name="T67" fmla="*/ 1577 h 2000"/>
                <a:gd name="T68" fmla="*/ 6281 w 12168"/>
                <a:gd name="T69" fmla="*/ 1254 h 2000"/>
                <a:gd name="T70" fmla="*/ 6488 w 12168"/>
                <a:gd name="T71" fmla="*/ 1127 h 2000"/>
                <a:gd name="T72" fmla="*/ 6961 w 12168"/>
                <a:gd name="T73" fmla="*/ 977 h 2000"/>
                <a:gd name="T74" fmla="*/ 10831 w 12168"/>
                <a:gd name="T75" fmla="*/ 954 h 2000"/>
                <a:gd name="T76" fmla="*/ 11327 w 12168"/>
                <a:gd name="T77" fmla="*/ 881 h 2000"/>
                <a:gd name="T78" fmla="*/ 11540 w 12168"/>
                <a:gd name="T79" fmla="*/ 793 h 2000"/>
                <a:gd name="T80" fmla="*/ 11880 w 12168"/>
                <a:gd name="T81" fmla="*/ 531 h 2000"/>
                <a:gd name="T82" fmla="*/ 11994 w 12168"/>
                <a:gd name="T83" fmla="*/ 377 h 2000"/>
                <a:gd name="T84" fmla="*/ 12098 w 12168"/>
                <a:gd name="T85" fmla="*/ 0 h 20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12168" h="2000">
                  <a:moveTo>
                    <a:pt x="12168" y="4"/>
                  </a:moveTo>
                  <a:lnTo>
                    <a:pt x="12140" y="204"/>
                  </a:lnTo>
                  <a:cubicBezTo>
                    <a:pt x="12140" y="208"/>
                    <a:pt x="12140" y="208"/>
                    <a:pt x="12140" y="212"/>
                  </a:cubicBezTo>
                  <a:lnTo>
                    <a:pt x="12065" y="397"/>
                  </a:lnTo>
                  <a:cubicBezTo>
                    <a:pt x="12065" y="400"/>
                    <a:pt x="12065" y="400"/>
                    <a:pt x="12060" y="400"/>
                  </a:cubicBezTo>
                  <a:lnTo>
                    <a:pt x="11942" y="566"/>
                  </a:lnTo>
                  <a:cubicBezTo>
                    <a:pt x="11942" y="570"/>
                    <a:pt x="11942" y="570"/>
                    <a:pt x="11942" y="574"/>
                  </a:cubicBezTo>
                  <a:lnTo>
                    <a:pt x="11786" y="720"/>
                  </a:lnTo>
                  <a:cubicBezTo>
                    <a:pt x="11781" y="720"/>
                    <a:pt x="11781" y="724"/>
                    <a:pt x="11776" y="724"/>
                  </a:cubicBezTo>
                  <a:lnTo>
                    <a:pt x="11583" y="843"/>
                  </a:lnTo>
                  <a:cubicBezTo>
                    <a:pt x="11583" y="843"/>
                    <a:pt x="11583" y="843"/>
                    <a:pt x="11578" y="847"/>
                  </a:cubicBezTo>
                  <a:lnTo>
                    <a:pt x="11356" y="939"/>
                  </a:lnTo>
                  <a:cubicBezTo>
                    <a:pt x="11356" y="939"/>
                    <a:pt x="11351" y="939"/>
                    <a:pt x="11351" y="939"/>
                  </a:cubicBezTo>
                  <a:lnTo>
                    <a:pt x="11105" y="997"/>
                  </a:lnTo>
                  <a:cubicBezTo>
                    <a:pt x="11101" y="997"/>
                    <a:pt x="11101" y="997"/>
                    <a:pt x="11096" y="997"/>
                  </a:cubicBezTo>
                  <a:lnTo>
                    <a:pt x="10836" y="1016"/>
                  </a:lnTo>
                  <a:lnTo>
                    <a:pt x="7230" y="1016"/>
                  </a:lnTo>
                  <a:lnTo>
                    <a:pt x="6975" y="1035"/>
                  </a:lnTo>
                  <a:lnTo>
                    <a:pt x="6985" y="1035"/>
                  </a:lnTo>
                  <a:lnTo>
                    <a:pt x="6739" y="1093"/>
                  </a:lnTo>
                  <a:lnTo>
                    <a:pt x="6744" y="1093"/>
                  </a:lnTo>
                  <a:lnTo>
                    <a:pt x="6522" y="1185"/>
                  </a:lnTo>
                  <a:lnTo>
                    <a:pt x="6526" y="1181"/>
                  </a:lnTo>
                  <a:lnTo>
                    <a:pt x="6333" y="1300"/>
                  </a:lnTo>
                  <a:lnTo>
                    <a:pt x="6337" y="1297"/>
                  </a:lnTo>
                  <a:lnTo>
                    <a:pt x="6177" y="1443"/>
                  </a:lnTo>
                  <a:lnTo>
                    <a:pt x="6181" y="1435"/>
                  </a:lnTo>
                  <a:lnTo>
                    <a:pt x="6063" y="1604"/>
                  </a:lnTo>
                  <a:lnTo>
                    <a:pt x="6068" y="1600"/>
                  </a:lnTo>
                  <a:lnTo>
                    <a:pt x="5992" y="1785"/>
                  </a:lnTo>
                  <a:lnTo>
                    <a:pt x="5992" y="1777"/>
                  </a:lnTo>
                  <a:lnTo>
                    <a:pt x="5964" y="1974"/>
                  </a:lnTo>
                  <a:cubicBezTo>
                    <a:pt x="5964" y="1989"/>
                    <a:pt x="5950" y="2000"/>
                    <a:pt x="5926" y="2000"/>
                  </a:cubicBezTo>
                  <a:cubicBezTo>
                    <a:pt x="5907" y="2000"/>
                    <a:pt x="5893" y="1989"/>
                    <a:pt x="5893" y="1974"/>
                  </a:cubicBezTo>
                  <a:lnTo>
                    <a:pt x="5865" y="1777"/>
                  </a:lnTo>
                  <a:lnTo>
                    <a:pt x="5865" y="1785"/>
                  </a:lnTo>
                  <a:lnTo>
                    <a:pt x="5789" y="1600"/>
                  </a:lnTo>
                  <a:lnTo>
                    <a:pt x="5794" y="1604"/>
                  </a:lnTo>
                  <a:lnTo>
                    <a:pt x="5676" y="1435"/>
                  </a:lnTo>
                  <a:lnTo>
                    <a:pt x="5676" y="1443"/>
                  </a:lnTo>
                  <a:lnTo>
                    <a:pt x="5520" y="1297"/>
                  </a:lnTo>
                  <a:lnTo>
                    <a:pt x="5529" y="1300"/>
                  </a:lnTo>
                  <a:lnTo>
                    <a:pt x="5335" y="1181"/>
                  </a:lnTo>
                  <a:lnTo>
                    <a:pt x="5340" y="1185"/>
                  </a:lnTo>
                  <a:lnTo>
                    <a:pt x="5118" y="1093"/>
                  </a:lnTo>
                  <a:lnTo>
                    <a:pt x="5123" y="1093"/>
                  </a:lnTo>
                  <a:lnTo>
                    <a:pt x="4877" y="1035"/>
                  </a:lnTo>
                  <a:lnTo>
                    <a:pt x="4887" y="1035"/>
                  </a:lnTo>
                  <a:lnTo>
                    <a:pt x="4627" y="1016"/>
                  </a:lnTo>
                  <a:lnTo>
                    <a:pt x="1338" y="1016"/>
                  </a:lnTo>
                  <a:lnTo>
                    <a:pt x="1078" y="997"/>
                  </a:lnTo>
                  <a:cubicBezTo>
                    <a:pt x="1073" y="997"/>
                    <a:pt x="1073" y="997"/>
                    <a:pt x="1068" y="997"/>
                  </a:cubicBezTo>
                  <a:lnTo>
                    <a:pt x="823" y="939"/>
                  </a:lnTo>
                  <a:cubicBezTo>
                    <a:pt x="823" y="939"/>
                    <a:pt x="818" y="939"/>
                    <a:pt x="818" y="939"/>
                  </a:cubicBezTo>
                  <a:lnTo>
                    <a:pt x="596" y="847"/>
                  </a:lnTo>
                  <a:cubicBezTo>
                    <a:pt x="591" y="843"/>
                    <a:pt x="591" y="843"/>
                    <a:pt x="591" y="843"/>
                  </a:cubicBezTo>
                  <a:lnTo>
                    <a:pt x="397" y="724"/>
                  </a:lnTo>
                  <a:cubicBezTo>
                    <a:pt x="393" y="724"/>
                    <a:pt x="393" y="720"/>
                    <a:pt x="388" y="720"/>
                  </a:cubicBezTo>
                  <a:lnTo>
                    <a:pt x="227" y="574"/>
                  </a:lnTo>
                  <a:cubicBezTo>
                    <a:pt x="227" y="570"/>
                    <a:pt x="227" y="570"/>
                    <a:pt x="227" y="566"/>
                  </a:cubicBezTo>
                  <a:lnTo>
                    <a:pt x="109" y="400"/>
                  </a:lnTo>
                  <a:cubicBezTo>
                    <a:pt x="104" y="400"/>
                    <a:pt x="104" y="400"/>
                    <a:pt x="104" y="397"/>
                  </a:cubicBezTo>
                  <a:lnTo>
                    <a:pt x="29" y="212"/>
                  </a:lnTo>
                  <a:cubicBezTo>
                    <a:pt x="29" y="208"/>
                    <a:pt x="29" y="208"/>
                    <a:pt x="29" y="204"/>
                  </a:cubicBezTo>
                  <a:lnTo>
                    <a:pt x="0" y="4"/>
                  </a:lnTo>
                  <a:lnTo>
                    <a:pt x="71" y="0"/>
                  </a:lnTo>
                  <a:lnTo>
                    <a:pt x="100" y="200"/>
                  </a:lnTo>
                  <a:lnTo>
                    <a:pt x="100" y="193"/>
                  </a:lnTo>
                  <a:lnTo>
                    <a:pt x="175" y="377"/>
                  </a:lnTo>
                  <a:lnTo>
                    <a:pt x="171" y="370"/>
                  </a:lnTo>
                  <a:lnTo>
                    <a:pt x="289" y="535"/>
                  </a:lnTo>
                  <a:lnTo>
                    <a:pt x="284" y="531"/>
                  </a:lnTo>
                  <a:lnTo>
                    <a:pt x="445" y="677"/>
                  </a:lnTo>
                  <a:lnTo>
                    <a:pt x="440" y="674"/>
                  </a:lnTo>
                  <a:lnTo>
                    <a:pt x="634" y="793"/>
                  </a:lnTo>
                  <a:lnTo>
                    <a:pt x="629" y="789"/>
                  </a:lnTo>
                  <a:lnTo>
                    <a:pt x="851" y="881"/>
                  </a:lnTo>
                  <a:lnTo>
                    <a:pt x="846" y="881"/>
                  </a:lnTo>
                  <a:lnTo>
                    <a:pt x="1092" y="939"/>
                  </a:lnTo>
                  <a:lnTo>
                    <a:pt x="1083" y="935"/>
                  </a:lnTo>
                  <a:lnTo>
                    <a:pt x="1338" y="954"/>
                  </a:lnTo>
                  <a:lnTo>
                    <a:pt x="4631" y="954"/>
                  </a:lnTo>
                  <a:lnTo>
                    <a:pt x="4891" y="974"/>
                  </a:lnTo>
                  <a:cubicBezTo>
                    <a:pt x="4896" y="977"/>
                    <a:pt x="4896" y="977"/>
                    <a:pt x="4901" y="977"/>
                  </a:cubicBezTo>
                  <a:lnTo>
                    <a:pt x="5146" y="1035"/>
                  </a:lnTo>
                  <a:cubicBezTo>
                    <a:pt x="5146" y="1035"/>
                    <a:pt x="5151" y="1035"/>
                    <a:pt x="5151" y="1035"/>
                  </a:cubicBezTo>
                  <a:lnTo>
                    <a:pt x="5373" y="1127"/>
                  </a:lnTo>
                  <a:cubicBezTo>
                    <a:pt x="5378" y="1131"/>
                    <a:pt x="5378" y="1131"/>
                    <a:pt x="5378" y="1131"/>
                  </a:cubicBezTo>
                  <a:lnTo>
                    <a:pt x="5572" y="1250"/>
                  </a:lnTo>
                  <a:cubicBezTo>
                    <a:pt x="5576" y="1250"/>
                    <a:pt x="5576" y="1254"/>
                    <a:pt x="5581" y="1254"/>
                  </a:cubicBezTo>
                  <a:lnTo>
                    <a:pt x="5737" y="1400"/>
                  </a:lnTo>
                  <a:cubicBezTo>
                    <a:pt x="5737" y="1404"/>
                    <a:pt x="5737" y="1404"/>
                    <a:pt x="5737" y="1408"/>
                  </a:cubicBezTo>
                  <a:lnTo>
                    <a:pt x="5855" y="1577"/>
                  </a:lnTo>
                  <a:cubicBezTo>
                    <a:pt x="5860" y="1577"/>
                    <a:pt x="5860" y="1577"/>
                    <a:pt x="5860" y="1581"/>
                  </a:cubicBezTo>
                  <a:lnTo>
                    <a:pt x="5936" y="1766"/>
                  </a:lnTo>
                  <a:cubicBezTo>
                    <a:pt x="5936" y="1766"/>
                    <a:pt x="5936" y="1770"/>
                    <a:pt x="5936" y="1774"/>
                  </a:cubicBezTo>
                  <a:lnTo>
                    <a:pt x="5964" y="1970"/>
                  </a:lnTo>
                  <a:lnTo>
                    <a:pt x="5893" y="1970"/>
                  </a:lnTo>
                  <a:lnTo>
                    <a:pt x="5921" y="1774"/>
                  </a:lnTo>
                  <a:cubicBezTo>
                    <a:pt x="5921" y="1770"/>
                    <a:pt x="5921" y="1766"/>
                    <a:pt x="5921" y="1766"/>
                  </a:cubicBezTo>
                  <a:lnTo>
                    <a:pt x="5997" y="1581"/>
                  </a:lnTo>
                  <a:cubicBezTo>
                    <a:pt x="5997" y="1577"/>
                    <a:pt x="5997" y="1577"/>
                    <a:pt x="6002" y="1577"/>
                  </a:cubicBezTo>
                  <a:lnTo>
                    <a:pt x="6120" y="1408"/>
                  </a:lnTo>
                  <a:cubicBezTo>
                    <a:pt x="6120" y="1404"/>
                    <a:pt x="6120" y="1404"/>
                    <a:pt x="6120" y="1400"/>
                  </a:cubicBezTo>
                  <a:lnTo>
                    <a:pt x="6281" y="1254"/>
                  </a:lnTo>
                  <a:cubicBezTo>
                    <a:pt x="6285" y="1254"/>
                    <a:pt x="6285" y="1250"/>
                    <a:pt x="6290" y="1250"/>
                  </a:cubicBezTo>
                  <a:lnTo>
                    <a:pt x="6484" y="1131"/>
                  </a:lnTo>
                  <a:cubicBezTo>
                    <a:pt x="6484" y="1131"/>
                    <a:pt x="6484" y="1131"/>
                    <a:pt x="6488" y="1127"/>
                  </a:cubicBezTo>
                  <a:lnTo>
                    <a:pt x="6711" y="1035"/>
                  </a:lnTo>
                  <a:cubicBezTo>
                    <a:pt x="6711" y="1035"/>
                    <a:pt x="6715" y="1035"/>
                    <a:pt x="6715" y="1035"/>
                  </a:cubicBezTo>
                  <a:lnTo>
                    <a:pt x="6961" y="977"/>
                  </a:lnTo>
                  <a:cubicBezTo>
                    <a:pt x="6966" y="977"/>
                    <a:pt x="6966" y="977"/>
                    <a:pt x="6970" y="974"/>
                  </a:cubicBezTo>
                  <a:lnTo>
                    <a:pt x="7230" y="954"/>
                  </a:lnTo>
                  <a:lnTo>
                    <a:pt x="10831" y="954"/>
                  </a:lnTo>
                  <a:lnTo>
                    <a:pt x="11091" y="935"/>
                  </a:lnTo>
                  <a:lnTo>
                    <a:pt x="11082" y="939"/>
                  </a:lnTo>
                  <a:lnTo>
                    <a:pt x="11327" y="881"/>
                  </a:lnTo>
                  <a:lnTo>
                    <a:pt x="11323" y="881"/>
                  </a:lnTo>
                  <a:lnTo>
                    <a:pt x="11545" y="789"/>
                  </a:lnTo>
                  <a:lnTo>
                    <a:pt x="11540" y="793"/>
                  </a:lnTo>
                  <a:lnTo>
                    <a:pt x="11734" y="674"/>
                  </a:lnTo>
                  <a:lnTo>
                    <a:pt x="11724" y="677"/>
                  </a:lnTo>
                  <a:lnTo>
                    <a:pt x="11880" y="531"/>
                  </a:lnTo>
                  <a:lnTo>
                    <a:pt x="11880" y="535"/>
                  </a:lnTo>
                  <a:lnTo>
                    <a:pt x="11998" y="370"/>
                  </a:lnTo>
                  <a:lnTo>
                    <a:pt x="11994" y="377"/>
                  </a:lnTo>
                  <a:lnTo>
                    <a:pt x="12069" y="193"/>
                  </a:lnTo>
                  <a:lnTo>
                    <a:pt x="12069" y="200"/>
                  </a:lnTo>
                  <a:lnTo>
                    <a:pt x="12098" y="0"/>
                  </a:lnTo>
                  <a:lnTo>
                    <a:pt x="12168" y="4"/>
                  </a:lnTo>
                  <a:close/>
                </a:path>
              </a:pathLst>
            </a:custGeom>
            <a:solidFill>
              <a:srgbClr val="4A7EBB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" name="Freeform 158">
              <a:extLst>
                <a:ext uri="{FF2B5EF4-FFF2-40B4-BE49-F238E27FC236}">
                  <a16:creationId xmlns:a16="http://schemas.microsoft.com/office/drawing/2014/main" id="{F532193C-FD5E-4384-A586-44540A58087A}"/>
                </a:ext>
              </a:extLst>
            </p:cNvPr>
            <p:cNvSpPr>
              <a:spLocks/>
            </p:cNvSpPr>
            <p:nvPr/>
          </p:nvSpPr>
          <p:spPr bwMode="auto">
            <a:xfrm>
              <a:off x="947" y="2547"/>
              <a:ext cx="947" cy="155"/>
            </a:xfrm>
            <a:custGeom>
              <a:avLst/>
              <a:gdLst>
                <a:gd name="T0" fmla="*/ 12140 w 12168"/>
                <a:gd name="T1" fmla="*/ 212 h 2000"/>
                <a:gd name="T2" fmla="*/ 11942 w 12168"/>
                <a:gd name="T3" fmla="*/ 566 h 2000"/>
                <a:gd name="T4" fmla="*/ 11776 w 12168"/>
                <a:gd name="T5" fmla="*/ 724 h 2000"/>
                <a:gd name="T6" fmla="*/ 11356 w 12168"/>
                <a:gd name="T7" fmla="*/ 939 h 2000"/>
                <a:gd name="T8" fmla="*/ 11096 w 12168"/>
                <a:gd name="T9" fmla="*/ 997 h 2000"/>
                <a:gd name="T10" fmla="*/ 6975 w 12168"/>
                <a:gd name="T11" fmla="*/ 1035 h 2000"/>
                <a:gd name="T12" fmla="*/ 6744 w 12168"/>
                <a:gd name="T13" fmla="*/ 1093 h 2000"/>
                <a:gd name="T14" fmla="*/ 6333 w 12168"/>
                <a:gd name="T15" fmla="*/ 1300 h 2000"/>
                <a:gd name="T16" fmla="*/ 6181 w 12168"/>
                <a:gd name="T17" fmla="*/ 1435 h 2000"/>
                <a:gd name="T18" fmla="*/ 5992 w 12168"/>
                <a:gd name="T19" fmla="*/ 1785 h 2000"/>
                <a:gd name="T20" fmla="*/ 5926 w 12168"/>
                <a:gd name="T21" fmla="*/ 2000 h 2000"/>
                <a:gd name="T22" fmla="*/ 5865 w 12168"/>
                <a:gd name="T23" fmla="*/ 1785 h 2000"/>
                <a:gd name="T24" fmla="*/ 5676 w 12168"/>
                <a:gd name="T25" fmla="*/ 1435 h 2000"/>
                <a:gd name="T26" fmla="*/ 5529 w 12168"/>
                <a:gd name="T27" fmla="*/ 1300 h 2000"/>
                <a:gd name="T28" fmla="*/ 5118 w 12168"/>
                <a:gd name="T29" fmla="*/ 1093 h 2000"/>
                <a:gd name="T30" fmla="*/ 4887 w 12168"/>
                <a:gd name="T31" fmla="*/ 1035 h 2000"/>
                <a:gd name="T32" fmla="*/ 1078 w 12168"/>
                <a:gd name="T33" fmla="*/ 997 h 2000"/>
                <a:gd name="T34" fmla="*/ 818 w 12168"/>
                <a:gd name="T35" fmla="*/ 939 h 2000"/>
                <a:gd name="T36" fmla="*/ 397 w 12168"/>
                <a:gd name="T37" fmla="*/ 724 h 2000"/>
                <a:gd name="T38" fmla="*/ 227 w 12168"/>
                <a:gd name="T39" fmla="*/ 566 h 2000"/>
                <a:gd name="T40" fmla="*/ 29 w 12168"/>
                <a:gd name="T41" fmla="*/ 212 h 2000"/>
                <a:gd name="T42" fmla="*/ 71 w 12168"/>
                <a:gd name="T43" fmla="*/ 0 h 2000"/>
                <a:gd name="T44" fmla="*/ 175 w 12168"/>
                <a:gd name="T45" fmla="*/ 377 h 2000"/>
                <a:gd name="T46" fmla="*/ 284 w 12168"/>
                <a:gd name="T47" fmla="*/ 531 h 2000"/>
                <a:gd name="T48" fmla="*/ 634 w 12168"/>
                <a:gd name="T49" fmla="*/ 793 h 2000"/>
                <a:gd name="T50" fmla="*/ 846 w 12168"/>
                <a:gd name="T51" fmla="*/ 881 h 2000"/>
                <a:gd name="T52" fmla="*/ 1338 w 12168"/>
                <a:gd name="T53" fmla="*/ 954 h 2000"/>
                <a:gd name="T54" fmla="*/ 4901 w 12168"/>
                <a:gd name="T55" fmla="*/ 977 h 2000"/>
                <a:gd name="T56" fmla="*/ 5373 w 12168"/>
                <a:gd name="T57" fmla="*/ 1127 h 2000"/>
                <a:gd name="T58" fmla="*/ 5581 w 12168"/>
                <a:gd name="T59" fmla="*/ 1254 h 2000"/>
                <a:gd name="T60" fmla="*/ 5855 w 12168"/>
                <a:gd name="T61" fmla="*/ 1577 h 2000"/>
                <a:gd name="T62" fmla="*/ 5936 w 12168"/>
                <a:gd name="T63" fmla="*/ 1774 h 2000"/>
                <a:gd name="T64" fmla="*/ 5921 w 12168"/>
                <a:gd name="T65" fmla="*/ 1774 h 2000"/>
                <a:gd name="T66" fmla="*/ 6002 w 12168"/>
                <a:gd name="T67" fmla="*/ 1577 h 2000"/>
                <a:gd name="T68" fmla="*/ 6281 w 12168"/>
                <a:gd name="T69" fmla="*/ 1254 h 2000"/>
                <a:gd name="T70" fmla="*/ 6488 w 12168"/>
                <a:gd name="T71" fmla="*/ 1127 h 2000"/>
                <a:gd name="T72" fmla="*/ 6961 w 12168"/>
                <a:gd name="T73" fmla="*/ 977 h 2000"/>
                <a:gd name="T74" fmla="*/ 10831 w 12168"/>
                <a:gd name="T75" fmla="*/ 954 h 2000"/>
                <a:gd name="T76" fmla="*/ 11327 w 12168"/>
                <a:gd name="T77" fmla="*/ 881 h 2000"/>
                <a:gd name="T78" fmla="*/ 11540 w 12168"/>
                <a:gd name="T79" fmla="*/ 793 h 2000"/>
                <a:gd name="T80" fmla="*/ 11880 w 12168"/>
                <a:gd name="T81" fmla="*/ 531 h 2000"/>
                <a:gd name="T82" fmla="*/ 11994 w 12168"/>
                <a:gd name="T83" fmla="*/ 377 h 2000"/>
                <a:gd name="T84" fmla="*/ 12098 w 12168"/>
                <a:gd name="T85" fmla="*/ 0 h 20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12168" h="2000">
                  <a:moveTo>
                    <a:pt x="12168" y="4"/>
                  </a:moveTo>
                  <a:lnTo>
                    <a:pt x="12140" y="204"/>
                  </a:lnTo>
                  <a:cubicBezTo>
                    <a:pt x="12140" y="208"/>
                    <a:pt x="12140" y="208"/>
                    <a:pt x="12140" y="212"/>
                  </a:cubicBezTo>
                  <a:lnTo>
                    <a:pt x="12065" y="397"/>
                  </a:lnTo>
                  <a:cubicBezTo>
                    <a:pt x="12065" y="400"/>
                    <a:pt x="12065" y="400"/>
                    <a:pt x="12060" y="400"/>
                  </a:cubicBezTo>
                  <a:lnTo>
                    <a:pt x="11942" y="566"/>
                  </a:lnTo>
                  <a:cubicBezTo>
                    <a:pt x="11942" y="570"/>
                    <a:pt x="11942" y="570"/>
                    <a:pt x="11942" y="574"/>
                  </a:cubicBezTo>
                  <a:lnTo>
                    <a:pt x="11786" y="720"/>
                  </a:lnTo>
                  <a:cubicBezTo>
                    <a:pt x="11781" y="720"/>
                    <a:pt x="11781" y="724"/>
                    <a:pt x="11776" y="724"/>
                  </a:cubicBezTo>
                  <a:lnTo>
                    <a:pt x="11583" y="843"/>
                  </a:lnTo>
                  <a:cubicBezTo>
                    <a:pt x="11583" y="843"/>
                    <a:pt x="11583" y="843"/>
                    <a:pt x="11578" y="847"/>
                  </a:cubicBezTo>
                  <a:lnTo>
                    <a:pt x="11356" y="939"/>
                  </a:lnTo>
                  <a:cubicBezTo>
                    <a:pt x="11356" y="939"/>
                    <a:pt x="11351" y="939"/>
                    <a:pt x="11351" y="939"/>
                  </a:cubicBezTo>
                  <a:lnTo>
                    <a:pt x="11105" y="997"/>
                  </a:lnTo>
                  <a:cubicBezTo>
                    <a:pt x="11101" y="997"/>
                    <a:pt x="11101" y="997"/>
                    <a:pt x="11096" y="997"/>
                  </a:cubicBezTo>
                  <a:lnTo>
                    <a:pt x="10836" y="1016"/>
                  </a:lnTo>
                  <a:lnTo>
                    <a:pt x="7230" y="1016"/>
                  </a:lnTo>
                  <a:lnTo>
                    <a:pt x="6975" y="1035"/>
                  </a:lnTo>
                  <a:lnTo>
                    <a:pt x="6985" y="1035"/>
                  </a:lnTo>
                  <a:lnTo>
                    <a:pt x="6739" y="1093"/>
                  </a:lnTo>
                  <a:lnTo>
                    <a:pt x="6744" y="1093"/>
                  </a:lnTo>
                  <a:lnTo>
                    <a:pt x="6522" y="1185"/>
                  </a:lnTo>
                  <a:lnTo>
                    <a:pt x="6526" y="1181"/>
                  </a:lnTo>
                  <a:lnTo>
                    <a:pt x="6333" y="1300"/>
                  </a:lnTo>
                  <a:lnTo>
                    <a:pt x="6337" y="1297"/>
                  </a:lnTo>
                  <a:lnTo>
                    <a:pt x="6177" y="1443"/>
                  </a:lnTo>
                  <a:lnTo>
                    <a:pt x="6181" y="1435"/>
                  </a:lnTo>
                  <a:lnTo>
                    <a:pt x="6063" y="1604"/>
                  </a:lnTo>
                  <a:lnTo>
                    <a:pt x="6068" y="1600"/>
                  </a:lnTo>
                  <a:lnTo>
                    <a:pt x="5992" y="1785"/>
                  </a:lnTo>
                  <a:lnTo>
                    <a:pt x="5992" y="1777"/>
                  </a:lnTo>
                  <a:lnTo>
                    <a:pt x="5964" y="1974"/>
                  </a:lnTo>
                  <a:cubicBezTo>
                    <a:pt x="5964" y="1989"/>
                    <a:pt x="5950" y="2000"/>
                    <a:pt x="5926" y="2000"/>
                  </a:cubicBezTo>
                  <a:cubicBezTo>
                    <a:pt x="5907" y="2000"/>
                    <a:pt x="5893" y="1989"/>
                    <a:pt x="5893" y="1974"/>
                  </a:cubicBezTo>
                  <a:lnTo>
                    <a:pt x="5865" y="1777"/>
                  </a:lnTo>
                  <a:lnTo>
                    <a:pt x="5865" y="1785"/>
                  </a:lnTo>
                  <a:lnTo>
                    <a:pt x="5789" y="1600"/>
                  </a:lnTo>
                  <a:lnTo>
                    <a:pt x="5794" y="1604"/>
                  </a:lnTo>
                  <a:lnTo>
                    <a:pt x="5676" y="1435"/>
                  </a:lnTo>
                  <a:lnTo>
                    <a:pt x="5676" y="1443"/>
                  </a:lnTo>
                  <a:lnTo>
                    <a:pt x="5520" y="1297"/>
                  </a:lnTo>
                  <a:lnTo>
                    <a:pt x="5529" y="1300"/>
                  </a:lnTo>
                  <a:lnTo>
                    <a:pt x="5335" y="1181"/>
                  </a:lnTo>
                  <a:lnTo>
                    <a:pt x="5340" y="1185"/>
                  </a:lnTo>
                  <a:lnTo>
                    <a:pt x="5118" y="1093"/>
                  </a:lnTo>
                  <a:lnTo>
                    <a:pt x="5123" y="1093"/>
                  </a:lnTo>
                  <a:lnTo>
                    <a:pt x="4877" y="1035"/>
                  </a:lnTo>
                  <a:lnTo>
                    <a:pt x="4887" y="1035"/>
                  </a:lnTo>
                  <a:lnTo>
                    <a:pt x="4627" y="1016"/>
                  </a:lnTo>
                  <a:lnTo>
                    <a:pt x="1338" y="1016"/>
                  </a:lnTo>
                  <a:lnTo>
                    <a:pt x="1078" y="997"/>
                  </a:lnTo>
                  <a:cubicBezTo>
                    <a:pt x="1073" y="997"/>
                    <a:pt x="1073" y="997"/>
                    <a:pt x="1068" y="997"/>
                  </a:cubicBezTo>
                  <a:lnTo>
                    <a:pt x="823" y="939"/>
                  </a:lnTo>
                  <a:cubicBezTo>
                    <a:pt x="823" y="939"/>
                    <a:pt x="818" y="939"/>
                    <a:pt x="818" y="939"/>
                  </a:cubicBezTo>
                  <a:lnTo>
                    <a:pt x="596" y="847"/>
                  </a:lnTo>
                  <a:cubicBezTo>
                    <a:pt x="591" y="843"/>
                    <a:pt x="591" y="843"/>
                    <a:pt x="591" y="843"/>
                  </a:cubicBezTo>
                  <a:lnTo>
                    <a:pt x="397" y="724"/>
                  </a:lnTo>
                  <a:cubicBezTo>
                    <a:pt x="393" y="724"/>
                    <a:pt x="393" y="720"/>
                    <a:pt x="388" y="720"/>
                  </a:cubicBezTo>
                  <a:lnTo>
                    <a:pt x="227" y="574"/>
                  </a:lnTo>
                  <a:cubicBezTo>
                    <a:pt x="227" y="570"/>
                    <a:pt x="227" y="570"/>
                    <a:pt x="227" y="566"/>
                  </a:cubicBezTo>
                  <a:lnTo>
                    <a:pt x="109" y="400"/>
                  </a:lnTo>
                  <a:cubicBezTo>
                    <a:pt x="104" y="400"/>
                    <a:pt x="104" y="400"/>
                    <a:pt x="104" y="397"/>
                  </a:cubicBezTo>
                  <a:lnTo>
                    <a:pt x="29" y="212"/>
                  </a:lnTo>
                  <a:cubicBezTo>
                    <a:pt x="29" y="208"/>
                    <a:pt x="29" y="208"/>
                    <a:pt x="29" y="204"/>
                  </a:cubicBezTo>
                  <a:lnTo>
                    <a:pt x="0" y="4"/>
                  </a:lnTo>
                  <a:lnTo>
                    <a:pt x="71" y="0"/>
                  </a:lnTo>
                  <a:lnTo>
                    <a:pt x="100" y="200"/>
                  </a:lnTo>
                  <a:lnTo>
                    <a:pt x="100" y="193"/>
                  </a:lnTo>
                  <a:lnTo>
                    <a:pt x="175" y="377"/>
                  </a:lnTo>
                  <a:lnTo>
                    <a:pt x="171" y="370"/>
                  </a:lnTo>
                  <a:lnTo>
                    <a:pt x="289" y="535"/>
                  </a:lnTo>
                  <a:lnTo>
                    <a:pt x="284" y="531"/>
                  </a:lnTo>
                  <a:lnTo>
                    <a:pt x="445" y="677"/>
                  </a:lnTo>
                  <a:lnTo>
                    <a:pt x="440" y="674"/>
                  </a:lnTo>
                  <a:lnTo>
                    <a:pt x="634" y="793"/>
                  </a:lnTo>
                  <a:lnTo>
                    <a:pt x="629" y="789"/>
                  </a:lnTo>
                  <a:lnTo>
                    <a:pt x="851" y="881"/>
                  </a:lnTo>
                  <a:lnTo>
                    <a:pt x="846" y="881"/>
                  </a:lnTo>
                  <a:lnTo>
                    <a:pt x="1092" y="939"/>
                  </a:lnTo>
                  <a:lnTo>
                    <a:pt x="1083" y="935"/>
                  </a:lnTo>
                  <a:lnTo>
                    <a:pt x="1338" y="954"/>
                  </a:lnTo>
                  <a:lnTo>
                    <a:pt x="4631" y="954"/>
                  </a:lnTo>
                  <a:lnTo>
                    <a:pt x="4891" y="974"/>
                  </a:lnTo>
                  <a:cubicBezTo>
                    <a:pt x="4896" y="977"/>
                    <a:pt x="4896" y="977"/>
                    <a:pt x="4901" y="977"/>
                  </a:cubicBezTo>
                  <a:lnTo>
                    <a:pt x="5146" y="1035"/>
                  </a:lnTo>
                  <a:cubicBezTo>
                    <a:pt x="5146" y="1035"/>
                    <a:pt x="5151" y="1035"/>
                    <a:pt x="5151" y="1035"/>
                  </a:cubicBezTo>
                  <a:lnTo>
                    <a:pt x="5373" y="1127"/>
                  </a:lnTo>
                  <a:cubicBezTo>
                    <a:pt x="5378" y="1131"/>
                    <a:pt x="5378" y="1131"/>
                    <a:pt x="5378" y="1131"/>
                  </a:cubicBezTo>
                  <a:lnTo>
                    <a:pt x="5572" y="1250"/>
                  </a:lnTo>
                  <a:cubicBezTo>
                    <a:pt x="5576" y="1250"/>
                    <a:pt x="5576" y="1254"/>
                    <a:pt x="5581" y="1254"/>
                  </a:cubicBezTo>
                  <a:lnTo>
                    <a:pt x="5737" y="1400"/>
                  </a:lnTo>
                  <a:cubicBezTo>
                    <a:pt x="5737" y="1404"/>
                    <a:pt x="5737" y="1404"/>
                    <a:pt x="5737" y="1408"/>
                  </a:cubicBezTo>
                  <a:lnTo>
                    <a:pt x="5855" y="1577"/>
                  </a:lnTo>
                  <a:cubicBezTo>
                    <a:pt x="5860" y="1577"/>
                    <a:pt x="5860" y="1577"/>
                    <a:pt x="5860" y="1581"/>
                  </a:cubicBezTo>
                  <a:lnTo>
                    <a:pt x="5936" y="1766"/>
                  </a:lnTo>
                  <a:cubicBezTo>
                    <a:pt x="5936" y="1766"/>
                    <a:pt x="5936" y="1770"/>
                    <a:pt x="5936" y="1774"/>
                  </a:cubicBezTo>
                  <a:lnTo>
                    <a:pt x="5964" y="1970"/>
                  </a:lnTo>
                  <a:lnTo>
                    <a:pt x="5893" y="1970"/>
                  </a:lnTo>
                  <a:lnTo>
                    <a:pt x="5921" y="1774"/>
                  </a:lnTo>
                  <a:cubicBezTo>
                    <a:pt x="5921" y="1770"/>
                    <a:pt x="5921" y="1766"/>
                    <a:pt x="5921" y="1766"/>
                  </a:cubicBezTo>
                  <a:lnTo>
                    <a:pt x="5997" y="1581"/>
                  </a:lnTo>
                  <a:cubicBezTo>
                    <a:pt x="5997" y="1577"/>
                    <a:pt x="5997" y="1577"/>
                    <a:pt x="6002" y="1577"/>
                  </a:cubicBezTo>
                  <a:lnTo>
                    <a:pt x="6120" y="1408"/>
                  </a:lnTo>
                  <a:cubicBezTo>
                    <a:pt x="6120" y="1404"/>
                    <a:pt x="6120" y="1404"/>
                    <a:pt x="6120" y="1400"/>
                  </a:cubicBezTo>
                  <a:lnTo>
                    <a:pt x="6281" y="1254"/>
                  </a:lnTo>
                  <a:cubicBezTo>
                    <a:pt x="6285" y="1254"/>
                    <a:pt x="6285" y="1250"/>
                    <a:pt x="6290" y="1250"/>
                  </a:cubicBezTo>
                  <a:lnTo>
                    <a:pt x="6484" y="1131"/>
                  </a:lnTo>
                  <a:cubicBezTo>
                    <a:pt x="6484" y="1131"/>
                    <a:pt x="6484" y="1131"/>
                    <a:pt x="6488" y="1127"/>
                  </a:cubicBezTo>
                  <a:lnTo>
                    <a:pt x="6711" y="1035"/>
                  </a:lnTo>
                  <a:cubicBezTo>
                    <a:pt x="6711" y="1035"/>
                    <a:pt x="6715" y="1035"/>
                    <a:pt x="6715" y="1035"/>
                  </a:cubicBezTo>
                  <a:lnTo>
                    <a:pt x="6961" y="977"/>
                  </a:lnTo>
                  <a:cubicBezTo>
                    <a:pt x="6966" y="977"/>
                    <a:pt x="6966" y="977"/>
                    <a:pt x="6970" y="974"/>
                  </a:cubicBezTo>
                  <a:lnTo>
                    <a:pt x="7230" y="954"/>
                  </a:lnTo>
                  <a:lnTo>
                    <a:pt x="10831" y="954"/>
                  </a:lnTo>
                  <a:lnTo>
                    <a:pt x="11091" y="935"/>
                  </a:lnTo>
                  <a:lnTo>
                    <a:pt x="11082" y="939"/>
                  </a:lnTo>
                  <a:lnTo>
                    <a:pt x="11327" y="881"/>
                  </a:lnTo>
                  <a:lnTo>
                    <a:pt x="11323" y="881"/>
                  </a:lnTo>
                  <a:lnTo>
                    <a:pt x="11545" y="789"/>
                  </a:lnTo>
                  <a:lnTo>
                    <a:pt x="11540" y="793"/>
                  </a:lnTo>
                  <a:lnTo>
                    <a:pt x="11734" y="674"/>
                  </a:lnTo>
                  <a:lnTo>
                    <a:pt x="11724" y="677"/>
                  </a:lnTo>
                  <a:lnTo>
                    <a:pt x="11880" y="531"/>
                  </a:lnTo>
                  <a:lnTo>
                    <a:pt x="11880" y="535"/>
                  </a:lnTo>
                  <a:lnTo>
                    <a:pt x="11998" y="370"/>
                  </a:lnTo>
                  <a:lnTo>
                    <a:pt x="11994" y="377"/>
                  </a:lnTo>
                  <a:lnTo>
                    <a:pt x="12069" y="193"/>
                  </a:lnTo>
                  <a:lnTo>
                    <a:pt x="12069" y="200"/>
                  </a:lnTo>
                  <a:lnTo>
                    <a:pt x="12098" y="0"/>
                  </a:lnTo>
                  <a:lnTo>
                    <a:pt x="12168" y="4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" name="Rectangle 159">
              <a:extLst>
                <a:ext uri="{FF2B5EF4-FFF2-40B4-BE49-F238E27FC236}">
                  <a16:creationId xmlns:a16="http://schemas.microsoft.com/office/drawing/2014/main" id="{716F123E-2AC3-4E2A-A72F-E115D8A8B6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" y="1946"/>
              <a:ext cx="90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ynthetic peptide library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160">
              <a:extLst>
                <a:ext uri="{FF2B5EF4-FFF2-40B4-BE49-F238E27FC236}">
                  <a16:creationId xmlns:a16="http://schemas.microsoft.com/office/drawing/2014/main" id="{99CC2B63-005B-4F4B-9077-CCEA002D82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" y="2033"/>
              <a:ext cx="19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20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161">
              <a:extLst>
                <a:ext uri="{FF2B5EF4-FFF2-40B4-BE49-F238E27FC236}">
                  <a16:creationId xmlns:a16="http://schemas.microsoft.com/office/drawing/2014/main" id="{1A289618-28D6-4594-9716-EE5004A617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" y="2033"/>
              <a:ext cx="6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162">
              <a:extLst>
                <a:ext uri="{FF2B5EF4-FFF2-40B4-BE49-F238E27FC236}">
                  <a16:creationId xmlns:a16="http://schemas.microsoft.com/office/drawing/2014/main" id="{6A352937-BAE2-4834-9DEA-15C189F144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9" y="2033"/>
              <a:ext cx="71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11 peptides /pool)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163">
              <a:extLst>
                <a:ext uri="{FF2B5EF4-FFF2-40B4-BE49-F238E27FC236}">
                  <a16:creationId xmlns:a16="http://schemas.microsoft.com/office/drawing/2014/main" id="{A4E1C6AB-9159-4D2B-AD20-8980B3605C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14" y="1929"/>
              <a:ext cx="84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ecombinant purified PKs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164">
              <a:extLst>
                <a:ext uri="{FF2B5EF4-FFF2-40B4-BE49-F238E27FC236}">
                  <a16:creationId xmlns:a16="http://schemas.microsoft.com/office/drawing/2014/main" id="{03041055-B51E-4B06-97DE-4717185649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6" y="2474"/>
              <a:ext cx="75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Kinase buffer containing 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165">
              <a:extLst>
                <a:ext uri="{FF2B5EF4-FFF2-40B4-BE49-F238E27FC236}">
                  <a16:creationId xmlns:a16="http://schemas.microsoft.com/office/drawing/2014/main" id="{182E5736-F34A-4F97-8ED8-4622718D5E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6" y="2542"/>
              <a:ext cx="54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TP, Mg, DTT etc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58" name="Group 183">
              <a:extLst>
                <a:ext uri="{FF2B5EF4-FFF2-40B4-BE49-F238E27FC236}">
                  <a16:creationId xmlns:a16="http://schemas.microsoft.com/office/drawing/2014/main" id="{48A9B6F1-BC66-4CFB-9B8C-30C09C129F2D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681" y="2284"/>
              <a:ext cx="377" cy="253"/>
              <a:chOff x="681" y="2284"/>
              <a:chExt cx="377" cy="253"/>
            </a:xfrm>
          </p:grpSpPr>
          <p:sp>
            <p:nvSpPr>
              <p:cNvPr id="115" name="Freeform 166">
                <a:extLst>
                  <a:ext uri="{FF2B5EF4-FFF2-40B4-BE49-F238E27FC236}">
                    <a16:creationId xmlns:a16="http://schemas.microsoft.com/office/drawing/2014/main" id="{64623AE5-96C1-4022-BD16-06085859E38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9" y="2410"/>
                <a:ext cx="93" cy="43"/>
              </a:xfrm>
              <a:custGeom>
                <a:avLst/>
                <a:gdLst>
                  <a:gd name="T0" fmla="*/ 0 w 93"/>
                  <a:gd name="T1" fmla="*/ 35 h 43"/>
                  <a:gd name="T2" fmla="*/ 89 w 93"/>
                  <a:gd name="T3" fmla="*/ 0 h 43"/>
                  <a:gd name="T4" fmla="*/ 93 w 93"/>
                  <a:gd name="T5" fmla="*/ 8 h 43"/>
                  <a:gd name="T6" fmla="*/ 3 w 93"/>
                  <a:gd name="T7" fmla="*/ 43 h 43"/>
                  <a:gd name="T8" fmla="*/ 0 w 93"/>
                  <a:gd name="T9" fmla="*/ 35 h 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93" h="43">
                    <a:moveTo>
                      <a:pt x="0" y="35"/>
                    </a:moveTo>
                    <a:lnTo>
                      <a:pt x="89" y="0"/>
                    </a:lnTo>
                    <a:lnTo>
                      <a:pt x="93" y="8"/>
                    </a:lnTo>
                    <a:lnTo>
                      <a:pt x="3" y="43"/>
                    </a:lnTo>
                    <a:lnTo>
                      <a:pt x="0" y="35"/>
                    </a:lnTo>
                    <a:close/>
                  </a:path>
                </a:pathLst>
              </a:custGeom>
              <a:solidFill>
                <a:srgbClr val="FAC090"/>
              </a:solidFill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" name="Freeform 167">
                <a:extLst>
                  <a:ext uri="{FF2B5EF4-FFF2-40B4-BE49-F238E27FC236}">
                    <a16:creationId xmlns:a16="http://schemas.microsoft.com/office/drawing/2014/main" id="{167C7CFD-C11A-4DB9-BB04-6F8549A8018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37" y="2409"/>
                <a:ext cx="97" cy="46"/>
              </a:xfrm>
              <a:custGeom>
                <a:avLst/>
                <a:gdLst>
                  <a:gd name="T0" fmla="*/ 2 w 498"/>
                  <a:gd name="T1" fmla="*/ 207 h 258"/>
                  <a:gd name="T2" fmla="*/ 6 w 498"/>
                  <a:gd name="T3" fmla="*/ 197 h 258"/>
                  <a:gd name="T4" fmla="*/ 467 w 498"/>
                  <a:gd name="T5" fmla="*/ 2 h 258"/>
                  <a:gd name="T6" fmla="*/ 478 w 498"/>
                  <a:gd name="T7" fmla="*/ 6 h 258"/>
                  <a:gd name="T8" fmla="*/ 497 w 498"/>
                  <a:gd name="T9" fmla="*/ 49 h 258"/>
                  <a:gd name="T10" fmla="*/ 497 w 498"/>
                  <a:gd name="T11" fmla="*/ 55 h 258"/>
                  <a:gd name="T12" fmla="*/ 493 w 498"/>
                  <a:gd name="T13" fmla="*/ 59 h 258"/>
                  <a:gd name="T14" fmla="*/ 32 w 498"/>
                  <a:gd name="T15" fmla="*/ 257 h 258"/>
                  <a:gd name="T16" fmla="*/ 25 w 498"/>
                  <a:gd name="T17" fmla="*/ 257 h 258"/>
                  <a:gd name="T18" fmla="*/ 21 w 498"/>
                  <a:gd name="T19" fmla="*/ 253 h 258"/>
                  <a:gd name="T20" fmla="*/ 2 w 498"/>
                  <a:gd name="T21" fmla="*/ 207 h 258"/>
                  <a:gd name="T22" fmla="*/ 36 w 498"/>
                  <a:gd name="T23" fmla="*/ 246 h 258"/>
                  <a:gd name="T24" fmla="*/ 25 w 498"/>
                  <a:gd name="T25" fmla="*/ 242 h 258"/>
                  <a:gd name="T26" fmla="*/ 486 w 498"/>
                  <a:gd name="T27" fmla="*/ 45 h 258"/>
                  <a:gd name="T28" fmla="*/ 482 w 498"/>
                  <a:gd name="T29" fmla="*/ 55 h 258"/>
                  <a:gd name="T30" fmla="*/ 463 w 498"/>
                  <a:gd name="T31" fmla="*/ 13 h 258"/>
                  <a:gd name="T32" fmla="*/ 474 w 498"/>
                  <a:gd name="T33" fmla="*/ 17 h 258"/>
                  <a:gd name="T34" fmla="*/ 13 w 498"/>
                  <a:gd name="T35" fmla="*/ 212 h 258"/>
                  <a:gd name="T36" fmla="*/ 17 w 498"/>
                  <a:gd name="T37" fmla="*/ 201 h 258"/>
                  <a:gd name="T38" fmla="*/ 36 w 498"/>
                  <a:gd name="T39" fmla="*/ 246 h 2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498" h="258">
                    <a:moveTo>
                      <a:pt x="2" y="207"/>
                    </a:moveTo>
                    <a:cubicBezTo>
                      <a:pt x="0" y="203"/>
                      <a:pt x="2" y="198"/>
                      <a:pt x="6" y="197"/>
                    </a:cubicBezTo>
                    <a:lnTo>
                      <a:pt x="467" y="2"/>
                    </a:lnTo>
                    <a:cubicBezTo>
                      <a:pt x="471" y="0"/>
                      <a:pt x="476" y="2"/>
                      <a:pt x="478" y="6"/>
                    </a:cubicBezTo>
                    <a:lnTo>
                      <a:pt x="497" y="49"/>
                    </a:lnTo>
                    <a:cubicBezTo>
                      <a:pt x="498" y="51"/>
                      <a:pt x="498" y="53"/>
                      <a:pt x="497" y="55"/>
                    </a:cubicBezTo>
                    <a:cubicBezTo>
                      <a:pt x="496" y="57"/>
                      <a:pt x="495" y="59"/>
                      <a:pt x="493" y="59"/>
                    </a:cubicBezTo>
                    <a:lnTo>
                      <a:pt x="32" y="257"/>
                    </a:lnTo>
                    <a:cubicBezTo>
                      <a:pt x="30" y="258"/>
                      <a:pt x="27" y="258"/>
                      <a:pt x="25" y="257"/>
                    </a:cubicBezTo>
                    <a:cubicBezTo>
                      <a:pt x="23" y="256"/>
                      <a:pt x="22" y="255"/>
                      <a:pt x="21" y="253"/>
                    </a:cubicBezTo>
                    <a:lnTo>
                      <a:pt x="2" y="207"/>
                    </a:lnTo>
                    <a:close/>
                    <a:moveTo>
                      <a:pt x="36" y="246"/>
                    </a:moveTo>
                    <a:lnTo>
                      <a:pt x="25" y="242"/>
                    </a:lnTo>
                    <a:lnTo>
                      <a:pt x="486" y="45"/>
                    </a:lnTo>
                    <a:lnTo>
                      <a:pt x="482" y="55"/>
                    </a:lnTo>
                    <a:lnTo>
                      <a:pt x="463" y="13"/>
                    </a:lnTo>
                    <a:lnTo>
                      <a:pt x="474" y="17"/>
                    </a:lnTo>
                    <a:lnTo>
                      <a:pt x="13" y="212"/>
                    </a:lnTo>
                    <a:lnTo>
                      <a:pt x="17" y="201"/>
                    </a:lnTo>
                    <a:lnTo>
                      <a:pt x="36" y="246"/>
                    </a:lnTo>
                    <a:close/>
                  </a:path>
                </a:pathLst>
              </a:custGeom>
              <a:solidFill>
                <a:srgbClr val="FAC090"/>
              </a:solidFill>
              <a:ln w="1588" cap="flat">
                <a:solidFill>
                  <a:srgbClr val="FAC09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" name="Freeform 168">
                <a:extLst>
                  <a:ext uri="{FF2B5EF4-FFF2-40B4-BE49-F238E27FC236}">
                    <a16:creationId xmlns:a16="http://schemas.microsoft.com/office/drawing/2014/main" id="{AA077E90-17E5-4804-A660-B119FD49718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01" y="2479"/>
                <a:ext cx="106" cy="34"/>
              </a:xfrm>
              <a:custGeom>
                <a:avLst/>
                <a:gdLst>
                  <a:gd name="T0" fmla="*/ 0 w 106"/>
                  <a:gd name="T1" fmla="*/ 25 h 34"/>
                  <a:gd name="T2" fmla="*/ 104 w 106"/>
                  <a:gd name="T3" fmla="*/ 0 h 34"/>
                  <a:gd name="T4" fmla="*/ 106 w 106"/>
                  <a:gd name="T5" fmla="*/ 9 h 34"/>
                  <a:gd name="T6" fmla="*/ 2 w 106"/>
                  <a:gd name="T7" fmla="*/ 34 h 34"/>
                  <a:gd name="T8" fmla="*/ 0 w 106"/>
                  <a:gd name="T9" fmla="*/ 25 h 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06" h="34">
                    <a:moveTo>
                      <a:pt x="0" y="25"/>
                    </a:moveTo>
                    <a:lnTo>
                      <a:pt x="104" y="0"/>
                    </a:lnTo>
                    <a:lnTo>
                      <a:pt x="106" y="9"/>
                    </a:lnTo>
                    <a:lnTo>
                      <a:pt x="2" y="34"/>
                    </a:lnTo>
                    <a:lnTo>
                      <a:pt x="0" y="25"/>
                    </a:lnTo>
                    <a:close/>
                  </a:path>
                </a:pathLst>
              </a:custGeom>
              <a:solidFill>
                <a:srgbClr val="C00000"/>
              </a:solidFill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" name="Freeform 169">
                <a:extLst>
                  <a:ext uri="{FF2B5EF4-FFF2-40B4-BE49-F238E27FC236}">
                    <a16:creationId xmlns:a16="http://schemas.microsoft.com/office/drawing/2014/main" id="{4F4ECA28-465C-4A28-B920-106FCE49388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99" y="2477"/>
                <a:ext cx="109" cy="38"/>
              </a:xfrm>
              <a:custGeom>
                <a:avLst/>
                <a:gdLst>
                  <a:gd name="T0" fmla="*/ 1 w 561"/>
                  <a:gd name="T1" fmla="*/ 151 h 209"/>
                  <a:gd name="T2" fmla="*/ 6 w 561"/>
                  <a:gd name="T3" fmla="*/ 141 h 209"/>
                  <a:gd name="T4" fmla="*/ 539 w 561"/>
                  <a:gd name="T5" fmla="*/ 1 h 209"/>
                  <a:gd name="T6" fmla="*/ 546 w 561"/>
                  <a:gd name="T7" fmla="*/ 2 h 209"/>
                  <a:gd name="T8" fmla="*/ 549 w 561"/>
                  <a:gd name="T9" fmla="*/ 7 h 209"/>
                  <a:gd name="T10" fmla="*/ 560 w 561"/>
                  <a:gd name="T11" fmla="*/ 58 h 209"/>
                  <a:gd name="T12" fmla="*/ 555 w 561"/>
                  <a:gd name="T13" fmla="*/ 68 h 209"/>
                  <a:gd name="T14" fmla="*/ 21 w 561"/>
                  <a:gd name="T15" fmla="*/ 208 h 209"/>
                  <a:gd name="T16" fmla="*/ 15 w 561"/>
                  <a:gd name="T17" fmla="*/ 207 h 209"/>
                  <a:gd name="T18" fmla="*/ 12 w 561"/>
                  <a:gd name="T19" fmla="*/ 202 h 209"/>
                  <a:gd name="T20" fmla="*/ 1 w 561"/>
                  <a:gd name="T21" fmla="*/ 151 h 209"/>
                  <a:gd name="T22" fmla="*/ 27 w 561"/>
                  <a:gd name="T23" fmla="*/ 199 h 209"/>
                  <a:gd name="T24" fmla="*/ 17 w 561"/>
                  <a:gd name="T25" fmla="*/ 193 h 209"/>
                  <a:gd name="T26" fmla="*/ 550 w 561"/>
                  <a:gd name="T27" fmla="*/ 52 h 209"/>
                  <a:gd name="T28" fmla="*/ 545 w 561"/>
                  <a:gd name="T29" fmla="*/ 62 h 209"/>
                  <a:gd name="T30" fmla="*/ 534 w 561"/>
                  <a:gd name="T31" fmla="*/ 10 h 209"/>
                  <a:gd name="T32" fmla="*/ 544 w 561"/>
                  <a:gd name="T33" fmla="*/ 16 h 209"/>
                  <a:gd name="T34" fmla="*/ 11 w 561"/>
                  <a:gd name="T35" fmla="*/ 157 h 209"/>
                  <a:gd name="T36" fmla="*/ 16 w 561"/>
                  <a:gd name="T37" fmla="*/ 147 h 209"/>
                  <a:gd name="T38" fmla="*/ 27 w 561"/>
                  <a:gd name="T39" fmla="*/ 199 h 2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561" h="209">
                    <a:moveTo>
                      <a:pt x="1" y="151"/>
                    </a:moveTo>
                    <a:cubicBezTo>
                      <a:pt x="0" y="146"/>
                      <a:pt x="2" y="142"/>
                      <a:pt x="6" y="141"/>
                    </a:cubicBezTo>
                    <a:lnTo>
                      <a:pt x="539" y="1"/>
                    </a:lnTo>
                    <a:cubicBezTo>
                      <a:pt x="542" y="0"/>
                      <a:pt x="544" y="1"/>
                      <a:pt x="546" y="2"/>
                    </a:cubicBezTo>
                    <a:cubicBezTo>
                      <a:pt x="548" y="3"/>
                      <a:pt x="549" y="5"/>
                      <a:pt x="549" y="7"/>
                    </a:cubicBezTo>
                    <a:lnTo>
                      <a:pt x="560" y="58"/>
                    </a:lnTo>
                    <a:cubicBezTo>
                      <a:pt x="561" y="63"/>
                      <a:pt x="559" y="67"/>
                      <a:pt x="555" y="68"/>
                    </a:cubicBezTo>
                    <a:lnTo>
                      <a:pt x="21" y="208"/>
                    </a:lnTo>
                    <a:cubicBezTo>
                      <a:pt x="19" y="209"/>
                      <a:pt x="17" y="208"/>
                      <a:pt x="15" y="207"/>
                    </a:cubicBezTo>
                    <a:cubicBezTo>
                      <a:pt x="13" y="206"/>
                      <a:pt x="12" y="204"/>
                      <a:pt x="12" y="202"/>
                    </a:cubicBezTo>
                    <a:lnTo>
                      <a:pt x="1" y="151"/>
                    </a:lnTo>
                    <a:close/>
                    <a:moveTo>
                      <a:pt x="27" y="199"/>
                    </a:moveTo>
                    <a:lnTo>
                      <a:pt x="17" y="193"/>
                    </a:lnTo>
                    <a:lnTo>
                      <a:pt x="550" y="52"/>
                    </a:lnTo>
                    <a:lnTo>
                      <a:pt x="545" y="62"/>
                    </a:lnTo>
                    <a:lnTo>
                      <a:pt x="534" y="10"/>
                    </a:lnTo>
                    <a:lnTo>
                      <a:pt x="544" y="16"/>
                    </a:lnTo>
                    <a:lnTo>
                      <a:pt x="11" y="157"/>
                    </a:lnTo>
                    <a:lnTo>
                      <a:pt x="16" y="147"/>
                    </a:lnTo>
                    <a:lnTo>
                      <a:pt x="27" y="199"/>
                    </a:lnTo>
                    <a:close/>
                  </a:path>
                </a:pathLst>
              </a:custGeom>
              <a:solidFill>
                <a:srgbClr val="C00000"/>
              </a:solidFill>
              <a:ln w="1588" cap="flat">
                <a:solidFill>
                  <a:srgbClr val="C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" name="Freeform 170">
                <a:extLst>
                  <a:ext uri="{FF2B5EF4-FFF2-40B4-BE49-F238E27FC236}">
                    <a16:creationId xmlns:a16="http://schemas.microsoft.com/office/drawing/2014/main" id="{F489C53C-11F2-45AA-B5BD-32A1C3E27AA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67" y="2436"/>
                <a:ext cx="115" cy="46"/>
              </a:xfrm>
              <a:custGeom>
                <a:avLst/>
                <a:gdLst>
                  <a:gd name="T0" fmla="*/ 74 w 592"/>
                  <a:gd name="T1" fmla="*/ 203 h 256"/>
                  <a:gd name="T2" fmla="*/ 193 w 592"/>
                  <a:gd name="T3" fmla="*/ 207 h 256"/>
                  <a:gd name="T4" fmla="*/ 242 w 592"/>
                  <a:gd name="T5" fmla="*/ 193 h 256"/>
                  <a:gd name="T6" fmla="*/ 259 w 592"/>
                  <a:gd name="T7" fmla="*/ 180 h 256"/>
                  <a:gd name="T8" fmla="*/ 275 w 592"/>
                  <a:gd name="T9" fmla="*/ 159 h 256"/>
                  <a:gd name="T10" fmla="*/ 313 w 592"/>
                  <a:gd name="T11" fmla="*/ 103 h 256"/>
                  <a:gd name="T12" fmla="*/ 350 w 592"/>
                  <a:gd name="T13" fmla="*/ 45 h 256"/>
                  <a:gd name="T14" fmla="*/ 376 w 592"/>
                  <a:gd name="T15" fmla="*/ 17 h 256"/>
                  <a:gd name="T16" fmla="*/ 405 w 592"/>
                  <a:gd name="T17" fmla="*/ 3 h 256"/>
                  <a:gd name="T18" fmla="*/ 435 w 592"/>
                  <a:gd name="T19" fmla="*/ 2 h 256"/>
                  <a:gd name="T20" fmla="*/ 460 w 592"/>
                  <a:gd name="T21" fmla="*/ 12 h 256"/>
                  <a:gd name="T22" fmla="*/ 485 w 592"/>
                  <a:gd name="T23" fmla="*/ 26 h 256"/>
                  <a:gd name="T24" fmla="*/ 546 w 592"/>
                  <a:gd name="T25" fmla="*/ 80 h 256"/>
                  <a:gd name="T26" fmla="*/ 571 w 592"/>
                  <a:gd name="T27" fmla="*/ 103 h 256"/>
                  <a:gd name="T28" fmla="*/ 587 w 592"/>
                  <a:gd name="T29" fmla="*/ 139 h 256"/>
                  <a:gd name="T30" fmla="*/ 555 w 592"/>
                  <a:gd name="T31" fmla="*/ 151 h 256"/>
                  <a:gd name="T32" fmla="*/ 538 w 592"/>
                  <a:gd name="T33" fmla="*/ 143 h 256"/>
                  <a:gd name="T34" fmla="*/ 569 w 592"/>
                  <a:gd name="T35" fmla="*/ 105 h 256"/>
                  <a:gd name="T36" fmla="*/ 545 w 592"/>
                  <a:gd name="T37" fmla="*/ 119 h 256"/>
                  <a:gd name="T38" fmla="*/ 553 w 592"/>
                  <a:gd name="T39" fmla="*/ 148 h 256"/>
                  <a:gd name="T40" fmla="*/ 529 w 592"/>
                  <a:gd name="T41" fmla="*/ 128 h 256"/>
                  <a:gd name="T42" fmla="*/ 477 w 592"/>
                  <a:gd name="T43" fmla="*/ 80 h 256"/>
                  <a:gd name="T44" fmla="*/ 459 w 592"/>
                  <a:gd name="T45" fmla="*/ 65 h 256"/>
                  <a:gd name="T46" fmla="*/ 441 w 592"/>
                  <a:gd name="T47" fmla="*/ 54 h 256"/>
                  <a:gd name="T48" fmla="*/ 429 w 592"/>
                  <a:gd name="T49" fmla="*/ 48 h 256"/>
                  <a:gd name="T50" fmla="*/ 418 w 592"/>
                  <a:gd name="T51" fmla="*/ 46 h 256"/>
                  <a:gd name="T52" fmla="*/ 405 w 592"/>
                  <a:gd name="T53" fmla="*/ 53 h 256"/>
                  <a:gd name="T54" fmla="*/ 371 w 592"/>
                  <a:gd name="T55" fmla="*/ 97 h 256"/>
                  <a:gd name="T56" fmla="*/ 332 w 592"/>
                  <a:gd name="T57" fmla="*/ 160 h 256"/>
                  <a:gd name="T58" fmla="*/ 290 w 592"/>
                  <a:gd name="T59" fmla="*/ 215 h 256"/>
                  <a:gd name="T60" fmla="*/ 261 w 592"/>
                  <a:gd name="T61" fmla="*/ 235 h 256"/>
                  <a:gd name="T62" fmla="*/ 200 w 592"/>
                  <a:gd name="T63" fmla="*/ 254 h 256"/>
                  <a:gd name="T64" fmla="*/ 132 w 592"/>
                  <a:gd name="T65" fmla="*/ 256 h 256"/>
                  <a:gd name="T66" fmla="*/ 0 w 592"/>
                  <a:gd name="T67" fmla="*/ 239 h 2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</a:cxnLst>
                <a:rect l="0" t="0" r="r" b="b"/>
                <a:pathLst>
                  <a:path w="592" h="256">
                    <a:moveTo>
                      <a:pt x="9" y="192"/>
                    </a:moveTo>
                    <a:lnTo>
                      <a:pt x="74" y="203"/>
                    </a:lnTo>
                    <a:lnTo>
                      <a:pt x="137" y="210"/>
                    </a:lnTo>
                    <a:lnTo>
                      <a:pt x="193" y="207"/>
                    </a:lnTo>
                    <a:lnTo>
                      <a:pt x="188" y="208"/>
                    </a:lnTo>
                    <a:lnTo>
                      <a:pt x="242" y="193"/>
                    </a:lnTo>
                    <a:lnTo>
                      <a:pt x="235" y="196"/>
                    </a:lnTo>
                    <a:lnTo>
                      <a:pt x="259" y="180"/>
                    </a:lnTo>
                    <a:lnTo>
                      <a:pt x="254" y="183"/>
                    </a:lnTo>
                    <a:lnTo>
                      <a:pt x="275" y="159"/>
                    </a:lnTo>
                    <a:lnTo>
                      <a:pt x="294" y="132"/>
                    </a:lnTo>
                    <a:lnTo>
                      <a:pt x="313" y="103"/>
                    </a:lnTo>
                    <a:lnTo>
                      <a:pt x="332" y="71"/>
                    </a:lnTo>
                    <a:lnTo>
                      <a:pt x="350" y="45"/>
                    </a:lnTo>
                    <a:lnTo>
                      <a:pt x="370" y="21"/>
                    </a:lnTo>
                    <a:cubicBezTo>
                      <a:pt x="372" y="20"/>
                      <a:pt x="374" y="17"/>
                      <a:pt x="376" y="17"/>
                    </a:cubicBezTo>
                    <a:lnTo>
                      <a:pt x="395" y="6"/>
                    </a:lnTo>
                    <a:cubicBezTo>
                      <a:pt x="398" y="3"/>
                      <a:pt x="401" y="3"/>
                      <a:pt x="405" y="3"/>
                    </a:cubicBezTo>
                    <a:lnTo>
                      <a:pt x="425" y="1"/>
                    </a:lnTo>
                    <a:cubicBezTo>
                      <a:pt x="428" y="0"/>
                      <a:pt x="432" y="1"/>
                      <a:pt x="435" y="2"/>
                    </a:cubicBezTo>
                    <a:lnTo>
                      <a:pt x="456" y="9"/>
                    </a:lnTo>
                    <a:cubicBezTo>
                      <a:pt x="458" y="10"/>
                      <a:pt x="459" y="11"/>
                      <a:pt x="460" y="12"/>
                    </a:cubicBezTo>
                    <a:lnTo>
                      <a:pt x="482" y="24"/>
                    </a:lnTo>
                    <a:cubicBezTo>
                      <a:pt x="483" y="24"/>
                      <a:pt x="484" y="25"/>
                      <a:pt x="485" y="26"/>
                    </a:cubicBezTo>
                    <a:lnTo>
                      <a:pt x="506" y="43"/>
                    </a:lnTo>
                    <a:lnTo>
                      <a:pt x="546" y="80"/>
                    </a:lnTo>
                    <a:lnTo>
                      <a:pt x="561" y="94"/>
                    </a:lnTo>
                    <a:lnTo>
                      <a:pt x="571" y="103"/>
                    </a:lnTo>
                    <a:lnTo>
                      <a:pt x="580" y="108"/>
                    </a:lnTo>
                    <a:cubicBezTo>
                      <a:pt x="590" y="116"/>
                      <a:pt x="592" y="128"/>
                      <a:pt x="587" y="139"/>
                    </a:cubicBezTo>
                    <a:lnTo>
                      <a:pt x="587" y="140"/>
                    </a:lnTo>
                    <a:cubicBezTo>
                      <a:pt x="581" y="152"/>
                      <a:pt x="567" y="157"/>
                      <a:pt x="555" y="151"/>
                    </a:cubicBezTo>
                    <a:lnTo>
                      <a:pt x="548" y="147"/>
                    </a:lnTo>
                    <a:lnTo>
                      <a:pt x="538" y="143"/>
                    </a:lnTo>
                    <a:lnTo>
                      <a:pt x="556" y="99"/>
                    </a:lnTo>
                    <a:lnTo>
                      <a:pt x="569" y="105"/>
                    </a:lnTo>
                    <a:lnTo>
                      <a:pt x="576" y="108"/>
                    </a:lnTo>
                    <a:lnTo>
                      <a:pt x="545" y="119"/>
                    </a:lnTo>
                    <a:lnTo>
                      <a:pt x="546" y="117"/>
                    </a:lnTo>
                    <a:lnTo>
                      <a:pt x="553" y="148"/>
                    </a:lnTo>
                    <a:lnTo>
                      <a:pt x="541" y="139"/>
                    </a:lnTo>
                    <a:lnTo>
                      <a:pt x="529" y="128"/>
                    </a:lnTo>
                    <a:lnTo>
                      <a:pt x="514" y="114"/>
                    </a:lnTo>
                    <a:lnTo>
                      <a:pt x="477" y="80"/>
                    </a:lnTo>
                    <a:lnTo>
                      <a:pt x="456" y="63"/>
                    </a:lnTo>
                    <a:lnTo>
                      <a:pt x="459" y="65"/>
                    </a:lnTo>
                    <a:lnTo>
                      <a:pt x="437" y="52"/>
                    </a:lnTo>
                    <a:lnTo>
                      <a:pt x="441" y="54"/>
                    </a:lnTo>
                    <a:lnTo>
                      <a:pt x="420" y="47"/>
                    </a:lnTo>
                    <a:lnTo>
                      <a:pt x="429" y="48"/>
                    </a:lnTo>
                    <a:lnTo>
                      <a:pt x="409" y="49"/>
                    </a:lnTo>
                    <a:lnTo>
                      <a:pt x="418" y="46"/>
                    </a:lnTo>
                    <a:lnTo>
                      <a:pt x="399" y="57"/>
                    </a:lnTo>
                    <a:lnTo>
                      <a:pt x="405" y="53"/>
                    </a:lnTo>
                    <a:lnTo>
                      <a:pt x="389" y="71"/>
                    </a:lnTo>
                    <a:lnTo>
                      <a:pt x="371" y="97"/>
                    </a:lnTo>
                    <a:lnTo>
                      <a:pt x="353" y="127"/>
                    </a:lnTo>
                    <a:lnTo>
                      <a:pt x="332" y="160"/>
                    </a:lnTo>
                    <a:lnTo>
                      <a:pt x="311" y="191"/>
                    </a:lnTo>
                    <a:lnTo>
                      <a:pt x="290" y="215"/>
                    </a:lnTo>
                    <a:cubicBezTo>
                      <a:pt x="288" y="217"/>
                      <a:pt x="287" y="218"/>
                      <a:pt x="285" y="219"/>
                    </a:cubicBezTo>
                    <a:lnTo>
                      <a:pt x="261" y="235"/>
                    </a:lnTo>
                    <a:cubicBezTo>
                      <a:pt x="258" y="236"/>
                      <a:pt x="256" y="237"/>
                      <a:pt x="254" y="238"/>
                    </a:cubicBezTo>
                    <a:lnTo>
                      <a:pt x="200" y="254"/>
                    </a:lnTo>
                    <a:cubicBezTo>
                      <a:pt x="199" y="254"/>
                      <a:pt x="197" y="254"/>
                      <a:pt x="195" y="254"/>
                    </a:cubicBezTo>
                    <a:lnTo>
                      <a:pt x="132" y="256"/>
                    </a:lnTo>
                    <a:lnTo>
                      <a:pt x="66" y="250"/>
                    </a:lnTo>
                    <a:lnTo>
                      <a:pt x="0" y="239"/>
                    </a:lnTo>
                    <a:lnTo>
                      <a:pt x="9" y="192"/>
                    </a:lnTo>
                    <a:close/>
                  </a:path>
                </a:pathLst>
              </a:custGeom>
              <a:solidFill>
                <a:srgbClr val="C3D69B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" name="Freeform 171">
                <a:extLst>
                  <a:ext uri="{FF2B5EF4-FFF2-40B4-BE49-F238E27FC236}">
                    <a16:creationId xmlns:a16="http://schemas.microsoft.com/office/drawing/2014/main" id="{69B8B3D9-8A3F-4776-975B-8562D43E54F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65" y="2435"/>
                <a:ext cx="118" cy="48"/>
              </a:xfrm>
              <a:custGeom>
                <a:avLst/>
                <a:gdLst>
                  <a:gd name="T0" fmla="*/ 146 w 606"/>
                  <a:gd name="T1" fmla="*/ 210 h 271"/>
                  <a:gd name="T2" fmla="*/ 203 w 606"/>
                  <a:gd name="T3" fmla="*/ 222 h 271"/>
                  <a:gd name="T4" fmla="*/ 248 w 606"/>
                  <a:gd name="T5" fmla="*/ 193 h 271"/>
                  <a:gd name="T6" fmla="*/ 236 w 606"/>
                  <a:gd name="T7" fmla="*/ 207 h 271"/>
                  <a:gd name="T8" fmla="*/ 267 w 606"/>
                  <a:gd name="T9" fmla="*/ 197 h 271"/>
                  <a:gd name="T10" fmla="*/ 296 w 606"/>
                  <a:gd name="T11" fmla="*/ 135 h 271"/>
                  <a:gd name="T12" fmla="*/ 372 w 606"/>
                  <a:gd name="T13" fmla="*/ 23 h 271"/>
                  <a:gd name="T14" fmla="*/ 401 w 606"/>
                  <a:gd name="T15" fmla="*/ 6 h 271"/>
                  <a:gd name="T16" fmla="*/ 434 w 606"/>
                  <a:gd name="T17" fmla="*/ 0 h 271"/>
                  <a:gd name="T18" fmla="*/ 469 w 606"/>
                  <a:gd name="T19" fmla="*/ 10 h 271"/>
                  <a:gd name="T20" fmla="*/ 498 w 606"/>
                  <a:gd name="T21" fmla="*/ 27 h 271"/>
                  <a:gd name="T22" fmla="*/ 585 w 606"/>
                  <a:gd name="T23" fmla="*/ 105 h 271"/>
                  <a:gd name="T24" fmla="*/ 604 w 606"/>
                  <a:gd name="T25" fmla="*/ 125 h 271"/>
                  <a:gd name="T26" fmla="*/ 601 w 606"/>
                  <a:gd name="T27" fmla="*/ 154 h 271"/>
                  <a:gd name="T28" fmla="*/ 559 w 606"/>
                  <a:gd name="T29" fmla="*/ 165 h 271"/>
                  <a:gd name="T30" fmla="*/ 539 w 606"/>
                  <a:gd name="T31" fmla="*/ 147 h 271"/>
                  <a:gd name="T32" fmla="*/ 581 w 606"/>
                  <a:gd name="T33" fmla="*/ 105 h 271"/>
                  <a:gd name="T34" fmla="*/ 556 w 606"/>
                  <a:gd name="T35" fmla="*/ 134 h 271"/>
                  <a:gd name="T36" fmla="*/ 555 w 606"/>
                  <a:gd name="T37" fmla="*/ 117 h 271"/>
                  <a:gd name="T38" fmla="*/ 557 w 606"/>
                  <a:gd name="T39" fmla="*/ 162 h 271"/>
                  <a:gd name="T40" fmla="*/ 480 w 606"/>
                  <a:gd name="T41" fmla="*/ 93 h 271"/>
                  <a:gd name="T42" fmla="*/ 472 w 606"/>
                  <a:gd name="T43" fmla="*/ 66 h 271"/>
                  <a:gd name="T44" fmla="*/ 438 w 606"/>
                  <a:gd name="T45" fmla="*/ 56 h 271"/>
                  <a:gd name="T46" fmla="*/ 447 w 606"/>
                  <a:gd name="T47" fmla="*/ 69 h 271"/>
                  <a:gd name="T48" fmla="*/ 438 w 606"/>
                  <a:gd name="T49" fmla="*/ 48 h 271"/>
                  <a:gd name="T50" fmla="*/ 410 w 606"/>
                  <a:gd name="T51" fmla="*/ 58 h 271"/>
                  <a:gd name="T52" fmla="*/ 430 w 606"/>
                  <a:gd name="T53" fmla="*/ 60 h 271"/>
                  <a:gd name="T54" fmla="*/ 409 w 606"/>
                  <a:gd name="T55" fmla="*/ 54 h 271"/>
                  <a:gd name="T56" fmla="*/ 386 w 606"/>
                  <a:gd name="T57" fmla="*/ 109 h 271"/>
                  <a:gd name="T58" fmla="*/ 304 w 606"/>
                  <a:gd name="T59" fmla="*/ 228 h 271"/>
                  <a:gd name="T60" fmla="*/ 273 w 606"/>
                  <a:gd name="T61" fmla="*/ 250 h 271"/>
                  <a:gd name="T62" fmla="*/ 203 w 606"/>
                  <a:gd name="T63" fmla="*/ 269 h 271"/>
                  <a:gd name="T64" fmla="*/ 2 w 606"/>
                  <a:gd name="T65" fmla="*/ 251 h 271"/>
                  <a:gd name="T66" fmla="*/ 10 w 606"/>
                  <a:gd name="T67" fmla="*/ 239 h 271"/>
                  <a:gd name="T68" fmla="*/ 208 w 606"/>
                  <a:gd name="T69" fmla="*/ 253 h 271"/>
                  <a:gd name="T70" fmla="*/ 265 w 606"/>
                  <a:gd name="T71" fmla="*/ 236 h 271"/>
                  <a:gd name="T72" fmla="*/ 313 w 606"/>
                  <a:gd name="T73" fmla="*/ 194 h 271"/>
                  <a:gd name="T74" fmla="*/ 391 w 606"/>
                  <a:gd name="T75" fmla="*/ 73 h 271"/>
                  <a:gd name="T76" fmla="*/ 403 w 606"/>
                  <a:gd name="T77" fmla="*/ 58 h 271"/>
                  <a:gd name="T78" fmla="*/ 417 w 606"/>
                  <a:gd name="T79" fmla="*/ 48 h 271"/>
                  <a:gd name="T80" fmla="*/ 431 w 606"/>
                  <a:gd name="T81" fmla="*/ 47 h 271"/>
                  <a:gd name="T82" fmla="*/ 450 w 606"/>
                  <a:gd name="T83" fmla="*/ 53 h 271"/>
                  <a:gd name="T84" fmla="*/ 470 w 606"/>
                  <a:gd name="T85" fmla="*/ 64 h 271"/>
                  <a:gd name="T86" fmla="*/ 554 w 606"/>
                  <a:gd name="T87" fmla="*/ 140 h 271"/>
                  <a:gd name="T88" fmla="*/ 562 w 606"/>
                  <a:gd name="T89" fmla="*/ 128 h 271"/>
                  <a:gd name="T90" fmla="*/ 581 w 606"/>
                  <a:gd name="T91" fmla="*/ 123 h 271"/>
                  <a:gd name="T92" fmla="*/ 554 w 606"/>
                  <a:gd name="T93" fmla="*/ 153 h 271"/>
                  <a:gd name="T94" fmla="*/ 564 w 606"/>
                  <a:gd name="T95" fmla="*/ 150 h 271"/>
                  <a:gd name="T96" fmla="*/ 587 w 606"/>
                  <a:gd name="T97" fmla="*/ 147 h 271"/>
                  <a:gd name="T98" fmla="*/ 582 w 606"/>
                  <a:gd name="T99" fmla="*/ 120 h 271"/>
                  <a:gd name="T100" fmla="*/ 564 w 606"/>
                  <a:gd name="T101" fmla="*/ 107 h 271"/>
                  <a:gd name="T102" fmla="*/ 487 w 606"/>
                  <a:gd name="T103" fmla="*/ 38 h 271"/>
                  <a:gd name="T104" fmla="*/ 462 w 606"/>
                  <a:gd name="T105" fmla="*/ 24 h 271"/>
                  <a:gd name="T106" fmla="*/ 434 w 606"/>
                  <a:gd name="T107" fmla="*/ 16 h 271"/>
                  <a:gd name="T108" fmla="*/ 407 w 606"/>
                  <a:gd name="T109" fmla="*/ 20 h 271"/>
                  <a:gd name="T110" fmla="*/ 365 w 606"/>
                  <a:gd name="T111" fmla="*/ 57 h 271"/>
                  <a:gd name="T112" fmla="*/ 289 w 606"/>
                  <a:gd name="T113" fmla="*/ 172 h 271"/>
                  <a:gd name="T114" fmla="*/ 274 w 606"/>
                  <a:gd name="T115" fmla="*/ 183 h 271"/>
                  <a:gd name="T116" fmla="*/ 247 w 606"/>
                  <a:gd name="T117" fmla="*/ 193 h 271"/>
                  <a:gd name="T118" fmla="*/ 200 w 606"/>
                  <a:gd name="T119" fmla="*/ 207 h 271"/>
                  <a:gd name="T120" fmla="*/ 81 w 606"/>
                  <a:gd name="T121" fmla="*/ 218 h 2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</a:cxnLst>
                <a:rect l="0" t="0" r="r" b="b"/>
                <a:pathLst>
                  <a:path w="606" h="271">
                    <a:moveTo>
                      <a:pt x="10" y="198"/>
                    </a:moveTo>
                    <a:cubicBezTo>
                      <a:pt x="10" y="194"/>
                      <a:pt x="15" y="191"/>
                      <a:pt x="19" y="192"/>
                    </a:cubicBezTo>
                    <a:lnTo>
                      <a:pt x="84" y="203"/>
                    </a:lnTo>
                    <a:lnTo>
                      <a:pt x="146" y="210"/>
                    </a:lnTo>
                    <a:lnTo>
                      <a:pt x="145" y="209"/>
                    </a:lnTo>
                    <a:lnTo>
                      <a:pt x="201" y="206"/>
                    </a:lnTo>
                    <a:cubicBezTo>
                      <a:pt x="205" y="206"/>
                      <a:pt x="209" y="209"/>
                      <a:pt x="209" y="213"/>
                    </a:cubicBezTo>
                    <a:cubicBezTo>
                      <a:pt x="210" y="218"/>
                      <a:pt x="207" y="221"/>
                      <a:pt x="203" y="222"/>
                    </a:cubicBezTo>
                    <a:lnTo>
                      <a:pt x="198" y="223"/>
                    </a:lnTo>
                    <a:cubicBezTo>
                      <a:pt x="194" y="224"/>
                      <a:pt x="190" y="222"/>
                      <a:pt x="189" y="217"/>
                    </a:cubicBezTo>
                    <a:cubicBezTo>
                      <a:pt x="188" y="213"/>
                      <a:pt x="190" y="209"/>
                      <a:pt x="194" y="208"/>
                    </a:cubicBezTo>
                    <a:lnTo>
                      <a:pt x="248" y="193"/>
                    </a:lnTo>
                    <a:cubicBezTo>
                      <a:pt x="252" y="192"/>
                      <a:pt x="257" y="194"/>
                      <a:pt x="258" y="198"/>
                    </a:cubicBezTo>
                    <a:cubicBezTo>
                      <a:pt x="259" y="202"/>
                      <a:pt x="257" y="206"/>
                      <a:pt x="254" y="208"/>
                    </a:cubicBezTo>
                    <a:lnTo>
                      <a:pt x="247" y="211"/>
                    </a:lnTo>
                    <a:cubicBezTo>
                      <a:pt x="243" y="212"/>
                      <a:pt x="238" y="211"/>
                      <a:pt x="236" y="207"/>
                    </a:cubicBezTo>
                    <a:cubicBezTo>
                      <a:pt x="234" y="204"/>
                      <a:pt x="236" y="199"/>
                      <a:pt x="239" y="197"/>
                    </a:cubicBezTo>
                    <a:lnTo>
                      <a:pt x="263" y="181"/>
                    </a:lnTo>
                    <a:lnTo>
                      <a:pt x="272" y="194"/>
                    </a:lnTo>
                    <a:lnTo>
                      <a:pt x="267" y="197"/>
                    </a:lnTo>
                    <a:cubicBezTo>
                      <a:pt x="263" y="199"/>
                      <a:pt x="259" y="199"/>
                      <a:pt x="256" y="196"/>
                    </a:cubicBezTo>
                    <a:cubicBezTo>
                      <a:pt x="254" y="193"/>
                      <a:pt x="254" y="188"/>
                      <a:pt x="256" y="185"/>
                    </a:cubicBezTo>
                    <a:lnTo>
                      <a:pt x="277" y="161"/>
                    </a:lnTo>
                    <a:lnTo>
                      <a:pt x="296" y="135"/>
                    </a:lnTo>
                    <a:lnTo>
                      <a:pt x="315" y="106"/>
                    </a:lnTo>
                    <a:lnTo>
                      <a:pt x="334" y="74"/>
                    </a:lnTo>
                    <a:lnTo>
                      <a:pt x="352" y="48"/>
                    </a:lnTo>
                    <a:lnTo>
                      <a:pt x="372" y="23"/>
                    </a:lnTo>
                    <a:cubicBezTo>
                      <a:pt x="373" y="23"/>
                      <a:pt x="373" y="22"/>
                      <a:pt x="374" y="22"/>
                    </a:cubicBezTo>
                    <a:lnTo>
                      <a:pt x="380" y="18"/>
                    </a:lnTo>
                    <a:lnTo>
                      <a:pt x="399" y="7"/>
                    </a:lnTo>
                    <a:cubicBezTo>
                      <a:pt x="400" y="6"/>
                      <a:pt x="401" y="6"/>
                      <a:pt x="401" y="6"/>
                    </a:cubicBezTo>
                    <a:lnTo>
                      <a:pt x="411" y="3"/>
                    </a:lnTo>
                    <a:cubicBezTo>
                      <a:pt x="412" y="3"/>
                      <a:pt x="412" y="3"/>
                      <a:pt x="413" y="2"/>
                    </a:cubicBezTo>
                    <a:lnTo>
                      <a:pt x="433" y="0"/>
                    </a:lnTo>
                    <a:cubicBezTo>
                      <a:pt x="433" y="0"/>
                      <a:pt x="434" y="0"/>
                      <a:pt x="434" y="0"/>
                    </a:cubicBezTo>
                    <a:lnTo>
                      <a:pt x="444" y="1"/>
                    </a:lnTo>
                    <a:cubicBezTo>
                      <a:pt x="445" y="2"/>
                      <a:pt x="445" y="2"/>
                      <a:pt x="446" y="2"/>
                    </a:cubicBezTo>
                    <a:lnTo>
                      <a:pt x="467" y="9"/>
                    </a:lnTo>
                    <a:cubicBezTo>
                      <a:pt x="468" y="9"/>
                      <a:pt x="469" y="10"/>
                      <a:pt x="469" y="10"/>
                    </a:cubicBezTo>
                    <a:lnTo>
                      <a:pt x="473" y="13"/>
                    </a:lnTo>
                    <a:lnTo>
                      <a:pt x="472" y="12"/>
                    </a:lnTo>
                    <a:lnTo>
                      <a:pt x="494" y="24"/>
                    </a:lnTo>
                    <a:lnTo>
                      <a:pt x="498" y="27"/>
                    </a:lnTo>
                    <a:lnTo>
                      <a:pt x="520" y="44"/>
                    </a:lnTo>
                    <a:lnTo>
                      <a:pt x="560" y="82"/>
                    </a:lnTo>
                    <a:lnTo>
                      <a:pt x="575" y="96"/>
                    </a:lnTo>
                    <a:lnTo>
                      <a:pt x="585" y="105"/>
                    </a:lnTo>
                    <a:lnTo>
                      <a:pt x="583" y="103"/>
                    </a:lnTo>
                    <a:lnTo>
                      <a:pt x="592" y="108"/>
                    </a:lnTo>
                    <a:cubicBezTo>
                      <a:pt x="594" y="109"/>
                      <a:pt x="594" y="110"/>
                      <a:pt x="595" y="111"/>
                    </a:cubicBezTo>
                    <a:lnTo>
                      <a:pt x="604" y="125"/>
                    </a:lnTo>
                    <a:cubicBezTo>
                      <a:pt x="605" y="127"/>
                      <a:pt x="606" y="129"/>
                      <a:pt x="605" y="130"/>
                    </a:cubicBezTo>
                    <a:lnTo>
                      <a:pt x="603" y="147"/>
                    </a:lnTo>
                    <a:lnTo>
                      <a:pt x="603" y="147"/>
                    </a:lnTo>
                    <a:cubicBezTo>
                      <a:pt x="603" y="150"/>
                      <a:pt x="602" y="152"/>
                      <a:pt x="601" y="154"/>
                    </a:cubicBezTo>
                    <a:lnTo>
                      <a:pt x="587" y="166"/>
                    </a:lnTo>
                    <a:cubicBezTo>
                      <a:pt x="585" y="167"/>
                      <a:pt x="583" y="168"/>
                      <a:pt x="581" y="167"/>
                    </a:cubicBezTo>
                    <a:lnTo>
                      <a:pt x="563" y="166"/>
                    </a:lnTo>
                    <a:cubicBezTo>
                      <a:pt x="562" y="166"/>
                      <a:pt x="561" y="166"/>
                      <a:pt x="559" y="165"/>
                    </a:cubicBezTo>
                    <a:lnTo>
                      <a:pt x="552" y="161"/>
                    </a:lnTo>
                    <a:lnTo>
                      <a:pt x="543" y="158"/>
                    </a:lnTo>
                    <a:cubicBezTo>
                      <a:pt x="542" y="157"/>
                      <a:pt x="540" y="156"/>
                      <a:pt x="539" y="154"/>
                    </a:cubicBezTo>
                    <a:cubicBezTo>
                      <a:pt x="538" y="152"/>
                      <a:pt x="538" y="149"/>
                      <a:pt x="539" y="147"/>
                    </a:cubicBezTo>
                    <a:lnTo>
                      <a:pt x="557" y="103"/>
                    </a:lnTo>
                    <a:cubicBezTo>
                      <a:pt x="558" y="101"/>
                      <a:pt x="559" y="100"/>
                      <a:pt x="562" y="99"/>
                    </a:cubicBezTo>
                    <a:cubicBezTo>
                      <a:pt x="564" y="98"/>
                      <a:pt x="566" y="98"/>
                      <a:pt x="568" y="99"/>
                    </a:cubicBezTo>
                    <a:lnTo>
                      <a:pt x="581" y="105"/>
                    </a:lnTo>
                    <a:lnTo>
                      <a:pt x="588" y="108"/>
                    </a:lnTo>
                    <a:cubicBezTo>
                      <a:pt x="591" y="109"/>
                      <a:pt x="593" y="112"/>
                      <a:pt x="592" y="116"/>
                    </a:cubicBezTo>
                    <a:cubicBezTo>
                      <a:pt x="592" y="119"/>
                      <a:pt x="590" y="122"/>
                      <a:pt x="587" y="123"/>
                    </a:cubicBezTo>
                    <a:lnTo>
                      <a:pt x="556" y="134"/>
                    </a:lnTo>
                    <a:cubicBezTo>
                      <a:pt x="553" y="135"/>
                      <a:pt x="550" y="134"/>
                      <a:pt x="547" y="132"/>
                    </a:cubicBezTo>
                    <a:cubicBezTo>
                      <a:pt x="545" y="129"/>
                      <a:pt x="545" y="126"/>
                      <a:pt x="546" y="123"/>
                    </a:cubicBezTo>
                    <a:lnTo>
                      <a:pt x="547" y="121"/>
                    </a:lnTo>
                    <a:cubicBezTo>
                      <a:pt x="549" y="118"/>
                      <a:pt x="552" y="116"/>
                      <a:pt x="555" y="117"/>
                    </a:cubicBezTo>
                    <a:cubicBezTo>
                      <a:pt x="559" y="117"/>
                      <a:pt x="562" y="119"/>
                      <a:pt x="562" y="123"/>
                    </a:cubicBezTo>
                    <a:lnTo>
                      <a:pt x="569" y="154"/>
                    </a:lnTo>
                    <a:cubicBezTo>
                      <a:pt x="570" y="157"/>
                      <a:pt x="569" y="160"/>
                      <a:pt x="566" y="162"/>
                    </a:cubicBezTo>
                    <a:cubicBezTo>
                      <a:pt x="563" y="164"/>
                      <a:pt x="559" y="164"/>
                      <a:pt x="557" y="162"/>
                    </a:cubicBezTo>
                    <a:lnTo>
                      <a:pt x="545" y="153"/>
                    </a:lnTo>
                    <a:lnTo>
                      <a:pt x="532" y="141"/>
                    </a:lnTo>
                    <a:lnTo>
                      <a:pt x="517" y="127"/>
                    </a:lnTo>
                    <a:lnTo>
                      <a:pt x="480" y="93"/>
                    </a:lnTo>
                    <a:lnTo>
                      <a:pt x="459" y="77"/>
                    </a:lnTo>
                    <a:cubicBezTo>
                      <a:pt x="456" y="74"/>
                      <a:pt x="455" y="69"/>
                      <a:pt x="458" y="66"/>
                    </a:cubicBezTo>
                    <a:cubicBezTo>
                      <a:pt x="461" y="62"/>
                      <a:pt x="465" y="61"/>
                      <a:pt x="469" y="64"/>
                    </a:cubicBezTo>
                    <a:lnTo>
                      <a:pt x="472" y="66"/>
                    </a:lnTo>
                    <a:cubicBezTo>
                      <a:pt x="476" y="68"/>
                      <a:pt x="477" y="73"/>
                      <a:pt x="474" y="77"/>
                    </a:cubicBezTo>
                    <a:cubicBezTo>
                      <a:pt x="472" y="80"/>
                      <a:pt x="467" y="82"/>
                      <a:pt x="463" y="79"/>
                    </a:cubicBezTo>
                    <a:lnTo>
                      <a:pt x="441" y="66"/>
                    </a:lnTo>
                    <a:cubicBezTo>
                      <a:pt x="438" y="64"/>
                      <a:pt x="436" y="59"/>
                      <a:pt x="438" y="56"/>
                    </a:cubicBezTo>
                    <a:cubicBezTo>
                      <a:pt x="440" y="52"/>
                      <a:pt x="445" y="50"/>
                      <a:pt x="449" y="52"/>
                    </a:cubicBezTo>
                    <a:lnTo>
                      <a:pt x="453" y="54"/>
                    </a:lnTo>
                    <a:cubicBezTo>
                      <a:pt x="457" y="56"/>
                      <a:pt x="458" y="61"/>
                      <a:pt x="457" y="65"/>
                    </a:cubicBezTo>
                    <a:cubicBezTo>
                      <a:pt x="455" y="68"/>
                      <a:pt x="451" y="70"/>
                      <a:pt x="447" y="69"/>
                    </a:cubicBezTo>
                    <a:lnTo>
                      <a:pt x="426" y="62"/>
                    </a:lnTo>
                    <a:cubicBezTo>
                      <a:pt x="422" y="61"/>
                      <a:pt x="420" y="57"/>
                      <a:pt x="421" y="53"/>
                    </a:cubicBezTo>
                    <a:cubicBezTo>
                      <a:pt x="422" y="49"/>
                      <a:pt x="425" y="46"/>
                      <a:pt x="429" y="47"/>
                    </a:cubicBezTo>
                    <a:lnTo>
                      <a:pt x="438" y="48"/>
                    </a:lnTo>
                    <a:cubicBezTo>
                      <a:pt x="442" y="48"/>
                      <a:pt x="446" y="52"/>
                      <a:pt x="445" y="56"/>
                    </a:cubicBezTo>
                    <a:cubicBezTo>
                      <a:pt x="445" y="60"/>
                      <a:pt x="442" y="63"/>
                      <a:pt x="438" y="63"/>
                    </a:cubicBezTo>
                    <a:lnTo>
                      <a:pt x="418" y="64"/>
                    </a:lnTo>
                    <a:cubicBezTo>
                      <a:pt x="414" y="65"/>
                      <a:pt x="410" y="62"/>
                      <a:pt x="410" y="58"/>
                    </a:cubicBezTo>
                    <a:cubicBezTo>
                      <a:pt x="409" y="54"/>
                      <a:pt x="411" y="50"/>
                      <a:pt x="415" y="49"/>
                    </a:cubicBezTo>
                    <a:lnTo>
                      <a:pt x="424" y="46"/>
                    </a:lnTo>
                    <a:cubicBezTo>
                      <a:pt x="428" y="45"/>
                      <a:pt x="432" y="46"/>
                      <a:pt x="434" y="50"/>
                    </a:cubicBezTo>
                    <a:cubicBezTo>
                      <a:pt x="435" y="54"/>
                      <a:pt x="434" y="58"/>
                      <a:pt x="430" y="60"/>
                    </a:cubicBezTo>
                    <a:lnTo>
                      <a:pt x="411" y="71"/>
                    </a:lnTo>
                    <a:cubicBezTo>
                      <a:pt x="408" y="74"/>
                      <a:pt x="403" y="72"/>
                      <a:pt x="401" y="69"/>
                    </a:cubicBezTo>
                    <a:cubicBezTo>
                      <a:pt x="398" y="65"/>
                      <a:pt x="399" y="60"/>
                      <a:pt x="403" y="58"/>
                    </a:cubicBezTo>
                    <a:lnTo>
                      <a:pt x="409" y="54"/>
                    </a:lnTo>
                    <a:cubicBezTo>
                      <a:pt x="412" y="52"/>
                      <a:pt x="417" y="52"/>
                      <a:pt x="420" y="55"/>
                    </a:cubicBezTo>
                    <a:cubicBezTo>
                      <a:pt x="422" y="58"/>
                      <a:pt x="422" y="63"/>
                      <a:pt x="419" y="66"/>
                    </a:cubicBezTo>
                    <a:lnTo>
                      <a:pt x="403" y="84"/>
                    </a:lnTo>
                    <a:lnTo>
                      <a:pt x="386" y="109"/>
                    </a:lnTo>
                    <a:lnTo>
                      <a:pt x="368" y="139"/>
                    </a:lnTo>
                    <a:lnTo>
                      <a:pt x="347" y="172"/>
                    </a:lnTo>
                    <a:lnTo>
                      <a:pt x="326" y="203"/>
                    </a:lnTo>
                    <a:lnTo>
                      <a:pt x="304" y="228"/>
                    </a:lnTo>
                    <a:cubicBezTo>
                      <a:pt x="304" y="228"/>
                      <a:pt x="304" y="228"/>
                      <a:pt x="303" y="229"/>
                    </a:cubicBezTo>
                    <a:lnTo>
                      <a:pt x="298" y="233"/>
                    </a:lnTo>
                    <a:lnTo>
                      <a:pt x="274" y="249"/>
                    </a:lnTo>
                    <a:cubicBezTo>
                      <a:pt x="274" y="249"/>
                      <a:pt x="273" y="250"/>
                      <a:pt x="273" y="250"/>
                    </a:cubicBezTo>
                    <a:lnTo>
                      <a:pt x="266" y="253"/>
                    </a:lnTo>
                    <a:lnTo>
                      <a:pt x="211" y="269"/>
                    </a:lnTo>
                    <a:cubicBezTo>
                      <a:pt x="210" y="269"/>
                      <a:pt x="209" y="269"/>
                      <a:pt x="208" y="269"/>
                    </a:cubicBezTo>
                    <a:lnTo>
                      <a:pt x="203" y="269"/>
                    </a:lnTo>
                    <a:lnTo>
                      <a:pt x="141" y="271"/>
                    </a:lnTo>
                    <a:lnTo>
                      <a:pt x="74" y="265"/>
                    </a:lnTo>
                    <a:lnTo>
                      <a:pt x="7" y="254"/>
                    </a:lnTo>
                    <a:cubicBezTo>
                      <a:pt x="5" y="254"/>
                      <a:pt x="3" y="253"/>
                      <a:pt x="2" y="251"/>
                    </a:cubicBezTo>
                    <a:cubicBezTo>
                      <a:pt x="1" y="249"/>
                      <a:pt x="0" y="247"/>
                      <a:pt x="1" y="245"/>
                    </a:cubicBezTo>
                    <a:lnTo>
                      <a:pt x="10" y="198"/>
                    </a:lnTo>
                    <a:close/>
                    <a:moveTo>
                      <a:pt x="16" y="248"/>
                    </a:moveTo>
                    <a:lnTo>
                      <a:pt x="10" y="239"/>
                    </a:lnTo>
                    <a:lnTo>
                      <a:pt x="75" y="249"/>
                    </a:lnTo>
                    <a:lnTo>
                      <a:pt x="140" y="255"/>
                    </a:lnTo>
                    <a:lnTo>
                      <a:pt x="203" y="253"/>
                    </a:lnTo>
                    <a:lnTo>
                      <a:pt x="208" y="253"/>
                    </a:lnTo>
                    <a:lnTo>
                      <a:pt x="206" y="254"/>
                    </a:lnTo>
                    <a:lnTo>
                      <a:pt x="259" y="238"/>
                    </a:lnTo>
                    <a:lnTo>
                      <a:pt x="266" y="235"/>
                    </a:lnTo>
                    <a:lnTo>
                      <a:pt x="265" y="236"/>
                    </a:lnTo>
                    <a:lnTo>
                      <a:pt x="288" y="220"/>
                    </a:lnTo>
                    <a:lnTo>
                      <a:pt x="293" y="216"/>
                    </a:lnTo>
                    <a:lnTo>
                      <a:pt x="292" y="217"/>
                    </a:lnTo>
                    <a:lnTo>
                      <a:pt x="313" y="194"/>
                    </a:lnTo>
                    <a:lnTo>
                      <a:pt x="334" y="163"/>
                    </a:lnTo>
                    <a:lnTo>
                      <a:pt x="355" y="130"/>
                    </a:lnTo>
                    <a:lnTo>
                      <a:pt x="373" y="100"/>
                    </a:lnTo>
                    <a:lnTo>
                      <a:pt x="391" y="73"/>
                    </a:lnTo>
                    <a:lnTo>
                      <a:pt x="407" y="55"/>
                    </a:lnTo>
                    <a:lnTo>
                      <a:pt x="418" y="67"/>
                    </a:lnTo>
                    <a:lnTo>
                      <a:pt x="412" y="71"/>
                    </a:lnTo>
                    <a:lnTo>
                      <a:pt x="403" y="58"/>
                    </a:lnTo>
                    <a:lnTo>
                      <a:pt x="422" y="47"/>
                    </a:lnTo>
                    <a:lnTo>
                      <a:pt x="429" y="61"/>
                    </a:lnTo>
                    <a:lnTo>
                      <a:pt x="420" y="64"/>
                    </a:lnTo>
                    <a:lnTo>
                      <a:pt x="417" y="48"/>
                    </a:lnTo>
                    <a:lnTo>
                      <a:pt x="437" y="47"/>
                    </a:lnTo>
                    <a:lnTo>
                      <a:pt x="437" y="63"/>
                    </a:lnTo>
                    <a:lnTo>
                      <a:pt x="428" y="62"/>
                    </a:lnTo>
                    <a:lnTo>
                      <a:pt x="431" y="47"/>
                    </a:lnTo>
                    <a:lnTo>
                      <a:pt x="452" y="54"/>
                    </a:lnTo>
                    <a:lnTo>
                      <a:pt x="446" y="69"/>
                    </a:lnTo>
                    <a:lnTo>
                      <a:pt x="442" y="67"/>
                    </a:lnTo>
                    <a:lnTo>
                      <a:pt x="450" y="53"/>
                    </a:lnTo>
                    <a:lnTo>
                      <a:pt x="472" y="66"/>
                    </a:lnTo>
                    <a:lnTo>
                      <a:pt x="463" y="79"/>
                    </a:lnTo>
                    <a:lnTo>
                      <a:pt x="460" y="77"/>
                    </a:lnTo>
                    <a:lnTo>
                      <a:pt x="470" y="64"/>
                    </a:lnTo>
                    <a:lnTo>
                      <a:pt x="491" y="82"/>
                    </a:lnTo>
                    <a:lnTo>
                      <a:pt x="528" y="116"/>
                    </a:lnTo>
                    <a:lnTo>
                      <a:pt x="543" y="130"/>
                    </a:lnTo>
                    <a:lnTo>
                      <a:pt x="554" y="140"/>
                    </a:lnTo>
                    <a:lnTo>
                      <a:pt x="566" y="149"/>
                    </a:lnTo>
                    <a:lnTo>
                      <a:pt x="554" y="157"/>
                    </a:lnTo>
                    <a:lnTo>
                      <a:pt x="547" y="126"/>
                    </a:lnTo>
                    <a:lnTo>
                      <a:pt x="562" y="128"/>
                    </a:lnTo>
                    <a:lnTo>
                      <a:pt x="561" y="130"/>
                    </a:lnTo>
                    <a:lnTo>
                      <a:pt x="551" y="119"/>
                    </a:lnTo>
                    <a:lnTo>
                      <a:pt x="582" y="108"/>
                    </a:lnTo>
                    <a:lnTo>
                      <a:pt x="581" y="123"/>
                    </a:lnTo>
                    <a:lnTo>
                      <a:pt x="574" y="120"/>
                    </a:lnTo>
                    <a:lnTo>
                      <a:pt x="561" y="114"/>
                    </a:lnTo>
                    <a:lnTo>
                      <a:pt x="572" y="109"/>
                    </a:lnTo>
                    <a:lnTo>
                      <a:pt x="554" y="153"/>
                    </a:lnTo>
                    <a:lnTo>
                      <a:pt x="549" y="143"/>
                    </a:lnTo>
                    <a:lnTo>
                      <a:pt x="560" y="148"/>
                    </a:lnTo>
                    <a:lnTo>
                      <a:pt x="567" y="152"/>
                    </a:lnTo>
                    <a:lnTo>
                      <a:pt x="564" y="150"/>
                    </a:lnTo>
                    <a:lnTo>
                      <a:pt x="582" y="151"/>
                    </a:lnTo>
                    <a:lnTo>
                      <a:pt x="576" y="153"/>
                    </a:lnTo>
                    <a:lnTo>
                      <a:pt x="590" y="141"/>
                    </a:lnTo>
                    <a:lnTo>
                      <a:pt x="587" y="147"/>
                    </a:lnTo>
                    <a:lnTo>
                      <a:pt x="588" y="146"/>
                    </a:lnTo>
                    <a:lnTo>
                      <a:pt x="590" y="129"/>
                    </a:lnTo>
                    <a:lnTo>
                      <a:pt x="591" y="134"/>
                    </a:lnTo>
                    <a:lnTo>
                      <a:pt x="582" y="120"/>
                    </a:lnTo>
                    <a:lnTo>
                      <a:pt x="585" y="122"/>
                    </a:lnTo>
                    <a:lnTo>
                      <a:pt x="576" y="117"/>
                    </a:lnTo>
                    <a:cubicBezTo>
                      <a:pt x="575" y="117"/>
                      <a:pt x="575" y="117"/>
                      <a:pt x="574" y="116"/>
                    </a:cubicBezTo>
                    <a:lnTo>
                      <a:pt x="564" y="107"/>
                    </a:lnTo>
                    <a:lnTo>
                      <a:pt x="549" y="93"/>
                    </a:lnTo>
                    <a:lnTo>
                      <a:pt x="509" y="57"/>
                    </a:lnTo>
                    <a:lnTo>
                      <a:pt x="489" y="40"/>
                    </a:lnTo>
                    <a:lnTo>
                      <a:pt x="487" y="38"/>
                    </a:lnTo>
                    <a:lnTo>
                      <a:pt x="465" y="26"/>
                    </a:lnTo>
                    <a:cubicBezTo>
                      <a:pt x="464" y="26"/>
                      <a:pt x="464" y="26"/>
                      <a:pt x="464" y="26"/>
                    </a:cubicBezTo>
                    <a:lnTo>
                      <a:pt x="460" y="23"/>
                    </a:lnTo>
                    <a:lnTo>
                      <a:pt x="462" y="24"/>
                    </a:lnTo>
                    <a:lnTo>
                      <a:pt x="441" y="17"/>
                    </a:lnTo>
                    <a:lnTo>
                      <a:pt x="443" y="17"/>
                    </a:lnTo>
                    <a:lnTo>
                      <a:pt x="433" y="16"/>
                    </a:lnTo>
                    <a:lnTo>
                      <a:pt x="434" y="16"/>
                    </a:lnTo>
                    <a:lnTo>
                      <a:pt x="414" y="18"/>
                    </a:lnTo>
                    <a:lnTo>
                      <a:pt x="416" y="18"/>
                    </a:lnTo>
                    <a:lnTo>
                      <a:pt x="406" y="21"/>
                    </a:lnTo>
                    <a:lnTo>
                      <a:pt x="407" y="20"/>
                    </a:lnTo>
                    <a:lnTo>
                      <a:pt x="389" y="31"/>
                    </a:lnTo>
                    <a:lnTo>
                      <a:pt x="383" y="35"/>
                    </a:lnTo>
                    <a:lnTo>
                      <a:pt x="385" y="34"/>
                    </a:lnTo>
                    <a:lnTo>
                      <a:pt x="365" y="57"/>
                    </a:lnTo>
                    <a:lnTo>
                      <a:pt x="347" y="83"/>
                    </a:lnTo>
                    <a:lnTo>
                      <a:pt x="328" y="115"/>
                    </a:lnTo>
                    <a:lnTo>
                      <a:pt x="309" y="144"/>
                    </a:lnTo>
                    <a:lnTo>
                      <a:pt x="289" y="172"/>
                    </a:lnTo>
                    <a:lnTo>
                      <a:pt x="268" y="196"/>
                    </a:lnTo>
                    <a:lnTo>
                      <a:pt x="258" y="184"/>
                    </a:lnTo>
                    <a:lnTo>
                      <a:pt x="263" y="181"/>
                    </a:lnTo>
                    <a:cubicBezTo>
                      <a:pt x="267" y="178"/>
                      <a:pt x="272" y="180"/>
                      <a:pt x="274" y="183"/>
                    </a:cubicBezTo>
                    <a:cubicBezTo>
                      <a:pt x="277" y="187"/>
                      <a:pt x="276" y="192"/>
                      <a:pt x="272" y="194"/>
                    </a:cubicBezTo>
                    <a:lnTo>
                      <a:pt x="248" y="210"/>
                    </a:lnTo>
                    <a:lnTo>
                      <a:pt x="240" y="196"/>
                    </a:lnTo>
                    <a:lnTo>
                      <a:pt x="247" y="193"/>
                    </a:lnTo>
                    <a:lnTo>
                      <a:pt x="253" y="208"/>
                    </a:lnTo>
                    <a:lnTo>
                      <a:pt x="199" y="223"/>
                    </a:lnTo>
                    <a:lnTo>
                      <a:pt x="195" y="208"/>
                    </a:lnTo>
                    <a:lnTo>
                      <a:pt x="200" y="207"/>
                    </a:lnTo>
                    <a:lnTo>
                      <a:pt x="202" y="222"/>
                    </a:lnTo>
                    <a:lnTo>
                      <a:pt x="146" y="225"/>
                    </a:lnTo>
                    <a:cubicBezTo>
                      <a:pt x="145" y="225"/>
                      <a:pt x="145" y="225"/>
                      <a:pt x="145" y="225"/>
                    </a:cubicBezTo>
                    <a:lnTo>
                      <a:pt x="81" y="218"/>
                    </a:lnTo>
                    <a:lnTo>
                      <a:pt x="16" y="207"/>
                    </a:lnTo>
                    <a:lnTo>
                      <a:pt x="25" y="201"/>
                    </a:lnTo>
                    <a:lnTo>
                      <a:pt x="16" y="248"/>
                    </a:lnTo>
                    <a:close/>
                  </a:path>
                </a:pathLst>
              </a:custGeom>
              <a:solidFill>
                <a:srgbClr val="C3D69B"/>
              </a:solidFill>
              <a:ln w="1588" cap="flat">
                <a:solidFill>
                  <a:srgbClr val="C3D69B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" name="Freeform 172">
                <a:extLst>
                  <a:ext uri="{FF2B5EF4-FFF2-40B4-BE49-F238E27FC236}">
                    <a16:creationId xmlns:a16="http://schemas.microsoft.com/office/drawing/2014/main" id="{7F91FDFF-FB49-41B6-8604-764C97555CB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51" y="2319"/>
                <a:ext cx="130" cy="40"/>
              </a:xfrm>
              <a:custGeom>
                <a:avLst/>
                <a:gdLst>
                  <a:gd name="T0" fmla="*/ 591 w 672"/>
                  <a:gd name="T1" fmla="*/ 53 h 224"/>
                  <a:gd name="T2" fmla="*/ 455 w 672"/>
                  <a:gd name="T3" fmla="*/ 49 h 224"/>
                  <a:gd name="T4" fmla="*/ 397 w 672"/>
                  <a:gd name="T5" fmla="*/ 63 h 224"/>
                  <a:gd name="T6" fmla="*/ 376 w 672"/>
                  <a:gd name="T7" fmla="*/ 74 h 224"/>
                  <a:gd name="T8" fmla="*/ 355 w 672"/>
                  <a:gd name="T9" fmla="*/ 92 h 224"/>
                  <a:gd name="T10" fmla="*/ 312 w 672"/>
                  <a:gd name="T11" fmla="*/ 140 h 224"/>
                  <a:gd name="T12" fmla="*/ 270 w 672"/>
                  <a:gd name="T13" fmla="*/ 189 h 224"/>
                  <a:gd name="T14" fmla="*/ 247 w 672"/>
                  <a:gd name="T15" fmla="*/ 208 h 224"/>
                  <a:gd name="T16" fmla="*/ 220 w 672"/>
                  <a:gd name="T17" fmla="*/ 222 h 224"/>
                  <a:gd name="T18" fmla="*/ 188 w 672"/>
                  <a:gd name="T19" fmla="*/ 224 h 224"/>
                  <a:gd name="T20" fmla="*/ 157 w 672"/>
                  <a:gd name="T21" fmla="*/ 218 h 224"/>
                  <a:gd name="T22" fmla="*/ 128 w 672"/>
                  <a:gd name="T23" fmla="*/ 205 h 224"/>
                  <a:gd name="T24" fmla="*/ 56 w 672"/>
                  <a:gd name="T25" fmla="*/ 159 h 224"/>
                  <a:gd name="T26" fmla="*/ 27 w 672"/>
                  <a:gd name="T27" fmla="*/ 139 h 224"/>
                  <a:gd name="T28" fmla="*/ 6 w 672"/>
                  <a:gd name="T29" fmla="*/ 102 h 224"/>
                  <a:gd name="T30" fmla="*/ 36 w 672"/>
                  <a:gd name="T31" fmla="*/ 89 h 224"/>
                  <a:gd name="T32" fmla="*/ 59 w 672"/>
                  <a:gd name="T33" fmla="*/ 98 h 224"/>
                  <a:gd name="T34" fmla="*/ 30 w 672"/>
                  <a:gd name="T35" fmla="*/ 137 h 224"/>
                  <a:gd name="T36" fmla="*/ 50 w 672"/>
                  <a:gd name="T37" fmla="*/ 122 h 224"/>
                  <a:gd name="T38" fmla="*/ 39 w 672"/>
                  <a:gd name="T39" fmla="*/ 93 h 224"/>
                  <a:gd name="T40" fmla="*/ 66 w 672"/>
                  <a:gd name="T41" fmla="*/ 108 h 224"/>
                  <a:gd name="T42" fmla="*/ 124 w 672"/>
                  <a:gd name="T43" fmla="*/ 149 h 224"/>
                  <a:gd name="T44" fmla="*/ 172 w 672"/>
                  <a:gd name="T45" fmla="*/ 173 h 224"/>
                  <a:gd name="T46" fmla="*/ 193 w 672"/>
                  <a:gd name="T47" fmla="*/ 177 h 224"/>
                  <a:gd name="T48" fmla="*/ 209 w 672"/>
                  <a:gd name="T49" fmla="*/ 176 h 224"/>
                  <a:gd name="T50" fmla="*/ 222 w 672"/>
                  <a:gd name="T51" fmla="*/ 168 h 224"/>
                  <a:gd name="T52" fmla="*/ 238 w 672"/>
                  <a:gd name="T53" fmla="*/ 155 h 224"/>
                  <a:gd name="T54" fmla="*/ 255 w 672"/>
                  <a:gd name="T55" fmla="*/ 135 h 224"/>
                  <a:gd name="T56" fmla="*/ 321 w 672"/>
                  <a:gd name="T57" fmla="*/ 58 h 224"/>
                  <a:gd name="T58" fmla="*/ 350 w 672"/>
                  <a:gd name="T59" fmla="*/ 35 h 224"/>
                  <a:gd name="T60" fmla="*/ 381 w 672"/>
                  <a:gd name="T61" fmla="*/ 18 h 224"/>
                  <a:gd name="T62" fmla="*/ 449 w 672"/>
                  <a:gd name="T63" fmla="*/ 3 h 224"/>
                  <a:gd name="T64" fmla="*/ 523 w 672"/>
                  <a:gd name="T65" fmla="*/ 0 h 224"/>
                  <a:gd name="T66" fmla="*/ 672 w 672"/>
                  <a:gd name="T67" fmla="*/ 16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</a:cxnLst>
                <a:rect l="0" t="0" r="r" b="b"/>
                <a:pathLst>
                  <a:path w="672" h="224">
                    <a:moveTo>
                      <a:pt x="666" y="63"/>
                    </a:moveTo>
                    <a:lnTo>
                      <a:pt x="591" y="53"/>
                    </a:lnTo>
                    <a:lnTo>
                      <a:pt x="520" y="47"/>
                    </a:lnTo>
                    <a:lnTo>
                      <a:pt x="455" y="49"/>
                    </a:lnTo>
                    <a:lnTo>
                      <a:pt x="458" y="49"/>
                    </a:lnTo>
                    <a:lnTo>
                      <a:pt x="397" y="63"/>
                    </a:lnTo>
                    <a:lnTo>
                      <a:pt x="402" y="60"/>
                    </a:lnTo>
                    <a:lnTo>
                      <a:pt x="376" y="74"/>
                    </a:lnTo>
                    <a:lnTo>
                      <a:pt x="380" y="71"/>
                    </a:lnTo>
                    <a:lnTo>
                      <a:pt x="355" y="92"/>
                    </a:lnTo>
                    <a:lnTo>
                      <a:pt x="357" y="90"/>
                    </a:lnTo>
                    <a:lnTo>
                      <a:pt x="312" y="140"/>
                    </a:lnTo>
                    <a:lnTo>
                      <a:pt x="292" y="165"/>
                    </a:lnTo>
                    <a:lnTo>
                      <a:pt x="270" y="189"/>
                    </a:lnTo>
                    <a:cubicBezTo>
                      <a:pt x="270" y="190"/>
                      <a:pt x="269" y="190"/>
                      <a:pt x="268" y="191"/>
                    </a:cubicBezTo>
                    <a:lnTo>
                      <a:pt x="247" y="208"/>
                    </a:lnTo>
                    <a:cubicBezTo>
                      <a:pt x="246" y="210"/>
                      <a:pt x="244" y="211"/>
                      <a:pt x="242" y="212"/>
                    </a:cubicBezTo>
                    <a:lnTo>
                      <a:pt x="220" y="222"/>
                    </a:lnTo>
                    <a:cubicBezTo>
                      <a:pt x="218" y="222"/>
                      <a:pt x="215" y="223"/>
                      <a:pt x="211" y="223"/>
                    </a:cubicBezTo>
                    <a:lnTo>
                      <a:pt x="188" y="224"/>
                    </a:lnTo>
                    <a:cubicBezTo>
                      <a:pt x="186" y="224"/>
                      <a:pt x="184" y="224"/>
                      <a:pt x="182" y="224"/>
                    </a:cubicBezTo>
                    <a:lnTo>
                      <a:pt x="157" y="218"/>
                    </a:lnTo>
                    <a:cubicBezTo>
                      <a:pt x="156" y="217"/>
                      <a:pt x="154" y="217"/>
                      <a:pt x="153" y="216"/>
                    </a:cubicBezTo>
                    <a:lnTo>
                      <a:pt x="128" y="205"/>
                    </a:lnTo>
                    <a:lnTo>
                      <a:pt x="101" y="191"/>
                    </a:lnTo>
                    <a:lnTo>
                      <a:pt x="56" y="159"/>
                    </a:lnTo>
                    <a:lnTo>
                      <a:pt x="39" y="148"/>
                    </a:lnTo>
                    <a:lnTo>
                      <a:pt x="27" y="139"/>
                    </a:lnTo>
                    <a:lnTo>
                      <a:pt x="16" y="134"/>
                    </a:lnTo>
                    <a:cubicBezTo>
                      <a:pt x="5" y="128"/>
                      <a:pt x="0" y="114"/>
                      <a:pt x="6" y="102"/>
                    </a:cubicBezTo>
                    <a:lnTo>
                      <a:pt x="7" y="101"/>
                    </a:lnTo>
                    <a:cubicBezTo>
                      <a:pt x="12" y="91"/>
                      <a:pt x="24" y="85"/>
                      <a:pt x="36" y="89"/>
                    </a:cubicBezTo>
                    <a:lnTo>
                      <a:pt x="45" y="92"/>
                    </a:lnTo>
                    <a:lnTo>
                      <a:pt x="59" y="98"/>
                    </a:lnTo>
                    <a:lnTo>
                      <a:pt x="42" y="142"/>
                    </a:lnTo>
                    <a:lnTo>
                      <a:pt x="30" y="137"/>
                    </a:lnTo>
                    <a:lnTo>
                      <a:pt x="21" y="134"/>
                    </a:lnTo>
                    <a:lnTo>
                      <a:pt x="50" y="122"/>
                    </a:lnTo>
                    <a:lnTo>
                      <a:pt x="49" y="124"/>
                    </a:lnTo>
                    <a:lnTo>
                      <a:pt x="39" y="93"/>
                    </a:lnTo>
                    <a:lnTo>
                      <a:pt x="53" y="100"/>
                    </a:lnTo>
                    <a:lnTo>
                      <a:pt x="66" y="108"/>
                    </a:lnTo>
                    <a:lnTo>
                      <a:pt x="83" y="120"/>
                    </a:lnTo>
                    <a:lnTo>
                      <a:pt x="124" y="149"/>
                    </a:lnTo>
                    <a:lnTo>
                      <a:pt x="147" y="162"/>
                    </a:lnTo>
                    <a:lnTo>
                      <a:pt x="172" y="173"/>
                    </a:lnTo>
                    <a:lnTo>
                      <a:pt x="168" y="171"/>
                    </a:lnTo>
                    <a:lnTo>
                      <a:pt x="193" y="177"/>
                    </a:lnTo>
                    <a:lnTo>
                      <a:pt x="186" y="176"/>
                    </a:lnTo>
                    <a:lnTo>
                      <a:pt x="209" y="176"/>
                    </a:lnTo>
                    <a:lnTo>
                      <a:pt x="200" y="178"/>
                    </a:lnTo>
                    <a:lnTo>
                      <a:pt x="222" y="168"/>
                    </a:lnTo>
                    <a:lnTo>
                      <a:pt x="217" y="172"/>
                    </a:lnTo>
                    <a:lnTo>
                      <a:pt x="238" y="155"/>
                    </a:lnTo>
                    <a:lnTo>
                      <a:pt x="235" y="157"/>
                    </a:lnTo>
                    <a:lnTo>
                      <a:pt x="255" y="135"/>
                    </a:lnTo>
                    <a:lnTo>
                      <a:pt x="276" y="108"/>
                    </a:lnTo>
                    <a:lnTo>
                      <a:pt x="321" y="58"/>
                    </a:lnTo>
                    <a:cubicBezTo>
                      <a:pt x="323" y="57"/>
                      <a:pt x="323" y="57"/>
                      <a:pt x="324" y="56"/>
                    </a:cubicBezTo>
                    <a:lnTo>
                      <a:pt x="350" y="35"/>
                    </a:lnTo>
                    <a:cubicBezTo>
                      <a:pt x="351" y="34"/>
                      <a:pt x="353" y="33"/>
                      <a:pt x="354" y="32"/>
                    </a:cubicBezTo>
                    <a:lnTo>
                      <a:pt x="381" y="18"/>
                    </a:lnTo>
                    <a:cubicBezTo>
                      <a:pt x="382" y="17"/>
                      <a:pt x="385" y="17"/>
                      <a:pt x="387" y="16"/>
                    </a:cubicBezTo>
                    <a:lnTo>
                      <a:pt x="449" y="3"/>
                    </a:lnTo>
                    <a:cubicBezTo>
                      <a:pt x="450" y="3"/>
                      <a:pt x="451" y="3"/>
                      <a:pt x="452" y="2"/>
                    </a:cubicBezTo>
                    <a:lnTo>
                      <a:pt x="523" y="0"/>
                    </a:lnTo>
                    <a:lnTo>
                      <a:pt x="598" y="6"/>
                    </a:lnTo>
                    <a:lnTo>
                      <a:pt x="672" y="16"/>
                    </a:lnTo>
                    <a:lnTo>
                      <a:pt x="666" y="63"/>
                    </a:lnTo>
                    <a:close/>
                  </a:path>
                </a:pathLst>
              </a:custGeom>
              <a:solidFill>
                <a:srgbClr val="8EB4E3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" name="Freeform 173">
                <a:extLst>
                  <a:ext uri="{FF2B5EF4-FFF2-40B4-BE49-F238E27FC236}">
                    <a16:creationId xmlns:a16="http://schemas.microsoft.com/office/drawing/2014/main" id="{095CB6E8-FB0F-4B0E-BCEF-67D28DF4142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50" y="2318"/>
                <a:ext cx="133" cy="43"/>
              </a:xfrm>
              <a:custGeom>
                <a:avLst/>
                <a:gdLst>
                  <a:gd name="T0" fmla="*/ 593 w 684"/>
                  <a:gd name="T1" fmla="*/ 69 h 240"/>
                  <a:gd name="T2" fmla="*/ 461 w 684"/>
                  <a:gd name="T3" fmla="*/ 49 h 240"/>
                  <a:gd name="T4" fmla="*/ 393 w 684"/>
                  <a:gd name="T5" fmla="*/ 74 h 240"/>
                  <a:gd name="T6" fmla="*/ 383 w 684"/>
                  <a:gd name="T7" fmla="*/ 90 h 240"/>
                  <a:gd name="T8" fmla="*/ 390 w 684"/>
                  <a:gd name="T9" fmla="*/ 74 h 240"/>
                  <a:gd name="T10" fmla="*/ 353 w 684"/>
                  <a:gd name="T11" fmla="*/ 95 h 240"/>
                  <a:gd name="T12" fmla="*/ 321 w 684"/>
                  <a:gd name="T13" fmla="*/ 154 h 240"/>
                  <a:gd name="T14" fmla="*/ 256 w 684"/>
                  <a:gd name="T15" fmla="*/ 223 h 240"/>
                  <a:gd name="T16" fmla="*/ 224 w 684"/>
                  <a:gd name="T17" fmla="*/ 238 h 240"/>
                  <a:gd name="T18" fmla="*/ 184 w 684"/>
                  <a:gd name="T19" fmla="*/ 240 h 240"/>
                  <a:gd name="T20" fmla="*/ 128 w 684"/>
                  <a:gd name="T21" fmla="*/ 221 h 240"/>
                  <a:gd name="T22" fmla="*/ 26 w 684"/>
                  <a:gd name="T23" fmla="*/ 154 h 240"/>
                  <a:gd name="T24" fmla="*/ 2 w 684"/>
                  <a:gd name="T25" fmla="*/ 133 h 240"/>
                  <a:gd name="T26" fmla="*/ 5 w 684"/>
                  <a:gd name="T27" fmla="*/ 104 h 240"/>
                  <a:gd name="T28" fmla="*/ 42 w 684"/>
                  <a:gd name="T29" fmla="*/ 90 h 240"/>
                  <a:gd name="T30" fmla="*/ 53 w 684"/>
                  <a:gd name="T31" fmla="*/ 153 h 240"/>
                  <a:gd name="T32" fmla="*/ 22 w 684"/>
                  <a:gd name="T33" fmla="*/ 150 h 240"/>
                  <a:gd name="T34" fmla="*/ 59 w 684"/>
                  <a:gd name="T35" fmla="*/ 125 h 240"/>
                  <a:gd name="T36" fmla="*/ 45 w 684"/>
                  <a:gd name="T37" fmla="*/ 135 h 240"/>
                  <a:gd name="T38" fmla="*/ 60 w 684"/>
                  <a:gd name="T39" fmla="*/ 101 h 240"/>
                  <a:gd name="T40" fmla="*/ 154 w 684"/>
                  <a:gd name="T41" fmla="*/ 163 h 240"/>
                  <a:gd name="T42" fmla="*/ 164 w 684"/>
                  <a:gd name="T43" fmla="*/ 177 h 240"/>
                  <a:gd name="T44" fmla="*/ 195 w 684"/>
                  <a:gd name="T45" fmla="*/ 193 h 240"/>
                  <a:gd name="T46" fmla="*/ 212 w 684"/>
                  <a:gd name="T47" fmla="*/ 176 h 240"/>
                  <a:gd name="T48" fmla="*/ 196 w 684"/>
                  <a:gd name="T49" fmla="*/ 189 h 240"/>
                  <a:gd name="T50" fmla="*/ 230 w 684"/>
                  <a:gd name="T51" fmla="*/ 183 h 240"/>
                  <a:gd name="T52" fmla="*/ 236 w 684"/>
                  <a:gd name="T53" fmla="*/ 157 h 240"/>
                  <a:gd name="T54" fmla="*/ 233 w 684"/>
                  <a:gd name="T55" fmla="*/ 160 h 240"/>
                  <a:gd name="T56" fmla="*/ 320 w 684"/>
                  <a:gd name="T57" fmla="*/ 60 h 240"/>
                  <a:gd name="T58" fmla="*/ 354 w 684"/>
                  <a:gd name="T59" fmla="*/ 33 h 240"/>
                  <a:gd name="T60" fmla="*/ 451 w 684"/>
                  <a:gd name="T61" fmla="*/ 4 h 240"/>
                  <a:gd name="T62" fmla="*/ 602 w 684"/>
                  <a:gd name="T63" fmla="*/ 6 h 240"/>
                  <a:gd name="T64" fmla="*/ 668 w 684"/>
                  <a:gd name="T65" fmla="*/ 23 h 240"/>
                  <a:gd name="T66" fmla="*/ 456 w 684"/>
                  <a:gd name="T67" fmla="*/ 18 h 240"/>
                  <a:gd name="T68" fmla="*/ 387 w 684"/>
                  <a:gd name="T69" fmla="*/ 34 h 240"/>
                  <a:gd name="T70" fmla="*/ 358 w 684"/>
                  <a:gd name="T71" fmla="*/ 50 h 240"/>
                  <a:gd name="T72" fmla="*/ 286 w 684"/>
                  <a:gd name="T73" fmla="*/ 121 h 240"/>
                  <a:gd name="T74" fmla="*/ 237 w 684"/>
                  <a:gd name="T75" fmla="*/ 157 h 240"/>
                  <a:gd name="T76" fmla="*/ 215 w 684"/>
                  <a:gd name="T77" fmla="*/ 174 h 240"/>
                  <a:gd name="T78" fmla="*/ 202 w 684"/>
                  <a:gd name="T79" fmla="*/ 179 h 240"/>
                  <a:gd name="T80" fmla="*/ 191 w 684"/>
                  <a:gd name="T81" fmla="*/ 177 h 240"/>
                  <a:gd name="T82" fmla="*/ 175 w 684"/>
                  <a:gd name="T83" fmla="*/ 172 h 240"/>
                  <a:gd name="T84" fmla="*/ 147 w 684"/>
                  <a:gd name="T85" fmla="*/ 177 h 240"/>
                  <a:gd name="T86" fmla="*/ 53 w 684"/>
                  <a:gd name="T87" fmla="*/ 116 h 240"/>
                  <a:gd name="T88" fmla="*/ 45 w 684"/>
                  <a:gd name="T89" fmla="*/ 129 h 240"/>
                  <a:gd name="T90" fmla="*/ 27 w 684"/>
                  <a:gd name="T91" fmla="*/ 135 h 240"/>
                  <a:gd name="T92" fmla="*/ 55 w 684"/>
                  <a:gd name="T93" fmla="*/ 104 h 240"/>
                  <a:gd name="T94" fmla="*/ 40 w 684"/>
                  <a:gd name="T95" fmla="*/ 105 h 240"/>
                  <a:gd name="T96" fmla="*/ 15 w 684"/>
                  <a:gd name="T97" fmla="*/ 116 h 240"/>
                  <a:gd name="T98" fmla="*/ 26 w 684"/>
                  <a:gd name="T99" fmla="*/ 138 h 240"/>
                  <a:gd name="T100" fmla="*/ 47 w 684"/>
                  <a:gd name="T101" fmla="*/ 150 h 240"/>
                  <a:gd name="T102" fmla="*/ 160 w 684"/>
                  <a:gd name="T103" fmla="*/ 217 h 240"/>
                  <a:gd name="T104" fmla="*/ 185 w 684"/>
                  <a:gd name="T105" fmla="*/ 224 h 240"/>
                  <a:gd name="T106" fmla="*/ 220 w 684"/>
                  <a:gd name="T107" fmla="*/ 223 h 240"/>
                  <a:gd name="T108" fmla="*/ 266 w 684"/>
                  <a:gd name="T109" fmla="*/ 194 h 240"/>
                  <a:gd name="T110" fmla="*/ 355 w 684"/>
                  <a:gd name="T111" fmla="*/ 93 h 240"/>
                  <a:gd name="T112" fmla="*/ 378 w 684"/>
                  <a:gd name="T113" fmla="*/ 73 h 240"/>
                  <a:gd name="T114" fmla="*/ 402 w 684"/>
                  <a:gd name="T115" fmla="*/ 61 h 240"/>
                  <a:gd name="T116" fmla="*/ 399 w 684"/>
                  <a:gd name="T117" fmla="*/ 64 h 240"/>
                  <a:gd name="T118" fmla="*/ 450 w 684"/>
                  <a:gd name="T119" fmla="*/ 58 h 240"/>
                  <a:gd name="T120" fmla="*/ 671 w 684"/>
                  <a:gd name="T121" fmla="*/ 64 h 2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</a:cxnLst>
                <a:rect l="0" t="0" r="r" b="b"/>
                <a:pathLst>
                  <a:path w="684" h="240">
                    <a:moveTo>
                      <a:pt x="677" y="72"/>
                    </a:moveTo>
                    <a:cubicBezTo>
                      <a:pt x="677" y="75"/>
                      <a:pt x="676" y="77"/>
                      <a:pt x="674" y="78"/>
                    </a:cubicBezTo>
                    <a:cubicBezTo>
                      <a:pt x="673" y="79"/>
                      <a:pt x="671" y="80"/>
                      <a:pt x="668" y="79"/>
                    </a:cubicBezTo>
                    <a:lnTo>
                      <a:pt x="593" y="69"/>
                    </a:lnTo>
                    <a:lnTo>
                      <a:pt x="523" y="63"/>
                    </a:lnTo>
                    <a:lnTo>
                      <a:pt x="459" y="65"/>
                    </a:lnTo>
                    <a:lnTo>
                      <a:pt x="458" y="49"/>
                    </a:lnTo>
                    <a:lnTo>
                      <a:pt x="461" y="49"/>
                    </a:lnTo>
                    <a:cubicBezTo>
                      <a:pt x="466" y="49"/>
                      <a:pt x="469" y="53"/>
                      <a:pt x="469" y="57"/>
                    </a:cubicBezTo>
                    <a:cubicBezTo>
                      <a:pt x="470" y="61"/>
                      <a:pt x="467" y="64"/>
                      <a:pt x="463" y="65"/>
                    </a:cubicBezTo>
                    <a:lnTo>
                      <a:pt x="402" y="79"/>
                    </a:lnTo>
                    <a:cubicBezTo>
                      <a:pt x="398" y="80"/>
                      <a:pt x="395" y="78"/>
                      <a:pt x="393" y="74"/>
                    </a:cubicBezTo>
                    <a:cubicBezTo>
                      <a:pt x="392" y="71"/>
                      <a:pt x="393" y="67"/>
                      <a:pt x="396" y="65"/>
                    </a:cubicBezTo>
                    <a:lnTo>
                      <a:pt x="401" y="62"/>
                    </a:lnTo>
                    <a:lnTo>
                      <a:pt x="409" y="76"/>
                    </a:lnTo>
                    <a:lnTo>
                      <a:pt x="383" y="90"/>
                    </a:lnTo>
                    <a:cubicBezTo>
                      <a:pt x="380" y="92"/>
                      <a:pt x="375" y="90"/>
                      <a:pt x="373" y="87"/>
                    </a:cubicBezTo>
                    <a:cubicBezTo>
                      <a:pt x="370" y="83"/>
                      <a:pt x="371" y="79"/>
                      <a:pt x="375" y="76"/>
                    </a:cubicBezTo>
                    <a:lnTo>
                      <a:pt x="379" y="73"/>
                    </a:lnTo>
                    <a:cubicBezTo>
                      <a:pt x="382" y="70"/>
                      <a:pt x="387" y="71"/>
                      <a:pt x="390" y="74"/>
                    </a:cubicBezTo>
                    <a:cubicBezTo>
                      <a:pt x="392" y="78"/>
                      <a:pt x="392" y="83"/>
                      <a:pt x="389" y="86"/>
                    </a:cubicBezTo>
                    <a:lnTo>
                      <a:pt x="364" y="107"/>
                    </a:lnTo>
                    <a:cubicBezTo>
                      <a:pt x="360" y="109"/>
                      <a:pt x="355" y="109"/>
                      <a:pt x="353" y="106"/>
                    </a:cubicBezTo>
                    <a:cubicBezTo>
                      <a:pt x="350" y="103"/>
                      <a:pt x="350" y="98"/>
                      <a:pt x="353" y="95"/>
                    </a:cubicBezTo>
                    <a:lnTo>
                      <a:pt x="355" y="93"/>
                    </a:lnTo>
                    <a:cubicBezTo>
                      <a:pt x="358" y="90"/>
                      <a:pt x="363" y="90"/>
                      <a:pt x="366" y="93"/>
                    </a:cubicBezTo>
                    <a:cubicBezTo>
                      <a:pt x="369" y="96"/>
                      <a:pt x="369" y="101"/>
                      <a:pt x="366" y="104"/>
                    </a:cubicBezTo>
                    <a:lnTo>
                      <a:pt x="321" y="154"/>
                    </a:lnTo>
                    <a:lnTo>
                      <a:pt x="302" y="178"/>
                    </a:lnTo>
                    <a:lnTo>
                      <a:pt x="279" y="203"/>
                    </a:lnTo>
                    <a:lnTo>
                      <a:pt x="277" y="205"/>
                    </a:lnTo>
                    <a:lnTo>
                      <a:pt x="256" y="223"/>
                    </a:lnTo>
                    <a:lnTo>
                      <a:pt x="250" y="227"/>
                    </a:lnTo>
                    <a:cubicBezTo>
                      <a:pt x="250" y="227"/>
                      <a:pt x="249" y="227"/>
                      <a:pt x="249" y="228"/>
                    </a:cubicBezTo>
                    <a:lnTo>
                      <a:pt x="227" y="238"/>
                    </a:lnTo>
                    <a:cubicBezTo>
                      <a:pt x="226" y="238"/>
                      <a:pt x="225" y="238"/>
                      <a:pt x="224" y="238"/>
                    </a:cubicBezTo>
                    <a:lnTo>
                      <a:pt x="215" y="239"/>
                    </a:lnTo>
                    <a:lnTo>
                      <a:pt x="192" y="240"/>
                    </a:lnTo>
                    <a:lnTo>
                      <a:pt x="185" y="240"/>
                    </a:lnTo>
                    <a:cubicBezTo>
                      <a:pt x="185" y="240"/>
                      <a:pt x="184" y="240"/>
                      <a:pt x="184" y="240"/>
                    </a:cubicBezTo>
                    <a:lnTo>
                      <a:pt x="159" y="234"/>
                    </a:lnTo>
                    <a:cubicBezTo>
                      <a:pt x="158" y="234"/>
                      <a:pt x="157" y="234"/>
                      <a:pt x="157" y="234"/>
                    </a:cubicBezTo>
                    <a:lnTo>
                      <a:pt x="153" y="232"/>
                    </a:lnTo>
                    <a:lnTo>
                      <a:pt x="128" y="221"/>
                    </a:lnTo>
                    <a:lnTo>
                      <a:pt x="101" y="207"/>
                    </a:lnTo>
                    <a:lnTo>
                      <a:pt x="55" y="174"/>
                    </a:lnTo>
                    <a:lnTo>
                      <a:pt x="38" y="163"/>
                    </a:lnTo>
                    <a:lnTo>
                      <a:pt x="26" y="154"/>
                    </a:lnTo>
                    <a:lnTo>
                      <a:pt x="27" y="155"/>
                    </a:lnTo>
                    <a:lnTo>
                      <a:pt x="16" y="150"/>
                    </a:lnTo>
                    <a:cubicBezTo>
                      <a:pt x="15" y="149"/>
                      <a:pt x="14" y="148"/>
                      <a:pt x="13" y="147"/>
                    </a:cubicBezTo>
                    <a:lnTo>
                      <a:pt x="2" y="133"/>
                    </a:lnTo>
                    <a:cubicBezTo>
                      <a:pt x="1" y="132"/>
                      <a:pt x="0" y="130"/>
                      <a:pt x="0" y="128"/>
                    </a:cubicBezTo>
                    <a:lnTo>
                      <a:pt x="1" y="110"/>
                    </a:lnTo>
                    <a:cubicBezTo>
                      <a:pt x="2" y="108"/>
                      <a:pt x="2" y="106"/>
                      <a:pt x="4" y="105"/>
                    </a:cubicBezTo>
                    <a:lnTo>
                      <a:pt x="5" y="104"/>
                    </a:lnTo>
                    <a:lnTo>
                      <a:pt x="17" y="93"/>
                    </a:lnTo>
                    <a:cubicBezTo>
                      <a:pt x="18" y="91"/>
                      <a:pt x="20" y="91"/>
                      <a:pt x="22" y="90"/>
                    </a:cubicBezTo>
                    <a:lnTo>
                      <a:pt x="39" y="89"/>
                    </a:lnTo>
                    <a:cubicBezTo>
                      <a:pt x="40" y="89"/>
                      <a:pt x="41" y="90"/>
                      <a:pt x="42" y="90"/>
                    </a:cubicBezTo>
                    <a:lnTo>
                      <a:pt x="51" y="93"/>
                    </a:lnTo>
                    <a:lnTo>
                      <a:pt x="66" y="99"/>
                    </a:lnTo>
                    <a:cubicBezTo>
                      <a:pt x="70" y="101"/>
                      <a:pt x="71" y="105"/>
                      <a:pt x="70" y="109"/>
                    </a:cubicBezTo>
                    <a:lnTo>
                      <a:pt x="53" y="153"/>
                    </a:lnTo>
                    <a:cubicBezTo>
                      <a:pt x="52" y="155"/>
                      <a:pt x="51" y="157"/>
                      <a:pt x="49" y="158"/>
                    </a:cubicBezTo>
                    <a:cubicBezTo>
                      <a:pt x="47" y="159"/>
                      <a:pt x="44" y="159"/>
                      <a:pt x="42" y="158"/>
                    </a:cubicBezTo>
                    <a:lnTo>
                      <a:pt x="30" y="153"/>
                    </a:lnTo>
                    <a:lnTo>
                      <a:pt x="22" y="150"/>
                    </a:lnTo>
                    <a:cubicBezTo>
                      <a:pt x="19" y="149"/>
                      <a:pt x="17" y="146"/>
                      <a:pt x="16" y="143"/>
                    </a:cubicBezTo>
                    <a:cubicBezTo>
                      <a:pt x="16" y="139"/>
                      <a:pt x="18" y="136"/>
                      <a:pt x="21" y="135"/>
                    </a:cubicBezTo>
                    <a:lnTo>
                      <a:pt x="50" y="123"/>
                    </a:lnTo>
                    <a:cubicBezTo>
                      <a:pt x="53" y="122"/>
                      <a:pt x="57" y="123"/>
                      <a:pt x="59" y="125"/>
                    </a:cubicBezTo>
                    <a:cubicBezTo>
                      <a:pt x="62" y="127"/>
                      <a:pt x="62" y="131"/>
                      <a:pt x="61" y="134"/>
                    </a:cubicBezTo>
                    <a:lnTo>
                      <a:pt x="60" y="136"/>
                    </a:lnTo>
                    <a:cubicBezTo>
                      <a:pt x="58" y="139"/>
                      <a:pt x="55" y="141"/>
                      <a:pt x="52" y="140"/>
                    </a:cubicBezTo>
                    <a:cubicBezTo>
                      <a:pt x="49" y="140"/>
                      <a:pt x="46" y="138"/>
                      <a:pt x="45" y="135"/>
                    </a:cubicBezTo>
                    <a:lnTo>
                      <a:pt x="35" y="104"/>
                    </a:lnTo>
                    <a:cubicBezTo>
                      <a:pt x="34" y="101"/>
                      <a:pt x="35" y="97"/>
                      <a:pt x="37" y="95"/>
                    </a:cubicBezTo>
                    <a:cubicBezTo>
                      <a:pt x="40" y="93"/>
                      <a:pt x="43" y="93"/>
                      <a:pt x="46" y="94"/>
                    </a:cubicBezTo>
                    <a:lnTo>
                      <a:pt x="60" y="101"/>
                    </a:lnTo>
                    <a:lnTo>
                      <a:pt x="74" y="110"/>
                    </a:lnTo>
                    <a:lnTo>
                      <a:pt x="91" y="122"/>
                    </a:lnTo>
                    <a:lnTo>
                      <a:pt x="132" y="151"/>
                    </a:lnTo>
                    <a:lnTo>
                      <a:pt x="154" y="163"/>
                    </a:lnTo>
                    <a:lnTo>
                      <a:pt x="179" y="174"/>
                    </a:lnTo>
                    <a:lnTo>
                      <a:pt x="172" y="189"/>
                    </a:lnTo>
                    <a:lnTo>
                      <a:pt x="168" y="187"/>
                    </a:lnTo>
                    <a:cubicBezTo>
                      <a:pt x="164" y="185"/>
                      <a:pt x="163" y="181"/>
                      <a:pt x="164" y="177"/>
                    </a:cubicBezTo>
                    <a:cubicBezTo>
                      <a:pt x="165" y="173"/>
                      <a:pt x="169" y="171"/>
                      <a:pt x="173" y="172"/>
                    </a:cubicBezTo>
                    <a:lnTo>
                      <a:pt x="198" y="178"/>
                    </a:lnTo>
                    <a:cubicBezTo>
                      <a:pt x="202" y="179"/>
                      <a:pt x="205" y="183"/>
                      <a:pt x="204" y="187"/>
                    </a:cubicBezTo>
                    <a:cubicBezTo>
                      <a:pt x="204" y="191"/>
                      <a:pt x="200" y="194"/>
                      <a:pt x="195" y="193"/>
                    </a:cubicBezTo>
                    <a:lnTo>
                      <a:pt x="188" y="192"/>
                    </a:lnTo>
                    <a:cubicBezTo>
                      <a:pt x="184" y="192"/>
                      <a:pt x="181" y="188"/>
                      <a:pt x="181" y="184"/>
                    </a:cubicBezTo>
                    <a:cubicBezTo>
                      <a:pt x="182" y="180"/>
                      <a:pt x="185" y="176"/>
                      <a:pt x="189" y="176"/>
                    </a:cubicBezTo>
                    <a:lnTo>
                      <a:pt x="212" y="176"/>
                    </a:lnTo>
                    <a:cubicBezTo>
                      <a:pt x="217" y="176"/>
                      <a:pt x="220" y="180"/>
                      <a:pt x="220" y="184"/>
                    </a:cubicBezTo>
                    <a:cubicBezTo>
                      <a:pt x="221" y="188"/>
                      <a:pt x="218" y="191"/>
                      <a:pt x="214" y="192"/>
                    </a:cubicBezTo>
                    <a:lnTo>
                      <a:pt x="205" y="194"/>
                    </a:lnTo>
                    <a:cubicBezTo>
                      <a:pt x="201" y="195"/>
                      <a:pt x="197" y="193"/>
                      <a:pt x="196" y="189"/>
                    </a:cubicBezTo>
                    <a:cubicBezTo>
                      <a:pt x="195" y="185"/>
                      <a:pt x="196" y="181"/>
                      <a:pt x="200" y="179"/>
                    </a:cubicBezTo>
                    <a:lnTo>
                      <a:pt x="222" y="169"/>
                    </a:lnTo>
                    <a:cubicBezTo>
                      <a:pt x="226" y="168"/>
                      <a:pt x="230" y="169"/>
                      <a:pt x="232" y="172"/>
                    </a:cubicBezTo>
                    <a:cubicBezTo>
                      <a:pt x="234" y="176"/>
                      <a:pt x="234" y="180"/>
                      <a:pt x="230" y="183"/>
                    </a:cubicBezTo>
                    <a:lnTo>
                      <a:pt x="225" y="187"/>
                    </a:lnTo>
                    <a:cubicBezTo>
                      <a:pt x="222" y="189"/>
                      <a:pt x="217" y="189"/>
                      <a:pt x="214" y="185"/>
                    </a:cubicBezTo>
                    <a:cubicBezTo>
                      <a:pt x="211" y="182"/>
                      <a:pt x="212" y="177"/>
                      <a:pt x="215" y="174"/>
                    </a:cubicBezTo>
                    <a:lnTo>
                      <a:pt x="236" y="157"/>
                    </a:lnTo>
                    <a:lnTo>
                      <a:pt x="246" y="170"/>
                    </a:lnTo>
                    <a:lnTo>
                      <a:pt x="243" y="172"/>
                    </a:lnTo>
                    <a:cubicBezTo>
                      <a:pt x="240" y="174"/>
                      <a:pt x="235" y="174"/>
                      <a:pt x="232" y="171"/>
                    </a:cubicBezTo>
                    <a:cubicBezTo>
                      <a:pt x="230" y="168"/>
                      <a:pt x="230" y="163"/>
                      <a:pt x="233" y="160"/>
                    </a:cubicBezTo>
                    <a:lnTo>
                      <a:pt x="253" y="138"/>
                    </a:lnTo>
                    <a:lnTo>
                      <a:pt x="273" y="112"/>
                    </a:lnTo>
                    <a:lnTo>
                      <a:pt x="319" y="61"/>
                    </a:lnTo>
                    <a:cubicBezTo>
                      <a:pt x="319" y="61"/>
                      <a:pt x="319" y="60"/>
                      <a:pt x="320" y="60"/>
                    </a:cubicBezTo>
                    <a:lnTo>
                      <a:pt x="323" y="58"/>
                    </a:lnTo>
                    <a:lnTo>
                      <a:pt x="348" y="37"/>
                    </a:lnTo>
                    <a:lnTo>
                      <a:pt x="353" y="34"/>
                    </a:lnTo>
                    <a:cubicBezTo>
                      <a:pt x="353" y="34"/>
                      <a:pt x="353" y="34"/>
                      <a:pt x="354" y="33"/>
                    </a:cubicBezTo>
                    <a:lnTo>
                      <a:pt x="381" y="19"/>
                    </a:lnTo>
                    <a:cubicBezTo>
                      <a:pt x="381" y="19"/>
                      <a:pt x="382" y="19"/>
                      <a:pt x="382" y="19"/>
                    </a:cubicBezTo>
                    <a:lnTo>
                      <a:pt x="388" y="17"/>
                    </a:lnTo>
                    <a:lnTo>
                      <a:pt x="451" y="4"/>
                    </a:lnTo>
                    <a:lnTo>
                      <a:pt x="453" y="3"/>
                    </a:lnTo>
                    <a:cubicBezTo>
                      <a:pt x="454" y="3"/>
                      <a:pt x="454" y="2"/>
                      <a:pt x="455" y="2"/>
                    </a:cubicBezTo>
                    <a:lnTo>
                      <a:pt x="526" y="0"/>
                    </a:lnTo>
                    <a:lnTo>
                      <a:pt x="602" y="6"/>
                    </a:lnTo>
                    <a:lnTo>
                      <a:pt x="677" y="17"/>
                    </a:lnTo>
                    <a:cubicBezTo>
                      <a:pt x="681" y="17"/>
                      <a:pt x="684" y="21"/>
                      <a:pt x="683" y="25"/>
                    </a:cubicBezTo>
                    <a:lnTo>
                      <a:pt x="677" y="72"/>
                    </a:lnTo>
                    <a:close/>
                    <a:moveTo>
                      <a:pt x="668" y="23"/>
                    </a:moveTo>
                    <a:lnTo>
                      <a:pt x="674" y="32"/>
                    </a:lnTo>
                    <a:lnTo>
                      <a:pt x="601" y="22"/>
                    </a:lnTo>
                    <a:lnTo>
                      <a:pt x="527" y="16"/>
                    </a:lnTo>
                    <a:lnTo>
                      <a:pt x="456" y="18"/>
                    </a:lnTo>
                    <a:lnTo>
                      <a:pt x="458" y="18"/>
                    </a:lnTo>
                    <a:lnTo>
                      <a:pt x="454" y="19"/>
                    </a:lnTo>
                    <a:lnTo>
                      <a:pt x="393" y="32"/>
                    </a:lnTo>
                    <a:lnTo>
                      <a:pt x="387" y="34"/>
                    </a:lnTo>
                    <a:lnTo>
                      <a:pt x="388" y="34"/>
                    </a:lnTo>
                    <a:lnTo>
                      <a:pt x="361" y="48"/>
                    </a:lnTo>
                    <a:lnTo>
                      <a:pt x="362" y="47"/>
                    </a:lnTo>
                    <a:lnTo>
                      <a:pt x="358" y="50"/>
                    </a:lnTo>
                    <a:lnTo>
                      <a:pt x="332" y="71"/>
                    </a:lnTo>
                    <a:lnTo>
                      <a:pt x="329" y="73"/>
                    </a:lnTo>
                    <a:lnTo>
                      <a:pt x="330" y="72"/>
                    </a:lnTo>
                    <a:lnTo>
                      <a:pt x="286" y="121"/>
                    </a:lnTo>
                    <a:lnTo>
                      <a:pt x="264" y="149"/>
                    </a:lnTo>
                    <a:lnTo>
                      <a:pt x="244" y="171"/>
                    </a:lnTo>
                    <a:lnTo>
                      <a:pt x="234" y="159"/>
                    </a:lnTo>
                    <a:lnTo>
                      <a:pt x="237" y="157"/>
                    </a:lnTo>
                    <a:cubicBezTo>
                      <a:pt x="241" y="154"/>
                      <a:pt x="245" y="155"/>
                      <a:pt x="248" y="159"/>
                    </a:cubicBezTo>
                    <a:cubicBezTo>
                      <a:pt x="250" y="162"/>
                      <a:pt x="250" y="167"/>
                      <a:pt x="247" y="170"/>
                    </a:cubicBezTo>
                    <a:lnTo>
                      <a:pt x="226" y="187"/>
                    </a:lnTo>
                    <a:lnTo>
                      <a:pt x="215" y="174"/>
                    </a:lnTo>
                    <a:lnTo>
                      <a:pt x="220" y="170"/>
                    </a:lnTo>
                    <a:lnTo>
                      <a:pt x="229" y="184"/>
                    </a:lnTo>
                    <a:lnTo>
                      <a:pt x="207" y="194"/>
                    </a:lnTo>
                    <a:lnTo>
                      <a:pt x="202" y="179"/>
                    </a:lnTo>
                    <a:lnTo>
                      <a:pt x="211" y="177"/>
                    </a:lnTo>
                    <a:lnTo>
                      <a:pt x="212" y="192"/>
                    </a:lnTo>
                    <a:lnTo>
                      <a:pt x="189" y="192"/>
                    </a:lnTo>
                    <a:lnTo>
                      <a:pt x="191" y="177"/>
                    </a:lnTo>
                    <a:lnTo>
                      <a:pt x="198" y="178"/>
                    </a:lnTo>
                    <a:lnTo>
                      <a:pt x="195" y="193"/>
                    </a:lnTo>
                    <a:lnTo>
                      <a:pt x="170" y="187"/>
                    </a:lnTo>
                    <a:lnTo>
                      <a:pt x="175" y="172"/>
                    </a:lnTo>
                    <a:lnTo>
                      <a:pt x="179" y="174"/>
                    </a:lnTo>
                    <a:cubicBezTo>
                      <a:pt x="183" y="176"/>
                      <a:pt x="185" y="181"/>
                      <a:pt x="183" y="185"/>
                    </a:cubicBezTo>
                    <a:cubicBezTo>
                      <a:pt x="181" y="189"/>
                      <a:pt x="176" y="191"/>
                      <a:pt x="172" y="189"/>
                    </a:cubicBezTo>
                    <a:lnTo>
                      <a:pt x="147" y="177"/>
                    </a:lnTo>
                    <a:lnTo>
                      <a:pt x="123" y="164"/>
                    </a:lnTo>
                    <a:lnTo>
                      <a:pt x="82" y="135"/>
                    </a:lnTo>
                    <a:lnTo>
                      <a:pt x="65" y="123"/>
                    </a:lnTo>
                    <a:lnTo>
                      <a:pt x="53" y="116"/>
                    </a:lnTo>
                    <a:lnTo>
                      <a:pt x="39" y="109"/>
                    </a:lnTo>
                    <a:lnTo>
                      <a:pt x="50" y="99"/>
                    </a:lnTo>
                    <a:lnTo>
                      <a:pt x="60" y="130"/>
                    </a:lnTo>
                    <a:lnTo>
                      <a:pt x="45" y="129"/>
                    </a:lnTo>
                    <a:lnTo>
                      <a:pt x="46" y="127"/>
                    </a:lnTo>
                    <a:lnTo>
                      <a:pt x="57" y="138"/>
                    </a:lnTo>
                    <a:lnTo>
                      <a:pt x="28" y="150"/>
                    </a:lnTo>
                    <a:lnTo>
                      <a:pt x="27" y="135"/>
                    </a:lnTo>
                    <a:lnTo>
                      <a:pt x="37" y="138"/>
                    </a:lnTo>
                    <a:lnTo>
                      <a:pt x="49" y="143"/>
                    </a:lnTo>
                    <a:lnTo>
                      <a:pt x="38" y="148"/>
                    </a:lnTo>
                    <a:lnTo>
                      <a:pt x="55" y="104"/>
                    </a:lnTo>
                    <a:lnTo>
                      <a:pt x="59" y="114"/>
                    </a:lnTo>
                    <a:lnTo>
                      <a:pt x="46" y="108"/>
                    </a:lnTo>
                    <a:lnTo>
                      <a:pt x="37" y="105"/>
                    </a:lnTo>
                    <a:lnTo>
                      <a:pt x="40" y="105"/>
                    </a:lnTo>
                    <a:lnTo>
                      <a:pt x="23" y="106"/>
                    </a:lnTo>
                    <a:lnTo>
                      <a:pt x="28" y="104"/>
                    </a:lnTo>
                    <a:lnTo>
                      <a:pt x="16" y="115"/>
                    </a:lnTo>
                    <a:lnTo>
                      <a:pt x="15" y="116"/>
                    </a:lnTo>
                    <a:lnTo>
                      <a:pt x="17" y="111"/>
                    </a:lnTo>
                    <a:lnTo>
                      <a:pt x="16" y="129"/>
                    </a:lnTo>
                    <a:lnTo>
                      <a:pt x="15" y="124"/>
                    </a:lnTo>
                    <a:lnTo>
                      <a:pt x="26" y="138"/>
                    </a:lnTo>
                    <a:lnTo>
                      <a:pt x="23" y="135"/>
                    </a:lnTo>
                    <a:lnTo>
                      <a:pt x="34" y="140"/>
                    </a:lnTo>
                    <a:cubicBezTo>
                      <a:pt x="34" y="140"/>
                      <a:pt x="35" y="141"/>
                      <a:pt x="35" y="141"/>
                    </a:cubicBezTo>
                    <a:lnTo>
                      <a:pt x="47" y="150"/>
                    </a:lnTo>
                    <a:lnTo>
                      <a:pt x="64" y="161"/>
                    </a:lnTo>
                    <a:lnTo>
                      <a:pt x="108" y="192"/>
                    </a:lnTo>
                    <a:lnTo>
                      <a:pt x="135" y="206"/>
                    </a:lnTo>
                    <a:lnTo>
                      <a:pt x="160" y="217"/>
                    </a:lnTo>
                    <a:lnTo>
                      <a:pt x="164" y="219"/>
                    </a:lnTo>
                    <a:lnTo>
                      <a:pt x="162" y="219"/>
                    </a:lnTo>
                    <a:lnTo>
                      <a:pt x="187" y="225"/>
                    </a:lnTo>
                    <a:lnTo>
                      <a:pt x="185" y="224"/>
                    </a:lnTo>
                    <a:lnTo>
                      <a:pt x="191" y="224"/>
                    </a:lnTo>
                    <a:lnTo>
                      <a:pt x="214" y="224"/>
                    </a:lnTo>
                    <a:lnTo>
                      <a:pt x="223" y="223"/>
                    </a:lnTo>
                    <a:lnTo>
                      <a:pt x="220" y="223"/>
                    </a:lnTo>
                    <a:lnTo>
                      <a:pt x="242" y="213"/>
                    </a:lnTo>
                    <a:lnTo>
                      <a:pt x="240" y="214"/>
                    </a:lnTo>
                    <a:lnTo>
                      <a:pt x="245" y="210"/>
                    </a:lnTo>
                    <a:lnTo>
                      <a:pt x="266" y="194"/>
                    </a:lnTo>
                    <a:lnTo>
                      <a:pt x="268" y="192"/>
                    </a:lnTo>
                    <a:lnTo>
                      <a:pt x="289" y="168"/>
                    </a:lnTo>
                    <a:lnTo>
                      <a:pt x="310" y="143"/>
                    </a:lnTo>
                    <a:lnTo>
                      <a:pt x="355" y="93"/>
                    </a:lnTo>
                    <a:lnTo>
                      <a:pt x="366" y="104"/>
                    </a:lnTo>
                    <a:lnTo>
                      <a:pt x="364" y="106"/>
                    </a:lnTo>
                    <a:lnTo>
                      <a:pt x="353" y="94"/>
                    </a:lnTo>
                    <a:lnTo>
                      <a:pt x="378" y="73"/>
                    </a:lnTo>
                    <a:lnTo>
                      <a:pt x="388" y="86"/>
                    </a:lnTo>
                    <a:lnTo>
                      <a:pt x="384" y="89"/>
                    </a:lnTo>
                    <a:lnTo>
                      <a:pt x="376" y="75"/>
                    </a:lnTo>
                    <a:lnTo>
                      <a:pt x="402" y="61"/>
                    </a:lnTo>
                    <a:cubicBezTo>
                      <a:pt x="406" y="59"/>
                      <a:pt x="410" y="61"/>
                      <a:pt x="412" y="65"/>
                    </a:cubicBezTo>
                    <a:cubicBezTo>
                      <a:pt x="415" y="68"/>
                      <a:pt x="413" y="73"/>
                      <a:pt x="410" y="75"/>
                    </a:cubicBezTo>
                    <a:lnTo>
                      <a:pt x="405" y="78"/>
                    </a:lnTo>
                    <a:lnTo>
                      <a:pt x="399" y="64"/>
                    </a:lnTo>
                    <a:lnTo>
                      <a:pt x="460" y="50"/>
                    </a:lnTo>
                    <a:lnTo>
                      <a:pt x="461" y="65"/>
                    </a:lnTo>
                    <a:lnTo>
                      <a:pt x="458" y="65"/>
                    </a:lnTo>
                    <a:cubicBezTo>
                      <a:pt x="454" y="65"/>
                      <a:pt x="451" y="62"/>
                      <a:pt x="450" y="58"/>
                    </a:cubicBezTo>
                    <a:cubicBezTo>
                      <a:pt x="450" y="53"/>
                      <a:pt x="454" y="50"/>
                      <a:pt x="458" y="49"/>
                    </a:cubicBezTo>
                    <a:lnTo>
                      <a:pt x="524" y="47"/>
                    </a:lnTo>
                    <a:lnTo>
                      <a:pt x="596" y="54"/>
                    </a:lnTo>
                    <a:lnTo>
                      <a:pt x="671" y="64"/>
                    </a:lnTo>
                    <a:lnTo>
                      <a:pt x="662" y="70"/>
                    </a:lnTo>
                    <a:lnTo>
                      <a:pt x="668" y="23"/>
                    </a:lnTo>
                    <a:close/>
                  </a:path>
                </a:pathLst>
              </a:custGeom>
              <a:solidFill>
                <a:srgbClr val="8EB4E3"/>
              </a:solidFill>
              <a:ln w="1588" cap="flat">
                <a:solidFill>
                  <a:srgbClr val="8EB4E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" name="Freeform 174">
                <a:extLst>
                  <a:ext uri="{FF2B5EF4-FFF2-40B4-BE49-F238E27FC236}">
                    <a16:creationId xmlns:a16="http://schemas.microsoft.com/office/drawing/2014/main" id="{22B256EB-A250-45A6-86C4-9BE1507A8AA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6" y="2376"/>
                <a:ext cx="103" cy="20"/>
              </a:xfrm>
              <a:custGeom>
                <a:avLst/>
                <a:gdLst>
                  <a:gd name="T0" fmla="*/ 2 w 103"/>
                  <a:gd name="T1" fmla="*/ 0 h 20"/>
                  <a:gd name="T2" fmla="*/ 103 w 103"/>
                  <a:gd name="T3" fmla="*/ 12 h 20"/>
                  <a:gd name="T4" fmla="*/ 102 w 103"/>
                  <a:gd name="T5" fmla="*/ 20 h 20"/>
                  <a:gd name="T6" fmla="*/ 0 w 103"/>
                  <a:gd name="T7" fmla="*/ 9 h 20"/>
                  <a:gd name="T8" fmla="*/ 2 w 103"/>
                  <a:gd name="T9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03" h="20">
                    <a:moveTo>
                      <a:pt x="2" y="0"/>
                    </a:moveTo>
                    <a:lnTo>
                      <a:pt x="103" y="12"/>
                    </a:lnTo>
                    <a:lnTo>
                      <a:pt x="102" y="20"/>
                    </a:lnTo>
                    <a:lnTo>
                      <a:pt x="0" y="9"/>
                    </a:lnTo>
                    <a:lnTo>
                      <a:pt x="2" y="0"/>
                    </a:lnTo>
                    <a:close/>
                  </a:path>
                </a:pathLst>
              </a:custGeom>
              <a:solidFill>
                <a:srgbClr val="948A54"/>
              </a:solidFill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" name="Freeform 175">
                <a:extLst>
                  <a:ext uri="{FF2B5EF4-FFF2-40B4-BE49-F238E27FC236}">
                    <a16:creationId xmlns:a16="http://schemas.microsoft.com/office/drawing/2014/main" id="{013A440B-253B-4AE6-AF8E-7E35EBE1097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15" y="2375"/>
                <a:ext cx="106" cy="23"/>
              </a:xfrm>
              <a:custGeom>
                <a:avLst/>
                <a:gdLst>
                  <a:gd name="T0" fmla="*/ 6 w 545"/>
                  <a:gd name="T1" fmla="*/ 8 h 129"/>
                  <a:gd name="T2" fmla="*/ 9 w 545"/>
                  <a:gd name="T3" fmla="*/ 2 h 129"/>
                  <a:gd name="T4" fmla="*/ 15 w 545"/>
                  <a:gd name="T5" fmla="*/ 1 h 129"/>
                  <a:gd name="T6" fmla="*/ 537 w 545"/>
                  <a:gd name="T7" fmla="*/ 67 h 129"/>
                  <a:gd name="T8" fmla="*/ 544 w 545"/>
                  <a:gd name="T9" fmla="*/ 76 h 129"/>
                  <a:gd name="T10" fmla="*/ 539 w 545"/>
                  <a:gd name="T11" fmla="*/ 121 h 129"/>
                  <a:gd name="T12" fmla="*/ 536 w 545"/>
                  <a:gd name="T13" fmla="*/ 127 h 129"/>
                  <a:gd name="T14" fmla="*/ 530 w 545"/>
                  <a:gd name="T15" fmla="*/ 128 h 129"/>
                  <a:gd name="T16" fmla="*/ 7 w 545"/>
                  <a:gd name="T17" fmla="*/ 64 h 129"/>
                  <a:gd name="T18" fmla="*/ 1 w 545"/>
                  <a:gd name="T19" fmla="*/ 56 h 129"/>
                  <a:gd name="T20" fmla="*/ 6 w 545"/>
                  <a:gd name="T21" fmla="*/ 8 h 129"/>
                  <a:gd name="T22" fmla="*/ 16 w 545"/>
                  <a:gd name="T23" fmla="*/ 57 h 129"/>
                  <a:gd name="T24" fmla="*/ 9 w 545"/>
                  <a:gd name="T25" fmla="*/ 49 h 129"/>
                  <a:gd name="T26" fmla="*/ 532 w 545"/>
                  <a:gd name="T27" fmla="*/ 113 h 129"/>
                  <a:gd name="T28" fmla="*/ 523 w 545"/>
                  <a:gd name="T29" fmla="*/ 120 h 129"/>
                  <a:gd name="T30" fmla="*/ 529 w 545"/>
                  <a:gd name="T31" fmla="*/ 74 h 129"/>
                  <a:gd name="T32" fmla="*/ 535 w 545"/>
                  <a:gd name="T33" fmla="*/ 83 h 129"/>
                  <a:gd name="T34" fmla="*/ 13 w 545"/>
                  <a:gd name="T35" fmla="*/ 16 h 129"/>
                  <a:gd name="T36" fmla="*/ 22 w 545"/>
                  <a:gd name="T37" fmla="*/ 9 h 129"/>
                  <a:gd name="T38" fmla="*/ 16 w 545"/>
                  <a:gd name="T39" fmla="*/ 57 h 1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545" h="129">
                    <a:moveTo>
                      <a:pt x="6" y="8"/>
                    </a:moveTo>
                    <a:cubicBezTo>
                      <a:pt x="6" y="5"/>
                      <a:pt x="7" y="4"/>
                      <a:pt x="9" y="2"/>
                    </a:cubicBezTo>
                    <a:cubicBezTo>
                      <a:pt x="11" y="1"/>
                      <a:pt x="13" y="0"/>
                      <a:pt x="15" y="1"/>
                    </a:cubicBezTo>
                    <a:lnTo>
                      <a:pt x="537" y="67"/>
                    </a:lnTo>
                    <a:cubicBezTo>
                      <a:pt x="542" y="68"/>
                      <a:pt x="545" y="72"/>
                      <a:pt x="544" y="76"/>
                    </a:cubicBezTo>
                    <a:lnTo>
                      <a:pt x="539" y="121"/>
                    </a:lnTo>
                    <a:cubicBezTo>
                      <a:pt x="539" y="124"/>
                      <a:pt x="538" y="125"/>
                      <a:pt x="536" y="127"/>
                    </a:cubicBezTo>
                    <a:cubicBezTo>
                      <a:pt x="534" y="128"/>
                      <a:pt x="532" y="129"/>
                      <a:pt x="530" y="128"/>
                    </a:cubicBezTo>
                    <a:lnTo>
                      <a:pt x="7" y="64"/>
                    </a:lnTo>
                    <a:cubicBezTo>
                      <a:pt x="3" y="64"/>
                      <a:pt x="0" y="60"/>
                      <a:pt x="1" y="56"/>
                    </a:cubicBezTo>
                    <a:lnTo>
                      <a:pt x="6" y="8"/>
                    </a:lnTo>
                    <a:close/>
                    <a:moveTo>
                      <a:pt x="16" y="57"/>
                    </a:moveTo>
                    <a:lnTo>
                      <a:pt x="9" y="49"/>
                    </a:lnTo>
                    <a:lnTo>
                      <a:pt x="532" y="113"/>
                    </a:lnTo>
                    <a:lnTo>
                      <a:pt x="523" y="120"/>
                    </a:lnTo>
                    <a:lnTo>
                      <a:pt x="529" y="74"/>
                    </a:lnTo>
                    <a:lnTo>
                      <a:pt x="535" y="83"/>
                    </a:lnTo>
                    <a:lnTo>
                      <a:pt x="13" y="16"/>
                    </a:lnTo>
                    <a:lnTo>
                      <a:pt x="22" y="9"/>
                    </a:lnTo>
                    <a:lnTo>
                      <a:pt x="16" y="57"/>
                    </a:lnTo>
                    <a:close/>
                  </a:path>
                </a:pathLst>
              </a:custGeom>
              <a:solidFill>
                <a:srgbClr val="948A54"/>
              </a:solidFill>
              <a:ln w="1588" cap="flat">
                <a:solidFill>
                  <a:srgbClr val="948A54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5" name="Freeform 176">
                <a:extLst>
                  <a:ext uri="{FF2B5EF4-FFF2-40B4-BE49-F238E27FC236}">
                    <a16:creationId xmlns:a16="http://schemas.microsoft.com/office/drawing/2014/main" id="{D7993D15-7E66-4B41-8692-DC6232360BF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6" y="2388"/>
                <a:ext cx="84" cy="65"/>
              </a:xfrm>
              <a:custGeom>
                <a:avLst/>
                <a:gdLst>
                  <a:gd name="T0" fmla="*/ 0 w 84"/>
                  <a:gd name="T1" fmla="*/ 59 h 65"/>
                  <a:gd name="T2" fmla="*/ 77 w 84"/>
                  <a:gd name="T3" fmla="*/ 0 h 65"/>
                  <a:gd name="T4" fmla="*/ 84 w 84"/>
                  <a:gd name="T5" fmla="*/ 6 h 65"/>
                  <a:gd name="T6" fmla="*/ 6 w 84"/>
                  <a:gd name="T7" fmla="*/ 65 h 65"/>
                  <a:gd name="T8" fmla="*/ 0 w 84"/>
                  <a:gd name="T9" fmla="*/ 59 h 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84" h="65">
                    <a:moveTo>
                      <a:pt x="0" y="59"/>
                    </a:moveTo>
                    <a:lnTo>
                      <a:pt x="77" y="0"/>
                    </a:lnTo>
                    <a:lnTo>
                      <a:pt x="84" y="6"/>
                    </a:lnTo>
                    <a:lnTo>
                      <a:pt x="6" y="65"/>
                    </a:lnTo>
                    <a:lnTo>
                      <a:pt x="0" y="59"/>
                    </a:lnTo>
                    <a:close/>
                  </a:path>
                </a:pathLst>
              </a:custGeom>
              <a:solidFill>
                <a:srgbClr val="002060"/>
              </a:solidFill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6" name="Freeform 177">
                <a:extLst>
                  <a:ext uri="{FF2B5EF4-FFF2-40B4-BE49-F238E27FC236}">
                    <a16:creationId xmlns:a16="http://schemas.microsoft.com/office/drawing/2014/main" id="{B7FD4BD7-B28B-40EB-B201-548B5D603CCC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74" y="2386"/>
                <a:ext cx="87" cy="69"/>
              </a:xfrm>
              <a:custGeom>
                <a:avLst/>
                <a:gdLst>
                  <a:gd name="T0" fmla="*/ 3 w 449"/>
                  <a:gd name="T1" fmla="*/ 346 h 385"/>
                  <a:gd name="T2" fmla="*/ 0 w 449"/>
                  <a:gd name="T3" fmla="*/ 341 h 385"/>
                  <a:gd name="T4" fmla="*/ 3 w 449"/>
                  <a:gd name="T5" fmla="*/ 335 h 385"/>
                  <a:gd name="T6" fmla="*/ 403 w 449"/>
                  <a:gd name="T7" fmla="*/ 2 h 385"/>
                  <a:gd name="T8" fmla="*/ 414 w 449"/>
                  <a:gd name="T9" fmla="*/ 3 h 385"/>
                  <a:gd name="T10" fmla="*/ 446 w 449"/>
                  <a:gd name="T11" fmla="*/ 38 h 385"/>
                  <a:gd name="T12" fmla="*/ 448 w 449"/>
                  <a:gd name="T13" fmla="*/ 44 h 385"/>
                  <a:gd name="T14" fmla="*/ 446 w 449"/>
                  <a:gd name="T15" fmla="*/ 50 h 385"/>
                  <a:gd name="T16" fmla="*/ 46 w 449"/>
                  <a:gd name="T17" fmla="*/ 383 h 385"/>
                  <a:gd name="T18" fmla="*/ 35 w 449"/>
                  <a:gd name="T19" fmla="*/ 382 h 385"/>
                  <a:gd name="T20" fmla="*/ 3 w 449"/>
                  <a:gd name="T21" fmla="*/ 346 h 385"/>
                  <a:gd name="T22" fmla="*/ 47 w 449"/>
                  <a:gd name="T23" fmla="*/ 371 h 385"/>
                  <a:gd name="T24" fmla="*/ 36 w 449"/>
                  <a:gd name="T25" fmla="*/ 370 h 385"/>
                  <a:gd name="T26" fmla="*/ 435 w 449"/>
                  <a:gd name="T27" fmla="*/ 38 h 385"/>
                  <a:gd name="T28" fmla="*/ 435 w 449"/>
                  <a:gd name="T29" fmla="*/ 49 h 385"/>
                  <a:gd name="T30" fmla="*/ 402 w 449"/>
                  <a:gd name="T31" fmla="*/ 14 h 385"/>
                  <a:gd name="T32" fmla="*/ 413 w 449"/>
                  <a:gd name="T33" fmla="*/ 15 h 385"/>
                  <a:gd name="T34" fmla="*/ 14 w 449"/>
                  <a:gd name="T35" fmla="*/ 347 h 385"/>
                  <a:gd name="T36" fmla="*/ 14 w 449"/>
                  <a:gd name="T37" fmla="*/ 336 h 385"/>
                  <a:gd name="T38" fmla="*/ 47 w 449"/>
                  <a:gd name="T39" fmla="*/ 371 h 3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449" h="385">
                    <a:moveTo>
                      <a:pt x="3" y="346"/>
                    </a:moveTo>
                    <a:cubicBezTo>
                      <a:pt x="1" y="345"/>
                      <a:pt x="0" y="343"/>
                      <a:pt x="0" y="341"/>
                    </a:cubicBezTo>
                    <a:cubicBezTo>
                      <a:pt x="1" y="338"/>
                      <a:pt x="2" y="336"/>
                      <a:pt x="3" y="335"/>
                    </a:cubicBezTo>
                    <a:lnTo>
                      <a:pt x="403" y="2"/>
                    </a:lnTo>
                    <a:cubicBezTo>
                      <a:pt x="406" y="0"/>
                      <a:pt x="411" y="0"/>
                      <a:pt x="414" y="3"/>
                    </a:cubicBezTo>
                    <a:lnTo>
                      <a:pt x="446" y="38"/>
                    </a:lnTo>
                    <a:cubicBezTo>
                      <a:pt x="448" y="40"/>
                      <a:pt x="449" y="42"/>
                      <a:pt x="448" y="44"/>
                    </a:cubicBezTo>
                    <a:cubicBezTo>
                      <a:pt x="448" y="47"/>
                      <a:pt x="447" y="49"/>
                      <a:pt x="446" y="50"/>
                    </a:cubicBezTo>
                    <a:lnTo>
                      <a:pt x="46" y="383"/>
                    </a:lnTo>
                    <a:cubicBezTo>
                      <a:pt x="43" y="385"/>
                      <a:pt x="38" y="385"/>
                      <a:pt x="35" y="382"/>
                    </a:cubicBezTo>
                    <a:lnTo>
                      <a:pt x="3" y="346"/>
                    </a:lnTo>
                    <a:close/>
                    <a:moveTo>
                      <a:pt x="47" y="371"/>
                    </a:moveTo>
                    <a:lnTo>
                      <a:pt x="36" y="370"/>
                    </a:lnTo>
                    <a:lnTo>
                      <a:pt x="435" y="38"/>
                    </a:lnTo>
                    <a:lnTo>
                      <a:pt x="435" y="49"/>
                    </a:lnTo>
                    <a:lnTo>
                      <a:pt x="402" y="14"/>
                    </a:lnTo>
                    <a:lnTo>
                      <a:pt x="413" y="15"/>
                    </a:lnTo>
                    <a:lnTo>
                      <a:pt x="14" y="347"/>
                    </a:lnTo>
                    <a:lnTo>
                      <a:pt x="14" y="336"/>
                    </a:lnTo>
                    <a:lnTo>
                      <a:pt x="47" y="371"/>
                    </a:lnTo>
                    <a:close/>
                  </a:path>
                </a:pathLst>
              </a:custGeom>
              <a:solidFill>
                <a:srgbClr val="002060"/>
              </a:solidFill>
              <a:ln w="1588" cap="flat">
                <a:solidFill>
                  <a:srgbClr val="00206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" name="Freeform 178">
                <a:extLst>
                  <a:ext uri="{FF2B5EF4-FFF2-40B4-BE49-F238E27FC236}">
                    <a16:creationId xmlns:a16="http://schemas.microsoft.com/office/drawing/2014/main" id="{665FAFE3-7819-426E-8767-8387F4C5168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2" y="2342"/>
                <a:ext cx="115" cy="40"/>
              </a:xfrm>
              <a:custGeom>
                <a:avLst/>
                <a:gdLst>
                  <a:gd name="T0" fmla="*/ 73 w 592"/>
                  <a:gd name="T1" fmla="*/ 173 h 224"/>
                  <a:gd name="T2" fmla="*/ 193 w 592"/>
                  <a:gd name="T3" fmla="*/ 176 h 224"/>
                  <a:gd name="T4" fmla="*/ 242 w 592"/>
                  <a:gd name="T5" fmla="*/ 163 h 224"/>
                  <a:gd name="T6" fmla="*/ 260 w 592"/>
                  <a:gd name="T7" fmla="*/ 152 h 224"/>
                  <a:gd name="T8" fmla="*/ 276 w 592"/>
                  <a:gd name="T9" fmla="*/ 134 h 224"/>
                  <a:gd name="T10" fmla="*/ 333 w 592"/>
                  <a:gd name="T11" fmla="*/ 61 h 224"/>
                  <a:gd name="T12" fmla="*/ 353 w 592"/>
                  <a:gd name="T13" fmla="*/ 35 h 224"/>
                  <a:gd name="T14" fmla="*/ 377 w 592"/>
                  <a:gd name="T15" fmla="*/ 15 h 224"/>
                  <a:gd name="T16" fmla="*/ 405 w 592"/>
                  <a:gd name="T17" fmla="*/ 3 h 224"/>
                  <a:gd name="T18" fmla="*/ 433 w 592"/>
                  <a:gd name="T19" fmla="*/ 2 h 224"/>
                  <a:gd name="T20" fmla="*/ 459 w 592"/>
                  <a:gd name="T21" fmla="*/ 9 h 224"/>
                  <a:gd name="T22" fmla="*/ 504 w 592"/>
                  <a:gd name="T23" fmla="*/ 36 h 224"/>
                  <a:gd name="T24" fmla="*/ 559 w 592"/>
                  <a:gd name="T25" fmla="*/ 79 h 224"/>
                  <a:gd name="T26" fmla="*/ 579 w 592"/>
                  <a:gd name="T27" fmla="*/ 93 h 224"/>
                  <a:gd name="T28" fmla="*/ 587 w 592"/>
                  <a:gd name="T29" fmla="*/ 125 h 224"/>
                  <a:gd name="T30" fmla="*/ 548 w 592"/>
                  <a:gd name="T31" fmla="*/ 131 h 224"/>
                  <a:gd name="T32" fmla="*/ 555 w 592"/>
                  <a:gd name="T33" fmla="*/ 84 h 224"/>
                  <a:gd name="T34" fmla="*/ 576 w 592"/>
                  <a:gd name="T35" fmla="*/ 93 h 224"/>
                  <a:gd name="T36" fmla="*/ 546 w 592"/>
                  <a:gd name="T37" fmla="*/ 102 h 224"/>
                  <a:gd name="T38" fmla="*/ 543 w 592"/>
                  <a:gd name="T39" fmla="*/ 125 h 224"/>
                  <a:gd name="T40" fmla="*/ 515 w 592"/>
                  <a:gd name="T41" fmla="*/ 105 h 224"/>
                  <a:gd name="T42" fmla="*/ 460 w 592"/>
                  <a:gd name="T43" fmla="*/ 63 h 224"/>
                  <a:gd name="T44" fmla="*/ 442 w 592"/>
                  <a:gd name="T45" fmla="*/ 53 h 224"/>
                  <a:gd name="T46" fmla="*/ 429 w 592"/>
                  <a:gd name="T47" fmla="*/ 48 h 224"/>
                  <a:gd name="T48" fmla="*/ 417 w 592"/>
                  <a:gd name="T49" fmla="*/ 47 h 224"/>
                  <a:gd name="T50" fmla="*/ 403 w 592"/>
                  <a:gd name="T51" fmla="*/ 53 h 224"/>
                  <a:gd name="T52" fmla="*/ 388 w 592"/>
                  <a:gd name="T53" fmla="*/ 67 h 224"/>
                  <a:gd name="T54" fmla="*/ 351 w 592"/>
                  <a:gd name="T55" fmla="*/ 116 h 224"/>
                  <a:gd name="T56" fmla="*/ 288 w 592"/>
                  <a:gd name="T57" fmla="*/ 189 h 224"/>
                  <a:gd name="T58" fmla="*/ 259 w 592"/>
                  <a:gd name="T59" fmla="*/ 207 h 224"/>
                  <a:gd name="T60" fmla="*/ 199 w 592"/>
                  <a:gd name="T61" fmla="*/ 223 h 224"/>
                  <a:gd name="T62" fmla="*/ 132 w 592"/>
                  <a:gd name="T63" fmla="*/ 224 h 224"/>
                  <a:gd name="T64" fmla="*/ 0 w 592"/>
                  <a:gd name="T65" fmla="*/ 210 h 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592" h="224">
                    <a:moveTo>
                      <a:pt x="7" y="163"/>
                    </a:moveTo>
                    <a:lnTo>
                      <a:pt x="73" y="173"/>
                    </a:lnTo>
                    <a:lnTo>
                      <a:pt x="135" y="178"/>
                    </a:lnTo>
                    <a:lnTo>
                      <a:pt x="193" y="176"/>
                    </a:lnTo>
                    <a:lnTo>
                      <a:pt x="188" y="176"/>
                    </a:lnTo>
                    <a:lnTo>
                      <a:pt x="242" y="163"/>
                    </a:lnTo>
                    <a:lnTo>
                      <a:pt x="236" y="166"/>
                    </a:lnTo>
                    <a:lnTo>
                      <a:pt x="260" y="152"/>
                    </a:lnTo>
                    <a:lnTo>
                      <a:pt x="255" y="155"/>
                    </a:lnTo>
                    <a:lnTo>
                      <a:pt x="276" y="134"/>
                    </a:lnTo>
                    <a:lnTo>
                      <a:pt x="314" y="87"/>
                    </a:lnTo>
                    <a:lnTo>
                      <a:pt x="333" y="61"/>
                    </a:lnTo>
                    <a:lnTo>
                      <a:pt x="350" y="38"/>
                    </a:lnTo>
                    <a:cubicBezTo>
                      <a:pt x="351" y="37"/>
                      <a:pt x="352" y="36"/>
                      <a:pt x="353" y="35"/>
                    </a:cubicBezTo>
                    <a:lnTo>
                      <a:pt x="372" y="18"/>
                    </a:lnTo>
                    <a:cubicBezTo>
                      <a:pt x="373" y="17"/>
                      <a:pt x="375" y="15"/>
                      <a:pt x="377" y="15"/>
                    </a:cubicBezTo>
                    <a:lnTo>
                      <a:pt x="396" y="5"/>
                    </a:lnTo>
                    <a:cubicBezTo>
                      <a:pt x="399" y="3"/>
                      <a:pt x="402" y="3"/>
                      <a:pt x="405" y="3"/>
                    </a:cubicBezTo>
                    <a:lnTo>
                      <a:pt x="425" y="1"/>
                    </a:lnTo>
                    <a:cubicBezTo>
                      <a:pt x="428" y="0"/>
                      <a:pt x="430" y="1"/>
                      <a:pt x="433" y="2"/>
                    </a:cubicBezTo>
                    <a:lnTo>
                      <a:pt x="455" y="8"/>
                    </a:lnTo>
                    <a:cubicBezTo>
                      <a:pt x="456" y="8"/>
                      <a:pt x="457" y="9"/>
                      <a:pt x="459" y="9"/>
                    </a:cubicBezTo>
                    <a:lnTo>
                      <a:pt x="481" y="20"/>
                    </a:lnTo>
                    <a:lnTo>
                      <a:pt x="504" y="36"/>
                    </a:lnTo>
                    <a:lnTo>
                      <a:pt x="544" y="67"/>
                    </a:lnTo>
                    <a:lnTo>
                      <a:pt x="559" y="79"/>
                    </a:lnTo>
                    <a:lnTo>
                      <a:pt x="570" y="87"/>
                    </a:lnTo>
                    <a:lnTo>
                      <a:pt x="579" y="93"/>
                    </a:lnTo>
                    <a:cubicBezTo>
                      <a:pt x="590" y="99"/>
                      <a:pt x="592" y="112"/>
                      <a:pt x="587" y="123"/>
                    </a:cubicBezTo>
                    <a:lnTo>
                      <a:pt x="587" y="125"/>
                    </a:lnTo>
                    <a:cubicBezTo>
                      <a:pt x="581" y="136"/>
                      <a:pt x="567" y="141"/>
                      <a:pt x="555" y="135"/>
                    </a:cubicBezTo>
                    <a:lnTo>
                      <a:pt x="548" y="131"/>
                    </a:lnTo>
                    <a:lnTo>
                      <a:pt x="538" y="128"/>
                    </a:lnTo>
                    <a:lnTo>
                      <a:pt x="555" y="84"/>
                    </a:lnTo>
                    <a:lnTo>
                      <a:pt x="569" y="89"/>
                    </a:lnTo>
                    <a:lnTo>
                      <a:pt x="576" y="93"/>
                    </a:lnTo>
                    <a:lnTo>
                      <a:pt x="545" y="103"/>
                    </a:lnTo>
                    <a:lnTo>
                      <a:pt x="546" y="102"/>
                    </a:lnTo>
                    <a:lnTo>
                      <a:pt x="554" y="132"/>
                    </a:lnTo>
                    <a:lnTo>
                      <a:pt x="543" y="125"/>
                    </a:lnTo>
                    <a:lnTo>
                      <a:pt x="531" y="117"/>
                    </a:lnTo>
                    <a:lnTo>
                      <a:pt x="515" y="105"/>
                    </a:lnTo>
                    <a:lnTo>
                      <a:pt x="479" y="75"/>
                    </a:lnTo>
                    <a:lnTo>
                      <a:pt x="460" y="63"/>
                    </a:lnTo>
                    <a:lnTo>
                      <a:pt x="438" y="51"/>
                    </a:lnTo>
                    <a:lnTo>
                      <a:pt x="442" y="53"/>
                    </a:lnTo>
                    <a:lnTo>
                      <a:pt x="421" y="47"/>
                    </a:lnTo>
                    <a:lnTo>
                      <a:pt x="429" y="48"/>
                    </a:lnTo>
                    <a:lnTo>
                      <a:pt x="408" y="49"/>
                    </a:lnTo>
                    <a:lnTo>
                      <a:pt x="417" y="47"/>
                    </a:lnTo>
                    <a:lnTo>
                      <a:pt x="398" y="57"/>
                    </a:lnTo>
                    <a:lnTo>
                      <a:pt x="403" y="53"/>
                    </a:lnTo>
                    <a:lnTo>
                      <a:pt x="385" y="70"/>
                    </a:lnTo>
                    <a:lnTo>
                      <a:pt x="388" y="67"/>
                    </a:lnTo>
                    <a:lnTo>
                      <a:pt x="370" y="90"/>
                    </a:lnTo>
                    <a:lnTo>
                      <a:pt x="351" y="116"/>
                    </a:lnTo>
                    <a:lnTo>
                      <a:pt x="309" y="168"/>
                    </a:lnTo>
                    <a:lnTo>
                      <a:pt x="288" y="189"/>
                    </a:lnTo>
                    <a:cubicBezTo>
                      <a:pt x="287" y="190"/>
                      <a:pt x="285" y="192"/>
                      <a:pt x="283" y="193"/>
                    </a:cubicBezTo>
                    <a:lnTo>
                      <a:pt x="259" y="207"/>
                    </a:lnTo>
                    <a:cubicBezTo>
                      <a:pt x="257" y="208"/>
                      <a:pt x="255" y="209"/>
                      <a:pt x="253" y="210"/>
                    </a:cubicBezTo>
                    <a:lnTo>
                      <a:pt x="199" y="223"/>
                    </a:lnTo>
                    <a:cubicBezTo>
                      <a:pt x="198" y="223"/>
                      <a:pt x="196" y="223"/>
                      <a:pt x="194" y="223"/>
                    </a:cubicBezTo>
                    <a:lnTo>
                      <a:pt x="132" y="224"/>
                    </a:lnTo>
                    <a:lnTo>
                      <a:pt x="66" y="219"/>
                    </a:lnTo>
                    <a:lnTo>
                      <a:pt x="0" y="210"/>
                    </a:lnTo>
                    <a:lnTo>
                      <a:pt x="7" y="163"/>
                    </a:lnTo>
                    <a:close/>
                  </a:path>
                </a:pathLst>
              </a:custGeom>
              <a:solidFill>
                <a:srgbClr val="FFC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" name="Freeform 179">
                <a:extLst>
                  <a:ext uri="{FF2B5EF4-FFF2-40B4-BE49-F238E27FC236}">
                    <a16:creationId xmlns:a16="http://schemas.microsoft.com/office/drawing/2014/main" id="{D2CFE63D-D54B-4B61-AABD-B3E1275337A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40" y="2341"/>
                <a:ext cx="118" cy="42"/>
              </a:xfrm>
              <a:custGeom>
                <a:avLst/>
                <a:gdLst>
                  <a:gd name="T0" fmla="*/ 83 w 606"/>
                  <a:gd name="T1" fmla="*/ 173 h 239"/>
                  <a:gd name="T2" fmla="*/ 196 w 606"/>
                  <a:gd name="T3" fmla="*/ 191 h 239"/>
                  <a:gd name="T4" fmla="*/ 258 w 606"/>
                  <a:gd name="T5" fmla="*/ 168 h 239"/>
                  <a:gd name="T6" fmla="*/ 240 w 606"/>
                  <a:gd name="T7" fmla="*/ 167 h 239"/>
                  <a:gd name="T8" fmla="*/ 268 w 606"/>
                  <a:gd name="T9" fmla="*/ 169 h 239"/>
                  <a:gd name="T10" fmla="*/ 316 w 606"/>
                  <a:gd name="T11" fmla="*/ 89 h 239"/>
                  <a:gd name="T12" fmla="*/ 356 w 606"/>
                  <a:gd name="T13" fmla="*/ 37 h 239"/>
                  <a:gd name="T14" fmla="*/ 401 w 606"/>
                  <a:gd name="T15" fmla="*/ 5 h 239"/>
                  <a:gd name="T16" fmla="*/ 434 w 606"/>
                  <a:gd name="T17" fmla="*/ 1 h 239"/>
                  <a:gd name="T18" fmla="*/ 469 w 606"/>
                  <a:gd name="T19" fmla="*/ 9 h 239"/>
                  <a:gd name="T20" fmla="*/ 517 w 606"/>
                  <a:gd name="T21" fmla="*/ 37 h 239"/>
                  <a:gd name="T22" fmla="*/ 592 w 606"/>
                  <a:gd name="T23" fmla="*/ 94 h 239"/>
                  <a:gd name="T24" fmla="*/ 603 w 606"/>
                  <a:gd name="T25" fmla="*/ 131 h 239"/>
                  <a:gd name="T26" fmla="*/ 581 w 606"/>
                  <a:gd name="T27" fmla="*/ 151 h 239"/>
                  <a:gd name="T28" fmla="*/ 554 w 606"/>
                  <a:gd name="T29" fmla="*/ 146 h 239"/>
                  <a:gd name="T30" fmla="*/ 556 w 606"/>
                  <a:gd name="T31" fmla="*/ 89 h 239"/>
                  <a:gd name="T32" fmla="*/ 588 w 606"/>
                  <a:gd name="T33" fmla="*/ 94 h 239"/>
                  <a:gd name="T34" fmla="*/ 547 w 606"/>
                  <a:gd name="T35" fmla="*/ 115 h 239"/>
                  <a:gd name="T36" fmla="*/ 562 w 606"/>
                  <a:gd name="T37" fmla="*/ 107 h 239"/>
                  <a:gd name="T38" fmla="*/ 547 w 606"/>
                  <a:gd name="T39" fmla="*/ 139 h 239"/>
                  <a:gd name="T40" fmla="*/ 464 w 606"/>
                  <a:gd name="T41" fmla="*/ 77 h 239"/>
                  <a:gd name="T42" fmla="*/ 454 w 606"/>
                  <a:gd name="T43" fmla="*/ 53 h 239"/>
                  <a:gd name="T44" fmla="*/ 422 w 606"/>
                  <a:gd name="T45" fmla="*/ 53 h 239"/>
                  <a:gd name="T46" fmla="*/ 438 w 606"/>
                  <a:gd name="T47" fmla="*/ 63 h 239"/>
                  <a:gd name="T48" fmla="*/ 424 w 606"/>
                  <a:gd name="T49" fmla="*/ 47 h 239"/>
                  <a:gd name="T50" fmla="*/ 400 w 606"/>
                  <a:gd name="T51" fmla="*/ 69 h 239"/>
                  <a:gd name="T52" fmla="*/ 417 w 606"/>
                  <a:gd name="T53" fmla="*/ 66 h 239"/>
                  <a:gd name="T54" fmla="*/ 391 w 606"/>
                  <a:gd name="T55" fmla="*/ 69 h 239"/>
                  <a:gd name="T56" fmla="*/ 366 w 606"/>
                  <a:gd name="T57" fmla="*/ 128 h 239"/>
                  <a:gd name="T58" fmla="*/ 296 w 606"/>
                  <a:gd name="T59" fmla="*/ 207 h 239"/>
                  <a:gd name="T60" fmla="*/ 209 w 606"/>
                  <a:gd name="T61" fmla="*/ 238 h 239"/>
                  <a:gd name="T62" fmla="*/ 74 w 606"/>
                  <a:gd name="T63" fmla="*/ 234 h 239"/>
                  <a:gd name="T64" fmla="*/ 8 w 606"/>
                  <a:gd name="T65" fmla="*/ 169 h 239"/>
                  <a:gd name="T66" fmla="*/ 140 w 606"/>
                  <a:gd name="T67" fmla="*/ 223 h 239"/>
                  <a:gd name="T68" fmla="*/ 260 w 606"/>
                  <a:gd name="T69" fmla="*/ 210 h 239"/>
                  <a:gd name="T70" fmla="*/ 286 w 606"/>
                  <a:gd name="T71" fmla="*/ 194 h 239"/>
                  <a:gd name="T72" fmla="*/ 372 w 606"/>
                  <a:gd name="T73" fmla="*/ 93 h 239"/>
                  <a:gd name="T74" fmla="*/ 388 w 606"/>
                  <a:gd name="T75" fmla="*/ 72 h 239"/>
                  <a:gd name="T76" fmla="*/ 403 w 606"/>
                  <a:gd name="T77" fmla="*/ 57 h 239"/>
                  <a:gd name="T78" fmla="*/ 416 w 606"/>
                  <a:gd name="T79" fmla="*/ 48 h 239"/>
                  <a:gd name="T80" fmla="*/ 432 w 606"/>
                  <a:gd name="T81" fmla="*/ 47 h 239"/>
                  <a:gd name="T82" fmla="*/ 450 w 606"/>
                  <a:gd name="T83" fmla="*/ 51 h 239"/>
                  <a:gd name="T84" fmla="*/ 544 w 606"/>
                  <a:gd name="T85" fmla="*/ 118 h 239"/>
                  <a:gd name="T86" fmla="*/ 547 w 606"/>
                  <a:gd name="T87" fmla="*/ 112 h 239"/>
                  <a:gd name="T88" fmla="*/ 582 w 606"/>
                  <a:gd name="T89" fmla="*/ 93 h 239"/>
                  <a:gd name="T90" fmla="*/ 561 w 606"/>
                  <a:gd name="T91" fmla="*/ 99 h 239"/>
                  <a:gd name="T92" fmla="*/ 559 w 606"/>
                  <a:gd name="T93" fmla="*/ 131 h 239"/>
                  <a:gd name="T94" fmla="*/ 582 w 606"/>
                  <a:gd name="T95" fmla="*/ 135 h 239"/>
                  <a:gd name="T96" fmla="*/ 588 w 606"/>
                  <a:gd name="T97" fmla="*/ 130 h 239"/>
                  <a:gd name="T98" fmla="*/ 583 w 606"/>
                  <a:gd name="T99" fmla="*/ 107 h 239"/>
                  <a:gd name="T100" fmla="*/ 508 w 606"/>
                  <a:gd name="T101" fmla="*/ 50 h 239"/>
                  <a:gd name="T102" fmla="*/ 466 w 606"/>
                  <a:gd name="T103" fmla="*/ 24 h 239"/>
                  <a:gd name="T104" fmla="*/ 432 w 606"/>
                  <a:gd name="T105" fmla="*/ 16 h 239"/>
                  <a:gd name="T106" fmla="*/ 408 w 606"/>
                  <a:gd name="T107" fmla="*/ 20 h 239"/>
                  <a:gd name="T108" fmla="*/ 367 w 606"/>
                  <a:gd name="T109" fmla="*/ 48 h 239"/>
                  <a:gd name="T110" fmla="*/ 329 w 606"/>
                  <a:gd name="T111" fmla="*/ 100 h 239"/>
                  <a:gd name="T112" fmla="*/ 264 w 606"/>
                  <a:gd name="T113" fmla="*/ 153 h 239"/>
                  <a:gd name="T114" fmla="*/ 247 w 606"/>
                  <a:gd name="T115" fmla="*/ 163 h 239"/>
                  <a:gd name="T116" fmla="*/ 201 w 606"/>
                  <a:gd name="T117" fmla="*/ 175 h 239"/>
                  <a:gd name="T118" fmla="*/ 80 w 606"/>
                  <a:gd name="T119" fmla="*/ 188 h 2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</a:cxnLst>
                <a:rect l="0" t="0" r="r" b="b"/>
                <a:pathLst>
                  <a:path w="606" h="239">
                    <a:moveTo>
                      <a:pt x="8" y="169"/>
                    </a:moveTo>
                    <a:cubicBezTo>
                      <a:pt x="8" y="167"/>
                      <a:pt x="9" y="165"/>
                      <a:pt x="11" y="164"/>
                    </a:cubicBezTo>
                    <a:cubicBezTo>
                      <a:pt x="12" y="163"/>
                      <a:pt x="15" y="162"/>
                      <a:pt x="17" y="163"/>
                    </a:cubicBezTo>
                    <a:lnTo>
                      <a:pt x="83" y="173"/>
                    </a:lnTo>
                    <a:lnTo>
                      <a:pt x="144" y="177"/>
                    </a:lnTo>
                    <a:lnTo>
                      <a:pt x="201" y="175"/>
                    </a:lnTo>
                    <a:lnTo>
                      <a:pt x="201" y="191"/>
                    </a:lnTo>
                    <a:lnTo>
                      <a:pt x="196" y="191"/>
                    </a:lnTo>
                    <a:cubicBezTo>
                      <a:pt x="192" y="191"/>
                      <a:pt x="189" y="188"/>
                      <a:pt x="189" y="184"/>
                    </a:cubicBezTo>
                    <a:cubicBezTo>
                      <a:pt x="188" y="180"/>
                      <a:pt x="191" y="177"/>
                      <a:pt x="195" y="176"/>
                    </a:cubicBezTo>
                    <a:lnTo>
                      <a:pt x="249" y="163"/>
                    </a:lnTo>
                    <a:cubicBezTo>
                      <a:pt x="253" y="162"/>
                      <a:pt x="257" y="164"/>
                      <a:pt x="258" y="168"/>
                    </a:cubicBezTo>
                    <a:cubicBezTo>
                      <a:pt x="259" y="172"/>
                      <a:pt x="258" y="176"/>
                      <a:pt x="254" y="178"/>
                    </a:cubicBezTo>
                    <a:lnTo>
                      <a:pt x="248" y="181"/>
                    </a:lnTo>
                    <a:cubicBezTo>
                      <a:pt x="244" y="183"/>
                      <a:pt x="239" y="181"/>
                      <a:pt x="237" y="177"/>
                    </a:cubicBezTo>
                    <a:cubicBezTo>
                      <a:pt x="235" y="173"/>
                      <a:pt x="237" y="169"/>
                      <a:pt x="240" y="167"/>
                    </a:cubicBezTo>
                    <a:lnTo>
                      <a:pt x="264" y="153"/>
                    </a:lnTo>
                    <a:cubicBezTo>
                      <a:pt x="268" y="150"/>
                      <a:pt x="273" y="152"/>
                      <a:pt x="275" y="155"/>
                    </a:cubicBezTo>
                    <a:cubicBezTo>
                      <a:pt x="278" y="159"/>
                      <a:pt x="276" y="164"/>
                      <a:pt x="273" y="166"/>
                    </a:cubicBezTo>
                    <a:lnTo>
                      <a:pt x="268" y="169"/>
                    </a:lnTo>
                    <a:cubicBezTo>
                      <a:pt x="264" y="171"/>
                      <a:pt x="260" y="171"/>
                      <a:pt x="257" y="167"/>
                    </a:cubicBezTo>
                    <a:cubicBezTo>
                      <a:pt x="255" y="164"/>
                      <a:pt x="255" y="160"/>
                      <a:pt x="258" y="157"/>
                    </a:cubicBezTo>
                    <a:lnTo>
                      <a:pt x="279" y="136"/>
                    </a:lnTo>
                    <a:lnTo>
                      <a:pt x="316" y="89"/>
                    </a:lnTo>
                    <a:lnTo>
                      <a:pt x="335" y="64"/>
                    </a:lnTo>
                    <a:lnTo>
                      <a:pt x="352" y="41"/>
                    </a:lnTo>
                    <a:cubicBezTo>
                      <a:pt x="352" y="40"/>
                      <a:pt x="353" y="40"/>
                      <a:pt x="353" y="40"/>
                    </a:cubicBezTo>
                    <a:lnTo>
                      <a:pt x="356" y="37"/>
                    </a:lnTo>
                    <a:lnTo>
                      <a:pt x="375" y="20"/>
                    </a:lnTo>
                    <a:cubicBezTo>
                      <a:pt x="376" y="19"/>
                      <a:pt x="376" y="19"/>
                      <a:pt x="376" y="19"/>
                    </a:cubicBezTo>
                    <a:lnTo>
                      <a:pt x="381" y="16"/>
                    </a:lnTo>
                    <a:lnTo>
                      <a:pt x="401" y="5"/>
                    </a:lnTo>
                    <a:cubicBezTo>
                      <a:pt x="401" y="5"/>
                      <a:pt x="402" y="5"/>
                      <a:pt x="403" y="5"/>
                    </a:cubicBezTo>
                    <a:lnTo>
                      <a:pt x="412" y="3"/>
                    </a:lnTo>
                    <a:lnTo>
                      <a:pt x="433" y="0"/>
                    </a:lnTo>
                    <a:cubicBezTo>
                      <a:pt x="433" y="0"/>
                      <a:pt x="434" y="0"/>
                      <a:pt x="434" y="1"/>
                    </a:cubicBezTo>
                    <a:lnTo>
                      <a:pt x="442" y="2"/>
                    </a:lnTo>
                    <a:cubicBezTo>
                      <a:pt x="443" y="2"/>
                      <a:pt x="443" y="2"/>
                      <a:pt x="444" y="2"/>
                    </a:cubicBezTo>
                    <a:lnTo>
                      <a:pt x="466" y="8"/>
                    </a:lnTo>
                    <a:lnTo>
                      <a:pt x="469" y="9"/>
                    </a:lnTo>
                    <a:cubicBezTo>
                      <a:pt x="470" y="9"/>
                      <a:pt x="471" y="9"/>
                      <a:pt x="471" y="9"/>
                    </a:cubicBezTo>
                    <a:lnTo>
                      <a:pt x="493" y="20"/>
                    </a:lnTo>
                    <a:cubicBezTo>
                      <a:pt x="493" y="20"/>
                      <a:pt x="494" y="21"/>
                      <a:pt x="494" y="21"/>
                    </a:cubicBezTo>
                    <a:lnTo>
                      <a:pt x="517" y="37"/>
                    </a:lnTo>
                    <a:lnTo>
                      <a:pt x="557" y="68"/>
                    </a:lnTo>
                    <a:lnTo>
                      <a:pt x="572" y="80"/>
                    </a:lnTo>
                    <a:lnTo>
                      <a:pt x="583" y="88"/>
                    </a:lnTo>
                    <a:lnTo>
                      <a:pt x="592" y="94"/>
                    </a:lnTo>
                    <a:cubicBezTo>
                      <a:pt x="593" y="94"/>
                      <a:pt x="593" y="95"/>
                      <a:pt x="594" y="96"/>
                    </a:cubicBezTo>
                    <a:lnTo>
                      <a:pt x="604" y="109"/>
                    </a:lnTo>
                    <a:cubicBezTo>
                      <a:pt x="605" y="110"/>
                      <a:pt x="606" y="112"/>
                      <a:pt x="605" y="114"/>
                    </a:cubicBezTo>
                    <a:lnTo>
                      <a:pt x="603" y="131"/>
                    </a:lnTo>
                    <a:lnTo>
                      <a:pt x="603" y="132"/>
                    </a:lnTo>
                    <a:cubicBezTo>
                      <a:pt x="603" y="135"/>
                      <a:pt x="602" y="137"/>
                      <a:pt x="600" y="139"/>
                    </a:cubicBezTo>
                    <a:lnTo>
                      <a:pt x="586" y="150"/>
                    </a:lnTo>
                    <a:cubicBezTo>
                      <a:pt x="585" y="151"/>
                      <a:pt x="583" y="152"/>
                      <a:pt x="581" y="151"/>
                    </a:cubicBezTo>
                    <a:lnTo>
                      <a:pt x="563" y="150"/>
                    </a:lnTo>
                    <a:cubicBezTo>
                      <a:pt x="562" y="150"/>
                      <a:pt x="561" y="150"/>
                      <a:pt x="559" y="149"/>
                    </a:cubicBezTo>
                    <a:lnTo>
                      <a:pt x="552" y="145"/>
                    </a:lnTo>
                    <a:lnTo>
                      <a:pt x="554" y="146"/>
                    </a:lnTo>
                    <a:lnTo>
                      <a:pt x="544" y="143"/>
                    </a:lnTo>
                    <a:cubicBezTo>
                      <a:pt x="542" y="142"/>
                      <a:pt x="540" y="141"/>
                      <a:pt x="539" y="139"/>
                    </a:cubicBezTo>
                    <a:cubicBezTo>
                      <a:pt x="538" y="137"/>
                      <a:pt x="538" y="135"/>
                      <a:pt x="539" y="133"/>
                    </a:cubicBezTo>
                    <a:lnTo>
                      <a:pt x="556" y="89"/>
                    </a:lnTo>
                    <a:cubicBezTo>
                      <a:pt x="558" y="85"/>
                      <a:pt x="562" y="82"/>
                      <a:pt x="566" y="84"/>
                    </a:cubicBezTo>
                    <a:lnTo>
                      <a:pt x="580" y="89"/>
                    </a:lnTo>
                    <a:cubicBezTo>
                      <a:pt x="581" y="89"/>
                      <a:pt x="581" y="89"/>
                      <a:pt x="581" y="90"/>
                    </a:cubicBezTo>
                    <a:lnTo>
                      <a:pt x="588" y="94"/>
                    </a:lnTo>
                    <a:cubicBezTo>
                      <a:pt x="591" y="95"/>
                      <a:pt x="593" y="98"/>
                      <a:pt x="592" y="101"/>
                    </a:cubicBezTo>
                    <a:cubicBezTo>
                      <a:pt x="592" y="104"/>
                      <a:pt x="590" y="107"/>
                      <a:pt x="587" y="108"/>
                    </a:cubicBezTo>
                    <a:lnTo>
                      <a:pt x="556" y="118"/>
                    </a:lnTo>
                    <a:cubicBezTo>
                      <a:pt x="552" y="119"/>
                      <a:pt x="549" y="118"/>
                      <a:pt x="547" y="115"/>
                    </a:cubicBezTo>
                    <a:cubicBezTo>
                      <a:pt x="545" y="111"/>
                      <a:pt x="545" y="107"/>
                      <a:pt x="548" y="105"/>
                    </a:cubicBezTo>
                    <a:lnTo>
                      <a:pt x="549" y="104"/>
                    </a:lnTo>
                    <a:cubicBezTo>
                      <a:pt x="551" y="102"/>
                      <a:pt x="554" y="101"/>
                      <a:pt x="557" y="102"/>
                    </a:cubicBezTo>
                    <a:cubicBezTo>
                      <a:pt x="559" y="102"/>
                      <a:pt x="561" y="105"/>
                      <a:pt x="562" y="107"/>
                    </a:cubicBezTo>
                    <a:lnTo>
                      <a:pt x="570" y="137"/>
                    </a:lnTo>
                    <a:cubicBezTo>
                      <a:pt x="571" y="141"/>
                      <a:pt x="570" y="144"/>
                      <a:pt x="567" y="146"/>
                    </a:cubicBezTo>
                    <a:cubicBezTo>
                      <a:pt x="565" y="148"/>
                      <a:pt x="561" y="148"/>
                      <a:pt x="558" y="146"/>
                    </a:cubicBezTo>
                    <a:lnTo>
                      <a:pt x="547" y="139"/>
                    </a:lnTo>
                    <a:lnTo>
                      <a:pt x="535" y="131"/>
                    </a:lnTo>
                    <a:lnTo>
                      <a:pt x="519" y="119"/>
                    </a:lnTo>
                    <a:lnTo>
                      <a:pt x="482" y="89"/>
                    </a:lnTo>
                    <a:lnTo>
                      <a:pt x="464" y="77"/>
                    </a:lnTo>
                    <a:lnTo>
                      <a:pt x="443" y="65"/>
                    </a:lnTo>
                    <a:cubicBezTo>
                      <a:pt x="439" y="63"/>
                      <a:pt x="437" y="59"/>
                      <a:pt x="439" y="55"/>
                    </a:cubicBezTo>
                    <a:cubicBezTo>
                      <a:pt x="441" y="51"/>
                      <a:pt x="446" y="49"/>
                      <a:pt x="450" y="51"/>
                    </a:cubicBezTo>
                    <a:lnTo>
                      <a:pt x="454" y="53"/>
                    </a:lnTo>
                    <a:cubicBezTo>
                      <a:pt x="458" y="55"/>
                      <a:pt x="459" y="60"/>
                      <a:pt x="458" y="63"/>
                    </a:cubicBezTo>
                    <a:cubicBezTo>
                      <a:pt x="456" y="67"/>
                      <a:pt x="452" y="69"/>
                      <a:pt x="448" y="68"/>
                    </a:cubicBezTo>
                    <a:lnTo>
                      <a:pt x="427" y="62"/>
                    </a:lnTo>
                    <a:cubicBezTo>
                      <a:pt x="423" y="61"/>
                      <a:pt x="421" y="57"/>
                      <a:pt x="422" y="53"/>
                    </a:cubicBezTo>
                    <a:cubicBezTo>
                      <a:pt x="422" y="49"/>
                      <a:pt x="426" y="46"/>
                      <a:pt x="430" y="47"/>
                    </a:cubicBezTo>
                    <a:lnTo>
                      <a:pt x="438" y="48"/>
                    </a:lnTo>
                    <a:cubicBezTo>
                      <a:pt x="443" y="48"/>
                      <a:pt x="446" y="52"/>
                      <a:pt x="445" y="56"/>
                    </a:cubicBezTo>
                    <a:cubicBezTo>
                      <a:pt x="445" y="60"/>
                      <a:pt x="442" y="63"/>
                      <a:pt x="438" y="63"/>
                    </a:cubicBezTo>
                    <a:lnTo>
                      <a:pt x="417" y="64"/>
                    </a:lnTo>
                    <a:cubicBezTo>
                      <a:pt x="413" y="65"/>
                      <a:pt x="409" y="62"/>
                      <a:pt x="409" y="58"/>
                    </a:cubicBezTo>
                    <a:cubicBezTo>
                      <a:pt x="408" y="53"/>
                      <a:pt x="411" y="50"/>
                      <a:pt x="415" y="49"/>
                    </a:cubicBezTo>
                    <a:lnTo>
                      <a:pt x="424" y="47"/>
                    </a:lnTo>
                    <a:cubicBezTo>
                      <a:pt x="428" y="46"/>
                      <a:pt x="432" y="48"/>
                      <a:pt x="433" y="52"/>
                    </a:cubicBezTo>
                    <a:cubicBezTo>
                      <a:pt x="434" y="55"/>
                      <a:pt x="433" y="60"/>
                      <a:pt x="429" y="62"/>
                    </a:cubicBezTo>
                    <a:lnTo>
                      <a:pt x="410" y="72"/>
                    </a:lnTo>
                    <a:cubicBezTo>
                      <a:pt x="407" y="73"/>
                      <a:pt x="402" y="72"/>
                      <a:pt x="400" y="69"/>
                    </a:cubicBezTo>
                    <a:cubicBezTo>
                      <a:pt x="398" y="65"/>
                      <a:pt x="398" y="61"/>
                      <a:pt x="401" y="58"/>
                    </a:cubicBezTo>
                    <a:lnTo>
                      <a:pt x="406" y="54"/>
                    </a:lnTo>
                    <a:cubicBezTo>
                      <a:pt x="410" y="52"/>
                      <a:pt x="415" y="52"/>
                      <a:pt x="418" y="55"/>
                    </a:cubicBezTo>
                    <a:cubicBezTo>
                      <a:pt x="420" y="58"/>
                      <a:pt x="420" y="63"/>
                      <a:pt x="417" y="66"/>
                    </a:cubicBezTo>
                    <a:lnTo>
                      <a:pt x="399" y="83"/>
                    </a:lnTo>
                    <a:cubicBezTo>
                      <a:pt x="396" y="86"/>
                      <a:pt x="391" y="86"/>
                      <a:pt x="388" y="83"/>
                    </a:cubicBezTo>
                    <a:cubicBezTo>
                      <a:pt x="385" y="80"/>
                      <a:pt x="385" y="75"/>
                      <a:pt x="388" y="72"/>
                    </a:cubicBezTo>
                    <a:lnTo>
                      <a:pt x="391" y="69"/>
                    </a:lnTo>
                    <a:cubicBezTo>
                      <a:pt x="394" y="66"/>
                      <a:pt x="399" y="66"/>
                      <a:pt x="402" y="68"/>
                    </a:cubicBezTo>
                    <a:cubicBezTo>
                      <a:pt x="405" y="71"/>
                      <a:pt x="405" y="76"/>
                      <a:pt x="403" y="79"/>
                    </a:cubicBezTo>
                    <a:lnTo>
                      <a:pt x="385" y="102"/>
                    </a:lnTo>
                    <a:lnTo>
                      <a:pt x="366" y="128"/>
                    </a:lnTo>
                    <a:lnTo>
                      <a:pt x="324" y="180"/>
                    </a:lnTo>
                    <a:lnTo>
                      <a:pt x="302" y="202"/>
                    </a:lnTo>
                    <a:lnTo>
                      <a:pt x="296" y="207"/>
                    </a:lnTo>
                    <a:cubicBezTo>
                      <a:pt x="296" y="207"/>
                      <a:pt x="296" y="207"/>
                      <a:pt x="296" y="207"/>
                    </a:cubicBezTo>
                    <a:lnTo>
                      <a:pt x="272" y="221"/>
                    </a:lnTo>
                    <a:lnTo>
                      <a:pt x="265" y="225"/>
                    </a:lnTo>
                    <a:cubicBezTo>
                      <a:pt x="265" y="225"/>
                      <a:pt x="264" y="225"/>
                      <a:pt x="263" y="225"/>
                    </a:cubicBezTo>
                    <a:lnTo>
                      <a:pt x="209" y="238"/>
                    </a:lnTo>
                    <a:cubicBezTo>
                      <a:pt x="209" y="238"/>
                      <a:pt x="208" y="238"/>
                      <a:pt x="207" y="238"/>
                    </a:cubicBezTo>
                    <a:lnTo>
                      <a:pt x="202" y="238"/>
                    </a:lnTo>
                    <a:lnTo>
                      <a:pt x="141" y="239"/>
                    </a:lnTo>
                    <a:lnTo>
                      <a:pt x="74" y="234"/>
                    </a:lnTo>
                    <a:lnTo>
                      <a:pt x="7" y="225"/>
                    </a:lnTo>
                    <a:cubicBezTo>
                      <a:pt x="5" y="225"/>
                      <a:pt x="3" y="224"/>
                      <a:pt x="2" y="222"/>
                    </a:cubicBezTo>
                    <a:cubicBezTo>
                      <a:pt x="1" y="221"/>
                      <a:pt x="0" y="218"/>
                      <a:pt x="1" y="216"/>
                    </a:cubicBezTo>
                    <a:lnTo>
                      <a:pt x="8" y="169"/>
                    </a:lnTo>
                    <a:close/>
                    <a:moveTo>
                      <a:pt x="16" y="219"/>
                    </a:moveTo>
                    <a:lnTo>
                      <a:pt x="10" y="210"/>
                    </a:lnTo>
                    <a:lnTo>
                      <a:pt x="75" y="218"/>
                    </a:lnTo>
                    <a:lnTo>
                      <a:pt x="140" y="223"/>
                    </a:lnTo>
                    <a:lnTo>
                      <a:pt x="202" y="222"/>
                    </a:lnTo>
                    <a:lnTo>
                      <a:pt x="207" y="222"/>
                    </a:lnTo>
                    <a:lnTo>
                      <a:pt x="206" y="223"/>
                    </a:lnTo>
                    <a:lnTo>
                      <a:pt x="260" y="210"/>
                    </a:lnTo>
                    <a:lnTo>
                      <a:pt x="258" y="210"/>
                    </a:lnTo>
                    <a:lnTo>
                      <a:pt x="263" y="208"/>
                    </a:lnTo>
                    <a:lnTo>
                      <a:pt x="287" y="194"/>
                    </a:lnTo>
                    <a:lnTo>
                      <a:pt x="286" y="194"/>
                    </a:lnTo>
                    <a:lnTo>
                      <a:pt x="291" y="191"/>
                    </a:lnTo>
                    <a:lnTo>
                      <a:pt x="311" y="170"/>
                    </a:lnTo>
                    <a:lnTo>
                      <a:pt x="353" y="119"/>
                    </a:lnTo>
                    <a:lnTo>
                      <a:pt x="372" y="93"/>
                    </a:lnTo>
                    <a:lnTo>
                      <a:pt x="390" y="70"/>
                    </a:lnTo>
                    <a:lnTo>
                      <a:pt x="402" y="80"/>
                    </a:lnTo>
                    <a:lnTo>
                      <a:pt x="399" y="83"/>
                    </a:lnTo>
                    <a:lnTo>
                      <a:pt x="388" y="72"/>
                    </a:lnTo>
                    <a:lnTo>
                      <a:pt x="406" y="55"/>
                    </a:lnTo>
                    <a:lnTo>
                      <a:pt x="416" y="67"/>
                    </a:lnTo>
                    <a:lnTo>
                      <a:pt x="411" y="71"/>
                    </a:lnTo>
                    <a:lnTo>
                      <a:pt x="403" y="57"/>
                    </a:lnTo>
                    <a:lnTo>
                      <a:pt x="422" y="47"/>
                    </a:lnTo>
                    <a:lnTo>
                      <a:pt x="427" y="62"/>
                    </a:lnTo>
                    <a:lnTo>
                      <a:pt x="418" y="64"/>
                    </a:lnTo>
                    <a:lnTo>
                      <a:pt x="416" y="48"/>
                    </a:lnTo>
                    <a:lnTo>
                      <a:pt x="437" y="47"/>
                    </a:lnTo>
                    <a:lnTo>
                      <a:pt x="436" y="63"/>
                    </a:lnTo>
                    <a:lnTo>
                      <a:pt x="428" y="62"/>
                    </a:lnTo>
                    <a:lnTo>
                      <a:pt x="432" y="47"/>
                    </a:lnTo>
                    <a:lnTo>
                      <a:pt x="453" y="53"/>
                    </a:lnTo>
                    <a:lnTo>
                      <a:pt x="447" y="68"/>
                    </a:lnTo>
                    <a:lnTo>
                      <a:pt x="443" y="66"/>
                    </a:lnTo>
                    <a:lnTo>
                      <a:pt x="450" y="51"/>
                    </a:lnTo>
                    <a:lnTo>
                      <a:pt x="473" y="64"/>
                    </a:lnTo>
                    <a:lnTo>
                      <a:pt x="493" y="76"/>
                    </a:lnTo>
                    <a:lnTo>
                      <a:pt x="528" y="106"/>
                    </a:lnTo>
                    <a:lnTo>
                      <a:pt x="544" y="118"/>
                    </a:lnTo>
                    <a:lnTo>
                      <a:pt x="556" y="126"/>
                    </a:lnTo>
                    <a:lnTo>
                      <a:pt x="567" y="133"/>
                    </a:lnTo>
                    <a:lnTo>
                      <a:pt x="555" y="142"/>
                    </a:lnTo>
                    <a:lnTo>
                      <a:pt x="547" y="112"/>
                    </a:lnTo>
                    <a:lnTo>
                      <a:pt x="560" y="115"/>
                    </a:lnTo>
                    <a:lnTo>
                      <a:pt x="559" y="116"/>
                    </a:lnTo>
                    <a:lnTo>
                      <a:pt x="551" y="103"/>
                    </a:lnTo>
                    <a:lnTo>
                      <a:pt x="582" y="93"/>
                    </a:lnTo>
                    <a:lnTo>
                      <a:pt x="580" y="107"/>
                    </a:lnTo>
                    <a:lnTo>
                      <a:pt x="573" y="103"/>
                    </a:lnTo>
                    <a:lnTo>
                      <a:pt x="575" y="104"/>
                    </a:lnTo>
                    <a:lnTo>
                      <a:pt x="561" y="99"/>
                    </a:lnTo>
                    <a:lnTo>
                      <a:pt x="571" y="94"/>
                    </a:lnTo>
                    <a:lnTo>
                      <a:pt x="554" y="138"/>
                    </a:lnTo>
                    <a:lnTo>
                      <a:pt x="549" y="128"/>
                    </a:lnTo>
                    <a:lnTo>
                      <a:pt x="559" y="131"/>
                    </a:lnTo>
                    <a:cubicBezTo>
                      <a:pt x="559" y="131"/>
                      <a:pt x="560" y="131"/>
                      <a:pt x="560" y="132"/>
                    </a:cubicBezTo>
                    <a:lnTo>
                      <a:pt x="567" y="136"/>
                    </a:lnTo>
                    <a:lnTo>
                      <a:pt x="564" y="134"/>
                    </a:lnTo>
                    <a:lnTo>
                      <a:pt x="582" y="135"/>
                    </a:lnTo>
                    <a:lnTo>
                      <a:pt x="577" y="137"/>
                    </a:lnTo>
                    <a:lnTo>
                      <a:pt x="591" y="126"/>
                    </a:lnTo>
                    <a:lnTo>
                      <a:pt x="587" y="132"/>
                    </a:lnTo>
                    <a:lnTo>
                      <a:pt x="588" y="130"/>
                    </a:lnTo>
                    <a:lnTo>
                      <a:pt x="590" y="113"/>
                    </a:lnTo>
                    <a:lnTo>
                      <a:pt x="591" y="118"/>
                    </a:lnTo>
                    <a:lnTo>
                      <a:pt x="581" y="105"/>
                    </a:lnTo>
                    <a:lnTo>
                      <a:pt x="583" y="107"/>
                    </a:lnTo>
                    <a:lnTo>
                      <a:pt x="574" y="101"/>
                    </a:lnTo>
                    <a:lnTo>
                      <a:pt x="562" y="93"/>
                    </a:lnTo>
                    <a:lnTo>
                      <a:pt x="548" y="81"/>
                    </a:lnTo>
                    <a:lnTo>
                      <a:pt x="508" y="50"/>
                    </a:lnTo>
                    <a:lnTo>
                      <a:pt x="485" y="34"/>
                    </a:lnTo>
                    <a:lnTo>
                      <a:pt x="486" y="35"/>
                    </a:lnTo>
                    <a:lnTo>
                      <a:pt x="464" y="24"/>
                    </a:lnTo>
                    <a:lnTo>
                      <a:pt x="466" y="24"/>
                    </a:lnTo>
                    <a:lnTo>
                      <a:pt x="461" y="23"/>
                    </a:lnTo>
                    <a:lnTo>
                      <a:pt x="439" y="17"/>
                    </a:lnTo>
                    <a:lnTo>
                      <a:pt x="440" y="17"/>
                    </a:lnTo>
                    <a:lnTo>
                      <a:pt x="432" y="16"/>
                    </a:lnTo>
                    <a:lnTo>
                      <a:pt x="434" y="16"/>
                    </a:lnTo>
                    <a:lnTo>
                      <a:pt x="415" y="18"/>
                    </a:lnTo>
                    <a:lnTo>
                      <a:pt x="406" y="20"/>
                    </a:lnTo>
                    <a:lnTo>
                      <a:pt x="408" y="20"/>
                    </a:lnTo>
                    <a:lnTo>
                      <a:pt x="390" y="29"/>
                    </a:lnTo>
                    <a:lnTo>
                      <a:pt x="385" y="32"/>
                    </a:lnTo>
                    <a:lnTo>
                      <a:pt x="386" y="31"/>
                    </a:lnTo>
                    <a:lnTo>
                      <a:pt x="367" y="48"/>
                    </a:lnTo>
                    <a:lnTo>
                      <a:pt x="364" y="51"/>
                    </a:lnTo>
                    <a:lnTo>
                      <a:pt x="365" y="50"/>
                    </a:lnTo>
                    <a:lnTo>
                      <a:pt x="348" y="73"/>
                    </a:lnTo>
                    <a:lnTo>
                      <a:pt x="329" y="100"/>
                    </a:lnTo>
                    <a:lnTo>
                      <a:pt x="290" y="147"/>
                    </a:lnTo>
                    <a:lnTo>
                      <a:pt x="269" y="168"/>
                    </a:lnTo>
                    <a:lnTo>
                      <a:pt x="259" y="156"/>
                    </a:lnTo>
                    <a:lnTo>
                      <a:pt x="264" y="153"/>
                    </a:lnTo>
                    <a:lnTo>
                      <a:pt x="273" y="166"/>
                    </a:lnTo>
                    <a:lnTo>
                      <a:pt x="249" y="180"/>
                    </a:lnTo>
                    <a:lnTo>
                      <a:pt x="241" y="166"/>
                    </a:lnTo>
                    <a:lnTo>
                      <a:pt x="247" y="163"/>
                    </a:lnTo>
                    <a:lnTo>
                      <a:pt x="252" y="178"/>
                    </a:lnTo>
                    <a:lnTo>
                      <a:pt x="198" y="191"/>
                    </a:lnTo>
                    <a:lnTo>
                      <a:pt x="196" y="175"/>
                    </a:lnTo>
                    <a:lnTo>
                      <a:pt x="201" y="175"/>
                    </a:lnTo>
                    <a:cubicBezTo>
                      <a:pt x="206" y="175"/>
                      <a:pt x="209" y="179"/>
                      <a:pt x="209" y="183"/>
                    </a:cubicBezTo>
                    <a:cubicBezTo>
                      <a:pt x="210" y="188"/>
                      <a:pt x="206" y="191"/>
                      <a:pt x="202" y="191"/>
                    </a:cubicBezTo>
                    <a:lnTo>
                      <a:pt x="143" y="193"/>
                    </a:lnTo>
                    <a:lnTo>
                      <a:pt x="80" y="188"/>
                    </a:lnTo>
                    <a:lnTo>
                      <a:pt x="14" y="178"/>
                    </a:lnTo>
                    <a:lnTo>
                      <a:pt x="23" y="172"/>
                    </a:lnTo>
                    <a:lnTo>
                      <a:pt x="16" y="219"/>
                    </a:lnTo>
                    <a:close/>
                  </a:path>
                </a:pathLst>
              </a:custGeom>
              <a:solidFill>
                <a:srgbClr val="FFC000"/>
              </a:solidFill>
              <a:ln w="1588" cap="flat">
                <a:solidFill>
                  <a:srgbClr val="FFC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" name="Freeform 180">
                <a:extLst>
                  <a:ext uri="{FF2B5EF4-FFF2-40B4-BE49-F238E27FC236}">
                    <a16:creationId xmlns:a16="http://schemas.microsoft.com/office/drawing/2014/main" id="{BBC4475E-D23A-4AF2-BB5A-11ED828A797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81" y="2284"/>
                <a:ext cx="377" cy="253"/>
              </a:xfrm>
              <a:custGeom>
                <a:avLst/>
                <a:gdLst>
                  <a:gd name="T0" fmla="*/ 6 w 1936"/>
                  <a:gd name="T1" fmla="*/ 639 h 1424"/>
                  <a:gd name="T2" fmla="*/ 76 w 1936"/>
                  <a:gd name="T3" fmla="*/ 435 h 1424"/>
                  <a:gd name="T4" fmla="*/ 222 w 1936"/>
                  <a:gd name="T5" fmla="*/ 260 h 1424"/>
                  <a:gd name="T6" fmla="*/ 428 w 1936"/>
                  <a:gd name="T7" fmla="*/ 121 h 1424"/>
                  <a:gd name="T8" fmla="*/ 774 w 1936"/>
                  <a:gd name="T9" fmla="*/ 15 h 1424"/>
                  <a:gd name="T10" fmla="*/ 1067 w 1936"/>
                  <a:gd name="T11" fmla="*/ 4 h 1424"/>
                  <a:gd name="T12" fmla="*/ 1344 w 1936"/>
                  <a:gd name="T13" fmla="*/ 56 h 1424"/>
                  <a:gd name="T14" fmla="*/ 1652 w 1936"/>
                  <a:gd name="T15" fmla="*/ 209 h 1424"/>
                  <a:gd name="T16" fmla="*/ 1819 w 1936"/>
                  <a:gd name="T17" fmla="*/ 372 h 1424"/>
                  <a:gd name="T18" fmla="*/ 1917 w 1936"/>
                  <a:gd name="T19" fmla="*/ 568 h 1424"/>
                  <a:gd name="T20" fmla="*/ 1936 w 1936"/>
                  <a:gd name="T21" fmla="*/ 712 h 1424"/>
                  <a:gd name="T22" fmla="*/ 1917 w 1936"/>
                  <a:gd name="T23" fmla="*/ 857 h 1424"/>
                  <a:gd name="T24" fmla="*/ 1819 w 1936"/>
                  <a:gd name="T25" fmla="*/ 1053 h 1424"/>
                  <a:gd name="T26" fmla="*/ 1652 w 1936"/>
                  <a:gd name="T27" fmla="*/ 1217 h 1424"/>
                  <a:gd name="T28" fmla="*/ 1345 w 1936"/>
                  <a:gd name="T29" fmla="*/ 1369 h 1424"/>
                  <a:gd name="T30" fmla="*/ 1067 w 1936"/>
                  <a:gd name="T31" fmla="*/ 1420 h 1424"/>
                  <a:gd name="T32" fmla="*/ 775 w 1936"/>
                  <a:gd name="T33" fmla="*/ 1410 h 1424"/>
                  <a:gd name="T34" fmla="*/ 429 w 1936"/>
                  <a:gd name="T35" fmla="*/ 1304 h 1424"/>
                  <a:gd name="T36" fmla="*/ 222 w 1936"/>
                  <a:gd name="T37" fmla="*/ 1167 h 1424"/>
                  <a:gd name="T38" fmla="*/ 77 w 1936"/>
                  <a:gd name="T39" fmla="*/ 991 h 1424"/>
                  <a:gd name="T40" fmla="*/ 6 w 1936"/>
                  <a:gd name="T41" fmla="*/ 786 h 1424"/>
                  <a:gd name="T42" fmla="*/ 21 w 1936"/>
                  <a:gd name="T43" fmla="*/ 784 h 1424"/>
                  <a:gd name="T44" fmla="*/ 59 w 1936"/>
                  <a:gd name="T45" fmla="*/ 918 h 1424"/>
                  <a:gd name="T46" fmla="*/ 178 w 1936"/>
                  <a:gd name="T47" fmla="*/ 1101 h 1424"/>
                  <a:gd name="T48" fmla="*/ 361 w 1936"/>
                  <a:gd name="T49" fmla="*/ 1248 h 1424"/>
                  <a:gd name="T50" fmla="*/ 685 w 1936"/>
                  <a:gd name="T51" fmla="*/ 1377 h 1424"/>
                  <a:gd name="T52" fmla="*/ 968 w 1936"/>
                  <a:gd name="T53" fmla="*/ 1408 h 1424"/>
                  <a:gd name="T54" fmla="*/ 1252 w 1936"/>
                  <a:gd name="T55" fmla="*/ 1377 h 1424"/>
                  <a:gd name="T56" fmla="*/ 1575 w 1936"/>
                  <a:gd name="T57" fmla="*/ 1249 h 1424"/>
                  <a:gd name="T58" fmla="*/ 1758 w 1936"/>
                  <a:gd name="T59" fmla="*/ 1101 h 1424"/>
                  <a:gd name="T60" fmla="*/ 1878 w 1936"/>
                  <a:gd name="T61" fmla="*/ 919 h 1424"/>
                  <a:gd name="T62" fmla="*/ 1915 w 1936"/>
                  <a:gd name="T63" fmla="*/ 784 h 1424"/>
                  <a:gd name="T64" fmla="*/ 1902 w 1936"/>
                  <a:gd name="T65" fmla="*/ 572 h 1424"/>
                  <a:gd name="T66" fmla="*/ 1847 w 1936"/>
                  <a:gd name="T67" fmla="*/ 443 h 1424"/>
                  <a:gd name="T68" fmla="*/ 1704 w 1936"/>
                  <a:gd name="T69" fmla="*/ 272 h 1424"/>
                  <a:gd name="T70" fmla="*/ 1503 w 1936"/>
                  <a:gd name="T71" fmla="*/ 136 h 1424"/>
                  <a:gd name="T72" fmla="*/ 1162 w 1936"/>
                  <a:gd name="T73" fmla="*/ 30 h 1424"/>
                  <a:gd name="T74" fmla="*/ 871 w 1936"/>
                  <a:gd name="T75" fmla="*/ 20 h 1424"/>
                  <a:gd name="T76" fmla="*/ 597 w 1936"/>
                  <a:gd name="T77" fmla="*/ 71 h 1424"/>
                  <a:gd name="T78" fmla="*/ 294 w 1936"/>
                  <a:gd name="T79" fmla="*/ 222 h 1424"/>
                  <a:gd name="T80" fmla="*/ 131 w 1936"/>
                  <a:gd name="T81" fmla="*/ 382 h 1424"/>
                  <a:gd name="T82" fmla="*/ 36 w 1936"/>
                  <a:gd name="T83" fmla="*/ 572 h 1424"/>
                  <a:gd name="T84" fmla="*/ 16 w 1936"/>
                  <a:gd name="T85" fmla="*/ 712 h 14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</a:cxnLst>
                <a:rect l="0" t="0" r="r" b="b"/>
                <a:pathLst>
                  <a:path w="1936" h="1424">
                    <a:moveTo>
                      <a:pt x="0" y="713"/>
                    </a:moveTo>
                    <a:lnTo>
                      <a:pt x="5" y="640"/>
                    </a:lnTo>
                    <a:cubicBezTo>
                      <a:pt x="6" y="640"/>
                      <a:pt x="6" y="639"/>
                      <a:pt x="6" y="639"/>
                    </a:cubicBezTo>
                    <a:lnTo>
                      <a:pt x="21" y="569"/>
                    </a:lnTo>
                    <a:lnTo>
                      <a:pt x="44" y="501"/>
                    </a:lnTo>
                    <a:lnTo>
                      <a:pt x="76" y="435"/>
                    </a:lnTo>
                    <a:lnTo>
                      <a:pt x="118" y="373"/>
                    </a:lnTo>
                    <a:lnTo>
                      <a:pt x="166" y="314"/>
                    </a:lnTo>
                    <a:lnTo>
                      <a:pt x="222" y="260"/>
                    </a:lnTo>
                    <a:lnTo>
                      <a:pt x="284" y="209"/>
                    </a:lnTo>
                    <a:lnTo>
                      <a:pt x="353" y="163"/>
                    </a:lnTo>
                    <a:lnTo>
                      <a:pt x="428" y="121"/>
                    </a:lnTo>
                    <a:lnTo>
                      <a:pt x="592" y="56"/>
                    </a:lnTo>
                    <a:lnTo>
                      <a:pt x="681" y="33"/>
                    </a:lnTo>
                    <a:lnTo>
                      <a:pt x="774" y="15"/>
                    </a:lnTo>
                    <a:lnTo>
                      <a:pt x="870" y="5"/>
                    </a:lnTo>
                    <a:lnTo>
                      <a:pt x="968" y="0"/>
                    </a:lnTo>
                    <a:lnTo>
                      <a:pt x="1067" y="4"/>
                    </a:lnTo>
                    <a:lnTo>
                      <a:pt x="1163" y="15"/>
                    </a:lnTo>
                    <a:lnTo>
                      <a:pt x="1256" y="33"/>
                    </a:lnTo>
                    <a:lnTo>
                      <a:pt x="1344" y="56"/>
                    </a:lnTo>
                    <a:lnTo>
                      <a:pt x="1508" y="121"/>
                    </a:lnTo>
                    <a:lnTo>
                      <a:pt x="1583" y="162"/>
                    </a:lnTo>
                    <a:lnTo>
                      <a:pt x="1652" y="209"/>
                    </a:lnTo>
                    <a:lnTo>
                      <a:pt x="1714" y="259"/>
                    </a:lnTo>
                    <a:lnTo>
                      <a:pt x="1770" y="314"/>
                    </a:lnTo>
                    <a:lnTo>
                      <a:pt x="1819" y="372"/>
                    </a:lnTo>
                    <a:lnTo>
                      <a:pt x="1860" y="434"/>
                    </a:lnTo>
                    <a:lnTo>
                      <a:pt x="1893" y="500"/>
                    </a:lnTo>
                    <a:lnTo>
                      <a:pt x="1917" y="568"/>
                    </a:lnTo>
                    <a:cubicBezTo>
                      <a:pt x="1917" y="568"/>
                      <a:pt x="1917" y="569"/>
                      <a:pt x="1917" y="569"/>
                    </a:cubicBezTo>
                    <a:lnTo>
                      <a:pt x="1931" y="639"/>
                    </a:lnTo>
                    <a:lnTo>
                      <a:pt x="1936" y="712"/>
                    </a:lnTo>
                    <a:lnTo>
                      <a:pt x="1931" y="785"/>
                    </a:lnTo>
                    <a:lnTo>
                      <a:pt x="1917" y="856"/>
                    </a:lnTo>
                    <a:cubicBezTo>
                      <a:pt x="1917" y="856"/>
                      <a:pt x="1917" y="857"/>
                      <a:pt x="1917" y="857"/>
                    </a:cubicBezTo>
                    <a:lnTo>
                      <a:pt x="1893" y="924"/>
                    </a:lnTo>
                    <a:lnTo>
                      <a:pt x="1861" y="990"/>
                    </a:lnTo>
                    <a:lnTo>
                      <a:pt x="1819" y="1053"/>
                    </a:lnTo>
                    <a:lnTo>
                      <a:pt x="1771" y="1112"/>
                    </a:lnTo>
                    <a:lnTo>
                      <a:pt x="1715" y="1166"/>
                    </a:lnTo>
                    <a:lnTo>
                      <a:pt x="1652" y="1217"/>
                    </a:lnTo>
                    <a:lnTo>
                      <a:pt x="1584" y="1262"/>
                    </a:lnTo>
                    <a:lnTo>
                      <a:pt x="1509" y="1303"/>
                    </a:lnTo>
                    <a:lnTo>
                      <a:pt x="1345" y="1369"/>
                    </a:lnTo>
                    <a:lnTo>
                      <a:pt x="1256" y="1392"/>
                    </a:lnTo>
                    <a:lnTo>
                      <a:pt x="1164" y="1410"/>
                    </a:lnTo>
                    <a:lnTo>
                      <a:pt x="1067" y="1420"/>
                    </a:lnTo>
                    <a:lnTo>
                      <a:pt x="969" y="1424"/>
                    </a:lnTo>
                    <a:lnTo>
                      <a:pt x="870" y="1420"/>
                    </a:lnTo>
                    <a:lnTo>
                      <a:pt x="775" y="1410"/>
                    </a:lnTo>
                    <a:lnTo>
                      <a:pt x="682" y="1392"/>
                    </a:lnTo>
                    <a:lnTo>
                      <a:pt x="592" y="1369"/>
                    </a:lnTo>
                    <a:lnTo>
                      <a:pt x="429" y="1304"/>
                    </a:lnTo>
                    <a:lnTo>
                      <a:pt x="354" y="1262"/>
                    </a:lnTo>
                    <a:lnTo>
                      <a:pt x="285" y="1217"/>
                    </a:lnTo>
                    <a:lnTo>
                      <a:pt x="222" y="1167"/>
                    </a:lnTo>
                    <a:lnTo>
                      <a:pt x="167" y="1112"/>
                    </a:lnTo>
                    <a:lnTo>
                      <a:pt x="118" y="1054"/>
                    </a:lnTo>
                    <a:lnTo>
                      <a:pt x="77" y="991"/>
                    </a:lnTo>
                    <a:lnTo>
                      <a:pt x="44" y="925"/>
                    </a:lnTo>
                    <a:lnTo>
                      <a:pt x="21" y="857"/>
                    </a:lnTo>
                    <a:lnTo>
                      <a:pt x="6" y="786"/>
                    </a:lnTo>
                    <a:cubicBezTo>
                      <a:pt x="6" y="786"/>
                      <a:pt x="6" y="785"/>
                      <a:pt x="5" y="785"/>
                    </a:cubicBezTo>
                    <a:lnTo>
                      <a:pt x="0" y="713"/>
                    </a:lnTo>
                    <a:close/>
                    <a:moveTo>
                      <a:pt x="21" y="784"/>
                    </a:moveTo>
                    <a:lnTo>
                      <a:pt x="21" y="783"/>
                    </a:lnTo>
                    <a:lnTo>
                      <a:pt x="36" y="852"/>
                    </a:lnTo>
                    <a:lnTo>
                      <a:pt x="59" y="918"/>
                    </a:lnTo>
                    <a:lnTo>
                      <a:pt x="90" y="982"/>
                    </a:lnTo>
                    <a:lnTo>
                      <a:pt x="131" y="1043"/>
                    </a:lnTo>
                    <a:lnTo>
                      <a:pt x="178" y="1101"/>
                    </a:lnTo>
                    <a:lnTo>
                      <a:pt x="232" y="1154"/>
                    </a:lnTo>
                    <a:lnTo>
                      <a:pt x="294" y="1204"/>
                    </a:lnTo>
                    <a:lnTo>
                      <a:pt x="361" y="1248"/>
                    </a:lnTo>
                    <a:lnTo>
                      <a:pt x="434" y="1289"/>
                    </a:lnTo>
                    <a:lnTo>
                      <a:pt x="596" y="1354"/>
                    </a:lnTo>
                    <a:lnTo>
                      <a:pt x="685" y="1377"/>
                    </a:lnTo>
                    <a:lnTo>
                      <a:pt x="776" y="1395"/>
                    </a:lnTo>
                    <a:lnTo>
                      <a:pt x="871" y="1404"/>
                    </a:lnTo>
                    <a:lnTo>
                      <a:pt x="968" y="1408"/>
                    </a:lnTo>
                    <a:lnTo>
                      <a:pt x="1066" y="1405"/>
                    </a:lnTo>
                    <a:lnTo>
                      <a:pt x="1161" y="1395"/>
                    </a:lnTo>
                    <a:lnTo>
                      <a:pt x="1252" y="1377"/>
                    </a:lnTo>
                    <a:lnTo>
                      <a:pt x="1340" y="1354"/>
                    </a:lnTo>
                    <a:lnTo>
                      <a:pt x="1502" y="1289"/>
                    </a:lnTo>
                    <a:lnTo>
                      <a:pt x="1575" y="1249"/>
                    </a:lnTo>
                    <a:lnTo>
                      <a:pt x="1642" y="1204"/>
                    </a:lnTo>
                    <a:lnTo>
                      <a:pt x="1704" y="1155"/>
                    </a:lnTo>
                    <a:lnTo>
                      <a:pt x="1758" y="1101"/>
                    </a:lnTo>
                    <a:lnTo>
                      <a:pt x="1806" y="1044"/>
                    </a:lnTo>
                    <a:lnTo>
                      <a:pt x="1846" y="983"/>
                    </a:lnTo>
                    <a:lnTo>
                      <a:pt x="1878" y="919"/>
                    </a:lnTo>
                    <a:lnTo>
                      <a:pt x="1902" y="852"/>
                    </a:lnTo>
                    <a:lnTo>
                      <a:pt x="1902" y="853"/>
                    </a:lnTo>
                    <a:lnTo>
                      <a:pt x="1915" y="784"/>
                    </a:lnTo>
                    <a:lnTo>
                      <a:pt x="1920" y="713"/>
                    </a:lnTo>
                    <a:lnTo>
                      <a:pt x="1916" y="642"/>
                    </a:lnTo>
                    <a:lnTo>
                      <a:pt x="1902" y="572"/>
                    </a:lnTo>
                    <a:lnTo>
                      <a:pt x="1902" y="573"/>
                    </a:lnTo>
                    <a:lnTo>
                      <a:pt x="1878" y="507"/>
                    </a:lnTo>
                    <a:lnTo>
                      <a:pt x="1847" y="443"/>
                    </a:lnTo>
                    <a:lnTo>
                      <a:pt x="1806" y="383"/>
                    </a:lnTo>
                    <a:lnTo>
                      <a:pt x="1759" y="325"/>
                    </a:lnTo>
                    <a:lnTo>
                      <a:pt x="1704" y="272"/>
                    </a:lnTo>
                    <a:lnTo>
                      <a:pt x="1643" y="222"/>
                    </a:lnTo>
                    <a:lnTo>
                      <a:pt x="1576" y="176"/>
                    </a:lnTo>
                    <a:lnTo>
                      <a:pt x="1503" y="136"/>
                    </a:lnTo>
                    <a:lnTo>
                      <a:pt x="1340" y="71"/>
                    </a:lnTo>
                    <a:lnTo>
                      <a:pt x="1253" y="48"/>
                    </a:lnTo>
                    <a:lnTo>
                      <a:pt x="1162" y="30"/>
                    </a:lnTo>
                    <a:lnTo>
                      <a:pt x="1066" y="20"/>
                    </a:lnTo>
                    <a:lnTo>
                      <a:pt x="969" y="16"/>
                    </a:lnTo>
                    <a:lnTo>
                      <a:pt x="871" y="20"/>
                    </a:lnTo>
                    <a:lnTo>
                      <a:pt x="777" y="30"/>
                    </a:lnTo>
                    <a:lnTo>
                      <a:pt x="685" y="48"/>
                    </a:lnTo>
                    <a:lnTo>
                      <a:pt x="597" y="71"/>
                    </a:lnTo>
                    <a:lnTo>
                      <a:pt x="435" y="135"/>
                    </a:lnTo>
                    <a:lnTo>
                      <a:pt x="362" y="176"/>
                    </a:lnTo>
                    <a:lnTo>
                      <a:pt x="294" y="222"/>
                    </a:lnTo>
                    <a:lnTo>
                      <a:pt x="233" y="271"/>
                    </a:lnTo>
                    <a:lnTo>
                      <a:pt x="179" y="325"/>
                    </a:lnTo>
                    <a:lnTo>
                      <a:pt x="131" y="382"/>
                    </a:lnTo>
                    <a:lnTo>
                      <a:pt x="91" y="442"/>
                    </a:lnTo>
                    <a:lnTo>
                      <a:pt x="59" y="506"/>
                    </a:lnTo>
                    <a:lnTo>
                      <a:pt x="36" y="572"/>
                    </a:lnTo>
                    <a:lnTo>
                      <a:pt x="21" y="642"/>
                    </a:lnTo>
                    <a:lnTo>
                      <a:pt x="21" y="641"/>
                    </a:lnTo>
                    <a:lnTo>
                      <a:pt x="16" y="712"/>
                    </a:lnTo>
                    <a:lnTo>
                      <a:pt x="21" y="78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" name="Freeform 181">
                <a:extLst>
                  <a:ext uri="{FF2B5EF4-FFF2-40B4-BE49-F238E27FC236}">
                    <a16:creationId xmlns:a16="http://schemas.microsoft.com/office/drawing/2014/main" id="{C6C01091-6562-4423-A7FC-8D141D3318A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34" y="2392"/>
                <a:ext cx="102" cy="82"/>
              </a:xfrm>
              <a:custGeom>
                <a:avLst/>
                <a:gdLst>
                  <a:gd name="T0" fmla="*/ 457 w 524"/>
                  <a:gd name="T1" fmla="*/ 75 h 460"/>
                  <a:gd name="T2" fmla="*/ 342 w 524"/>
                  <a:gd name="T3" fmla="*/ 147 h 460"/>
                  <a:gd name="T4" fmla="*/ 302 w 524"/>
                  <a:gd name="T5" fmla="*/ 190 h 460"/>
                  <a:gd name="T6" fmla="*/ 291 w 524"/>
                  <a:gd name="T7" fmla="*/ 212 h 460"/>
                  <a:gd name="T8" fmla="*/ 283 w 524"/>
                  <a:gd name="T9" fmla="*/ 238 h 460"/>
                  <a:gd name="T10" fmla="*/ 275 w 524"/>
                  <a:gd name="T11" fmla="*/ 301 h 460"/>
                  <a:gd name="T12" fmla="*/ 268 w 524"/>
                  <a:gd name="T13" fmla="*/ 365 h 460"/>
                  <a:gd name="T14" fmla="*/ 259 w 524"/>
                  <a:gd name="T15" fmla="*/ 394 h 460"/>
                  <a:gd name="T16" fmla="*/ 244 w 524"/>
                  <a:gd name="T17" fmla="*/ 420 h 460"/>
                  <a:gd name="T18" fmla="*/ 219 w 524"/>
                  <a:gd name="T19" fmla="*/ 439 h 460"/>
                  <a:gd name="T20" fmla="*/ 190 w 524"/>
                  <a:gd name="T21" fmla="*/ 451 h 460"/>
                  <a:gd name="T22" fmla="*/ 159 w 524"/>
                  <a:gd name="T23" fmla="*/ 457 h 460"/>
                  <a:gd name="T24" fmla="*/ 74 w 524"/>
                  <a:gd name="T25" fmla="*/ 459 h 460"/>
                  <a:gd name="T26" fmla="*/ 39 w 524"/>
                  <a:gd name="T27" fmla="*/ 458 h 460"/>
                  <a:gd name="T28" fmla="*/ 2 w 524"/>
                  <a:gd name="T29" fmla="*/ 438 h 460"/>
                  <a:gd name="T30" fmla="*/ 19 w 524"/>
                  <a:gd name="T31" fmla="*/ 411 h 460"/>
                  <a:gd name="T32" fmla="*/ 43 w 524"/>
                  <a:gd name="T33" fmla="*/ 405 h 460"/>
                  <a:gd name="T34" fmla="*/ 40 w 524"/>
                  <a:gd name="T35" fmla="*/ 455 h 460"/>
                  <a:gd name="T36" fmla="*/ 49 w 524"/>
                  <a:gd name="T37" fmla="*/ 431 h 460"/>
                  <a:gd name="T38" fmla="*/ 23 w 524"/>
                  <a:gd name="T39" fmla="*/ 412 h 460"/>
                  <a:gd name="T40" fmla="*/ 54 w 524"/>
                  <a:gd name="T41" fmla="*/ 410 h 460"/>
                  <a:gd name="T42" fmla="*/ 125 w 524"/>
                  <a:gd name="T43" fmla="*/ 412 h 460"/>
                  <a:gd name="T44" fmla="*/ 177 w 524"/>
                  <a:gd name="T45" fmla="*/ 406 h 460"/>
                  <a:gd name="T46" fmla="*/ 197 w 524"/>
                  <a:gd name="T47" fmla="*/ 398 h 460"/>
                  <a:gd name="T48" fmla="*/ 210 w 524"/>
                  <a:gd name="T49" fmla="*/ 388 h 460"/>
                  <a:gd name="T50" fmla="*/ 216 w 524"/>
                  <a:gd name="T51" fmla="*/ 374 h 460"/>
                  <a:gd name="T52" fmla="*/ 222 w 524"/>
                  <a:gd name="T53" fmla="*/ 355 h 460"/>
                  <a:gd name="T54" fmla="*/ 225 w 524"/>
                  <a:gd name="T55" fmla="*/ 329 h 460"/>
                  <a:gd name="T56" fmla="*/ 237 w 524"/>
                  <a:gd name="T57" fmla="*/ 228 h 460"/>
                  <a:gd name="T58" fmla="*/ 248 w 524"/>
                  <a:gd name="T59" fmla="*/ 194 h 460"/>
                  <a:gd name="T60" fmla="*/ 264 w 524"/>
                  <a:gd name="T61" fmla="*/ 162 h 460"/>
                  <a:gd name="T62" fmla="*/ 311 w 524"/>
                  <a:gd name="T63" fmla="*/ 112 h 460"/>
                  <a:gd name="T64" fmla="*/ 372 w 524"/>
                  <a:gd name="T65" fmla="*/ 69 h 460"/>
                  <a:gd name="T66" fmla="*/ 503 w 524"/>
                  <a:gd name="T67" fmla="*/ 0 h 4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</a:cxnLst>
                <a:rect l="0" t="0" r="r" b="b"/>
                <a:pathLst>
                  <a:path w="524" h="460">
                    <a:moveTo>
                      <a:pt x="524" y="42"/>
                    </a:moveTo>
                    <a:lnTo>
                      <a:pt x="457" y="75"/>
                    </a:lnTo>
                    <a:lnTo>
                      <a:pt x="395" y="110"/>
                    </a:lnTo>
                    <a:lnTo>
                      <a:pt x="342" y="147"/>
                    </a:lnTo>
                    <a:lnTo>
                      <a:pt x="345" y="145"/>
                    </a:lnTo>
                    <a:lnTo>
                      <a:pt x="302" y="190"/>
                    </a:lnTo>
                    <a:lnTo>
                      <a:pt x="305" y="185"/>
                    </a:lnTo>
                    <a:lnTo>
                      <a:pt x="291" y="212"/>
                    </a:lnTo>
                    <a:lnTo>
                      <a:pt x="293" y="207"/>
                    </a:lnTo>
                    <a:lnTo>
                      <a:pt x="283" y="238"/>
                    </a:lnTo>
                    <a:lnTo>
                      <a:pt x="284" y="235"/>
                    </a:lnTo>
                    <a:lnTo>
                      <a:pt x="275" y="301"/>
                    </a:lnTo>
                    <a:lnTo>
                      <a:pt x="272" y="333"/>
                    </a:lnTo>
                    <a:lnTo>
                      <a:pt x="268" y="365"/>
                    </a:lnTo>
                    <a:cubicBezTo>
                      <a:pt x="267" y="366"/>
                      <a:pt x="267" y="367"/>
                      <a:pt x="267" y="368"/>
                    </a:cubicBezTo>
                    <a:lnTo>
                      <a:pt x="259" y="394"/>
                    </a:lnTo>
                    <a:cubicBezTo>
                      <a:pt x="259" y="396"/>
                      <a:pt x="258" y="398"/>
                      <a:pt x="257" y="400"/>
                    </a:cubicBezTo>
                    <a:lnTo>
                      <a:pt x="244" y="420"/>
                    </a:lnTo>
                    <a:cubicBezTo>
                      <a:pt x="242" y="422"/>
                      <a:pt x="240" y="424"/>
                      <a:pt x="237" y="426"/>
                    </a:cubicBezTo>
                    <a:lnTo>
                      <a:pt x="219" y="439"/>
                    </a:lnTo>
                    <a:cubicBezTo>
                      <a:pt x="218" y="441"/>
                      <a:pt x="216" y="442"/>
                      <a:pt x="214" y="443"/>
                    </a:cubicBezTo>
                    <a:lnTo>
                      <a:pt x="190" y="451"/>
                    </a:lnTo>
                    <a:cubicBezTo>
                      <a:pt x="188" y="452"/>
                      <a:pt x="187" y="452"/>
                      <a:pt x="186" y="452"/>
                    </a:cubicBezTo>
                    <a:lnTo>
                      <a:pt x="159" y="457"/>
                    </a:lnTo>
                    <a:lnTo>
                      <a:pt x="129" y="460"/>
                    </a:lnTo>
                    <a:lnTo>
                      <a:pt x="74" y="459"/>
                    </a:lnTo>
                    <a:lnTo>
                      <a:pt x="53" y="458"/>
                    </a:lnTo>
                    <a:lnTo>
                      <a:pt x="39" y="458"/>
                    </a:lnTo>
                    <a:lnTo>
                      <a:pt x="27" y="459"/>
                    </a:lnTo>
                    <a:cubicBezTo>
                      <a:pt x="14" y="460"/>
                      <a:pt x="3" y="451"/>
                      <a:pt x="2" y="438"/>
                    </a:cubicBezTo>
                    <a:lnTo>
                      <a:pt x="2" y="437"/>
                    </a:lnTo>
                    <a:cubicBezTo>
                      <a:pt x="0" y="425"/>
                      <a:pt x="7" y="414"/>
                      <a:pt x="19" y="411"/>
                    </a:cubicBezTo>
                    <a:lnTo>
                      <a:pt x="28" y="408"/>
                    </a:lnTo>
                    <a:lnTo>
                      <a:pt x="43" y="405"/>
                    </a:lnTo>
                    <a:lnTo>
                      <a:pt x="53" y="451"/>
                    </a:lnTo>
                    <a:lnTo>
                      <a:pt x="40" y="455"/>
                    </a:lnTo>
                    <a:lnTo>
                      <a:pt x="31" y="457"/>
                    </a:lnTo>
                    <a:lnTo>
                      <a:pt x="49" y="431"/>
                    </a:lnTo>
                    <a:lnTo>
                      <a:pt x="49" y="433"/>
                    </a:lnTo>
                    <a:lnTo>
                      <a:pt x="23" y="412"/>
                    </a:lnTo>
                    <a:lnTo>
                      <a:pt x="39" y="411"/>
                    </a:lnTo>
                    <a:lnTo>
                      <a:pt x="54" y="410"/>
                    </a:lnTo>
                    <a:lnTo>
                      <a:pt x="75" y="411"/>
                    </a:lnTo>
                    <a:lnTo>
                      <a:pt x="125" y="412"/>
                    </a:lnTo>
                    <a:lnTo>
                      <a:pt x="150" y="410"/>
                    </a:lnTo>
                    <a:lnTo>
                      <a:pt x="177" y="406"/>
                    </a:lnTo>
                    <a:lnTo>
                      <a:pt x="173" y="406"/>
                    </a:lnTo>
                    <a:lnTo>
                      <a:pt x="197" y="398"/>
                    </a:lnTo>
                    <a:lnTo>
                      <a:pt x="191" y="401"/>
                    </a:lnTo>
                    <a:lnTo>
                      <a:pt x="210" y="388"/>
                    </a:lnTo>
                    <a:lnTo>
                      <a:pt x="204" y="394"/>
                    </a:lnTo>
                    <a:lnTo>
                      <a:pt x="216" y="374"/>
                    </a:lnTo>
                    <a:lnTo>
                      <a:pt x="214" y="380"/>
                    </a:lnTo>
                    <a:lnTo>
                      <a:pt x="222" y="355"/>
                    </a:lnTo>
                    <a:lnTo>
                      <a:pt x="221" y="358"/>
                    </a:lnTo>
                    <a:lnTo>
                      <a:pt x="225" y="329"/>
                    </a:lnTo>
                    <a:lnTo>
                      <a:pt x="228" y="295"/>
                    </a:lnTo>
                    <a:lnTo>
                      <a:pt x="237" y="228"/>
                    </a:lnTo>
                    <a:cubicBezTo>
                      <a:pt x="238" y="227"/>
                      <a:pt x="238" y="226"/>
                      <a:pt x="238" y="225"/>
                    </a:cubicBezTo>
                    <a:lnTo>
                      <a:pt x="248" y="194"/>
                    </a:lnTo>
                    <a:cubicBezTo>
                      <a:pt x="248" y="191"/>
                      <a:pt x="249" y="190"/>
                      <a:pt x="250" y="189"/>
                    </a:cubicBezTo>
                    <a:lnTo>
                      <a:pt x="264" y="162"/>
                    </a:lnTo>
                    <a:cubicBezTo>
                      <a:pt x="265" y="161"/>
                      <a:pt x="266" y="159"/>
                      <a:pt x="268" y="157"/>
                    </a:cubicBezTo>
                    <a:lnTo>
                      <a:pt x="311" y="112"/>
                    </a:lnTo>
                    <a:cubicBezTo>
                      <a:pt x="313" y="111"/>
                      <a:pt x="313" y="111"/>
                      <a:pt x="314" y="109"/>
                    </a:cubicBezTo>
                    <a:lnTo>
                      <a:pt x="372" y="69"/>
                    </a:lnTo>
                    <a:lnTo>
                      <a:pt x="437" y="33"/>
                    </a:lnTo>
                    <a:lnTo>
                      <a:pt x="503" y="0"/>
                    </a:lnTo>
                    <a:lnTo>
                      <a:pt x="524" y="42"/>
                    </a:lnTo>
                    <a:close/>
                  </a:path>
                </a:pathLst>
              </a:custGeom>
              <a:solidFill>
                <a:srgbClr val="4F6228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" name="Freeform 182">
                <a:extLst>
                  <a:ext uri="{FF2B5EF4-FFF2-40B4-BE49-F238E27FC236}">
                    <a16:creationId xmlns:a16="http://schemas.microsoft.com/office/drawing/2014/main" id="{E7F12C69-98CD-428F-B8A7-3A11BD514FE1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933" y="2390"/>
                <a:ext cx="105" cy="85"/>
              </a:xfrm>
              <a:custGeom>
                <a:avLst/>
                <a:gdLst>
                  <a:gd name="T0" fmla="*/ 467 w 539"/>
                  <a:gd name="T1" fmla="*/ 92 h 477"/>
                  <a:gd name="T2" fmla="*/ 347 w 539"/>
                  <a:gd name="T3" fmla="*/ 148 h 477"/>
                  <a:gd name="T4" fmla="*/ 304 w 539"/>
                  <a:gd name="T5" fmla="*/ 206 h 477"/>
                  <a:gd name="T6" fmla="*/ 319 w 539"/>
                  <a:gd name="T7" fmla="*/ 198 h 477"/>
                  <a:gd name="T8" fmla="*/ 292 w 539"/>
                  <a:gd name="T9" fmla="*/ 213 h 477"/>
                  <a:gd name="T10" fmla="*/ 282 w 539"/>
                  <a:gd name="T11" fmla="*/ 245 h 477"/>
                  <a:gd name="T12" fmla="*/ 289 w 539"/>
                  <a:gd name="T13" fmla="*/ 312 h 477"/>
                  <a:gd name="T14" fmla="*/ 281 w 539"/>
                  <a:gd name="T15" fmla="*/ 380 h 477"/>
                  <a:gd name="T16" fmla="*/ 257 w 539"/>
                  <a:gd name="T17" fmla="*/ 434 h 477"/>
                  <a:gd name="T18" fmla="*/ 225 w 539"/>
                  <a:gd name="T19" fmla="*/ 459 h 477"/>
                  <a:gd name="T20" fmla="*/ 167 w 539"/>
                  <a:gd name="T21" fmla="*/ 474 h 477"/>
                  <a:gd name="T22" fmla="*/ 45 w 539"/>
                  <a:gd name="T23" fmla="*/ 475 h 477"/>
                  <a:gd name="T24" fmla="*/ 9 w 539"/>
                  <a:gd name="T25" fmla="*/ 467 h 477"/>
                  <a:gd name="T26" fmla="*/ 1 w 539"/>
                  <a:gd name="T27" fmla="*/ 445 h 477"/>
                  <a:gd name="T28" fmla="*/ 23 w 539"/>
                  <a:gd name="T29" fmla="*/ 413 h 477"/>
                  <a:gd name="T30" fmla="*/ 67 w 539"/>
                  <a:gd name="T31" fmla="*/ 459 h 477"/>
                  <a:gd name="T32" fmla="*/ 31 w 539"/>
                  <a:gd name="T33" fmla="*/ 471 h 477"/>
                  <a:gd name="T34" fmla="*/ 63 w 539"/>
                  <a:gd name="T35" fmla="*/ 440 h 477"/>
                  <a:gd name="T36" fmla="*/ 24 w 539"/>
                  <a:gd name="T37" fmla="*/ 428 h 477"/>
                  <a:gd name="T38" fmla="*/ 60 w 539"/>
                  <a:gd name="T39" fmla="*/ 411 h 477"/>
                  <a:gd name="T40" fmla="*/ 182 w 539"/>
                  <a:gd name="T41" fmla="*/ 408 h 477"/>
                  <a:gd name="T42" fmla="*/ 177 w 539"/>
                  <a:gd name="T43" fmla="*/ 408 h 477"/>
                  <a:gd name="T44" fmla="*/ 201 w 539"/>
                  <a:gd name="T45" fmla="*/ 418 h 477"/>
                  <a:gd name="T46" fmla="*/ 223 w 539"/>
                  <a:gd name="T47" fmla="*/ 392 h 477"/>
                  <a:gd name="T48" fmla="*/ 204 w 539"/>
                  <a:gd name="T49" fmla="*/ 399 h 477"/>
                  <a:gd name="T50" fmla="*/ 228 w 539"/>
                  <a:gd name="T51" fmla="*/ 392 h 477"/>
                  <a:gd name="T52" fmla="*/ 236 w 539"/>
                  <a:gd name="T53" fmla="*/ 367 h 477"/>
                  <a:gd name="T54" fmla="*/ 224 w 539"/>
                  <a:gd name="T55" fmla="*/ 337 h 477"/>
                  <a:gd name="T56" fmla="*/ 237 w 539"/>
                  <a:gd name="T57" fmla="*/ 232 h 477"/>
                  <a:gd name="T58" fmla="*/ 264 w 539"/>
                  <a:gd name="T59" fmla="*/ 166 h 477"/>
                  <a:gd name="T60" fmla="*/ 316 w 539"/>
                  <a:gd name="T61" fmla="*/ 112 h 477"/>
                  <a:gd name="T62" fmla="*/ 517 w 539"/>
                  <a:gd name="T63" fmla="*/ 6 h 477"/>
                  <a:gd name="T64" fmla="*/ 447 w 539"/>
                  <a:gd name="T65" fmla="*/ 49 h 477"/>
                  <a:gd name="T66" fmla="*/ 323 w 539"/>
                  <a:gd name="T67" fmla="*/ 127 h 477"/>
                  <a:gd name="T68" fmla="*/ 264 w 539"/>
                  <a:gd name="T69" fmla="*/ 201 h 477"/>
                  <a:gd name="T70" fmla="*/ 251 w 539"/>
                  <a:gd name="T71" fmla="*/ 239 h 477"/>
                  <a:gd name="T72" fmla="*/ 220 w 539"/>
                  <a:gd name="T73" fmla="*/ 365 h 477"/>
                  <a:gd name="T74" fmla="*/ 228 w 539"/>
                  <a:gd name="T75" fmla="*/ 392 h 477"/>
                  <a:gd name="T76" fmla="*/ 217 w 539"/>
                  <a:gd name="T77" fmla="*/ 408 h 477"/>
                  <a:gd name="T78" fmla="*/ 202 w 539"/>
                  <a:gd name="T79" fmla="*/ 417 h 477"/>
                  <a:gd name="T80" fmla="*/ 182 w 539"/>
                  <a:gd name="T81" fmla="*/ 423 h 477"/>
                  <a:gd name="T82" fmla="*/ 185 w 539"/>
                  <a:gd name="T83" fmla="*/ 423 h 477"/>
                  <a:gd name="T84" fmla="*/ 61 w 539"/>
                  <a:gd name="T85" fmla="*/ 427 h 477"/>
                  <a:gd name="T86" fmla="*/ 60 w 539"/>
                  <a:gd name="T87" fmla="*/ 436 h 477"/>
                  <a:gd name="T88" fmla="*/ 44 w 539"/>
                  <a:gd name="T89" fmla="*/ 471 h 477"/>
                  <a:gd name="T90" fmla="*/ 52 w 539"/>
                  <a:gd name="T91" fmla="*/ 462 h 477"/>
                  <a:gd name="T92" fmla="*/ 28 w 539"/>
                  <a:gd name="T93" fmla="*/ 428 h 477"/>
                  <a:gd name="T94" fmla="*/ 16 w 539"/>
                  <a:gd name="T95" fmla="*/ 448 h 477"/>
                  <a:gd name="T96" fmla="*/ 24 w 539"/>
                  <a:gd name="T97" fmla="*/ 460 h 477"/>
                  <a:gd name="T98" fmla="*/ 45 w 539"/>
                  <a:gd name="T99" fmla="*/ 459 h 477"/>
                  <a:gd name="T100" fmla="*/ 164 w 539"/>
                  <a:gd name="T101" fmla="*/ 459 h 477"/>
                  <a:gd name="T102" fmla="*/ 215 w 539"/>
                  <a:gd name="T103" fmla="*/ 446 h 477"/>
                  <a:gd name="T104" fmla="*/ 244 w 539"/>
                  <a:gd name="T105" fmla="*/ 425 h 477"/>
                  <a:gd name="T106" fmla="*/ 266 w 539"/>
                  <a:gd name="T107" fmla="*/ 375 h 477"/>
                  <a:gd name="T108" fmla="*/ 274 w 539"/>
                  <a:gd name="T109" fmla="*/ 309 h 477"/>
                  <a:gd name="T110" fmla="*/ 287 w 539"/>
                  <a:gd name="T111" fmla="*/ 255 h 477"/>
                  <a:gd name="T112" fmla="*/ 305 w 539"/>
                  <a:gd name="T113" fmla="*/ 224 h 477"/>
                  <a:gd name="T114" fmla="*/ 315 w 539"/>
                  <a:gd name="T115" fmla="*/ 204 h 477"/>
                  <a:gd name="T116" fmla="*/ 353 w 539"/>
                  <a:gd name="T117" fmla="*/ 163 h 477"/>
                  <a:gd name="T118" fmla="*/ 460 w 539"/>
                  <a:gd name="T119" fmla="*/ 77 h 4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</a:cxnLst>
                <a:rect l="0" t="0" r="r" b="b"/>
                <a:pathLst>
                  <a:path w="539" h="477">
                    <a:moveTo>
                      <a:pt x="538" y="48"/>
                    </a:moveTo>
                    <a:cubicBezTo>
                      <a:pt x="539" y="50"/>
                      <a:pt x="539" y="52"/>
                      <a:pt x="538" y="54"/>
                    </a:cubicBezTo>
                    <a:cubicBezTo>
                      <a:pt x="537" y="56"/>
                      <a:pt x="536" y="58"/>
                      <a:pt x="534" y="59"/>
                    </a:cubicBezTo>
                    <a:lnTo>
                      <a:pt x="467" y="92"/>
                    </a:lnTo>
                    <a:lnTo>
                      <a:pt x="405" y="126"/>
                    </a:lnTo>
                    <a:lnTo>
                      <a:pt x="353" y="163"/>
                    </a:lnTo>
                    <a:lnTo>
                      <a:pt x="344" y="150"/>
                    </a:lnTo>
                    <a:lnTo>
                      <a:pt x="347" y="148"/>
                    </a:lnTo>
                    <a:cubicBezTo>
                      <a:pt x="350" y="146"/>
                      <a:pt x="355" y="146"/>
                      <a:pt x="358" y="149"/>
                    </a:cubicBezTo>
                    <a:cubicBezTo>
                      <a:pt x="360" y="152"/>
                      <a:pt x="360" y="157"/>
                      <a:pt x="357" y="160"/>
                    </a:cubicBezTo>
                    <a:lnTo>
                      <a:pt x="314" y="205"/>
                    </a:lnTo>
                    <a:cubicBezTo>
                      <a:pt x="311" y="208"/>
                      <a:pt x="307" y="208"/>
                      <a:pt x="304" y="206"/>
                    </a:cubicBezTo>
                    <a:cubicBezTo>
                      <a:pt x="300" y="203"/>
                      <a:pt x="300" y="199"/>
                      <a:pt x="302" y="195"/>
                    </a:cubicBezTo>
                    <a:lnTo>
                      <a:pt x="305" y="190"/>
                    </a:lnTo>
                    <a:cubicBezTo>
                      <a:pt x="307" y="187"/>
                      <a:pt x="312" y="185"/>
                      <a:pt x="315" y="187"/>
                    </a:cubicBezTo>
                    <a:cubicBezTo>
                      <a:pt x="319" y="190"/>
                      <a:pt x="321" y="194"/>
                      <a:pt x="319" y="198"/>
                    </a:cubicBezTo>
                    <a:lnTo>
                      <a:pt x="305" y="225"/>
                    </a:lnTo>
                    <a:cubicBezTo>
                      <a:pt x="303" y="229"/>
                      <a:pt x="298" y="231"/>
                      <a:pt x="294" y="229"/>
                    </a:cubicBezTo>
                    <a:cubicBezTo>
                      <a:pt x="290" y="227"/>
                      <a:pt x="288" y="222"/>
                      <a:pt x="290" y="218"/>
                    </a:cubicBezTo>
                    <a:lnTo>
                      <a:pt x="292" y="213"/>
                    </a:lnTo>
                    <a:cubicBezTo>
                      <a:pt x="294" y="209"/>
                      <a:pt x="298" y="207"/>
                      <a:pt x="302" y="209"/>
                    </a:cubicBezTo>
                    <a:cubicBezTo>
                      <a:pt x="306" y="210"/>
                      <a:pt x="308" y="215"/>
                      <a:pt x="307" y="219"/>
                    </a:cubicBezTo>
                    <a:lnTo>
                      <a:pt x="297" y="250"/>
                    </a:lnTo>
                    <a:lnTo>
                      <a:pt x="282" y="245"/>
                    </a:lnTo>
                    <a:lnTo>
                      <a:pt x="283" y="242"/>
                    </a:lnTo>
                    <a:cubicBezTo>
                      <a:pt x="284" y="238"/>
                      <a:pt x="288" y="236"/>
                      <a:pt x="292" y="237"/>
                    </a:cubicBezTo>
                    <a:cubicBezTo>
                      <a:pt x="296" y="238"/>
                      <a:pt x="299" y="241"/>
                      <a:pt x="298" y="246"/>
                    </a:cubicBezTo>
                    <a:lnTo>
                      <a:pt x="289" y="312"/>
                    </a:lnTo>
                    <a:lnTo>
                      <a:pt x="286" y="343"/>
                    </a:lnTo>
                    <a:lnTo>
                      <a:pt x="282" y="375"/>
                    </a:lnTo>
                    <a:cubicBezTo>
                      <a:pt x="282" y="376"/>
                      <a:pt x="282" y="377"/>
                      <a:pt x="282" y="377"/>
                    </a:cubicBezTo>
                    <a:lnTo>
                      <a:pt x="281" y="380"/>
                    </a:lnTo>
                    <a:lnTo>
                      <a:pt x="273" y="406"/>
                    </a:lnTo>
                    <a:lnTo>
                      <a:pt x="271" y="412"/>
                    </a:lnTo>
                    <a:cubicBezTo>
                      <a:pt x="271" y="413"/>
                      <a:pt x="271" y="413"/>
                      <a:pt x="270" y="414"/>
                    </a:cubicBezTo>
                    <a:lnTo>
                      <a:pt x="257" y="434"/>
                    </a:lnTo>
                    <a:cubicBezTo>
                      <a:pt x="257" y="434"/>
                      <a:pt x="256" y="435"/>
                      <a:pt x="256" y="436"/>
                    </a:cubicBezTo>
                    <a:lnTo>
                      <a:pt x="249" y="442"/>
                    </a:lnTo>
                    <a:lnTo>
                      <a:pt x="230" y="455"/>
                    </a:lnTo>
                    <a:lnTo>
                      <a:pt x="225" y="459"/>
                    </a:lnTo>
                    <a:cubicBezTo>
                      <a:pt x="225" y="459"/>
                      <a:pt x="224" y="460"/>
                      <a:pt x="223" y="460"/>
                    </a:cubicBezTo>
                    <a:lnTo>
                      <a:pt x="199" y="468"/>
                    </a:lnTo>
                    <a:lnTo>
                      <a:pt x="194" y="469"/>
                    </a:lnTo>
                    <a:lnTo>
                      <a:pt x="167" y="474"/>
                    </a:lnTo>
                    <a:lnTo>
                      <a:pt x="136" y="477"/>
                    </a:lnTo>
                    <a:lnTo>
                      <a:pt x="80" y="476"/>
                    </a:lnTo>
                    <a:lnTo>
                      <a:pt x="59" y="475"/>
                    </a:lnTo>
                    <a:lnTo>
                      <a:pt x="45" y="475"/>
                    </a:lnTo>
                    <a:lnTo>
                      <a:pt x="34" y="476"/>
                    </a:lnTo>
                    <a:cubicBezTo>
                      <a:pt x="33" y="477"/>
                      <a:pt x="32" y="476"/>
                      <a:pt x="31" y="476"/>
                    </a:cubicBezTo>
                    <a:lnTo>
                      <a:pt x="14" y="471"/>
                    </a:lnTo>
                    <a:cubicBezTo>
                      <a:pt x="12" y="471"/>
                      <a:pt x="10" y="469"/>
                      <a:pt x="9" y="467"/>
                    </a:cubicBezTo>
                    <a:lnTo>
                      <a:pt x="1" y="451"/>
                    </a:lnTo>
                    <a:cubicBezTo>
                      <a:pt x="1" y="450"/>
                      <a:pt x="0" y="449"/>
                      <a:pt x="0" y="447"/>
                    </a:cubicBezTo>
                    <a:lnTo>
                      <a:pt x="0" y="446"/>
                    </a:lnTo>
                    <a:cubicBezTo>
                      <a:pt x="0" y="446"/>
                      <a:pt x="1" y="445"/>
                      <a:pt x="1" y="445"/>
                    </a:cubicBezTo>
                    <a:lnTo>
                      <a:pt x="4" y="429"/>
                    </a:lnTo>
                    <a:cubicBezTo>
                      <a:pt x="4" y="427"/>
                      <a:pt x="5" y="425"/>
                      <a:pt x="7" y="424"/>
                    </a:cubicBezTo>
                    <a:lnTo>
                      <a:pt x="21" y="414"/>
                    </a:lnTo>
                    <a:cubicBezTo>
                      <a:pt x="21" y="413"/>
                      <a:pt x="22" y="413"/>
                      <a:pt x="23" y="413"/>
                    </a:cubicBezTo>
                    <a:lnTo>
                      <a:pt x="32" y="410"/>
                    </a:lnTo>
                    <a:lnTo>
                      <a:pt x="48" y="407"/>
                    </a:lnTo>
                    <a:cubicBezTo>
                      <a:pt x="52" y="406"/>
                      <a:pt x="56" y="408"/>
                      <a:pt x="57" y="413"/>
                    </a:cubicBezTo>
                    <a:lnTo>
                      <a:pt x="67" y="459"/>
                    </a:lnTo>
                    <a:cubicBezTo>
                      <a:pt x="68" y="463"/>
                      <a:pt x="66" y="467"/>
                      <a:pt x="62" y="468"/>
                    </a:cubicBezTo>
                    <a:lnTo>
                      <a:pt x="49" y="472"/>
                    </a:lnTo>
                    <a:lnTo>
                      <a:pt x="39" y="474"/>
                    </a:lnTo>
                    <a:cubicBezTo>
                      <a:pt x="36" y="475"/>
                      <a:pt x="33" y="474"/>
                      <a:pt x="31" y="471"/>
                    </a:cubicBezTo>
                    <a:cubicBezTo>
                      <a:pt x="29" y="468"/>
                      <a:pt x="29" y="465"/>
                      <a:pt x="31" y="462"/>
                    </a:cubicBezTo>
                    <a:lnTo>
                      <a:pt x="49" y="436"/>
                    </a:lnTo>
                    <a:cubicBezTo>
                      <a:pt x="51" y="433"/>
                      <a:pt x="55" y="432"/>
                      <a:pt x="58" y="433"/>
                    </a:cubicBezTo>
                    <a:cubicBezTo>
                      <a:pt x="61" y="434"/>
                      <a:pt x="63" y="437"/>
                      <a:pt x="63" y="440"/>
                    </a:cubicBezTo>
                    <a:lnTo>
                      <a:pt x="63" y="442"/>
                    </a:lnTo>
                    <a:cubicBezTo>
                      <a:pt x="63" y="446"/>
                      <a:pt x="62" y="448"/>
                      <a:pt x="59" y="450"/>
                    </a:cubicBezTo>
                    <a:cubicBezTo>
                      <a:pt x="56" y="451"/>
                      <a:pt x="53" y="451"/>
                      <a:pt x="50" y="449"/>
                    </a:cubicBezTo>
                    <a:lnTo>
                      <a:pt x="24" y="428"/>
                    </a:lnTo>
                    <a:cubicBezTo>
                      <a:pt x="22" y="426"/>
                      <a:pt x="21" y="422"/>
                      <a:pt x="22" y="419"/>
                    </a:cubicBezTo>
                    <a:cubicBezTo>
                      <a:pt x="23" y="416"/>
                      <a:pt x="26" y="414"/>
                      <a:pt x="29" y="413"/>
                    </a:cubicBezTo>
                    <a:lnTo>
                      <a:pt x="45" y="412"/>
                    </a:lnTo>
                    <a:lnTo>
                      <a:pt x="60" y="411"/>
                    </a:lnTo>
                    <a:lnTo>
                      <a:pt x="82" y="412"/>
                    </a:lnTo>
                    <a:lnTo>
                      <a:pt x="132" y="413"/>
                    </a:lnTo>
                    <a:lnTo>
                      <a:pt x="156" y="411"/>
                    </a:lnTo>
                    <a:lnTo>
                      <a:pt x="182" y="408"/>
                    </a:lnTo>
                    <a:lnTo>
                      <a:pt x="183" y="423"/>
                    </a:lnTo>
                    <a:lnTo>
                      <a:pt x="179" y="423"/>
                    </a:lnTo>
                    <a:cubicBezTo>
                      <a:pt x="176" y="423"/>
                      <a:pt x="172" y="421"/>
                      <a:pt x="172" y="417"/>
                    </a:cubicBezTo>
                    <a:cubicBezTo>
                      <a:pt x="171" y="413"/>
                      <a:pt x="173" y="409"/>
                      <a:pt x="177" y="408"/>
                    </a:cubicBezTo>
                    <a:lnTo>
                      <a:pt x="201" y="400"/>
                    </a:lnTo>
                    <a:cubicBezTo>
                      <a:pt x="205" y="399"/>
                      <a:pt x="209" y="401"/>
                      <a:pt x="211" y="404"/>
                    </a:cubicBezTo>
                    <a:cubicBezTo>
                      <a:pt x="212" y="408"/>
                      <a:pt x="211" y="413"/>
                      <a:pt x="207" y="415"/>
                    </a:cubicBezTo>
                    <a:lnTo>
                      <a:pt x="201" y="418"/>
                    </a:lnTo>
                    <a:cubicBezTo>
                      <a:pt x="197" y="420"/>
                      <a:pt x="193" y="418"/>
                      <a:pt x="191" y="415"/>
                    </a:cubicBezTo>
                    <a:cubicBezTo>
                      <a:pt x="188" y="411"/>
                      <a:pt x="189" y="406"/>
                      <a:pt x="193" y="404"/>
                    </a:cubicBezTo>
                    <a:lnTo>
                      <a:pt x="212" y="391"/>
                    </a:lnTo>
                    <a:cubicBezTo>
                      <a:pt x="215" y="389"/>
                      <a:pt x="220" y="389"/>
                      <a:pt x="223" y="392"/>
                    </a:cubicBezTo>
                    <a:cubicBezTo>
                      <a:pt x="225" y="396"/>
                      <a:pt x="225" y="400"/>
                      <a:pt x="222" y="403"/>
                    </a:cubicBezTo>
                    <a:lnTo>
                      <a:pt x="216" y="409"/>
                    </a:lnTo>
                    <a:cubicBezTo>
                      <a:pt x="213" y="412"/>
                      <a:pt x="209" y="412"/>
                      <a:pt x="206" y="410"/>
                    </a:cubicBezTo>
                    <a:cubicBezTo>
                      <a:pt x="202" y="407"/>
                      <a:pt x="202" y="403"/>
                      <a:pt x="204" y="399"/>
                    </a:cubicBezTo>
                    <a:lnTo>
                      <a:pt x="216" y="379"/>
                    </a:lnTo>
                    <a:cubicBezTo>
                      <a:pt x="218" y="376"/>
                      <a:pt x="222" y="374"/>
                      <a:pt x="226" y="376"/>
                    </a:cubicBezTo>
                    <a:cubicBezTo>
                      <a:pt x="230" y="378"/>
                      <a:pt x="231" y="382"/>
                      <a:pt x="230" y="386"/>
                    </a:cubicBezTo>
                    <a:lnTo>
                      <a:pt x="228" y="392"/>
                    </a:lnTo>
                    <a:cubicBezTo>
                      <a:pt x="227" y="396"/>
                      <a:pt x="222" y="398"/>
                      <a:pt x="218" y="397"/>
                    </a:cubicBezTo>
                    <a:cubicBezTo>
                      <a:pt x="214" y="396"/>
                      <a:pt x="211" y="391"/>
                      <a:pt x="213" y="387"/>
                    </a:cubicBezTo>
                    <a:lnTo>
                      <a:pt x="221" y="362"/>
                    </a:lnTo>
                    <a:lnTo>
                      <a:pt x="236" y="367"/>
                    </a:lnTo>
                    <a:lnTo>
                      <a:pt x="235" y="370"/>
                    </a:lnTo>
                    <a:cubicBezTo>
                      <a:pt x="234" y="374"/>
                      <a:pt x="230" y="376"/>
                      <a:pt x="226" y="375"/>
                    </a:cubicBezTo>
                    <a:cubicBezTo>
                      <a:pt x="222" y="374"/>
                      <a:pt x="219" y="370"/>
                      <a:pt x="220" y="366"/>
                    </a:cubicBezTo>
                    <a:lnTo>
                      <a:pt x="224" y="337"/>
                    </a:lnTo>
                    <a:lnTo>
                      <a:pt x="226" y="304"/>
                    </a:lnTo>
                    <a:lnTo>
                      <a:pt x="236" y="236"/>
                    </a:lnTo>
                    <a:cubicBezTo>
                      <a:pt x="236" y="236"/>
                      <a:pt x="236" y="235"/>
                      <a:pt x="236" y="235"/>
                    </a:cubicBezTo>
                    <a:lnTo>
                      <a:pt x="237" y="232"/>
                    </a:lnTo>
                    <a:lnTo>
                      <a:pt x="247" y="201"/>
                    </a:lnTo>
                    <a:lnTo>
                      <a:pt x="249" y="195"/>
                    </a:lnTo>
                    <a:lnTo>
                      <a:pt x="263" y="168"/>
                    </a:lnTo>
                    <a:cubicBezTo>
                      <a:pt x="264" y="167"/>
                      <a:pt x="264" y="167"/>
                      <a:pt x="264" y="166"/>
                    </a:cubicBezTo>
                    <a:lnTo>
                      <a:pt x="268" y="161"/>
                    </a:lnTo>
                    <a:lnTo>
                      <a:pt x="312" y="116"/>
                    </a:lnTo>
                    <a:lnTo>
                      <a:pt x="315" y="113"/>
                    </a:lnTo>
                    <a:cubicBezTo>
                      <a:pt x="315" y="112"/>
                      <a:pt x="316" y="112"/>
                      <a:pt x="316" y="112"/>
                    </a:cubicBezTo>
                    <a:lnTo>
                      <a:pt x="374" y="72"/>
                    </a:lnTo>
                    <a:lnTo>
                      <a:pt x="440" y="35"/>
                    </a:lnTo>
                    <a:lnTo>
                      <a:pt x="506" y="2"/>
                    </a:lnTo>
                    <a:cubicBezTo>
                      <a:pt x="510" y="0"/>
                      <a:pt x="515" y="2"/>
                      <a:pt x="517" y="6"/>
                    </a:cubicBezTo>
                    <a:lnTo>
                      <a:pt x="538" y="48"/>
                    </a:lnTo>
                    <a:close/>
                    <a:moveTo>
                      <a:pt x="502" y="13"/>
                    </a:moveTo>
                    <a:lnTo>
                      <a:pt x="513" y="17"/>
                    </a:lnTo>
                    <a:lnTo>
                      <a:pt x="447" y="49"/>
                    </a:lnTo>
                    <a:lnTo>
                      <a:pt x="383" y="85"/>
                    </a:lnTo>
                    <a:lnTo>
                      <a:pt x="325" y="125"/>
                    </a:lnTo>
                    <a:lnTo>
                      <a:pt x="326" y="124"/>
                    </a:lnTo>
                    <a:lnTo>
                      <a:pt x="323" y="127"/>
                    </a:lnTo>
                    <a:lnTo>
                      <a:pt x="281" y="171"/>
                    </a:lnTo>
                    <a:lnTo>
                      <a:pt x="277" y="176"/>
                    </a:lnTo>
                    <a:lnTo>
                      <a:pt x="278" y="175"/>
                    </a:lnTo>
                    <a:lnTo>
                      <a:pt x="264" y="201"/>
                    </a:lnTo>
                    <a:lnTo>
                      <a:pt x="262" y="206"/>
                    </a:lnTo>
                    <a:lnTo>
                      <a:pt x="252" y="237"/>
                    </a:lnTo>
                    <a:lnTo>
                      <a:pt x="251" y="240"/>
                    </a:lnTo>
                    <a:lnTo>
                      <a:pt x="251" y="239"/>
                    </a:lnTo>
                    <a:lnTo>
                      <a:pt x="242" y="305"/>
                    </a:lnTo>
                    <a:lnTo>
                      <a:pt x="239" y="340"/>
                    </a:lnTo>
                    <a:lnTo>
                      <a:pt x="235" y="369"/>
                    </a:lnTo>
                    <a:lnTo>
                      <a:pt x="220" y="365"/>
                    </a:lnTo>
                    <a:lnTo>
                      <a:pt x="221" y="362"/>
                    </a:lnTo>
                    <a:cubicBezTo>
                      <a:pt x="222" y="358"/>
                      <a:pt x="227" y="355"/>
                      <a:pt x="231" y="357"/>
                    </a:cubicBezTo>
                    <a:cubicBezTo>
                      <a:pt x="235" y="358"/>
                      <a:pt x="237" y="363"/>
                      <a:pt x="236" y="367"/>
                    </a:cubicBezTo>
                    <a:lnTo>
                      <a:pt x="228" y="392"/>
                    </a:lnTo>
                    <a:lnTo>
                      <a:pt x="213" y="387"/>
                    </a:lnTo>
                    <a:lnTo>
                      <a:pt x="215" y="381"/>
                    </a:lnTo>
                    <a:lnTo>
                      <a:pt x="229" y="388"/>
                    </a:lnTo>
                    <a:lnTo>
                      <a:pt x="217" y="408"/>
                    </a:lnTo>
                    <a:lnTo>
                      <a:pt x="205" y="398"/>
                    </a:lnTo>
                    <a:lnTo>
                      <a:pt x="211" y="392"/>
                    </a:lnTo>
                    <a:lnTo>
                      <a:pt x="221" y="404"/>
                    </a:lnTo>
                    <a:lnTo>
                      <a:pt x="202" y="417"/>
                    </a:lnTo>
                    <a:lnTo>
                      <a:pt x="194" y="403"/>
                    </a:lnTo>
                    <a:lnTo>
                      <a:pt x="200" y="400"/>
                    </a:lnTo>
                    <a:lnTo>
                      <a:pt x="206" y="415"/>
                    </a:lnTo>
                    <a:lnTo>
                      <a:pt x="182" y="423"/>
                    </a:lnTo>
                    <a:lnTo>
                      <a:pt x="179" y="407"/>
                    </a:lnTo>
                    <a:lnTo>
                      <a:pt x="183" y="407"/>
                    </a:lnTo>
                    <a:cubicBezTo>
                      <a:pt x="188" y="407"/>
                      <a:pt x="191" y="411"/>
                      <a:pt x="191" y="415"/>
                    </a:cubicBezTo>
                    <a:cubicBezTo>
                      <a:pt x="192" y="419"/>
                      <a:pt x="189" y="423"/>
                      <a:pt x="185" y="423"/>
                    </a:cubicBezTo>
                    <a:lnTo>
                      <a:pt x="157" y="427"/>
                    </a:lnTo>
                    <a:lnTo>
                      <a:pt x="131" y="429"/>
                    </a:lnTo>
                    <a:lnTo>
                      <a:pt x="81" y="428"/>
                    </a:lnTo>
                    <a:lnTo>
                      <a:pt x="61" y="427"/>
                    </a:lnTo>
                    <a:lnTo>
                      <a:pt x="46" y="428"/>
                    </a:lnTo>
                    <a:lnTo>
                      <a:pt x="30" y="429"/>
                    </a:lnTo>
                    <a:lnTo>
                      <a:pt x="34" y="415"/>
                    </a:lnTo>
                    <a:lnTo>
                      <a:pt x="60" y="436"/>
                    </a:lnTo>
                    <a:lnTo>
                      <a:pt x="47" y="442"/>
                    </a:lnTo>
                    <a:lnTo>
                      <a:pt x="47" y="440"/>
                    </a:lnTo>
                    <a:lnTo>
                      <a:pt x="62" y="445"/>
                    </a:lnTo>
                    <a:lnTo>
                      <a:pt x="44" y="471"/>
                    </a:lnTo>
                    <a:lnTo>
                      <a:pt x="36" y="459"/>
                    </a:lnTo>
                    <a:lnTo>
                      <a:pt x="44" y="457"/>
                    </a:lnTo>
                    <a:lnTo>
                      <a:pt x="57" y="453"/>
                    </a:lnTo>
                    <a:lnTo>
                      <a:pt x="52" y="462"/>
                    </a:lnTo>
                    <a:lnTo>
                      <a:pt x="42" y="416"/>
                    </a:lnTo>
                    <a:lnTo>
                      <a:pt x="51" y="422"/>
                    </a:lnTo>
                    <a:lnTo>
                      <a:pt x="37" y="425"/>
                    </a:lnTo>
                    <a:lnTo>
                      <a:pt x="28" y="428"/>
                    </a:lnTo>
                    <a:lnTo>
                      <a:pt x="30" y="427"/>
                    </a:lnTo>
                    <a:lnTo>
                      <a:pt x="16" y="437"/>
                    </a:lnTo>
                    <a:lnTo>
                      <a:pt x="19" y="432"/>
                    </a:lnTo>
                    <a:lnTo>
                      <a:pt x="16" y="448"/>
                    </a:lnTo>
                    <a:lnTo>
                      <a:pt x="16" y="446"/>
                    </a:lnTo>
                    <a:lnTo>
                      <a:pt x="16" y="447"/>
                    </a:lnTo>
                    <a:lnTo>
                      <a:pt x="16" y="444"/>
                    </a:lnTo>
                    <a:lnTo>
                      <a:pt x="24" y="460"/>
                    </a:lnTo>
                    <a:lnTo>
                      <a:pt x="19" y="456"/>
                    </a:lnTo>
                    <a:lnTo>
                      <a:pt x="36" y="461"/>
                    </a:lnTo>
                    <a:lnTo>
                      <a:pt x="33" y="460"/>
                    </a:lnTo>
                    <a:lnTo>
                      <a:pt x="45" y="459"/>
                    </a:lnTo>
                    <a:lnTo>
                      <a:pt x="60" y="459"/>
                    </a:lnTo>
                    <a:lnTo>
                      <a:pt x="81" y="460"/>
                    </a:lnTo>
                    <a:lnTo>
                      <a:pt x="135" y="461"/>
                    </a:lnTo>
                    <a:lnTo>
                      <a:pt x="164" y="459"/>
                    </a:lnTo>
                    <a:lnTo>
                      <a:pt x="191" y="454"/>
                    </a:lnTo>
                    <a:lnTo>
                      <a:pt x="194" y="453"/>
                    </a:lnTo>
                    <a:lnTo>
                      <a:pt x="218" y="445"/>
                    </a:lnTo>
                    <a:lnTo>
                      <a:pt x="215" y="446"/>
                    </a:lnTo>
                    <a:lnTo>
                      <a:pt x="221" y="442"/>
                    </a:lnTo>
                    <a:lnTo>
                      <a:pt x="238" y="429"/>
                    </a:lnTo>
                    <a:lnTo>
                      <a:pt x="245" y="423"/>
                    </a:lnTo>
                    <a:lnTo>
                      <a:pt x="244" y="425"/>
                    </a:lnTo>
                    <a:lnTo>
                      <a:pt x="257" y="405"/>
                    </a:lnTo>
                    <a:lnTo>
                      <a:pt x="256" y="407"/>
                    </a:lnTo>
                    <a:lnTo>
                      <a:pt x="258" y="401"/>
                    </a:lnTo>
                    <a:lnTo>
                      <a:pt x="266" y="375"/>
                    </a:lnTo>
                    <a:lnTo>
                      <a:pt x="267" y="372"/>
                    </a:lnTo>
                    <a:lnTo>
                      <a:pt x="267" y="373"/>
                    </a:lnTo>
                    <a:lnTo>
                      <a:pt x="270" y="342"/>
                    </a:lnTo>
                    <a:lnTo>
                      <a:pt x="274" y="309"/>
                    </a:lnTo>
                    <a:lnTo>
                      <a:pt x="283" y="243"/>
                    </a:lnTo>
                    <a:lnTo>
                      <a:pt x="298" y="247"/>
                    </a:lnTo>
                    <a:lnTo>
                      <a:pt x="297" y="250"/>
                    </a:lnTo>
                    <a:cubicBezTo>
                      <a:pt x="296" y="254"/>
                      <a:pt x="291" y="256"/>
                      <a:pt x="287" y="255"/>
                    </a:cubicBezTo>
                    <a:cubicBezTo>
                      <a:pt x="283" y="254"/>
                      <a:pt x="280" y="249"/>
                      <a:pt x="282" y="245"/>
                    </a:cubicBezTo>
                    <a:lnTo>
                      <a:pt x="292" y="214"/>
                    </a:lnTo>
                    <a:lnTo>
                      <a:pt x="307" y="219"/>
                    </a:lnTo>
                    <a:lnTo>
                      <a:pt x="305" y="224"/>
                    </a:lnTo>
                    <a:lnTo>
                      <a:pt x="290" y="218"/>
                    </a:lnTo>
                    <a:lnTo>
                      <a:pt x="304" y="191"/>
                    </a:lnTo>
                    <a:lnTo>
                      <a:pt x="318" y="199"/>
                    </a:lnTo>
                    <a:lnTo>
                      <a:pt x="315" y="204"/>
                    </a:lnTo>
                    <a:lnTo>
                      <a:pt x="303" y="194"/>
                    </a:lnTo>
                    <a:lnTo>
                      <a:pt x="346" y="149"/>
                    </a:lnTo>
                    <a:lnTo>
                      <a:pt x="356" y="161"/>
                    </a:lnTo>
                    <a:lnTo>
                      <a:pt x="353" y="163"/>
                    </a:lnTo>
                    <a:cubicBezTo>
                      <a:pt x="349" y="166"/>
                      <a:pt x="344" y="165"/>
                      <a:pt x="342" y="161"/>
                    </a:cubicBezTo>
                    <a:cubicBezTo>
                      <a:pt x="339" y="157"/>
                      <a:pt x="340" y="152"/>
                      <a:pt x="344" y="150"/>
                    </a:cubicBezTo>
                    <a:lnTo>
                      <a:pt x="398" y="112"/>
                    </a:lnTo>
                    <a:lnTo>
                      <a:pt x="460" y="77"/>
                    </a:lnTo>
                    <a:lnTo>
                      <a:pt x="527" y="44"/>
                    </a:lnTo>
                    <a:lnTo>
                      <a:pt x="523" y="55"/>
                    </a:lnTo>
                    <a:lnTo>
                      <a:pt x="502" y="13"/>
                    </a:lnTo>
                    <a:close/>
                  </a:path>
                </a:pathLst>
              </a:custGeom>
              <a:solidFill>
                <a:srgbClr val="4F6228"/>
              </a:solidFill>
              <a:ln w="1588" cap="flat">
                <a:solidFill>
                  <a:srgbClr val="4F6228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grpSp>
          <p:nvGrpSpPr>
            <p:cNvPr id="59" name="Group 197">
              <a:extLst>
                <a:ext uri="{FF2B5EF4-FFF2-40B4-BE49-F238E27FC236}">
                  <a16:creationId xmlns:a16="http://schemas.microsoft.com/office/drawing/2014/main" id="{1769CC2A-C01D-414C-B8A3-97F1A28A9734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987" y="2070"/>
              <a:ext cx="376" cy="256"/>
              <a:chOff x="1987" y="2070"/>
              <a:chExt cx="376" cy="256"/>
            </a:xfrm>
          </p:grpSpPr>
          <p:sp>
            <p:nvSpPr>
              <p:cNvPr id="102" name="Freeform 184">
                <a:extLst>
                  <a:ext uri="{FF2B5EF4-FFF2-40B4-BE49-F238E27FC236}">
                    <a16:creationId xmlns:a16="http://schemas.microsoft.com/office/drawing/2014/main" id="{F41FB8C3-AFCA-4901-B305-B82718CF238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00" y="2107"/>
                <a:ext cx="75" cy="36"/>
              </a:xfrm>
              <a:custGeom>
                <a:avLst/>
                <a:gdLst>
                  <a:gd name="T0" fmla="*/ 0 w 304"/>
                  <a:gd name="T1" fmla="*/ 72 h 144"/>
                  <a:gd name="T2" fmla="*/ 152 w 304"/>
                  <a:gd name="T3" fmla="*/ 0 h 144"/>
                  <a:gd name="T4" fmla="*/ 152 w 304"/>
                  <a:gd name="T5" fmla="*/ 0 h 144"/>
                  <a:gd name="T6" fmla="*/ 304 w 304"/>
                  <a:gd name="T7" fmla="*/ 0 h 144"/>
                  <a:gd name="T8" fmla="*/ 304 w 304"/>
                  <a:gd name="T9" fmla="*/ 72 h 144"/>
                  <a:gd name="T10" fmla="*/ 304 w 304"/>
                  <a:gd name="T11" fmla="*/ 72 h 144"/>
                  <a:gd name="T12" fmla="*/ 152 w 304"/>
                  <a:gd name="T13" fmla="*/ 144 h 144"/>
                  <a:gd name="T14" fmla="*/ 152 w 304"/>
                  <a:gd name="T15" fmla="*/ 144 h 144"/>
                  <a:gd name="T16" fmla="*/ 152 w 304"/>
                  <a:gd name="T17" fmla="*/ 144 h 144"/>
                  <a:gd name="T18" fmla="*/ 0 w 304"/>
                  <a:gd name="T19" fmla="*/ 72 h 144"/>
                  <a:gd name="T20" fmla="*/ 0 w 304"/>
                  <a:gd name="T21" fmla="*/ 72 h 1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304" h="144">
                    <a:moveTo>
                      <a:pt x="0" y="72"/>
                    </a:moveTo>
                    <a:cubicBezTo>
                      <a:pt x="0" y="33"/>
                      <a:pt x="69" y="0"/>
                      <a:pt x="152" y="0"/>
                    </a:cubicBezTo>
                    <a:lnTo>
                      <a:pt x="152" y="0"/>
                    </a:lnTo>
                    <a:cubicBezTo>
                      <a:pt x="203" y="0"/>
                      <a:pt x="254" y="0"/>
                      <a:pt x="304" y="0"/>
                    </a:cubicBezTo>
                    <a:cubicBezTo>
                      <a:pt x="304" y="24"/>
                      <a:pt x="304" y="48"/>
                      <a:pt x="304" y="72"/>
                    </a:cubicBezTo>
                    <a:lnTo>
                      <a:pt x="304" y="72"/>
                    </a:lnTo>
                    <a:cubicBezTo>
                      <a:pt x="304" y="112"/>
                      <a:pt x="236" y="144"/>
                      <a:pt x="152" y="144"/>
                    </a:cubicBezTo>
                    <a:cubicBezTo>
                      <a:pt x="152" y="144"/>
                      <a:pt x="152" y="144"/>
                      <a:pt x="152" y="144"/>
                    </a:cubicBezTo>
                    <a:lnTo>
                      <a:pt x="152" y="144"/>
                    </a:lnTo>
                    <a:cubicBezTo>
                      <a:pt x="69" y="144"/>
                      <a:pt x="0" y="112"/>
                      <a:pt x="0" y="72"/>
                    </a:cubicBezTo>
                    <a:cubicBezTo>
                      <a:pt x="0" y="72"/>
                      <a:pt x="0" y="72"/>
                      <a:pt x="0" y="72"/>
                    </a:cubicBezTo>
                    <a:close/>
                  </a:path>
                </a:pathLst>
              </a:cu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" name="Freeform 185">
                <a:extLst>
                  <a:ext uri="{FF2B5EF4-FFF2-40B4-BE49-F238E27FC236}">
                    <a16:creationId xmlns:a16="http://schemas.microsoft.com/office/drawing/2014/main" id="{E52FC769-DA0C-4B2C-9446-4DF362982D8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098" y="2105"/>
                <a:ext cx="79" cy="40"/>
              </a:xfrm>
              <a:custGeom>
                <a:avLst/>
                <a:gdLst>
                  <a:gd name="T0" fmla="*/ 1 w 320"/>
                  <a:gd name="T1" fmla="*/ 79 h 160"/>
                  <a:gd name="T2" fmla="*/ 5 w 320"/>
                  <a:gd name="T3" fmla="*/ 62 h 160"/>
                  <a:gd name="T4" fmla="*/ 16 w 320"/>
                  <a:gd name="T5" fmla="*/ 46 h 160"/>
                  <a:gd name="T6" fmla="*/ 51 w 320"/>
                  <a:gd name="T7" fmla="*/ 22 h 160"/>
                  <a:gd name="T8" fmla="*/ 101 w 320"/>
                  <a:gd name="T9" fmla="*/ 7 h 160"/>
                  <a:gd name="T10" fmla="*/ 312 w 320"/>
                  <a:gd name="T11" fmla="*/ 0 h 160"/>
                  <a:gd name="T12" fmla="*/ 320 w 320"/>
                  <a:gd name="T13" fmla="*/ 80 h 160"/>
                  <a:gd name="T14" fmla="*/ 317 w 320"/>
                  <a:gd name="T15" fmla="*/ 97 h 160"/>
                  <a:gd name="T16" fmla="*/ 307 w 320"/>
                  <a:gd name="T17" fmla="*/ 113 h 160"/>
                  <a:gd name="T18" fmla="*/ 273 w 320"/>
                  <a:gd name="T19" fmla="*/ 138 h 160"/>
                  <a:gd name="T20" fmla="*/ 222 w 320"/>
                  <a:gd name="T21" fmla="*/ 154 h 160"/>
                  <a:gd name="T22" fmla="*/ 161 w 320"/>
                  <a:gd name="T23" fmla="*/ 160 h 160"/>
                  <a:gd name="T24" fmla="*/ 101 w 320"/>
                  <a:gd name="T25" fmla="*/ 154 h 160"/>
                  <a:gd name="T26" fmla="*/ 51 w 320"/>
                  <a:gd name="T27" fmla="*/ 139 h 160"/>
                  <a:gd name="T28" fmla="*/ 16 w 320"/>
                  <a:gd name="T29" fmla="*/ 115 h 160"/>
                  <a:gd name="T30" fmla="*/ 5 w 320"/>
                  <a:gd name="T31" fmla="*/ 100 h 160"/>
                  <a:gd name="T32" fmla="*/ 1 w 320"/>
                  <a:gd name="T33" fmla="*/ 82 h 160"/>
                  <a:gd name="T34" fmla="*/ 18 w 320"/>
                  <a:gd name="T35" fmla="*/ 91 h 160"/>
                  <a:gd name="T36" fmla="*/ 25 w 320"/>
                  <a:gd name="T37" fmla="*/ 102 h 160"/>
                  <a:gd name="T38" fmla="*/ 56 w 320"/>
                  <a:gd name="T39" fmla="*/ 124 h 160"/>
                  <a:gd name="T40" fmla="*/ 102 w 320"/>
                  <a:gd name="T41" fmla="*/ 139 h 160"/>
                  <a:gd name="T42" fmla="*/ 160 w 320"/>
                  <a:gd name="T43" fmla="*/ 145 h 160"/>
                  <a:gd name="T44" fmla="*/ 217 w 320"/>
                  <a:gd name="T45" fmla="*/ 139 h 160"/>
                  <a:gd name="T46" fmla="*/ 264 w 320"/>
                  <a:gd name="T47" fmla="*/ 125 h 160"/>
                  <a:gd name="T48" fmla="*/ 294 w 320"/>
                  <a:gd name="T49" fmla="*/ 104 h 160"/>
                  <a:gd name="T50" fmla="*/ 302 w 320"/>
                  <a:gd name="T51" fmla="*/ 94 h 160"/>
                  <a:gd name="T52" fmla="*/ 304 w 320"/>
                  <a:gd name="T53" fmla="*/ 80 h 160"/>
                  <a:gd name="T54" fmla="*/ 312 w 320"/>
                  <a:gd name="T55" fmla="*/ 16 h 160"/>
                  <a:gd name="T56" fmla="*/ 102 w 320"/>
                  <a:gd name="T57" fmla="*/ 22 h 160"/>
                  <a:gd name="T58" fmla="*/ 56 w 320"/>
                  <a:gd name="T59" fmla="*/ 37 h 160"/>
                  <a:gd name="T60" fmla="*/ 25 w 320"/>
                  <a:gd name="T61" fmla="*/ 59 h 160"/>
                  <a:gd name="T62" fmla="*/ 18 w 320"/>
                  <a:gd name="T63" fmla="*/ 71 h 160"/>
                  <a:gd name="T64" fmla="*/ 16 w 320"/>
                  <a:gd name="T65" fmla="*/ 82 h 160"/>
                  <a:gd name="T66" fmla="*/ 19 w 320"/>
                  <a:gd name="T67" fmla="*/ 94 h 1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</a:cxnLst>
                <a:rect l="0" t="0" r="r" b="b"/>
                <a:pathLst>
                  <a:path w="320" h="160">
                    <a:moveTo>
                      <a:pt x="1" y="82"/>
                    </a:moveTo>
                    <a:cubicBezTo>
                      <a:pt x="0" y="81"/>
                      <a:pt x="0" y="80"/>
                      <a:pt x="1" y="79"/>
                    </a:cubicBezTo>
                    <a:lnTo>
                      <a:pt x="4" y="65"/>
                    </a:lnTo>
                    <a:cubicBezTo>
                      <a:pt x="4" y="64"/>
                      <a:pt x="4" y="63"/>
                      <a:pt x="5" y="62"/>
                    </a:cubicBezTo>
                    <a:lnTo>
                      <a:pt x="14" y="48"/>
                    </a:lnTo>
                    <a:cubicBezTo>
                      <a:pt x="14" y="47"/>
                      <a:pt x="15" y="46"/>
                      <a:pt x="16" y="46"/>
                    </a:cubicBezTo>
                    <a:lnTo>
                      <a:pt x="49" y="23"/>
                    </a:lnTo>
                    <a:cubicBezTo>
                      <a:pt x="50" y="22"/>
                      <a:pt x="50" y="22"/>
                      <a:pt x="51" y="22"/>
                    </a:cubicBezTo>
                    <a:lnTo>
                      <a:pt x="99" y="7"/>
                    </a:lnTo>
                    <a:cubicBezTo>
                      <a:pt x="100" y="7"/>
                      <a:pt x="100" y="7"/>
                      <a:pt x="101" y="7"/>
                    </a:cubicBezTo>
                    <a:lnTo>
                      <a:pt x="160" y="1"/>
                    </a:lnTo>
                    <a:lnTo>
                      <a:pt x="312" y="0"/>
                    </a:lnTo>
                    <a:cubicBezTo>
                      <a:pt x="317" y="0"/>
                      <a:pt x="320" y="4"/>
                      <a:pt x="320" y="8"/>
                    </a:cubicBezTo>
                    <a:lnTo>
                      <a:pt x="320" y="80"/>
                    </a:lnTo>
                    <a:cubicBezTo>
                      <a:pt x="320" y="81"/>
                      <a:pt x="320" y="82"/>
                      <a:pt x="320" y="82"/>
                    </a:cubicBezTo>
                    <a:lnTo>
                      <a:pt x="317" y="97"/>
                    </a:lnTo>
                    <a:cubicBezTo>
                      <a:pt x="317" y="98"/>
                      <a:pt x="317" y="99"/>
                      <a:pt x="316" y="100"/>
                    </a:cubicBezTo>
                    <a:lnTo>
                      <a:pt x="307" y="113"/>
                    </a:lnTo>
                    <a:cubicBezTo>
                      <a:pt x="307" y="114"/>
                      <a:pt x="306" y="114"/>
                      <a:pt x="305" y="115"/>
                    </a:cubicBezTo>
                    <a:lnTo>
                      <a:pt x="273" y="138"/>
                    </a:lnTo>
                    <a:cubicBezTo>
                      <a:pt x="272" y="138"/>
                      <a:pt x="272" y="139"/>
                      <a:pt x="271" y="139"/>
                    </a:cubicBezTo>
                    <a:lnTo>
                      <a:pt x="222" y="154"/>
                    </a:lnTo>
                    <a:cubicBezTo>
                      <a:pt x="221" y="154"/>
                      <a:pt x="221" y="154"/>
                      <a:pt x="220" y="154"/>
                    </a:cubicBezTo>
                    <a:lnTo>
                      <a:pt x="161" y="160"/>
                    </a:lnTo>
                    <a:cubicBezTo>
                      <a:pt x="161" y="160"/>
                      <a:pt x="160" y="160"/>
                      <a:pt x="160" y="160"/>
                    </a:cubicBezTo>
                    <a:lnTo>
                      <a:pt x="101" y="154"/>
                    </a:lnTo>
                    <a:cubicBezTo>
                      <a:pt x="100" y="154"/>
                      <a:pt x="100" y="154"/>
                      <a:pt x="99" y="154"/>
                    </a:cubicBezTo>
                    <a:lnTo>
                      <a:pt x="51" y="139"/>
                    </a:lnTo>
                    <a:cubicBezTo>
                      <a:pt x="50" y="139"/>
                      <a:pt x="50" y="139"/>
                      <a:pt x="49" y="138"/>
                    </a:cubicBezTo>
                    <a:lnTo>
                      <a:pt x="16" y="115"/>
                    </a:lnTo>
                    <a:cubicBezTo>
                      <a:pt x="15" y="114"/>
                      <a:pt x="14" y="114"/>
                      <a:pt x="14" y="113"/>
                    </a:cubicBezTo>
                    <a:lnTo>
                      <a:pt x="5" y="100"/>
                    </a:lnTo>
                    <a:cubicBezTo>
                      <a:pt x="4" y="99"/>
                      <a:pt x="4" y="98"/>
                      <a:pt x="4" y="97"/>
                    </a:cubicBezTo>
                    <a:lnTo>
                      <a:pt x="1" y="82"/>
                    </a:lnTo>
                    <a:close/>
                    <a:moveTo>
                      <a:pt x="19" y="94"/>
                    </a:moveTo>
                    <a:lnTo>
                      <a:pt x="18" y="91"/>
                    </a:lnTo>
                    <a:lnTo>
                      <a:pt x="27" y="104"/>
                    </a:lnTo>
                    <a:lnTo>
                      <a:pt x="25" y="102"/>
                    </a:lnTo>
                    <a:lnTo>
                      <a:pt x="58" y="125"/>
                    </a:lnTo>
                    <a:lnTo>
                      <a:pt x="56" y="124"/>
                    </a:lnTo>
                    <a:lnTo>
                      <a:pt x="104" y="139"/>
                    </a:lnTo>
                    <a:lnTo>
                      <a:pt x="102" y="139"/>
                    </a:lnTo>
                    <a:lnTo>
                      <a:pt x="161" y="145"/>
                    </a:lnTo>
                    <a:lnTo>
                      <a:pt x="160" y="145"/>
                    </a:lnTo>
                    <a:lnTo>
                      <a:pt x="219" y="139"/>
                    </a:lnTo>
                    <a:lnTo>
                      <a:pt x="217" y="139"/>
                    </a:lnTo>
                    <a:lnTo>
                      <a:pt x="266" y="124"/>
                    </a:lnTo>
                    <a:lnTo>
                      <a:pt x="264" y="125"/>
                    </a:lnTo>
                    <a:lnTo>
                      <a:pt x="296" y="102"/>
                    </a:lnTo>
                    <a:lnTo>
                      <a:pt x="294" y="104"/>
                    </a:lnTo>
                    <a:lnTo>
                      <a:pt x="303" y="91"/>
                    </a:lnTo>
                    <a:lnTo>
                      <a:pt x="302" y="94"/>
                    </a:lnTo>
                    <a:lnTo>
                      <a:pt x="305" y="79"/>
                    </a:lnTo>
                    <a:lnTo>
                      <a:pt x="304" y="80"/>
                    </a:lnTo>
                    <a:lnTo>
                      <a:pt x="304" y="8"/>
                    </a:lnTo>
                    <a:lnTo>
                      <a:pt x="312" y="16"/>
                    </a:lnTo>
                    <a:lnTo>
                      <a:pt x="161" y="16"/>
                    </a:lnTo>
                    <a:lnTo>
                      <a:pt x="102" y="22"/>
                    </a:lnTo>
                    <a:lnTo>
                      <a:pt x="104" y="22"/>
                    </a:lnTo>
                    <a:lnTo>
                      <a:pt x="56" y="37"/>
                    </a:lnTo>
                    <a:lnTo>
                      <a:pt x="58" y="36"/>
                    </a:lnTo>
                    <a:lnTo>
                      <a:pt x="25" y="59"/>
                    </a:lnTo>
                    <a:lnTo>
                      <a:pt x="27" y="57"/>
                    </a:lnTo>
                    <a:lnTo>
                      <a:pt x="18" y="71"/>
                    </a:lnTo>
                    <a:lnTo>
                      <a:pt x="19" y="68"/>
                    </a:lnTo>
                    <a:lnTo>
                      <a:pt x="16" y="82"/>
                    </a:lnTo>
                    <a:lnTo>
                      <a:pt x="16" y="79"/>
                    </a:lnTo>
                    <a:lnTo>
                      <a:pt x="19" y="9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" name="Freeform 186">
                <a:extLst>
                  <a:ext uri="{FF2B5EF4-FFF2-40B4-BE49-F238E27FC236}">
                    <a16:creationId xmlns:a16="http://schemas.microsoft.com/office/drawing/2014/main" id="{0C8A3F7C-EB63-44C5-8889-BCFEDD7B7BA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75" y="2178"/>
                <a:ext cx="75" cy="40"/>
              </a:xfrm>
              <a:custGeom>
                <a:avLst/>
                <a:gdLst>
                  <a:gd name="T0" fmla="*/ 0 w 304"/>
                  <a:gd name="T1" fmla="*/ 80 h 160"/>
                  <a:gd name="T2" fmla="*/ 152 w 304"/>
                  <a:gd name="T3" fmla="*/ 0 h 160"/>
                  <a:gd name="T4" fmla="*/ 152 w 304"/>
                  <a:gd name="T5" fmla="*/ 0 h 160"/>
                  <a:gd name="T6" fmla="*/ 304 w 304"/>
                  <a:gd name="T7" fmla="*/ 0 h 160"/>
                  <a:gd name="T8" fmla="*/ 304 w 304"/>
                  <a:gd name="T9" fmla="*/ 80 h 160"/>
                  <a:gd name="T10" fmla="*/ 304 w 304"/>
                  <a:gd name="T11" fmla="*/ 80 h 160"/>
                  <a:gd name="T12" fmla="*/ 152 w 304"/>
                  <a:gd name="T13" fmla="*/ 160 h 160"/>
                  <a:gd name="T14" fmla="*/ 152 w 304"/>
                  <a:gd name="T15" fmla="*/ 160 h 160"/>
                  <a:gd name="T16" fmla="*/ 152 w 304"/>
                  <a:gd name="T17" fmla="*/ 160 h 160"/>
                  <a:gd name="T18" fmla="*/ 0 w 304"/>
                  <a:gd name="T19" fmla="*/ 80 h 160"/>
                  <a:gd name="T20" fmla="*/ 0 w 304"/>
                  <a:gd name="T21" fmla="*/ 80 h 1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304" h="160">
                    <a:moveTo>
                      <a:pt x="0" y="80"/>
                    </a:moveTo>
                    <a:cubicBezTo>
                      <a:pt x="0" y="36"/>
                      <a:pt x="69" y="0"/>
                      <a:pt x="152" y="0"/>
                    </a:cubicBezTo>
                    <a:lnTo>
                      <a:pt x="152" y="0"/>
                    </a:lnTo>
                    <a:cubicBezTo>
                      <a:pt x="203" y="0"/>
                      <a:pt x="254" y="0"/>
                      <a:pt x="304" y="0"/>
                    </a:cubicBezTo>
                    <a:cubicBezTo>
                      <a:pt x="304" y="27"/>
                      <a:pt x="304" y="54"/>
                      <a:pt x="304" y="80"/>
                    </a:cubicBezTo>
                    <a:lnTo>
                      <a:pt x="304" y="80"/>
                    </a:lnTo>
                    <a:cubicBezTo>
                      <a:pt x="304" y="125"/>
                      <a:pt x="236" y="160"/>
                      <a:pt x="152" y="160"/>
                    </a:cubicBezTo>
                    <a:cubicBezTo>
                      <a:pt x="152" y="160"/>
                      <a:pt x="152" y="160"/>
                      <a:pt x="152" y="160"/>
                    </a:cubicBezTo>
                    <a:lnTo>
                      <a:pt x="152" y="160"/>
                    </a:lnTo>
                    <a:cubicBezTo>
                      <a:pt x="69" y="160"/>
                      <a:pt x="0" y="125"/>
                      <a:pt x="0" y="80"/>
                    </a:cubicBezTo>
                    <a:cubicBezTo>
                      <a:pt x="0" y="80"/>
                      <a:pt x="0" y="80"/>
                      <a:pt x="0" y="80"/>
                    </a:cubicBezTo>
                    <a:close/>
                  </a:path>
                </a:pathLst>
              </a:custGeom>
              <a:solidFill>
                <a:srgbClr val="00B05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" name="Freeform 187">
                <a:extLst>
                  <a:ext uri="{FF2B5EF4-FFF2-40B4-BE49-F238E27FC236}">
                    <a16:creationId xmlns:a16="http://schemas.microsoft.com/office/drawing/2014/main" id="{75016040-A030-457B-B107-F115E860186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173" y="2176"/>
                <a:ext cx="79" cy="44"/>
              </a:xfrm>
              <a:custGeom>
                <a:avLst/>
                <a:gdLst>
                  <a:gd name="T0" fmla="*/ 1 w 320"/>
                  <a:gd name="T1" fmla="*/ 87 h 176"/>
                  <a:gd name="T2" fmla="*/ 5 w 320"/>
                  <a:gd name="T3" fmla="*/ 68 h 176"/>
                  <a:gd name="T4" fmla="*/ 16 w 320"/>
                  <a:gd name="T5" fmla="*/ 51 h 176"/>
                  <a:gd name="T6" fmla="*/ 51 w 320"/>
                  <a:gd name="T7" fmla="*/ 25 h 176"/>
                  <a:gd name="T8" fmla="*/ 101 w 320"/>
                  <a:gd name="T9" fmla="*/ 7 h 176"/>
                  <a:gd name="T10" fmla="*/ 312 w 320"/>
                  <a:gd name="T11" fmla="*/ 0 h 176"/>
                  <a:gd name="T12" fmla="*/ 320 w 320"/>
                  <a:gd name="T13" fmla="*/ 88 h 176"/>
                  <a:gd name="T14" fmla="*/ 317 w 320"/>
                  <a:gd name="T15" fmla="*/ 106 h 176"/>
                  <a:gd name="T16" fmla="*/ 307 w 320"/>
                  <a:gd name="T17" fmla="*/ 124 h 176"/>
                  <a:gd name="T18" fmla="*/ 274 w 320"/>
                  <a:gd name="T19" fmla="*/ 152 h 176"/>
                  <a:gd name="T20" fmla="*/ 222 w 320"/>
                  <a:gd name="T21" fmla="*/ 170 h 176"/>
                  <a:gd name="T22" fmla="*/ 161 w 320"/>
                  <a:gd name="T23" fmla="*/ 176 h 176"/>
                  <a:gd name="T24" fmla="*/ 101 w 320"/>
                  <a:gd name="T25" fmla="*/ 170 h 176"/>
                  <a:gd name="T26" fmla="*/ 51 w 320"/>
                  <a:gd name="T27" fmla="*/ 153 h 176"/>
                  <a:gd name="T28" fmla="*/ 16 w 320"/>
                  <a:gd name="T29" fmla="*/ 126 h 176"/>
                  <a:gd name="T30" fmla="*/ 5 w 320"/>
                  <a:gd name="T31" fmla="*/ 109 h 176"/>
                  <a:gd name="T32" fmla="*/ 1 w 320"/>
                  <a:gd name="T33" fmla="*/ 90 h 176"/>
                  <a:gd name="T34" fmla="*/ 18 w 320"/>
                  <a:gd name="T35" fmla="*/ 100 h 176"/>
                  <a:gd name="T36" fmla="*/ 25 w 320"/>
                  <a:gd name="T37" fmla="*/ 113 h 176"/>
                  <a:gd name="T38" fmla="*/ 56 w 320"/>
                  <a:gd name="T39" fmla="*/ 138 h 176"/>
                  <a:gd name="T40" fmla="*/ 102 w 320"/>
                  <a:gd name="T41" fmla="*/ 155 h 176"/>
                  <a:gd name="T42" fmla="*/ 160 w 320"/>
                  <a:gd name="T43" fmla="*/ 161 h 176"/>
                  <a:gd name="T44" fmla="*/ 217 w 320"/>
                  <a:gd name="T45" fmla="*/ 155 h 176"/>
                  <a:gd name="T46" fmla="*/ 263 w 320"/>
                  <a:gd name="T47" fmla="*/ 139 h 176"/>
                  <a:gd name="T48" fmla="*/ 294 w 320"/>
                  <a:gd name="T49" fmla="*/ 115 h 176"/>
                  <a:gd name="T50" fmla="*/ 302 w 320"/>
                  <a:gd name="T51" fmla="*/ 103 h 176"/>
                  <a:gd name="T52" fmla="*/ 304 w 320"/>
                  <a:gd name="T53" fmla="*/ 88 h 176"/>
                  <a:gd name="T54" fmla="*/ 312 w 320"/>
                  <a:gd name="T55" fmla="*/ 16 h 176"/>
                  <a:gd name="T56" fmla="*/ 102 w 320"/>
                  <a:gd name="T57" fmla="*/ 22 h 176"/>
                  <a:gd name="T58" fmla="*/ 56 w 320"/>
                  <a:gd name="T59" fmla="*/ 40 h 176"/>
                  <a:gd name="T60" fmla="*/ 25 w 320"/>
                  <a:gd name="T61" fmla="*/ 64 h 176"/>
                  <a:gd name="T62" fmla="*/ 18 w 320"/>
                  <a:gd name="T63" fmla="*/ 77 h 176"/>
                  <a:gd name="T64" fmla="*/ 16 w 320"/>
                  <a:gd name="T65" fmla="*/ 90 h 176"/>
                  <a:gd name="T66" fmla="*/ 19 w 320"/>
                  <a:gd name="T67" fmla="*/ 103 h 1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</a:cxnLst>
                <a:rect l="0" t="0" r="r" b="b"/>
                <a:pathLst>
                  <a:path w="320" h="176">
                    <a:moveTo>
                      <a:pt x="1" y="90"/>
                    </a:moveTo>
                    <a:cubicBezTo>
                      <a:pt x="0" y="89"/>
                      <a:pt x="0" y="88"/>
                      <a:pt x="1" y="87"/>
                    </a:cubicBezTo>
                    <a:lnTo>
                      <a:pt x="4" y="71"/>
                    </a:lnTo>
                    <a:cubicBezTo>
                      <a:pt x="4" y="70"/>
                      <a:pt x="4" y="69"/>
                      <a:pt x="5" y="68"/>
                    </a:cubicBezTo>
                    <a:lnTo>
                      <a:pt x="14" y="53"/>
                    </a:lnTo>
                    <a:cubicBezTo>
                      <a:pt x="14" y="52"/>
                      <a:pt x="15" y="52"/>
                      <a:pt x="16" y="51"/>
                    </a:cubicBezTo>
                    <a:lnTo>
                      <a:pt x="49" y="26"/>
                    </a:lnTo>
                    <a:cubicBezTo>
                      <a:pt x="49" y="26"/>
                      <a:pt x="50" y="25"/>
                      <a:pt x="51" y="25"/>
                    </a:cubicBezTo>
                    <a:lnTo>
                      <a:pt x="99" y="7"/>
                    </a:lnTo>
                    <a:cubicBezTo>
                      <a:pt x="99" y="7"/>
                      <a:pt x="100" y="7"/>
                      <a:pt x="101" y="7"/>
                    </a:cubicBezTo>
                    <a:lnTo>
                      <a:pt x="160" y="1"/>
                    </a:lnTo>
                    <a:lnTo>
                      <a:pt x="312" y="0"/>
                    </a:lnTo>
                    <a:cubicBezTo>
                      <a:pt x="317" y="0"/>
                      <a:pt x="320" y="4"/>
                      <a:pt x="320" y="8"/>
                    </a:cubicBezTo>
                    <a:lnTo>
                      <a:pt x="320" y="88"/>
                    </a:lnTo>
                    <a:cubicBezTo>
                      <a:pt x="320" y="89"/>
                      <a:pt x="320" y="89"/>
                      <a:pt x="320" y="90"/>
                    </a:cubicBezTo>
                    <a:lnTo>
                      <a:pt x="317" y="106"/>
                    </a:lnTo>
                    <a:cubicBezTo>
                      <a:pt x="317" y="107"/>
                      <a:pt x="317" y="108"/>
                      <a:pt x="316" y="109"/>
                    </a:cubicBezTo>
                    <a:lnTo>
                      <a:pt x="307" y="124"/>
                    </a:lnTo>
                    <a:cubicBezTo>
                      <a:pt x="307" y="124"/>
                      <a:pt x="306" y="125"/>
                      <a:pt x="306" y="126"/>
                    </a:cubicBezTo>
                    <a:lnTo>
                      <a:pt x="274" y="152"/>
                    </a:lnTo>
                    <a:cubicBezTo>
                      <a:pt x="273" y="152"/>
                      <a:pt x="272" y="153"/>
                      <a:pt x="271" y="153"/>
                    </a:cubicBezTo>
                    <a:lnTo>
                      <a:pt x="222" y="170"/>
                    </a:lnTo>
                    <a:cubicBezTo>
                      <a:pt x="222" y="170"/>
                      <a:pt x="221" y="170"/>
                      <a:pt x="220" y="170"/>
                    </a:cubicBezTo>
                    <a:lnTo>
                      <a:pt x="161" y="176"/>
                    </a:lnTo>
                    <a:cubicBezTo>
                      <a:pt x="161" y="176"/>
                      <a:pt x="160" y="176"/>
                      <a:pt x="160" y="176"/>
                    </a:cubicBezTo>
                    <a:lnTo>
                      <a:pt x="101" y="170"/>
                    </a:lnTo>
                    <a:cubicBezTo>
                      <a:pt x="100" y="170"/>
                      <a:pt x="99" y="170"/>
                      <a:pt x="99" y="170"/>
                    </a:cubicBezTo>
                    <a:lnTo>
                      <a:pt x="51" y="153"/>
                    </a:lnTo>
                    <a:cubicBezTo>
                      <a:pt x="50" y="153"/>
                      <a:pt x="49" y="152"/>
                      <a:pt x="49" y="152"/>
                    </a:cubicBezTo>
                    <a:lnTo>
                      <a:pt x="16" y="126"/>
                    </a:lnTo>
                    <a:cubicBezTo>
                      <a:pt x="15" y="125"/>
                      <a:pt x="14" y="124"/>
                      <a:pt x="14" y="124"/>
                    </a:cubicBezTo>
                    <a:lnTo>
                      <a:pt x="5" y="109"/>
                    </a:lnTo>
                    <a:cubicBezTo>
                      <a:pt x="4" y="108"/>
                      <a:pt x="4" y="107"/>
                      <a:pt x="4" y="106"/>
                    </a:cubicBezTo>
                    <a:lnTo>
                      <a:pt x="1" y="90"/>
                    </a:lnTo>
                    <a:close/>
                    <a:moveTo>
                      <a:pt x="19" y="103"/>
                    </a:moveTo>
                    <a:lnTo>
                      <a:pt x="18" y="100"/>
                    </a:lnTo>
                    <a:lnTo>
                      <a:pt x="27" y="115"/>
                    </a:lnTo>
                    <a:lnTo>
                      <a:pt x="25" y="113"/>
                    </a:lnTo>
                    <a:lnTo>
                      <a:pt x="58" y="139"/>
                    </a:lnTo>
                    <a:lnTo>
                      <a:pt x="56" y="138"/>
                    </a:lnTo>
                    <a:lnTo>
                      <a:pt x="104" y="155"/>
                    </a:lnTo>
                    <a:lnTo>
                      <a:pt x="102" y="155"/>
                    </a:lnTo>
                    <a:lnTo>
                      <a:pt x="161" y="161"/>
                    </a:lnTo>
                    <a:lnTo>
                      <a:pt x="160" y="161"/>
                    </a:lnTo>
                    <a:lnTo>
                      <a:pt x="219" y="155"/>
                    </a:lnTo>
                    <a:lnTo>
                      <a:pt x="217" y="155"/>
                    </a:lnTo>
                    <a:lnTo>
                      <a:pt x="266" y="138"/>
                    </a:lnTo>
                    <a:lnTo>
                      <a:pt x="263" y="139"/>
                    </a:lnTo>
                    <a:lnTo>
                      <a:pt x="295" y="113"/>
                    </a:lnTo>
                    <a:lnTo>
                      <a:pt x="294" y="115"/>
                    </a:lnTo>
                    <a:lnTo>
                      <a:pt x="303" y="100"/>
                    </a:lnTo>
                    <a:lnTo>
                      <a:pt x="302" y="103"/>
                    </a:lnTo>
                    <a:lnTo>
                      <a:pt x="305" y="87"/>
                    </a:lnTo>
                    <a:lnTo>
                      <a:pt x="304" y="88"/>
                    </a:lnTo>
                    <a:lnTo>
                      <a:pt x="304" y="8"/>
                    </a:lnTo>
                    <a:lnTo>
                      <a:pt x="312" y="16"/>
                    </a:lnTo>
                    <a:lnTo>
                      <a:pt x="161" y="16"/>
                    </a:lnTo>
                    <a:lnTo>
                      <a:pt x="102" y="22"/>
                    </a:lnTo>
                    <a:lnTo>
                      <a:pt x="104" y="22"/>
                    </a:lnTo>
                    <a:lnTo>
                      <a:pt x="56" y="40"/>
                    </a:lnTo>
                    <a:lnTo>
                      <a:pt x="58" y="39"/>
                    </a:lnTo>
                    <a:lnTo>
                      <a:pt x="25" y="64"/>
                    </a:lnTo>
                    <a:lnTo>
                      <a:pt x="27" y="62"/>
                    </a:lnTo>
                    <a:lnTo>
                      <a:pt x="18" y="77"/>
                    </a:lnTo>
                    <a:lnTo>
                      <a:pt x="19" y="74"/>
                    </a:lnTo>
                    <a:lnTo>
                      <a:pt x="16" y="90"/>
                    </a:lnTo>
                    <a:lnTo>
                      <a:pt x="16" y="87"/>
                    </a:lnTo>
                    <a:lnTo>
                      <a:pt x="19" y="103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" name="Freeform 188">
                <a:extLst>
                  <a:ext uri="{FF2B5EF4-FFF2-40B4-BE49-F238E27FC236}">
                    <a16:creationId xmlns:a16="http://schemas.microsoft.com/office/drawing/2014/main" id="{71E1A960-BA83-4761-B0E9-56938A94C4F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00" y="2253"/>
                <a:ext cx="75" cy="36"/>
              </a:xfrm>
              <a:custGeom>
                <a:avLst/>
                <a:gdLst>
                  <a:gd name="T0" fmla="*/ 0 w 304"/>
                  <a:gd name="T1" fmla="*/ 72 h 144"/>
                  <a:gd name="T2" fmla="*/ 152 w 304"/>
                  <a:gd name="T3" fmla="*/ 0 h 144"/>
                  <a:gd name="T4" fmla="*/ 152 w 304"/>
                  <a:gd name="T5" fmla="*/ 0 h 144"/>
                  <a:gd name="T6" fmla="*/ 304 w 304"/>
                  <a:gd name="T7" fmla="*/ 0 h 144"/>
                  <a:gd name="T8" fmla="*/ 304 w 304"/>
                  <a:gd name="T9" fmla="*/ 72 h 144"/>
                  <a:gd name="T10" fmla="*/ 304 w 304"/>
                  <a:gd name="T11" fmla="*/ 72 h 144"/>
                  <a:gd name="T12" fmla="*/ 152 w 304"/>
                  <a:gd name="T13" fmla="*/ 144 h 144"/>
                  <a:gd name="T14" fmla="*/ 152 w 304"/>
                  <a:gd name="T15" fmla="*/ 144 h 144"/>
                  <a:gd name="T16" fmla="*/ 152 w 304"/>
                  <a:gd name="T17" fmla="*/ 144 h 144"/>
                  <a:gd name="T18" fmla="*/ 0 w 304"/>
                  <a:gd name="T19" fmla="*/ 72 h 144"/>
                  <a:gd name="T20" fmla="*/ 0 w 304"/>
                  <a:gd name="T21" fmla="*/ 72 h 1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304" h="144">
                    <a:moveTo>
                      <a:pt x="0" y="72"/>
                    </a:moveTo>
                    <a:cubicBezTo>
                      <a:pt x="0" y="33"/>
                      <a:pt x="69" y="0"/>
                      <a:pt x="152" y="0"/>
                    </a:cubicBezTo>
                    <a:lnTo>
                      <a:pt x="152" y="0"/>
                    </a:lnTo>
                    <a:cubicBezTo>
                      <a:pt x="203" y="0"/>
                      <a:pt x="254" y="0"/>
                      <a:pt x="304" y="0"/>
                    </a:cubicBezTo>
                    <a:cubicBezTo>
                      <a:pt x="304" y="24"/>
                      <a:pt x="304" y="48"/>
                      <a:pt x="304" y="72"/>
                    </a:cubicBezTo>
                    <a:lnTo>
                      <a:pt x="304" y="72"/>
                    </a:lnTo>
                    <a:cubicBezTo>
                      <a:pt x="304" y="112"/>
                      <a:pt x="236" y="144"/>
                      <a:pt x="152" y="144"/>
                    </a:cubicBezTo>
                    <a:cubicBezTo>
                      <a:pt x="152" y="144"/>
                      <a:pt x="152" y="144"/>
                      <a:pt x="152" y="144"/>
                    </a:cubicBezTo>
                    <a:lnTo>
                      <a:pt x="152" y="144"/>
                    </a:lnTo>
                    <a:cubicBezTo>
                      <a:pt x="69" y="144"/>
                      <a:pt x="0" y="112"/>
                      <a:pt x="0" y="72"/>
                    </a:cubicBezTo>
                    <a:cubicBezTo>
                      <a:pt x="0" y="72"/>
                      <a:pt x="0" y="72"/>
                      <a:pt x="0" y="72"/>
                    </a:cubicBezTo>
                    <a:close/>
                  </a:path>
                </a:pathLst>
              </a:custGeom>
              <a:solidFill>
                <a:srgbClr val="948A54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" name="Freeform 189">
                <a:extLst>
                  <a:ext uri="{FF2B5EF4-FFF2-40B4-BE49-F238E27FC236}">
                    <a16:creationId xmlns:a16="http://schemas.microsoft.com/office/drawing/2014/main" id="{1CC7F321-FFE3-481A-850A-DC82319A4EFC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098" y="2251"/>
                <a:ext cx="79" cy="40"/>
              </a:xfrm>
              <a:custGeom>
                <a:avLst/>
                <a:gdLst>
                  <a:gd name="T0" fmla="*/ 1 w 320"/>
                  <a:gd name="T1" fmla="*/ 79 h 160"/>
                  <a:gd name="T2" fmla="*/ 5 w 320"/>
                  <a:gd name="T3" fmla="*/ 62 h 160"/>
                  <a:gd name="T4" fmla="*/ 16 w 320"/>
                  <a:gd name="T5" fmla="*/ 46 h 160"/>
                  <a:gd name="T6" fmla="*/ 51 w 320"/>
                  <a:gd name="T7" fmla="*/ 22 h 160"/>
                  <a:gd name="T8" fmla="*/ 101 w 320"/>
                  <a:gd name="T9" fmla="*/ 7 h 160"/>
                  <a:gd name="T10" fmla="*/ 312 w 320"/>
                  <a:gd name="T11" fmla="*/ 0 h 160"/>
                  <a:gd name="T12" fmla="*/ 320 w 320"/>
                  <a:gd name="T13" fmla="*/ 80 h 160"/>
                  <a:gd name="T14" fmla="*/ 317 w 320"/>
                  <a:gd name="T15" fmla="*/ 97 h 160"/>
                  <a:gd name="T16" fmla="*/ 307 w 320"/>
                  <a:gd name="T17" fmla="*/ 113 h 160"/>
                  <a:gd name="T18" fmla="*/ 273 w 320"/>
                  <a:gd name="T19" fmla="*/ 138 h 160"/>
                  <a:gd name="T20" fmla="*/ 222 w 320"/>
                  <a:gd name="T21" fmla="*/ 154 h 160"/>
                  <a:gd name="T22" fmla="*/ 161 w 320"/>
                  <a:gd name="T23" fmla="*/ 160 h 160"/>
                  <a:gd name="T24" fmla="*/ 101 w 320"/>
                  <a:gd name="T25" fmla="*/ 154 h 160"/>
                  <a:gd name="T26" fmla="*/ 51 w 320"/>
                  <a:gd name="T27" fmla="*/ 139 h 160"/>
                  <a:gd name="T28" fmla="*/ 16 w 320"/>
                  <a:gd name="T29" fmla="*/ 115 h 160"/>
                  <a:gd name="T30" fmla="*/ 5 w 320"/>
                  <a:gd name="T31" fmla="*/ 100 h 160"/>
                  <a:gd name="T32" fmla="*/ 1 w 320"/>
                  <a:gd name="T33" fmla="*/ 82 h 160"/>
                  <a:gd name="T34" fmla="*/ 18 w 320"/>
                  <a:gd name="T35" fmla="*/ 91 h 160"/>
                  <a:gd name="T36" fmla="*/ 25 w 320"/>
                  <a:gd name="T37" fmla="*/ 102 h 160"/>
                  <a:gd name="T38" fmla="*/ 56 w 320"/>
                  <a:gd name="T39" fmla="*/ 124 h 160"/>
                  <a:gd name="T40" fmla="*/ 102 w 320"/>
                  <a:gd name="T41" fmla="*/ 139 h 160"/>
                  <a:gd name="T42" fmla="*/ 160 w 320"/>
                  <a:gd name="T43" fmla="*/ 145 h 160"/>
                  <a:gd name="T44" fmla="*/ 217 w 320"/>
                  <a:gd name="T45" fmla="*/ 139 h 160"/>
                  <a:gd name="T46" fmla="*/ 264 w 320"/>
                  <a:gd name="T47" fmla="*/ 125 h 160"/>
                  <a:gd name="T48" fmla="*/ 294 w 320"/>
                  <a:gd name="T49" fmla="*/ 104 h 160"/>
                  <a:gd name="T50" fmla="*/ 302 w 320"/>
                  <a:gd name="T51" fmla="*/ 94 h 160"/>
                  <a:gd name="T52" fmla="*/ 304 w 320"/>
                  <a:gd name="T53" fmla="*/ 80 h 160"/>
                  <a:gd name="T54" fmla="*/ 312 w 320"/>
                  <a:gd name="T55" fmla="*/ 16 h 160"/>
                  <a:gd name="T56" fmla="*/ 102 w 320"/>
                  <a:gd name="T57" fmla="*/ 22 h 160"/>
                  <a:gd name="T58" fmla="*/ 56 w 320"/>
                  <a:gd name="T59" fmla="*/ 37 h 160"/>
                  <a:gd name="T60" fmla="*/ 25 w 320"/>
                  <a:gd name="T61" fmla="*/ 59 h 160"/>
                  <a:gd name="T62" fmla="*/ 18 w 320"/>
                  <a:gd name="T63" fmla="*/ 71 h 160"/>
                  <a:gd name="T64" fmla="*/ 16 w 320"/>
                  <a:gd name="T65" fmla="*/ 82 h 160"/>
                  <a:gd name="T66" fmla="*/ 19 w 320"/>
                  <a:gd name="T67" fmla="*/ 94 h 1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</a:cxnLst>
                <a:rect l="0" t="0" r="r" b="b"/>
                <a:pathLst>
                  <a:path w="320" h="160">
                    <a:moveTo>
                      <a:pt x="1" y="82"/>
                    </a:moveTo>
                    <a:cubicBezTo>
                      <a:pt x="0" y="81"/>
                      <a:pt x="0" y="80"/>
                      <a:pt x="1" y="79"/>
                    </a:cubicBezTo>
                    <a:lnTo>
                      <a:pt x="4" y="65"/>
                    </a:lnTo>
                    <a:cubicBezTo>
                      <a:pt x="4" y="64"/>
                      <a:pt x="4" y="63"/>
                      <a:pt x="5" y="62"/>
                    </a:cubicBezTo>
                    <a:lnTo>
                      <a:pt x="14" y="48"/>
                    </a:lnTo>
                    <a:cubicBezTo>
                      <a:pt x="14" y="47"/>
                      <a:pt x="15" y="46"/>
                      <a:pt x="16" y="46"/>
                    </a:cubicBezTo>
                    <a:lnTo>
                      <a:pt x="49" y="23"/>
                    </a:lnTo>
                    <a:cubicBezTo>
                      <a:pt x="50" y="22"/>
                      <a:pt x="50" y="22"/>
                      <a:pt x="51" y="22"/>
                    </a:cubicBezTo>
                    <a:lnTo>
                      <a:pt x="99" y="7"/>
                    </a:lnTo>
                    <a:cubicBezTo>
                      <a:pt x="100" y="7"/>
                      <a:pt x="100" y="7"/>
                      <a:pt x="101" y="7"/>
                    </a:cubicBezTo>
                    <a:lnTo>
                      <a:pt x="160" y="1"/>
                    </a:lnTo>
                    <a:lnTo>
                      <a:pt x="312" y="0"/>
                    </a:lnTo>
                    <a:cubicBezTo>
                      <a:pt x="317" y="0"/>
                      <a:pt x="320" y="4"/>
                      <a:pt x="320" y="8"/>
                    </a:cubicBezTo>
                    <a:lnTo>
                      <a:pt x="320" y="80"/>
                    </a:lnTo>
                    <a:cubicBezTo>
                      <a:pt x="320" y="81"/>
                      <a:pt x="320" y="82"/>
                      <a:pt x="320" y="82"/>
                    </a:cubicBezTo>
                    <a:lnTo>
                      <a:pt x="317" y="97"/>
                    </a:lnTo>
                    <a:cubicBezTo>
                      <a:pt x="317" y="98"/>
                      <a:pt x="317" y="99"/>
                      <a:pt x="316" y="100"/>
                    </a:cubicBezTo>
                    <a:lnTo>
                      <a:pt x="307" y="113"/>
                    </a:lnTo>
                    <a:cubicBezTo>
                      <a:pt x="307" y="114"/>
                      <a:pt x="306" y="114"/>
                      <a:pt x="305" y="115"/>
                    </a:cubicBezTo>
                    <a:lnTo>
                      <a:pt x="273" y="138"/>
                    </a:lnTo>
                    <a:cubicBezTo>
                      <a:pt x="272" y="138"/>
                      <a:pt x="272" y="139"/>
                      <a:pt x="271" y="139"/>
                    </a:cubicBezTo>
                    <a:lnTo>
                      <a:pt x="222" y="154"/>
                    </a:lnTo>
                    <a:cubicBezTo>
                      <a:pt x="221" y="154"/>
                      <a:pt x="221" y="154"/>
                      <a:pt x="220" y="154"/>
                    </a:cubicBezTo>
                    <a:lnTo>
                      <a:pt x="161" y="160"/>
                    </a:lnTo>
                    <a:cubicBezTo>
                      <a:pt x="161" y="160"/>
                      <a:pt x="160" y="160"/>
                      <a:pt x="160" y="160"/>
                    </a:cubicBezTo>
                    <a:lnTo>
                      <a:pt x="101" y="154"/>
                    </a:lnTo>
                    <a:cubicBezTo>
                      <a:pt x="100" y="154"/>
                      <a:pt x="100" y="154"/>
                      <a:pt x="99" y="154"/>
                    </a:cubicBezTo>
                    <a:lnTo>
                      <a:pt x="51" y="139"/>
                    </a:lnTo>
                    <a:cubicBezTo>
                      <a:pt x="50" y="139"/>
                      <a:pt x="50" y="139"/>
                      <a:pt x="49" y="138"/>
                    </a:cubicBezTo>
                    <a:lnTo>
                      <a:pt x="16" y="115"/>
                    </a:lnTo>
                    <a:cubicBezTo>
                      <a:pt x="15" y="114"/>
                      <a:pt x="14" y="114"/>
                      <a:pt x="14" y="113"/>
                    </a:cubicBezTo>
                    <a:lnTo>
                      <a:pt x="5" y="100"/>
                    </a:lnTo>
                    <a:cubicBezTo>
                      <a:pt x="4" y="99"/>
                      <a:pt x="4" y="98"/>
                      <a:pt x="4" y="97"/>
                    </a:cubicBezTo>
                    <a:lnTo>
                      <a:pt x="1" y="82"/>
                    </a:lnTo>
                    <a:close/>
                    <a:moveTo>
                      <a:pt x="19" y="94"/>
                    </a:moveTo>
                    <a:lnTo>
                      <a:pt x="18" y="91"/>
                    </a:lnTo>
                    <a:lnTo>
                      <a:pt x="27" y="104"/>
                    </a:lnTo>
                    <a:lnTo>
                      <a:pt x="25" y="102"/>
                    </a:lnTo>
                    <a:lnTo>
                      <a:pt x="58" y="125"/>
                    </a:lnTo>
                    <a:lnTo>
                      <a:pt x="56" y="124"/>
                    </a:lnTo>
                    <a:lnTo>
                      <a:pt x="104" y="139"/>
                    </a:lnTo>
                    <a:lnTo>
                      <a:pt x="102" y="139"/>
                    </a:lnTo>
                    <a:lnTo>
                      <a:pt x="161" y="145"/>
                    </a:lnTo>
                    <a:lnTo>
                      <a:pt x="160" y="145"/>
                    </a:lnTo>
                    <a:lnTo>
                      <a:pt x="219" y="139"/>
                    </a:lnTo>
                    <a:lnTo>
                      <a:pt x="217" y="139"/>
                    </a:lnTo>
                    <a:lnTo>
                      <a:pt x="266" y="124"/>
                    </a:lnTo>
                    <a:lnTo>
                      <a:pt x="264" y="125"/>
                    </a:lnTo>
                    <a:lnTo>
                      <a:pt x="296" y="102"/>
                    </a:lnTo>
                    <a:lnTo>
                      <a:pt x="294" y="104"/>
                    </a:lnTo>
                    <a:lnTo>
                      <a:pt x="303" y="91"/>
                    </a:lnTo>
                    <a:lnTo>
                      <a:pt x="302" y="94"/>
                    </a:lnTo>
                    <a:lnTo>
                      <a:pt x="305" y="79"/>
                    </a:lnTo>
                    <a:lnTo>
                      <a:pt x="304" y="80"/>
                    </a:lnTo>
                    <a:lnTo>
                      <a:pt x="304" y="8"/>
                    </a:lnTo>
                    <a:lnTo>
                      <a:pt x="312" y="16"/>
                    </a:lnTo>
                    <a:lnTo>
                      <a:pt x="161" y="16"/>
                    </a:lnTo>
                    <a:lnTo>
                      <a:pt x="102" y="22"/>
                    </a:lnTo>
                    <a:lnTo>
                      <a:pt x="104" y="22"/>
                    </a:lnTo>
                    <a:lnTo>
                      <a:pt x="56" y="37"/>
                    </a:lnTo>
                    <a:lnTo>
                      <a:pt x="58" y="36"/>
                    </a:lnTo>
                    <a:lnTo>
                      <a:pt x="25" y="59"/>
                    </a:lnTo>
                    <a:lnTo>
                      <a:pt x="27" y="57"/>
                    </a:lnTo>
                    <a:lnTo>
                      <a:pt x="18" y="71"/>
                    </a:lnTo>
                    <a:lnTo>
                      <a:pt x="19" y="68"/>
                    </a:lnTo>
                    <a:lnTo>
                      <a:pt x="16" y="82"/>
                    </a:lnTo>
                    <a:lnTo>
                      <a:pt x="16" y="79"/>
                    </a:lnTo>
                    <a:lnTo>
                      <a:pt x="19" y="9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" name="Freeform 190">
                <a:extLst>
                  <a:ext uri="{FF2B5EF4-FFF2-40B4-BE49-F238E27FC236}">
                    <a16:creationId xmlns:a16="http://schemas.microsoft.com/office/drawing/2014/main" id="{F96C3DAA-418D-4771-926F-9B5839FB3FD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24" y="2178"/>
                <a:ext cx="76" cy="40"/>
              </a:xfrm>
              <a:custGeom>
                <a:avLst/>
                <a:gdLst>
                  <a:gd name="T0" fmla="*/ 0 w 304"/>
                  <a:gd name="T1" fmla="*/ 80 h 160"/>
                  <a:gd name="T2" fmla="*/ 152 w 304"/>
                  <a:gd name="T3" fmla="*/ 0 h 160"/>
                  <a:gd name="T4" fmla="*/ 152 w 304"/>
                  <a:gd name="T5" fmla="*/ 0 h 160"/>
                  <a:gd name="T6" fmla="*/ 304 w 304"/>
                  <a:gd name="T7" fmla="*/ 0 h 160"/>
                  <a:gd name="T8" fmla="*/ 304 w 304"/>
                  <a:gd name="T9" fmla="*/ 80 h 160"/>
                  <a:gd name="T10" fmla="*/ 304 w 304"/>
                  <a:gd name="T11" fmla="*/ 80 h 160"/>
                  <a:gd name="T12" fmla="*/ 152 w 304"/>
                  <a:gd name="T13" fmla="*/ 160 h 160"/>
                  <a:gd name="T14" fmla="*/ 152 w 304"/>
                  <a:gd name="T15" fmla="*/ 160 h 160"/>
                  <a:gd name="T16" fmla="*/ 152 w 304"/>
                  <a:gd name="T17" fmla="*/ 160 h 160"/>
                  <a:gd name="T18" fmla="*/ 0 w 304"/>
                  <a:gd name="T19" fmla="*/ 80 h 160"/>
                  <a:gd name="T20" fmla="*/ 0 w 304"/>
                  <a:gd name="T21" fmla="*/ 80 h 1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304" h="160">
                    <a:moveTo>
                      <a:pt x="0" y="80"/>
                    </a:moveTo>
                    <a:cubicBezTo>
                      <a:pt x="0" y="36"/>
                      <a:pt x="69" y="0"/>
                      <a:pt x="152" y="0"/>
                    </a:cubicBezTo>
                    <a:lnTo>
                      <a:pt x="152" y="0"/>
                    </a:lnTo>
                    <a:cubicBezTo>
                      <a:pt x="203" y="0"/>
                      <a:pt x="254" y="0"/>
                      <a:pt x="304" y="0"/>
                    </a:cubicBezTo>
                    <a:cubicBezTo>
                      <a:pt x="304" y="27"/>
                      <a:pt x="304" y="54"/>
                      <a:pt x="304" y="80"/>
                    </a:cubicBezTo>
                    <a:lnTo>
                      <a:pt x="304" y="80"/>
                    </a:lnTo>
                    <a:cubicBezTo>
                      <a:pt x="304" y="125"/>
                      <a:pt x="236" y="160"/>
                      <a:pt x="152" y="160"/>
                    </a:cubicBezTo>
                    <a:cubicBezTo>
                      <a:pt x="152" y="160"/>
                      <a:pt x="152" y="160"/>
                      <a:pt x="152" y="160"/>
                    </a:cubicBezTo>
                    <a:lnTo>
                      <a:pt x="152" y="160"/>
                    </a:lnTo>
                    <a:cubicBezTo>
                      <a:pt x="69" y="160"/>
                      <a:pt x="0" y="125"/>
                      <a:pt x="0" y="80"/>
                    </a:cubicBezTo>
                    <a:cubicBezTo>
                      <a:pt x="0" y="80"/>
                      <a:pt x="0" y="80"/>
                      <a:pt x="0" y="80"/>
                    </a:cubicBezTo>
                    <a:close/>
                  </a:path>
                </a:pathLst>
              </a:custGeom>
              <a:solidFill>
                <a:srgbClr val="E6B9B8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" name="Freeform 191">
                <a:extLst>
                  <a:ext uri="{FF2B5EF4-FFF2-40B4-BE49-F238E27FC236}">
                    <a16:creationId xmlns:a16="http://schemas.microsoft.com/office/drawing/2014/main" id="{F1DE21E9-DC3D-4961-8C10-754A1948732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022" y="2176"/>
                <a:ext cx="80" cy="44"/>
              </a:xfrm>
              <a:custGeom>
                <a:avLst/>
                <a:gdLst>
                  <a:gd name="T0" fmla="*/ 1 w 320"/>
                  <a:gd name="T1" fmla="*/ 87 h 176"/>
                  <a:gd name="T2" fmla="*/ 5 w 320"/>
                  <a:gd name="T3" fmla="*/ 68 h 176"/>
                  <a:gd name="T4" fmla="*/ 16 w 320"/>
                  <a:gd name="T5" fmla="*/ 51 h 176"/>
                  <a:gd name="T6" fmla="*/ 51 w 320"/>
                  <a:gd name="T7" fmla="*/ 25 h 176"/>
                  <a:gd name="T8" fmla="*/ 101 w 320"/>
                  <a:gd name="T9" fmla="*/ 7 h 176"/>
                  <a:gd name="T10" fmla="*/ 312 w 320"/>
                  <a:gd name="T11" fmla="*/ 0 h 176"/>
                  <a:gd name="T12" fmla="*/ 320 w 320"/>
                  <a:gd name="T13" fmla="*/ 88 h 176"/>
                  <a:gd name="T14" fmla="*/ 317 w 320"/>
                  <a:gd name="T15" fmla="*/ 106 h 176"/>
                  <a:gd name="T16" fmla="*/ 307 w 320"/>
                  <a:gd name="T17" fmla="*/ 124 h 176"/>
                  <a:gd name="T18" fmla="*/ 274 w 320"/>
                  <a:gd name="T19" fmla="*/ 152 h 176"/>
                  <a:gd name="T20" fmla="*/ 222 w 320"/>
                  <a:gd name="T21" fmla="*/ 170 h 176"/>
                  <a:gd name="T22" fmla="*/ 161 w 320"/>
                  <a:gd name="T23" fmla="*/ 176 h 176"/>
                  <a:gd name="T24" fmla="*/ 101 w 320"/>
                  <a:gd name="T25" fmla="*/ 170 h 176"/>
                  <a:gd name="T26" fmla="*/ 51 w 320"/>
                  <a:gd name="T27" fmla="*/ 153 h 176"/>
                  <a:gd name="T28" fmla="*/ 16 w 320"/>
                  <a:gd name="T29" fmla="*/ 126 h 176"/>
                  <a:gd name="T30" fmla="*/ 5 w 320"/>
                  <a:gd name="T31" fmla="*/ 109 h 176"/>
                  <a:gd name="T32" fmla="*/ 1 w 320"/>
                  <a:gd name="T33" fmla="*/ 90 h 176"/>
                  <a:gd name="T34" fmla="*/ 18 w 320"/>
                  <a:gd name="T35" fmla="*/ 100 h 176"/>
                  <a:gd name="T36" fmla="*/ 25 w 320"/>
                  <a:gd name="T37" fmla="*/ 113 h 176"/>
                  <a:gd name="T38" fmla="*/ 56 w 320"/>
                  <a:gd name="T39" fmla="*/ 138 h 176"/>
                  <a:gd name="T40" fmla="*/ 102 w 320"/>
                  <a:gd name="T41" fmla="*/ 155 h 176"/>
                  <a:gd name="T42" fmla="*/ 160 w 320"/>
                  <a:gd name="T43" fmla="*/ 161 h 176"/>
                  <a:gd name="T44" fmla="*/ 217 w 320"/>
                  <a:gd name="T45" fmla="*/ 155 h 176"/>
                  <a:gd name="T46" fmla="*/ 263 w 320"/>
                  <a:gd name="T47" fmla="*/ 139 h 176"/>
                  <a:gd name="T48" fmla="*/ 294 w 320"/>
                  <a:gd name="T49" fmla="*/ 115 h 176"/>
                  <a:gd name="T50" fmla="*/ 302 w 320"/>
                  <a:gd name="T51" fmla="*/ 103 h 176"/>
                  <a:gd name="T52" fmla="*/ 304 w 320"/>
                  <a:gd name="T53" fmla="*/ 88 h 176"/>
                  <a:gd name="T54" fmla="*/ 312 w 320"/>
                  <a:gd name="T55" fmla="*/ 16 h 176"/>
                  <a:gd name="T56" fmla="*/ 102 w 320"/>
                  <a:gd name="T57" fmla="*/ 22 h 176"/>
                  <a:gd name="T58" fmla="*/ 56 w 320"/>
                  <a:gd name="T59" fmla="*/ 40 h 176"/>
                  <a:gd name="T60" fmla="*/ 25 w 320"/>
                  <a:gd name="T61" fmla="*/ 64 h 176"/>
                  <a:gd name="T62" fmla="*/ 18 w 320"/>
                  <a:gd name="T63" fmla="*/ 77 h 176"/>
                  <a:gd name="T64" fmla="*/ 16 w 320"/>
                  <a:gd name="T65" fmla="*/ 90 h 176"/>
                  <a:gd name="T66" fmla="*/ 19 w 320"/>
                  <a:gd name="T67" fmla="*/ 103 h 1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</a:cxnLst>
                <a:rect l="0" t="0" r="r" b="b"/>
                <a:pathLst>
                  <a:path w="320" h="176">
                    <a:moveTo>
                      <a:pt x="1" y="90"/>
                    </a:moveTo>
                    <a:cubicBezTo>
                      <a:pt x="0" y="89"/>
                      <a:pt x="0" y="88"/>
                      <a:pt x="1" y="87"/>
                    </a:cubicBezTo>
                    <a:lnTo>
                      <a:pt x="4" y="71"/>
                    </a:lnTo>
                    <a:cubicBezTo>
                      <a:pt x="4" y="70"/>
                      <a:pt x="4" y="69"/>
                      <a:pt x="5" y="68"/>
                    </a:cubicBezTo>
                    <a:lnTo>
                      <a:pt x="14" y="53"/>
                    </a:lnTo>
                    <a:cubicBezTo>
                      <a:pt x="14" y="52"/>
                      <a:pt x="15" y="52"/>
                      <a:pt x="16" y="51"/>
                    </a:cubicBezTo>
                    <a:lnTo>
                      <a:pt x="49" y="26"/>
                    </a:lnTo>
                    <a:cubicBezTo>
                      <a:pt x="49" y="26"/>
                      <a:pt x="50" y="25"/>
                      <a:pt x="51" y="25"/>
                    </a:cubicBezTo>
                    <a:lnTo>
                      <a:pt x="99" y="7"/>
                    </a:lnTo>
                    <a:cubicBezTo>
                      <a:pt x="99" y="7"/>
                      <a:pt x="100" y="7"/>
                      <a:pt x="101" y="7"/>
                    </a:cubicBezTo>
                    <a:lnTo>
                      <a:pt x="160" y="1"/>
                    </a:lnTo>
                    <a:lnTo>
                      <a:pt x="312" y="0"/>
                    </a:lnTo>
                    <a:cubicBezTo>
                      <a:pt x="317" y="0"/>
                      <a:pt x="320" y="4"/>
                      <a:pt x="320" y="8"/>
                    </a:cubicBezTo>
                    <a:lnTo>
                      <a:pt x="320" y="88"/>
                    </a:lnTo>
                    <a:cubicBezTo>
                      <a:pt x="320" y="89"/>
                      <a:pt x="320" y="89"/>
                      <a:pt x="320" y="90"/>
                    </a:cubicBezTo>
                    <a:lnTo>
                      <a:pt x="317" y="106"/>
                    </a:lnTo>
                    <a:cubicBezTo>
                      <a:pt x="317" y="107"/>
                      <a:pt x="317" y="108"/>
                      <a:pt x="316" y="109"/>
                    </a:cubicBezTo>
                    <a:lnTo>
                      <a:pt x="307" y="124"/>
                    </a:lnTo>
                    <a:cubicBezTo>
                      <a:pt x="307" y="124"/>
                      <a:pt x="306" y="125"/>
                      <a:pt x="306" y="126"/>
                    </a:cubicBezTo>
                    <a:lnTo>
                      <a:pt x="274" y="152"/>
                    </a:lnTo>
                    <a:cubicBezTo>
                      <a:pt x="273" y="152"/>
                      <a:pt x="272" y="153"/>
                      <a:pt x="271" y="153"/>
                    </a:cubicBezTo>
                    <a:lnTo>
                      <a:pt x="222" y="170"/>
                    </a:lnTo>
                    <a:cubicBezTo>
                      <a:pt x="222" y="170"/>
                      <a:pt x="221" y="170"/>
                      <a:pt x="220" y="170"/>
                    </a:cubicBezTo>
                    <a:lnTo>
                      <a:pt x="161" y="176"/>
                    </a:lnTo>
                    <a:cubicBezTo>
                      <a:pt x="161" y="176"/>
                      <a:pt x="160" y="176"/>
                      <a:pt x="160" y="176"/>
                    </a:cubicBezTo>
                    <a:lnTo>
                      <a:pt x="101" y="170"/>
                    </a:lnTo>
                    <a:cubicBezTo>
                      <a:pt x="100" y="170"/>
                      <a:pt x="99" y="170"/>
                      <a:pt x="99" y="170"/>
                    </a:cubicBezTo>
                    <a:lnTo>
                      <a:pt x="51" y="153"/>
                    </a:lnTo>
                    <a:cubicBezTo>
                      <a:pt x="50" y="153"/>
                      <a:pt x="49" y="152"/>
                      <a:pt x="49" y="152"/>
                    </a:cubicBezTo>
                    <a:lnTo>
                      <a:pt x="16" y="126"/>
                    </a:lnTo>
                    <a:cubicBezTo>
                      <a:pt x="15" y="125"/>
                      <a:pt x="14" y="124"/>
                      <a:pt x="14" y="124"/>
                    </a:cubicBezTo>
                    <a:lnTo>
                      <a:pt x="5" y="109"/>
                    </a:lnTo>
                    <a:cubicBezTo>
                      <a:pt x="4" y="108"/>
                      <a:pt x="4" y="107"/>
                      <a:pt x="4" y="106"/>
                    </a:cubicBezTo>
                    <a:lnTo>
                      <a:pt x="1" y="90"/>
                    </a:lnTo>
                    <a:close/>
                    <a:moveTo>
                      <a:pt x="19" y="103"/>
                    </a:moveTo>
                    <a:lnTo>
                      <a:pt x="18" y="100"/>
                    </a:lnTo>
                    <a:lnTo>
                      <a:pt x="27" y="115"/>
                    </a:lnTo>
                    <a:lnTo>
                      <a:pt x="25" y="113"/>
                    </a:lnTo>
                    <a:lnTo>
                      <a:pt x="58" y="139"/>
                    </a:lnTo>
                    <a:lnTo>
                      <a:pt x="56" y="138"/>
                    </a:lnTo>
                    <a:lnTo>
                      <a:pt x="104" y="155"/>
                    </a:lnTo>
                    <a:lnTo>
                      <a:pt x="102" y="155"/>
                    </a:lnTo>
                    <a:lnTo>
                      <a:pt x="161" y="161"/>
                    </a:lnTo>
                    <a:lnTo>
                      <a:pt x="160" y="161"/>
                    </a:lnTo>
                    <a:lnTo>
                      <a:pt x="219" y="155"/>
                    </a:lnTo>
                    <a:lnTo>
                      <a:pt x="217" y="155"/>
                    </a:lnTo>
                    <a:lnTo>
                      <a:pt x="266" y="138"/>
                    </a:lnTo>
                    <a:lnTo>
                      <a:pt x="263" y="139"/>
                    </a:lnTo>
                    <a:lnTo>
                      <a:pt x="295" y="113"/>
                    </a:lnTo>
                    <a:lnTo>
                      <a:pt x="294" y="115"/>
                    </a:lnTo>
                    <a:lnTo>
                      <a:pt x="303" y="100"/>
                    </a:lnTo>
                    <a:lnTo>
                      <a:pt x="302" y="103"/>
                    </a:lnTo>
                    <a:lnTo>
                      <a:pt x="305" y="87"/>
                    </a:lnTo>
                    <a:lnTo>
                      <a:pt x="304" y="88"/>
                    </a:lnTo>
                    <a:lnTo>
                      <a:pt x="304" y="8"/>
                    </a:lnTo>
                    <a:lnTo>
                      <a:pt x="312" y="16"/>
                    </a:lnTo>
                    <a:lnTo>
                      <a:pt x="161" y="16"/>
                    </a:lnTo>
                    <a:lnTo>
                      <a:pt x="102" y="22"/>
                    </a:lnTo>
                    <a:lnTo>
                      <a:pt x="104" y="22"/>
                    </a:lnTo>
                    <a:lnTo>
                      <a:pt x="56" y="40"/>
                    </a:lnTo>
                    <a:lnTo>
                      <a:pt x="58" y="39"/>
                    </a:lnTo>
                    <a:lnTo>
                      <a:pt x="25" y="64"/>
                    </a:lnTo>
                    <a:lnTo>
                      <a:pt x="27" y="62"/>
                    </a:lnTo>
                    <a:lnTo>
                      <a:pt x="18" y="77"/>
                    </a:lnTo>
                    <a:lnTo>
                      <a:pt x="19" y="74"/>
                    </a:lnTo>
                    <a:lnTo>
                      <a:pt x="16" y="90"/>
                    </a:lnTo>
                    <a:lnTo>
                      <a:pt x="16" y="87"/>
                    </a:lnTo>
                    <a:lnTo>
                      <a:pt x="19" y="103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" name="Freeform 192">
                <a:extLst>
                  <a:ext uri="{FF2B5EF4-FFF2-40B4-BE49-F238E27FC236}">
                    <a16:creationId xmlns:a16="http://schemas.microsoft.com/office/drawing/2014/main" id="{75EB06E4-765F-4F14-A79D-BAE3F862CED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10" y="2253"/>
                <a:ext cx="76" cy="36"/>
              </a:xfrm>
              <a:custGeom>
                <a:avLst/>
                <a:gdLst>
                  <a:gd name="T0" fmla="*/ 0 w 304"/>
                  <a:gd name="T1" fmla="*/ 72 h 144"/>
                  <a:gd name="T2" fmla="*/ 152 w 304"/>
                  <a:gd name="T3" fmla="*/ 0 h 144"/>
                  <a:gd name="T4" fmla="*/ 152 w 304"/>
                  <a:gd name="T5" fmla="*/ 0 h 144"/>
                  <a:gd name="T6" fmla="*/ 304 w 304"/>
                  <a:gd name="T7" fmla="*/ 0 h 144"/>
                  <a:gd name="T8" fmla="*/ 304 w 304"/>
                  <a:gd name="T9" fmla="*/ 72 h 144"/>
                  <a:gd name="T10" fmla="*/ 304 w 304"/>
                  <a:gd name="T11" fmla="*/ 72 h 144"/>
                  <a:gd name="T12" fmla="*/ 152 w 304"/>
                  <a:gd name="T13" fmla="*/ 144 h 144"/>
                  <a:gd name="T14" fmla="*/ 152 w 304"/>
                  <a:gd name="T15" fmla="*/ 144 h 144"/>
                  <a:gd name="T16" fmla="*/ 152 w 304"/>
                  <a:gd name="T17" fmla="*/ 144 h 144"/>
                  <a:gd name="T18" fmla="*/ 0 w 304"/>
                  <a:gd name="T19" fmla="*/ 72 h 144"/>
                  <a:gd name="T20" fmla="*/ 0 w 304"/>
                  <a:gd name="T21" fmla="*/ 72 h 1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304" h="144">
                    <a:moveTo>
                      <a:pt x="0" y="72"/>
                    </a:moveTo>
                    <a:cubicBezTo>
                      <a:pt x="0" y="33"/>
                      <a:pt x="69" y="0"/>
                      <a:pt x="152" y="0"/>
                    </a:cubicBezTo>
                    <a:lnTo>
                      <a:pt x="152" y="0"/>
                    </a:lnTo>
                    <a:cubicBezTo>
                      <a:pt x="203" y="0"/>
                      <a:pt x="254" y="0"/>
                      <a:pt x="304" y="0"/>
                    </a:cubicBezTo>
                    <a:cubicBezTo>
                      <a:pt x="304" y="24"/>
                      <a:pt x="304" y="48"/>
                      <a:pt x="304" y="72"/>
                    </a:cubicBezTo>
                    <a:lnTo>
                      <a:pt x="304" y="72"/>
                    </a:lnTo>
                    <a:cubicBezTo>
                      <a:pt x="304" y="112"/>
                      <a:pt x="236" y="144"/>
                      <a:pt x="152" y="144"/>
                    </a:cubicBezTo>
                    <a:cubicBezTo>
                      <a:pt x="152" y="144"/>
                      <a:pt x="152" y="144"/>
                      <a:pt x="152" y="144"/>
                    </a:cubicBezTo>
                    <a:lnTo>
                      <a:pt x="152" y="144"/>
                    </a:lnTo>
                    <a:cubicBezTo>
                      <a:pt x="69" y="144"/>
                      <a:pt x="0" y="112"/>
                      <a:pt x="0" y="72"/>
                    </a:cubicBezTo>
                    <a:cubicBezTo>
                      <a:pt x="0" y="72"/>
                      <a:pt x="0" y="72"/>
                      <a:pt x="0" y="72"/>
                    </a:cubicBezTo>
                    <a:close/>
                  </a:path>
                </a:pathLst>
              </a:custGeom>
              <a:solidFill>
                <a:srgbClr val="E46C0A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" name="Freeform 193">
                <a:extLst>
                  <a:ext uri="{FF2B5EF4-FFF2-40B4-BE49-F238E27FC236}">
                    <a16:creationId xmlns:a16="http://schemas.microsoft.com/office/drawing/2014/main" id="{7A213D5C-0FBE-41BE-BA82-B4BE685546C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208" y="2251"/>
                <a:ext cx="79" cy="40"/>
              </a:xfrm>
              <a:custGeom>
                <a:avLst/>
                <a:gdLst>
                  <a:gd name="T0" fmla="*/ 1 w 320"/>
                  <a:gd name="T1" fmla="*/ 79 h 160"/>
                  <a:gd name="T2" fmla="*/ 5 w 320"/>
                  <a:gd name="T3" fmla="*/ 62 h 160"/>
                  <a:gd name="T4" fmla="*/ 16 w 320"/>
                  <a:gd name="T5" fmla="*/ 46 h 160"/>
                  <a:gd name="T6" fmla="*/ 51 w 320"/>
                  <a:gd name="T7" fmla="*/ 22 h 160"/>
                  <a:gd name="T8" fmla="*/ 101 w 320"/>
                  <a:gd name="T9" fmla="*/ 7 h 160"/>
                  <a:gd name="T10" fmla="*/ 312 w 320"/>
                  <a:gd name="T11" fmla="*/ 0 h 160"/>
                  <a:gd name="T12" fmla="*/ 320 w 320"/>
                  <a:gd name="T13" fmla="*/ 80 h 160"/>
                  <a:gd name="T14" fmla="*/ 317 w 320"/>
                  <a:gd name="T15" fmla="*/ 97 h 160"/>
                  <a:gd name="T16" fmla="*/ 307 w 320"/>
                  <a:gd name="T17" fmla="*/ 113 h 160"/>
                  <a:gd name="T18" fmla="*/ 273 w 320"/>
                  <a:gd name="T19" fmla="*/ 138 h 160"/>
                  <a:gd name="T20" fmla="*/ 222 w 320"/>
                  <a:gd name="T21" fmla="*/ 154 h 160"/>
                  <a:gd name="T22" fmla="*/ 161 w 320"/>
                  <a:gd name="T23" fmla="*/ 160 h 160"/>
                  <a:gd name="T24" fmla="*/ 101 w 320"/>
                  <a:gd name="T25" fmla="*/ 154 h 160"/>
                  <a:gd name="T26" fmla="*/ 51 w 320"/>
                  <a:gd name="T27" fmla="*/ 139 h 160"/>
                  <a:gd name="T28" fmla="*/ 16 w 320"/>
                  <a:gd name="T29" fmla="*/ 115 h 160"/>
                  <a:gd name="T30" fmla="*/ 5 w 320"/>
                  <a:gd name="T31" fmla="*/ 100 h 160"/>
                  <a:gd name="T32" fmla="*/ 1 w 320"/>
                  <a:gd name="T33" fmla="*/ 82 h 160"/>
                  <a:gd name="T34" fmla="*/ 18 w 320"/>
                  <a:gd name="T35" fmla="*/ 91 h 160"/>
                  <a:gd name="T36" fmla="*/ 25 w 320"/>
                  <a:gd name="T37" fmla="*/ 102 h 160"/>
                  <a:gd name="T38" fmla="*/ 56 w 320"/>
                  <a:gd name="T39" fmla="*/ 124 h 160"/>
                  <a:gd name="T40" fmla="*/ 102 w 320"/>
                  <a:gd name="T41" fmla="*/ 139 h 160"/>
                  <a:gd name="T42" fmla="*/ 160 w 320"/>
                  <a:gd name="T43" fmla="*/ 145 h 160"/>
                  <a:gd name="T44" fmla="*/ 217 w 320"/>
                  <a:gd name="T45" fmla="*/ 139 h 160"/>
                  <a:gd name="T46" fmla="*/ 264 w 320"/>
                  <a:gd name="T47" fmla="*/ 125 h 160"/>
                  <a:gd name="T48" fmla="*/ 294 w 320"/>
                  <a:gd name="T49" fmla="*/ 104 h 160"/>
                  <a:gd name="T50" fmla="*/ 302 w 320"/>
                  <a:gd name="T51" fmla="*/ 94 h 160"/>
                  <a:gd name="T52" fmla="*/ 304 w 320"/>
                  <a:gd name="T53" fmla="*/ 80 h 160"/>
                  <a:gd name="T54" fmla="*/ 312 w 320"/>
                  <a:gd name="T55" fmla="*/ 16 h 160"/>
                  <a:gd name="T56" fmla="*/ 102 w 320"/>
                  <a:gd name="T57" fmla="*/ 22 h 160"/>
                  <a:gd name="T58" fmla="*/ 56 w 320"/>
                  <a:gd name="T59" fmla="*/ 37 h 160"/>
                  <a:gd name="T60" fmla="*/ 25 w 320"/>
                  <a:gd name="T61" fmla="*/ 59 h 160"/>
                  <a:gd name="T62" fmla="*/ 18 w 320"/>
                  <a:gd name="T63" fmla="*/ 71 h 160"/>
                  <a:gd name="T64" fmla="*/ 16 w 320"/>
                  <a:gd name="T65" fmla="*/ 82 h 160"/>
                  <a:gd name="T66" fmla="*/ 19 w 320"/>
                  <a:gd name="T67" fmla="*/ 94 h 1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</a:cxnLst>
                <a:rect l="0" t="0" r="r" b="b"/>
                <a:pathLst>
                  <a:path w="320" h="160">
                    <a:moveTo>
                      <a:pt x="1" y="82"/>
                    </a:moveTo>
                    <a:cubicBezTo>
                      <a:pt x="0" y="81"/>
                      <a:pt x="0" y="80"/>
                      <a:pt x="1" y="79"/>
                    </a:cubicBezTo>
                    <a:lnTo>
                      <a:pt x="4" y="65"/>
                    </a:lnTo>
                    <a:cubicBezTo>
                      <a:pt x="4" y="64"/>
                      <a:pt x="4" y="63"/>
                      <a:pt x="5" y="62"/>
                    </a:cubicBezTo>
                    <a:lnTo>
                      <a:pt x="14" y="48"/>
                    </a:lnTo>
                    <a:cubicBezTo>
                      <a:pt x="14" y="47"/>
                      <a:pt x="15" y="46"/>
                      <a:pt x="16" y="46"/>
                    </a:cubicBezTo>
                    <a:lnTo>
                      <a:pt x="49" y="23"/>
                    </a:lnTo>
                    <a:cubicBezTo>
                      <a:pt x="50" y="22"/>
                      <a:pt x="50" y="22"/>
                      <a:pt x="51" y="22"/>
                    </a:cubicBezTo>
                    <a:lnTo>
                      <a:pt x="99" y="7"/>
                    </a:lnTo>
                    <a:cubicBezTo>
                      <a:pt x="100" y="7"/>
                      <a:pt x="100" y="7"/>
                      <a:pt x="101" y="7"/>
                    </a:cubicBezTo>
                    <a:lnTo>
                      <a:pt x="160" y="1"/>
                    </a:lnTo>
                    <a:lnTo>
                      <a:pt x="312" y="0"/>
                    </a:lnTo>
                    <a:cubicBezTo>
                      <a:pt x="317" y="0"/>
                      <a:pt x="320" y="4"/>
                      <a:pt x="320" y="8"/>
                    </a:cubicBezTo>
                    <a:lnTo>
                      <a:pt x="320" y="80"/>
                    </a:lnTo>
                    <a:cubicBezTo>
                      <a:pt x="320" y="81"/>
                      <a:pt x="320" y="82"/>
                      <a:pt x="320" y="82"/>
                    </a:cubicBezTo>
                    <a:lnTo>
                      <a:pt x="317" y="97"/>
                    </a:lnTo>
                    <a:cubicBezTo>
                      <a:pt x="317" y="98"/>
                      <a:pt x="317" y="99"/>
                      <a:pt x="316" y="100"/>
                    </a:cubicBezTo>
                    <a:lnTo>
                      <a:pt x="307" y="113"/>
                    </a:lnTo>
                    <a:cubicBezTo>
                      <a:pt x="307" y="114"/>
                      <a:pt x="306" y="114"/>
                      <a:pt x="305" y="115"/>
                    </a:cubicBezTo>
                    <a:lnTo>
                      <a:pt x="273" y="138"/>
                    </a:lnTo>
                    <a:cubicBezTo>
                      <a:pt x="272" y="138"/>
                      <a:pt x="272" y="139"/>
                      <a:pt x="271" y="139"/>
                    </a:cubicBezTo>
                    <a:lnTo>
                      <a:pt x="222" y="154"/>
                    </a:lnTo>
                    <a:cubicBezTo>
                      <a:pt x="221" y="154"/>
                      <a:pt x="221" y="154"/>
                      <a:pt x="220" y="154"/>
                    </a:cubicBezTo>
                    <a:lnTo>
                      <a:pt x="161" y="160"/>
                    </a:lnTo>
                    <a:cubicBezTo>
                      <a:pt x="161" y="160"/>
                      <a:pt x="160" y="160"/>
                      <a:pt x="160" y="160"/>
                    </a:cubicBezTo>
                    <a:lnTo>
                      <a:pt x="101" y="154"/>
                    </a:lnTo>
                    <a:cubicBezTo>
                      <a:pt x="100" y="154"/>
                      <a:pt x="100" y="154"/>
                      <a:pt x="99" y="154"/>
                    </a:cubicBezTo>
                    <a:lnTo>
                      <a:pt x="51" y="139"/>
                    </a:lnTo>
                    <a:cubicBezTo>
                      <a:pt x="50" y="139"/>
                      <a:pt x="50" y="139"/>
                      <a:pt x="49" y="138"/>
                    </a:cubicBezTo>
                    <a:lnTo>
                      <a:pt x="16" y="115"/>
                    </a:lnTo>
                    <a:cubicBezTo>
                      <a:pt x="15" y="114"/>
                      <a:pt x="14" y="114"/>
                      <a:pt x="14" y="113"/>
                    </a:cubicBezTo>
                    <a:lnTo>
                      <a:pt x="5" y="100"/>
                    </a:lnTo>
                    <a:cubicBezTo>
                      <a:pt x="4" y="99"/>
                      <a:pt x="4" y="98"/>
                      <a:pt x="4" y="97"/>
                    </a:cubicBezTo>
                    <a:lnTo>
                      <a:pt x="1" y="82"/>
                    </a:lnTo>
                    <a:close/>
                    <a:moveTo>
                      <a:pt x="19" y="94"/>
                    </a:moveTo>
                    <a:lnTo>
                      <a:pt x="18" y="91"/>
                    </a:lnTo>
                    <a:lnTo>
                      <a:pt x="27" y="104"/>
                    </a:lnTo>
                    <a:lnTo>
                      <a:pt x="25" y="102"/>
                    </a:lnTo>
                    <a:lnTo>
                      <a:pt x="58" y="125"/>
                    </a:lnTo>
                    <a:lnTo>
                      <a:pt x="56" y="124"/>
                    </a:lnTo>
                    <a:lnTo>
                      <a:pt x="104" y="139"/>
                    </a:lnTo>
                    <a:lnTo>
                      <a:pt x="102" y="139"/>
                    </a:lnTo>
                    <a:lnTo>
                      <a:pt x="161" y="145"/>
                    </a:lnTo>
                    <a:lnTo>
                      <a:pt x="160" y="145"/>
                    </a:lnTo>
                    <a:lnTo>
                      <a:pt x="219" y="139"/>
                    </a:lnTo>
                    <a:lnTo>
                      <a:pt x="217" y="139"/>
                    </a:lnTo>
                    <a:lnTo>
                      <a:pt x="266" y="124"/>
                    </a:lnTo>
                    <a:lnTo>
                      <a:pt x="264" y="125"/>
                    </a:lnTo>
                    <a:lnTo>
                      <a:pt x="296" y="102"/>
                    </a:lnTo>
                    <a:lnTo>
                      <a:pt x="294" y="104"/>
                    </a:lnTo>
                    <a:lnTo>
                      <a:pt x="303" y="91"/>
                    </a:lnTo>
                    <a:lnTo>
                      <a:pt x="302" y="94"/>
                    </a:lnTo>
                    <a:lnTo>
                      <a:pt x="305" y="79"/>
                    </a:lnTo>
                    <a:lnTo>
                      <a:pt x="304" y="80"/>
                    </a:lnTo>
                    <a:lnTo>
                      <a:pt x="304" y="8"/>
                    </a:lnTo>
                    <a:lnTo>
                      <a:pt x="312" y="16"/>
                    </a:lnTo>
                    <a:lnTo>
                      <a:pt x="161" y="16"/>
                    </a:lnTo>
                    <a:lnTo>
                      <a:pt x="102" y="22"/>
                    </a:lnTo>
                    <a:lnTo>
                      <a:pt x="104" y="22"/>
                    </a:lnTo>
                    <a:lnTo>
                      <a:pt x="56" y="37"/>
                    </a:lnTo>
                    <a:lnTo>
                      <a:pt x="58" y="36"/>
                    </a:lnTo>
                    <a:lnTo>
                      <a:pt x="25" y="59"/>
                    </a:lnTo>
                    <a:lnTo>
                      <a:pt x="27" y="57"/>
                    </a:lnTo>
                    <a:lnTo>
                      <a:pt x="18" y="71"/>
                    </a:lnTo>
                    <a:lnTo>
                      <a:pt x="19" y="68"/>
                    </a:lnTo>
                    <a:lnTo>
                      <a:pt x="16" y="82"/>
                    </a:lnTo>
                    <a:lnTo>
                      <a:pt x="16" y="79"/>
                    </a:lnTo>
                    <a:lnTo>
                      <a:pt x="19" y="9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" name="Freeform 194">
                <a:extLst>
                  <a:ext uri="{FF2B5EF4-FFF2-40B4-BE49-F238E27FC236}">
                    <a16:creationId xmlns:a16="http://schemas.microsoft.com/office/drawing/2014/main" id="{5D2E2D72-A9C8-4F0A-B1CD-163456A31B3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10" y="2107"/>
                <a:ext cx="76" cy="36"/>
              </a:xfrm>
              <a:custGeom>
                <a:avLst/>
                <a:gdLst>
                  <a:gd name="T0" fmla="*/ 0 w 304"/>
                  <a:gd name="T1" fmla="*/ 72 h 144"/>
                  <a:gd name="T2" fmla="*/ 152 w 304"/>
                  <a:gd name="T3" fmla="*/ 0 h 144"/>
                  <a:gd name="T4" fmla="*/ 152 w 304"/>
                  <a:gd name="T5" fmla="*/ 0 h 144"/>
                  <a:gd name="T6" fmla="*/ 304 w 304"/>
                  <a:gd name="T7" fmla="*/ 0 h 144"/>
                  <a:gd name="T8" fmla="*/ 304 w 304"/>
                  <a:gd name="T9" fmla="*/ 72 h 144"/>
                  <a:gd name="T10" fmla="*/ 304 w 304"/>
                  <a:gd name="T11" fmla="*/ 72 h 144"/>
                  <a:gd name="T12" fmla="*/ 152 w 304"/>
                  <a:gd name="T13" fmla="*/ 144 h 144"/>
                  <a:gd name="T14" fmla="*/ 152 w 304"/>
                  <a:gd name="T15" fmla="*/ 144 h 144"/>
                  <a:gd name="T16" fmla="*/ 152 w 304"/>
                  <a:gd name="T17" fmla="*/ 144 h 144"/>
                  <a:gd name="T18" fmla="*/ 0 w 304"/>
                  <a:gd name="T19" fmla="*/ 72 h 144"/>
                  <a:gd name="T20" fmla="*/ 0 w 304"/>
                  <a:gd name="T21" fmla="*/ 72 h 1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304" h="144">
                    <a:moveTo>
                      <a:pt x="0" y="72"/>
                    </a:moveTo>
                    <a:cubicBezTo>
                      <a:pt x="0" y="33"/>
                      <a:pt x="69" y="0"/>
                      <a:pt x="152" y="0"/>
                    </a:cubicBezTo>
                    <a:lnTo>
                      <a:pt x="152" y="0"/>
                    </a:lnTo>
                    <a:cubicBezTo>
                      <a:pt x="203" y="0"/>
                      <a:pt x="254" y="0"/>
                      <a:pt x="304" y="0"/>
                    </a:cubicBezTo>
                    <a:cubicBezTo>
                      <a:pt x="304" y="24"/>
                      <a:pt x="304" y="48"/>
                      <a:pt x="304" y="72"/>
                    </a:cubicBezTo>
                    <a:lnTo>
                      <a:pt x="304" y="72"/>
                    </a:lnTo>
                    <a:cubicBezTo>
                      <a:pt x="304" y="112"/>
                      <a:pt x="236" y="144"/>
                      <a:pt x="152" y="144"/>
                    </a:cubicBezTo>
                    <a:cubicBezTo>
                      <a:pt x="152" y="144"/>
                      <a:pt x="152" y="144"/>
                      <a:pt x="152" y="144"/>
                    </a:cubicBezTo>
                    <a:lnTo>
                      <a:pt x="152" y="144"/>
                    </a:lnTo>
                    <a:cubicBezTo>
                      <a:pt x="69" y="144"/>
                      <a:pt x="0" y="112"/>
                      <a:pt x="0" y="72"/>
                    </a:cubicBezTo>
                    <a:cubicBezTo>
                      <a:pt x="0" y="72"/>
                      <a:pt x="0" y="72"/>
                      <a:pt x="0" y="72"/>
                    </a:cubicBezTo>
                    <a:close/>
                  </a:path>
                </a:pathLst>
              </a:custGeom>
              <a:solidFill>
                <a:srgbClr val="B3A2C7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" name="Freeform 195">
                <a:extLst>
                  <a:ext uri="{FF2B5EF4-FFF2-40B4-BE49-F238E27FC236}">
                    <a16:creationId xmlns:a16="http://schemas.microsoft.com/office/drawing/2014/main" id="{EAAEC20D-7AB7-44CF-91A3-174250A1293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208" y="2105"/>
                <a:ext cx="79" cy="40"/>
              </a:xfrm>
              <a:custGeom>
                <a:avLst/>
                <a:gdLst>
                  <a:gd name="T0" fmla="*/ 1 w 320"/>
                  <a:gd name="T1" fmla="*/ 79 h 160"/>
                  <a:gd name="T2" fmla="*/ 5 w 320"/>
                  <a:gd name="T3" fmla="*/ 62 h 160"/>
                  <a:gd name="T4" fmla="*/ 16 w 320"/>
                  <a:gd name="T5" fmla="*/ 46 h 160"/>
                  <a:gd name="T6" fmla="*/ 51 w 320"/>
                  <a:gd name="T7" fmla="*/ 22 h 160"/>
                  <a:gd name="T8" fmla="*/ 101 w 320"/>
                  <a:gd name="T9" fmla="*/ 7 h 160"/>
                  <a:gd name="T10" fmla="*/ 312 w 320"/>
                  <a:gd name="T11" fmla="*/ 0 h 160"/>
                  <a:gd name="T12" fmla="*/ 320 w 320"/>
                  <a:gd name="T13" fmla="*/ 80 h 160"/>
                  <a:gd name="T14" fmla="*/ 317 w 320"/>
                  <a:gd name="T15" fmla="*/ 97 h 160"/>
                  <a:gd name="T16" fmla="*/ 307 w 320"/>
                  <a:gd name="T17" fmla="*/ 113 h 160"/>
                  <a:gd name="T18" fmla="*/ 273 w 320"/>
                  <a:gd name="T19" fmla="*/ 138 h 160"/>
                  <a:gd name="T20" fmla="*/ 222 w 320"/>
                  <a:gd name="T21" fmla="*/ 154 h 160"/>
                  <a:gd name="T22" fmla="*/ 161 w 320"/>
                  <a:gd name="T23" fmla="*/ 160 h 160"/>
                  <a:gd name="T24" fmla="*/ 101 w 320"/>
                  <a:gd name="T25" fmla="*/ 154 h 160"/>
                  <a:gd name="T26" fmla="*/ 51 w 320"/>
                  <a:gd name="T27" fmla="*/ 139 h 160"/>
                  <a:gd name="T28" fmla="*/ 16 w 320"/>
                  <a:gd name="T29" fmla="*/ 115 h 160"/>
                  <a:gd name="T30" fmla="*/ 5 w 320"/>
                  <a:gd name="T31" fmla="*/ 100 h 160"/>
                  <a:gd name="T32" fmla="*/ 1 w 320"/>
                  <a:gd name="T33" fmla="*/ 82 h 160"/>
                  <a:gd name="T34" fmla="*/ 18 w 320"/>
                  <a:gd name="T35" fmla="*/ 91 h 160"/>
                  <a:gd name="T36" fmla="*/ 25 w 320"/>
                  <a:gd name="T37" fmla="*/ 102 h 160"/>
                  <a:gd name="T38" fmla="*/ 56 w 320"/>
                  <a:gd name="T39" fmla="*/ 124 h 160"/>
                  <a:gd name="T40" fmla="*/ 102 w 320"/>
                  <a:gd name="T41" fmla="*/ 139 h 160"/>
                  <a:gd name="T42" fmla="*/ 160 w 320"/>
                  <a:gd name="T43" fmla="*/ 145 h 160"/>
                  <a:gd name="T44" fmla="*/ 217 w 320"/>
                  <a:gd name="T45" fmla="*/ 139 h 160"/>
                  <a:gd name="T46" fmla="*/ 264 w 320"/>
                  <a:gd name="T47" fmla="*/ 125 h 160"/>
                  <a:gd name="T48" fmla="*/ 294 w 320"/>
                  <a:gd name="T49" fmla="*/ 104 h 160"/>
                  <a:gd name="T50" fmla="*/ 302 w 320"/>
                  <a:gd name="T51" fmla="*/ 94 h 160"/>
                  <a:gd name="T52" fmla="*/ 304 w 320"/>
                  <a:gd name="T53" fmla="*/ 80 h 160"/>
                  <a:gd name="T54" fmla="*/ 312 w 320"/>
                  <a:gd name="T55" fmla="*/ 16 h 160"/>
                  <a:gd name="T56" fmla="*/ 102 w 320"/>
                  <a:gd name="T57" fmla="*/ 22 h 160"/>
                  <a:gd name="T58" fmla="*/ 56 w 320"/>
                  <a:gd name="T59" fmla="*/ 37 h 160"/>
                  <a:gd name="T60" fmla="*/ 25 w 320"/>
                  <a:gd name="T61" fmla="*/ 59 h 160"/>
                  <a:gd name="T62" fmla="*/ 18 w 320"/>
                  <a:gd name="T63" fmla="*/ 71 h 160"/>
                  <a:gd name="T64" fmla="*/ 16 w 320"/>
                  <a:gd name="T65" fmla="*/ 82 h 160"/>
                  <a:gd name="T66" fmla="*/ 19 w 320"/>
                  <a:gd name="T67" fmla="*/ 94 h 1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</a:cxnLst>
                <a:rect l="0" t="0" r="r" b="b"/>
                <a:pathLst>
                  <a:path w="320" h="160">
                    <a:moveTo>
                      <a:pt x="1" y="82"/>
                    </a:moveTo>
                    <a:cubicBezTo>
                      <a:pt x="0" y="81"/>
                      <a:pt x="0" y="80"/>
                      <a:pt x="1" y="79"/>
                    </a:cubicBezTo>
                    <a:lnTo>
                      <a:pt x="4" y="65"/>
                    </a:lnTo>
                    <a:cubicBezTo>
                      <a:pt x="4" y="64"/>
                      <a:pt x="4" y="63"/>
                      <a:pt x="5" y="62"/>
                    </a:cubicBezTo>
                    <a:lnTo>
                      <a:pt x="14" y="48"/>
                    </a:lnTo>
                    <a:cubicBezTo>
                      <a:pt x="14" y="47"/>
                      <a:pt x="15" y="46"/>
                      <a:pt x="16" y="46"/>
                    </a:cubicBezTo>
                    <a:lnTo>
                      <a:pt x="49" y="23"/>
                    </a:lnTo>
                    <a:cubicBezTo>
                      <a:pt x="50" y="22"/>
                      <a:pt x="50" y="22"/>
                      <a:pt x="51" y="22"/>
                    </a:cubicBezTo>
                    <a:lnTo>
                      <a:pt x="99" y="7"/>
                    </a:lnTo>
                    <a:cubicBezTo>
                      <a:pt x="100" y="7"/>
                      <a:pt x="100" y="7"/>
                      <a:pt x="101" y="7"/>
                    </a:cubicBezTo>
                    <a:lnTo>
                      <a:pt x="160" y="1"/>
                    </a:lnTo>
                    <a:lnTo>
                      <a:pt x="312" y="0"/>
                    </a:lnTo>
                    <a:cubicBezTo>
                      <a:pt x="317" y="0"/>
                      <a:pt x="320" y="4"/>
                      <a:pt x="320" y="8"/>
                    </a:cubicBezTo>
                    <a:lnTo>
                      <a:pt x="320" y="80"/>
                    </a:lnTo>
                    <a:cubicBezTo>
                      <a:pt x="320" y="81"/>
                      <a:pt x="320" y="82"/>
                      <a:pt x="320" y="82"/>
                    </a:cubicBezTo>
                    <a:lnTo>
                      <a:pt x="317" y="97"/>
                    </a:lnTo>
                    <a:cubicBezTo>
                      <a:pt x="317" y="98"/>
                      <a:pt x="317" y="99"/>
                      <a:pt x="316" y="100"/>
                    </a:cubicBezTo>
                    <a:lnTo>
                      <a:pt x="307" y="113"/>
                    </a:lnTo>
                    <a:cubicBezTo>
                      <a:pt x="307" y="114"/>
                      <a:pt x="306" y="114"/>
                      <a:pt x="305" y="115"/>
                    </a:cubicBezTo>
                    <a:lnTo>
                      <a:pt x="273" y="138"/>
                    </a:lnTo>
                    <a:cubicBezTo>
                      <a:pt x="272" y="138"/>
                      <a:pt x="272" y="139"/>
                      <a:pt x="271" y="139"/>
                    </a:cubicBezTo>
                    <a:lnTo>
                      <a:pt x="222" y="154"/>
                    </a:lnTo>
                    <a:cubicBezTo>
                      <a:pt x="221" y="154"/>
                      <a:pt x="221" y="154"/>
                      <a:pt x="220" y="154"/>
                    </a:cubicBezTo>
                    <a:lnTo>
                      <a:pt x="161" y="160"/>
                    </a:lnTo>
                    <a:cubicBezTo>
                      <a:pt x="161" y="160"/>
                      <a:pt x="160" y="160"/>
                      <a:pt x="160" y="160"/>
                    </a:cubicBezTo>
                    <a:lnTo>
                      <a:pt x="101" y="154"/>
                    </a:lnTo>
                    <a:cubicBezTo>
                      <a:pt x="100" y="154"/>
                      <a:pt x="100" y="154"/>
                      <a:pt x="99" y="154"/>
                    </a:cubicBezTo>
                    <a:lnTo>
                      <a:pt x="51" y="139"/>
                    </a:lnTo>
                    <a:cubicBezTo>
                      <a:pt x="50" y="139"/>
                      <a:pt x="50" y="139"/>
                      <a:pt x="49" y="138"/>
                    </a:cubicBezTo>
                    <a:lnTo>
                      <a:pt x="16" y="115"/>
                    </a:lnTo>
                    <a:cubicBezTo>
                      <a:pt x="15" y="114"/>
                      <a:pt x="14" y="114"/>
                      <a:pt x="14" y="113"/>
                    </a:cubicBezTo>
                    <a:lnTo>
                      <a:pt x="5" y="100"/>
                    </a:lnTo>
                    <a:cubicBezTo>
                      <a:pt x="4" y="99"/>
                      <a:pt x="4" y="98"/>
                      <a:pt x="4" y="97"/>
                    </a:cubicBezTo>
                    <a:lnTo>
                      <a:pt x="1" y="82"/>
                    </a:lnTo>
                    <a:close/>
                    <a:moveTo>
                      <a:pt x="19" y="94"/>
                    </a:moveTo>
                    <a:lnTo>
                      <a:pt x="18" y="91"/>
                    </a:lnTo>
                    <a:lnTo>
                      <a:pt x="27" y="104"/>
                    </a:lnTo>
                    <a:lnTo>
                      <a:pt x="25" y="102"/>
                    </a:lnTo>
                    <a:lnTo>
                      <a:pt x="58" y="125"/>
                    </a:lnTo>
                    <a:lnTo>
                      <a:pt x="56" y="124"/>
                    </a:lnTo>
                    <a:lnTo>
                      <a:pt x="104" y="139"/>
                    </a:lnTo>
                    <a:lnTo>
                      <a:pt x="102" y="139"/>
                    </a:lnTo>
                    <a:lnTo>
                      <a:pt x="161" y="145"/>
                    </a:lnTo>
                    <a:lnTo>
                      <a:pt x="160" y="145"/>
                    </a:lnTo>
                    <a:lnTo>
                      <a:pt x="219" y="139"/>
                    </a:lnTo>
                    <a:lnTo>
                      <a:pt x="217" y="139"/>
                    </a:lnTo>
                    <a:lnTo>
                      <a:pt x="266" y="124"/>
                    </a:lnTo>
                    <a:lnTo>
                      <a:pt x="264" y="125"/>
                    </a:lnTo>
                    <a:lnTo>
                      <a:pt x="296" y="102"/>
                    </a:lnTo>
                    <a:lnTo>
                      <a:pt x="294" y="104"/>
                    </a:lnTo>
                    <a:lnTo>
                      <a:pt x="303" y="91"/>
                    </a:lnTo>
                    <a:lnTo>
                      <a:pt x="302" y="94"/>
                    </a:lnTo>
                    <a:lnTo>
                      <a:pt x="305" y="79"/>
                    </a:lnTo>
                    <a:lnTo>
                      <a:pt x="304" y="80"/>
                    </a:lnTo>
                    <a:lnTo>
                      <a:pt x="304" y="8"/>
                    </a:lnTo>
                    <a:lnTo>
                      <a:pt x="312" y="16"/>
                    </a:lnTo>
                    <a:lnTo>
                      <a:pt x="161" y="16"/>
                    </a:lnTo>
                    <a:lnTo>
                      <a:pt x="102" y="22"/>
                    </a:lnTo>
                    <a:lnTo>
                      <a:pt x="104" y="22"/>
                    </a:lnTo>
                    <a:lnTo>
                      <a:pt x="56" y="37"/>
                    </a:lnTo>
                    <a:lnTo>
                      <a:pt x="58" y="36"/>
                    </a:lnTo>
                    <a:lnTo>
                      <a:pt x="25" y="59"/>
                    </a:lnTo>
                    <a:lnTo>
                      <a:pt x="27" y="57"/>
                    </a:lnTo>
                    <a:lnTo>
                      <a:pt x="18" y="71"/>
                    </a:lnTo>
                    <a:lnTo>
                      <a:pt x="19" y="68"/>
                    </a:lnTo>
                    <a:lnTo>
                      <a:pt x="16" y="82"/>
                    </a:lnTo>
                    <a:lnTo>
                      <a:pt x="16" y="79"/>
                    </a:lnTo>
                    <a:lnTo>
                      <a:pt x="19" y="9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" name="Freeform 196">
                <a:extLst>
                  <a:ext uri="{FF2B5EF4-FFF2-40B4-BE49-F238E27FC236}">
                    <a16:creationId xmlns:a16="http://schemas.microsoft.com/office/drawing/2014/main" id="{4BAD1A72-DDBE-4573-83D3-051E9D0884A1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987" y="2070"/>
                <a:ext cx="376" cy="256"/>
              </a:xfrm>
              <a:custGeom>
                <a:avLst/>
                <a:gdLst>
                  <a:gd name="T0" fmla="*/ 4 w 1520"/>
                  <a:gd name="T1" fmla="*/ 468 h 1040"/>
                  <a:gd name="T2" fmla="*/ 35 w 1520"/>
                  <a:gd name="T3" fmla="*/ 366 h 1040"/>
                  <a:gd name="T4" fmla="*/ 132 w 1520"/>
                  <a:gd name="T5" fmla="*/ 229 h 1040"/>
                  <a:gd name="T6" fmla="*/ 337 w 1520"/>
                  <a:gd name="T7" fmla="*/ 89 h 1040"/>
                  <a:gd name="T8" fmla="*/ 466 w 1520"/>
                  <a:gd name="T9" fmla="*/ 41 h 1040"/>
                  <a:gd name="T10" fmla="*/ 760 w 1520"/>
                  <a:gd name="T11" fmla="*/ 0 h 1040"/>
                  <a:gd name="T12" fmla="*/ 1055 w 1520"/>
                  <a:gd name="T13" fmla="*/ 41 h 1040"/>
                  <a:gd name="T14" fmla="*/ 1185 w 1520"/>
                  <a:gd name="T15" fmla="*/ 89 h 1040"/>
                  <a:gd name="T16" fmla="*/ 1390 w 1520"/>
                  <a:gd name="T17" fmla="*/ 228 h 1040"/>
                  <a:gd name="T18" fmla="*/ 1460 w 1520"/>
                  <a:gd name="T19" fmla="*/ 317 h 1040"/>
                  <a:gd name="T20" fmla="*/ 1505 w 1520"/>
                  <a:gd name="T21" fmla="*/ 416 h 1040"/>
                  <a:gd name="T22" fmla="*/ 1520 w 1520"/>
                  <a:gd name="T23" fmla="*/ 521 h 1040"/>
                  <a:gd name="T24" fmla="*/ 1505 w 1520"/>
                  <a:gd name="T25" fmla="*/ 626 h 1040"/>
                  <a:gd name="T26" fmla="*/ 1428 w 1520"/>
                  <a:gd name="T27" fmla="*/ 769 h 1040"/>
                  <a:gd name="T28" fmla="*/ 1298 w 1520"/>
                  <a:gd name="T29" fmla="*/ 889 h 1040"/>
                  <a:gd name="T30" fmla="*/ 1184 w 1520"/>
                  <a:gd name="T31" fmla="*/ 953 h 1040"/>
                  <a:gd name="T32" fmla="*/ 914 w 1520"/>
                  <a:gd name="T33" fmla="*/ 1030 h 1040"/>
                  <a:gd name="T34" fmla="*/ 609 w 1520"/>
                  <a:gd name="T35" fmla="*/ 1030 h 1040"/>
                  <a:gd name="T36" fmla="*/ 465 w 1520"/>
                  <a:gd name="T37" fmla="*/ 1000 h 1040"/>
                  <a:gd name="T38" fmla="*/ 225 w 1520"/>
                  <a:gd name="T39" fmla="*/ 889 h 1040"/>
                  <a:gd name="T40" fmla="*/ 94 w 1520"/>
                  <a:gd name="T41" fmla="*/ 770 h 1040"/>
                  <a:gd name="T42" fmla="*/ 16 w 1520"/>
                  <a:gd name="T43" fmla="*/ 626 h 1040"/>
                  <a:gd name="T44" fmla="*/ 0 w 1520"/>
                  <a:gd name="T45" fmla="*/ 521 h 1040"/>
                  <a:gd name="T46" fmla="*/ 31 w 1520"/>
                  <a:gd name="T47" fmla="*/ 621 h 1040"/>
                  <a:gd name="T48" fmla="*/ 105 w 1520"/>
                  <a:gd name="T49" fmla="*/ 759 h 1040"/>
                  <a:gd name="T50" fmla="*/ 232 w 1520"/>
                  <a:gd name="T51" fmla="*/ 875 h 1040"/>
                  <a:gd name="T52" fmla="*/ 470 w 1520"/>
                  <a:gd name="T53" fmla="*/ 985 h 1040"/>
                  <a:gd name="T54" fmla="*/ 610 w 1520"/>
                  <a:gd name="T55" fmla="*/ 1014 h 1040"/>
                  <a:gd name="T56" fmla="*/ 911 w 1520"/>
                  <a:gd name="T57" fmla="*/ 1015 h 1040"/>
                  <a:gd name="T58" fmla="*/ 1179 w 1520"/>
                  <a:gd name="T59" fmla="*/ 938 h 1040"/>
                  <a:gd name="T60" fmla="*/ 1287 w 1520"/>
                  <a:gd name="T61" fmla="*/ 876 h 1040"/>
                  <a:gd name="T62" fmla="*/ 1415 w 1520"/>
                  <a:gd name="T63" fmla="*/ 760 h 1040"/>
                  <a:gd name="T64" fmla="*/ 1490 w 1520"/>
                  <a:gd name="T65" fmla="*/ 621 h 1040"/>
                  <a:gd name="T66" fmla="*/ 1504 w 1520"/>
                  <a:gd name="T67" fmla="*/ 520 h 1040"/>
                  <a:gd name="T68" fmla="*/ 1490 w 1520"/>
                  <a:gd name="T69" fmla="*/ 419 h 1040"/>
                  <a:gd name="T70" fmla="*/ 1447 w 1520"/>
                  <a:gd name="T71" fmla="*/ 326 h 1040"/>
                  <a:gd name="T72" fmla="*/ 1379 w 1520"/>
                  <a:gd name="T73" fmla="*/ 241 h 1040"/>
                  <a:gd name="T74" fmla="*/ 1178 w 1520"/>
                  <a:gd name="T75" fmla="*/ 103 h 1040"/>
                  <a:gd name="T76" fmla="*/ 1052 w 1520"/>
                  <a:gd name="T77" fmla="*/ 56 h 1040"/>
                  <a:gd name="T78" fmla="*/ 761 w 1520"/>
                  <a:gd name="T79" fmla="*/ 16 h 1040"/>
                  <a:gd name="T80" fmla="*/ 469 w 1520"/>
                  <a:gd name="T81" fmla="*/ 56 h 1040"/>
                  <a:gd name="T82" fmla="*/ 344 w 1520"/>
                  <a:gd name="T83" fmla="*/ 103 h 1040"/>
                  <a:gd name="T84" fmla="*/ 143 w 1520"/>
                  <a:gd name="T85" fmla="*/ 240 h 1040"/>
                  <a:gd name="T86" fmla="*/ 50 w 1520"/>
                  <a:gd name="T87" fmla="*/ 371 h 1040"/>
                  <a:gd name="T88" fmla="*/ 20 w 1520"/>
                  <a:gd name="T89" fmla="*/ 469 h 1040"/>
                  <a:gd name="T90" fmla="*/ 20 w 1520"/>
                  <a:gd name="T91" fmla="*/ 571 h 10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</a:cxnLst>
                <a:rect l="0" t="0" r="r" b="b"/>
                <a:pathLst>
                  <a:path w="1520" h="1040">
                    <a:moveTo>
                      <a:pt x="0" y="521"/>
                    </a:moveTo>
                    <a:cubicBezTo>
                      <a:pt x="0" y="521"/>
                      <a:pt x="0" y="520"/>
                      <a:pt x="0" y="520"/>
                    </a:cubicBezTo>
                    <a:lnTo>
                      <a:pt x="4" y="468"/>
                    </a:lnTo>
                    <a:lnTo>
                      <a:pt x="16" y="416"/>
                    </a:lnTo>
                    <a:cubicBezTo>
                      <a:pt x="16" y="415"/>
                      <a:pt x="16" y="415"/>
                      <a:pt x="16" y="415"/>
                    </a:cubicBezTo>
                    <a:lnTo>
                      <a:pt x="35" y="366"/>
                    </a:lnTo>
                    <a:lnTo>
                      <a:pt x="60" y="318"/>
                    </a:lnTo>
                    <a:lnTo>
                      <a:pt x="93" y="272"/>
                    </a:lnTo>
                    <a:lnTo>
                      <a:pt x="132" y="229"/>
                    </a:lnTo>
                    <a:lnTo>
                      <a:pt x="223" y="152"/>
                    </a:lnTo>
                    <a:cubicBezTo>
                      <a:pt x="224" y="152"/>
                      <a:pt x="224" y="152"/>
                      <a:pt x="225" y="151"/>
                    </a:cubicBezTo>
                    <a:lnTo>
                      <a:pt x="337" y="89"/>
                    </a:lnTo>
                    <a:cubicBezTo>
                      <a:pt x="337" y="89"/>
                      <a:pt x="337" y="89"/>
                      <a:pt x="338" y="89"/>
                    </a:cubicBezTo>
                    <a:lnTo>
                      <a:pt x="465" y="41"/>
                    </a:lnTo>
                    <a:cubicBezTo>
                      <a:pt x="465" y="41"/>
                      <a:pt x="465" y="41"/>
                      <a:pt x="466" y="41"/>
                    </a:cubicBezTo>
                    <a:lnTo>
                      <a:pt x="608" y="11"/>
                    </a:lnTo>
                    <a:cubicBezTo>
                      <a:pt x="608" y="11"/>
                      <a:pt x="609" y="11"/>
                      <a:pt x="609" y="10"/>
                    </a:cubicBezTo>
                    <a:lnTo>
                      <a:pt x="760" y="0"/>
                    </a:lnTo>
                    <a:lnTo>
                      <a:pt x="913" y="10"/>
                    </a:lnTo>
                    <a:cubicBezTo>
                      <a:pt x="913" y="11"/>
                      <a:pt x="914" y="11"/>
                      <a:pt x="914" y="11"/>
                    </a:cubicBezTo>
                    <a:lnTo>
                      <a:pt x="1055" y="41"/>
                    </a:lnTo>
                    <a:cubicBezTo>
                      <a:pt x="1056" y="41"/>
                      <a:pt x="1056" y="41"/>
                      <a:pt x="1056" y="41"/>
                    </a:cubicBezTo>
                    <a:lnTo>
                      <a:pt x="1184" y="89"/>
                    </a:lnTo>
                    <a:cubicBezTo>
                      <a:pt x="1185" y="89"/>
                      <a:pt x="1185" y="89"/>
                      <a:pt x="1185" y="89"/>
                    </a:cubicBezTo>
                    <a:lnTo>
                      <a:pt x="1296" y="151"/>
                    </a:lnTo>
                    <a:cubicBezTo>
                      <a:pt x="1297" y="152"/>
                      <a:pt x="1297" y="152"/>
                      <a:pt x="1298" y="152"/>
                    </a:cubicBezTo>
                    <a:lnTo>
                      <a:pt x="1390" y="228"/>
                    </a:lnTo>
                    <a:cubicBezTo>
                      <a:pt x="1390" y="229"/>
                      <a:pt x="1390" y="229"/>
                      <a:pt x="1390" y="229"/>
                    </a:cubicBezTo>
                    <a:lnTo>
                      <a:pt x="1427" y="271"/>
                    </a:lnTo>
                    <a:lnTo>
                      <a:pt x="1460" y="317"/>
                    </a:lnTo>
                    <a:lnTo>
                      <a:pt x="1486" y="365"/>
                    </a:lnTo>
                    <a:lnTo>
                      <a:pt x="1505" y="415"/>
                    </a:lnTo>
                    <a:cubicBezTo>
                      <a:pt x="1505" y="415"/>
                      <a:pt x="1505" y="415"/>
                      <a:pt x="1505" y="416"/>
                    </a:cubicBezTo>
                    <a:lnTo>
                      <a:pt x="1516" y="467"/>
                    </a:lnTo>
                    <a:lnTo>
                      <a:pt x="1520" y="520"/>
                    </a:lnTo>
                    <a:cubicBezTo>
                      <a:pt x="1520" y="520"/>
                      <a:pt x="1520" y="521"/>
                      <a:pt x="1520" y="521"/>
                    </a:cubicBezTo>
                    <a:lnTo>
                      <a:pt x="1516" y="573"/>
                    </a:lnTo>
                    <a:lnTo>
                      <a:pt x="1505" y="625"/>
                    </a:lnTo>
                    <a:cubicBezTo>
                      <a:pt x="1505" y="626"/>
                      <a:pt x="1505" y="626"/>
                      <a:pt x="1505" y="626"/>
                    </a:cubicBezTo>
                    <a:lnTo>
                      <a:pt x="1486" y="675"/>
                    </a:lnTo>
                    <a:lnTo>
                      <a:pt x="1461" y="723"/>
                    </a:lnTo>
                    <a:lnTo>
                      <a:pt x="1428" y="769"/>
                    </a:lnTo>
                    <a:lnTo>
                      <a:pt x="1390" y="812"/>
                    </a:lnTo>
                    <a:cubicBezTo>
                      <a:pt x="1390" y="812"/>
                      <a:pt x="1390" y="812"/>
                      <a:pt x="1390" y="813"/>
                    </a:cubicBezTo>
                    <a:lnTo>
                      <a:pt x="1298" y="889"/>
                    </a:lnTo>
                    <a:cubicBezTo>
                      <a:pt x="1297" y="889"/>
                      <a:pt x="1297" y="889"/>
                      <a:pt x="1296" y="889"/>
                    </a:cubicBezTo>
                    <a:lnTo>
                      <a:pt x="1185" y="952"/>
                    </a:lnTo>
                    <a:cubicBezTo>
                      <a:pt x="1185" y="953"/>
                      <a:pt x="1185" y="953"/>
                      <a:pt x="1184" y="953"/>
                    </a:cubicBezTo>
                    <a:lnTo>
                      <a:pt x="1056" y="1000"/>
                    </a:lnTo>
                    <a:cubicBezTo>
                      <a:pt x="1056" y="1000"/>
                      <a:pt x="1056" y="1000"/>
                      <a:pt x="1055" y="1000"/>
                    </a:cubicBezTo>
                    <a:lnTo>
                      <a:pt x="914" y="1030"/>
                    </a:lnTo>
                    <a:cubicBezTo>
                      <a:pt x="914" y="1030"/>
                      <a:pt x="913" y="1030"/>
                      <a:pt x="913" y="1030"/>
                    </a:cubicBezTo>
                    <a:lnTo>
                      <a:pt x="761" y="1040"/>
                    </a:lnTo>
                    <a:lnTo>
                      <a:pt x="609" y="1030"/>
                    </a:lnTo>
                    <a:cubicBezTo>
                      <a:pt x="609" y="1030"/>
                      <a:pt x="608" y="1030"/>
                      <a:pt x="608" y="1030"/>
                    </a:cubicBezTo>
                    <a:lnTo>
                      <a:pt x="466" y="1000"/>
                    </a:lnTo>
                    <a:cubicBezTo>
                      <a:pt x="465" y="1000"/>
                      <a:pt x="465" y="1000"/>
                      <a:pt x="465" y="1000"/>
                    </a:cubicBezTo>
                    <a:lnTo>
                      <a:pt x="338" y="953"/>
                    </a:lnTo>
                    <a:cubicBezTo>
                      <a:pt x="337" y="953"/>
                      <a:pt x="337" y="953"/>
                      <a:pt x="337" y="952"/>
                    </a:cubicBezTo>
                    <a:lnTo>
                      <a:pt x="225" y="889"/>
                    </a:lnTo>
                    <a:cubicBezTo>
                      <a:pt x="224" y="889"/>
                      <a:pt x="224" y="889"/>
                      <a:pt x="223" y="889"/>
                    </a:cubicBezTo>
                    <a:lnTo>
                      <a:pt x="132" y="813"/>
                    </a:lnTo>
                    <a:lnTo>
                      <a:pt x="94" y="770"/>
                    </a:lnTo>
                    <a:lnTo>
                      <a:pt x="61" y="724"/>
                    </a:lnTo>
                    <a:lnTo>
                      <a:pt x="35" y="676"/>
                    </a:lnTo>
                    <a:lnTo>
                      <a:pt x="16" y="626"/>
                    </a:lnTo>
                    <a:cubicBezTo>
                      <a:pt x="16" y="626"/>
                      <a:pt x="16" y="626"/>
                      <a:pt x="16" y="625"/>
                    </a:cubicBezTo>
                    <a:lnTo>
                      <a:pt x="5" y="574"/>
                    </a:lnTo>
                    <a:lnTo>
                      <a:pt x="0" y="521"/>
                    </a:lnTo>
                    <a:close/>
                    <a:moveTo>
                      <a:pt x="20" y="571"/>
                    </a:moveTo>
                    <a:lnTo>
                      <a:pt x="31" y="622"/>
                    </a:lnTo>
                    <a:lnTo>
                      <a:pt x="31" y="621"/>
                    </a:lnTo>
                    <a:lnTo>
                      <a:pt x="50" y="669"/>
                    </a:lnTo>
                    <a:lnTo>
                      <a:pt x="74" y="715"/>
                    </a:lnTo>
                    <a:lnTo>
                      <a:pt x="105" y="759"/>
                    </a:lnTo>
                    <a:lnTo>
                      <a:pt x="143" y="800"/>
                    </a:lnTo>
                    <a:lnTo>
                      <a:pt x="234" y="876"/>
                    </a:lnTo>
                    <a:lnTo>
                      <a:pt x="232" y="875"/>
                    </a:lnTo>
                    <a:lnTo>
                      <a:pt x="344" y="938"/>
                    </a:lnTo>
                    <a:lnTo>
                      <a:pt x="343" y="938"/>
                    </a:lnTo>
                    <a:lnTo>
                      <a:pt x="470" y="985"/>
                    </a:lnTo>
                    <a:lnTo>
                      <a:pt x="469" y="985"/>
                    </a:lnTo>
                    <a:lnTo>
                      <a:pt x="611" y="1015"/>
                    </a:lnTo>
                    <a:lnTo>
                      <a:pt x="610" y="1014"/>
                    </a:lnTo>
                    <a:lnTo>
                      <a:pt x="760" y="1024"/>
                    </a:lnTo>
                    <a:lnTo>
                      <a:pt x="912" y="1014"/>
                    </a:lnTo>
                    <a:lnTo>
                      <a:pt x="911" y="1015"/>
                    </a:lnTo>
                    <a:lnTo>
                      <a:pt x="1052" y="985"/>
                    </a:lnTo>
                    <a:lnTo>
                      <a:pt x="1051" y="985"/>
                    </a:lnTo>
                    <a:lnTo>
                      <a:pt x="1179" y="938"/>
                    </a:lnTo>
                    <a:lnTo>
                      <a:pt x="1178" y="939"/>
                    </a:lnTo>
                    <a:lnTo>
                      <a:pt x="1289" y="876"/>
                    </a:lnTo>
                    <a:lnTo>
                      <a:pt x="1287" y="876"/>
                    </a:lnTo>
                    <a:lnTo>
                      <a:pt x="1379" y="800"/>
                    </a:lnTo>
                    <a:lnTo>
                      <a:pt x="1378" y="801"/>
                    </a:lnTo>
                    <a:lnTo>
                      <a:pt x="1415" y="760"/>
                    </a:lnTo>
                    <a:lnTo>
                      <a:pt x="1446" y="716"/>
                    </a:lnTo>
                    <a:lnTo>
                      <a:pt x="1471" y="670"/>
                    </a:lnTo>
                    <a:lnTo>
                      <a:pt x="1490" y="621"/>
                    </a:lnTo>
                    <a:lnTo>
                      <a:pt x="1490" y="622"/>
                    </a:lnTo>
                    <a:lnTo>
                      <a:pt x="1500" y="572"/>
                    </a:lnTo>
                    <a:lnTo>
                      <a:pt x="1504" y="520"/>
                    </a:lnTo>
                    <a:lnTo>
                      <a:pt x="1504" y="521"/>
                    </a:lnTo>
                    <a:lnTo>
                      <a:pt x="1501" y="470"/>
                    </a:lnTo>
                    <a:lnTo>
                      <a:pt x="1490" y="419"/>
                    </a:lnTo>
                    <a:lnTo>
                      <a:pt x="1490" y="420"/>
                    </a:lnTo>
                    <a:lnTo>
                      <a:pt x="1471" y="372"/>
                    </a:lnTo>
                    <a:lnTo>
                      <a:pt x="1447" y="326"/>
                    </a:lnTo>
                    <a:lnTo>
                      <a:pt x="1415" y="282"/>
                    </a:lnTo>
                    <a:lnTo>
                      <a:pt x="1378" y="240"/>
                    </a:lnTo>
                    <a:lnTo>
                      <a:pt x="1379" y="241"/>
                    </a:lnTo>
                    <a:lnTo>
                      <a:pt x="1287" y="165"/>
                    </a:lnTo>
                    <a:lnTo>
                      <a:pt x="1289" y="165"/>
                    </a:lnTo>
                    <a:lnTo>
                      <a:pt x="1178" y="103"/>
                    </a:lnTo>
                    <a:lnTo>
                      <a:pt x="1179" y="104"/>
                    </a:lnTo>
                    <a:lnTo>
                      <a:pt x="1051" y="56"/>
                    </a:lnTo>
                    <a:lnTo>
                      <a:pt x="1052" y="56"/>
                    </a:lnTo>
                    <a:lnTo>
                      <a:pt x="911" y="26"/>
                    </a:lnTo>
                    <a:lnTo>
                      <a:pt x="912" y="26"/>
                    </a:lnTo>
                    <a:lnTo>
                      <a:pt x="761" y="16"/>
                    </a:lnTo>
                    <a:lnTo>
                      <a:pt x="610" y="26"/>
                    </a:lnTo>
                    <a:lnTo>
                      <a:pt x="611" y="26"/>
                    </a:lnTo>
                    <a:lnTo>
                      <a:pt x="469" y="56"/>
                    </a:lnTo>
                    <a:lnTo>
                      <a:pt x="470" y="56"/>
                    </a:lnTo>
                    <a:lnTo>
                      <a:pt x="343" y="104"/>
                    </a:lnTo>
                    <a:lnTo>
                      <a:pt x="344" y="103"/>
                    </a:lnTo>
                    <a:lnTo>
                      <a:pt x="232" y="165"/>
                    </a:lnTo>
                    <a:lnTo>
                      <a:pt x="234" y="165"/>
                    </a:lnTo>
                    <a:lnTo>
                      <a:pt x="143" y="240"/>
                    </a:lnTo>
                    <a:lnTo>
                      <a:pt x="106" y="281"/>
                    </a:lnTo>
                    <a:lnTo>
                      <a:pt x="75" y="325"/>
                    </a:lnTo>
                    <a:lnTo>
                      <a:pt x="50" y="371"/>
                    </a:lnTo>
                    <a:lnTo>
                      <a:pt x="31" y="420"/>
                    </a:lnTo>
                    <a:lnTo>
                      <a:pt x="31" y="419"/>
                    </a:lnTo>
                    <a:lnTo>
                      <a:pt x="20" y="469"/>
                    </a:lnTo>
                    <a:lnTo>
                      <a:pt x="16" y="521"/>
                    </a:lnTo>
                    <a:lnTo>
                      <a:pt x="16" y="520"/>
                    </a:lnTo>
                    <a:lnTo>
                      <a:pt x="20" y="571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60" name="Freeform 198">
              <a:extLst>
                <a:ext uri="{FF2B5EF4-FFF2-40B4-BE49-F238E27FC236}">
                  <a16:creationId xmlns:a16="http://schemas.microsoft.com/office/drawing/2014/main" id="{7D8E64D9-C655-44FE-AB30-1CCCA7BC4E6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988" y="2327"/>
              <a:ext cx="96" cy="95"/>
            </a:xfrm>
            <a:custGeom>
              <a:avLst/>
              <a:gdLst>
                <a:gd name="T0" fmla="*/ 94 w 96"/>
                <a:gd name="T1" fmla="*/ 0 h 95"/>
                <a:gd name="T2" fmla="*/ 17 w 96"/>
                <a:gd name="T3" fmla="*/ 76 h 95"/>
                <a:gd name="T4" fmla="*/ 20 w 96"/>
                <a:gd name="T5" fmla="*/ 78 h 95"/>
                <a:gd name="T6" fmla="*/ 96 w 96"/>
                <a:gd name="T7" fmla="*/ 3 h 95"/>
                <a:gd name="T8" fmla="*/ 94 w 96"/>
                <a:gd name="T9" fmla="*/ 0 h 95"/>
                <a:gd name="T10" fmla="*/ 11 w 96"/>
                <a:gd name="T11" fmla="*/ 62 h 95"/>
                <a:gd name="T12" fmla="*/ 0 w 96"/>
                <a:gd name="T13" fmla="*/ 95 h 95"/>
                <a:gd name="T14" fmla="*/ 33 w 96"/>
                <a:gd name="T15" fmla="*/ 84 h 95"/>
                <a:gd name="T16" fmla="*/ 11 w 96"/>
                <a:gd name="T17" fmla="*/ 62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96" h="95">
                  <a:moveTo>
                    <a:pt x="94" y="0"/>
                  </a:moveTo>
                  <a:lnTo>
                    <a:pt x="17" y="76"/>
                  </a:lnTo>
                  <a:lnTo>
                    <a:pt x="20" y="78"/>
                  </a:lnTo>
                  <a:lnTo>
                    <a:pt x="96" y="3"/>
                  </a:lnTo>
                  <a:lnTo>
                    <a:pt x="94" y="0"/>
                  </a:lnTo>
                  <a:close/>
                  <a:moveTo>
                    <a:pt x="11" y="62"/>
                  </a:moveTo>
                  <a:lnTo>
                    <a:pt x="0" y="95"/>
                  </a:lnTo>
                  <a:lnTo>
                    <a:pt x="33" y="84"/>
                  </a:lnTo>
                  <a:lnTo>
                    <a:pt x="11" y="62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" name="Freeform 199">
              <a:extLst>
                <a:ext uri="{FF2B5EF4-FFF2-40B4-BE49-F238E27FC236}">
                  <a16:creationId xmlns:a16="http://schemas.microsoft.com/office/drawing/2014/main" id="{899EF4C1-C886-456D-B33D-15956947BBDE}"/>
                </a:ext>
              </a:extLst>
            </p:cNvPr>
            <p:cNvSpPr>
              <a:spLocks/>
            </p:cNvSpPr>
            <p:nvPr/>
          </p:nvSpPr>
          <p:spPr bwMode="auto">
            <a:xfrm>
              <a:off x="482" y="2345"/>
              <a:ext cx="52" cy="90"/>
            </a:xfrm>
            <a:custGeom>
              <a:avLst/>
              <a:gdLst>
                <a:gd name="T0" fmla="*/ 0 w 52"/>
                <a:gd name="T1" fmla="*/ 86 h 90"/>
                <a:gd name="T2" fmla="*/ 44 w 52"/>
                <a:gd name="T3" fmla="*/ 0 h 90"/>
                <a:gd name="T4" fmla="*/ 52 w 52"/>
                <a:gd name="T5" fmla="*/ 4 h 90"/>
                <a:gd name="T6" fmla="*/ 8 w 52"/>
                <a:gd name="T7" fmla="*/ 90 h 90"/>
                <a:gd name="T8" fmla="*/ 0 w 52"/>
                <a:gd name="T9" fmla="*/ 86 h 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2" h="90">
                  <a:moveTo>
                    <a:pt x="0" y="86"/>
                  </a:moveTo>
                  <a:lnTo>
                    <a:pt x="44" y="0"/>
                  </a:lnTo>
                  <a:lnTo>
                    <a:pt x="52" y="4"/>
                  </a:lnTo>
                  <a:lnTo>
                    <a:pt x="8" y="90"/>
                  </a:lnTo>
                  <a:lnTo>
                    <a:pt x="0" y="86"/>
                  </a:lnTo>
                  <a:close/>
                </a:path>
              </a:pathLst>
            </a:custGeom>
            <a:solidFill>
              <a:srgbClr val="FAC09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" name="Freeform 200">
              <a:extLst>
                <a:ext uri="{FF2B5EF4-FFF2-40B4-BE49-F238E27FC236}">
                  <a16:creationId xmlns:a16="http://schemas.microsoft.com/office/drawing/2014/main" id="{4370461A-BDC6-48D1-8E89-E695A7CDDAA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1" y="2344"/>
              <a:ext cx="55" cy="92"/>
            </a:xfrm>
            <a:custGeom>
              <a:avLst/>
              <a:gdLst>
                <a:gd name="T0" fmla="*/ 25 w 1419"/>
                <a:gd name="T1" fmla="*/ 2274 h 2370"/>
                <a:gd name="T2" fmla="*/ 10 w 1419"/>
                <a:gd name="T3" fmla="*/ 2224 h 2370"/>
                <a:gd name="T4" fmla="*/ 1145 w 1419"/>
                <a:gd name="T5" fmla="*/ 28 h 2370"/>
                <a:gd name="T6" fmla="*/ 1196 w 1419"/>
                <a:gd name="T7" fmla="*/ 8 h 2370"/>
                <a:gd name="T8" fmla="*/ 1397 w 1419"/>
                <a:gd name="T9" fmla="*/ 91 h 2370"/>
                <a:gd name="T10" fmla="*/ 1416 w 1419"/>
                <a:gd name="T11" fmla="*/ 112 h 2370"/>
                <a:gd name="T12" fmla="*/ 1413 w 1419"/>
                <a:gd name="T13" fmla="*/ 141 h 2370"/>
                <a:gd name="T14" fmla="*/ 286 w 1419"/>
                <a:gd name="T15" fmla="*/ 2345 h 2370"/>
                <a:gd name="T16" fmla="*/ 263 w 1419"/>
                <a:gd name="T17" fmla="*/ 2366 h 2370"/>
                <a:gd name="T18" fmla="*/ 234 w 1419"/>
                <a:gd name="T19" fmla="*/ 2366 h 2370"/>
                <a:gd name="T20" fmla="*/ 25 w 1419"/>
                <a:gd name="T21" fmla="*/ 2274 h 2370"/>
                <a:gd name="T22" fmla="*/ 270 w 1419"/>
                <a:gd name="T23" fmla="*/ 2296 h 2370"/>
                <a:gd name="T24" fmla="*/ 218 w 1419"/>
                <a:gd name="T25" fmla="*/ 2316 h 2370"/>
                <a:gd name="T26" fmla="*/ 1345 w 1419"/>
                <a:gd name="T27" fmla="*/ 112 h 2370"/>
                <a:gd name="T28" fmla="*/ 1362 w 1419"/>
                <a:gd name="T29" fmla="*/ 162 h 2370"/>
                <a:gd name="T30" fmla="*/ 1161 w 1419"/>
                <a:gd name="T31" fmla="*/ 79 h 2370"/>
                <a:gd name="T32" fmla="*/ 1213 w 1419"/>
                <a:gd name="T33" fmla="*/ 58 h 2370"/>
                <a:gd name="T34" fmla="*/ 78 w 1419"/>
                <a:gd name="T35" fmla="*/ 2253 h 2370"/>
                <a:gd name="T36" fmla="*/ 62 w 1419"/>
                <a:gd name="T37" fmla="*/ 2203 h 2370"/>
                <a:gd name="T38" fmla="*/ 270 w 1419"/>
                <a:gd name="T39" fmla="*/ 2296 h 23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1419" h="2370">
                  <a:moveTo>
                    <a:pt x="25" y="2274"/>
                  </a:moveTo>
                  <a:cubicBezTo>
                    <a:pt x="7" y="2265"/>
                    <a:pt x="0" y="2243"/>
                    <a:pt x="10" y="2224"/>
                  </a:cubicBezTo>
                  <a:lnTo>
                    <a:pt x="1145" y="28"/>
                  </a:lnTo>
                  <a:cubicBezTo>
                    <a:pt x="1155" y="9"/>
                    <a:pt x="1178" y="0"/>
                    <a:pt x="1196" y="8"/>
                  </a:cubicBezTo>
                  <a:lnTo>
                    <a:pt x="1397" y="91"/>
                  </a:lnTo>
                  <a:cubicBezTo>
                    <a:pt x="1406" y="95"/>
                    <a:pt x="1413" y="102"/>
                    <a:pt x="1416" y="112"/>
                  </a:cubicBezTo>
                  <a:cubicBezTo>
                    <a:pt x="1419" y="121"/>
                    <a:pt x="1418" y="132"/>
                    <a:pt x="1413" y="141"/>
                  </a:cubicBezTo>
                  <a:lnTo>
                    <a:pt x="286" y="2345"/>
                  </a:lnTo>
                  <a:cubicBezTo>
                    <a:pt x="281" y="2355"/>
                    <a:pt x="273" y="2362"/>
                    <a:pt x="263" y="2366"/>
                  </a:cubicBezTo>
                  <a:cubicBezTo>
                    <a:pt x="254" y="2370"/>
                    <a:pt x="243" y="2370"/>
                    <a:pt x="234" y="2366"/>
                  </a:cubicBezTo>
                  <a:lnTo>
                    <a:pt x="25" y="2274"/>
                  </a:lnTo>
                  <a:close/>
                  <a:moveTo>
                    <a:pt x="270" y="2296"/>
                  </a:moveTo>
                  <a:lnTo>
                    <a:pt x="218" y="2316"/>
                  </a:lnTo>
                  <a:lnTo>
                    <a:pt x="1345" y="112"/>
                  </a:lnTo>
                  <a:lnTo>
                    <a:pt x="1362" y="162"/>
                  </a:lnTo>
                  <a:lnTo>
                    <a:pt x="1161" y="79"/>
                  </a:lnTo>
                  <a:lnTo>
                    <a:pt x="1213" y="58"/>
                  </a:lnTo>
                  <a:lnTo>
                    <a:pt x="78" y="2253"/>
                  </a:lnTo>
                  <a:lnTo>
                    <a:pt x="62" y="2203"/>
                  </a:lnTo>
                  <a:lnTo>
                    <a:pt x="270" y="2296"/>
                  </a:lnTo>
                  <a:close/>
                </a:path>
              </a:pathLst>
            </a:custGeom>
            <a:solidFill>
              <a:srgbClr val="FAC090"/>
            </a:solidFill>
            <a:ln w="0" cap="flat">
              <a:solidFill>
                <a:srgbClr val="FAC09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" name="Freeform 201">
              <a:extLst>
                <a:ext uri="{FF2B5EF4-FFF2-40B4-BE49-F238E27FC236}">
                  <a16:creationId xmlns:a16="http://schemas.microsoft.com/office/drawing/2014/main" id="{CE06CC8B-80A1-4CA2-A239-E5AC015769D7}"/>
                </a:ext>
              </a:extLst>
            </p:cNvPr>
            <p:cNvSpPr>
              <a:spLocks/>
            </p:cNvSpPr>
            <p:nvPr/>
          </p:nvSpPr>
          <p:spPr bwMode="auto">
            <a:xfrm>
              <a:off x="568" y="2346"/>
              <a:ext cx="69" cy="93"/>
            </a:xfrm>
            <a:custGeom>
              <a:avLst/>
              <a:gdLst>
                <a:gd name="T0" fmla="*/ 0 w 69"/>
                <a:gd name="T1" fmla="*/ 88 h 93"/>
                <a:gd name="T2" fmla="*/ 61 w 69"/>
                <a:gd name="T3" fmla="*/ 0 h 93"/>
                <a:gd name="T4" fmla="*/ 69 w 69"/>
                <a:gd name="T5" fmla="*/ 5 h 93"/>
                <a:gd name="T6" fmla="*/ 7 w 69"/>
                <a:gd name="T7" fmla="*/ 93 h 93"/>
                <a:gd name="T8" fmla="*/ 0 w 69"/>
                <a:gd name="T9" fmla="*/ 88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9" h="93">
                  <a:moveTo>
                    <a:pt x="0" y="88"/>
                  </a:moveTo>
                  <a:lnTo>
                    <a:pt x="61" y="0"/>
                  </a:lnTo>
                  <a:lnTo>
                    <a:pt x="69" y="5"/>
                  </a:lnTo>
                  <a:lnTo>
                    <a:pt x="7" y="93"/>
                  </a:lnTo>
                  <a:lnTo>
                    <a:pt x="0" y="88"/>
                  </a:lnTo>
                  <a:close/>
                </a:path>
              </a:pathLst>
            </a:custGeom>
            <a:solidFill>
              <a:srgbClr val="C0000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" name="Freeform 202">
              <a:extLst>
                <a:ext uri="{FF2B5EF4-FFF2-40B4-BE49-F238E27FC236}">
                  <a16:creationId xmlns:a16="http://schemas.microsoft.com/office/drawing/2014/main" id="{F87FC304-4464-4942-AD95-08560A18250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66" y="2344"/>
              <a:ext cx="72" cy="97"/>
            </a:xfrm>
            <a:custGeom>
              <a:avLst/>
              <a:gdLst>
                <a:gd name="T0" fmla="*/ 19 w 1853"/>
                <a:gd name="T1" fmla="*/ 2320 h 2468"/>
                <a:gd name="T2" fmla="*/ 12 w 1853"/>
                <a:gd name="T3" fmla="*/ 2269 h 2468"/>
                <a:gd name="T4" fmla="*/ 1581 w 1853"/>
                <a:gd name="T5" fmla="*/ 20 h 2468"/>
                <a:gd name="T6" fmla="*/ 1608 w 1853"/>
                <a:gd name="T7" fmla="*/ 3 h 2468"/>
                <a:gd name="T8" fmla="*/ 1637 w 1853"/>
                <a:gd name="T9" fmla="*/ 8 h 2468"/>
                <a:gd name="T10" fmla="*/ 1834 w 1853"/>
                <a:gd name="T11" fmla="*/ 148 h 2468"/>
                <a:gd name="T12" fmla="*/ 1841 w 1853"/>
                <a:gd name="T13" fmla="*/ 200 h 2468"/>
                <a:gd name="T14" fmla="*/ 272 w 1853"/>
                <a:gd name="T15" fmla="*/ 2448 h 2468"/>
                <a:gd name="T16" fmla="*/ 246 w 1853"/>
                <a:gd name="T17" fmla="*/ 2466 h 2468"/>
                <a:gd name="T18" fmla="*/ 216 w 1853"/>
                <a:gd name="T19" fmla="*/ 2460 h 2468"/>
                <a:gd name="T20" fmla="*/ 19 w 1853"/>
                <a:gd name="T21" fmla="*/ 2320 h 2468"/>
                <a:gd name="T22" fmla="*/ 265 w 1853"/>
                <a:gd name="T23" fmla="*/ 2397 h 2468"/>
                <a:gd name="T24" fmla="*/ 209 w 1853"/>
                <a:gd name="T25" fmla="*/ 2409 h 2468"/>
                <a:gd name="T26" fmla="*/ 1779 w 1853"/>
                <a:gd name="T27" fmla="*/ 160 h 2468"/>
                <a:gd name="T28" fmla="*/ 1786 w 1853"/>
                <a:gd name="T29" fmla="*/ 212 h 2468"/>
                <a:gd name="T30" fmla="*/ 1588 w 1853"/>
                <a:gd name="T31" fmla="*/ 72 h 2468"/>
                <a:gd name="T32" fmla="*/ 1644 w 1853"/>
                <a:gd name="T33" fmla="*/ 60 h 2468"/>
                <a:gd name="T34" fmla="*/ 74 w 1853"/>
                <a:gd name="T35" fmla="*/ 2308 h 2468"/>
                <a:gd name="T36" fmla="*/ 68 w 1853"/>
                <a:gd name="T37" fmla="*/ 2257 h 2468"/>
                <a:gd name="T38" fmla="*/ 265 w 1853"/>
                <a:gd name="T39" fmla="*/ 2397 h 24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1853" h="2468">
                  <a:moveTo>
                    <a:pt x="19" y="2320"/>
                  </a:moveTo>
                  <a:cubicBezTo>
                    <a:pt x="3" y="2309"/>
                    <a:pt x="0" y="2286"/>
                    <a:pt x="12" y="2269"/>
                  </a:cubicBezTo>
                  <a:lnTo>
                    <a:pt x="1581" y="20"/>
                  </a:lnTo>
                  <a:cubicBezTo>
                    <a:pt x="1588" y="11"/>
                    <a:pt x="1597" y="5"/>
                    <a:pt x="1608" y="3"/>
                  </a:cubicBezTo>
                  <a:cubicBezTo>
                    <a:pt x="1618" y="0"/>
                    <a:pt x="1629" y="2"/>
                    <a:pt x="1637" y="8"/>
                  </a:cubicBezTo>
                  <a:lnTo>
                    <a:pt x="1834" y="148"/>
                  </a:lnTo>
                  <a:cubicBezTo>
                    <a:pt x="1850" y="160"/>
                    <a:pt x="1853" y="182"/>
                    <a:pt x="1841" y="200"/>
                  </a:cubicBezTo>
                  <a:lnTo>
                    <a:pt x="272" y="2448"/>
                  </a:lnTo>
                  <a:cubicBezTo>
                    <a:pt x="265" y="2457"/>
                    <a:pt x="256" y="2464"/>
                    <a:pt x="246" y="2466"/>
                  </a:cubicBezTo>
                  <a:cubicBezTo>
                    <a:pt x="235" y="2468"/>
                    <a:pt x="224" y="2466"/>
                    <a:pt x="216" y="2460"/>
                  </a:cubicBezTo>
                  <a:lnTo>
                    <a:pt x="19" y="2320"/>
                  </a:lnTo>
                  <a:close/>
                  <a:moveTo>
                    <a:pt x="265" y="2397"/>
                  </a:moveTo>
                  <a:lnTo>
                    <a:pt x="209" y="2409"/>
                  </a:lnTo>
                  <a:lnTo>
                    <a:pt x="1779" y="160"/>
                  </a:lnTo>
                  <a:lnTo>
                    <a:pt x="1786" y="212"/>
                  </a:lnTo>
                  <a:lnTo>
                    <a:pt x="1588" y="72"/>
                  </a:lnTo>
                  <a:lnTo>
                    <a:pt x="1644" y="60"/>
                  </a:lnTo>
                  <a:lnTo>
                    <a:pt x="74" y="2308"/>
                  </a:lnTo>
                  <a:lnTo>
                    <a:pt x="68" y="2257"/>
                  </a:lnTo>
                  <a:lnTo>
                    <a:pt x="265" y="2397"/>
                  </a:lnTo>
                  <a:close/>
                </a:path>
              </a:pathLst>
            </a:custGeom>
            <a:solidFill>
              <a:srgbClr val="C00000"/>
            </a:solidFill>
            <a:ln w="0" cap="flat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" name="Freeform 203">
              <a:extLst>
                <a:ext uri="{FF2B5EF4-FFF2-40B4-BE49-F238E27FC236}">
                  <a16:creationId xmlns:a16="http://schemas.microsoft.com/office/drawing/2014/main" id="{3D356064-C2C3-4C1C-A0DB-3773110B98A0}"/>
                </a:ext>
              </a:extLst>
            </p:cNvPr>
            <p:cNvSpPr>
              <a:spLocks/>
            </p:cNvSpPr>
            <p:nvPr/>
          </p:nvSpPr>
          <p:spPr bwMode="auto">
            <a:xfrm>
              <a:off x="521" y="2345"/>
              <a:ext cx="79" cy="92"/>
            </a:xfrm>
            <a:custGeom>
              <a:avLst/>
              <a:gdLst>
                <a:gd name="T0" fmla="*/ 281 w 2021"/>
                <a:gd name="T1" fmla="*/ 2007 h 2374"/>
                <a:gd name="T2" fmla="*/ 736 w 2021"/>
                <a:gd name="T3" fmla="*/ 1626 h 2374"/>
                <a:gd name="T4" fmla="*/ 874 w 2021"/>
                <a:gd name="T5" fmla="*/ 1417 h 2374"/>
                <a:gd name="T6" fmla="*/ 900 w 2021"/>
                <a:gd name="T7" fmla="*/ 1313 h 2374"/>
                <a:gd name="T8" fmla="*/ 897 w 2021"/>
                <a:gd name="T9" fmla="*/ 1189 h 2374"/>
                <a:gd name="T10" fmla="*/ 867 w 2021"/>
                <a:gd name="T11" fmla="*/ 873 h 2374"/>
                <a:gd name="T12" fmla="*/ 832 w 2021"/>
                <a:gd name="T13" fmla="*/ 551 h 2374"/>
                <a:gd name="T14" fmla="*/ 842 w 2021"/>
                <a:gd name="T15" fmla="*/ 370 h 2374"/>
                <a:gd name="T16" fmla="*/ 909 w 2021"/>
                <a:gd name="T17" fmla="*/ 225 h 2374"/>
                <a:gd name="T18" fmla="*/ 1020 w 2021"/>
                <a:gd name="T19" fmla="*/ 122 h 2374"/>
                <a:gd name="T20" fmla="*/ 1142 w 2021"/>
                <a:gd name="T21" fmla="*/ 73 h 2374"/>
                <a:gd name="T22" fmla="*/ 1278 w 2021"/>
                <a:gd name="T23" fmla="*/ 38 h 2374"/>
                <a:gd name="T24" fmla="*/ 1669 w 2021"/>
                <a:gd name="T25" fmla="*/ 21 h 2374"/>
                <a:gd name="T26" fmla="*/ 1835 w 2021"/>
                <a:gd name="T27" fmla="*/ 15 h 2374"/>
                <a:gd name="T28" fmla="*/ 2005 w 2021"/>
                <a:gd name="T29" fmla="*/ 85 h 2374"/>
                <a:gd name="T30" fmla="*/ 1920 w 2021"/>
                <a:gd name="T31" fmla="*/ 233 h 2374"/>
                <a:gd name="T32" fmla="*/ 1830 w 2021"/>
                <a:gd name="T33" fmla="*/ 263 h 2374"/>
                <a:gd name="T34" fmla="*/ 1833 w 2021"/>
                <a:gd name="T35" fmla="*/ 30 h 2374"/>
                <a:gd name="T36" fmla="*/ 1785 w 2021"/>
                <a:gd name="T37" fmla="*/ 158 h 2374"/>
                <a:gd name="T38" fmla="*/ 1903 w 2021"/>
                <a:gd name="T39" fmla="*/ 230 h 2374"/>
                <a:gd name="T40" fmla="*/ 1757 w 2021"/>
                <a:gd name="T41" fmla="*/ 242 h 2374"/>
                <a:gd name="T42" fmla="*/ 1416 w 2021"/>
                <a:gd name="T43" fmla="*/ 250 h 2374"/>
                <a:gd name="T44" fmla="*/ 1301 w 2021"/>
                <a:gd name="T45" fmla="*/ 257 h 2374"/>
                <a:gd name="T46" fmla="*/ 1201 w 2021"/>
                <a:gd name="T47" fmla="*/ 283 h 2374"/>
                <a:gd name="T48" fmla="*/ 1137 w 2021"/>
                <a:gd name="T49" fmla="*/ 299 h 2374"/>
                <a:gd name="T50" fmla="*/ 1091 w 2021"/>
                <a:gd name="T51" fmla="*/ 330 h 2374"/>
                <a:gd name="T52" fmla="*/ 1062 w 2021"/>
                <a:gd name="T53" fmla="*/ 397 h 2374"/>
                <a:gd name="T54" fmla="*/ 1070 w 2021"/>
                <a:gd name="T55" fmla="*/ 660 h 2374"/>
                <a:gd name="T56" fmla="*/ 1114 w 2021"/>
                <a:gd name="T57" fmla="*/ 1002 h 2374"/>
                <a:gd name="T58" fmla="*/ 1123 w 2021"/>
                <a:gd name="T59" fmla="*/ 1333 h 2374"/>
                <a:gd name="T60" fmla="*/ 1074 w 2021"/>
                <a:gd name="T61" fmla="*/ 1498 h 2374"/>
                <a:gd name="T62" fmla="*/ 905 w 2021"/>
                <a:gd name="T63" fmla="*/ 1761 h 2374"/>
                <a:gd name="T64" fmla="*/ 656 w 2021"/>
                <a:gd name="T65" fmla="*/ 1999 h 2374"/>
                <a:gd name="T66" fmla="*/ 111 w 2021"/>
                <a:gd name="T67" fmla="*/ 2374 h 23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2021" h="2374">
                  <a:moveTo>
                    <a:pt x="0" y="2187"/>
                  </a:moveTo>
                  <a:lnTo>
                    <a:pt x="281" y="2007"/>
                  </a:lnTo>
                  <a:lnTo>
                    <a:pt x="534" y="1823"/>
                  </a:lnTo>
                  <a:lnTo>
                    <a:pt x="736" y="1626"/>
                  </a:lnTo>
                  <a:lnTo>
                    <a:pt x="721" y="1648"/>
                  </a:lnTo>
                  <a:lnTo>
                    <a:pt x="874" y="1417"/>
                  </a:lnTo>
                  <a:lnTo>
                    <a:pt x="859" y="1449"/>
                  </a:lnTo>
                  <a:lnTo>
                    <a:pt x="900" y="1313"/>
                  </a:lnTo>
                  <a:lnTo>
                    <a:pt x="892" y="1343"/>
                  </a:lnTo>
                  <a:lnTo>
                    <a:pt x="897" y="1189"/>
                  </a:lnTo>
                  <a:lnTo>
                    <a:pt x="888" y="1035"/>
                  </a:lnTo>
                  <a:lnTo>
                    <a:pt x="867" y="873"/>
                  </a:lnTo>
                  <a:lnTo>
                    <a:pt x="844" y="703"/>
                  </a:lnTo>
                  <a:lnTo>
                    <a:pt x="832" y="551"/>
                  </a:lnTo>
                  <a:lnTo>
                    <a:pt x="837" y="402"/>
                  </a:lnTo>
                  <a:cubicBezTo>
                    <a:pt x="838" y="392"/>
                    <a:pt x="839" y="377"/>
                    <a:pt x="842" y="370"/>
                  </a:cubicBezTo>
                  <a:lnTo>
                    <a:pt x="880" y="269"/>
                  </a:lnTo>
                  <a:cubicBezTo>
                    <a:pt x="887" y="249"/>
                    <a:pt x="896" y="237"/>
                    <a:pt x="909" y="225"/>
                  </a:cubicBezTo>
                  <a:lnTo>
                    <a:pt x="982" y="152"/>
                  </a:lnTo>
                  <a:cubicBezTo>
                    <a:pt x="990" y="139"/>
                    <a:pt x="1006" y="130"/>
                    <a:pt x="1020" y="122"/>
                  </a:cubicBezTo>
                  <a:lnTo>
                    <a:pt x="1122" y="77"/>
                  </a:lnTo>
                  <a:cubicBezTo>
                    <a:pt x="1129" y="75"/>
                    <a:pt x="1137" y="73"/>
                    <a:pt x="1142" y="73"/>
                  </a:cubicBezTo>
                  <a:lnTo>
                    <a:pt x="1262" y="43"/>
                  </a:lnTo>
                  <a:cubicBezTo>
                    <a:pt x="1268" y="38"/>
                    <a:pt x="1273" y="38"/>
                    <a:pt x="1278" y="38"/>
                  </a:cubicBezTo>
                  <a:lnTo>
                    <a:pt x="1409" y="26"/>
                  </a:lnTo>
                  <a:lnTo>
                    <a:pt x="1669" y="21"/>
                  </a:lnTo>
                  <a:lnTo>
                    <a:pt x="1769" y="18"/>
                  </a:lnTo>
                  <a:lnTo>
                    <a:pt x="1835" y="15"/>
                  </a:lnTo>
                  <a:lnTo>
                    <a:pt x="1886" y="6"/>
                  </a:lnTo>
                  <a:cubicBezTo>
                    <a:pt x="1944" y="0"/>
                    <a:pt x="1993" y="33"/>
                    <a:pt x="2005" y="85"/>
                  </a:cubicBezTo>
                  <a:lnTo>
                    <a:pt x="2007" y="93"/>
                  </a:lnTo>
                  <a:cubicBezTo>
                    <a:pt x="2021" y="153"/>
                    <a:pt x="1982" y="214"/>
                    <a:pt x="1920" y="233"/>
                  </a:cubicBezTo>
                  <a:lnTo>
                    <a:pt x="1882" y="244"/>
                  </a:lnTo>
                  <a:lnTo>
                    <a:pt x="1830" y="263"/>
                  </a:lnTo>
                  <a:lnTo>
                    <a:pt x="1766" y="53"/>
                  </a:lnTo>
                  <a:lnTo>
                    <a:pt x="1833" y="30"/>
                  </a:lnTo>
                  <a:lnTo>
                    <a:pt x="1872" y="18"/>
                  </a:lnTo>
                  <a:lnTo>
                    <a:pt x="1785" y="158"/>
                  </a:lnTo>
                  <a:lnTo>
                    <a:pt x="1784" y="150"/>
                  </a:lnTo>
                  <a:lnTo>
                    <a:pt x="1903" y="230"/>
                  </a:lnTo>
                  <a:lnTo>
                    <a:pt x="1832" y="238"/>
                  </a:lnTo>
                  <a:lnTo>
                    <a:pt x="1757" y="242"/>
                  </a:lnTo>
                  <a:lnTo>
                    <a:pt x="1657" y="245"/>
                  </a:lnTo>
                  <a:lnTo>
                    <a:pt x="1416" y="250"/>
                  </a:lnTo>
                  <a:lnTo>
                    <a:pt x="1285" y="262"/>
                  </a:lnTo>
                  <a:lnTo>
                    <a:pt x="1301" y="257"/>
                  </a:lnTo>
                  <a:lnTo>
                    <a:pt x="1180" y="287"/>
                  </a:lnTo>
                  <a:lnTo>
                    <a:pt x="1201" y="283"/>
                  </a:lnTo>
                  <a:lnTo>
                    <a:pt x="1099" y="328"/>
                  </a:lnTo>
                  <a:lnTo>
                    <a:pt x="1137" y="299"/>
                  </a:lnTo>
                  <a:lnTo>
                    <a:pt x="1064" y="372"/>
                  </a:lnTo>
                  <a:lnTo>
                    <a:pt x="1091" y="330"/>
                  </a:lnTo>
                  <a:lnTo>
                    <a:pt x="1054" y="431"/>
                  </a:lnTo>
                  <a:lnTo>
                    <a:pt x="1062" y="397"/>
                  </a:lnTo>
                  <a:lnTo>
                    <a:pt x="1055" y="511"/>
                  </a:lnTo>
                  <a:lnTo>
                    <a:pt x="1070" y="660"/>
                  </a:lnTo>
                  <a:lnTo>
                    <a:pt x="1092" y="822"/>
                  </a:lnTo>
                  <a:lnTo>
                    <a:pt x="1114" y="1002"/>
                  </a:lnTo>
                  <a:lnTo>
                    <a:pt x="1128" y="1179"/>
                  </a:lnTo>
                  <a:lnTo>
                    <a:pt x="1123" y="1333"/>
                  </a:lnTo>
                  <a:cubicBezTo>
                    <a:pt x="1122" y="1343"/>
                    <a:pt x="1121" y="1353"/>
                    <a:pt x="1115" y="1362"/>
                  </a:cubicBezTo>
                  <a:lnTo>
                    <a:pt x="1074" y="1498"/>
                  </a:lnTo>
                  <a:cubicBezTo>
                    <a:pt x="1070" y="1511"/>
                    <a:pt x="1064" y="1520"/>
                    <a:pt x="1058" y="1530"/>
                  </a:cubicBezTo>
                  <a:lnTo>
                    <a:pt x="905" y="1761"/>
                  </a:lnTo>
                  <a:cubicBezTo>
                    <a:pt x="902" y="1768"/>
                    <a:pt x="893" y="1776"/>
                    <a:pt x="888" y="1780"/>
                  </a:cubicBezTo>
                  <a:lnTo>
                    <a:pt x="656" y="1999"/>
                  </a:lnTo>
                  <a:lnTo>
                    <a:pt x="392" y="2193"/>
                  </a:lnTo>
                  <a:lnTo>
                    <a:pt x="111" y="2374"/>
                  </a:lnTo>
                  <a:lnTo>
                    <a:pt x="0" y="2187"/>
                  </a:lnTo>
                  <a:close/>
                </a:path>
              </a:pathLst>
            </a:custGeom>
            <a:solidFill>
              <a:srgbClr val="C3D69B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" name="Freeform 204">
              <a:extLst>
                <a:ext uri="{FF2B5EF4-FFF2-40B4-BE49-F238E27FC236}">
                  <a16:creationId xmlns:a16="http://schemas.microsoft.com/office/drawing/2014/main" id="{A98B7EAB-8B9A-4EAE-A1E5-2CF2F2A9537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19" y="2344"/>
              <a:ext cx="82" cy="95"/>
            </a:xfrm>
            <a:custGeom>
              <a:avLst/>
              <a:gdLst>
                <a:gd name="T0" fmla="*/ 553 w 2091"/>
                <a:gd name="T1" fmla="*/ 1829 h 2446"/>
                <a:gd name="T2" fmla="*/ 743 w 2091"/>
                <a:gd name="T3" fmla="*/ 1714 h 2446"/>
                <a:gd name="T4" fmla="*/ 938 w 2091"/>
                <a:gd name="T5" fmla="*/ 1495 h 2446"/>
                <a:gd name="T6" fmla="*/ 982 w 2091"/>
                <a:gd name="T7" fmla="*/ 1352 h 2446"/>
                <a:gd name="T8" fmla="*/ 894 w 2091"/>
                <a:gd name="T9" fmla="*/ 1073 h 2446"/>
                <a:gd name="T10" fmla="*/ 845 w 2091"/>
                <a:gd name="T11" fmla="*/ 416 h 2446"/>
                <a:gd name="T12" fmla="*/ 909 w 2091"/>
                <a:gd name="T13" fmla="*/ 253 h 2446"/>
                <a:gd name="T14" fmla="*/ 1046 w 2091"/>
                <a:gd name="T15" fmla="*/ 123 h 2446"/>
                <a:gd name="T16" fmla="*/ 1300 w 2091"/>
                <a:gd name="T17" fmla="*/ 39 h 2446"/>
                <a:gd name="T18" fmla="*/ 1453 w 2091"/>
                <a:gd name="T19" fmla="*/ 20 h 2446"/>
                <a:gd name="T20" fmla="*/ 1937 w 2091"/>
                <a:gd name="T21" fmla="*/ 0 h 2446"/>
                <a:gd name="T22" fmla="*/ 2063 w 2091"/>
                <a:gd name="T23" fmla="*/ 54 h 2446"/>
                <a:gd name="T24" fmla="*/ 2090 w 2091"/>
                <a:gd name="T25" fmla="*/ 121 h 2446"/>
                <a:gd name="T26" fmla="*/ 2035 w 2091"/>
                <a:gd name="T27" fmla="*/ 268 h 2446"/>
                <a:gd name="T28" fmla="*/ 1885 w 2091"/>
                <a:gd name="T29" fmla="*/ 331 h 2446"/>
                <a:gd name="T30" fmla="*/ 1868 w 2091"/>
                <a:gd name="T31" fmla="*/ 27 h 2446"/>
                <a:gd name="T32" fmla="*/ 1821 w 2091"/>
                <a:gd name="T33" fmla="*/ 228 h 2446"/>
                <a:gd name="T34" fmla="*/ 1971 w 2091"/>
                <a:gd name="T35" fmla="*/ 230 h 2446"/>
                <a:gd name="T36" fmla="*/ 1699 w 2091"/>
                <a:gd name="T37" fmla="*/ 316 h 2446"/>
                <a:gd name="T38" fmla="*/ 1337 w 2091"/>
                <a:gd name="T39" fmla="*/ 253 h 2446"/>
                <a:gd name="T40" fmla="*/ 1283 w 2091"/>
                <a:gd name="T41" fmla="*/ 304 h 2446"/>
                <a:gd name="T42" fmla="*/ 1160 w 2091"/>
                <a:gd name="T43" fmla="*/ 302 h 2446"/>
                <a:gd name="T44" fmla="*/ 1076 w 2091"/>
                <a:gd name="T45" fmla="*/ 386 h 2446"/>
                <a:gd name="T46" fmla="*/ 1087 w 2091"/>
                <a:gd name="T47" fmla="*/ 501 h 2446"/>
                <a:gd name="T48" fmla="*/ 1138 w 2091"/>
                <a:gd name="T49" fmla="*/ 542 h 2446"/>
                <a:gd name="T50" fmla="*/ 1211 w 2091"/>
                <a:gd name="T51" fmla="*/ 1205 h 2446"/>
                <a:gd name="T52" fmla="*/ 1155 w 2091"/>
                <a:gd name="T53" fmla="*/ 1538 h 2446"/>
                <a:gd name="T54" fmla="*/ 966 w 2091"/>
                <a:gd name="T55" fmla="*/ 1832 h 2446"/>
                <a:gd name="T56" fmla="*/ 145 w 2091"/>
                <a:gd name="T57" fmla="*/ 2444 h 2446"/>
                <a:gd name="T58" fmla="*/ 415 w 2091"/>
                <a:gd name="T59" fmla="*/ 2196 h 2446"/>
                <a:gd name="T60" fmla="*/ 918 w 2091"/>
                <a:gd name="T61" fmla="*/ 1775 h 2446"/>
                <a:gd name="T62" fmla="*/ 1130 w 2091"/>
                <a:gd name="T63" fmla="*/ 1368 h 2446"/>
                <a:gd name="T64" fmla="*/ 1098 w 2091"/>
                <a:gd name="T65" fmla="*/ 863 h 2446"/>
                <a:gd name="T66" fmla="*/ 1144 w 2091"/>
                <a:gd name="T67" fmla="*/ 435 h 2446"/>
                <a:gd name="T68" fmla="*/ 1140 w 2091"/>
                <a:gd name="T69" fmla="*/ 423 h 2446"/>
                <a:gd name="T70" fmla="*/ 1130 w 2091"/>
                <a:gd name="T71" fmla="*/ 326 h 2446"/>
                <a:gd name="T72" fmla="*/ 1218 w 2091"/>
                <a:gd name="T73" fmla="*/ 282 h 2446"/>
                <a:gd name="T74" fmla="*/ 1329 w 2091"/>
                <a:gd name="T75" fmla="*/ 256 h 2446"/>
                <a:gd name="T76" fmla="*/ 1946 w 2091"/>
                <a:gd name="T77" fmla="*/ 225 h 2446"/>
                <a:gd name="T78" fmla="*/ 1797 w 2091"/>
                <a:gd name="T79" fmla="*/ 173 h 2446"/>
                <a:gd name="T80" fmla="*/ 1847 w 2091"/>
                <a:gd name="T81" fmla="*/ 72 h 2446"/>
                <a:gd name="T82" fmla="*/ 1950 w 2091"/>
                <a:gd name="T83" fmla="*/ 232 h 2446"/>
                <a:gd name="T84" fmla="*/ 2017 w 2091"/>
                <a:gd name="T85" fmla="*/ 159 h 2446"/>
                <a:gd name="T86" fmla="*/ 2014 w 2091"/>
                <a:gd name="T87" fmla="*/ 135 h 2446"/>
                <a:gd name="T88" fmla="*/ 1954 w 2091"/>
                <a:gd name="T89" fmla="*/ 77 h 2446"/>
                <a:gd name="T90" fmla="*/ 1811 w 2091"/>
                <a:gd name="T91" fmla="*/ 89 h 2446"/>
                <a:gd name="T92" fmla="*/ 1329 w 2091"/>
                <a:gd name="T93" fmla="*/ 105 h 2446"/>
                <a:gd name="T94" fmla="*/ 1179 w 2091"/>
                <a:gd name="T95" fmla="*/ 144 h 2446"/>
                <a:gd name="T96" fmla="*/ 1053 w 2091"/>
                <a:gd name="T97" fmla="*/ 210 h 2446"/>
                <a:gd name="T98" fmla="*/ 922 w 2091"/>
                <a:gd name="T99" fmla="*/ 413 h 2446"/>
                <a:gd name="T100" fmla="*/ 927 w 2091"/>
                <a:gd name="T101" fmla="*/ 727 h 2446"/>
                <a:gd name="T102" fmla="*/ 899 w 2091"/>
                <a:gd name="T103" fmla="*/ 1369 h 2446"/>
                <a:gd name="T104" fmla="*/ 884 w 2091"/>
                <a:gd name="T105" fmla="*/ 1436 h 2446"/>
                <a:gd name="T106" fmla="*/ 806 w 2091"/>
                <a:gd name="T107" fmla="*/ 1684 h 2446"/>
                <a:gd name="T108" fmla="*/ 78 w 2091"/>
                <a:gd name="T109" fmla="*/ 2198 h 24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2091" h="2446">
                  <a:moveTo>
                    <a:pt x="11" y="2241"/>
                  </a:moveTo>
                  <a:cubicBezTo>
                    <a:pt x="0" y="2224"/>
                    <a:pt x="7" y="2200"/>
                    <a:pt x="26" y="2188"/>
                  </a:cubicBezTo>
                  <a:lnTo>
                    <a:pt x="307" y="2008"/>
                  </a:lnTo>
                  <a:lnTo>
                    <a:pt x="557" y="1825"/>
                  </a:lnTo>
                  <a:lnTo>
                    <a:pt x="553" y="1829"/>
                  </a:lnTo>
                  <a:lnTo>
                    <a:pt x="755" y="1632"/>
                  </a:lnTo>
                  <a:cubicBezTo>
                    <a:pt x="769" y="1618"/>
                    <a:pt x="791" y="1616"/>
                    <a:pt x="806" y="1628"/>
                  </a:cubicBezTo>
                  <a:cubicBezTo>
                    <a:pt x="821" y="1639"/>
                    <a:pt x="823" y="1661"/>
                    <a:pt x="812" y="1678"/>
                  </a:cubicBezTo>
                  <a:lnTo>
                    <a:pt x="797" y="1700"/>
                  </a:lnTo>
                  <a:cubicBezTo>
                    <a:pt x="785" y="1718"/>
                    <a:pt x="761" y="1724"/>
                    <a:pt x="743" y="1714"/>
                  </a:cubicBezTo>
                  <a:cubicBezTo>
                    <a:pt x="726" y="1703"/>
                    <a:pt x="722" y="1680"/>
                    <a:pt x="734" y="1662"/>
                  </a:cubicBezTo>
                  <a:lnTo>
                    <a:pt x="887" y="1431"/>
                  </a:lnTo>
                  <a:cubicBezTo>
                    <a:pt x="898" y="1413"/>
                    <a:pt x="920" y="1406"/>
                    <a:pt x="938" y="1415"/>
                  </a:cubicBezTo>
                  <a:cubicBezTo>
                    <a:pt x="955" y="1423"/>
                    <a:pt x="962" y="1444"/>
                    <a:pt x="953" y="1463"/>
                  </a:cubicBezTo>
                  <a:lnTo>
                    <a:pt x="938" y="1495"/>
                  </a:lnTo>
                  <a:cubicBezTo>
                    <a:pt x="929" y="1514"/>
                    <a:pt x="908" y="1524"/>
                    <a:pt x="889" y="1518"/>
                  </a:cubicBezTo>
                  <a:cubicBezTo>
                    <a:pt x="871" y="1513"/>
                    <a:pt x="861" y="1493"/>
                    <a:pt x="867" y="1474"/>
                  </a:cubicBezTo>
                  <a:lnTo>
                    <a:pt x="908" y="1338"/>
                  </a:lnTo>
                  <a:cubicBezTo>
                    <a:pt x="914" y="1317"/>
                    <a:pt x="935" y="1304"/>
                    <a:pt x="955" y="1308"/>
                  </a:cubicBezTo>
                  <a:cubicBezTo>
                    <a:pt x="975" y="1312"/>
                    <a:pt x="987" y="1332"/>
                    <a:pt x="982" y="1352"/>
                  </a:cubicBezTo>
                  <a:lnTo>
                    <a:pt x="974" y="1382"/>
                  </a:lnTo>
                  <a:cubicBezTo>
                    <a:pt x="969" y="1401"/>
                    <a:pt x="950" y="1415"/>
                    <a:pt x="931" y="1414"/>
                  </a:cubicBezTo>
                  <a:cubicBezTo>
                    <a:pt x="911" y="1412"/>
                    <a:pt x="897" y="1397"/>
                    <a:pt x="898" y="1378"/>
                  </a:cubicBezTo>
                  <a:lnTo>
                    <a:pt x="903" y="1224"/>
                  </a:lnTo>
                  <a:lnTo>
                    <a:pt x="894" y="1073"/>
                  </a:lnTo>
                  <a:lnTo>
                    <a:pt x="873" y="914"/>
                  </a:lnTo>
                  <a:lnTo>
                    <a:pt x="850" y="744"/>
                  </a:lnTo>
                  <a:lnTo>
                    <a:pt x="838" y="590"/>
                  </a:lnTo>
                  <a:lnTo>
                    <a:pt x="843" y="437"/>
                  </a:lnTo>
                  <a:lnTo>
                    <a:pt x="845" y="416"/>
                  </a:lnTo>
                  <a:lnTo>
                    <a:pt x="849" y="398"/>
                  </a:lnTo>
                  <a:cubicBezTo>
                    <a:pt x="849" y="396"/>
                    <a:pt x="850" y="394"/>
                    <a:pt x="850" y="392"/>
                  </a:cubicBezTo>
                  <a:lnTo>
                    <a:pt x="888" y="291"/>
                  </a:lnTo>
                  <a:lnTo>
                    <a:pt x="902" y="263"/>
                  </a:lnTo>
                  <a:cubicBezTo>
                    <a:pt x="904" y="259"/>
                    <a:pt x="906" y="256"/>
                    <a:pt x="909" y="253"/>
                  </a:cubicBezTo>
                  <a:lnTo>
                    <a:pt x="926" y="234"/>
                  </a:lnTo>
                  <a:lnTo>
                    <a:pt x="1000" y="159"/>
                  </a:lnTo>
                  <a:lnTo>
                    <a:pt x="1017" y="142"/>
                  </a:lnTo>
                  <a:cubicBezTo>
                    <a:pt x="1020" y="139"/>
                    <a:pt x="1022" y="137"/>
                    <a:pt x="1025" y="136"/>
                  </a:cubicBezTo>
                  <a:lnTo>
                    <a:pt x="1046" y="123"/>
                  </a:lnTo>
                  <a:cubicBezTo>
                    <a:pt x="1048" y="122"/>
                    <a:pt x="1050" y="121"/>
                    <a:pt x="1051" y="120"/>
                  </a:cubicBezTo>
                  <a:lnTo>
                    <a:pt x="1153" y="75"/>
                  </a:lnTo>
                  <a:cubicBezTo>
                    <a:pt x="1156" y="74"/>
                    <a:pt x="1159" y="73"/>
                    <a:pt x="1162" y="72"/>
                  </a:cubicBezTo>
                  <a:lnTo>
                    <a:pt x="1182" y="68"/>
                  </a:lnTo>
                  <a:lnTo>
                    <a:pt x="1300" y="39"/>
                  </a:lnTo>
                  <a:lnTo>
                    <a:pt x="1292" y="42"/>
                  </a:lnTo>
                  <a:lnTo>
                    <a:pt x="1300" y="38"/>
                  </a:lnTo>
                  <a:cubicBezTo>
                    <a:pt x="1304" y="36"/>
                    <a:pt x="1308" y="34"/>
                    <a:pt x="1313" y="34"/>
                  </a:cubicBezTo>
                  <a:lnTo>
                    <a:pt x="1321" y="33"/>
                  </a:lnTo>
                  <a:lnTo>
                    <a:pt x="1453" y="20"/>
                  </a:lnTo>
                  <a:lnTo>
                    <a:pt x="1716" y="15"/>
                  </a:lnTo>
                  <a:lnTo>
                    <a:pt x="1816" y="12"/>
                  </a:lnTo>
                  <a:lnTo>
                    <a:pt x="1881" y="9"/>
                  </a:lnTo>
                  <a:lnTo>
                    <a:pt x="1927" y="1"/>
                  </a:lnTo>
                  <a:cubicBezTo>
                    <a:pt x="1930" y="0"/>
                    <a:pt x="1933" y="0"/>
                    <a:pt x="1937" y="0"/>
                  </a:cubicBezTo>
                  <a:lnTo>
                    <a:pt x="1978" y="3"/>
                  </a:lnTo>
                  <a:cubicBezTo>
                    <a:pt x="1982" y="4"/>
                    <a:pt x="1985" y="5"/>
                    <a:pt x="1989" y="6"/>
                  </a:cubicBezTo>
                  <a:lnTo>
                    <a:pt x="2025" y="21"/>
                  </a:lnTo>
                  <a:cubicBezTo>
                    <a:pt x="2029" y="23"/>
                    <a:pt x="2033" y="25"/>
                    <a:pt x="2036" y="28"/>
                  </a:cubicBezTo>
                  <a:lnTo>
                    <a:pt x="2063" y="54"/>
                  </a:lnTo>
                  <a:cubicBezTo>
                    <a:pt x="2066" y="57"/>
                    <a:pt x="2068" y="61"/>
                    <a:pt x="2070" y="65"/>
                  </a:cubicBezTo>
                  <a:lnTo>
                    <a:pt x="2085" y="100"/>
                  </a:lnTo>
                  <a:cubicBezTo>
                    <a:pt x="2086" y="102"/>
                    <a:pt x="2087" y="103"/>
                    <a:pt x="2087" y="105"/>
                  </a:cubicBezTo>
                  <a:lnTo>
                    <a:pt x="2089" y="113"/>
                  </a:lnTo>
                  <a:cubicBezTo>
                    <a:pt x="2090" y="116"/>
                    <a:pt x="2090" y="119"/>
                    <a:pt x="2090" y="121"/>
                  </a:cubicBezTo>
                  <a:lnTo>
                    <a:pt x="2091" y="166"/>
                  </a:lnTo>
                  <a:cubicBezTo>
                    <a:pt x="2091" y="171"/>
                    <a:pt x="2090" y="177"/>
                    <a:pt x="2088" y="182"/>
                  </a:cubicBezTo>
                  <a:lnTo>
                    <a:pt x="2072" y="222"/>
                  </a:lnTo>
                  <a:cubicBezTo>
                    <a:pt x="2070" y="226"/>
                    <a:pt x="2068" y="230"/>
                    <a:pt x="2065" y="234"/>
                  </a:cubicBezTo>
                  <a:lnTo>
                    <a:pt x="2035" y="268"/>
                  </a:lnTo>
                  <a:cubicBezTo>
                    <a:pt x="2031" y="272"/>
                    <a:pt x="2026" y="276"/>
                    <a:pt x="2021" y="278"/>
                  </a:cubicBezTo>
                  <a:lnTo>
                    <a:pt x="1979" y="299"/>
                  </a:lnTo>
                  <a:cubicBezTo>
                    <a:pt x="1977" y="300"/>
                    <a:pt x="1975" y="301"/>
                    <a:pt x="1972" y="302"/>
                  </a:cubicBezTo>
                  <a:lnTo>
                    <a:pt x="1934" y="313"/>
                  </a:lnTo>
                  <a:lnTo>
                    <a:pt x="1885" y="331"/>
                  </a:lnTo>
                  <a:cubicBezTo>
                    <a:pt x="1865" y="339"/>
                    <a:pt x="1843" y="329"/>
                    <a:pt x="1837" y="309"/>
                  </a:cubicBezTo>
                  <a:lnTo>
                    <a:pt x="1773" y="99"/>
                  </a:lnTo>
                  <a:cubicBezTo>
                    <a:pt x="1771" y="90"/>
                    <a:pt x="1772" y="79"/>
                    <a:pt x="1777" y="70"/>
                  </a:cubicBezTo>
                  <a:cubicBezTo>
                    <a:pt x="1782" y="60"/>
                    <a:pt x="1791" y="53"/>
                    <a:pt x="1801" y="50"/>
                  </a:cubicBezTo>
                  <a:lnTo>
                    <a:pt x="1868" y="27"/>
                  </a:lnTo>
                  <a:lnTo>
                    <a:pt x="1908" y="14"/>
                  </a:lnTo>
                  <a:cubicBezTo>
                    <a:pt x="1923" y="9"/>
                    <a:pt x="1939" y="14"/>
                    <a:pt x="1948" y="26"/>
                  </a:cubicBezTo>
                  <a:cubicBezTo>
                    <a:pt x="1957" y="38"/>
                    <a:pt x="1957" y="55"/>
                    <a:pt x="1949" y="68"/>
                  </a:cubicBezTo>
                  <a:lnTo>
                    <a:pt x="1862" y="208"/>
                  </a:lnTo>
                  <a:cubicBezTo>
                    <a:pt x="1853" y="222"/>
                    <a:pt x="1837" y="230"/>
                    <a:pt x="1821" y="228"/>
                  </a:cubicBezTo>
                  <a:cubicBezTo>
                    <a:pt x="1805" y="226"/>
                    <a:pt x="1793" y="214"/>
                    <a:pt x="1791" y="198"/>
                  </a:cubicBezTo>
                  <a:lnTo>
                    <a:pt x="1790" y="190"/>
                  </a:lnTo>
                  <a:cubicBezTo>
                    <a:pt x="1788" y="175"/>
                    <a:pt x="1796" y="160"/>
                    <a:pt x="1809" y="151"/>
                  </a:cubicBezTo>
                  <a:cubicBezTo>
                    <a:pt x="1823" y="142"/>
                    <a:pt x="1840" y="142"/>
                    <a:pt x="1852" y="150"/>
                  </a:cubicBezTo>
                  <a:lnTo>
                    <a:pt x="1971" y="230"/>
                  </a:lnTo>
                  <a:cubicBezTo>
                    <a:pt x="1984" y="239"/>
                    <a:pt x="1989" y="255"/>
                    <a:pt x="1984" y="271"/>
                  </a:cubicBezTo>
                  <a:cubicBezTo>
                    <a:pt x="1979" y="287"/>
                    <a:pt x="1965" y="299"/>
                    <a:pt x="1948" y="300"/>
                  </a:cubicBezTo>
                  <a:lnTo>
                    <a:pt x="1877" y="308"/>
                  </a:lnTo>
                  <a:lnTo>
                    <a:pt x="1800" y="313"/>
                  </a:lnTo>
                  <a:lnTo>
                    <a:pt x="1699" y="316"/>
                  </a:lnTo>
                  <a:lnTo>
                    <a:pt x="1458" y="321"/>
                  </a:lnTo>
                  <a:lnTo>
                    <a:pt x="1330" y="332"/>
                  </a:lnTo>
                  <a:cubicBezTo>
                    <a:pt x="1310" y="334"/>
                    <a:pt x="1293" y="321"/>
                    <a:pt x="1291" y="302"/>
                  </a:cubicBezTo>
                  <a:cubicBezTo>
                    <a:pt x="1289" y="283"/>
                    <a:pt x="1302" y="264"/>
                    <a:pt x="1321" y="258"/>
                  </a:cubicBezTo>
                  <a:lnTo>
                    <a:pt x="1337" y="253"/>
                  </a:lnTo>
                  <a:lnTo>
                    <a:pt x="1352" y="326"/>
                  </a:lnTo>
                  <a:lnTo>
                    <a:pt x="1231" y="356"/>
                  </a:lnTo>
                  <a:lnTo>
                    <a:pt x="1220" y="282"/>
                  </a:lnTo>
                  <a:lnTo>
                    <a:pt x="1241" y="278"/>
                  </a:lnTo>
                  <a:cubicBezTo>
                    <a:pt x="1261" y="274"/>
                    <a:pt x="1279" y="285"/>
                    <a:pt x="1283" y="304"/>
                  </a:cubicBezTo>
                  <a:cubicBezTo>
                    <a:pt x="1287" y="322"/>
                    <a:pt x="1277" y="342"/>
                    <a:pt x="1258" y="350"/>
                  </a:cubicBezTo>
                  <a:lnTo>
                    <a:pt x="1156" y="395"/>
                  </a:lnTo>
                  <a:cubicBezTo>
                    <a:pt x="1138" y="403"/>
                    <a:pt x="1118" y="397"/>
                    <a:pt x="1109" y="381"/>
                  </a:cubicBezTo>
                  <a:cubicBezTo>
                    <a:pt x="1100" y="365"/>
                    <a:pt x="1106" y="343"/>
                    <a:pt x="1122" y="331"/>
                  </a:cubicBezTo>
                  <a:lnTo>
                    <a:pt x="1160" y="302"/>
                  </a:lnTo>
                  <a:cubicBezTo>
                    <a:pt x="1176" y="289"/>
                    <a:pt x="1199" y="291"/>
                    <a:pt x="1212" y="305"/>
                  </a:cubicBezTo>
                  <a:cubicBezTo>
                    <a:pt x="1224" y="320"/>
                    <a:pt x="1223" y="342"/>
                    <a:pt x="1208" y="357"/>
                  </a:cubicBezTo>
                  <a:lnTo>
                    <a:pt x="1135" y="430"/>
                  </a:lnTo>
                  <a:cubicBezTo>
                    <a:pt x="1120" y="444"/>
                    <a:pt x="1098" y="447"/>
                    <a:pt x="1083" y="436"/>
                  </a:cubicBezTo>
                  <a:cubicBezTo>
                    <a:pt x="1069" y="424"/>
                    <a:pt x="1066" y="403"/>
                    <a:pt x="1076" y="386"/>
                  </a:cubicBezTo>
                  <a:lnTo>
                    <a:pt x="1103" y="344"/>
                  </a:lnTo>
                  <a:cubicBezTo>
                    <a:pt x="1114" y="327"/>
                    <a:pt x="1136" y="320"/>
                    <a:pt x="1153" y="327"/>
                  </a:cubicBezTo>
                  <a:cubicBezTo>
                    <a:pt x="1170" y="334"/>
                    <a:pt x="1178" y="354"/>
                    <a:pt x="1172" y="373"/>
                  </a:cubicBezTo>
                  <a:lnTo>
                    <a:pt x="1135" y="474"/>
                  </a:lnTo>
                  <a:cubicBezTo>
                    <a:pt x="1127" y="493"/>
                    <a:pt x="1107" y="505"/>
                    <a:pt x="1087" y="501"/>
                  </a:cubicBezTo>
                  <a:cubicBezTo>
                    <a:pt x="1068" y="497"/>
                    <a:pt x="1056" y="478"/>
                    <a:pt x="1061" y="458"/>
                  </a:cubicBezTo>
                  <a:lnTo>
                    <a:pt x="1069" y="424"/>
                  </a:lnTo>
                  <a:cubicBezTo>
                    <a:pt x="1074" y="404"/>
                    <a:pt x="1092" y="390"/>
                    <a:pt x="1112" y="391"/>
                  </a:cubicBezTo>
                  <a:cubicBezTo>
                    <a:pt x="1132" y="393"/>
                    <a:pt x="1146" y="409"/>
                    <a:pt x="1145" y="428"/>
                  </a:cubicBezTo>
                  <a:lnTo>
                    <a:pt x="1138" y="542"/>
                  </a:lnTo>
                  <a:lnTo>
                    <a:pt x="1138" y="536"/>
                  </a:lnTo>
                  <a:lnTo>
                    <a:pt x="1153" y="685"/>
                  </a:lnTo>
                  <a:lnTo>
                    <a:pt x="1175" y="846"/>
                  </a:lnTo>
                  <a:lnTo>
                    <a:pt x="1197" y="1027"/>
                  </a:lnTo>
                  <a:lnTo>
                    <a:pt x="1211" y="1205"/>
                  </a:lnTo>
                  <a:lnTo>
                    <a:pt x="1206" y="1363"/>
                  </a:lnTo>
                  <a:lnTo>
                    <a:pt x="1204" y="1382"/>
                  </a:lnTo>
                  <a:cubicBezTo>
                    <a:pt x="1203" y="1386"/>
                    <a:pt x="1202" y="1389"/>
                    <a:pt x="1201" y="1393"/>
                  </a:cubicBezTo>
                  <a:lnTo>
                    <a:pt x="1195" y="1407"/>
                  </a:lnTo>
                  <a:lnTo>
                    <a:pt x="1155" y="1538"/>
                  </a:lnTo>
                  <a:cubicBezTo>
                    <a:pt x="1155" y="1541"/>
                    <a:pt x="1154" y="1543"/>
                    <a:pt x="1153" y="1545"/>
                  </a:cubicBezTo>
                  <a:lnTo>
                    <a:pt x="1137" y="1577"/>
                  </a:lnTo>
                  <a:lnTo>
                    <a:pt x="981" y="1812"/>
                  </a:lnTo>
                  <a:lnTo>
                    <a:pt x="972" y="1825"/>
                  </a:lnTo>
                  <a:cubicBezTo>
                    <a:pt x="970" y="1827"/>
                    <a:pt x="968" y="1830"/>
                    <a:pt x="966" y="1832"/>
                  </a:cubicBezTo>
                  <a:lnTo>
                    <a:pt x="957" y="1840"/>
                  </a:lnTo>
                  <a:lnTo>
                    <a:pt x="726" y="2058"/>
                  </a:lnTo>
                  <a:lnTo>
                    <a:pt x="458" y="2255"/>
                  </a:lnTo>
                  <a:lnTo>
                    <a:pt x="174" y="2438"/>
                  </a:lnTo>
                  <a:cubicBezTo>
                    <a:pt x="165" y="2444"/>
                    <a:pt x="155" y="2446"/>
                    <a:pt x="145" y="2444"/>
                  </a:cubicBezTo>
                  <a:cubicBezTo>
                    <a:pt x="135" y="2442"/>
                    <a:pt x="127" y="2436"/>
                    <a:pt x="122" y="2428"/>
                  </a:cubicBezTo>
                  <a:lnTo>
                    <a:pt x="11" y="2241"/>
                  </a:lnTo>
                  <a:close/>
                  <a:moveTo>
                    <a:pt x="189" y="2385"/>
                  </a:moveTo>
                  <a:lnTo>
                    <a:pt x="137" y="2375"/>
                  </a:lnTo>
                  <a:lnTo>
                    <a:pt x="415" y="2196"/>
                  </a:lnTo>
                  <a:lnTo>
                    <a:pt x="675" y="2005"/>
                  </a:lnTo>
                  <a:lnTo>
                    <a:pt x="908" y="1785"/>
                  </a:lnTo>
                  <a:lnTo>
                    <a:pt x="917" y="1777"/>
                  </a:lnTo>
                  <a:lnTo>
                    <a:pt x="911" y="1784"/>
                  </a:lnTo>
                  <a:lnTo>
                    <a:pt x="918" y="1775"/>
                  </a:lnTo>
                  <a:lnTo>
                    <a:pt x="1068" y="1548"/>
                  </a:lnTo>
                  <a:lnTo>
                    <a:pt x="1084" y="1516"/>
                  </a:lnTo>
                  <a:lnTo>
                    <a:pt x="1082" y="1523"/>
                  </a:lnTo>
                  <a:lnTo>
                    <a:pt x="1124" y="1382"/>
                  </a:lnTo>
                  <a:lnTo>
                    <a:pt x="1130" y="1368"/>
                  </a:lnTo>
                  <a:lnTo>
                    <a:pt x="1127" y="1379"/>
                  </a:lnTo>
                  <a:lnTo>
                    <a:pt x="1129" y="1368"/>
                  </a:lnTo>
                  <a:lnTo>
                    <a:pt x="1134" y="1218"/>
                  </a:lnTo>
                  <a:lnTo>
                    <a:pt x="1120" y="1042"/>
                  </a:lnTo>
                  <a:lnTo>
                    <a:pt x="1098" y="863"/>
                  </a:lnTo>
                  <a:lnTo>
                    <a:pt x="1076" y="700"/>
                  </a:lnTo>
                  <a:lnTo>
                    <a:pt x="1061" y="551"/>
                  </a:lnTo>
                  <a:cubicBezTo>
                    <a:pt x="1061" y="549"/>
                    <a:pt x="1061" y="547"/>
                    <a:pt x="1061" y="545"/>
                  </a:cubicBezTo>
                  <a:lnTo>
                    <a:pt x="1068" y="431"/>
                  </a:lnTo>
                  <a:lnTo>
                    <a:pt x="1144" y="435"/>
                  </a:lnTo>
                  <a:lnTo>
                    <a:pt x="1136" y="469"/>
                  </a:lnTo>
                  <a:lnTo>
                    <a:pt x="1062" y="453"/>
                  </a:lnTo>
                  <a:lnTo>
                    <a:pt x="1099" y="352"/>
                  </a:lnTo>
                  <a:lnTo>
                    <a:pt x="1167" y="381"/>
                  </a:lnTo>
                  <a:lnTo>
                    <a:pt x="1140" y="423"/>
                  </a:lnTo>
                  <a:lnTo>
                    <a:pt x="1082" y="379"/>
                  </a:lnTo>
                  <a:lnTo>
                    <a:pt x="1155" y="306"/>
                  </a:lnTo>
                  <a:lnTo>
                    <a:pt x="1203" y="361"/>
                  </a:lnTo>
                  <a:lnTo>
                    <a:pt x="1165" y="390"/>
                  </a:lnTo>
                  <a:lnTo>
                    <a:pt x="1130" y="326"/>
                  </a:lnTo>
                  <a:lnTo>
                    <a:pt x="1232" y="281"/>
                  </a:lnTo>
                  <a:lnTo>
                    <a:pt x="1249" y="353"/>
                  </a:lnTo>
                  <a:lnTo>
                    <a:pt x="1228" y="357"/>
                  </a:lnTo>
                  <a:cubicBezTo>
                    <a:pt x="1208" y="361"/>
                    <a:pt x="1189" y="348"/>
                    <a:pt x="1186" y="328"/>
                  </a:cubicBezTo>
                  <a:cubicBezTo>
                    <a:pt x="1183" y="308"/>
                    <a:pt x="1198" y="288"/>
                    <a:pt x="1218" y="282"/>
                  </a:cubicBezTo>
                  <a:lnTo>
                    <a:pt x="1339" y="252"/>
                  </a:lnTo>
                  <a:cubicBezTo>
                    <a:pt x="1360" y="247"/>
                    <a:pt x="1379" y="259"/>
                    <a:pt x="1383" y="279"/>
                  </a:cubicBezTo>
                  <a:cubicBezTo>
                    <a:pt x="1387" y="299"/>
                    <a:pt x="1374" y="319"/>
                    <a:pt x="1354" y="326"/>
                  </a:cubicBezTo>
                  <a:lnTo>
                    <a:pt x="1338" y="331"/>
                  </a:lnTo>
                  <a:lnTo>
                    <a:pt x="1329" y="256"/>
                  </a:lnTo>
                  <a:lnTo>
                    <a:pt x="1463" y="244"/>
                  </a:lnTo>
                  <a:lnTo>
                    <a:pt x="1704" y="239"/>
                  </a:lnTo>
                  <a:lnTo>
                    <a:pt x="1803" y="236"/>
                  </a:lnTo>
                  <a:lnTo>
                    <a:pt x="1875" y="233"/>
                  </a:lnTo>
                  <a:lnTo>
                    <a:pt x="1946" y="225"/>
                  </a:lnTo>
                  <a:lnTo>
                    <a:pt x="1924" y="295"/>
                  </a:lnTo>
                  <a:lnTo>
                    <a:pt x="1805" y="215"/>
                  </a:lnTo>
                  <a:lnTo>
                    <a:pt x="1867" y="175"/>
                  </a:lnTo>
                  <a:lnTo>
                    <a:pt x="1868" y="183"/>
                  </a:lnTo>
                  <a:lnTo>
                    <a:pt x="1797" y="173"/>
                  </a:lnTo>
                  <a:lnTo>
                    <a:pt x="1884" y="33"/>
                  </a:lnTo>
                  <a:lnTo>
                    <a:pt x="1925" y="87"/>
                  </a:lnTo>
                  <a:lnTo>
                    <a:pt x="1887" y="98"/>
                  </a:lnTo>
                  <a:lnTo>
                    <a:pt x="1820" y="121"/>
                  </a:lnTo>
                  <a:lnTo>
                    <a:pt x="1847" y="72"/>
                  </a:lnTo>
                  <a:lnTo>
                    <a:pt x="1911" y="282"/>
                  </a:lnTo>
                  <a:lnTo>
                    <a:pt x="1864" y="260"/>
                  </a:lnTo>
                  <a:lnTo>
                    <a:pt x="1919" y="240"/>
                  </a:lnTo>
                  <a:lnTo>
                    <a:pt x="1957" y="229"/>
                  </a:lnTo>
                  <a:lnTo>
                    <a:pt x="1950" y="232"/>
                  </a:lnTo>
                  <a:lnTo>
                    <a:pt x="1992" y="211"/>
                  </a:lnTo>
                  <a:lnTo>
                    <a:pt x="1978" y="221"/>
                  </a:lnTo>
                  <a:lnTo>
                    <a:pt x="2008" y="187"/>
                  </a:lnTo>
                  <a:lnTo>
                    <a:pt x="2001" y="199"/>
                  </a:lnTo>
                  <a:lnTo>
                    <a:pt x="2017" y="159"/>
                  </a:lnTo>
                  <a:lnTo>
                    <a:pt x="2014" y="175"/>
                  </a:lnTo>
                  <a:lnTo>
                    <a:pt x="2013" y="130"/>
                  </a:lnTo>
                  <a:lnTo>
                    <a:pt x="2014" y="138"/>
                  </a:lnTo>
                  <a:lnTo>
                    <a:pt x="2012" y="130"/>
                  </a:lnTo>
                  <a:lnTo>
                    <a:pt x="2014" y="135"/>
                  </a:lnTo>
                  <a:lnTo>
                    <a:pt x="1999" y="100"/>
                  </a:lnTo>
                  <a:lnTo>
                    <a:pt x="2006" y="111"/>
                  </a:lnTo>
                  <a:lnTo>
                    <a:pt x="1979" y="85"/>
                  </a:lnTo>
                  <a:lnTo>
                    <a:pt x="1990" y="92"/>
                  </a:lnTo>
                  <a:lnTo>
                    <a:pt x="1954" y="77"/>
                  </a:lnTo>
                  <a:lnTo>
                    <a:pt x="1965" y="80"/>
                  </a:lnTo>
                  <a:lnTo>
                    <a:pt x="1924" y="77"/>
                  </a:lnTo>
                  <a:lnTo>
                    <a:pt x="1934" y="76"/>
                  </a:lnTo>
                  <a:lnTo>
                    <a:pt x="1878" y="86"/>
                  </a:lnTo>
                  <a:lnTo>
                    <a:pt x="1811" y="89"/>
                  </a:lnTo>
                  <a:lnTo>
                    <a:pt x="1711" y="92"/>
                  </a:lnTo>
                  <a:lnTo>
                    <a:pt x="1454" y="96"/>
                  </a:lnTo>
                  <a:lnTo>
                    <a:pt x="1324" y="108"/>
                  </a:lnTo>
                  <a:lnTo>
                    <a:pt x="1316" y="109"/>
                  </a:lnTo>
                  <a:lnTo>
                    <a:pt x="1329" y="105"/>
                  </a:lnTo>
                  <a:lnTo>
                    <a:pt x="1321" y="109"/>
                  </a:lnTo>
                  <a:cubicBezTo>
                    <a:pt x="1319" y="111"/>
                    <a:pt x="1316" y="112"/>
                    <a:pt x="1313" y="112"/>
                  </a:cubicBezTo>
                  <a:lnTo>
                    <a:pt x="1191" y="143"/>
                  </a:lnTo>
                  <a:lnTo>
                    <a:pt x="1171" y="147"/>
                  </a:lnTo>
                  <a:lnTo>
                    <a:pt x="1179" y="144"/>
                  </a:lnTo>
                  <a:lnTo>
                    <a:pt x="1077" y="189"/>
                  </a:lnTo>
                  <a:lnTo>
                    <a:pt x="1083" y="186"/>
                  </a:lnTo>
                  <a:lnTo>
                    <a:pt x="1062" y="199"/>
                  </a:lnTo>
                  <a:lnTo>
                    <a:pt x="1070" y="193"/>
                  </a:lnTo>
                  <a:lnTo>
                    <a:pt x="1053" y="210"/>
                  </a:lnTo>
                  <a:lnTo>
                    <a:pt x="981" y="281"/>
                  </a:lnTo>
                  <a:lnTo>
                    <a:pt x="964" y="300"/>
                  </a:lnTo>
                  <a:lnTo>
                    <a:pt x="971" y="290"/>
                  </a:lnTo>
                  <a:lnTo>
                    <a:pt x="960" y="312"/>
                  </a:lnTo>
                  <a:lnTo>
                    <a:pt x="922" y="413"/>
                  </a:lnTo>
                  <a:lnTo>
                    <a:pt x="924" y="407"/>
                  </a:lnTo>
                  <a:lnTo>
                    <a:pt x="922" y="419"/>
                  </a:lnTo>
                  <a:lnTo>
                    <a:pt x="920" y="432"/>
                  </a:lnTo>
                  <a:lnTo>
                    <a:pt x="915" y="577"/>
                  </a:lnTo>
                  <a:lnTo>
                    <a:pt x="927" y="727"/>
                  </a:lnTo>
                  <a:lnTo>
                    <a:pt x="950" y="897"/>
                  </a:lnTo>
                  <a:lnTo>
                    <a:pt x="971" y="1062"/>
                  </a:lnTo>
                  <a:lnTo>
                    <a:pt x="980" y="1219"/>
                  </a:lnTo>
                  <a:lnTo>
                    <a:pt x="975" y="1373"/>
                  </a:lnTo>
                  <a:lnTo>
                    <a:pt x="899" y="1369"/>
                  </a:lnTo>
                  <a:lnTo>
                    <a:pt x="907" y="1339"/>
                  </a:lnTo>
                  <a:lnTo>
                    <a:pt x="981" y="1353"/>
                  </a:lnTo>
                  <a:lnTo>
                    <a:pt x="940" y="1489"/>
                  </a:lnTo>
                  <a:lnTo>
                    <a:pt x="869" y="1468"/>
                  </a:lnTo>
                  <a:lnTo>
                    <a:pt x="884" y="1436"/>
                  </a:lnTo>
                  <a:lnTo>
                    <a:pt x="950" y="1468"/>
                  </a:lnTo>
                  <a:lnTo>
                    <a:pt x="797" y="1699"/>
                  </a:lnTo>
                  <a:lnTo>
                    <a:pt x="734" y="1661"/>
                  </a:lnTo>
                  <a:lnTo>
                    <a:pt x="749" y="1639"/>
                  </a:lnTo>
                  <a:lnTo>
                    <a:pt x="806" y="1684"/>
                  </a:lnTo>
                  <a:lnTo>
                    <a:pt x="604" y="1881"/>
                  </a:lnTo>
                  <a:cubicBezTo>
                    <a:pt x="603" y="1883"/>
                    <a:pt x="601" y="1884"/>
                    <a:pt x="599" y="1886"/>
                  </a:cubicBezTo>
                  <a:lnTo>
                    <a:pt x="344" y="2071"/>
                  </a:lnTo>
                  <a:lnTo>
                    <a:pt x="63" y="2251"/>
                  </a:lnTo>
                  <a:lnTo>
                    <a:pt x="78" y="2198"/>
                  </a:lnTo>
                  <a:lnTo>
                    <a:pt x="189" y="2385"/>
                  </a:lnTo>
                  <a:close/>
                </a:path>
              </a:pathLst>
            </a:custGeom>
            <a:solidFill>
              <a:srgbClr val="C3D69B"/>
            </a:solidFill>
            <a:ln w="0" cap="flat">
              <a:solidFill>
                <a:srgbClr val="C3D69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" name="Freeform 205">
              <a:extLst>
                <a:ext uri="{FF2B5EF4-FFF2-40B4-BE49-F238E27FC236}">
                  <a16:creationId xmlns:a16="http://schemas.microsoft.com/office/drawing/2014/main" id="{54388B7A-0D97-43F2-801D-11E09EE550C4}"/>
                </a:ext>
              </a:extLst>
            </p:cNvPr>
            <p:cNvSpPr>
              <a:spLocks/>
            </p:cNvSpPr>
            <p:nvPr/>
          </p:nvSpPr>
          <p:spPr bwMode="auto">
            <a:xfrm>
              <a:off x="495" y="2178"/>
              <a:ext cx="92" cy="101"/>
            </a:xfrm>
            <a:custGeom>
              <a:avLst/>
              <a:gdLst>
                <a:gd name="T0" fmla="*/ 2052 w 2360"/>
                <a:gd name="T1" fmla="*/ 396 h 2596"/>
                <a:gd name="T2" fmla="*/ 1530 w 2360"/>
                <a:gd name="T3" fmla="*/ 836 h 2596"/>
                <a:gd name="T4" fmla="*/ 1352 w 2360"/>
                <a:gd name="T5" fmla="*/ 1075 h 2596"/>
                <a:gd name="T6" fmla="*/ 1310 w 2360"/>
                <a:gd name="T7" fmla="*/ 1185 h 2596"/>
                <a:gd name="T8" fmla="*/ 1286 w 2360"/>
                <a:gd name="T9" fmla="*/ 1315 h 2596"/>
                <a:gd name="T10" fmla="*/ 1272 w 2360"/>
                <a:gd name="T11" fmla="*/ 1620 h 2596"/>
                <a:gd name="T12" fmla="*/ 1264 w 2360"/>
                <a:gd name="T13" fmla="*/ 1925 h 2596"/>
                <a:gd name="T14" fmla="*/ 1236 w 2360"/>
                <a:gd name="T15" fmla="*/ 2068 h 2596"/>
                <a:gd name="T16" fmla="*/ 1175 w 2360"/>
                <a:gd name="T17" fmla="*/ 2203 h 2596"/>
                <a:gd name="T18" fmla="*/ 1059 w 2360"/>
                <a:gd name="T19" fmla="*/ 2319 h 2596"/>
                <a:gd name="T20" fmla="*/ 927 w 2360"/>
                <a:gd name="T21" fmla="*/ 2400 h 2596"/>
                <a:gd name="T22" fmla="*/ 780 w 2360"/>
                <a:gd name="T23" fmla="*/ 2454 h 2596"/>
                <a:gd name="T24" fmla="*/ 370 w 2360"/>
                <a:gd name="T25" fmla="*/ 2537 h 2596"/>
                <a:gd name="T26" fmla="*/ 201 w 2360"/>
                <a:gd name="T27" fmla="*/ 2565 h 2596"/>
                <a:gd name="T28" fmla="*/ 13 w 2360"/>
                <a:gd name="T29" fmla="*/ 2505 h 2596"/>
                <a:gd name="T30" fmla="*/ 85 w 2360"/>
                <a:gd name="T31" fmla="*/ 2361 h 2596"/>
                <a:gd name="T32" fmla="*/ 198 w 2360"/>
                <a:gd name="T33" fmla="*/ 2314 h 2596"/>
                <a:gd name="T34" fmla="*/ 205 w 2360"/>
                <a:gd name="T35" fmla="*/ 2547 h 2596"/>
                <a:gd name="T36" fmla="*/ 236 w 2360"/>
                <a:gd name="T37" fmla="*/ 2430 h 2596"/>
                <a:gd name="T38" fmla="*/ 107 w 2360"/>
                <a:gd name="T39" fmla="*/ 2363 h 2596"/>
                <a:gd name="T40" fmla="*/ 255 w 2360"/>
                <a:gd name="T41" fmla="*/ 2328 h 2596"/>
                <a:gd name="T42" fmla="*/ 596 w 2360"/>
                <a:gd name="T43" fmla="*/ 2274 h 2596"/>
                <a:gd name="T44" fmla="*/ 846 w 2360"/>
                <a:gd name="T45" fmla="*/ 2196 h 2596"/>
                <a:gd name="T46" fmla="*/ 938 w 2360"/>
                <a:gd name="T47" fmla="*/ 2142 h 2596"/>
                <a:gd name="T48" fmla="*/ 995 w 2360"/>
                <a:gd name="T49" fmla="*/ 2083 h 2596"/>
                <a:gd name="T50" fmla="*/ 1020 w 2360"/>
                <a:gd name="T51" fmla="*/ 2015 h 2596"/>
                <a:gd name="T52" fmla="*/ 1038 w 2360"/>
                <a:gd name="T53" fmla="*/ 1918 h 2596"/>
                <a:gd name="T54" fmla="*/ 1042 w 2360"/>
                <a:gd name="T55" fmla="*/ 1793 h 2596"/>
                <a:gd name="T56" fmla="*/ 1057 w 2360"/>
                <a:gd name="T57" fmla="*/ 1309 h 2596"/>
                <a:gd name="T58" fmla="*/ 1094 w 2360"/>
                <a:gd name="T59" fmla="*/ 1137 h 2596"/>
                <a:gd name="T60" fmla="*/ 1159 w 2360"/>
                <a:gd name="T61" fmla="*/ 975 h 2596"/>
                <a:gd name="T62" fmla="*/ 1366 w 2360"/>
                <a:gd name="T63" fmla="*/ 697 h 2596"/>
                <a:gd name="T64" fmla="*/ 1639 w 2360"/>
                <a:gd name="T65" fmla="*/ 442 h 2596"/>
                <a:gd name="T66" fmla="*/ 2244 w 2360"/>
                <a:gd name="T67" fmla="*/ 0 h 25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2360" h="2596">
                  <a:moveTo>
                    <a:pt x="2360" y="182"/>
                  </a:moveTo>
                  <a:lnTo>
                    <a:pt x="2052" y="396"/>
                  </a:lnTo>
                  <a:lnTo>
                    <a:pt x="1766" y="614"/>
                  </a:lnTo>
                  <a:lnTo>
                    <a:pt x="1530" y="836"/>
                  </a:lnTo>
                  <a:lnTo>
                    <a:pt x="1544" y="824"/>
                  </a:lnTo>
                  <a:lnTo>
                    <a:pt x="1352" y="1075"/>
                  </a:lnTo>
                  <a:lnTo>
                    <a:pt x="1368" y="1047"/>
                  </a:lnTo>
                  <a:lnTo>
                    <a:pt x="1310" y="1185"/>
                  </a:lnTo>
                  <a:lnTo>
                    <a:pt x="1318" y="1160"/>
                  </a:lnTo>
                  <a:lnTo>
                    <a:pt x="1286" y="1315"/>
                  </a:lnTo>
                  <a:lnTo>
                    <a:pt x="1287" y="1300"/>
                  </a:lnTo>
                  <a:lnTo>
                    <a:pt x="1272" y="1620"/>
                  </a:lnTo>
                  <a:lnTo>
                    <a:pt x="1271" y="1770"/>
                  </a:lnTo>
                  <a:lnTo>
                    <a:pt x="1264" y="1925"/>
                  </a:lnTo>
                  <a:cubicBezTo>
                    <a:pt x="1263" y="1930"/>
                    <a:pt x="1263" y="1935"/>
                    <a:pt x="1262" y="1940"/>
                  </a:cubicBezTo>
                  <a:lnTo>
                    <a:pt x="1236" y="2068"/>
                  </a:lnTo>
                  <a:cubicBezTo>
                    <a:pt x="1235" y="2078"/>
                    <a:pt x="1231" y="2090"/>
                    <a:pt x="1227" y="2098"/>
                  </a:cubicBezTo>
                  <a:lnTo>
                    <a:pt x="1175" y="2203"/>
                  </a:lnTo>
                  <a:cubicBezTo>
                    <a:pt x="1167" y="2215"/>
                    <a:pt x="1158" y="2227"/>
                    <a:pt x="1144" y="2240"/>
                  </a:cubicBezTo>
                  <a:lnTo>
                    <a:pt x="1059" y="2319"/>
                  </a:lnTo>
                  <a:cubicBezTo>
                    <a:pt x="1056" y="2326"/>
                    <a:pt x="1045" y="2331"/>
                    <a:pt x="1037" y="2339"/>
                  </a:cubicBezTo>
                  <a:lnTo>
                    <a:pt x="927" y="2400"/>
                  </a:lnTo>
                  <a:cubicBezTo>
                    <a:pt x="919" y="2403"/>
                    <a:pt x="914" y="2407"/>
                    <a:pt x="909" y="2407"/>
                  </a:cubicBezTo>
                  <a:lnTo>
                    <a:pt x="780" y="2454"/>
                  </a:lnTo>
                  <a:lnTo>
                    <a:pt x="637" y="2495"/>
                  </a:lnTo>
                  <a:lnTo>
                    <a:pt x="370" y="2537"/>
                  </a:lnTo>
                  <a:lnTo>
                    <a:pt x="270" y="2553"/>
                  </a:lnTo>
                  <a:lnTo>
                    <a:pt x="201" y="2565"/>
                  </a:lnTo>
                  <a:lnTo>
                    <a:pt x="144" y="2579"/>
                  </a:lnTo>
                  <a:cubicBezTo>
                    <a:pt x="84" y="2596"/>
                    <a:pt x="25" y="2563"/>
                    <a:pt x="13" y="2505"/>
                  </a:cubicBezTo>
                  <a:lnTo>
                    <a:pt x="12" y="2498"/>
                  </a:lnTo>
                  <a:cubicBezTo>
                    <a:pt x="0" y="2445"/>
                    <a:pt x="29" y="2388"/>
                    <a:pt x="85" y="2361"/>
                  </a:cubicBezTo>
                  <a:lnTo>
                    <a:pt x="127" y="2341"/>
                  </a:lnTo>
                  <a:lnTo>
                    <a:pt x="198" y="2314"/>
                  </a:lnTo>
                  <a:lnTo>
                    <a:pt x="266" y="2521"/>
                  </a:lnTo>
                  <a:lnTo>
                    <a:pt x="205" y="2547"/>
                  </a:lnTo>
                  <a:lnTo>
                    <a:pt x="163" y="2567"/>
                  </a:lnTo>
                  <a:lnTo>
                    <a:pt x="236" y="2430"/>
                  </a:lnTo>
                  <a:lnTo>
                    <a:pt x="238" y="2438"/>
                  </a:lnTo>
                  <a:lnTo>
                    <a:pt x="107" y="2363"/>
                  </a:lnTo>
                  <a:lnTo>
                    <a:pt x="180" y="2344"/>
                  </a:lnTo>
                  <a:lnTo>
                    <a:pt x="255" y="2328"/>
                  </a:lnTo>
                  <a:lnTo>
                    <a:pt x="355" y="2311"/>
                  </a:lnTo>
                  <a:lnTo>
                    <a:pt x="596" y="2274"/>
                  </a:lnTo>
                  <a:lnTo>
                    <a:pt x="718" y="2243"/>
                  </a:lnTo>
                  <a:lnTo>
                    <a:pt x="846" y="2196"/>
                  </a:lnTo>
                  <a:lnTo>
                    <a:pt x="828" y="2204"/>
                  </a:lnTo>
                  <a:lnTo>
                    <a:pt x="938" y="2142"/>
                  </a:lnTo>
                  <a:lnTo>
                    <a:pt x="910" y="2162"/>
                  </a:lnTo>
                  <a:lnTo>
                    <a:pt x="995" y="2083"/>
                  </a:lnTo>
                  <a:lnTo>
                    <a:pt x="968" y="2120"/>
                  </a:lnTo>
                  <a:lnTo>
                    <a:pt x="1020" y="2015"/>
                  </a:lnTo>
                  <a:lnTo>
                    <a:pt x="1011" y="2045"/>
                  </a:lnTo>
                  <a:lnTo>
                    <a:pt x="1038" y="1918"/>
                  </a:lnTo>
                  <a:lnTo>
                    <a:pt x="1036" y="1933"/>
                  </a:lnTo>
                  <a:lnTo>
                    <a:pt x="1042" y="1793"/>
                  </a:lnTo>
                  <a:lnTo>
                    <a:pt x="1042" y="1630"/>
                  </a:lnTo>
                  <a:lnTo>
                    <a:pt x="1057" y="1309"/>
                  </a:lnTo>
                  <a:cubicBezTo>
                    <a:pt x="1060" y="1302"/>
                    <a:pt x="1061" y="1297"/>
                    <a:pt x="1061" y="1292"/>
                  </a:cubicBezTo>
                  <a:lnTo>
                    <a:pt x="1094" y="1137"/>
                  </a:lnTo>
                  <a:cubicBezTo>
                    <a:pt x="1095" y="1127"/>
                    <a:pt x="1098" y="1120"/>
                    <a:pt x="1101" y="1112"/>
                  </a:cubicBezTo>
                  <a:lnTo>
                    <a:pt x="1159" y="975"/>
                  </a:lnTo>
                  <a:cubicBezTo>
                    <a:pt x="1163" y="968"/>
                    <a:pt x="1169" y="958"/>
                    <a:pt x="1175" y="948"/>
                  </a:cubicBezTo>
                  <a:lnTo>
                    <a:pt x="1366" y="697"/>
                  </a:lnTo>
                  <a:cubicBezTo>
                    <a:pt x="1372" y="692"/>
                    <a:pt x="1375" y="689"/>
                    <a:pt x="1378" y="682"/>
                  </a:cubicBezTo>
                  <a:lnTo>
                    <a:pt x="1639" y="442"/>
                  </a:lnTo>
                  <a:lnTo>
                    <a:pt x="1936" y="215"/>
                  </a:lnTo>
                  <a:lnTo>
                    <a:pt x="2244" y="0"/>
                  </a:lnTo>
                  <a:lnTo>
                    <a:pt x="2360" y="182"/>
                  </a:lnTo>
                  <a:close/>
                </a:path>
              </a:pathLst>
            </a:custGeom>
            <a:solidFill>
              <a:srgbClr val="8EB4E3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" name="Freeform 206">
              <a:extLst>
                <a:ext uri="{FF2B5EF4-FFF2-40B4-BE49-F238E27FC236}">
                  <a16:creationId xmlns:a16="http://schemas.microsoft.com/office/drawing/2014/main" id="{FC43FE5C-A682-492E-A67A-28E1489D9D8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94" y="2176"/>
              <a:ext cx="95" cy="104"/>
            </a:xfrm>
            <a:custGeom>
              <a:avLst/>
              <a:gdLst>
                <a:gd name="T0" fmla="*/ 1584 w 2432"/>
                <a:gd name="T1" fmla="*/ 902 h 2661"/>
                <a:gd name="T2" fmla="*/ 1410 w 2432"/>
                <a:gd name="T3" fmla="*/ 1136 h 2661"/>
                <a:gd name="T4" fmla="*/ 1432 w 2432"/>
                <a:gd name="T5" fmla="*/ 1098 h 2661"/>
                <a:gd name="T6" fmla="*/ 1356 w 2432"/>
                <a:gd name="T7" fmla="*/ 1162 h 2661"/>
                <a:gd name="T8" fmla="*/ 1277 w 2432"/>
                <a:gd name="T9" fmla="*/ 1340 h 2661"/>
                <a:gd name="T10" fmla="*/ 1331 w 2432"/>
                <a:gd name="T11" fmla="*/ 1963 h 2661"/>
                <a:gd name="T12" fmla="*/ 1238 w 2432"/>
                <a:gd name="T13" fmla="*/ 2257 h 2661"/>
                <a:gd name="T14" fmla="*/ 1113 w 2432"/>
                <a:gd name="T15" fmla="*/ 2385 h 2661"/>
                <a:gd name="T16" fmla="*/ 972 w 2432"/>
                <a:gd name="T17" fmla="*/ 2472 h 2661"/>
                <a:gd name="T18" fmla="*/ 401 w 2432"/>
                <a:gd name="T19" fmla="*/ 2614 h 2661"/>
                <a:gd name="T20" fmla="*/ 129 w 2432"/>
                <a:gd name="T21" fmla="*/ 2660 h 2661"/>
                <a:gd name="T22" fmla="*/ 23 w 2432"/>
                <a:gd name="T23" fmla="*/ 2600 h 2661"/>
                <a:gd name="T24" fmla="*/ 2 w 2432"/>
                <a:gd name="T25" fmla="*/ 2488 h 2661"/>
                <a:gd name="T26" fmla="*/ 94 w 2432"/>
                <a:gd name="T27" fmla="*/ 2370 h 2661"/>
                <a:gd name="T28" fmla="*/ 331 w 2432"/>
                <a:gd name="T29" fmla="*/ 2546 h 2661"/>
                <a:gd name="T30" fmla="*/ 158 w 2432"/>
                <a:gd name="T31" fmla="*/ 2591 h 2661"/>
                <a:gd name="T32" fmla="*/ 289 w 2432"/>
                <a:gd name="T33" fmla="*/ 2507 h 2661"/>
                <a:gd name="T34" fmla="*/ 202 w 2432"/>
                <a:gd name="T35" fmla="*/ 2347 h 2661"/>
                <a:gd name="T36" fmla="*/ 864 w 2432"/>
                <a:gd name="T37" fmla="*/ 2200 h 2661"/>
                <a:gd name="T38" fmla="*/ 840 w 2432"/>
                <a:gd name="T39" fmla="*/ 2211 h 2661"/>
                <a:gd name="T40" fmla="*/ 907 w 2432"/>
                <a:gd name="T41" fmla="*/ 2227 h 2661"/>
                <a:gd name="T42" fmla="*/ 1027 w 2432"/>
                <a:gd name="T43" fmla="*/ 2180 h 2661"/>
                <a:gd name="T44" fmla="*/ 1085 w 2432"/>
                <a:gd name="T45" fmla="*/ 2062 h 2661"/>
                <a:gd name="T46" fmla="*/ 1073 w 2432"/>
                <a:gd name="T47" fmla="*/ 1919 h 2661"/>
                <a:gd name="T48" fmla="*/ 1032 w 2432"/>
                <a:gd name="T49" fmla="*/ 1834 h 2661"/>
                <a:gd name="T50" fmla="*/ 1085 w 2432"/>
                <a:gd name="T51" fmla="*/ 1172 h 2661"/>
                <a:gd name="T52" fmla="*/ 1364 w 2432"/>
                <a:gd name="T53" fmla="*/ 715 h 2661"/>
                <a:gd name="T54" fmla="*/ 2252 w 2432"/>
                <a:gd name="T55" fmla="*/ 9 h 2661"/>
                <a:gd name="T56" fmla="*/ 2293 w 2432"/>
                <a:gd name="T57" fmla="*/ 70 h 2661"/>
                <a:gd name="T58" fmla="*/ 1425 w 2432"/>
                <a:gd name="T59" fmla="*/ 758 h 2661"/>
                <a:gd name="T60" fmla="*/ 1160 w 2432"/>
                <a:gd name="T61" fmla="*/ 1181 h 2661"/>
                <a:gd name="T62" fmla="*/ 1109 w 2432"/>
                <a:gd name="T63" fmla="*/ 1831 h 2661"/>
                <a:gd name="T64" fmla="*/ 1077 w 2432"/>
                <a:gd name="T65" fmla="*/ 2089 h 2661"/>
                <a:gd name="T66" fmla="*/ 966 w 2432"/>
                <a:gd name="T67" fmla="*/ 2139 h 2661"/>
                <a:gd name="T68" fmla="*/ 946 w 2432"/>
                <a:gd name="T69" fmla="*/ 2151 h 2661"/>
                <a:gd name="T70" fmla="*/ 885 w 2432"/>
                <a:gd name="T71" fmla="*/ 2271 h 2661"/>
                <a:gd name="T72" fmla="*/ 215 w 2432"/>
                <a:gd name="T73" fmla="*/ 2420 h 2661"/>
                <a:gd name="T74" fmla="*/ 227 w 2432"/>
                <a:gd name="T75" fmla="*/ 2482 h 2661"/>
                <a:gd name="T76" fmla="*/ 282 w 2432"/>
                <a:gd name="T77" fmla="*/ 2526 h 2661"/>
                <a:gd name="T78" fmla="*/ 128 w 2432"/>
                <a:gd name="T79" fmla="*/ 2435 h 2661"/>
                <a:gd name="T80" fmla="*/ 88 w 2432"/>
                <a:gd name="T81" fmla="*/ 2469 h 2661"/>
                <a:gd name="T82" fmla="*/ 77 w 2432"/>
                <a:gd name="T83" fmla="*/ 2527 h 2661"/>
                <a:gd name="T84" fmla="*/ 144 w 2432"/>
                <a:gd name="T85" fmla="*/ 2586 h 2661"/>
                <a:gd name="T86" fmla="*/ 296 w 2432"/>
                <a:gd name="T87" fmla="*/ 2555 h 2661"/>
                <a:gd name="T88" fmla="*/ 944 w 2432"/>
                <a:gd name="T89" fmla="*/ 2404 h 2661"/>
                <a:gd name="T90" fmla="*/ 1051 w 2432"/>
                <a:gd name="T91" fmla="*/ 2345 h 2661"/>
                <a:gd name="T92" fmla="*/ 1173 w 2432"/>
                <a:gd name="T93" fmla="*/ 2222 h 2661"/>
                <a:gd name="T94" fmla="*/ 1252 w 2432"/>
                <a:gd name="T95" fmla="*/ 1978 h 2661"/>
                <a:gd name="T96" fmla="*/ 1354 w 2432"/>
                <a:gd name="T97" fmla="*/ 1339 h 2661"/>
                <a:gd name="T98" fmla="*/ 1375 w 2432"/>
                <a:gd name="T99" fmla="*/ 1233 h 2661"/>
                <a:gd name="T100" fmla="*/ 1350 w 2432"/>
                <a:gd name="T101" fmla="*/ 1093 h 2661"/>
                <a:gd name="T102" fmla="*/ 1533 w 2432"/>
                <a:gd name="T103" fmla="*/ 849 h 2661"/>
                <a:gd name="T104" fmla="*/ 2239 w 2432"/>
                <a:gd name="T105" fmla="*/ 62 h 26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</a:cxnLst>
              <a:rect l="0" t="0" r="r" b="b"/>
              <a:pathLst>
                <a:path w="2432" h="2661">
                  <a:moveTo>
                    <a:pt x="2422" y="199"/>
                  </a:moveTo>
                  <a:cubicBezTo>
                    <a:pt x="2432" y="216"/>
                    <a:pt x="2427" y="240"/>
                    <a:pt x="2409" y="252"/>
                  </a:cubicBezTo>
                  <a:lnTo>
                    <a:pt x="2101" y="466"/>
                  </a:lnTo>
                  <a:lnTo>
                    <a:pt x="1816" y="683"/>
                  </a:lnTo>
                  <a:lnTo>
                    <a:pt x="1584" y="902"/>
                  </a:lnTo>
                  <a:lnTo>
                    <a:pt x="1535" y="848"/>
                  </a:lnTo>
                  <a:lnTo>
                    <a:pt x="1549" y="836"/>
                  </a:lnTo>
                  <a:cubicBezTo>
                    <a:pt x="1564" y="822"/>
                    <a:pt x="1586" y="822"/>
                    <a:pt x="1600" y="834"/>
                  </a:cubicBezTo>
                  <a:cubicBezTo>
                    <a:pt x="1614" y="847"/>
                    <a:pt x="1615" y="869"/>
                    <a:pt x="1602" y="885"/>
                  </a:cubicBezTo>
                  <a:lnTo>
                    <a:pt x="1410" y="1136"/>
                  </a:lnTo>
                  <a:cubicBezTo>
                    <a:pt x="1398" y="1152"/>
                    <a:pt x="1375" y="1158"/>
                    <a:pt x="1358" y="1148"/>
                  </a:cubicBezTo>
                  <a:cubicBezTo>
                    <a:pt x="1342" y="1138"/>
                    <a:pt x="1337" y="1116"/>
                    <a:pt x="1347" y="1098"/>
                  </a:cubicBezTo>
                  <a:lnTo>
                    <a:pt x="1363" y="1070"/>
                  </a:lnTo>
                  <a:cubicBezTo>
                    <a:pt x="1374" y="1052"/>
                    <a:pt x="1396" y="1044"/>
                    <a:pt x="1414" y="1051"/>
                  </a:cubicBezTo>
                  <a:cubicBezTo>
                    <a:pt x="1432" y="1059"/>
                    <a:pt x="1440" y="1079"/>
                    <a:pt x="1432" y="1098"/>
                  </a:cubicBezTo>
                  <a:lnTo>
                    <a:pt x="1374" y="1236"/>
                  </a:lnTo>
                  <a:cubicBezTo>
                    <a:pt x="1366" y="1256"/>
                    <a:pt x="1344" y="1267"/>
                    <a:pt x="1325" y="1261"/>
                  </a:cubicBezTo>
                  <a:cubicBezTo>
                    <a:pt x="1306" y="1256"/>
                    <a:pt x="1295" y="1236"/>
                    <a:pt x="1302" y="1216"/>
                  </a:cubicBezTo>
                  <a:lnTo>
                    <a:pt x="1310" y="1191"/>
                  </a:lnTo>
                  <a:cubicBezTo>
                    <a:pt x="1316" y="1171"/>
                    <a:pt x="1337" y="1158"/>
                    <a:pt x="1356" y="1162"/>
                  </a:cubicBezTo>
                  <a:cubicBezTo>
                    <a:pt x="1376" y="1165"/>
                    <a:pt x="1388" y="1184"/>
                    <a:pt x="1384" y="1204"/>
                  </a:cubicBezTo>
                  <a:lnTo>
                    <a:pt x="1352" y="1359"/>
                  </a:lnTo>
                  <a:cubicBezTo>
                    <a:pt x="1348" y="1379"/>
                    <a:pt x="1329" y="1394"/>
                    <a:pt x="1309" y="1393"/>
                  </a:cubicBezTo>
                  <a:cubicBezTo>
                    <a:pt x="1289" y="1392"/>
                    <a:pt x="1275" y="1375"/>
                    <a:pt x="1276" y="1355"/>
                  </a:cubicBezTo>
                  <a:lnTo>
                    <a:pt x="1277" y="1340"/>
                  </a:lnTo>
                  <a:cubicBezTo>
                    <a:pt x="1278" y="1319"/>
                    <a:pt x="1297" y="1302"/>
                    <a:pt x="1318" y="1301"/>
                  </a:cubicBezTo>
                  <a:cubicBezTo>
                    <a:pt x="1339" y="1301"/>
                    <a:pt x="1355" y="1317"/>
                    <a:pt x="1354" y="1338"/>
                  </a:cubicBezTo>
                  <a:lnTo>
                    <a:pt x="1339" y="1658"/>
                  </a:lnTo>
                  <a:lnTo>
                    <a:pt x="1338" y="1806"/>
                  </a:lnTo>
                  <a:lnTo>
                    <a:pt x="1331" y="1963"/>
                  </a:lnTo>
                  <a:lnTo>
                    <a:pt x="1329" y="1981"/>
                  </a:lnTo>
                  <a:lnTo>
                    <a:pt x="1302" y="2112"/>
                  </a:lnTo>
                  <a:lnTo>
                    <a:pt x="1292" y="2145"/>
                  </a:lnTo>
                  <a:cubicBezTo>
                    <a:pt x="1292" y="2147"/>
                    <a:pt x="1291" y="2150"/>
                    <a:pt x="1290" y="2152"/>
                  </a:cubicBezTo>
                  <a:lnTo>
                    <a:pt x="1238" y="2257"/>
                  </a:lnTo>
                  <a:cubicBezTo>
                    <a:pt x="1237" y="2259"/>
                    <a:pt x="1236" y="2261"/>
                    <a:pt x="1234" y="2263"/>
                  </a:cubicBezTo>
                  <a:lnTo>
                    <a:pt x="1221" y="2281"/>
                  </a:lnTo>
                  <a:cubicBezTo>
                    <a:pt x="1220" y="2282"/>
                    <a:pt x="1219" y="2284"/>
                    <a:pt x="1217" y="2285"/>
                  </a:cubicBezTo>
                  <a:lnTo>
                    <a:pt x="1199" y="2304"/>
                  </a:lnTo>
                  <a:lnTo>
                    <a:pt x="1113" y="2385"/>
                  </a:lnTo>
                  <a:lnTo>
                    <a:pt x="1106" y="2392"/>
                  </a:lnTo>
                  <a:cubicBezTo>
                    <a:pt x="1104" y="2394"/>
                    <a:pt x="1103" y="2396"/>
                    <a:pt x="1100" y="2398"/>
                  </a:cubicBezTo>
                  <a:lnTo>
                    <a:pt x="1087" y="2408"/>
                  </a:lnTo>
                  <a:cubicBezTo>
                    <a:pt x="1086" y="2409"/>
                    <a:pt x="1084" y="2410"/>
                    <a:pt x="1082" y="2411"/>
                  </a:cubicBezTo>
                  <a:lnTo>
                    <a:pt x="972" y="2472"/>
                  </a:lnTo>
                  <a:cubicBezTo>
                    <a:pt x="970" y="2473"/>
                    <a:pt x="969" y="2474"/>
                    <a:pt x="967" y="2475"/>
                  </a:cubicBezTo>
                  <a:lnTo>
                    <a:pt x="949" y="2482"/>
                  </a:lnTo>
                  <a:lnTo>
                    <a:pt x="819" y="2529"/>
                  </a:lnTo>
                  <a:lnTo>
                    <a:pt x="673" y="2571"/>
                  </a:lnTo>
                  <a:lnTo>
                    <a:pt x="401" y="2614"/>
                  </a:lnTo>
                  <a:lnTo>
                    <a:pt x="301" y="2630"/>
                  </a:lnTo>
                  <a:lnTo>
                    <a:pt x="233" y="2642"/>
                  </a:lnTo>
                  <a:lnTo>
                    <a:pt x="179" y="2655"/>
                  </a:lnTo>
                  <a:cubicBezTo>
                    <a:pt x="177" y="2656"/>
                    <a:pt x="175" y="2656"/>
                    <a:pt x="173" y="2656"/>
                  </a:cubicBezTo>
                  <a:lnTo>
                    <a:pt x="129" y="2660"/>
                  </a:lnTo>
                  <a:cubicBezTo>
                    <a:pt x="123" y="2661"/>
                    <a:pt x="118" y="2660"/>
                    <a:pt x="113" y="2659"/>
                  </a:cubicBezTo>
                  <a:lnTo>
                    <a:pt x="74" y="2646"/>
                  </a:lnTo>
                  <a:cubicBezTo>
                    <a:pt x="70" y="2644"/>
                    <a:pt x="66" y="2642"/>
                    <a:pt x="63" y="2639"/>
                  </a:cubicBezTo>
                  <a:lnTo>
                    <a:pt x="32" y="2612"/>
                  </a:lnTo>
                  <a:cubicBezTo>
                    <a:pt x="28" y="2609"/>
                    <a:pt x="25" y="2605"/>
                    <a:pt x="23" y="2600"/>
                  </a:cubicBezTo>
                  <a:lnTo>
                    <a:pt x="6" y="2562"/>
                  </a:lnTo>
                  <a:cubicBezTo>
                    <a:pt x="5" y="2559"/>
                    <a:pt x="4" y="2556"/>
                    <a:pt x="3" y="2553"/>
                  </a:cubicBezTo>
                  <a:lnTo>
                    <a:pt x="2" y="2546"/>
                  </a:lnTo>
                  <a:lnTo>
                    <a:pt x="0" y="2503"/>
                  </a:lnTo>
                  <a:cubicBezTo>
                    <a:pt x="0" y="2498"/>
                    <a:pt x="0" y="2493"/>
                    <a:pt x="2" y="2488"/>
                  </a:cubicBezTo>
                  <a:lnTo>
                    <a:pt x="15" y="2450"/>
                  </a:lnTo>
                  <a:cubicBezTo>
                    <a:pt x="16" y="2446"/>
                    <a:pt x="18" y="2442"/>
                    <a:pt x="21" y="2439"/>
                  </a:cubicBezTo>
                  <a:lnTo>
                    <a:pt x="46" y="2405"/>
                  </a:lnTo>
                  <a:cubicBezTo>
                    <a:pt x="49" y="2401"/>
                    <a:pt x="53" y="2397"/>
                    <a:pt x="57" y="2395"/>
                  </a:cubicBezTo>
                  <a:lnTo>
                    <a:pt x="94" y="2370"/>
                  </a:lnTo>
                  <a:cubicBezTo>
                    <a:pt x="95" y="2368"/>
                    <a:pt x="97" y="2367"/>
                    <a:pt x="99" y="2366"/>
                  </a:cubicBezTo>
                  <a:lnTo>
                    <a:pt x="141" y="2346"/>
                  </a:lnTo>
                  <a:lnTo>
                    <a:pt x="215" y="2318"/>
                  </a:lnTo>
                  <a:cubicBezTo>
                    <a:pt x="236" y="2310"/>
                    <a:pt x="257" y="2320"/>
                    <a:pt x="263" y="2339"/>
                  </a:cubicBezTo>
                  <a:lnTo>
                    <a:pt x="331" y="2546"/>
                  </a:lnTo>
                  <a:cubicBezTo>
                    <a:pt x="338" y="2565"/>
                    <a:pt x="327" y="2587"/>
                    <a:pt x="307" y="2595"/>
                  </a:cubicBezTo>
                  <a:lnTo>
                    <a:pt x="246" y="2621"/>
                  </a:lnTo>
                  <a:lnTo>
                    <a:pt x="206" y="2641"/>
                  </a:lnTo>
                  <a:cubicBezTo>
                    <a:pt x="190" y="2648"/>
                    <a:pt x="173" y="2645"/>
                    <a:pt x="162" y="2634"/>
                  </a:cubicBezTo>
                  <a:cubicBezTo>
                    <a:pt x="152" y="2623"/>
                    <a:pt x="150" y="2606"/>
                    <a:pt x="158" y="2591"/>
                  </a:cubicBezTo>
                  <a:lnTo>
                    <a:pt x="231" y="2454"/>
                  </a:lnTo>
                  <a:cubicBezTo>
                    <a:pt x="238" y="2440"/>
                    <a:pt x="254" y="2431"/>
                    <a:pt x="270" y="2431"/>
                  </a:cubicBezTo>
                  <a:cubicBezTo>
                    <a:pt x="285" y="2432"/>
                    <a:pt x="298" y="2442"/>
                    <a:pt x="302" y="2457"/>
                  </a:cubicBezTo>
                  <a:lnTo>
                    <a:pt x="304" y="2465"/>
                  </a:lnTo>
                  <a:cubicBezTo>
                    <a:pt x="308" y="2480"/>
                    <a:pt x="302" y="2497"/>
                    <a:pt x="289" y="2507"/>
                  </a:cubicBezTo>
                  <a:cubicBezTo>
                    <a:pt x="275" y="2517"/>
                    <a:pt x="258" y="2518"/>
                    <a:pt x="245" y="2511"/>
                  </a:cubicBezTo>
                  <a:lnTo>
                    <a:pt x="114" y="2436"/>
                  </a:lnTo>
                  <a:cubicBezTo>
                    <a:pt x="101" y="2428"/>
                    <a:pt x="94" y="2413"/>
                    <a:pt x="98" y="2398"/>
                  </a:cubicBezTo>
                  <a:cubicBezTo>
                    <a:pt x="101" y="2382"/>
                    <a:pt x="113" y="2370"/>
                    <a:pt x="129" y="2366"/>
                  </a:cubicBezTo>
                  <a:lnTo>
                    <a:pt x="202" y="2347"/>
                  </a:lnTo>
                  <a:lnTo>
                    <a:pt x="279" y="2330"/>
                  </a:lnTo>
                  <a:lnTo>
                    <a:pt x="380" y="2313"/>
                  </a:lnTo>
                  <a:lnTo>
                    <a:pt x="622" y="2276"/>
                  </a:lnTo>
                  <a:lnTo>
                    <a:pt x="740" y="2246"/>
                  </a:lnTo>
                  <a:lnTo>
                    <a:pt x="864" y="2200"/>
                  </a:lnTo>
                  <a:cubicBezTo>
                    <a:pt x="884" y="2192"/>
                    <a:pt x="905" y="2202"/>
                    <a:pt x="911" y="2221"/>
                  </a:cubicBezTo>
                  <a:cubicBezTo>
                    <a:pt x="918" y="2240"/>
                    <a:pt x="907" y="2261"/>
                    <a:pt x="888" y="2270"/>
                  </a:cubicBezTo>
                  <a:lnTo>
                    <a:pt x="870" y="2278"/>
                  </a:lnTo>
                  <a:cubicBezTo>
                    <a:pt x="850" y="2287"/>
                    <a:pt x="829" y="2279"/>
                    <a:pt x="821" y="2261"/>
                  </a:cubicBezTo>
                  <a:cubicBezTo>
                    <a:pt x="813" y="2243"/>
                    <a:pt x="821" y="2221"/>
                    <a:pt x="840" y="2211"/>
                  </a:cubicBezTo>
                  <a:lnTo>
                    <a:pt x="950" y="2149"/>
                  </a:lnTo>
                  <a:cubicBezTo>
                    <a:pt x="968" y="2138"/>
                    <a:pt x="990" y="2143"/>
                    <a:pt x="1000" y="2160"/>
                  </a:cubicBezTo>
                  <a:cubicBezTo>
                    <a:pt x="1010" y="2177"/>
                    <a:pt x="1004" y="2199"/>
                    <a:pt x="987" y="2212"/>
                  </a:cubicBezTo>
                  <a:lnTo>
                    <a:pt x="959" y="2232"/>
                  </a:lnTo>
                  <a:cubicBezTo>
                    <a:pt x="942" y="2244"/>
                    <a:pt x="919" y="2242"/>
                    <a:pt x="907" y="2227"/>
                  </a:cubicBezTo>
                  <a:cubicBezTo>
                    <a:pt x="895" y="2212"/>
                    <a:pt x="898" y="2189"/>
                    <a:pt x="913" y="2175"/>
                  </a:cubicBezTo>
                  <a:lnTo>
                    <a:pt x="998" y="2096"/>
                  </a:lnTo>
                  <a:cubicBezTo>
                    <a:pt x="1013" y="2082"/>
                    <a:pt x="1036" y="2080"/>
                    <a:pt x="1050" y="2093"/>
                  </a:cubicBezTo>
                  <a:cubicBezTo>
                    <a:pt x="1064" y="2105"/>
                    <a:pt x="1066" y="2126"/>
                    <a:pt x="1054" y="2143"/>
                  </a:cubicBezTo>
                  <a:lnTo>
                    <a:pt x="1027" y="2180"/>
                  </a:lnTo>
                  <a:cubicBezTo>
                    <a:pt x="1015" y="2197"/>
                    <a:pt x="993" y="2202"/>
                    <a:pt x="976" y="2193"/>
                  </a:cubicBezTo>
                  <a:cubicBezTo>
                    <a:pt x="959" y="2184"/>
                    <a:pt x="953" y="2164"/>
                    <a:pt x="962" y="2145"/>
                  </a:cubicBezTo>
                  <a:lnTo>
                    <a:pt x="1014" y="2040"/>
                  </a:lnTo>
                  <a:cubicBezTo>
                    <a:pt x="1023" y="2022"/>
                    <a:pt x="1044" y="2012"/>
                    <a:pt x="1063" y="2018"/>
                  </a:cubicBezTo>
                  <a:cubicBezTo>
                    <a:pt x="1081" y="2024"/>
                    <a:pt x="1091" y="2043"/>
                    <a:pt x="1085" y="2062"/>
                  </a:cubicBezTo>
                  <a:lnTo>
                    <a:pt x="1076" y="2092"/>
                  </a:lnTo>
                  <a:cubicBezTo>
                    <a:pt x="1070" y="2112"/>
                    <a:pt x="1050" y="2125"/>
                    <a:pt x="1030" y="2122"/>
                  </a:cubicBezTo>
                  <a:cubicBezTo>
                    <a:pt x="1010" y="2119"/>
                    <a:pt x="997" y="2100"/>
                    <a:pt x="1002" y="2080"/>
                  </a:cubicBezTo>
                  <a:lnTo>
                    <a:pt x="1029" y="1953"/>
                  </a:lnTo>
                  <a:cubicBezTo>
                    <a:pt x="1033" y="1933"/>
                    <a:pt x="1053" y="1918"/>
                    <a:pt x="1073" y="1919"/>
                  </a:cubicBezTo>
                  <a:cubicBezTo>
                    <a:pt x="1093" y="1921"/>
                    <a:pt x="1107" y="1939"/>
                    <a:pt x="1105" y="1959"/>
                  </a:cubicBezTo>
                  <a:lnTo>
                    <a:pt x="1103" y="1974"/>
                  </a:lnTo>
                  <a:cubicBezTo>
                    <a:pt x="1100" y="1995"/>
                    <a:pt x="1082" y="2011"/>
                    <a:pt x="1061" y="2011"/>
                  </a:cubicBezTo>
                  <a:cubicBezTo>
                    <a:pt x="1041" y="2011"/>
                    <a:pt x="1025" y="1995"/>
                    <a:pt x="1026" y="1974"/>
                  </a:cubicBezTo>
                  <a:lnTo>
                    <a:pt x="1032" y="1834"/>
                  </a:lnTo>
                  <a:lnTo>
                    <a:pt x="1032" y="1673"/>
                  </a:lnTo>
                  <a:lnTo>
                    <a:pt x="1047" y="1350"/>
                  </a:lnTo>
                  <a:cubicBezTo>
                    <a:pt x="1047" y="1348"/>
                    <a:pt x="1047" y="1345"/>
                    <a:pt x="1048" y="1343"/>
                  </a:cubicBezTo>
                  <a:lnTo>
                    <a:pt x="1052" y="1326"/>
                  </a:lnTo>
                  <a:lnTo>
                    <a:pt x="1085" y="1172"/>
                  </a:lnTo>
                  <a:lnTo>
                    <a:pt x="1092" y="1144"/>
                  </a:lnTo>
                  <a:lnTo>
                    <a:pt x="1152" y="1002"/>
                  </a:lnTo>
                  <a:cubicBezTo>
                    <a:pt x="1153" y="1001"/>
                    <a:pt x="1154" y="999"/>
                    <a:pt x="1155" y="997"/>
                  </a:cubicBezTo>
                  <a:lnTo>
                    <a:pt x="1171" y="970"/>
                  </a:lnTo>
                  <a:lnTo>
                    <a:pt x="1364" y="715"/>
                  </a:lnTo>
                  <a:lnTo>
                    <a:pt x="1377" y="699"/>
                  </a:lnTo>
                  <a:cubicBezTo>
                    <a:pt x="1378" y="698"/>
                    <a:pt x="1380" y="696"/>
                    <a:pt x="1382" y="695"/>
                  </a:cubicBezTo>
                  <a:lnTo>
                    <a:pt x="1643" y="455"/>
                  </a:lnTo>
                  <a:lnTo>
                    <a:pt x="1943" y="225"/>
                  </a:lnTo>
                  <a:lnTo>
                    <a:pt x="2252" y="9"/>
                  </a:lnTo>
                  <a:cubicBezTo>
                    <a:pt x="2261" y="3"/>
                    <a:pt x="2272" y="0"/>
                    <a:pt x="2282" y="2"/>
                  </a:cubicBezTo>
                  <a:cubicBezTo>
                    <a:pt x="2292" y="3"/>
                    <a:pt x="2300" y="9"/>
                    <a:pt x="2306" y="17"/>
                  </a:cubicBezTo>
                  <a:lnTo>
                    <a:pt x="2422" y="199"/>
                  </a:lnTo>
                  <a:close/>
                  <a:moveTo>
                    <a:pt x="2239" y="62"/>
                  </a:moveTo>
                  <a:lnTo>
                    <a:pt x="2293" y="70"/>
                  </a:lnTo>
                  <a:lnTo>
                    <a:pt x="1986" y="284"/>
                  </a:lnTo>
                  <a:lnTo>
                    <a:pt x="1692" y="508"/>
                  </a:lnTo>
                  <a:lnTo>
                    <a:pt x="1431" y="748"/>
                  </a:lnTo>
                  <a:lnTo>
                    <a:pt x="1436" y="743"/>
                  </a:lnTo>
                  <a:lnTo>
                    <a:pt x="1425" y="758"/>
                  </a:lnTo>
                  <a:lnTo>
                    <a:pt x="1236" y="1005"/>
                  </a:lnTo>
                  <a:lnTo>
                    <a:pt x="1220" y="1032"/>
                  </a:lnTo>
                  <a:lnTo>
                    <a:pt x="1223" y="1026"/>
                  </a:lnTo>
                  <a:lnTo>
                    <a:pt x="1167" y="1159"/>
                  </a:lnTo>
                  <a:lnTo>
                    <a:pt x="1160" y="1181"/>
                  </a:lnTo>
                  <a:lnTo>
                    <a:pt x="1127" y="1337"/>
                  </a:lnTo>
                  <a:lnTo>
                    <a:pt x="1123" y="1354"/>
                  </a:lnTo>
                  <a:lnTo>
                    <a:pt x="1124" y="1347"/>
                  </a:lnTo>
                  <a:lnTo>
                    <a:pt x="1109" y="1666"/>
                  </a:lnTo>
                  <a:lnTo>
                    <a:pt x="1109" y="1831"/>
                  </a:lnTo>
                  <a:lnTo>
                    <a:pt x="1103" y="1971"/>
                  </a:lnTo>
                  <a:lnTo>
                    <a:pt x="1026" y="1971"/>
                  </a:lnTo>
                  <a:lnTo>
                    <a:pt x="1028" y="1956"/>
                  </a:lnTo>
                  <a:lnTo>
                    <a:pt x="1104" y="1962"/>
                  </a:lnTo>
                  <a:lnTo>
                    <a:pt x="1077" y="2089"/>
                  </a:lnTo>
                  <a:lnTo>
                    <a:pt x="1003" y="2077"/>
                  </a:lnTo>
                  <a:lnTo>
                    <a:pt x="1012" y="2047"/>
                  </a:lnTo>
                  <a:lnTo>
                    <a:pt x="1083" y="2069"/>
                  </a:lnTo>
                  <a:lnTo>
                    <a:pt x="1031" y="2174"/>
                  </a:lnTo>
                  <a:lnTo>
                    <a:pt x="966" y="2139"/>
                  </a:lnTo>
                  <a:lnTo>
                    <a:pt x="993" y="2102"/>
                  </a:lnTo>
                  <a:lnTo>
                    <a:pt x="1049" y="2149"/>
                  </a:lnTo>
                  <a:lnTo>
                    <a:pt x="964" y="2228"/>
                  </a:lnTo>
                  <a:lnTo>
                    <a:pt x="918" y="2171"/>
                  </a:lnTo>
                  <a:lnTo>
                    <a:pt x="946" y="2151"/>
                  </a:lnTo>
                  <a:lnTo>
                    <a:pt x="983" y="2214"/>
                  </a:lnTo>
                  <a:lnTo>
                    <a:pt x="873" y="2276"/>
                  </a:lnTo>
                  <a:lnTo>
                    <a:pt x="843" y="2209"/>
                  </a:lnTo>
                  <a:lnTo>
                    <a:pt x="861" y="2201"/>
                  </a:lnTo>
                  <a:lnTo>
                    <a:pt x="885" y="2271"/>
                  </a:lnTo>
                  <a:lnTo>
                    <a:pt x="753" y="2319"/>
                  </a:lnTo>
                  <a:lnTo>
                    <a:pt x="627" y="2351"/>
                  </a:lnTo>
                  <a:lnTo>
                    <a:pt x="387" y="2388"/>
                  </a:lnTo>
                  <a:lnTo>
                    <a:pt x="288" y="2405"/>
                  </a:lnTo>
                  <a:lnTo>
                    <a:pt x="215" y="2420"/>
                  </a:lnTo>
                  <a:lnTo>
                    <a:pt x="142" y="2439"/>
                  </a:lnTo>
                  <a:lnTo>
                    <a:pt x="157" y="2369"/>
                  </a:lnTo>
                  <a:lnTo>
                    <a:pt x="288" y="2444"/>
                  </a:lnTo>
                  <a:lnTo>
                    <a:pt x="229" y="2490"/>
                  </a:lnTo>
                  <a:lnTo>
                    <a:pt x="227" y="2482"/>
                  </a:lnTo>
                  <a:lnTo>
                    <a:pt x="298" y="2485"/>
                  </a:lnTo>
                  <a:lnTo>
                    <a:pt x="225" y="2622"/>
                  </a:lnTo>
                  <a:lnTo>
                    <a:pt x="177" y="2572"/>
                  </a:lnTo>
                  <a:lnTo>
                    <a:pt x="221" y="2552"/>
                  </a:lnTo>
                  <a:lnTo>
                    <a:pt x="282" y="2526"/>
                  </a:lnTo>
                  <a:lnTo>
                    <a:pt x="258" y="2575"/>
                  </a:lnTo>
                  <a:lnTo>
                    <a:pt x="190" y="2368"/>
                  </a:lnTo>
                  <a:lnTo>
                    <a:pt x="237" y="2389"/>
                  </a:lnTo>
                  <a:lnTo>
                    <a:pt x="170" y="2415"/>
                  </a:lnTo>
                  <a:lnTo>
                    <a:pt x="128" y="2435"/>
                  </a:lnTo>
                  <a:lnTo>
                    <a:pt x="133" y="2431"/>
                  </a:lnTo>
                  <a:lnTo>
                    <a:pt x="96" y="2456"/>
                  </a:lnTo>
                  <a:lnTo>
                    <a:pt x="107" y="2446"/>
                  </a:lnTo>
                  <a:lnTo>
                    <a:pt x="82" y="2480"/>
                  </a:lnTo>
                  <a:lnTo>
                    <a:pt x="88" y="2469"/>
                  </a:lnTo>
                  <a:lnTo>
                    <a:pt x="75" y="2507"/>
                  </a:lnTo>
                  <a:lnTo>
                    <a:pt x="77" y="2492"/>
                  </a:lnTo>
                  <a:lnTo>
                    <a:pt x="79" y="2529"/>
                  </a:lnTo>
                  <a:lnTo>
                    <a:pt x="80" y="2536"/>
                  </a:lnTo>
                  <a:lnTo>
                    <a:pt x="77" y="2527"/>
                  </a:lnTo>
                  <a:lnTo>
                    <a:pt x="94" y="2565"/>
                  </a:lnTo>
                  <a:lnTo>
                    <a:pt x="85" y="2553"/>
                  </a:lnTo>
                  <a:lnTo>
                    <a:pt x="116" y="2580"/>
                  </a:lnTo>
                  <a:lnTo>
                    <a:pt x="105" y="2573"/>
                  </a:lnTo>
                  <a:lnTo>
                    <a:pt x="144" y="2586"/>
                  </a:lnTo>
                  <a:lnTo>
                    <a:pt x="128" y="2584"/>
                  </a:lnTo>
                  <a:lnTo>
                    <a:pt x="172" y="2580"/>
                  </a:lnTo>
                  <a:lnTo>
                    <a:pt x="166" y="2581"/>
                  </a:lnTo>
                  <a:lnTo>
                    <a:pt x="226" y="2567"/>
                  </a:lnTo>
                  <a:lnTo>
                    <a:pt x="296" y="2555"/>
                  </a:lnTo>
                  <a:lnTo>
                    <a:pt x="396" y="2539"/>
                  </a:lnTo>
                  <a:lnTo>
                    <a:pt x="658" y="2498"/>
                  </a:lnTo>
                  <a:lnTo>
                    <a:pt x="798" y="2458"/>
                  </a:lnTo>
                  <a:lnTo>
                    <a:pt x="926" y="2411"/>
                  </a:lnTo>
                  <a:lnTo>
                    <a:pt x="944" y="2404"/>
                  </a:lnTo>
                  <a:lnTo>
                    <a:pt x="939" y="2407"/>
                  </a:lnTo>
                  <a:lnTo>
                    <a:pt x="1049" y="2346"/>
                  </a:lnTo>
                  <a:lnTo>
                    <a:pt x="1044" y="2349"/>
                  </a:lnTo>
                  <a:lnTo>
                    <a:pt x="1057" y="2339"/>
                  </a:lnTo>
                  <a:lnTo>
                    <a:pt x="1051" y="2345"/>
                  </a:lnTo>
                  <a:lnTo>
                    <a:pt x="1062" y="2332"/>
                  </a:lnTo>
                  <a:lnTo>
                    <a:pt x="1145" y="2255"/>
                  </a:lnTo>
                  <a:lnTo>
                    <a:pt x="1163" y="2236"/>
                  </a:lnTo>
                  <a:lnTo>
                    <a:pt x="1160" y="2240"/>
                  </a:lnTo>
                  <a:lnTo>
                    <a:pt x="1173" y="2222"/>
                  </a:lnTo>
                  <a:lnTo>
                    <a:pt x="1169" y="2228"/>
                  </a:lnTo>
                  <a:lnTo>
                    <a:pt x="1221" y="2123"/>
                  </a:lnTo>
                  <a:lnTo>
                    <a:pt x="1219" y="2130"/>
                  </a:lnTo>
                  <a:lnTo>
                    <a:pt x="1227" y="2103"/>
                  </a:lnTo>
                  <a:lnTo>
                    <a:pt x="1252" y="1978"/>
                  </a:lnTo>
                  <a:lnTo>
                    <a:pt x="1254" y="1966"/>
                  </a:lnTo>
                  <a:lnTo>
                    <a:pt x="1261" y="1813"/>
                  </a:lnTo>
                  <a:lnTo>
                    <a:pt x="1262" y="1661"/>
                  </a:lnTo>
                  <a:lnTo>
                    <a:pt x="1277" y="1341"/>
                  </a:lnTo>
                  <a:lnTo>
                    <a:pt x="1354" y="1339"/>
                  </a:lnTo>
                  <a:lnTo>
                    <a:pt x="1353" y="1354"/>
                  </a:lnTo>
                  <a:lnTo>
                    <a:pt x="1277" y="1350"/>
                  </a:lnTo>
                  <a:lnTo>
                    <a:pt x="1309" y="1195"/>
                  </a:lnTo>
                  <a:lnTo>
                    <a:pt x="1383" y="1208"/>
                  </a:lnTo>
                  <a:lnTo>
                    <a:pt x="1375" y="1233"/>
                  </a:lnTo>
                  <a:lnTo>
                    <a:pt x="1303" y="1213"/>
                  </a:lnTo>
                  <a:lnTo>
                    <a:pt x="1361" y="1075"/>
                  </a:lnTo>
                  <a:lnTo>
                    <a:pt x="1430" y="1103"/>
                  </a:lnTo>
                  <a:lnTo>
                    <a:pt x="1414" y="1131"/>
                  </a:lnTo>
                  <a:lnTo>
                    <a:pt x="1350" y="1093"/>
                  </a:lnTo>
                  <a:lnTo>
                    <a:pt x="1542" y="842"/>
                  </a:lnTo>
                  <a:lnTo>
                    <a:pt x="1596" y="891"/>
                  </a:lnTo>
                  <a:lnTo>
                    <a:pt x="1582" y="903"/>
                  </a:lnTo>
                  <a:cubicBezTo>
                    <a:pt x="1566" y="917"/>
                    <a:pt x="1542" y="917"/>
                    <a:pt x="1529" y="902"/>
                  </a:cubicBezTo>
                  <a:cubicBezTo>
                    <a:pt x="1515" y="887"/>
                    <a:pt x="1517" y="864"/>
                    <a:pt x="1533" y="849"/>
                  </a:cubicBezTo>
                  <a:lnTo>
                    <a:pt x="1773" y="624"/>
                  </a:lnTo>
                  <a:lnTo>
                    <a:pt x="2060" y="405"/>
                  </a:lnTo>
                  <a:lnTo>
                    <a:pt x="2368" y="191"/>
                  </a:lnTo>
                  <a:lnTo>
                    <a:pt x="2355" y="244"/>
                  </a:lnTo>
                  <a:lnTo>
                    <a:pt x="2239" y="62"/>
                  </a:lnTo>
                  <a:close/>
                </a:path>
              </a:pathLst>
            </a:custGeom>
            <a:solidFill>
              <a:srgbClr val="8EB4E3"/>
            </a:solidFill>
            <a:ln w="0" cap="flat">
              <a:solidFill>
                <a:srgbClr val="8EB4E3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" name="Freeform 207">
              <a:extLst>
                <a:ext uri="{FF2B5EF4-FFF2-40B4-BE49-F238E27FC236}">
                  <a16:creationId xmlns:a16="http://schemas.microsoft.com/office/drawing/2014/main" id="{96232E56-E07C-4369-A010-3157B9044EBF}"/>
                </a:ext>
              </a:extLst>
            </p:cNvPr>
            <p:cNvSpPr>
              <a:spLocks/>
            </p:cNvSpPr>
            <p:nvPr/>
          </p:nvSpPr>
          <p:spPr bwMode="auto">
            <a:xfrm>
              <a:off x="496" y="2269"/>
              <a:ext cx="88" cy="65"/>
            </a:xfrm>
            <a:custGeom>
              <a:avLst/>
              <a:gdLst>
                <a:gd name="T0" fmla="*/ 0 w 88"/>
                <a:gd name="T1" fmla="*/ 58 h 65"/>
                <a:gd name="T2" fmla="*/ 84 w 88"/>
                <a:gd name="T3" fmla="*/ 0 h 65"/>
                <a:gd name="T4" fmla="*/ 88 w 88"/>
                <a:gd name="T5" fmla="*/ 6 h 65"/>
                <a:gd name="T6" fmla="*/ 5 w 88"/>
                <a:gd name="T7" fmla="*/ 65 h 65"/>
                <a:gd name="T8" fmla="*/ 0 w 88"/>
                <a:gd name="T9" fmla="*/ 58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8" h="65">
                  <a:moveTo>
                    <a:pt x="0" y="58"/>
                  </a:moveTo>
                  <a:lnTo>
                    <a:pt x="84" y="0"/>
                  </a:lnTo>
                  <a:lnTo>
                    <a:pt x="88" y="6"/>
                  </a:lnTo>
                  <a:lnTo>
                    <a:pt x="5" y="65"/>
                  </a:lnTo>
                  <a:lnTo>
                    <a:pt x="0" y="58"/>
                  </a:lnTo>
                  <a:close/>
                </a:path>
              </a:pathLst>
            </a:custGeom>
            <a:solidFill>
              <a:srgbClr val="948A54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" name="Freeform 208">
              <a:extLst>
                <a:ext uri="{FF2B5EF4-FFF2-40B4-BE49-F238E27FC236}">
                  <a16:creationId xmlns:a16="http://schemas.microsoft.com/office/drawing/2014/main" id="{3D25A643-137E-48E6-8D83-5EAD66D6197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94" y="2267"/>
              <a:ext cx="92" cy="69"/>
            </a:xfrm>
            <a:custGeom>
              <a:avLst/>
              <a:gdLst>
                <a:gd name="T0" fmla="*/ 8 w 2356"/>
                <a:gd name="T1" fmla="*/ 1572 h 1774"/>
                <a:gd name="T2" fmla="*/ 3 w 2356"/>
                <a:gd name="T3" fmla="*/ 1544 h 1774"/>
                <a:gd name="T4" fmla="*/ 20 w 2356"/>
                <a:gd name="T5" fmla="*/ 1518 h 1774"/>
                <a:gd name="T6" fmla="*/ 2178 w 2356"/>
                <a:gd name="T7" fmla="*/ 13 h 1774"/>
                <a:gd name="T8" fmla="*/ 2231 w 2356"/>
                <a:gd name="T9" fmla="*/ 20 h 1774"/>
                <a:gd name="T10" fmla="*/ 2349 w 2356"/>
                <a:gd name="T11" fmla="*/ 193 h 1774"/>
                <a:gd name="T12" fmla="*/ 2354 w 2356"/>
                <a:gd name="T13" fmla="*/ 222 h 1774"/>
                <a:gd name="T14" fmla="*/ 2337 w 2356"/>
                <a:gd name="T15" fmla="*/ 247 h 1774"/>
                <a:gd name="T16" fmla="*/ 186 w 2356"/>
                <a:gd name="T17" fmla="*/ 1761 h 1774"/>
                <a:gd name="T18" fmla="*/ 133 w 2356"/>
                <a:gd name="T19" fmla="*/ 1754 h 1774"/>
                <a:gd name="T20" fmla="*/ 8 w 2356"/>
                <a:gd name="T21" fmla="*/ 1572 h 1774"/>
                <a:gd name="T22" fmla="*/ 198 w 2356"/>
                <a:gd name="T23" fmla="*/ 1708 h 1774"/>
                <a:gd name="T24" fmla="*/ 145 w 2356"/>
                <a:gd name="T25" fmla="*/ 1700 h 1774"/>
                <a:gd name="T26" fmla="*/ 2296 w 2356"/>
                <a:gd name="T27" fmla="*/ 186 h 1774"/>
                <a:gd name="T28" fmla="*/ 2283 w 2356"/>
                <a:gd name="T29" fmla="*/ 240 h 1774"/>
                <a:gd name="T30" fmla="*/ 2166 w 2356"/>
                <a:gd name="T31" fmla="*/ 67 h 1774"/>
                <a:gd name="T32" fmla="*/ 2219 w 2356"/>
                <a:gd name="T33" fmla="*/ 74 h 1774"/>
                <a:gd name="T34" fmla="*/ 61 w 2356"/>
                <a:gd name="T35" fmla="*/ 1579 h 1774"/>
                <a:gd name="T36" fmla="*/ 73 w 2356"/>
                <a:gd name="T37" fmla="*/ 1525 h 1774"/>
                <a:gd name="T38" fmla="*/ 198 w 2356"/>
                <a:gd name="T39" fmla="*/ 1708 h 17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2356" h="1774">
                  <a:moveTo>
                    <a:pt x="8" y="1572"/>
                  </a:moveTo>
                  <a:cubicBezTo>
                    <a:pt x="2" y="1564"/>
                    <a:pt x="0" y="1554"/>
                    <a:pt x="3" y="1544"/>
                  </a:cubicBezTo>
                  <a:cubicBezTo>
                    <a:pt x="5" y="1534"/>
                    <a:pt x="11" y="1524"/>
                    <a:pt x="20" y="1518"/>
                  </a:cubicBezTo>
                  <a:lnTo>
                    <a:pt x="2178" y="13"/>
                  </a:lnTo>
                  <a:cubicBezTo>
                    <a:pt x="2196" y="0"/>
                    <a:pt x="2220" y="4"/>
                    <a:pt x="2231" y="20"/>
                  </a:cubicBezTo>
                  <a:lnTo>
                    <a:pt x="2349" y="193"/>
                  </a:lnTo>
                  <a:cubicBezTo>
                    <a:pt x="2354" y="201"/>
                    <a:pt x="2356" y="211"/>
                    <a:pt x="2354" y="222"/>
                  </a:cubicBezTo>
                  <a:cubicBezTo>
                    <a:pt x="2351" y="232"/>
                    <a:pt x="2345" y="241"/>
                    <a:pt x="2337" y="247"/>
                  </a:cubicBezTo>
                  <a:lnTo>
                    <a:pt x="186" y="1761"/>
                  </a:lnTo>
                  <a:cubicBezTo>
                    <a:pt x="168" y="1774"/>
                    <a:pt x="145" y="1771"/>
                    <a:pt x="133" y="1754"/>
                  </a:cubicBezTo>
                  <a:lnTo>
                    <a:pt x="8" y="1572"/>
                  </a:lnTo>
                  <a:close/>
                  <a:moveTo>
                    <a:pt x="198" y="1708"/>
                  </a:moveTo>
                  <a:lnTo>
                    <a:pt x="145" y="1700"/>
                  </a:lnTo>
                  <a:lnTo>
                    <a:pt x="2296" y="186"/>
                  </a:lnTo>
                  <a:lnTo>
                    <a:pt x="2283" y="240"/>
                  </a:lnTo>
                  <a:lnTo>
                    <a:pt x="2166" y="67"/>
                  </a:lnTo>
                  <a:lnTo>
                    <a:pt x="2219" y="74"/>
                  </a:lnTo>
                  <a:lnTo>
                    <a:pt x="61" y="1579"/>
                  </a:lnTo>
                  <a:lnTo>
                    <a:pt x="73" y="1525"/>
                  </a:lnTo>
                  <a:lnTo>
                    <a:pt x="198" y="1708"/>
                  </a:lnTo>
                  <a:close/>
                </a:path>
              </a:pathLst>
            </a:custGeom>
            <a:solidFill>
              <a:srgbClr val="948A54"/>
            </a:solidFill>
            <a:ln w="0" cap="flat">
              <a:solidFill>
                <a:srgbClr val="948A54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" name="Freeform 209">
              <a:extLst>
                <a:ext uri="{FF2B5EF4-FFF2-40B4-BE49-F238E27FC236}">
                  <a16:creationId xmlns:a16="http://schemas.microsoft.com/office/drawing/2014/main" id="{318EEEB1-D7DB-4891-942A-A7556047DBDD}"/>
                </a:ext>
              </a:extLst>
            </p:cNvPr>
            <p:cNvSpPr>
              <a:spLocks/>
            </p:cNvSpPr>
            <p:nvPr/>
          </p:nvSpPr>
          <p:spPr bwMode="auto">
            <a:xfrm>
              <a:off x="586" y="2246"/>
              <a:ext cx="28" cy="96"/>
            </a:xfrm>
            <a:custGeom>
              <a:avLst/>
              <a:gdLst>
                <a:gd name="T0" fmla="*/ 0 w 28"/>
                <a:gd name="T1" fmla="*/ 95 h 96"/>
                <a:gd name="T2" fmla="*/ 19 w 28"/>
                <a:gd name="T3" fmla="*/ 0 h 96"/>
                <a:gd name="T4" fmla="*/ 28 w 28"/>
                <a:gd name="T5" fmla="*/ 0 h 96"/>
                <a:gd name="T6" fmla="*/ 9 w 28"/>
                <a:gd name="T7" fmla="*/ 96 h 96"/>
                <a:gd name="T8" fmla="*/ 0 w 28"/>
                <a:gd name="T9" fmla="*/ 95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" h="96">
                  <a:moveTo>
                    <a:pt x="0" y="95"/>
                  </a:moveTo>
                  <a:lnTo>
                    <a:pt x="19" y="0"/>
                  </a:lnTo>
                  <a:lnTo>
                    <a:pt x="28" y="0"/>
                  </a:lnTo>
                  <a:lnTo>
                    <a:pt x="9" y="96"/>
                  </a:lnTo>
                  <a:lnTo>
                    <a:pt x="0" y="95"/>
                  </a:lnTo>
                  <a:close/>
                </a:path>
              </a:pathLst>
            </a:custGeom>
            <a:solidFill>
              <a:srgbClr val="00206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" name="Freeform 210">
              <a:extLst>
                <a:ext uri="{FF2B5EF4-FFF2-40B4-BE49-F238E27FC236}">
                  <a16:creationId xmlns:a16="http://schemas.microsoft.com/office/drawing/2014/main" id="{03146820-174B-44C1-BAC2-1E60F7043F5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84" y="2244"/>
              <a:ext cx="31" cy="99"/>
            </a:xfrm>
            <a:custGeom>
              <a:avLst/>
              <a:gdLst>
                <a:gd name="T0" fmla="*/ 34 w 795"/>
                <a:gd name="T1" fmla="*/ 2539 h 2553"/>
                <a:gd name="T2" fmla="*/ 8 w 795"/>
                <a:gd name="T3" fmla="*/ 2526 h 2553"/>
                <a:gd name="T4" fmla="*/ 2 w 795"/>
                <a:gd name="T5" fmla="*/ 2497 h 2553"/>
                <a:gd name="T6" fmla="*/ 487 w 795"/>
                <a:gd name="T7" fmla="*/ 35 h 2553"/>
                <a:gd name="T8" fmla="*/ 531 w 795"/>
                <a:gd name="T9" fmla="*/ 1 h 2553"/>
                <a:gd name="T10" fmla="*/ 761 w 795"/>
                <a:gd name="T11" fmla="*/ 14 h 2553"/>
                <a:gd name="T12" fmla="*/ 787 w 795"/>
                <a:gd name="T13" fmla="*/ 27 h 2553"/>
                <a:gd name="T14" fmla="*/ 793 w 795"/>
                <a:gd name="T15" fmla="*/ 56 h 2553"/>
                <a:gd name="T16" fmla="*/ 308 w 795"/>
                <a:gd name="T17" fmla="*/ 2518 h 2553"/>
                <a:gd name="T18" fmla="*/ 264 w 795"/>
                <a:gd name="T19" fmla="*/ 2552 h 2553"/>
                <a:gd name="T20" fmla="*/ 34 w 795"/>
                <a:gd name="T21" fmla="*/ 2539 h 2553"/>
                <a:gd name="T22" fmla="*/ 275 w 795"/>
                <a:gd name="T23" fmla="*/ 2476 h 2553"/>
                <a:gd name="T24" fmla="*/ 232 w 795"/>
                <a:gd name="T25" fmla="*/ 2510 h 2553"/>
                <a:gd name="T26" fmla="*/ 718 w 795"/>
                <a:gd name="T27" fmla="*/ 48 h 2553"/>
                <a:gd name="T28" fmla="*/ 750 w 795"/>
                <a:gd name="T29" fmla="*/ 90 h 2553"/>
                <a:gd name="T30" fmla="*/ 520 w 795"/>
                <a:gd name="T31" fmla="*/ 77 h 2553"/>
                <a:gd name="T32" fmla="*/ 563 w 795"/>
                <a:gd name="T33" fmla="*/ 43 h 2553"/>
                <a:gd name="T34" fmla="*/ 77 w 795"/>
                <a:gd name="T35" fmla="*/ 2505 h 2553"/>
                <a:gd name="T36" fmla="*/ 45 w 795"/>
                <a:gd name="T37" fmla="*/ 2463 h 2553"/>
                <a:gd name="T38" fmla="*/ 275 w 795"/>
                <a:gd name="T39" fmla="*/ 2476 h 25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795" h="2553">
                  <a:moveTo>
                    <a:pt x="34" y="2539"/>
                  </a:moveTo>
                  <a:cubicBezTo>
                    <a:pt x="24" y="2539"/>
                    <a:pt x="14" y="2534"/>
                    <a:pt x="8" y="2526"/>
                  </a:cubicBezTo>
                  <a:cubicBezTo>
                    <a:pt x="2" y="2518"/>
                    <a:pt x="0" y="2508"/>
                    <a:pt x="2" y="2497"/>
                  </a:cubicBezTo>
                  <a:lnTo>
                    <a:pt x="487" y="35"/>
                  </a:lnTo>
                  <a:cubicBezTo>
                    <a:pt x="491" y="15"/>
                    <a:pt x="510" y="0"/>
                    <a:pt x="531" y="1"/>
                  </a:cubicBezTo>
                  <a:lnTo>
                    <a:pt x="761" y="14"/>
                  </a:lnTo>
                  <a:cubicBezTo>
                    <a:pt x="771" y="14"/>
                    <a:pt x="781" y="19"/>
                    <a:pt x="787" y="27"/>
                  </a:cubicBezTo>
                  <a:cubicBezTo>
                    <a:pt x="793" y="35"/>
                    <a:pt x="795" y="45"/>
                    <a:pt x="793" y="56"/>
                  </a:cubicBezTo>
                  <a:lnTo>
                    <a:pt x="308" y="2518"/>
                  </a:lnTo>
                  <a:cubicBezTo>
                    <a:pt x="304" y="2538"/>
                    <a:pt x="285" y="2553"/>
                    <a:pt x="264" y="2552"/>
                  </a:cubicBezTo>
                  <a:lnTo>
                    <a:pt x="34" y="2539"/>
                  </a:lnTo>
                  <a:close/>
                  <a:moveTo>
                    <a:pt x="275" y="2476"/>
                  </a:moveTo>
                  <a:lnTo>
                    <a:pt x="232" y="2510"/>
                  </a:lnTo>
                  <a:lnTo>
                    <a:pt x="718" y="48"/>
                  </a:lnTo>
                  <a:lnTo>
                    <a:pt x="750" y="90"/>
                  </a:lnTo>
                  <a:lnTo>
                    <a:pt x="520" y="77"/>
                  </a:lnTo>
                  <a:lnTo>
                    <a:pt x="563" y="43"/>
                  </a:lnTo>
                  <a:lnTo>
                    <a:pt x="77" y="2505"/>
                  </a:lnTo>
                  <a:lnTo>
                    <a:pt x="45" y="2463"/>
                  </a:lnTo>
                  <a:lnTo>
                    <a:pt x="275" y="2476"/>
                  </a:lnTo>
                  <a:close/>
                </a:path>
              </a:pathLst>
            </a:custGeom>
            <a:solidFill>
              <a:srgbClr val="002060"/>
            </a:solidFill>
            <a:ln w="0" cap="flat">
              <a:solidFill>
                <a:srgbClr val="00206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" name="Freeform 211">
              <a:extLst>
                <a:ext uri="{FF2B5EF4-FFF2-40B4-BE49-F238E27FC236}">
                  <a16:creationId xmlns:a16="http://schemas.microsoft.com/office/drawing/2014/main" id="{BAC1C9A8-EEAB-499E-994C-61CE4275176A}"/>
                </a:ext>
              </a:extLst>
            </p:cNvPr>
            <p:cNvSpPr>
              <a:spLocks/>
            </p:cNvSpPr>
            <p:nvPr/>
          </p:nvSpPr>
          <p:spPr bwMode="auto">
            <a:xfrm>
              <a:off x="437" y="2289"/>
              <a:ext cx="80" cy="91"/>
            </a:xfrm>
            <a:custGeom>
              <a:avLst/>
              <a:gdLst>
                <a:gd name="T0" fmla="*/ 276 w 2066"/>
                <a:gd name="T1" fmla="*/ 1966 h 2333"/>
                <a:gd name="T2" fmla="*/ 735 w 2066"/>
                <a:gd name="T3" fmla="*/ 1577 h 2333"/>
                <a:gd name="T4" fmla="*/ 878 w 2066"/>
                <a:gd name="T5" fmla="*/ 1373 h 2333"/>
                <a:gd name="T6" fmla="*/ 913 w 2066"/>
                <a:gd name="T7" fmla="*/ 1275 h 2333"/>
                <a:gd name="T8" fmla="*/ 920 w 2066"/>
                <a:gd name="T9" fmla="*/ 1160 h 2333"/>
                <a:gd name="T10" fmla="*/ 909 w 2066"/>
                <a:gd name="T11" fmla="*/ 723 h 2333"/>
                <a:gd name="T12" fmla="*/ 908 w 2066"/>
                <a:gd name="T13" fmla="*/ 566 h 2333"/>
                <a:gd name="T14" fmla="*/ 933 w 2066"/>
                <a:gd name="T15" fmla="*/ 417 h 2333"/>
                <a:gd name="T16" fmla="*/ 1001 w 2066"/>
                <a:gd name="T17" fmla="*/ 284 h 2333"/>
                <a:gd name="T18" fmla="*/ 1106 w 2066"/>
                <a:gd name="T19" fmla="*/ 187 h 2333"/>
                <a:gd name="T20" fmla="*/ 1225 w 2066"/>
                <a:gd name="T21" fmla="*/ 127 h 2333"/>
                <a:gd name="T22" fmla="*/ 1476 w 2066"/>
                <a:gd name="T23" fmla="*/ 67 h 2333"/>
                <a:gd name="T24" fmla="*/ 1812 w 2066"/>
                <a:gd name="T25" fmla="*/ 31 h 2333"/>
                <a:gd name="T26" fmla="*/ 1928 w 2066"/>
                <a:gd name="T27" fmla="*/ 14 h 2333"/>
                <a:gd name="T28" fmla="*/ 2052 w 2066"/>
                <a:gd name="T29" fmla="*/ 98 h 2333"/>
                <a:gd name="T30" fmla="*/ 1927 w 2066"/>
                <a:gd name="T31" fmla="*/ 250 h 2333"/>
                <a:gd name="T32" fmla="*/ 1811 w 2066"/>
                <a:gd name="T33" fmla="*/ 64 h 2333"/>
                <a:gd name="T34" fmla="*/ 1917 w 2066"/>
                <a:gd name="T35" fmla="*/ 23 h 2333"/>
                <a:gd name="T36" fmla="*/ 1829 w 2066"/>
                <a:gd name="T37" fmla="*/ 156 h 2333"/>
                <a:gd name="T38" fmla="*/ 1887 w 2066"/>
                <a:gd name="T39" fmla="*/ 244 h 2333"/>
                <a:gd name="T40" fmla="*/ 1725 w 2066"/>
                <a:gd name="T41" fmla="*/ 266 h 2333"/>
                <a:gd name="T42" fmla="*/ 1389 w 2066"/>
                <a:gd name="T43" fmla="*/ 307 h 2333"/>
                <a:gd name="T44" fmla="*/ 1294 w 2066"/>
                <a:gd name="T45" fmla="*/ 332 h 2333"/>
                <a:gd name="T46" fmla="*/ 1229 w 2066"/>
                <a:gd name="T47" fmla="*/ 358 h 2333"/>
                <a:gd name="T48" fmla="*/ 1183 w 2066"/>
                <a:gd name="T49" fmla="*/ 395 h 2333"/>
                <a:gd name="T50" fmla="*/ 1148 w 2066"/>
                <a:gd name="T51" fmla="*/ 461 h 2333"/>
                <a:gd name="T52" fmla="*/ 1133 w 2066"/>
                <a:gd name="T53" fmla="*/ 560 h 2333"/>
                <a:gd name="T54" fmla="*/ 1144 w 2066"/>
                <a:gd name="T55" fmla="*/ 849 h 2333"/>
                <a:gd name="T56" fmla="*/ 1130 w 2066"/>
                <a:gd name="T57" fmla="*/ 1309 h 2333"/>
                <a:gd name="T58" fmla="*/ 1074 w 2066"/>
                <a:gd name="T59" fmla="*/ 1467 h 2333"/>
                <a:gd name="T60" fmla="*/ 901 w 2066"/>
                <a:gd name="T61" fmla="*/ 1719 h 2333"/>
                <a:gd name="T62" fmla="*/ 653 w 2066"/>
                <a:gd name="T63" fmla="*/ 1948 h 2333"/>
                <a:gd name="T64" fmla="*/ 116 w 2066"/>
                <a:gd name="T65" fmla="*/ 2333 h 23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2066" h="2333">
                  <a:moveTo>
                    <a:pt x="0" y="2152"/>
                  </a:moveTo>
                  <a:lnTo>
                    <a:pt x="276" y="1966"/>
                  </a:lnTo>
                  <a:lnTo>
                    <a:pt x="525" y="1777"/>
                  </a:lnTo>
                  <a:lnTo>
                    <a:pt x="735" y="1577"/>
                  </a:lnTo>
                  <a:lnTo>
                    <a:pt x="718" y="1596"/>
                  </a:lnTo>
                  <a:lnTo>
                    <a:pt x="878" y="1373"/>
                  </a:lnTo>
                  <a:lnTo>
                    <a:pt x="865" y="1403"/>
                  </a:lnTo>
                  <a:lnTo>
                    <a:pt x="913" y="1275"/>
                  </a:lnTo>
                  <a:lnTo>
                    <a:pt x="903" y="1302"/>
                  </a:lnTo>
                  <a:lnTo>
                    <a:pt x="920" y="1160"/>
                  </a:lnTo>
                  <a:lnTo>
                    <a:pt x="917" y="874"/>
                  </a:lnTo>
                  <a:lnTo>
                    <a:pt x="909" y="723"/>
                  </a:lnTo>
                  <a:lnTo>
                    <a:pt x="906" y="586"/>
                  </a:lnTo>
                  <a:cubicBezTo>
                    <a:pt x="904" y="578"/>
                    <a:pt x="905" y="573"/>
                    <a:pt x="908" y="566"/>
                  </a:cubicBezTo>
                  <a:lnTo>
                    <a:pt x="925" y="447"/>
                  </a:lnTo>
                  <a:cubicBezTo>
                    <a:pt x="926" y="437"/>
                    <a:pt x="927" y="427"/>
                    <a:pt x="933" y="417"/>
                  </a:cubicBezTo>
                  <a:lnTo>
                    <a:pt x="975" y="321"/>
                  </a:lnTo>
                  <a:cubicBezTo>
                    <a:pt x="982" y="306"/>
                    <a:pt x="990" y="294"/>
                    <a:pt x="1001" y="284"/>
                  </a:cubicBezTo>
                  <a:lnTo>
                    <a:pt x="1074" y="211"/>
                  </a:lnTo>
                  <a:cubicBezTo>
                    <a:pt x="1083" y="199"/>
                    <a:pt x="1093" y="194"/>
                    <a:pt x="1106" y="187"/>
                  </a:cubicBezTo>
                  <a:lnTo>
                    <a:pt x="1204" y="136"/>
                  </a:lnTo>
                  <a:cubicBezTo>
                    <a:pt x="1209" y="132"/>
                    <a:pt x="1217" y="129"/>
                    <a:pt x="1225" y="127"/>
                  </a:cubicBezTo>
                  <a:lnTo>
                    <a:pt x="1341" y="92"/>
                  </a:lnTo>
                  <a:lnTo>
                    <a:pt x="1476" y="67"/>
                  </a:lnTo>
                  <a:lnTo>
                    <a:pt x="1718" y="42"/>
                  </a:lnTo>
                  <a:lnTo>
                    <a:pt x="1812" y="31"/>
                  </a:lnTo>
                  <a:lnTo>
                    <a:pt x="1875" y="25"/>
                  </a:lnTo>
                  <a:lnTo>
                    <a:pt x="1928" y="14"/>
                  </a:lnTo>
                  <a:cubicBezTo>
                    <a:pt x="1985" y="0"/>
                    <a:pt x="2036" y="36"/>
                    <a:pt x="2050" y="91"/>
                  </a:cubicBezTo>
                  <a:lnTo>
                    <a:pt x="2052" y="98"/>
                  </a:lnTo>
                  <a:cubicBezTo>
                    <a:pt x="2066" y="158"/>
                    <a:pt x="2027" y="220"/>
                    <a:pt x="1966" y="238"/>
                  </a:cubicBezTo>
                  <a:lnTo>
                    <a:pt x="1927" y="250"/>
                  </a:lnTo>
                  <a:lnTo>
                    <a:pt x="1880" y="269"/>
                  </a:lnTo>
                  <a:lnTo>
                    <a:pt x="1811" y="64"/>
                  </a:lnTo>
                  <a:lnTo>
                    <a:pt x="1879" y="35"/>
                  </a:lnTo>
                  <a:lnTo>
                    <a:pt x="1917" y="23"/>
                  </a:lnTo>
                  <a:lnTo>
                    <a:pt x="1831" y="164"/>
                  </a:lnTo>
                  <a:lnTo>
                    <a:pt x="1829" y="156"/>
                  </a:lnTo>
                  <a:lnTo>
                    <a:pt x="1951" y="233"/>
                  </a:lnTo>
                  <a:lnTo>
                    <a:pt x="1887" y="244"/>
                  </a:lnTo>
                  <a:lnTo>
                    <a:pt x="1819" y="255"/>
                  </a:lnTo>
                  <a:lnTo>
                    <a:pt x="1725" y="266"/>
                  </a:lnTo>
                  <a:lnTo>
                    <a:pt x="1498" y="286"/>
                  </a:lnTo>
                  <a:lnTo>
                    <a:pt x="1389" y="307"/>
                  </a:lnTo>
                  <a:lnTo>
                    <a:pt x="1273" y="342"/>
                  </a:lnTo>
                  <a:lnTo>
                    <a:pt x="1294" y="332"/>
                  </a:lnTo>
                  <a:lnTo>
                    <a:pt x="1196" y="382"/>
                  </a:lnTo>
                  <a:lnTo>
                    <a:pt x="1229" y="358"/>
                  </a:lnTo>
                  <a:lnTo>
                    <a:pt x="1156" y="431"/>
                  </a:lnTo>
                  <a:lnTo>
                    <a:pt x="1183" y="395"/>
                  </a:lnTo>
                  <a:lnTo>
                    <a:pt x="1140" y="491"/>
                  </a:lnTo>
                  <a:lnTo>
                    <a:pt x="1148" y="461"/>
                  </a:lnTo>
                  <a:lnTo>
                    <a:pt x="1131" y="580"/>
                  </a:lnTo>
                  <a:lnTo>
                    <a:pt x="1133" y="560"/>
                  </a:lnTo>
                  <a:lnTo>
                    <a:pt x="1137" y="697"/>
                  </a:lnTo>
                  <a:lnTo>
                    <a:pt x="1144" y="849"/>
                  </a:lnTo>
                  <a:lnTo>
                    <a:pt x="1147" y="1167"/>
                  </a:lnTo>
                  <a:lnTo>
                    <a:pt x="1130" y="1309"/>
                  </a:lnTo>
                  <a:cubicBezTo>
                    <a:pt x="1129" y="1318"/>
                    <a:pt x="1128" y="1328"/>
                    <a:pt x="1122" y="1338"/>
                  </a:cubicBezTo>
                  <a:lnTo>
                    <a:pt x="1074" y="1467"/>
                  </a:lnTo>
                  <a:cubicBezTo>
                    <a:pt x="1073" y="1477"/>
                    <a:pt x="1067" y="1486"/>
                    <a:pt x="1061" y="1496"/>
                  </a:cubicBezTo>
                  <a:lnTo>
                    <a:pt x="901" y="1719"/>
                  </a:lnTo>
                  <a:cubicBezTo>
                    <a:pt x="895" y="1724"/>
                    <a:pt x="890" y="1729"/>
                    <a:pt x="881" y="1736"/>
                  </a:cubicBezTo>
                  <a:lnTo>
                    <a:pt x="653" y="1948"/>
                  </a:lnTo>
                  <a:lnTo>
                    <a:pt x="392" y="2147"/>
                  </a:lnTo>
                  <a:lnTo>
                    <a:pt x="116" y="2333"/>
                  </a:lnTo>
                  <a:lnTo>
                    <a:pt x="0" y="2152"/>
                  </a:lnTo>
                  <a:close/>
                </a:path>
              </a:pathLst>
            </a:custGeom>
            <a:solidFill>
              <a:srgbClr val="FFC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" name="Freeform 212">
              <a:extLst>
                <a:ext uri="{FF2B5EF4-FFF2-40B4-BE49-F238E27FC236}">
                  <a16:creationId xmlns:a16="http://schemas.microsoft.com/office/drawing/2014/main" id="{77BA940D-6392-4617-AEF2-EC65063B2E7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35" y="2288"/>
              <a:ext cx="83" cy="93"/>
            </a:xfrm>
            <a:custGeom>
              <a:avLst/>
              <a:gdLst>
                <a:gd name="T0" fmla="*/ 543 w 2131"/>
                <a:gd name="T1" fmla="*/ 1774 h 2403"/>
                <a:gd name="T2" fmla="*/ 732 w 2131"/>
                <a:gd name="T3" fmla="*/ 1654 h 2403"/>
                <a:gd name="T4" fmla="*/ 940 w 2131"/>
                <a:gd name="T5" fmla="*/ 1442 h 2403"/>
                <a:gd name="T6" fmla="*/ 989 w 2131"/>
                <a:gd name="T7" fmla="*/ 1312 h 2403"/>
                <a:gd name="T8" fmla="*/ 918 w 2131"/>
                <a:gd name="T9" fmla="*/ 904 h 2403"/>
                <a:gd name="T10" fmla="*/ 928 w 2131"/>
                <a:gd name="T11" fmla="*/ 457 h 2403"/>
                <a:gd name="T12" fmla="*/ 1009 w 2131"/>
                <a:gd name="T13" fmla="*/ 291 h 2403"/>
                <a:gd name="T14" fmla="*/ 1128 w 2131"/>
                <a:gd name="T15" fmla="*/ 181 h 2403"/>
                <a:gd name="T16" fmla="*/ 1757 w 2131"/>
                <a:gd name="T17" fmla="*/ 31 h 2403"/>
                <a:gd name="T18" fmla="*/ 2010 w 2131"/>
                <a:gd name="T19" fmla="*/ 0 h 2403"/>
                <a:gd name="T20" fmla="*/ 2108 w 2131"/>
                <a:gd name="T21" fmla="*/ 62 h 2403"/>
                <a:gd name="T22" fmla="*/ 2131 w 2131"/>
                <a:gd name="T23" fmla="*/ 165 h 2403"/>
                <a:gd name="T24" fmla="*/ 2062 w 2131"/>
                <a:gd name="T25" fmla="*/ 277 h 2403"/>
                <a:gd name="T26" fmla="*/ 1883 w 2131"/>
                <a:gd name="T27" fmla="*/ 310 h 2403"/>
                <a:gd name="T28" fmla="*/ 1988 w 2131"/>
                <a:gd name="T29" fmla="*/ 25 h 2403"/>
                <a:gd name="T30" fmla="*/ 1831 w 2131"/>
                <a:gd name="T31" fmla="*/ 195 h 2403"/>
                <a:gd name="T32" fmla="*/ 1994 w 2131"/>
                <a:gd name="T33" fmla="*/ 297 h 2403"/>
                <a:gd name="T34" fmla="*/ 1433 w 2131"/>
                <a:gd name="T35" fmla="*/ 371 h 2403"/>
                <a:gd name="T36" fmla="*/ 1369 w 2131"/>
                <a:gd name="T37" fmla="*/ 341 h 2403"/>
                <a:gd name="T38" fmla="*/ 1247 w 2131"/>
                <a:gd name="T39" fmla="*/ 354 h 2403"/>
                <a:gd name="T40" fmla="*/ 1165 w 2131"/>
                <a:gd name="T41" fmla="*/ 437 h 2403"/>
                <a:gd name="T42" fmla="*/ 1166 w 2131"/>
                <a:gd name="T43" fmla="*/ 554 h 2403"/>
                <a:gd name="T44" fmla="*/ 1209 w 2131"/>
                <a:gd name="T45" fmla="*/ 608 h 2403"/>
                <a:gd name="T46" fmla="*/ 1211 w 2131"/>
                <a:gd name="T47" fmla="*/ 582 h 2403"/>
                <a:gd name="T48" fmla="*/ 1206 w 2131"/>
                <a:gd name="T49" fmla="*/ 1351 h 2403"/>
                <a:gd name="T50" fmla="*/ 1142 w 2131"/>
                <a:gd name="T51" fmla="*/ 1525 h 2403"/>
                <a:gd name="T52" fmla="*/ 718 w 2131"/>
                <a:gd name="T53" fmla="*/ 2001 h 2403"/>
                <a:gd name="T54" fmla="*/ 189 w 2131"/>
                <a:gd name="T55" fmla="*/ 2337 h 2403"/>
                <a:gd name="T56" fmla="*/ 917 w 2131"/>
                <a:gd name="T57" fmla="*/ 1717 h 2403"/>
                <a:gd name="T58" fmla="*/ 1077 w 2131"/>
                <a:gd name="T59" fmla="*/ 1483 h 2403"/>
                <a:gd name="T60" fmla="*/ 1148 w 2131"/>
                <a:gd name="T61" fmla="*/ 1197 h 2403"/>
                <a:gd name="T62" fmla="*/ 1209 w 2131"/>
                <a:gd name="T63" fmla="*/ 607 h 2403"/>
                <a:gd name="T64" fmla="*/ 1144 w 2131"/>
                <a:gd name="T65" fmla="*/ 505 h 2403"/>
                <a:gd name="T66" fmla="*/ 1242 w 2131"/>
                <a:gd name="T67" fmla="*/ 359 h 2403"/>
                <a:gd name="T68" fmla="*/ 1348 w 2131"/>
                <a:gd name="T69" fmla="*/ 393 h 2403"/>
                <a:gd name="T70" fmla="*/ 1763 w 2131"/>
                <a:gd name="T71" fmla="*/ 255 h 2403"/>
                <a:gd name="T72" fmla="*/ 1846 w 2131"/>
                <a:gd name="T73" fmla="*/ 215 h 2403"/>
                <a:gd name="T74" fmla="*/ 1965 w 2131"/>
                <a:gd name="T75" fmla="*/ 86 h 2403"/>
                <a:gd name="T76" fmla="*/ 1908 w 2131"/>
                <a:gd name="T77" fmla="*/ 260 h 2403"/>
                <a:gd name="T78" fmla="*/ 2019 w 2131"/>
                <a:gd name="T79" fmla="*/ 219 h 2403"/>
                <a:gd name="T80" fmla="*/ 2053 w 2131"/>
                <a:gd name="T81" fmla="*/ 129 h 2403"/>
                <a:gd name="T82" fmla="*/ 2044 w 2131"/>
                <a:gd name="T83" fmla="*/ 109 h 2403"/>
                <a:gd name="T84" fmla="*/ 1966 w 2131"/>
                <a:gd name="T85" fmla="*/ 79 h 2403"/>
                <a:gd name="T86" fmla="*/ 1519 w 2131"/>
                <a:gd name="T87" fmla="*/ 131 h 2403"/>
                <a:gd name="T88" fmla="*/ 1146 w 2131"/>
                <a:gd name="T89" fmla="*/ 256 h 2403"/>
                <a:gd name="T90" fmla="*/ 1046 w 2131"/>
                <a:gd name="T91" fmla="*/ 367 h 2403"/>
                <a:gd name="T92" fmla="*/ 1003 w 2131"/>
                <a:gd name="T93" fmla="*/ 475 h 2403"/>
                <a:gd name="T94" fmla="*/ 998 w 2131"/>
                <a:gd name="T95" fmla="*/ 1188 h 2403"/>
                <a:gd name="T96" fmla="*/ 941 w 2131"/>
                <a:gd name="T97" fmla="*/ 1440 h 2403"/>
                <a:gd name="T98" fmla="*/ 730 w 2131"/>
                <a:gd name="T99" fmla="*/ 1599 h 2403"/>
                <a:gd name="T100" fmla="*/ 59 w 2131"/>
                <a:gd name="T101" fmla="*/ 2209 h 24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2131" h="2403">
                  <a:moveTo>
                    <a:pt x="6" y="2201"/>
                  </a:moveTo>
                  <a:cubicBezTo>
                    <a:pt x="1" y="2193"/>
                    <a:pt x="0" y="2182"/>
                    <a:pt x="2" y="2172"/>
                  </a:cubicBezTo>
                  <a:cubicBezTo>
                    <a:pt x="5" y="2162"/>
                    <a:pt x="11" y="2153"/>
                    <a:pt x="20" y="2148"/>
                  </a:cubicBezTo>
                  <a:lnTo>
                    <a:pt x="296" y="1962"/>
                  </a:lnTo>
                  <a:lnTo>
                    <a:pt x="543" y="1774"/>
                  </a:lnTo>
                  <a:lnTo>
                    <a:pt x="749" y="1577"/>
                  </a:lnTo>
                  <a:cubicBezTo>
                    <a:pt x="765" y="1562"/>
                    <a:pt x="788" y="1561"/>
                    <a:pt x="802" y="1575"/>
                  </a:cubicBezTo>
                  <a:cubicBezTo>
                    <a:pt x="817" y="1588"/>
                    <a:pt x="817" y="1611"/>
                    <a:pt x="802" y="1627"/>
                  </a:cubicBezTo>
                  <a:lnTo>
                    <a:pt x="785" y="1646"/>
                  </a:lnTo>
                  <a:cubicBezTo>
                    <a:pt x="771" y="1662"/>
                    <a:pt x="748" y="1665"/>
                    <a:pt x="732" y="1654"/>
                  </a:cubicBezTo>
                  <a:cubicBezTo>
                    <a:pt x="717" y="1642"/>
                    <a:pt x="714" y="1619"/>
                    <a:pt x="727" y="1602"/>
                  </a:cubicBezTo>
                  <a:lnTo>
                    <a:pt x="887" y="1379"/>
                  </a:lnTo>
                  <a:cubicBezTo>
                    <a:pt x="898" y="1363"/>
                    <a:pt x="920" y="1357"/>
                    <a:pt x="937" y="1365"/>
                  </a:cubicBezTo>
                  <a:cubicBezTo>
                    <a:pt x="954" y="1373"/>
                    <a:pt x="961" y="1393"/>
                    <a:pt x="953" y="1412"/>
                  </a:cubicBezTo>
                  <a:lnTo>
                    <a:pt x="940" y="1442"/>
                  </a:lnTo>
                  <a:cubicBezTo>
                    <a:pt x="931" y="1461"/>
                    <a:pt x="909" y="1472"/>
                    <a:pt x="890" y="1466"/>
                  </a:cubicBezTo>
                  <a:cubicBezTo>
                    <a:pt x="870" y="1460"/>
                    <a:pt x="861" y="1439"/>
                    <a:pt x="868" y="1419"/>
                  </a:cubicBezTo>
                  <a:lnTo>
                    <a:pt x="916" y="1291"/>
                  </a:lnTo>
                  <a:cubicBezTo>
                    <a:pt x="924" y="1271"/>
                    <a:pt x="946" y="1259"/>
                    <a:pt x="966" y="1265"/>
                  </a:cubicBezTo>
                  <a:cubicBezTo>
                    <a:pt x="986" y="1270"/>
                    <a:pt x="996" y="1291"/>
                    <a:pt x="989" y="1312"/>
                  </a:cubicBezTo>
                  <a:lnTo>
                    <a:pt x="979" y="1339"/>
                  </a:lnTo>
                  <a:cubicBezTo>
                    <a:pt x="972" y="1357"/>
                    <a:pt x="952" y="1369"/>
                    <a:pt x="933" y="1366"/>
                  </a:cubicBezTo>
                  <a:cubicBezTo>
                    <a:pt x="914" y="1363"/>
                    <a:pt x="902" y="1347"/>
                    <a:pt x="904" y="1327"/>
                  </a:cubicBezTo>
                  <a:lnTo>
                    <a:pt x="921" y="1185"/>
                  </a:lnTo>
                  <a:lnTo>
                    <a:pt x="918" y="904"/>
                  </a:lnTo>
                  <a:lnTo>
                    <a:pt x="910" y="755"/>
                  </a:lnTo>
                  <a:lnTo>
                    <a:pt x="907" y="617"/>
                  </a:lnTo>
                  <a:lnTo>
                    <a:pt x="909" y="592"/>
                  </a:lnTo>
                  <a:lnTo>
                    <a:pt x="926" y="471"/>
                  </a:lnTo>
                  <a:lnTo>
                    <a:pt x="928" y="457"/>
                  </a:lnTo>
                  <a:cubicBezTo>
                    <a:pt x="929" y="454"/>
                    <a:pt x="930" y="450"/>
                    <a:pt x="931" y="447"/>
                  </a:cubicBezTo>
                  <a:lnTo>
                    <a:pt x="937" y="432"/>
                  </a:lnTo>
                  <a:lnTo>
                    <a:pt x="979" y="335"/>
                  </a:lnTo>
                  <a:cubicBezTo>
                    <a:pt x="980" y="332"/>
                    <a:pt x="982" y="330"/>
                    <a:pt x="983" y="328"/>
                  </a:cubicBezTo>
                  <a:lnTo>
                    <a:pt x="1009" y="291"/>
                  </a:lnTo>
                  <a:cubicBezTo>
                    <a:pt x="1011" y="289"/>
                    <a:pt x="1012" y="287"/>
                    <a:pt x="1014" y="285"/>
                  </a:cubicBezTo>
                  <a:lnTo>
                    <a:pt x="1087" y="212"/>
                  </a:lnTo>
                  <a:lnTo>
                    <a:pt x="1103" y="197"/>
                  </a:lnTo>
                  <a:cubicBezTo>
                    <a:pt x="1106" y="195"/>
                    <a:pt x="1108" y="193"/>
                    <a:pt x="1111" y="191"/>
                  </a:cubicBezTo>
                  <a:lnTo>
                    <a:pt x="1128" y="181"/>
                  </a:lnTo>
                  <a:lnTo>
                    <a:pt x="1228" y="129"/>
                  </a:lnTo>
                  <a:lnTo>
                    <a:pt x="1252" y="119"/>
                  </a:lnTo>
                  <a:lnTo>
                    <a:pt x="1372" y="82"/>
                  </a:lnTo>
                  <a:lnTo>
                    <a:pt x="1512" y="56"/>
                  </a:lnTo>
                  <a:lnTo>
                    <a:pt x="1757" y="31"/>
                  </a:lnTo>
                  <a:lnTo>
                    <a:pt x="1850" y="20"/>
                  </a:lnTo>
                  <a:lnTo>
                    <a:pt x="1914" y="13"/>
                  </a:lnTo>
                  <a:lnTo>
                    <a:pt x="1963" y="3"/>
                  </a:lnTo>
                  <a:cubicBezTo>
                    <a:pt x="1965" y="3"/>
                    <a:pt x="1967" y="2"/>
                    <a:pt x="1969" y="2"/>
                  </a:cubicBezTo>
                  <a:lnTo>
                    <a:pt x="2010" y="0"/>
                  </a:lnTo>
                  <a:cubicBezTo>
                    <a:pt x="2016" y="0"/>
                    <a:pt x="2021" y="1"/>
                    <a:pt x="2026" y="3"/>
                  </a:cubicBezTo>
                  <a:lnTo>
                    <a:pt x="2062" y="18"/>
                  </a:lnTo>
                  <a:cubicBezTo>
                    <a:pt x="2066" y="20"/>
                    <a:pt x="2070" y="22"/>
                    <a:pt x="2073" y="25"/>
                  </a:cubicBezTo>
                  <a:lnTo>
                    <a:pt x="2101" y="52"/>
                  </a:lnTo>
                  <a:cubicBezTo>
                    <a:pt x="2104" y="55"/>
                    <a:pt x="2106" y="58"/>
                    <a:pt x="2108" y="62"/>
                  </a:cubicBezTo>
                  <a:lnTo>
                    <a:pt x="2125" y="99"/>
                  </a:lnTo>
                  <a:cubicBezTo>
                    <a:pt x="2126" y="101"/>
                    <a:pt x="2126" y="102"/>
                    <a:pt x="2127" y="104"/>
                  </a:cubicBezTo>
                  <a:lnTo>
                    <a:pt x="2129" y="111"/>
                  </a:lnTo>
                  <a:cubicBezTo>
                    <a:pt x="2130" y="114"/>
                    <a:pt x="2130" y="117"/>
                    <a:pt x="2130" y="120"/>
                  </a:cubicBezTo>
                  <a:lnTo>
                    <a:pt x="2131" y="165"/>
                  </a:lnTo>
                  <a:cubicBezTo>
                    <a:pt x="2131" y="170"/>
                    <a:pt x="2130" y="175"/>
                    <a:pt x="2128" y="180"/>
                  </a:cubicBezTo>
                  <a:lnTo>
                    <a:pt x="2112" y="221"/>
                  </a:lnTo>
                  <a:cubicBezTo>
                    <a:pt x="2110" y="226"/>
                    <a:pt x="2108" y="231"/>
                    <a:pt x="2104" y="235"/>
                  </a:cubicBezTo>
                  <a:lnTo>
                    <a:pt x="2074" y="268"/>
                  </a:lnTo>
                  <a:cubicBezTo>
                    <a:pt x="2071" y="271"/>
                    <a:pt x="2066" y="275"/>
                    <a:pt x="2062" y="277"/>
                  </a:cubicBezTo>
                  <a:lnTo>
                    <a:pt x="2021" y="298"/>
                  </a:lnTo>
                  <a:cubicBezTo>
                    <a:pt x="2019" y="299"/>
                    <a:pt x="2016" y="300"/>
                    <a:pt x="2014" y="301"/>
                  </a:cubicBezTo>
                  <a:lnTo>
                    <a:pt x="1975" y="313"/>
                  </a:lnTo>
                  <a:lnTo>
                    <a:pt x="1931" y="331"/>
                  </a:lnTo>
                  <a:cubicBezTo>
                    <a:pt x="1911" y="339"/>
                    <a:pt x="1889" y="330"/>
                    <a:pt x="1883" y="310"/>
                  </a:cubicBezTo>
                  <a:lnTo>
                    <a:pt x="1814" y="105"/>
                  </a:lnTo>
                  <a:cubicBezTo>
                    <a:pt x="1807" y="86"/>
                    <a:pt x="1818" y="64"/>
                    <a:pt x="1838" y="56"/>
                  </a:cubicBezTo>
                  <a:lnTo>
                    <a:pt x="1906" y="27"/>
                  </a:lnTo>
                  <a:lnTo>
                    <a:pt x="1948" y="13"/>
                  </a:lnTo>
                  <a:cubicBezTo>
                    <a:pt x="1963" y="8"/>
                    <a:pt x="1979" y="13"/>
                    <a:pt x="1988" y="25"/>
                  </a:cubicBezTo>
                  <a:cubicBezTo>
                    <a:pt x="1997" y="37"/>
                    <a:pt x="1997" y="53"/>
                    <a:pt x="1989" y="67"/>
                  </a:cubicBezTo>
                  <a:lnTo>
                    <a:pt x="1903" y="208"/>
                  </a:lnTo>
                  <a:cubicBezTo>
                    <a:pt x="1895" y="222"/>
                    <a:pt x="1879" y="230"/>
                    <a:pt x="1864" y="229"/>
                  </a:cubicBezTo>
                  <a:cubicBezTo>
                    <a:pt x="1849" y="227"/>
                    <a:pt x="1837" y="217"/>
                    <a:pt x="1833" y="203"/>
                  </a:cubicBezTo>
                  <a:lnTo>
                    <a:pt x="1831" y="195"/>
                  </a:lnTo>
                  <a:cubicBezTo>
                    <a:pt x="1827" y="180"/>
                    <a:pt x="1834" y="163"/>
                    <a:pt x="1847" y="153"/>
                  </a:cubicBezTo>
                  <a:cubicBezTo>
                    <a:pt x="1861" y="143"/>
                    <a:pt x="1878" y="142"/>
                    <a:pt x="1891" y="150"/>
                  </a:cubicBezTo>
                  <a:lnTo>
                    <a:pt x="2013" y="227"/>
                  </a:lnTo>
                  <a:cubicBezTo>
                    <a:pt x="2026" y="235"/>
                    <a:pt x="2032" y="251"/>
                    <a:pt x="2028" y="266"/>
                  </a:cubicBezTo>
                  <a:cubicBezTo>
                    <a:pt x="2023" y="282"/>
                    <a:pt x="2010" y="294"/>
                    <a:pt x="1994" y="297"/>
                  </a:cubicBezTo>
                  <a:lnTo>
                    <a:pt x="1930" y="308"/>
                  </a:lnTo>
                  <a:lnTo>
                    <a:pt x="1861" y="319"/>
                  </a:lnTo>
                  <a:lnTo>
                    <a:pt x="1766" y="330"/>
                  </a:lnTo>
                  <a:lnTo>
                    <a:pt x="1537" y="350"/>
                  </a:lnTo>
                  <a:lnTo>
                    <a:pt x="1433" y="371"/>
                  </a:lnTo>
                  <a:lnTo>
                    <a:pt x="1321" y="405"/>
                  </a:lnTo>
                  <a:cubicBezTo>
                    <a:pt x="1301" y="411"/>
                    <a:pt x="1281" y="401"/>
                    <a:pt x="1276" y="383"/>
                  </a:cubicBezTo>
                  <a:cubicBezTo>
                    <a:pt x="1270" y="364"/>
                    <a:pt x="1280" y="343"/>
                    <a:pt x="1298" y="334"/>
                  </a:cubicBezTo>
                  <a:lnTo>
                    <a:pt x="1319" y="324"/>
                  </a:lnTo>
                  <a:cubicBezTo>
                    <a:pt x="1339" y="315"/>
                    <a:pt x="1361" y="322"/>
                    <a:pt x="1369" y="341"/>
                  </a:cubicBezTo>
                  <a:cubicBezTo>
                    <a:pt x="1377" y="359"/>
                    <a:pt x="1368" y="382"/>
                    <a:pt x="1349" y="392"/>
                  </a:cubicBezTo>
                  <a:lnTo>
                    <a:pt x="1251" y="442"/>
                  </a:lnTo>
                  <a:cubicBezTo>
                    <a:pt x="1232" y="451"/>
                    <a:pt x="1211" y="446"/>
                    <a:pt x="1201" y="429"/>
                  </a:cubicBezTo>
                  <a:cubicBezTo>
                    <a:pt x="1192" y="413"/>
                    <a:pt x="1198" y="391"/>
                    <a:pt x="1214" y="378"/>
                  </a:cubicBezTo>
                  <a:lnTo>
                    <a:pt x="1247" y="354"/>
                  </a:lnTo>
                  <a:cubicBezTo>
                    <a:pt x="1264" y="342"/>
                    <a:pt x="1287" y="344"/>
                    <a:pt x="1299" y="358"/>
                  </a:cubicBezTo>
                  <a:cubicBezTo>
                    <a:pt x="1311" y="373"/>
                    <a:pt x="1309" y="395"/>
                    <a:pt x="1295" y="410"/>
                  </a:cubicBezTo>
                  <a:lnTo>
                    <a:pt x="1222" y="483"/>
                  </a:lnTo>
                  <a:cubicBezTo>
                    <a:pt x="1207" y="498"/>
                    <a:pt x="1184" y="500"/>
                    <a:pt x="1169" y="488"/>
                  </a:cubicBezTo>
                  <a:cubicBezTo>
                    <a:pt x="1154" y="475"/>
                    <a:pt x="1153" y="453"/>
                    <a:pt x="1165" y="437"/>
                  </a:cubicBezTo>
                  <a:lnTo>
                    <a:pt x="1192" y="401"/>
                  </a:lnTo>
                  <a:cubicBezTo>
                    <a:pt x="1204" y="384"/>
                    <a:pt x="1226" y="379"/>
                    <a:pt x="1243" y="387"/>
                  </a:cubicBezTo>
                  <a:cubicBezTo>
                    <a:pt x="1259" y="396"/>
                    <a:pt x="1266" y="416"/>
                    <a:pt x="1258" y="434"/>
                  </a:cubicBezTo>
                  <a:lnTo>
                    <a:pt x="1215" y="530"/>
                  </a:lnTo>
                  <a:cubicBezTo>
                    <a:pt x="1206" y="549"/>
                    <a:pt x="1185" y="559"/>
                    <a:pt x="1166" y="554"/>
                  </a:cubicBezTo>
                  <a:cubicBezTo>
                    <a:pt x="1147" y="549"/>
                    <a:pt x="1137" y="530"/>
                    <a:pt x="1142" y="511"/>
                  </a:cubicBezTo>
                  <a:lnTo>
                    <a:pt x="1150" y="481"/>
                  </a:lnTo>
                  <a:cubicBezTo>
                    <a:pt x="1156" y="461"/>
                    <a:pt x="1175" y="447"/>
                    <a:pt x="1195" y="450"/>
                  </a:cubicBezTo>
                  <a:cubicBezTo>
                    <a:pt x="1215" y="452"/>
                    <a:pt x="1229" y="469"/>
                    <a:pt x="1226" y="489"/>
                  </a:cubicBezTo>
                  <a:lnTo>
                    <a:pt x="1209" y="608"/>
                  </a:lnTo>
                  <a:cubicBezTo>
                    <a:pt x="1206" y="629"/>
                    <a:pt x="1187" y="645"/>
                    <a:pt x="1166" y="645"/>
                  </a:cubicBezTo>
                  <a:cubicBezTo>
                    <a:pt x="1145" y="644"/>
                    <a:pt x="1130" y="627"/>
                    <a:pt x="1132" y="606"/>
                  </a:cubicBezTo>
                  <a:lnTo>
                    <a:pt x="1134" y="586"/>
                  </a:lnTo>
                  <a:cubicBezTo>
                    <a:pt x="1136" y="566"/>
                    <a:pt x="1153" y="549"/>
                    <a:pt x="1174" y="548"/>
                  </a:cubicBezTo>
                  <a:cubicBezTo>
                    <a:pt x="1194" y="547"/>
                    <a:pt x="1210" y="562"/>
                    <a:pt x="1211" y="582"/>
                  </a:cubicBezTo>
                  <a:lnTo>
                    <a:pt x="1215" y="719"/>
                  </a:lnTo>
                  <a:lnTo>
                    <a:pt x="1222" y="870"/>
                  </a:lnTo>
                  <a:lnTo>
                    <a:pt x="1225" y="1190"/>
                  </a:lnTo>
                  <a:lnTo>
                    <a:pt x="1208" y="1337"/>
                  </a:lnTo>
                  <a:lnTo>
                    <a:pt x="1206" y="1351"/>
                  </a:lnTo>
                  <a:cubicBezTo>
                    <a:pt x="1205" y="1355"/>
                    <a:pt x="1204" y="1358"/>
                    <a:pt x="1203" y="1361"/>
                  </a:cubicBezTo>
                  <a:lnTo>
                    <a:pt x="1197" y="1376"/>
                  </a:lnTo>
                  <a:lnTo>
                    <a:pt x="1150" y="1504"/>
                  </a:lnTo>
                  <a:lnTo>
                    <a:pt x="1145" y="1517"/>
                  </a:lnTo>
                  <a:cubicBezTo>
                    <a:pt x="1144" y="1520"/>
                    <a:pt x="1143" y="1523"/>
                    <a:pt x="1142" y="1525"/>
                  </a:cubicBezTo>
                  <a:lnTo>
                    <a:pt x="1134" y="1539"/>
                  </a:lnTo>
                  <a:lnTo>
                    <a:pt x="971" y="1766"/>
                  </a:lnTo>
                  <a:cubicBezTo>
                    <a:pt x="969" y="1769"/>
                    <a:pt x="967" y="1771"/>
                    <a:pt x="964" y="1773"/>
                  </a:cubicBezTo>
                  <a:lnTo>
                    <a:pt x="944" y="1790"/>
                  </a:lnTo>
                  <a:lnTo>
                    <a:pt x="718" y="2001"/>
                  </a:lnTo>
                  <a:lnTo>
                    <a:pt x="453" y="2203"/>
                  </a:lnTo>
                  <a:lnTo>
                    <a:pt x="175" y="2390"/>
                  </a:lnTo>
                  <a:cubicBezTo>
                    <a:pt x="157" y="2403"/>
                    <a:pt x="133" y="2399"/>
                    <a:pt x="122" y="2382"/>
                  </a:cubicBezTo>
                  <a:lnTo>
                    <a:pt x="6" y="2201"/>
                  </a:lnTo>
                  <a:close/>
                  <a:moveTo>
                    <a:pt x="189" y="2337"/>
                  </a:moveTo>
                  <a:lnTo>
                    <a:pt x="136" y="2329"/>
                  </a:lnTo>
                  <a:lnTo>
                    <a:pt x="410" y="2144"/>
                  </a:lnTo>
                  <a:lnTo>
                    <a:pt x="667" y="1948"/>
                  </a:lnTo>
                  <a:lnTo>
                    <a:pt x="897" y="1734"/>
                  </a:lnTo>
                  <a:lnTo>
                    <a:pt x="917" y="1717"/>
                  </a:lnTo>
                  <a:lnTo>
                    <a:pt x="910" y="1725"/>
                  </a:lnTo>
                  <a:lnTo>
                    <a:pt x="1067" y="1506"/>
                  </a:lnTo>
                  <a:lnTo>
                    <a:pt x="1075" y="1492"/>
                  </a:lnTo>
                  <a:lnTo>
                    <a:pt x="1072" y="1499"/>
                  </a:lnTo>
                  <a:lnTo>
                    <a:pt x="1077" y="1483"/>
                  </a:lnTo>
                  <a:lnTo>
                    <a:pt x="1126" y="1353"/>
                  </a:lnTo>
                  <a:lnTo>
                    <a:pt x="1132" y="1338"/>
                  </a:lnTo>
                  <a:lnTo>
                    <a:pt x="1129" y="1347"/>
                  </a:lnTo>
                  <a:lnTo>
                    <a:pt x="1131" y="1334"/>
                  </a:lnTo>
                  <a:lnTo>
                    <a:pt x="1148" y="1197"/>
                  </a:lnTo>
                  <a:lnTo>
                    <a:pt x="1145" y="881"/>
                  </a:lnTo>
                  <a:lnTo>
                    <a:pt x="1138" y="728"/>
                  </a:lnTo>
                  <a:lnTo>
                    <a:pt x="1134" y="591"/>
                  </a:lnTo>
                  <a:lnTo>
                    <a:pt x="1211" y="587"/>
                  </a:lnTo>
                  <a:lnTo>
                    <a:pt x="1209" y="607"/>
                  </a:lnTo>
                  <a:lnTo>
                    <a:pt x="1132" y="604"/>
                  </a:lnTo>
                  <a:lnTo>
                    <a:pt x="1149" y="485"/>
                  </a:lnTo>
                  <a:lnTo>
                    <a:pt x="1225" y="494"/>
                  </a:lnTo>
                  <a:lnTo>
                    <a:pt x="1217" y="524"/>
                  </a:lnTo>
                  <a:lnTo>
                    <a:pt x="1144" y="505"/>
                  </a:lnTo>
                  <a:lnTo>
                    <a:pt x="1187" y="409"/>
                  </a:lnTo>
                  <a:lnTo>
                    <a:pt x="1253" y="442"/>
                  </a:lnTo>
                  <a:lnTo>
                    <a:pt x="1226" y="478"/>
                  </a:lnTo>
                  <a:lnTo>
                    <a:pt x="1169" y="432"/>
                  </a:lnTo>
                  <a:lnTo>
                    <a:pt x="1242" y="359"/>
                  </a:lnTo>
                  <a:lnTo>
                    <a:pt x="1289" y="415"/>
                  </a:lnTo>
                  <a:lnTo>
                    <a:pt x="1256" y="439"/>
                  </a:lnTo>
                  <a:lnTo>
                    <a:pt x="1220" y="375"/>
                  </a:lnTo>
                  <a:lnTo>
                    <a:pt x="1318" y="325"/>
                  </a:lnTo>
                  <a:lnTo>
                    <a:pt x="1348" y="393"/>
                  </a:lnTo>
                  <a:lnTo>
                    <a:pt x="1327" y="403"/>
                  </a:lnTo>
                  <a:lnTo>
                    <a:pt x="1304" y="332"/>
                  </a:lnTo>
                  <a:lnTo>
                    <a:pt x="1424" y="296"/>
                  </a:lnTo>
                  <a:lnTo>
                    <a:pt x="1537" y="274"/>
                  </a:lnTo>
                  <a:lnTo>
                    <a:pt x="1763" y="255"/>
                  </a:lnTo>
                  <a:lnTo>
                    <a:pt x="1856" y="244"/>
                  </a:lnTo>
                  <a:lnTo>
                    <a:pt x="1923" y="233"/>
                  </a:lnTo>
                  <a:lnTo>
                    <a:pt x="1987" y="222"/>
                  </a:lnTo>
                  <a:lnTo>
                    <a:pt x="1968" y="292"/>
                  </a:lnTo>
                  <a:lnTo>
                    <a:pt x="1846" y="215"/>
                  </a:lnTo>
                  <a:lnTo>
                    <a:pt x="1906" y="170"/>
                  </a:lnTo>
                  <a:lnTo>
                    <a:pt x="1908" y="178"/>
                  </a:lnTo>
                  <a:lnTo>
                    <a:pt x="1838" y="173"/>
                  </a:lnTo>
                  <a:lnTo>
                    <a:pt x="1924" y="32"/>
                  </a:lnTo>
                  <a:lnTo>
                    <a:pt x="1965" y="86"/>
                  </a:lnTo>
                  <a:lnTo>
                    <a:pt x="1931" y="96"/>
                  </a:lnTo>
                  <a:lnTo>
                    <a:pt x="1863" y="125"/>
                  </a:lnTo>
                  <a:lnTo>
                    <a:pt x="1887" y="76"/>
                  </a:lnTo>
                  <a:lnTo>
                    <a:pt x="1956" y="281"/>
                  </a:lnTo>
                  <a:lnTo>
                    <a:pt x="1908" y="260"/>
                  </a:lnTo>
                  <a:lnTo>
                    <a:pt x="1958" y="240"/>
                  </a:lnTo>
                  <a:lnTo>
                    <a:pt x="1997" y="228"/>
                  </a:lnTo>
                  <a:lnTo>
                    <a:pt x="1990" y="231"/>
                  </a:lnTo>
                  <a:lnTo>
                    <a:pt x="2031" y="210"/>
                  </a:lnTo>
                  <a:lnTo>
                    <a:pt x="2019" y="219"/>
                  </a:lnTo>
                  <a:lnTo>
                    <a:pt x="2049" y="186"/>
                  </a:lnTo>
                  <a:lnTo>
                    <a:pt x="2041" y="200"/>
                  </a:lnTo>
                  <a:lnTo>
                    <a:pt x="2057" y="159"/>
                  </a:lnTo>
                  <a:lnTo>
                    <a:pt x="2054" y="174"/>
                  </a:lnTo>
                  <a:lnTo>
                    <a:pt x="2053" y="129"/>
                  </a:lnTo>
                  <a:lnTo>
                    <a:pt x="2054" y="138"/>
                  </a:lnTo>
                  <a:lnTo>
                    <a:pt x="2052" y="131"/>
                  </a:lnTo>
                  <a:lnTo>
                    <a:pt x="2054" y="136"/>
                  </a:lnTo>
                  <a:lnTo>
                    <a:pt x="2037" y="99"/>
                  </a:lnTo>
                  <a:lnTo>
                    <a:pt x="2044" y="109"/>
                  </a:lnTo>
                  <a:lnTo>
                    <a:pt x="2016" y="82"/>
                  </a:lnTo>
                  <a:lnTo>
                    <a:pt x="2027" y="89"/>
                  </a:lnTo>
                  <a:lnTo>
                    <a:pt x="1991" y="74"/>
                  </a:lnTo>
                  <a:lnTo>
                    <a:pt x="2007" y="77"/>
                  </a:lnTo>
                  <a:lnTo>
                    <a:pt x="1966" y="79"/>
                  </a:lnTo>
                  <a:lnTo>
                    <a:pt x="1972" y="78"/>
                  </a:lnTo>
                  <a:lnTo>
                    <a:pt x="1915" y="89"/>
                  </a:lnTo>
                  <a:lnTo>
                    <a:pt x="1853" y="95"/>
                  </a:lnTo>
                  <a:lnTo>
                    <a:pt x="1758" y="106"/>
                  </a:lnTo>
                  <a:lnTo>
                    <a:pt x="1519" y="131"/>
                  </a:lnTo>
                  <a:lnTo>
                    <a:pt x="1389" y="155"/>
                  </a:lnTo>
                  <a:lnTo>
                    <a:pt x="1277" y="188"/>
                  </a:lnTo>
                  <a:lnTo>
                    <a:pt x="1259" y="196"/>
                  </a:lnTo>
                  <a:lnTo>
                    <a:pt x="1163" y="246"/>
                  </a:lnTo>
                  <a:lnTo>
                    <a:pt x="1146" y="256"/>
                  </a:lnTo>
                  <a:lnTo>
                    <a:pt x="1154" y="250"/>
                  </a:lnTo>
                  <a:lnTo>
                    <a:pt x="1140" y="263"/>
                  </a:lnTo>
                  <a:lnTo>
                    <a:pt x="1067" y="336"/>
                  </a:lnTo>
                  <a:lnTo>
                    <a:pt x="1072" y="330"/>
                  </a:lnTo>
                  <a:lnTo>
                    <a:pt x="1046" y="367"/>
                  </a:lnTo>
                  <a:lnTo>
                    <a:pt x="1050" y="360"/>
                  </a:lnTo>
                  <a:lnTo>
                    <a:pt x="1008" y="455"/>
                  </a:lnTo>
                  <a:lnTo>
                    <a:pt x="1002" y="470"/>
                  </a:lnTo>
                  <a:lnTo>
                    <a:pt x="1005" y="460"/>
                  </a:lnTo>
                  <a:lnTo>
                    <a:pt x="1003" y="475"/>
                  </a:lnTo>
                  <a:lnTo>
                    <a:pt x="986" y="593"/>
                  </a:lnTo>
                  <a:lnTo>
                    <a:pt x="984" y="608"/>
                  </a:lnTo>
                  <a:lnTo>
                    <a:pt x="987" y="744"/>
                  </a:lnTo>
                  <a:lnTo>
                    <a:pt x="995" y="897"/>
                  </a:lnTo>
                  <a:lnTo>
                    <a:pt x="998" y="1188"/>
                  </a:lnTo>
                  <a:lnTo>
                    <a:pt x="981" y="1330"/>
                  </a:lnTo>
                  <a:lnTo>
                    <a:pt x="906" y="1318"/>
                  </a:lnTo>
                  <a:lnTo>
                    <a:pt x="916" y="1291"/>
                  </a:lnTo>
                  <a:lnTo>
                    <a:pt x="989" y="1312"/>
                  </a:lnTo>
                  <a:lnTo>
                    <a:pt x="941" y="1440"/>
                  </a:lnTo>
                  <a:lnTo>
                    <a:pt x="869" y="1417"/>
                  </a:lnTo>
                  <a:lnTo>
                    <a:pt x="882" y="1387"/>
                  </a:lnTo>
                  <a:lnTo>
                    <a:pt x="948" y="1420"/>
                  </a:lnTo>
                  <a:lnTo>
                    <a:pt x="788" y="1643"/>
                  </a:lnTo>
                  <a:lnTo>
                    <a:pt x="730" y="1599"/>
                  </a:lnTo>
                  <a:lnTo>
                    <a:pt x="747" y="1580"/>
                  </a:lnTo>
                  <a:lnTo>
                    <a:pt x="800" y="1630"/>
                  </a:lnTo>
                  <a:lnTo>
                    <a:pt x="586" y="1833"/>
                  </a:lnTo>
                  <a:lnTo>
                    <a:pt x="335" y="2023"/>
                  </a:lnTo>
                  <a:lnTo>
                    <a:pt x="59" y="2209"/>
                  </a:lnTo>
                  <a:lnTo>
                    <a:pt x="73" y="2156"/>
                  </a:lnTo>
                  <a:lnTo>
                    <a:pt x="189" y="2337"/>
                  </a:lnTo>
                  <a:close/>
                </a:path>
              </a:pathLst>
            </a:custGeom>
            <a:solidFill>
              <a:srgbClr val="FFC000"/>
            </a:solidFill>
            <a:ln w="0" cap="flat">
              <a:solidFill>
                <a:srgbClr val="FFC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" name="Freeform 213">
              <a:extLst>
                <a:ext uri="{FF2B5EF4-FFF2-40B4-BE49-F238E27FC236}">
                  <a16:creationId xmlns:a16="http://schemas.microsoft.com/office/drawing/2014/main" id="{9B088026-ADAE-40C1-9F36-799D841A1CD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93" y="2161"/>
              <a:ext cx="328" cy="314"/>
            </a:xfrm>
            <a:custGeom>
              <a:avLst/>
              <a:gdLst>
                <a:gd name="T0" fmla="*/ 9 w 328"/>
                <a:gd name="T1" fmla="*/ 261 h 314"/>
                <a:gd name="T2" fmla="*/ 1 w 328"/>
                <a:gd name="T3" fmla="*/ 229 h 314"/>
                <a:gd name="T4" fmla="*/ 2 w 328"/>
                <a:gd name="T5" fmla="*/ 193 h 314"/>
                <a:gd name="T6" fmla="*/ 13 w 328"/>
                <a:gd name="T7" fmla="*/ 156 h 314"/>
                <a:gd name="T8" fmla="*/ 32 w 328"/>
                <a:gd name="T9" fmla="*/ 118 h 314"/>
                <a:gd name="T10" fmla="*/ 60 w 328"/>
                <a:gd name="T11" fmla="*/ 83 h 314"/>
                <a:gd name="T12" fmla="*/ 95 w 328"/>
                <a:gd name="T13" fmla="*/ 50 h 314"/>
                <a:gd name="T14" fmla="*/ 134 w 328"/>
                <a:gd name="T15" fmla="*/ 25 h 314"/>
                <a:gd name="T16" fmla="*/ 173 w 328"/>
                <a:gd name="T17" fmla="*/ 9 h 314"/>
                <a:gd name="T18" fmla="*/ 212 w 328"/>
                <a:gd name="T19" fmla="*/ 1 h 314"/>
                <a:gd name="T20" fmla="*/ 248 w 328"/>
                <a:gd name="T21" fmla="*/ 2 h 314"/>
                <a:gd name="T22" fmla="*/ 280 w 328"/>
                <a:gd name="T23" fmla="*/ 13 h 314"/>
                <a:gd name="T24" fmla="*/ 305 w 328"/>
                <a:gd name="T25" fmla="*/ 32 h 314"/>
                <a:gd name="T26" fmla="*/ 322 w 328"/>
                <a:gd name="T27" fmla="*/ 60 h 314"/>
                <a:gd name="T28" fmla="*/ 328 w 328"/>
                <a:gd name="T29" fmla="*/ 93 h 314"/>
                <a:gd name="T30" fmla="*/ 325 w 328"/>
                <a:gd name="T31" fmla="*/ 129 h 314"/>
                <a:gd name="T32" fmla="*/ 313 w 328"/>
                <a:gd name="T33" fmla="*/ 166 h 314"/>
                <a:gd name="T34" fmla="*/ 292 w 328"/>
                <a:gd name="T35" fmla="*/ 203 h 314"/>
                <a:gd name="T36" fmla="*/ 262 w 328"/>
                <a:gd name="T37" fmla="*/ 239 h 314"/>
                <a:gd name="T38" fmla="*/ 226 w 328"/>
                <a:gd name="T39" fmla="*/ 270 h 314"/>
                <a:gd name="T40" fmla="*/ 187 w 328"/>
                <a:gd name="T41" fmla="*/ 293 h 314"/>
                <a:gd name="T42" fmla="*/ 147 w 328"/>
                <a:gd name="T43" fmla="*/ 308 h 314"/>
                <a:gd name="T44" fmla="*/ 109 w 328"/>
                <a:gd name="T45" fmla="*/ 314 h 314"/>
                <a:gd name="T46" fmla="*/ 74 w 328"/>
                <a:gd name="T47" fmla="*/ 311 h 314"/>
                <a:gd name="T48" fmla="*/ 43 w 328"/>
                <a:gd name="T49" fmla="*/ 299 h 314"/>
                <a:gd name="T50" fmla="*/ 30 w 328"/>
                <a:gd name="T51" fmla="*/ 285 h 314"/>
                <a:gd name="T52" fmla="*/ 56 w 328"/>
                <a:gd name="T53" fmla="*/ 302 h 314"/>
                <a:gd name="T54" fmla="*/ 88 w 328"/>
                <a:gd name="T55" fmla="*/ 310 h 314"/>
                <a:gd name="T56" fmla="*/ 124 w 328"/>
                <a:gd name="T57" fmla="*/ 310 h 314"/>
                <a:gd name="T58" fmla="*/ 162 w 328"/>
                <a:gd name="T59" fmla="*/ 300 h 314"/>
                <a:gd name="T60" fmla="*/ 201 w 328"/>
                <a:gd name="T61" fmla="*/ 282 h 314"/>
                <a:gd name="T62" fmla="*/ 239 w 328"/>
                <a:gd name="T63" fmla="*/ 256 h 314"/>
                <a:gd name="T64" fmla="*/ 273 w 328"/>
                <a:gd name="T65" fmla="*/ 223 h 314"/>
                <a:gd name="T66" fmla="*/ 298 w 328"/>
                <a:gd name="T67" fmla="*/ 187 h 314"/>
                <a:gd name="T68" fmla="*/ 316 w 328"/>
                <a:gd name="T69" fmla="*/ 150 h 314"/>
                <a:gd name="T70" fmla="*/ 324 w 328"/>
                <a:gd name="T71" fmla="*/ 114 h 314"/>
                <a:gd name="T72" fmla="*/ 324 w 328"/>
                <a:gd name="T73" fmla="*/ 80 h 314"/>
                <a:gd name="T74" fmla="*/ 314 w 328"/>
                <a:gd name="T75" fmla="*/ 50 h 314"/>
                <a:gd name="T76" fmla="*/ 294 w 328"/>
                <a:gd name="T77" fmla="*/ 26 h 314"/>
                <a:gd name="T78" fmla="*/ 266 w 328"/>
                <a:gd name="T79" fmla="*/ 10 h 314"/>
                <a:gd name="T80" fmla="*/ 234 w 328"/>
                <a:gd name="T81" fmla="*/ 4 h 314"/>
                <a:gd name="T82" fmla="*/ 197 w 328"/>
                <a:gd name="T83" fmla="*/ 6 h 314"/>
                <a:gd name="T84" fmla="*/ 158 w 328"/>
                <a:gd name="T85" fmla="*/ 17 h 314"/>
                <a:gd name="T86" fmla="*/ 119 w 328"/>
                <a:gd name="T87" fmla="*/ 37 h 314"/>
                <a:gd name="T88" fmla="*/ 82 w 328"/>
                <a:gd name="T89" fmla="*/ 65 h 314"/>
                <a:gd name="T90" fmla="*/ 50 w 328"/>
                <a:gd name="T91" fmla="*/ 98 h 314"/>
                <a:gd name="T92" fmla="*/ 26 w 328"/>
                <a:gd name="T93" fmla="*/ 135 h 314"/>
                <a:gd name="T94" fmla="*/ 10 w 328"/>
                <a:gd name="T95" fmla="*/ 171 h 314"/>
                <a:gd name="T96" fmla="*/ 3 w 328"/>
                <a:gd name="T97" fmla="*/ 208 h 314"/>
                <a:gd name="T98" fmla="*/ 6 w 328"/>
                <a:gd name="T99" fmla="*/ 241 h 314"/>
                <a:gd name="T100" fmla="*/ 18 w 328"/>
                <a:gd name="T101" fmla="*/ 270 h 3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328" h="314">
                  <a:moveTo>
                    <a:pt x="23" y="282"/>
                  </a:moveTo>
                  <a:lnTo>
                    <a:pt x="19" y="277"/>
                  </a:lnTo>
                  <a:lnTo>
                    <a:pt x="15" y="272"/>
                  </a:lnTo>
                  <a:lnTo>
                    <a:pt x="12" y="266"/>
                  </a:lnTo>
                  <a:lnTo>
                    <a:pt x="9" y="261"/>
                  </a:lnTo>
                  <a:lnTo>
                    <a:pt x="7" y="255"/>
                  </a:lnTo>
                  <a:lnTo>
                    <a:pt x="5" y="248"/>
                  </a:lnTo>
                  <a:lnTo>
                    <a:pt x="3" y="242"/>
                  </a:lnTo>
                  <a:lnTo>
                    <a:pt x="2" y="235"/>
                  </a:lnTo>
                  <a:lnTo>
                    <a:pt x="1" y="229"/>
                  </a:lnTo>
                  <a:lnTo>
                    <a:pt x="0" y="222"/>
                  </a:lnTo>
                  <a:lnTo>
                    <a:pt x="0" y="215"/>
                  </a:lnTo>
                  <a:lnTo>
                    <a:pt x="0" y="208"/>
                  </a:lnTo>
                  <a:lnTo>
                    <a:pt x="1" y="200"/>
                  </a:lnTo>
                  <a:lnTo>
                    <a:pt x="2" y="193"/>
                  </a:lnTo>
                  <a:lnTo>
                    <a:pt x="3" y="186"/>
                  </a:lnTo>
                  <a:lnTo>
                    <a:pt x="5" y="178"/>
                  </a:lnTo>
                  <a:lnTo>
                    <a:pt x="7" y="171"/>
                  </a:lnTo>
                  <a:lnTo>
                    <a:pt x="10" y="163"/>
                  </a:lnTo>
                  <a:lnTo>
                    <a:pt x="13" y="156"/>
                  </a:lnTo>
                  <a:lnTo>
                    <a:pt x="16" y="148"/>
                  </a:lnTo>
                  <a:lnTo>
                    <a:pt x="19" y="141"/>
                  </a:lnTo>
                  <a:lnTo>
                    <a:pt x="23" y="133"/>
                  </a:lnTo>
                  <a:lnTo>
                    <a:pt x="27" y="126"/>
                  </a:lnTo>
                  <a:lnTo>
                    <a:pt x="32" y="118"/>
                  </a:lnTo>
                  <a:lnTo>
                    <a:pt x="37" y="111"/>
                  </a:lnTo>
                  <a:lnTo>
                    <a:pt x="42" y="104"/>
                  </a:lnTo>
                  <a:lnTo>
                    <a:pt x="48" y="97"/>
                  </a:lnTo>
                  <a:lnTo>
                    <a:pt x="54" y="90"/>
                  </a:lnTo>
                  <a:lnTo>
                    <a:pt x="60" y="83"/>
                  </a:lnTo>
                  <a:lnTo>
                    <a:pt x="66" y="76"/>
                  </a:lnTo>
                  <a:lnTo>
                    <a:pt x="73" y="69"/>
                  </a:lnTo>
                  <a:lnTo>
                    <a:pt x="80" y="63"/>
                  </a:lnTo>
                  <a:lnTo>
                    <a:pt x="88" y="56"/>
                  </a:lnTo>
                  <a:lnTo>
                    <a:pt x="95" y="50"/>
                  </a:lnTo>
                  <a:lnTo>
                    <a:pt x="103" y="45"/>
                  </a:lnTo>
                  <a:lnTo>
                    <a:pt x="110" y="39"/>
                  </a:lnTo>
                  <a:lnTo>
                    <a:pt x="118" y="34"/>
                  </a:lnTo>
                  <a:lnTo>
                    <a:pt x="126" y="30"/>
                  </a:lnTo>
                  <a:lnTo>
                    <a:pt x="134" y="25"/>
                  </a:lnTo>
                  <a:lnTo>
                    <a:pt x="142" y="21"/>
                  </a:lnTo>
                  <a:lnTo>
                    <a:pt x="149" y="18"/>
                  </a:lnTo>
                  <a:lnTo>
                    <a:pt x="157" y="14"/>
                  </a:lnTo>
                  <a:lnTo>
                    <a:pt x="165" y="11"/>
                  </a:lnTo>
                  <a:lnTo>
                    <a:pt x="173" y="9"/>
                  </a:lnTo>
                  <a:lnTo>
                    <a:pt x="181" y="7"/>
                  </a:lnTo>
                  <a:lnTo>
                    <a:pt x="189" y="5"/>
                  </a:lnTo>
                  <a:lnTo>
                    <a:pt x="197" y="3"/>
                  </a:lnTo>
                  <a:lnTo>
                    <a:pt x="204" y="2"/>
                  </a:lnTo>
                  <a:lnTo>
                    <a:pt x="212" y="1"/>
                  </a:lnTo>
                  <a:lnTo>
                    <a:pt x="219" y="1"/>
                  </a:lnTo>
                  <a:lnTo>
                    <a:pt x="227" y="0"/>
                  </a:lnTo>
                  <a:lnTo>
                    <a:pt x="234" y="1"/>
                  </a:lnTo>
                  <a:lnTo>
                    <a:pt x="241" y="1"/>
                  </a:lnTo>
                  <a:lnTo>
                    <a:pt x="248" y="2"/>
                  </a:lnTo>
                  <a:lnTo>
                    <a:pt x="255" y="4"/>
                  </a:lnTo>
                  <a:lnTo>
                    <a:pt x="261" y="5"/>
                  </a:lnTo>
                  <a:lnTo>
                    <a:pt x="268" y="7"/>
                  </a:lnTo>
                  <a:lnTo>
                    <a:pt x="274" y="10"/>
                  </a:lnTo>
                  <a:lnTo>
                    <a:pt x="280" y="13"/>
                  </a:lnTo>
                  <a:lnTo>
                    <a:pt x="285" y="16"/>
                  </a:lnTo>
                  <a:lnTo>
                    <a:pt x="291" y="19"/>
                  </a:lnTo>
                  <a:lnTo>
                    <a:pt x="296" y="23"/>
                  </a:lnTo>
                  <a:lnTo>
                    <a:pt x="301" y="28"/>
                  </a:lnTo>
                  <a:lnTo>
                    <a:pt x="305" y="32"/>
                  </a:lnTo>
                  <a:lnTo>
                    <a:pt x="309" y="37"/>
                  </a:lnTo>
                  <a:lnTo>
                    <a:pt x="313" y="43"/>
                  </a:lnTo>
                  <a:lnTo>
                    <a:pt x="316" y="48"/>
                  </a:lnTo>
                  <a:lnTo>
                    <a:pt x="319" y="54"/>
                  </a:lnTo>
                  <a:lnTo>
                    <a:pt x="322" y="60"/>
                  </a:lnTo>
                  <a:lnTo>
                    <a:pt x="324" y="66"/>
                  </a:lnTo>
                  <a:lnTo>
                    <a:pt x="326" y="73"/>
                  </a:lnTo>
                  <a:lnTo>
                    <a:pt x="327" y="79"/>
                  </a:lnTo>
                  <a:lnTo>
                    <a:pt x="328" y="86"/>
                  </a:lnTo>
                  <a:lnTo>
                    <a:pt x="328" y="93"/>
                  </a:lnTo>
                  <a:lnTo>
                    <a:pt x="328" y="100"/>
                  </a:lnTo>
                  <a:lnTo>
                    <a:pt x="328" y="107"/>
                  </a:lnTo>
                  <a:lnTo>
                    <a:pt x="327" y="114"/>
                  </a:lnTo>
                  <a:lnTo>
                    <a:pt x="326" y="121"/>
                  </a:lnTo>
                  <a:lnTo>
                    <a:pt x="325" y="129"/>
                  </a:lnTo>
                  <a:lnTo>
                    <a:pt x="323" y="136"/>
                  </a:lnTo>
                  <a:lnTo>
                    <a:pt x="321" y="144"/>
                  </a:lnTo>
                  <a:lnTo>
                    <a:pt x="319" y="151"/>
                  </a:lnTo>
                  <a:lnTo>
                    <a:pt x="316" y="159"/>
                  </a:lnTo>
                  <a:lnTo>
                    <a:pt x="313" y="166"/>
                  </a:lnTo>
                  <a:lnTo>
                    <a:pt x="309" y="174"/>
                  </a:lnTo>
                  <a:lnTo>
                    <a:pt x="305" y="181"/>
                  </a:lnTo>
                  <a:lnTo>
                    <a:pt x="301" y="189"/>
                  </a:lnTo>
                  <a:lnTo>
                    <a:pt x="296" y="196"/>
                  </a:lnTo>
                  <a:lnTo>
                    <a:pt x="292" y="203"/>
                  </a:lnTo>
                  <a:lnTo>
                    <a:pt x="286" y="211"/>
                  </a:lnTo>
                  <a:lnTo>
                    <a:pt x="281" y="218"/>
                  </a:lnTo>
                  <a:lnTo>
                    <a:pt x="275" y="225"/>
                  </a:lnTo>
                  <a:lnTo>
                    <a:pt x="269" y="232"/>
                  </a:lnTo>
                  <a:lnTo>
                    <a:pt x="262" y="239"/>
                  </a:lnTo>
                  <a:lnTo>
                    <a:pt x="255" y="246"/>
                  </a:lnTo>
                  <a:lnTo>
                    <a:pt x="248" y="252"/>
                  </a:lnTo>
                  <a:lnTo>
                    <a:pt x="241" y="258"/>
                  </a:lnTo>
                  <a:lnTo>
                    <a:pt x="233" y="264"/>
                  </a:lnTo>
                  <a:lnTo>
                    <a:pt x="226" y="270"/>
                  </a:lnTo>
                  <a:lnTo>
                    <a:pt x="218" y="275"/>
                  </a:lnTo>
                  <a:lnTo>
                    <a:pt x="210" y="280"/>
                  </a:lnTo>
                  <a:lnTo>
                    <a:pt x="203" y="285"/>
                  </a:lnTo>
                  <a:lnTo>
                    <a:pt x="195" y="289"/>
                  </a:lnTo>
                  <a:lnTo>
                    <a:pt x="187" y="293"/>
                  </a:lnTo>
                  <a:lnTo>
                    <a:pt x="179" y="297"/>
                  </a:lnTo>
                  <a:lnTo>
                    <a:pt x="171" y="300"/>
                  </a:lnTo>
                  <a:lnTo>
                    <a:pt x="163" y="303"/>
                  </a:lnTo>
                  <a:lnTo>
                    <a:pt x="155" y="306"/>
                  </a:lnTo>
                  <a:lnTo>
                    <a:pt x="147" y="308"/>
                  </a:lnTo>
                  <a:lnTo>
                    <a:pt x="140" y="310"/>
                  </a:lnTo>
                  <a:lnTo>
                    <a:pt x="132" y="311"/>
                  </a:lnTo>
                  <a:lnTo>
                    <a:pt x="124" y="313"/>
                  </a:lnTo>
                  <a:lnTo>
                    <a:pt x="117" y="313"/>
                  </a:lnTo>
                  <a:lnTo>
                    <a:pt x="109" y="314"/>
                  </a:lnTo>
                  <a:lnTo>
                    <a:pt x="102" y="314"/>
                  </a:lnTo>
                  <a:lnTo>
                    <a:pt x="95" y="314"/>
                  </a:lnTo>
                  <a:lnTo>
                    <a:pt x="87" y="313"/>
                  </a:lnTo>
                  <a:lnTo>
                    <a:pt x="81" y="312"/>
                  </a:lnTo>
                  <a:lnTo>
                    <a:pt x="74" y="311"/>
                  </a:lnTo>
                  <a:lnTo>
                    <a:pt x="67" y="309"/>
                  </a:lnTo>
                  <a:lnTo>
                    <a:pt x="61" y="307"/>
                  </a:lnTo>
                  <a:lnTo>
                    <a:pt x="55" y="305"/>
                  </a:lnTo>
                  <a:lnTo>
                    <a:pt x="49" y="302"/>
                  </a:lnTo>
                  <a:lnTo>
                    <a:pt x="43" y="299"/>
                  </a:lnTo>
                  <a:lnTo>
                    <a:pt x="38" y="295"/>
                  </a:lnTo>
                  <a:lnTo>
                    <a:pt x="33" y="291"/>
                  </a:lnTo>
                  <a:lnTo>
                    <a:pt x="28" y="287"/>
                  </a:lnTo>
                  <a:lnTo>
                    <a:pt x="23" y="282"/>
                  </a:lnTo>
                  <a:close/>
                  <a:moveTo>
                    <a:pt x="30" y="285"/>
                  </a:moveTo>
                  <a:lnTo>
                    <a:pt x="35" y="289"/>
                  </a:lnTo>
                  <a:lnTo>
                    <a:pt x="40" y="293"/>
                  </a:lnTo>
                  <a:lnTo>
                    <a:pt x="45" y="296"/>
                  </a:lnTo>
                  <a:lnTo>
                    <a:pt x="50" y="299"/>
                  </a:lnTo>
                  <a:lnTo>
                    <a:pt x="56" y="302"/>
                  </a:lnTo>
                  <a:lnTo>
                    <a:pt x="62" y="304"/>
                  </a:lnTo>
                  <a:lnTo>
                    <a:pt x="68" y="306"/>
                  </a:lnTo>
                  <a:lnTo>
                    <a:pt x="75" y="308"/>
                  </a:lnTo>
                  <a:lnTo>
                    <a:pt x="81" y="309"/>
                  </a:lnTo>
                  <a:lnTo>
                    <a:pt x="88" y="310"/>
                  </a:lnTo>
                  <a:lnTo>
                    <a:pt x="95" y="311"/>
                  </a:lnTo>
                  <a:lnTo>
                    <a:pt x="102" y="311"/>
                  </a:lnTo>
                  <a:lnTo>
                    <a:pt x="109" y="311"/>
                  </a:lnTo>
                  <a:lnTo>
                    <a:pt x="117" y="311"/>
                  </a:lnTo>
                  <a:lnTo>
                    <a:pt x="124" y="310"/>
                  </a:lnTo>
                  <a:lnTo>
                    <a:pt x="132" y="309"/>
                  </a:lnTo>
                  <a:lnTo>
                    <a:pt x="139" y="307"/>
                  </a:lnTo>
                  <a:lnTo>
                    <a:pt x="147" y="305"/>
                  </a:lnTo>
                  <a:lnTo>
                    <a:pt x="155" y="303"/>
                  </a:lnTo>
                  <a:lnTo>
                    <a:pt x="162" y="300"/>
                  </a:lnTo>
                  <a:lnTo>
                    <a:pt x="170" y="297"/>
                  </a:lnTo>
                  <a:lnTo>
                    <a:pt x="178" y="294"/>
                  </a:lnTo>
                  <a:lnTo>
                    <a:pt x="186" y="291"/>
                  </a:lnTo>
                  <a:lnTo>
                    <a:pt x="194" y="287"/>
                  </a:lnTo>
                  <a:lnTo>
                    <a:pt x="201" y="282"/>
                  </a:lnTo>
                  <a:lnTo>
                    <a:pt x="209" y="278"/>
                  </a:lnTo>
                  <a:lnTo>
                    <a:pt x="217" y="273"/>
                  </a:lnTo>
                  <a:lnTo>
                    <a:pt x="224" y="268"/>
                  </a:lnTo>
                  <a:lnTo>
                    <a:pt x="232" y="262"/>
                  </a:lnTo>
                  <a:lnTo>
                    <a:pt x="239" y="256"/>
                  </a:lnTo>
                  <a:lnTo>
                    <a:pt x="246" y="250"/>
                  </a:lnTo>
                  <a:lnTo>
                    <a:pt x="253" y="244"/>
                  </a:lnTo>
                  <a:lnTo>
                    <a:pt x="260" y="237"/>
                  </a:lnTo>
                  <a:lnTo>
                    <a:pt x="266" y="230"/>
                  </a:lnTo>
                  <a:lnTo>
                    <a:pt x="273" y="223"/>
                  </a:lnTo>
                  <a:lnTo>
                    <a:pt x="278" y="216"/>
                  </a:lnTo>
                  <a:lnTo>
                    <a:pt x="284" y="209"/>
                  </a:lnTo>
                  <a:lnTo>
                    <a:pt x="289" y="202"/>
                  </a:lnTo>
                  <a:lnTo>
                    <a:pt x="294" y="195"/>
                  </a:lnTo>
                  <a:lnTo>
                    <a:pt x="298" y="187"/>
                  </a:lnTo>
                  <a:lnTo>
                    <a:pt x="303" y="180"/>
                  </a:lnTo>
                  <a:lnTo>
                    <a:pt x="306" y="173"/>
                  </a:lnTo>
                  <a:lnTo>
                    <a:pt x="310" y="165"/>
                  </a:lnTo>
                  <a:lnTo>
                    <a:pt x="313" y="158"/>
                  </a:lnTo>
                  <a:lnTo>
                    <a:pt x="316" y="150"/>
                  </a:lnTo>
                  <a:lnTo>
                    <a:pt x="318" y="143"/>
                  </a:lnTo>
                  <a:lnTo>
                    <a:pt x="320" y="136"/>
                  </a:lnTo>
                  <a:lnTo>
                    <a:pt x="322" y="128"/>
                  </a:lnTo>
                  <a:lnTo>
                    <a:pt x="323" y="121"/>
                  </a:lnTo>
                  <a:lnTo>
                    <a:pt x="324" y="114"/>
                  </a:lnTo>
                  <a:lnTo>
                    <a:pt x="325" y="107"/>
                  </a:lnTo>
                  <a:lnTo>
                    <a:pt x="325" y="100"/>
                  </a:lnTo>
                  <a:lnTo>
                    <a:pt x="325" y="93"/>
                  </a:lnTo>
                  <a:lnTo>
                    <a:pt x="325" y="87"/>
                  </a:lnTo>
                  <a:lnTo>
                    <a:pt x="324" y="80"/>
                  </a:lnTo>
                  <a:lnTo>
                    <a:pt x="323" y="74"/>
                  </a:lnTo>
                  <a:lnTo>
                    <a:pt x="321" y="67"/>
                  </a:lnTo>
                  <a:lnTo>
                    <a:pt x="319" y="61"/>
                  </a:lnTo>
                  <a:lnTo>
                    <a:pt x="317" y="56"/>
                  </a:lnTo>
                  <a:lnTo>
                    <a:pt x="314" y="50"/>
                  </a:lnTo>
                  <a:lnTo>
                    <a:pt x="311" y="45"/>
                  </a:lnTo>
                  <a:lnTo>
                    <a:pt x="307" y="39"/>
                  </a:lnTo>
                  <a:lnTo>
                    <a:pt x="303" y="34"/>
                  </a:lnTo>
                  <a:lnTo>
                    <a:pt x="298" y="30"/>
                  </a:lnTo>
                  <a:lnTo>
                    <a:pt x="294" y="26"/>
                  </a:lnTo>
                  <a:lnTo>
                    <a:pt x="289" y="22"/>
                  </a:lnTo>
                  <a:lnTo>
                    <a:pt x="284" y="18"/>
                  </a:lnTo>
                  <a:lnTo>
                    <a:pt x="278" y="15"/>
                  </a:lnTo>
                  <a:lnTo>
                    <a:pt x="272" y="12"/>
                  </a:lnTo>
                  <a:lnTo>
                    <a:pt x="266" y="10"/>
                  </a:lnTo>
                  <a:lnTo>
                    <a:pt x="260" y="8"/>
                  </a:lnTo>
                  <a:lnTo>
                    <a:pt x="254" y="6"/>
                  </a:lnTo>
                  <a:lnTo>
                    <a:pt x="247" y="5"/>
                  </a:lnTo>
                  <a:lnTo>
                    <a:pt x="240" y="4"/>
                  </a:lnTo>
                  <a:lnTo>
                    <a:pt x="234" y="4"/>
                  </a:lnTo>
                  <a:lnTo>
                    <a:pt x="226" y="3"/>
                  </a:lnTo>
                  <a:lnTo>
                    <a:pt x="219" y="4"/>
                  </a:lnTo>
                  <a:lnTo>
                    <a:pt x="212" y="4"/>
                  </a:lnTo>
                  <a:lnTo>
                    <a:pt x="204" y="5"/>
                  </a:lnTo>
                  <a:lnTo>
                    <a:pt x="197" y="6"/>
                  </a:lnTo>
                  <a:lnTo>
                    <a:pt x="189" y="8"/>
                  </a:lnTo>
                  <a:lnTo>
                    <a:pt x="182" y="9"/>
                  </a:lnTo>
                  <a:lnTo>
                    <a:pt x="174" y="12"/>
                  </a:lnTo>
                  <a:lnTo>
                    <a:pt x="166" y="14"/>
                  </a:lnTo>
                  <a:lnTo>
                    <a:pt x="158" y="17"/>
                  </a:lnTo>
                  <a:lnTo>
                    <a:pt x="150" y="20"/>
                  </a:lnTo>
                  <a:lnTo>
                    <a:pt x="143" y="24"/>
                  </a:lnTo>
                  <a:lnTo>
                    <a:pt x="135" y="28"/>
                  </a:lnTo>
                  <a:lnTo>
                    <a:pt x="127" y="32"/>
                  </a:lnTo>
                  <a:lnTo>
                    <a:pt x="119" y="37"/>
                  </a:lnTo>
                  <a:lnTo>
                    <a:pt x="112" y="42"/>
                  </a:lnTo>
                  <a:lnTo>
                    <a:pt x="104" y="47"/>
                  </a:lnTo>
                  <a:lnTo>
                    <a:pt x="97" y="53"/>
                  </a:lnTo>
                  <a:lnTo>
                    <a:pt x="89" y="58"/>
                  </a:lnTo>
                  <a:lnTo>
                    <a:pt x="82" y="65"/>
                  </a:lnTo>
                  <a:lnTo>
                    <a:pt x="75" y="71"/>
                  </a:lnTo>
                  <a:lnTo>
                    <a:pt x="68" y="78"/>
                  </a:lnTo>
                  <a:lnTo>
                    <a:pt x="62" y="84"/>
                  </a:lnTo>
                  <a:lnTo>
                    <a:pt x="56" y="91"/>
                  </a:lnTo>
                  <a:lnTo>
                    <a:pt x="50" y="98"/>
                  </a:lnTo>
                  <a:lnTo>
                    <a:pt x="44" y="105"/>
                  </a:lnTo>
                  <a:lnTo>
                    <a:pt x="39" y="113"/>
                  </a:lnTo>
                  <a:lnTo>
                    <a:pt x="35" y="120"/>
                  </a:lnTo>
                  <a:lnTo>
                    <a:pt x="30" y="127"/>
                  </a:lnTo>
                  <a:lnTo>
                    <a:pt x="26" y="135"/>
                  </a:lnTo>
                  <a:lnTo>
                    <a:pt x="22" y="142"/>
                  </a:lnTo>
                  <a:lnTo>
                    <a:pt x="19" y="149"/>
                  </a:lnTo>
                  <a:lnTo>
                    <a:pt x="15" y="157"/>
                  </a:lnTo>
                  <a:lnTo>
                    <a:pt x="13" y="164"/>
                  </a:lnTo>
                  <a:lnTo>
                    <a:pt x="10" y="171"/>
                  </a:lnTo>
                  <a:lnTo>
                    <a:pt x="8" y="179"/>
                  </a:lnTo>
                  <a:lnTo>
                    <a:pt x="6" y="186"/>
                  </a:lnTo>
                  <a:lnTo>
                    <a:pt x="5" y="193"/>
                  </a:lnTo>
                  <a:lnTo>
                    <a:pt x="4" y="201"/>
                  </a:lnTo>
                  <a:lnTo>
                    <a:pt x="3" y="208"/>
                  </a:lnTo>
                  <a:lnTo>
                    <a:pt x="3" y="214"/>
                  </a:lnTo>
                  <a:lnTo>
                    <a:pt x="3" y="221"/>
                  </a:lnTo>
                  <a:lnTo>
                    <a:pt x="4" y="228"/>
                  </a:lnTo>
                  <a:lnTo>
                    <a:pt x="4" y="235"/>
                  </a:lnTo>
                  <a:lnTo>
                    <a:pt x="6" y="241"/>
                  </a:lnTo>
                  <a:lnTo>
                    <a:pt x="7" y="247"/>
                  </a:lnTo>
                  <a:lnTo>
                    <a:pt x="9" y="253"/>
                  </a:lnTo>
                  <a:lnTo>
                    <a:pt x="12" y="259"/>
                  </a:lnTo>
                  <a:lnTo>
                    <a:pt x="15" y="265"/>
                  </a:lnTo>
                  <a:lnTo>
                    <a:pt x="18" y="270"/>
                  </a:lnTo>
                  <a:lnTo>
                    <a:pt x="21" y="275"/>
                  </a:lnTo>
                  <a:lnTo>
                    <a:pt x="26" y="280"/>
                  </a:lnTo>
                  <a:lnTo>
                    <a:pt x="30" y="285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" name="Freeform 214">
              <a:extLst>
                <a:ext uri="{FF2B5EF4-FFF2-40B4-BE49-F238E27FC236}">
                  <a16:creationId xmlns:a16="http://schemas.microsoft.com/office/drawing/2014/main" id="{5D374C13-B3D0-4B8E-A40A-1F8A2D0430A1}"/>
                </a:ext>
              </a:extLst>
            </p:cNvPr>
            <p:cNvSpPr>
              <a:spLocks/>
            </p:cNvSpPr>
            <p:nvPr/>
          </p:nvSpPr>
          <p:spPr bwMode="auto">
            <a:xfrm>
              <a:off x="643" y="2196"/>
              <a:ext cx="36" cy="125"/>
            </a:xfrm>
            <a:custGeom>
              <a:avLst/>
              <a:gdLst>
                <a:gd name="T0" fmla="*/ 656 w 904"/>
                <a:gd name="T1" fmla="*/ 413 h 3204"/>
                <a:gd name="T2" fmla="*/ 445 w 904"/>
                <a:gd name="T3" fmla="*/ 1040 h 3204"/>
                <a:gd name="T4" fmla="*/ 423 w 904"/>
                <a:gd name="T5" fmla="*/ 1322 h 3204"/>
                <a:gd name="T6" fmla="*/ 448 w 904"/>
                <a:gd name="T7" fmla="*/ 1431 h 3204"/>
                <a:gd name="T8" fmla="*/ 500 w 904"/>
                <a:gd name="T9" fmla="*/ 1545 h 3204"/>
                <a:gd name="T10" fmla="*/ 661 w 904"/>
                <a:gd name="T11" fmla="*/ 1790 h 3204"/>
                <a:gd name="T12" fmla="*/ 826 w 904"/>
                <a:gd name="T13" fmla="*/ 2032 h 3204"/>
                <a:gd name="T14" fmla="*/ 881 w 904"/>
                <a:gd name="T15" fmla="*/ 2158 h 3204"/>
                <a:gd name="T16" fmla="*/ 904 w 904"/>
                <a:gd name="T17" fmla="*/ 2296 h 3204"/>
                <a:gd name="T18" fmla="*/ 868 w 904"/>
                <a:gd name="T19" fmla="*/ 2449 h 3204"/>
                <a:gd name="T20" fmla="*/ 797 w 904"/>
                <a:gd name="T21" fmla="*/ 2585 h 3204"/>
                <a:gd name="T22" fmla="*/ 698 w 904"/>
                <a:gd name="T23" fmla="*/ 2707 h 3204"/>
                <a:gd name="T24" fmla="*/ 384 w 904"/>
                <a:gd name="T25" fmla="*/ 2995 h 3204"/>
                <a:gd name="T26" fmla="*/ 251 w 904"/>
                <a:gd name="T27" fmla="*/ 3109 h 3204"/>
                <a:gd name="T28" fmla="*/ 53 w 904"/>
                <a:gd name="T29" fmla="*/ 3165 h 3204"/>
                <a:gd name="T30" fmla="*/ 34 w 904"/>
                <a:gd name="T31" fmla="*/ 3014 h 3204"/>
                <a:gd name="T32" fmla="*/ 108 w 904"/>
                <a:gd name="T33" fmla="*/ 2916 h 3204"/>
                <a:gd name="T34" fmla="*/ 245 w 904"/>
                <a:gd name="T35" fmla="*/ 3093 h 3204"/>
                <a:gd name="T36" fmla="*/ 206 w 904"/>
                <a:gd name="T37" fmla="*/ 2985 h 3204"/>
                <a:gd name="T38" fmla="*/ 55 w 904"/>
                <a:gd name="T39" fmla="*/ 3004 h 3204"/>
                <a:gd name="T40" fmla="*/ 165 w 904"/>
                <a:gd name="T41" fmla="*/ 2895 h 3204"/>
                <a:gd name="T42" fmla="*/ 434 w 904"/>
                <a:gd name="T43" fmla="*/ 2667 h 3204"/>
                <a:gd name="T44" fmla="*/ 611 w 904"/>
                <a:gd name="T45" fmla="*/ 2470 h 3204"/>
                <a:gd name="T46" fmla="*/ 661 w 904"/>
                <a:gd name="T47" fmla="*/ 2378 h 3204"/>
                <a:gd name="T48" fmla="*/ 678 w 904"/>
                <a:gd name="T49" fmla="*/ 2301 h 3204"/>
                <a:gd name="T50" fmla="*/ 662 w 904"/>
                <a:gd name="T51" fmla="*/ 2235 h 3204"/>
                <a:gd name="T52" fmla="*/ 623 w 904"/>
                <a:gd name="T53" fmla="*/ 2149 h 3204"/>
                <a:gd name="T54" fmla="*/ 555 w 904"/>
                <a:gd name="T55" fmla="*/ 2050 h 3204"/>
                <a:gd name="T56" fmla="*/ 296 w 904"/>
                <a:gd name="T57" fmla="*/ 1666 h 3204"/>
                <a:gd name="T58" fmla="*/ 231 w 904"/>
                <a:gd name="T59" fmla="*/ 1512 h 3204"/>
                <a:gd name="T60" fmla="*/ 197 w 904"/>
                <a:gd name="T61" fmla="*/ 1350 h 3204"/>
                <a:gd name="T62" fmla="*/ 222 w 904"/>
                <a:gd name="T63" fmla="*/ 1021 h 3204"/>
                <a:gd name="T64" fmla="*/ 318 w 904"/>
                <a:gd name="T65" fmla="*/ 674 h 3204"/>
                <a:gd name="T66" fmla="*/ 601 w 904"/>
                <a:gd name="T67" fmla="*/ 0 h 32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904" h="3204">
                  <a:moveTo>
                    <a:pt x="806" y="78"/>
                  </a:moveTo>
                  <a:lnTo>
                    <a:pt x="656" y="413"/>
                  </a:lnTo>
                  <a:lnTo>
                    <a:pt x="527" y="738"/>
                  </a:lnTo>
                  <a:lnTo>
                    <a:pt x="445" y="1040"/>
                  </a:lnTo>
                  <a:lnTo>
                    <a:pt x="450" y="1023"/>
                  </a:lnTo>
                  <a:lnTo>
                    <a:pt x="423" y="1322"/>
                  </a:lnTo>
                  <a:lnTo>
                    <a:pt x="422" y="1292"/>
                  </a:lnTo>
                  <a:lnTo>
                    <a:pt x="448" y="1431"/>
                  </a:lnTo>
                  <a:lnTo>
                    <a:pt x="441" y="1407"/>
                  </a:lnTo>
                  <a:lnTo>
                    <a:pt x="500" y="1545"/>
                  </a:lnTo>
                  <a:lnTo>
                    <a:pt x="493" y="1532"/>
                  </a:lnTo>
                  <a:lnTo>
                    <a:pt x="661" y="1790"/>
                  </a:lnTo>
                  <a:lnTo>
                    <a:pt x="744" y="1907"/>
                  </a:lnTo>
                  <a:lnTo>
                    <a:pt x="826" y="2032"/>
                  </a:lnTo>
                  <a:cubicBezTo>
                    <a:pt x="828" y="2036"/>
                    <a:pt x="830" y="2040"/>
                    <a:pt x="833" y="2045"/>
                  </a:cubicBezTo>
                  <a:lnTo>
                    <a:pt x="881" y="2158"/>
                  </a:lnTo>
                  <a:cubicBezTo>
                    <a:pt x="886" y="2167"/>
                    <a:pt x="889" y="2178"/>
                    <a:pt x="891" y="2186"/>
                  </a:cubicBezTo>
                  <a:lnTo>
                    <a:pt x="904" y="2296"/>
                  </a:lnTo>
                  <a:cubicBezTo>
                    <a:pt x="903" y="2310"/>
                    <a:pt x="903" y="2325"/>
                    <a:pt x="897" y="2342"/>
                  </a:cubicBezTo>
                  <a:lnTo>
                    <a:pt x="868" y="2449"/>
                  </a:lnTo>
                  <a:cubicBezTo>
                    <a:pt x="869" y="2457"/>
                    <a:pt x="862" y="2467"/>
                    <a:pt x="859" y="2477"/>
                  </a:cubicBezTo>
                  <a:lnTo>
                    <a:pt x="797" y="2585"/>
                  </a:lnTo>
                  <a:cubicBezTo>
                    <a:pt x="792" y="2591"/>
                    <a:pt x="789" y="2598"/>
                    <a:pt x="785" y="2601"/>
                  </a:cubicBezTo>
                  <a:lnTo>
                    <a:pt x="698" y="2707"/>
                  </a:lnTo>
                  <a:lnTo>
                    <a:pt x="595" y="2817"/>
                  </a:lnTo>
                  <a:lnTo>
                    <a:pt x="384" y="2995"/>
                  </a:lnTo>
                  <a:lnTo>
                    <a:pt x="306" y="3062"/>
                  </a:lnTo>
                  <a:lnTo>
                    <a:pt x="251" y="3109"/>
                  </a:lnTo>
                  <a:lnTo>
                    <a:pt x="209" y="3151"/>
                  </a:lnTo>
                  <a:cubicBezTo>
                    <a:pt x="166" y="3197"/>
                    <a:pt x="95" y="3204"/>
                    <a:pt x="53" y="3165"/>
                  </a:cubicBezTo>
                  <a:lnTo>
                    <a:pt x="47" y="3160"/>
                  </a:lnTo>
                  <a:cubicBezTo>
                    <a:pt x="7" y="3125"/>
                    <a:pt x="0" y="3065"/>
                    <a:pt x="34" y="3014"/>
                  </a:cubicBezTo>
                  <a:lnTo>
                    <a:pt x="60" y="2975"/>
                  </a:lnTo>
                  <a:lnTo>
                    <a:pt x="108" y="2916"/>
                  </a:lnTo>
                  <a:lnTo>
                    <a:pt x="284" y="3039"/>
                  </a:lnTo>
                  <a:lnTo>
                    <a:pt x="245" y="3093"/>
                  </a:lnTo>
                  <a:lnTo>
                    <a:pt x="219" y="3131"/>
                  </a:lnTo>
                  <a:lnTo>
                    <a:pt x="206" y="2985"/>
                  </a:lnTo>
                  <a:lnTo>
                    <a:pt x="212" y="2990"/>
                  </a:lnTo>
                  <a:lnTo>
                    <a:pt x="55" y="3004"/>
                  </a:lnTo>
                  <a:lnTo>
                    <a:pt x="108" y="2949"/>
                  </a:lnTo>
                  <a:lnTo>
                    <a:pt x="165" y="2895"/>
                  </a:lnTo>
                  <a:lnTo>
                    <a:pt x="243" y="2828"/>
                  </a:lnTo>
                  <a:lnTo>
                    <a:pt x="434" y="2667"/>
                  </a:lnTo>
                  <a:lnTo>
                    <a:pt x="524" y="2577"/>
                  </a:lnTo>
                  <a:lnTo>
                    <a:pt x="611" y="2470"/>
                  </a:lnTo>
                  <a:lnTo>
                    <a:pt x="599" y="2486"/>
                  </a:lnTo>
                  <a:lnTo>
                    <a:pt x="661" y="2378"/>
                  </a:lnTo>
                  <a:lnTo>
                    <a:pt x="648" y="2409"/>
                  </a:lnTo>
                  <a:lnTo>
                    <a:pt x="678" y="2301"/>
                  </a:lnTo>
                  <a:lnTo>
                    <a:pt x="675" y="2345"/>
                  </a:lnTo>
                  <a:lnTo>
                    <a:pt x="662" y="2235"/>
                  </a:lnTo>
                  <a:lnTo>
                    <a:pt x="671" y="2263"/>
                  </a:lnTo>
                  <a:lnTo>
                    <a:pt x="623" y="2149"/>
                  </a:lnTo>
                  <a:lnTo>
                    <a:pt x="630" y="2162"/>
                  </a:lnTo>
                  <a:lnTo>
                    <a:pt x="555" y="2050"/>
                  </a:lnTo>
                  <a:lnTo>
                    <a:pt x="463" y="1923"/>
                  </a:lnTo>
                  <a:lnTo>
                    <a:pt x="296" y="1666"/>
                  </a:lnTo>
                  <a:cubicBezTo>
                    <a:pt x="295" y="1658"/>
                    <a:pt x="292" y="1654"/>
                    <a:pt x="290" y="1650"/>
                  </a:cubicBezTo>
                  <a:lnTo>
                    <a:pt x="231" y="1512"/>
                  </a:lnTo>
                  <a:cubicBezTo>
                    <a:pt x="226" y="1503"/>
                    <a:pt x="225" y="1496"/>
                    <a:pt x="223" y="1488"/>
                  </a:cubicBezTo>
                  <a:lnTo>
                    <a:pt x="197" y="1350"/>
                  </a:lnTo>
                  <a:cubicBezTo>
                    <a:pt x="196" y="1342"/>
                    <a:pt x="195" y="1331"/>
                    <a:pt x="195" y="1320"/>
                  </a:cubicBezTo>
                  <a:lnTo>
                    <a:pt x="222" y="1021"/>
                  </a:lnTo>
                  <a:cubicBezTo>
                    <a:pt x="224" y="1014"/>
                    <a:pt x="225" y="1010"/>
                    <a:pt x="224" y="1003"/>
                  </a:cubicBezTo>
                  <a:lnTo>
                    <a:pt x="318" y="674"/>
                  </a:lnTo>
                  <a:lnTo>
                    <a:pt x="451" y="335"/>
                  </a:lnTo>
                  <a:lnTo>
                    <a:pt x="601" y="0"/>
                  </a:lnTo>
                  <a:lnTo>
                    <a:pt x="806" y="78"/>
                  </a:lnTo>
                  <a:close/>
                </a:path>
              </a:pathLst>
            </a:custGeom>
            <a:solidFill>
              <a:srgbClr val="4F6228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" name="Freeform 215">
              <a:extLst>
                <a:ext uri="{FF2B5EF4-FFF2-40B4-BE49-F238E27FC236}">
                  <a16:creationId xmlns:a16="http://schemas.microsoft.com/office/drawing/2014/main" id="{45706892-12E9-4D48-A0D4-8549E6223BC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42" y="2195"/>
              <a:ext cx="38" cy="127"/>
            </a:xfrm>
            <a:custGeom>
              <a:avLst/>
              <a:gdLst>
                <a:gd name="T0" fmla="*/ 508 w 968"/>
                <a:gd name="T1" fmla="*/ 1086 h 3268"/>
                <a:gd name="T2" fmla="*/ 487 w 968"/>
                <a:gd name="T3" fmla="*/ 1361 h 3268"/>
                <a:gd name="T4" fmla="*/ 485 w 968"/>
                <a:gd name="T5" fmla="*/ 1321 h 3268"/>
                <a:gd name="T6" fmla="*/ 454 w 968"/>
                <a:gd name="T7" fmla="*/ 1412 h 3268"/>
                <a:gd name="T8" fmla="*/ 484 w 968"/>
                <a:gd name="T9" fmla="*/ 1592 h 3268"/>
                <a:gd name="T10" fmla="*/ 884 w 968"/>
                <a:gd name="T11" fmla="*/ 2049 h 3268"/>
                <a:gd name="T12" fmla="*/ 968 w 968"/>
                <a:gd name="T13" fmla="*/ 2328 h 3268"/>
                <a:gd name="T14" fmla="*/ 928 w 968"/>
                <a:gd name="T15" fmla="*/ 2507 h 3268"/>
                <a:gd name="T16" fmla="*/ 841 w 968"/>
                <a:gd name="T17" fmla="*/ 2661 h 3268"/>
                <a:gd name="T18" fmla="*/ 300 w 968"/>
                <a:gd name="T19" fmla="*/ 3176 h 3268"/>
                <a:gd name="T20" fmla="*/ 164 w 968"/>
                <a:gd name="T21" fmla="*/ 3266 h 3268"/>
                <a:gd name="T22" fmla="*/ 52 w 968"/>
                <a:gd name="T23" fmla="*/ 3235 h 3268"/>
                <a:gd name="T24" fmla="*/ 1 w 968"/>
                <a:gd name="T25" fmla="*/ 3145 h 3268"/>
                <a:gd name="T26" fmla="*/ 28 w 968"/>
                <a:gd name="T27" fmla="*/ 3034 h 3268"/>
                <a:gd name="T28" fmla="*/ 340 w 968"/>
                <a:gd name="T29" fmla="*/ 3099 h 3268"/>
                <a:gd name="T30" fmla="*/ 193 w 968"/>
                <a:gd name="T31" fmla="*/ 3031 h 3268"/>
                <a:gd name="T32" fmla="*/ 238 w 968"/>
                <a:gd name="T33" fmla="*/ 3067 h 3268"/>
                <a:gd name="T34" fmla="*/ 165 w 968"/>
                <a:gd name="T35" fmla="*/ 2908 h 3268"/>
                <a:gd name="T36" fmla="*/ 661 w 968"/>
                <a:gd name="T37" fmla="*/ 2478 h 3268"/>
                <a:gd name="T38" fmla="*/ 653 w 968"/>
                <a:gd name="T39" fmla="*/ 2401 h 3268"/>
                <a:gd name="T40" fmla="*/ 636 w 968"/>
                <a:gd name="T41" fmla="*/ 2441 h 3268"/>
                <a:gd name="T42" fmla="*/ 701 w 968"/>
                <a:gd name="T43" fmla="*/ 2422 h 3268"/>
                <a:gd name="T44" fmla="*/ 733 w 968"/>
                <a:gd name="T45" fmla="*/ 2288 h 3268"/>
                <a:gd name="T46" fmla="*/ 683 w 968"/>
                <a:gd name="T47" fmla="*/ 2168 h 3268"/>
                <a:gd name="T48" fmla="*/ 456 w 968"/>
                <a:gd name="T49" fmla="*/ 1986 h 3268"/>
                <a:gd name="T50" fmla="*/ 212 w 968"/>
                <a:gd name="T51" fmla="*/ 1542 h 3268"/>
                <a:gd name="T52" fmla="*/ 211 w 968"/>
                <a:gd name="T53" fmla="*/ 1042 h 3268"/>
                <a:gd name="T54" fmla="*/ 613 w 968"/>
                <a:gd name="T55" fmla="*/ 5 h 3268"/>
                <a:gd name="T56" fmla="*/ 512 w 968"/>
                <a:gd name="T57" fmla="*/ 385 h 3268"/>
                <a:gd name="T58" fmla="*/ 259 w 968"/>
                <a:gd name="T59" fmla="*/ 1359 h 3268"/>
                <a:gd name="T60" fmla="*/ 352 w 968"/>
                <a:gd name="T61" fmla="*/ 1673 h 3268"/>
                <a:gd name="T62" fmla="*/ 688 w 968"/>
                <a:gd name="T63" fmla="*/ 2178 h 3268"/>
                <a:gd name="T64" fmla="*/ 660 w 968"/>
                <a:gd name="T65" fmla="*/ 2317 h 3268"/>
                <a:gd name="T66" fmla="*/ 665 w 968"/>
                <a:gd name="T67" fmla="*/ 2341 h 3268"/>
                <a:gd name="T68" fmla="*/ 720 w 968"/>
                <a:gd name="T69" fmla="*/ 2434 h 3268"/>
                <a:gd name="T70" fmla="*/ 576 w 968"/>
                <a:gd name="T71" fmla="*/ 2642 h 3268"/>
                <a:gd name="T72" fmla="*/ 107 w 968"/>
                <a:gd name="T73" fmla="*/ 3068 h 3268"/>
                <a:gd name="T74" fmla="*/ 270 w 968"/>
                <a:gd name="T75" fmla="*/ 3018 h 3268"/>
                <a:gd name="T76" fmla="*/ 285 w 968"/>
                <a:gd name="T77" fmla="*/ 3110 h 3268"/>
                <a:gd name="T78" fmla="*/ 94 w 968"/>
                <a:gd name="T79" fmla="*/ 3067 h 3268"/>
                <a:gd name="T80" fmla="*/ 86 w 968"/>
                <a:gd name="T81" fmla="*/ 3157 h 3268"/>
                <a:gd name="T82" fmla="*/ 100 w 968"/>
                <a:gd name="T83" fmla="*/ 3171 h 3268"/>
                <a:gd name="T84" fmla="*/ 190 w 968"/>
                <a:gd name="T85" fmla="*/ 3181 h 3268"/>
                <a:gd name="T86" fmla="*/ 308 w 968"/>
                <a:gd name="T87" fmla="*/ 3074 h 3268"/>
                <a:gd name="T88" fmla="*/ 789 w 968"/>
                <a:gd name="T89" fmla="*/ 2608 h 3268"/>
                <a:gd name="T90" fmla="*/ 856 w 968"/>
                <a:gd name="T91" fmla="*/ 2482 h 3268"/>
                <a:gd name="T92" fmla="*/ 878 w 968"/>
                <a:gd name="T93" fmla="*/ 2233 h 3268"/>
                <a:gd name="T94" fmla="*/ 737 w 968"/>
                <a:gd name="T95" fmla="*/ 1970 h 3268"/>
                <a:gd name="T96" fmla="*/ 490 w 968"/>
                <a:gd name="T97" fmla="*/ 1602 h 3268"/>
                <a:gd name="T98" fmla="*/ 410 w 968"/>
                <a:gd name="T99" fmla="*/ 1342 h 3268"/>
                <a:gd name="T100" fmla="*/ 512 w 968"/>
                <a:gd name="T101" fmla="*/ 1070 h 3268"/>
                <a:gd name="T102" fmla="*/ 646 w 968"/>
                <a:gd name="T103" fmla="*/ 440 h 32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968" h="3268">
                  <a:moveTo>
                    <a:pt x="848" y="82"/>
                  </a:moveTo>
                  <a:cubicBezTo>
                    <a:pt x="867" y="89"/>
                    <a:pt x="875" y="111"/>
                    <a:pt x="867" y="130"/>
                  </a:cubicBezTo>
                  <a:lnTo>
                    <a:pt x="717" y="465"/>
                  </a:lnTo>
                  <a:lnTo>
                    <a:pt x="588" y="789"/>
                  </a:lnTo>
                  <a:lnTo>
                    <a:pt x="508" y="1086"/>
                  </a:lnTo>
                  <a:lnTo>
                    <a:pt x="433" y="1072"/>
                  </a:lnTo>
                  <a:lnTo>
                    <a:pt x="438" y="1055"/>
                  </a:lnTo>
                  <a:cubicBezTo>
                    <a:pt x="444" y="1036"/>
                    <a:pt x="463" y="1023"/>
                    <a:pt x="483" y="1024"/>
                  </a:cubicBezTo>
                  <a:cubicBezTo>
                    <a:pt x="502" y="1026"/>
                    <a:pt x="516" y="1043"/>
                    <a:pt x="514" y="1062"/>
                  </a:cubicBezTo>
                  <a:lnTo>
                    <a:pt x="487" y="1361"/>
                  </a:lnTo>
                  <a:cubicBezTo>
                    <a:pt x="485" y="1382"/>
                    <a:pt x="468" y="1398"/>
                    <a:pt x="447" y="1400"/>
                  </a:cubicBezTo>
                  <a:cubicBezTo>
                    <a:pt x="427" y="1401"/>
                    <a:pt x="411" y="1386"/>
                    <a:pt x="410" y="1366"/>
                  </a:cubicBezTo>
                  <a:lnTo>
                    <a:pt x="409" y="1336"/>
                  </a:lnTo>
                  <a:cubicBezTo>
                    <a:pt x="408" y="1316"/>
                    <a:pt x="423" y="1298"/>
                    <a:pt x="443" y="1294"/>
                  </a:cubicBezTo>
                  <a:cubicBezTo>
                    <a:pt x="463" y="1290"/>
                    <a:pt x="482" y="1302"/>
                    <a:pt x="485" y="1321"/>
                  </a:cubicBezTo>
                  <a:lnTo>
                    <a:pt x="511" y="1460"/>
                  </a:lnTo>
                  <a:cubicBezTo>
                    <a:pt x="515" y="1480"/>
                    <a:pt x="502" y="1500"/>
                    <a:pt x="482" y="1507"/>
                  </a:cubicBezTo>
                  <a:cubicBezTo>
                    <a:pt x="462" y="1513"/>
                    <a:pt x="442" y="1503"/>
                    <a:pt x="436" y="1484"/>
                  </a:cubicBezTo>
                  <a:lnTo>
                    <a:pt x="429" y="1460"/>
                  </a:lnTo>
                  <a:cubicBezTo>
                    <a:pt x="424" y="1441"/>
                    <a:pt x="435" y="1420"/>
                    <a:pt x="454" y="1412"/>
                  </a:cubicBezTo>
                  <a:cubicBezTo>
                    <a:pt x="473" y="1403"/>
                    <a:pt x="495" y="1411"/>
                    <a:pt x="502" y="1429"/>
                  </a:cubicBezTo>
                  <a:lnTo>
                    <a:pt x="561" y="1567"/>
                  </a:lnTo>
                  <a:cubicBezTo>
                    <a:pt x="569" y="1585"/>
                    <a:pt x="560" y="1608"/>
                    <a:pt x="541" y="1618"/>
                  </a:cubicBezTo>
                  <a:cubicBezTo>
                    <a:pt x="523" y="1628"/>
                    <a:pt x="500" y="1622"/>
                    <a:pt x="491" y="1605"/>
                  </a:cubicBezTo>
                  <a:lnTo>
                    <a:pt x="484" y="1592"/>
                  </a:lnTo>
                  <a:cubicBezTo>
                    <a:pt x="475" y="1574"/>
                    <a:pt x="482" y="1551"/>
                    <a:pt x="500" y="1540"/>
                  </a:cubicBezTo>
                  <a:cubicBezTo>
                    <a:pt x="518" y="1528"/>
                    <a:pt x="541" y="1532"/>
                    <a:pt x="551" y="1549"/>
                  </a:cubicBezTo>
                  <a:lnTo>
                    <a:pt x="719" y="1807"/>
                  </a:lnTo>
                  <a:lnTo>
                    <a:pt x="802" y="1923"/>
                  </a:lnTo>
                  <a:lnTo>
                    <a:pt x="884" y="2049"/>
                  </a:lnTo>
                  <a:lnTo>
                    <a:pt x="893" y="2064"/>
                  </a:lnTo>
                  <a:lnTo>
                    <a:pt x="942" y="2180"/>
                  </a:lnTo>
                  <a:lnTo>
                    <a:pt x="953" y="2210"/>
                  </a:lnTo>
                  <a:cubicBezTo>
                    <a:pt x="954" y="2212"/>
                    <a:pt x="954" y="2215"/>
                    <a:pt x="955" y="2218"/>
                  </a:cubicBezTo>
                  <a:lnTo>
                    <a:pt x="968" y="2328"/>
                  </a:lnTo>
                  <a:cubicBezTo>
                    <a:pt x="968" y="2330"/>
                    <a:pt x="968" y="2333"/>
                    <a:pt x="968" y="2336"/>
                  </a:cubicBezTo>
                  <a:lnTo>
                    <a:pt x="966" y="2358"/>
                  </a:lnTo>
                  <a:lnTo>
                    <a:pt x="960" y="2386"/>
                  </a:lnTo>
                  <a:lnTo>
                    <a:pt x="931" y="2495"/>
                  </a:lnTo>
                  <a:lnTo>
                    <a:pt x="928" y="2507"/>
                  </a:lnTo>
                  <a:cubicBezTo>
                    <a:pt x="928" y="2509"/>
                    <a:pt x="927" y="2511"/>
                    <a:pt x="926" y="2513"/>
                  </a:cubicBezTo>
                  <a:lnTo>
                    <a:pt x="920" y="2528"/>
                  </a:lnTo>
                  <a:cubicBezTo>
                    <a:pt x="919" y="2530"/>
                    <a:pt x="919" y="2531"/>
                    <a:pt x="918" y="2533"/>
                  </a:cubicBezTo>
                  <a:lnTo>
                    <a:pt x="856" y="2641"/>
                  </a:lnTo>
                  <a:lnTo>
                    <a:pt x="841" y="2661"/>
                  </a:lnTo>
                  <a:lnTo>
                    <a:pt x="753" y="2769"/>
                  </a:lnTo>
                  <a:lnTo>
                    <a:pt x="648" y="2881"/>
                  </a:lnTo>
                  <a:lnTo>
                    <a:pt x="433" y="3063"/>
                  </a:lnTo>
                  <a:lnTo>
                    <a:pt x="355" y="3129"/>
                  </a:lnTo>
                  <a:lnTo>
                    <a:pt x="300" y="3176"/>
                  </a:lnTo>
                  <a:lnTo>
                    <a:pt x="261" y="3216"/>
                  </a:lnTo>
                  <a:cubicBezTo>
                    <a:pt x="259" y="3218"/>
                    <a:pt x="257" y="3219"/>
                    <a:pt x="256" y="3220"/>
                  </a:cubicBezTo>
                  <a:lnTo>
                    <a:pt x="219" y="3247"/>
                  </a:lnTo>
                  <a:cubicBezTo>
                    <a:pt x="214" y="3250"/>
                    <a:pt x="210" y="3253"/>
                    <a:pt x="205" y="3254"/>
                  </a:cubicBezTo>
                  <a:lnTo>
                    <a:pt x="164" y="3266"/>
                  </a:lnTo>
                  <a:cubicBezTo>
                    <a:pt x="159" y="3267"/>
                    <a:pt x="154" y="3268"/>
                    <a:pt x="149" y="3267"/>
                  </a:cubicBezTo>
                  <a:lnTo>
                    <a:pt x="107" y="3263"/>
                  </a:lnTo>
                  <a:cubicBezTo>
                    <a:pt x="102" y="3263"/>
                    <a:pt x="97" y="3261"/>
                    <a:pt x="93" y="3259"/>
                  </a:cubicBezTo>
                  <a:lnTo>
                    <a:pt x="57" y="3238"/>
                  </a:lnTo>
                  <a:cubicBezTo>
                    <a:pt x="55" y="3237"/>
                    <a:pt x="54" y="3236"/>
                    <a:pt x="52" y="3235"/>
                  </a:cubicBezTo>
                  <a:lnTo>
                    <a:pt x="46" y="3230"/>
                  </a:lnTo>
                  <a:cubicBezTo>
                    <a:pt x="44" y="3228"/>
                    <a:pt x="43" y="3226"/>
                    <a:pt x="41" y="3225"/>
                  </a:cubicBezTo>
                  <a:lnTo>
                    <a:pt x="17" y="3195"/>
                  </a:lnTo>
                  <a:cubicBezTo>
                    <a:pt x="14" y="3191"/>
                    <a:pt x="12" y="3187"/>
                    <a:pt x="11" y="3182"/>
                  </a:cubicBezTo>
                  <a:lnTo>
                    <a:pt x="1" y="3145"/>
                  </a:lnTo>
                  <a:cubicBezTo>
                    <a:pt x="0" y="3141"/>
                    <a:pt x="0" y="3137"/>
                    <a:pt x="0" y="3133"/>
                  </a:cubicBezTo>
                  <a:lnTo>
                    <a:pt x="3" y="3093"/>
                  </a:lnTo>
                  <a:cubicBezTo>
                    <a:pt x="3" y="3088"/>
                    <a:pt x="5" y="3084"/>
                    <a:pt x="7" y="3079"/>
                  </a:cubicBezTo>
                  <a:lnTo>
                    <a:pt x="25" y="3040"/>
                  </a:lnTo>
                  <a:cubicBezTo>
                    <a:pt x="26" y="3038"/>
                    <a:pt x="27" y="3036"/>
                    <a:pt x="28" y="3034"/>
                  </a:cubicBezTo>
                  <a:lnTo>
                    <a:pt x="54" y="2995"/>
                  </a:lnTo>
                  <a:lnTo>
                    <a:pt x="104" y="2933"/>
                  </a:lnTo>
                  <a:cubicBezTo>
                    <a:pt x="118" y="2917"/>
                    <a:pt x="141" y="2912"/>
                    <a:pt x="158" y="2924"/>
                  </a:cubicBezTo>
                  <a:lnTo>
                    <a:pt x="334" y="3047"/>
                  </a:lnTo>
                  <a:cubicBezTo>
                    <a:pt x="350" y="3058"/>
                    <a:pt x="353" y="3081"/>
                    <a:pt x="340" y="3099"/>
                  </a:cubicBezTo>
                  <a:lnTo>
                    <a:pt x="301" y="3153"/>
                  </a:lnTo>
                  <a:lnTo>
                    <a:pt x="276" y="3190"/>
                  </a:lnTo>
                  <a:cubicBezTo>
                    <a:pt x="266" y="3204"/>
                    <a:pt x="250" y="3211"/>
                    <a:pt x="234" y="3208"/>
                  </a:cubicBezTo>
                  <a:cubicBezTo>
                    <a:pt x="219" y="3205"/>
                    <a:pt x="207" y="3193"/>
                    <a:pt x="206" y="3177"/>
                  </a:cubicBezTo>
                  <a:lnTo>
                    <a:pt x="193" y="3031"/>
                  </a:lnTo>
                  <a:cubicBezTo>
                    <a:pt x="192" y="3016"/>
                    <a:pt x="200" y="3000"/>
                    <a:pt x="215" y="2992"/>
                  </a:cubicBezTo>
                  <a:cubicBezTo>
                    <a:pt x="229" y="2984"/>
                    <a:pt x="246" y="2985"/>
                    <a:pt x="258" y="2994"/>
                  </a:cubicBezTo>
                  <a:lnTo>
                    <a:pt x="264" y="2999"/>
                  </a:lnTo>
                  <a:cubicBezTo>
                    <a:pt x="275" y="3009"/>
                    <a:pt x="279" y="3025"/>
                    <a:pt x="273" y="3040"/>
                  </a:cubicBezTo>
                  <a:cubicBezTo>
                    <a:pt x="268" y="3055"/>
                    <a:pt x="253" y="3066"/>
                    <a:pt x="238" y="3067"/>
                  </a:cubicBezTo>
                  <a:lnTo>
                    <a:pt x="81" y="3081"/>
                  </a:lnTo>
                  <a:cubicBezTo>
                    <a:pt x="65" y="3083"/>
                    <a:pt x="51" y="3075"/>
                    <a:pt x="45" y="3061"/>
                  </a:cubicBezTo>
                  <a:cubicBezTo>
                    <a:pt x="39" y="3047"/>
                    <a:pt x="42" y="3030"/>
                    <a:pt x="54" y="3018"/>
                  </a:cubicBezTo>
                  <a:lnTo>
                    <a:pt x="107" y="2963"/>
                  </a:lnTo>
                  <a:lnTo>
                    <a:pt x="165" y="2908"/>
                  </a:lnTo>
                  <a:lnTo>
                    <a:pt x="245" y="2840"/>
                  </a:lnTo>
                  <a:lnTo>
                    <a:pt x="436" y="2678"/>
                  </a:lnTo>
                  <a:lnTo>
                    <a:pt x="523" y="2591"/>
                  </a:lnTo>
                  <a:lnTo>
                    <a:pt x="607" y="2487"/>
                  </a:lnTo>
                  <a:cubicBezTo>
                    <a:pt x="621" y="2470"/>
                    <a:pt x="645" y="2466"/>
                    <a:pt x="661" y="2478"/>
                  </a:cubicBezTo>
                  <a:cubicBezTo>
                    <a:pt x="677" y="2490"/>
                    <a:pt x="680" y="2513"/>
                    <a:pt x="667" y="2530"/>
                  </a:cubicBezTo>
                  <a:lnTo>
                    <a:pt x="655" y="2546"/>
                  </a:lnTo>
                  <a:cubicBezTo>
                    <a:pt x="642" y="2563"/>
                    <a:pt x="619" y="2569"/>
                    <a:pt x="603" y="2559"/>
                  </a:cubicBezTo>
                  <a:cubicBezTo>
                    <a:pt x="586" y="2549"/>
                    <a:pt x="581" y="2527"/>
                    <a:pt x="591" y="2509"/>
                  </a:cubicBezTo>
                  <a:lnTo>
                    <a:pt x="653" y="2401"/>
                  </a:lnTo>
                  <a:cubicBezTo>
                    <a:pt x="664" y="2383"/>
                    <a:pt x="686" y="2375"/>
                    <a:pt x="704" y="2382"/>
                  </a:cubicBezTo>
                  <a:cubicBezTo>
                    <a:pt x="722" y="2390"/>
                    <a:pt x="730" y="2410"/>
                    <a:pt x="722" y="2429"/>
                  </a:cubicBezTo>
                  <a:lnTo>
                    <a:pt x="709" y="2460"/>
                  </a:lnTo>
                  <a:cubicBezTo>
                    <a:pt x="701" y="2479"/>
                    <a:pt x="680" y="2490"/>
                    <a:pt x="661" y="2485"/>
                  </a:cubicBezTo>
                  <a:cubicBezTo>
                    <a:pt x="641" y="2480"/>
                    <a:pt x="631" y="2461"/>
                    <a:pt x="636" y="2441"/>
                  </a:cubicBezTo>
                  <a:lnTo>
                    <a:pt x="666" y="2333"/>
                  </a:lnTo>
                  <a:cubicBezTo>
                    <a:pt x="672" y="2314"/>
                    <a:pt x="691" y="2301"/>
                    <a:pt x="710" y="2302"/>
                  </a:cubicBezTo>
                  <a:cubicBezTo>
                    <a:pt x="729" y="2304"/>
                    <a:pt x="743" y="2320"/>
                    <a:pt x="742" y="2340"/>
                  </a:cubicBezTo>
                  <a:lnTo>
                    <a:pt x="739" y="2384"/>
                  </a:lnTo>
                  <a:cubicBezTo>
                    <a:pt x="738" y="2403"/>
                    <a:pt x="721" y="2420"/>
                    <a:pt x="701" y="2422"/>
                  </a:cubicBezTo>
                  <a:cubicBezTo>
                    <a:pt x="681" y="2425"/>
                    <a:pt x="664" y="2412"/>
                    <a:pt x="662" y="2392"/>
                  </a:cubicBezTo>
                  <a:lnTo>
                    <a:pt x="649" y="2282"/>
                  </a:lnTo>
                  <a:cubicBezTo>
                    <a:pt x="647" y="2263"/>
                    <a:pt x="660" y="2244"/>
                    <a:pt x="680" y="2238"/>
                  </a:cubicBezTo>
                  <a:cubicBezTo>
                    <a:pt x="699" y="2232"/>
                    <a:pt x="718" y="2242"/>
                    <a:pt x="724" y="2260"/>
                  </a:cubicBezTo>
                  <a:lnTo>
                    <a:pt x="733" y="2288"/>
                  </a:lnTo>
                  <a:cubicBezTo>
                    <a:pt x="739" y="2307"/>
                    <a:pt x="729" y="2329"/>
                    <a:pt x="709" y="2337"/>
                  </a:cubicBezTo>
                  <a:cubicBezTo>
                    <a:pt x="690" y="2346"/>
                    <a:pt x="668" y="2338"/>
                    <a:pt x="661" y="2320"/>
                  </a:cubicBezTo>
                  <a:lnTo>
                    <a:pt x="613" y="2206"/>
                  </a:lnTo>
                  <a:cubicBezTo>
                    <a:pt x="605" y="2188"/>
                    <a:pt x="614" y="2165"/>
                    <a:pt x="633" y="2155"/>
                  </a:cubicBezTo>
                  <a:cubicBezTo>
                    <a:pt x="651" y="2145"/>
                    <a:pt x="674" y="2151"/>
                    <a:pt x="683" y="2168"/>
                  </a:cubicBezTo>
                  <a:lnTo>
                    <a:pt x="690" y="2181"/>
                  </a:lnTo>
                  <a:cubicBezTo>
                    <a:pt x="699" y="2199"/>
                    <a:pt x="692" y="2221"/>
                    <a:pt x="674" y="2233"/>
                  </a:cubicBezTo>
                  <a:cubicBezTo>
                    <a:pt x="656" y="2244"/>
                    <a:pt x="634" y="2241"/>
                    <a:pt x="623" y="2224"/>
                  </a:cubicBezTo>
                  <a:lnTo>
                    <a:pt x="548" y="2112"/>
                  </a:lnTo>
                  <a:lnTo>
                    <a:pt x="456" y="1986"/>
                  </a:lnTo>
                  <a:lnTo>
                    <a:pt x="288" y="1728"/>
                  </a:lnTo>
                  <a:cubicBezTo>
                    <a:pt x="287" y="1726"/>
                    <a:pt x="286" y="1724"/>
                    <a:pt x="285" y="1721"/>
                  </a:cubicBezTo>
                  <a:lnTo>
                    <a:pt x="279" y="1705"/>
                  </a:lnTo>
                  <a:lnTo>
                    <a:pt x="221" y="1569"/>
                  </a:lnTo>
                  <a:lnTo>
                    <a:pt x="212" y="1542"/>
                  </a:lnTo>
                  <a:lnTo>
                    <a:pt x="185" y="1400"/>
                  </a:lnTo>
                  <a:lnTo>
                    <a:pt x="182" y="1365"/>
                  </a:lnTo>
                  <a:cubicBezTo>
                    <a:pt x="182" y="1363"/>
                    <a:pt x="182" y="1361"/>
                    <a:pt x="182" y="1359"/>
                  </a:cubicBezTo>
                  <a:lnTo>
                    <a:pt x="209" y="1060"/>
                  </a:lnTo>
                  <a:lnTo>
                    <a:pt x="211" y="1042"/>
                  </a:lnTo>
                  <a:cubicBezTo>
                    <a:pt x="211" y="1039"/>
                    <a:pt x="212" y="1037"/>
                    <a:pt x="212" y="1035"/>
                  </a:cubicBezTo>
                  <a:lnTo>
                    <a:pt x="306" y="706"/>
                  </a:lnTo>
                  <a:lnTo>
                    <a:pt x="441" y="363"/>
                  </a:lnTo>
                  <a:lnTo>
                    <a:pt x="591" y="27"/>
                  </a:lnTo>
                  <a:cubicBezTo>
                    <a:pt x="596" y="17"/>
                    <a:pt x="604" y="9"/>
                    <a:pt x="613" y="5"/>
                  </a:cubicBezTo>
                  <a:cubicBezTo>
                    <a:pt x="623" y="1"/>
                    <a:pt x="634" y="0"/>
                    <a:pt x="643" y="4"/>
                  </a:cubicBezTo>
                  <a:lnTo>
                    <a:pt x="848" y="82"/>
                  </a:lnTo>
                  <a:close/>
                  <a:moveTo>
                    <a:pt x="610" y="75"/>
                  </a:moveTo>
                  <a:lnTo>
                    <a:pt x="662" y="52"/>
                  </a:lnTo>
                  <a:lnTo>
                    <a:pt x="512" y="385"/>
                  </a:lnTo>
                  <a:lnTo>
                    <a:pt x="381" y="721"/>
                  </a:lnTo>
                  <a:lnTo>
                    <a:pt x="287" y="1050"/>
                  </a:lnTo>
                  <a:lnTo>
                    <a:pt x="288" y="1043"/>
                  </a:lnTo>
                  <a:lnTo>
                    <a:pt x="286" y="1060"/>
                  </a:lnTo>
                  <a:lnTo>
                    <a:pt x="259" y="1359"/>
                  </a:lnTo>
                  <a:lnTo>
                    <a:pt x="259" y="1354"/>
                  </a:lnTo>
                  <a:lnTo>
                    <a:pt x="260" y="1379"/>
                  </a:lnTo>
                  <a:lnTo>
                    <a:pt x="285" y="1513"/>
                  </a:lnTo>
                  <a:lnTo>
                    <a:pt x="292" y="1534"/>
                  </a:lnTo>
                  <a:lnTo>
                    <a:pt x="352" y="1673"/>
                  </a:lnTo>
                  <a:lnTo>
                    <a:pt x="358" y="1689"/>
                  </a:lnTo>
                  <a:lnTo>
                    <a:pt x="354" y="1683"/>
                  </a:lnTo>
                  <a:lnTo>
                    <a:pt x="520" y="1938"/>
                  </a:lnTo>
                  <a:lnTo>
                    <a:pt x="613" y="2066"/>
                  </a:lnTo>
                  <a:lnTo>
                    <a:pt x="688" y="2178"/>
                  </a:lnTo>
                  <a:lnTo>
                    <a:pt x="621" y="2222"/>
                  </a:lnTo>
                  <a:lnTo>
                    <a:pt x="614" y="2209"/>
                  </a:lnTo>
                  <a:lnTo>
                    <a:pt x="684" y="2171"/>
                  </a:lnTo>
                  <a:lnTo>
                    <a:pt x="732" y="2285"/>
                  </a:lnTo>
                  <a:lnTo>
                    <a:pt x="660" y="2317"/>
                  </a:lnTo>
                  <a:lnTo>
                    <a:pt x="651" y="2289"/>
                  </a:lnTo>
                  <a:lnTo>
                    <a:pt x="726" y="2267"/>
                  </a:lnTo>
                  <a:lnTo>
                    <a:pt x="739" y="2377"/>
                  </a:lnTo>
                  <a:lnTo>
                    <a:pt x="662" y="2385"/>
                  </a:lnTo>
                  <a:lnTo>
                    <a:pt x="665" y="2341"/>
                  </a:lnTo>
                  <a:lnTo>
                    <a:pt x="741" y="2347"/>
                  </a:lnTo>
                  <a:lnTo>
                    <a:pt x="711" y="2455"/>
                  </a:lnTo>
                  <a:lnTo>
                    <a:pt x="638" y="2437"/>
                  </a:lnTo>
                  <a:lnTo>
                    <a:pt x="651" y="2406"/>
                  </a:lnTo>
                  <a:lnTo>
                    <a:pt x="720" y="2434"/>
                  </a:lnTo>
                  <a:lnTo>
                    <a:pt x="658" y="2542"/>
                  </a:lnTo>
                  <a:lnTo>
                    <a:pt x="594" y="2505"/>
                  </a:lnTo>
                  <a:lnTo>
                    <a:pt x="606" y="2489"/>
                  </a:lnTo>
                  <a:lnTo>
                    <a:pt x="666" y="2532"/>
                  </a:lnTo>
                  <a:lnTo>
                    <a:pt x="576" y="2642"/>
                  </a:lnTo>
                  <a:lnTo>
                    <a:pt x="483" y="2735"/>
                  </a:lnTo>
                  <a:lnTo>
                    <a:pt x="292" y="2895"/>
                  </a:lnTo>
                  <a:lnTo>
                    <a:pt x="216" y="2961"/>
                  </a:lnTo>
                  <a:lnTo>
                    <a:pt x="160" y="3013"/>
                  </a:lnTo>
                  <a:lnTo>
                    <a:pt x="107" y="3068"/>
                  </a:lnTo>
                  <a:lnTo>
                    <a:pt x="80" y="3005"/>
                  </a:lnTo>
                  <a:lnTo>
                    <a:pt x="237" y="2991"/>
                  </a:lnTo>
                  <a:lnTo>
                    <a:pt x="211" y="3060"/>
                  </a:lnTo>
                  <a:lnTo>
                    <a:pt x="205" y="3055"/>
                  </a:lnTo>
                  <a:lnTo>
                    <a:pt x="270" y="3018"/>
                  </a:lnTo>
                  <a:lnTo>
                    <a:pt x="283" y="3164"/>
                  </a:lnTo>
                  <a:lnTo>
                    <a:pt x="213" y="3151"/>
                  </a:lnTo>
                  <a:lnTo>
                    <a:pt x="240" y="3112"/>
                  </a:lnTo>
                  <a:lnTo>
                    <a:pt x="279" y="3058"/>
                  </a:lnTo>
                  <a:lnTo>
                    <a:pt x="285" y="3110"/>
                  </a:lnTo>
                  <a:lnTo>
                    <a:pt x="109" y="2987"/>
                  </a:lnTo>
                  <a:lnTo>
                    <a:pt x="163" y="2978"/>
                  </a:lnTo>
                  <a:lnTo>
                    <a:pt x="117" y="3033"/>
                  </a:lnTo>
                  <a:lnTo>
                    <a:pt x="91" y="3072"/>
                  </a:lnTo>
                  <a:lnTo>
                    <a:pt x="94" y="3067"/>
                  </a:lnTo>
                  <a:lnTo>
                    <a:pt x="76" y="3106"/>
                  </a:lnTo>
                  <a:lnTo>
                    <a:pt x="80" y="3092"/>
                  </a:lnTo>
                  <a:lnTo>
                    <a:pt x="77" y="3132"/>
                  </a:lnTo>
                  <a:lnTo>
                    <a:pt x="76" y="3120"/>
                  </a:lnTo>
                  <a:lnTo>
                    <a:pt x="86" y="3157"/>
                  </a:lnTo>
                  <a:lnTo>
                    <a:pt x="80" y="3144"/>
                  </a:lnTo>
                  <a:lnTo>
                    <a:pt x="104" y="3174"/>
                  </a:lnTo>
                  <a:lnTo>
                    <a:pt x="99" y="3169"/>
                  </a:lnTo>
                  <a:lnTo>
                    <a:pt x="105" y="3174"/>
                  </a:lnTo>
                  <a:lnTo>
                    <a:pt x="100" y="3171"/>
                  </a:lnTo>
                  <a:lnTo>
                    <a:pt x="136" y="3192"/>
                  </a:lnTo>
                  <a:lnTo>
                    <a:pt x="122" y="3187"/>
                  </a:lnTo>
                  <a:lnTo>
                    <a:pt x="164" y="3191"/>
                  </a:lnTo>
                  <a:lnTo>
                    <a:pt x="149" y="3193"/>
                  </a:lnTo>
                  <a:lnTo>
                    <a:pt x="190" y="3181"/>
                  </a:lnTo>
                  <a:lnTo>
                    <a:pt x="176" y="3187"/>
                  </a:lnTo>
                  <a:lnTo>
                    <a:pt x="213" y="3160"/>
                  </a:lnTo>
                  <a:lnTo>
                    <a:pt x="208" y="3165"/>
                  </a:lnTo>
                  <a:lnTo>
                    <a:pt x="253" y="3121"/>
                  </a:lnTo>
                  <a:lnTo>
                    <a:pt x="308" y="3074"/>
                  </a:lnTo>
                  <a:lnTo>
                    <a:pt x="386" y="3006"/>
                  </a:lnTo>
                  <a:lnTo>
                    <a:pt x="593" y="2832"/>
                  </a:lnTo>
                  <a:lnTo>
                    <a:pt x="694" y="2724"/>
                  </a:lnTo>
                  <a:lnTo>
                    <a:pt x="780" y="2620"/>
                  </a:lnTo>
                  <a:lnTo>
                    <a:pt x="789" y="2608"/>
                  </a:lnTo>
                  <a:lnTo>
                    <a:pt x="851" y="2500"/>
                  </a:lnTo>
                  <a:lnTo>
                    <a:pt x="849" y="2505"/>
                  </a:lnTo>
                  <a:lnTo>
                    <a:pt x="855" y="2490"/>
                  </a:lnTo>
                  <a:lnTo>
                    <a:pt x="853" y="2496"/>
                  </a:lnTo>
                  <a:lnTo>
                    <a:pt x="856" y="2482"/>
                  </a:lnTo>
                  <a:lnTo>
                    <a:pt x="885" y="2377"/>
                  </a:lnTo>
                  <a:lnTo>
                    <a:pt x="889" y="2357"/>
                  </a:lnTo>
                  <a:lnTo>
                    <a:pt x="891" y="2335"/>
                  </a:lnTo>
                  <a:lnTo>
                    <a:pt x="891" y="2343"/>
                  </a:lnTo>
                  <a:lnTo>
                    <a:pt x="878" y="2233"/>
                  </a:lnTo>
                  <a:lnTo>
                    <a:pt x="880" y="2241"/>
                  </a:lnTo>
                  <a:lnTo>
                    <a:pt x="871" y="2215"/>
                  </a:lnTo>
                  <a:lnTo>
                    <a:pt x="824" y="2105"/>
                  </a:lnTo>
                  <a:lnTo>
                    <a:pt x="819" y="2094"/>
                  </a:lnTo>
                  <a:lnTo>
                    <a:pt x="737" y="1970"/>
                  </a:lnTo>
                  <a:lnTo>
                    <a:pt x="653" y="1852"/>
                  </a:lnTo>
                  <a:lnTo>
                    <a:pt x="485" y="1594"/>
                  </a:lnTo>
                  <a:lnTo>
                    <a:pt x="553" y="1551"/>
                  </a:lnTo>
                  <a:lnTo>
                    <a:pt x="560" y="1564"/>
                  </a:lnTo>
                  <a:lnTo>
                    <a:pt x="490" y="1602"/>
                  </a:lnTo>
                  <a:lnTo>
                    <a:pt x="431" y="1464"/>
                  </a:lnTo>
                  <a:lnTo>
                    <a:pt x="504" y="1433"/>
                  </a:lnTo>
                  <a:lnTo>
                    <a:pt x="511" y="1457"/>
                  </a:lnTo>
                  <a:lnTo>
                    <a:pt x="436" y="1481"/>
                  </a:lnTo>
                  <a:lnTo>
                    <a:pt x="410" y="1342"/>
                  </a:lnTo>
                  <a:lnTo>
                    <a:pt x="486" y="1327"/>
                  </a:lnTo>
                  <a:lnTo>
                    <a:pt x="487" y="1357"/>
                  </a:lnTo>
                  <a:lnTo>
                    <a:pt x="410" y="1361"/>
                  </a:lnTo>
                  <a:lnTo>
                    <a:pt x="437" y="1062"/>
                  </a:lnTo>
                  <a:lnTo>
                    <a:pt x="512" y="1070"/>
                  </a:lnTo>
                  <a:lnTo>
                    <a:pt x="507" y="1087"/>
                  </a:lnTo>
                  <a:cubicBezTo>
                    <a:pt x="501" y="1108"/>
                    <a:pt x="480" y="1121"/>
                    <a:pt x="460" y="1117"/>
                  </a:cubicBezTo>
                  <a:cubicBezTo>
                    <a:pt x="440" y="1113"/>
                    <a:pt x="428" y="1093"/>
                    <a:pt x="433" y="1073"/>
                  </a:cubicBezTo>
                  <a:lnTo>
                    <a:pt x="517" y="766"/>
                  </a:lnTo>
                  <a:lnTo>
                    <a:pt x="646" y="440"/>
                  </a:lnTo>
                  <a:lnTo>
                    <a:pt x="796" y="105"/>
                  </a:lnTo>
                  <a:lnTo>
                    <a:pt x="815" y="153"/>
                  </a:lnTo>
                  <a:lnTo>
                    <a:pt x="610" y="75"/>
                  </a:lnTo>
                  <a:close/>
                </a:path>
              </a:pathLst>
            </a:custGeom>
            <a:solidFill>
              <a:srgbClr val="4F6228"/>
            </a:solidFill>
            <a:ln w="0" cap="flat">
              <a:solidFill>
                <a:srgbClr val="4F6228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" name="Freeform 216">
              <a:extLst>
                <a:ext uri="{FF2B5EF4-FFF2-40B4-BE49-F238E27FC236}">
                  <a16:creationId xmlns:a16="http://schemas.microsoft.com/office/drawing/2014/main" id="{CC33AAF9-F0A0-4AC6-A430-B258465A8F9A}"/>
                </a:ext>
              </a:extLst>
            </p:cNvPr>
            <p:cNvSpPr>
              <a:spLocks/>
            </p:cNvSpPr>
            <p:nvPr/>
          </p:nvSpPr>
          <p:spPr bwMode="auto">
            <a:xfrm>
              <a:off x="625" y="2670"/>
              <a:ext cx="64" cy="82"/>
            </a:xfrm>
            <a:custGeom>
              <a:avLst/>
              <a:gdLst>
                <a:gd name="T0" fmla="*/ 57 w 64"/>
                <a:gd name="T1" fmla="*/ 82 h 82"/>
                <a:gd name="T2" fmla="*/ 0 w 64"/>
                <a:gd name="T3" fmla="*/ 6 h 82"/>
                <a:gd name="T4" fmla="*/ 7 w 64"/>
                <a:gd name="T5" fmla="*/ 0 h 82"/>
                <a:gd name="T6" fmla="*/ 64 w 64"/>
                <a:gd name="T7" fmla="*/ 76 h 82"/>
                <a:gd name="T8" fmla="*/ 57 w 64"/>
                <a:gd name="T9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4" h="82">
                  <a:moveTo>
                    <a:pt x="57" y="82"/>
                  </a:moveTo>
                  <a:lnTo>
                    <a:pt x="0" y="6"/>
                  </a:lnTo>
                  <a:lnTo>
                    <a:pt x="7" y="0"/>
                  </a:lnTo>
                  <a:lnTo>
                    <a:pt x="64" y="76"/>
                  </a:lnTo>
                  <a:lnTo>
                    <a:pt x="57" y="82"/>
                  </a:lnTo>
                  <a:close/>
                </a:path>
              </a:pathLst>
            </a:custGeom>
            <a:solidFill>
              <a:srgbClr val="FAC09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" name="Freeform 217">
              <a:extLst>
                <a:ext uri="{FF2B5EF4-FFF2-40B4-BE49-F238E27FC236}">
                  <a16:creationId xmlns:a16="http://schemas.microsoft.com/office/drawing/2014/main" id="{C3D5D460-BF07-4B90-8B56-44AC8CE0526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24" y="2669"/>
              <a:ext cx="66" cy="85"/>
            </a:xfrm>
            <a:custGeom>
              <a:avLst/>
              <a:gdLst>
                <a:gd name="T0" fmla="*/ 1521 w 1715"/>
                <a:gd name="T1" fmla="*/ 2176 h 2189"/>
                <a:gd name="T2" fmla="*/ 1468 w 1715"/>
                <a:gd name="T3" fmla="*/ 2168 h 2189"/>
                <a:gd name="T4" fmla="*/ 12 w 1715"/>
                <a:gd name="T5" fmla="*/ 205 h 2189"/>
                <a:gd name="T6" fmla="*/ 18 w 1715"/>
                <a:gd name="T7" fmla="*/ 150 h 2189"/>
                <a:gd name="T8" fmla="*/ 185 w 1715"/>
                <a:gd name="T9" fmla="*/ 9 h 2189"/>
                <a:gd name="T10" fmla="*/ 213 w 1715"/>
                <a:gd name="T11" fmla="*/ 1 h 2189"/>
                <a:gd name="T12" fmla="*/ 238 w 1715"/>
                <a:gd name="T13" fmla="*/ 16 h 2189"/>
                <a:gd name="T14" fmla="*/ 1706 w 1715"/>
                <a:gd name="T15" fmla="*/ 1977 h 2189"/>
                <a:gd name="T16" fmla="*/ 1714 w 1715"/>
                <a:gd name="T17" fmla="*/ 2006 h 2189"/>
                <a:gd name="T18" fmla="*/ 1700 w 1715"/>
                <a:gd name="T19" fmla="*/ 2032 h 2189"/>
                <a:gd name="T20" fmla="*/ 1521 w 1715"/>
                <a:gd name="T21" fmla="*/ 2176 h 2189"/>
                <a:gd name="T22" fmla="*/ 1654 w 1715"/>
                <a:gd name="T23" fmla="*/ 1969 h 2189"/>
                <a:gd name="T24" fmla="*/ 1648 w 1715"/>
                <a:gd name="T25" fmla="*/ 2024 h 2189"/>
                <a:gd name="T26" fmla="*/ 180 w 1715"/>
                <a:gd name="T27" fmla="*/ 64 h 2189"/>
                <a:gd name="T28" fmla="*/ 233 w 1715"/>
                <a:gd name="T29" fmla="*/ 71 h 2189"/>
                <a:gd name="T30" fmla="*/ 65 w 1715"/>
                <a:gd name="T31" fmla="*/ 212 h 2189"/>
                <a:gd name="T32" fmla="*/ 71 w 1715"/>
                <a:gd name="T33" fmla="*/ 158 h 2189"/>
                <a:gd name="T34" fmla="*/ 1527 w 1715"/>
                <a:gd name="T35" fmla="*/ 2121 h 2189"/>
                <a:gd name="T36" fmla="*/ 1474 w 1715"/>
                <a:gd name="T37" fmla="*/ 2113 h 2189"/>
                <a:gd name="T38" fmla="*/ 1654 w 1715"/>
                <a:gd name="T39" fmla="*/ 1969 h 21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1715" h="2189">
                  <a:moveTo>
                    <a:pt x="1521" y="2176"/>
                  </a:moveTo>
                  <a:cubicBezTo>
                    <a:pt x="1504" y="2189"/>
                    <a:pt x="1481" y="2186"/>
                    <a:pt x="1468" y="2168"/>
                  </a:cubicBezTo>
                  <a:lnTo>
                    <a:pt x="12" y="205"/>
                  </a:lnTo>
                  <a:cubicBezTo>
                    <a:pt x="0" y="188"/>
                    <a:pt x="2" y="163"/>
                    <a:pt x="18" y="150"/>
                  </a:cubicBezTo>
                  <a:lnTo>
                    <a:pt x="185" y="9"/>
                  </a:lnTo>
                  <a:cubicBezTo>
                    <a:pt x="193" y="3"/>
                    <a:pt x="203" y="0"/>
                    <a:pt x="213" y="1"/>
                  </a:cubicBezTo>
                  <a:cubicBezTo>
                    <a:pt x="223" y="2"/>
                    <a:pt x="232" y="8"/>
                    <a:pt x="238" y="16"/>
                  </a:cubicBezTo>
                  <a:lnTo>
                    <a:pt x="1706" y="1977"/>
                  </a:lnTo>
                  <a:cubicBezTo>
                    <a:pt x="1712" y="1985"/>
                    <a:pt x="1715" y="1995"/>
                    <a:pt x="1714" y="2006"/>
                  </a:cubicBezTo>
                  <a:cubicBezTo>
                    <a:pt x="1713" y="2016"/>
                    <a:pt x="1708" y="2026"/>
                    <a:pt x="1700" y="2032"/>
                  </a:cubicBezTo>
                  <a:lnTo>
                    <a:pt x="1521" y="2176"/>
                  </a:lnTo>
                  <a:close/>
                  <a:moveTo>
                    <a:pt x="1654" y="1969"/>
                  </a:moveTo>
                  <a:lnTo>
                    <a:pt x="1648" y="2024"/>
                  </a:lnTo>
                  <a:lnTo>
                    <a:pt x="180" y="64"/>
                  </a:lnTo>
                  <a:lnTo>
                    <a:pt x="233" y="71"/>
                  </a:lnTo>
                  <a:lnTo>
                    <a:pt x="65" y="212"/>
                  </a:lnTo>
                  <a:lnTo>
                    <a:pt x="71" y="158"/>
                  </a:lnTo>
                  <a:lnTo>
                    <a:pt x="1527" y="2121"/>
                  </a:lnTo>
                  <a:lnTo>
                    <a:pt x="1474" y="2113"/>
                  </a:lnTo>
                  <a:lnTo>
                    <a:pt x="1654" y="1969"/>
                  </a:lnTo>
                  <a:close/>
                </a:path>
              </a:pathLst>
            </a:custGeom>
            <a:solidFill>
              <a:srgbClr val="FAC090"/>
            </a:solidFill>
            <a:ln w="0" cap="flat">
              <a:solidFill>
                <a:srgbClr val="FAC09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" name="Freeform 218">
              <a:extLst>
                <a:ext uri="{FF2B5EF4-FFF2-40B4-BE49-F238E27FC236}">
                  <a16:creationId xmlns:a16="http://schemas.microsoft.com/office/drawing/2014/main" id="{7BD04369-C3C5-4E40-A3A0-F99E61E0139F}"/>
                </a:ext>
              </a:extLst>
            </p:cNvPr>
            <p:cNvSpPr>
              <a:spLocks/>
            </p:cNvSpPr>
            <p:nvPr/>
          </p:nvSpPr>
          <p:spPr bwMode="auto">
            <a:xfrm>
              <a:off x="673" y="2581"/>
              <a:ext cx="59" cy="96"/>
            </a:xfrm>
            <a:custGeom>
              <a:avLst/>
              <a:gdLst>
                <a:gd name="T0" fmla="*/ 51 w 59"/>
                <a:gd name="T1" fmla="*/ 96 h 96"/>
                <a:gd name="T2" fmla="*/ 0 w 59"/>
                <a:gd name="T3" fmla="*/ 4 h 96"/>
                <a:gd name="T4" fmla="*/ 8 w 59"/>
                <a:gd name="T5" fmla="*/ 0 h 96"/>
                <a:gd name="T6" fmla="*/ 59 w 59"/>
                <a:gd name="T7" fmla="*/ 92 h 96"/>
                <a:gd name="T8" fmla="*/ 51 w 59"/>
                <a:gd name="T9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9" h="96">
                  <a:moveTo>
                    <a:pt x="51" y="96"/>
                  </a:moveTo>
                  <a:lnTo>
                    <a:pt x="0" y="4"/>
                  </a:lnTo>
                  <a:lnTo>
                    <a:pt x="8" y="0"/>
                  </a:lnTo>
                  <a:lnTo>
                    <a:pt x="59" y="92"/>
                  </a:lnTo>
                  <a:lnTo>
                    <a:pt x="51" y="96"/>
                  </a:lnTo>
                  <a:close/>
                </a:path>
              </a:pathLst>
            </a:custGeom>
            <a:solidFill>
              <a:srgbClr val="C0000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" name="Freeform 219">
              <a:extLst>
                <a:ext uri="{FF2B5EF4-FFF2-40B4-BE49-F238E27FC236}">
                  <a16:creationId xmlns:a16="http://schemas.microsoft.com/office/drawing/2014/main" id="{0919A520-EE41-4A48-874D-C4A23F9E344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1" y="2579"/>
              <a:ext cx="63" cy="100"/>
            </a:xfrm>
            <a:custGeom>
              <a:avLst/>
              <a:gdLst>
                <a:gd name="T0" fmla="*/ 1359 w 1598"/>
                <a:gd name="T1" fmla="*/ 2565 h 2574"/>
                <a:gd name="T2" fmla="*/ 1310 w 1598"/>
                <a:gd name="T3" fmla="*/ 2548 h 2574"/>
                <a:gd name="T4" fmla="*/ 6 w 1598"/>
                <a:gd name="T5" fmla="*/ 177 h 2574"/>
                <a:gd name="T6" fmla="*/ 3 w 1598"/>
                <a:gd name="T7" fmla="*/ 146 h 2574"/>
                <a:gd name="T8" fmla="*/ 21 w 1598"/>
                <a:gd name="T9" fmla="*/ 123 h 2574"/>
                <a:gd name="T10" fmla="*/ 239 w 1598"/>
                <a:gd name="T11" fmla="*/ 9 h 2574"/>
                <a:gd name="T12" fmla="*/ 288 w 1598"/>
                <a:gd name="T13" fmla="*/ 26 h 2574"/>
                <a:gd name="T14" fmla="*/ 1592 w 1598"/>
                <a:gd name="T15" fmla="*/ 2397 h 2574"/>
                <a:gd name="T16" fmla="*/ 1596 w 1598"/>
                <a:gd name="T17" fmla="*/ 2428 h 2574"/>
                <a:gd name="T18" fmla="*/ 1577 w 1598"/>
                <a:gd name="T19" fmla="*/ 2451 h 2574"/>
                <a:gd name="T20" fmla="*/ 1359 w 1598"/>
                <a:gd name="T21" fmla="*/ 2565 h 2574"/>
                <a:gd name="T22" fmla="*/ 1542 w 1598"/>
                <a:gd name="T23" fmla="*/ 2381 h 2574"/>
                <a:gd name="T24" fmla="*/ 1527 w 1598"/>
                <a:gd name="T25" fmla="*/ 2435 h 2574"/>
                <a:gd name="T26" fmla="*/ 224 w 1598"/>
                <a:gd name="T27" fmla="*/ 64 h 2574"/>
                <a:gd name="T28" fmla="*/ 273 w 1598"/>
                <a:gd name="T29" fmla="*/ 80 h 2574"/>
                <a:gd name="T30" fmla="*/ 56 w 1598"/>
                <a:gd name="T31" fmla="*/ 193 h 2574"/>
                <a:gd name="T32" fmla="*/ 71 w 1598"/>
                <a:gd name="T33" fmla="*/ 139 h 2574"/>
                <a:gd name="T34" fmla="*/ 1374 w 1598"/>
                <a:gd name="T35" fmla="*/ 2510 h 2574"/>
                <a:gd name="T36" fmla="*/ 1325 w 1598"/>
                <a:gd name="T37" fmla="*/ 2494 h 2574"/>
                <a:gd name="T38" fmla="*/ 1542 w 1598"/>
                <a:gd name="T39" fmla="*/ 2381 h 25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1598" h="2574">
                  <a:moveTo>
                    <a:pt x="1359" y="2565"/>
                  </a:moveTo>
                  <a:cubicBezTo>
                    <a:pt x="1342" y="2574"/>
                    <a:pt x="1320" y="2567"/>
                    <a:pt x="1310" y="2548"/>
                  </a:cubicBezTo>
                  <a:lnTo>
                    <a:pt x="6" y="177"/>
                  </a:lnTo>
                  <a:cubicBezTo>
                    <a:pt x="1" y="168"/>
                    <a:pt x="0" y="156"/>
                    <a:pt x="3" y="146"/>
                  </a:cubicBezTo>
                  <a:cubicBezTo>
                    <a:pt x="5" y="136"/>
                    <a:pt x="12" y="127"/>
                    <a:pt x="21" y="123"/>
                  </a:cubicBezTo>
                  <a:lnTo>
                    <a:pt x="239" y="9"/>
                  </a:lnTo>
                  <a:cubicBezTo>
                    <a:pt x="256" y="0"/>
                    <a:pt x="278" y="7"/>
                    <a:pt x="288" y="26"/>
                  </a:cubicBezTo>
                  <a:lnTo>
                    <a:pt x="1592" y="2397"/>
                  </a:lnTo>
                  <a:cubicBezTo>
                    <a:pt x="1597" y="2406"/>
                    <a:pt x="1598" y="2417"/>
                    <a:pt x="1596" y="2428"/>
                  </a:cubicBezTo>
                  <a:cubicBezTo>
                    <a:pt x="1593" y="2438"/>
                    <a:pt x="1586" y="2446"/>
                    <a:pt x="1577" y="2451"/>
                  </a:cubicBezTo>
                  <a:lnTo>
                    <a:pt x="1359" y="2565"/>
                  </a:lnTo>
                  <a:close/>
                  <a:moveTo>
                    <a:pt x="1542" y="2381"/>
                  </a:moveTo>
                  <a:lnTo>
                    <a:pt x="1527" y="2435"/>
                  </a:lnTo>
                  <a:lnTo>
                    <a:pt x="224" y="64"/>
                  </a:lnTo>
                  <a:lnTo>
                    <a:pt x="273" y="80"/>
                  </a:lnTo>
                  <a:lnTo>
                    <a:pt x="56" y="193"/>
                  </a:lnTo>
                  <a:lnTo>
                    <a:pt x="71" y="139"/>
                  </a:lnTo>
                  <a:lnTo>
                    <a:pt x="1374" y="2510"/>
                  </a:lnTo>
                  <a:lnTo>
                    <a:pt x="1325" y="2494"/>
                  </a:lnTo>
                  <a:lnTo>
                    <a:pt x="1542" y="2381"/>
                  </a:lnTo>
                  <a:close/>
                </a:path>
              </a:pathLst>
            </a:custGeom>
            <a:solidFill>
              <a:srgbClr val="C00000"/>
            </a:solidFill>
            <a:ln w="0" cap="flat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" name="Freeform 220">
              <a:extLst>
                <a:ext uri="{FF2B5EF4-FFF2-40B4-BE49-F238E27FC236}">
                  <a16:creationId xmlns:a16="http://schemas.microsoft.com/office/drawing/2014/main" id="{593763E0-0A2F-4CC8-B4D2-D52E3632006A}"/>
                </a:ext>
              </a:extLst>
            </p:cNvPr>
            <p:cNvSpPr>
              <a:spLocks/>
            </p:cNvSpPr>
            <p:nvPr/>
          </p:nvSpPr>
          <p:spPr bwMode="auto">
            <a:xfrm>
              <a:off x="645" y="2612"/>
              <a:ext cx="63" cy="105"/>
            </a:xfrm>
            <a:custGeom>
              <a:avLst/>
              <a:gdLst>
                <a:gd name="T0" fmla="*/ 1358 w 1611"/>
                <a:gd name="T1" fmla="*/ 2378 h 2705"/>
                <a:gd name="T2" fmla="*/ 1225 w 1611"/>
                <a:gd name="T3" fmla="*/ 1808 h 2705"/>
                <a:gd name="T4" fmla="*/ 1100 w 1611"/>
                <a:gd name="T5" fmla="*/ 1594 h 2705"/>
                <a:gd name="T6" fmla="*/ 1018 w 1611"/>
                <a:gd name="T7" fmla="*/ 1527 h 2705"/>
                <a:gd name="T8" fmla="*/ 905 w 1611"/>
                <a:gd name="T9" fmla="*/ 1474 h 2705"/>
                <a:gd name="T10" fmla="*/ 606 w 1611"/>
                <a:gd name="T11" fmla="*/ 1363 h 2705"/>
                <a:gd name="T12" fmla="*/ 300 w 1611"/>
                <a:gd name="T13" fmla="*/ 1254 h 2705"/>
                <a:gd name="T14" fmla="*/ 141 w 1611"/>
                <a:gd name="T15" fmla="*/ 1166 h 2705"/>
                <a:gd name="T16" fmla="*/ 41 w 1611"/>
                <a:gd name="T17" fmla="*/ 1043 h 2705"/>
                <a:gd name="T18" fmla="*/ 0 w 1611"/>
                <a:gd name="T19" fmla="*/ 901 h 2705"/>
                <a:gd name="T20" fmla="*/ 11 w 1611"/>
                <a:gd name="T21" fmla="*/ 771 h 2705"/>
                <a:gd name="T22" fmla="*/ 43 w 1611"/>
                <a:gd name="T23" fmla="*/ 635 h 2705"/>
                <a:gd name="T24" fmla="*/ 208 w 1611"/>
                <a:gd name="T25" fmla="*/ 281 h 2705"/>
                <a:gd name="T26" fmla="*/ 279 w 1611"/>
                <a:gd name="T27" fmla="*/ 132 h 2705"/>
                <a:gd name="T28" fmla="*/ 421 w 1611"/>
                <a:gd name="T29" fmla="*/ 12 h 2705"/>
                <a:gd name="T30" fmla="*/ 515 w 1611"/>
                <a:gd name="T31" fmla="*/ 151 h 2705"/>
                <a:gd name="T32" fmla="*/ 501 w 1611"/>
                <a:gd name="T33" fmla="*/ 245 h 2705"/>
                <a:gd name="T34" fmla="*/ 291 w 1611"/>
                <a:gd name="T35" fmla="*/ 140 h 2705"/>
                <a:gd name="T36" fmla="*/ 385 w 1611"/>
                <a:gd name="T37" fmla="*/ 238 h 2705"/>
                <a:gd name="T38" fmla="*/ 504 w 1611"/>
                <a:gd name="T39" fmla="*/ 165 h 2705"/>
                <a:gd name="T40" fmla="*/ 448 w 1611"/>
                <a:gd name="T41" fmla="*/ 300 h 2705"/>
                <a:gd name="T42" fmla="*/ 298 w 1611"/>
                <a:gd name="T43" fmla="*/ 605 h 2705"/>
                <a:gd name="T44" fmla="*/ 251 w 1611"/>
                <a:gd name="T45" fmla="*/ 711 h 2705"/>
                <a:gd name="T46" fmla="*/ 228 w 1611"/>
                <a:gd name="T47" fmla="*/ 810 h 2705"/>
                <a:gd name="T48" fmla="*/ 213 w 1611"/>
                <a:gd name="T49" fmla="*/ 874 h 2705"/>
                <a:gd name="T50" fmla="*/ 220 w 1611"/>
                <a:gd name="T51" fmla="*/ 928 h 2705"/>
                <a:gd name="T52" fmla="*/ 267 w 1611"/>
                <a:gd name="T53" fmla="*/ 983 h 2705"/>
                <a:gd name="T54" fmla="*/ 508 w 1611"/>
                <a:gd name="T55" fmla="*/ 1091 h 2705"/>
                <a:gd name="T56" fmla="*/ 836 w 1611"/>
                <a:gd name="T57" fmla="*/ 1201 h 2705"/>
                <a:gd name="T58" fmla="*/ 1139 w 1611"/>
                <a:gd name="T59" fmla="*/ 1338 h 2705"/>
                <a:gd name="T60" fmla="*/ 1265 w 1611"/>
                <a:gd name="T61" fmla="*/ 1454 h 2705"/>
                <a:gd name="T62" fmla="*/ 1424 w 1611"/>
                <a:gd name="T63" fmla="*/ 1718 h 2705"/>
                <a:gd name="T64" fmla="*/ 1525 w 1611"/>
                <a:gd name="T65" fmla="*/ 2042 h 2705"/>
                <a:gd name="T66" fmla="*/ 1611 w 1611"/>
                <a:gd name="T67" fmla="*/ 2688 h 27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1611" h="2705">
                  <a:moveTo>
                    <a:pt x="1391" y="2705"/>
                  </a:moveTo>
                  <a:lnTo>
                    <a:pt x="1358" y="2378"/>
                  </a:lnTo>
                  <a:lnTo>
                    <a:pt x="1309" y="2073"/>
                  </a:lnTo>
                  <a:lnTo>
                    <a:pt x="1225" y="1808"/>
                  </a:lnTo>
                  <a:lnTo>
                    <a:pt x="1238" y="1831"/>
                  </a:lnTo>
                  <a:lnTo>
                    <a:pt x="1100" y="1594"/>
                  </a:lnTo>
                  <a:lnTo>
                    <a:pt x="1122" y="1622"/>
                  </a:lnTo>
                  <a:lnTo>
                    <a:pt x="1018" y="1527"/>
                  </a:lnTo>
                  <a:lnTo>
                    <a:pt x="1041" y="1547"/>
                  </a:lnTo>
                  <a:lnTo>
                    <a:pt x="905" y="1474"/>
                  </a:lnTo>
                  <a:lnTo>
                    <a:pt x="762" y="1415"/>
                  </a:lnTo>
                  <a:lnTo>
                    <a:pt x="606" y="1363"/>
                  </a:lnTo>
                  <a:lnTo>
                    <a:pt x="442" y="1310"/>
                  </a:lnTo>
                  <a:lnTo>
                    <a:pt x="300" y="1254"/>
                  </a:lnTo>
                  <a:lnTo>
                    <a:pt x="167" y="1185"/>
                  </a:lnTo>
                  <a:cubicBezTo>
                    <a:pt x="159" y="1180"/>
                    <a:pt x="146" y="1172"/>
                    <a:pt x="141" y="1166"/>
                  </a:cubicBezTo>
                  <a:lnTo>
                    <a:pt x="67" y="1088"/>
                  </a:lnTo>
                  <a:cubicBezTo>
                    <a:pt x="53" y="1073"/>
                    <a:pt x="46" y="1060"/>
                    <a:pt x="41" y="1043"/>
                  </a:cubicBezTo>
                  <a:lnTo>
                    <a:pt x="8" y="947"/>
                  </a:lnTo>
                  <a:cubicBezTo>
                    <a:pt x="1" y="934"/>
                    <a:pt x="0" y="915"/>
                    <a:pt x="0" y="901"/>
                  </a:cubicBezTo>
                  <a:lnTo>
                    <a:pt x="6" y="791"/>
                  </a:lnTo>
                  <a:cubicBezTo>
                    <a:pt x="7" y="783"/>
                    <a:pt x="9" y="775"/>
                    <a:pt x="11" y="771"/>
                  </a:cubicBezTo>
                  <a:lnTo>
                    <a:pt x="40" y="651"/>
                  </a:lnTo>
                  <a:cubicBezTo>
                    <a:pt x="38" y="644"/>
                    <a:pt x="40" y="640"/>
                    <a:pt x="43" y="635"/>
                  </a:cubicBezTo>
                  <a:lnTo>
                    <a:pt x="92" y="514"/>
                  </a:lnTo>
                  <a:lnTo>
                    <a:pt x="208" y="281"/>
                  </a:lnTo>
                  <a:lnTo>
                    <a:pt x="252" y="191"/>
                  </a:lnTo>
                  <a:lnTo>
                    <a:pt x="279" y="132"/>
                  </a:lnTo>
                  <a:lnTo>
                    <a:pt x="294" y="83"/>
                  </a:lnTo>
                  <a:cubicBezTo>
                    <a:pt x="315" y="29"/>
                    <a:pt x="368" y="0"/>
                    <a:pt x="421" y="12"/>
                  </a:cubicBezTo>
                  <a:lnTo>
                    <a:pt x="429" y="14"/>
                  </a:lnTo>
                  <a:cubicBezTo>
                    <a:pt x="489" y="28"/>
                    <a:pt x="527" y="89"/>
                    <a:pt x="515" y="151"/>
                  </a:cubicBezTo>
                  <a:lnTo>
                    <a:pt x="508" y="191"/>
                  </a:lnTo>
                  <a:lnTo>
                    <a:pt x="501" y="245"/>
                  </a:lnTo>
                  <a:lnTo>
                    <a:pt x="282" y="210"/>
                  </a:lnTo>
                  <a:lnTo>
                    <a:pt x="291" y="140"/>
                  </a:lnTo>
                  <a:lnTo>
                    <a:pt x="299" y="100"/>
                  </a:lnTo>
                  <a:lnTo>
                    <a:pt x="385" y="238"/>
                  </a:lnTo>
                  <a:lnTo>
                    <a:pt x="378" y="236"/>
                  </a:lnTo>
                  <a:lnTo>
                    <a:pt x="504" y="165"/>
                  </a:lnTo>
                  <a:lnTo>
                    <a:pt x="479" y="232"/>
                  </a:lnTo>
                  <a:lnTo>
                    <a:pt x="448" y="300"/>
                  </a:lnTo>
                  <a:lnTo>
                    <a:pt x="404" y="390"/>
                  </a:lnTo>
                  <a:lnTo>
                    <a:pt x="298" y="605"/>
                  </a:lnTo>
                  <a:lnTo>
                    <a:pt x="248" y="726"/>
                  </a:lnTo>
                  <a:lnTo>
                    <a:pt x="251" y="711"/>
                  </a:lnTo>
                  <a:lnTo>
                    <a:pt x="223" y="830"/>
                  </a:lnTo>
                  <a:lnTo>
                    <a:pt x="228" y="810"/>
                  </a:lnTo>
                  <a:lnTo>
                    <a:pt x="222" y="920"/>
                  </a:lnTo>
                  <a:lnTo>
                    <a:pt x="213" y="874"/>
                  </a:lnTo>
                  <a:lnTo>
                    <a:pt x="245" y="970"/>
                  </a:lnTo>
                  <a:lnTo>
                    <a:pt x="220" y="928"/>
                  </a:lnTo>
                  <a:lnTo>
                    <a:pt x="294" y="1006"/>
                  </a:lnTo>
                  <a:lnTo>
                    <a:pt x="267" y="983"/>
                  </a:lnTo>
                  <a:lnTo>
                    <a:pt x="367" y="1039"/>
                  </a:lnTo>
                  <a:lnTo>
                    <a:pt x="508" y="1091"/>
                  </a:lnTo>
                  <a:lnTo>
                    <a:pt x="664" y="1143"/>
                  </a:lnTo>
                  <a:lnTo>
                    <a:pt x="836" y="1201"/>
                  </a:lnTo>
                  <a:lnTo>
                    <a:pt x="1002" y="1266"/>
                  </a:lnTo>
                  <a:lnTo>
                    <a:pt x="1139" y="1338"/>
                  </a:lnTo>
                  <a:cubicBezTo>
                    <a:pt x="1147" y="1343"/>
                    <a:pt x="1156" y="1348"/>
                    <a:pt x="1162" y="1358"/>
                  </a:cubicBezTo>
                  <a:lnTo>
                    <a:pt x="1265" y="1454"/>
                  </a:lnTo>
                  <a:cubicBezTo>
                    <a:pt x="1275" y="1462"/>
                    <a:pt x="1281" y="1472"/>
                    <a:pt x="1287" y="1481"/>
                  </a:cubicBezTo>
                  <a:lnTo>
                    <a:pt x="1424" y="1718"/>
                  </a:lnTo>
                  <a:cubicBezTo>
                    <a:pt x="1430" y="1724"/>
                    <a:pt x="1432" y="1734"/>
                    <a:pt x="1434" y="1741"/>
                  </a:cubicBezTo>
                  <a:lnTo>
                    <a:pt x="1525" y="2042"/>
                  </a:lnTo>
                  <a:lnTo>
                    <a:pt x="1577" y="2360"/>
                  </a:lnTo>
                  <a:lnTo>
                    <a:pt x="1611" y="2688"/>
                  </a:lnTo>
                  <a:lnTo>
                    <a:pt x="1391" y="2705"/>
                  </a:lnTo>
                  <a:close/>
                </a:path>
              </a:pathLst>
            </a:custGeom>
            <a:solidFill>
              <a:srgbClr val="C3D69B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" name="Freeform 221">
              <a:extLst>
                <a:ext uri="{FF2B5EF4-FFF2-40B4-BE49-F238E27FC236}">
                  <a16:creationId xmlns:a16="http://schemas.microsoft.com/office/drawing/2014/main" id="{DB05CEC9-8348-4C2C-AF3B-6CA382AE3DF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43" y="2611"/>
              <a:ext cx="66" cy="108"/>
            </a:xfrm>
            <a:custGeom>
              <a:avLst/>
              <a:gdLst>
                <a:gd name="T0" fmla="*/ 1311 w 1687"/>
                <a:gd name="T1" fmla="*/ 2114 h 2775"/>
                <a:gd name="T2" fmla="*/ 1295 w 1687"/>
                <a:gd name="T3" fmla="*/ 1895 h 2775"/>
                <a:gd name="T4" fmla="*/ 1188 w 1687"/>
                <a:gd name="T5" fmla="*/ 1627 h 2775"/>
                <a:gd name="T6" fmla="*/ 1079 w 1687"/>
                <a:gd name="T7" fmla="*/ 1526 h 2775"/>
                <a:gd name="T8" fmla="*/ 787 w 1687"/>
                <a:gd name="T9" fmla="*/ 1481 h 2775"/>
                <a:gd name="T10" fmla="*/ 172 w 1687"/>
                <a:gd name="T11" fmla="*/ 1239 h 2775"/>
                <a:gd name="T12" fmla="*/ 45 w 1687"/>
                <a:gd name="T13" fmla="*/ 1088 h 2775"/>
                <a:gd name="T14" fmla="*/ 6 w 1687"/>
                <a:gd name="T15" fmla="*/ 817 h 2775"/>
                <a:gd name="T16" fmla="*/ 46 w 1687"/>
                <a:gd name="T17" fmla="*/ 648 h 2775"/>
                <a:gd name="T18" fmla="*/ 296 w 1687"/>
                <a:gd name="T19" fmla="*/ 99 h 2775"/>
                <a:gd name="T20" fmla="*/ 370 w 1687"/>
                <a:gd name="T21" fmla="*/ 15 h 2775"/>
                <a:gd name="T22" fmla="*/ 474 w 1687"/>
                <a:gd name="T23" fmla="*/ 5 h 2775"/>
                <a:gd name="T24" fmla="*/ 571 w 1687"/>
                <a:gd name="T25" fmla="*/ 80 h 2775"/>
                <a:gd name="T26" fmla="*/ 582 w 1687"/>
                <a:gd name="T27" fmla="*/ 229 h 2775"/>
                <a:gd name="T28" fmla="*/ 282 w 1687"/>
                <a:gd name="T29" fmla="*/ 233 h 2775"/>
                <a:gd name="T30" fmla="*/ 453 w 1687"/>
                <a:gd name="T31" fmla="*/ 247 h 2775"/>
                <a:gd name="T32" fmla="*/ 397 w 1687"/>
                <a:gd name="T33" fmla="*/ 231 h 2775"/>
                <a:gd name="T34" fmla="*/ 519 w 1687"/>
                <a:gd name="T35" fmla="*/ 347 h 2775"/>
                <a:gd name="T36" fmla="*/ 249 w 1687"/>
                <a:gd name="T37" fmla="*/ 746 h 2775"/>
                <a:gd name="T38" fmla="*/ 229 w 1687"/>
                <a:gd name="T39" fmla="*/ 828 h 2775"/>
                <a:gd name="T40" fmla="*/ 223 w 1687"/>
                <a:gd name="T41" fmla="*/ 956 h 2775"/>
                <a:gd name="T42" fmla="*/ 299 w 1687"/>
                <a:gd name="T43" fmla="*/ 1035 h 2775"/>
                <a:gd name="T44" fmla="*/ 357 w 1687"/>
                <a:gd name="T45" fmla="*/ 1008 h 2775"/>
                <a:gd name="T46" fmla="*/ 321 w 1687"/>
                <a:gd name="T47" fmla="*/ 978 h 2775"/>
                <a:gd name="T48" fmla="*/ 884 w 1687"/>
                <a:gd name="T49" fmla="*/ 1193 h 2775"/>
                <a:gd name="T50" fmla="*/ 1226 w 1687"/>
                <a:gd name="T51" fmla="*/ 1361 h 2775"/>
                <a:gd name="T52" fmla="*/ 1505 w 1687"/>
                <a:gd name="T53" fmla="*/ 1755 h 2775"/>
                <a:gd name="T54" fmla="*/ 1652 w 1687"/>
                <a:gd name="T55" fmla="*/ 2757 h 2775"/>
                <a:gd name="T56" fmla="*/ 1527 w 1687"/>
                <a:gd name="T57" fmla="*/ 2082 h 2775"/>
                <a:gd name="T58" fmla="*/ 1278 w 1687"/>
                <a:gd name="T59" fmla="*/ 1513 h 2775"/>
                <a:gd name="T60" fmla="*/ 1027 w 1687"/>
                <a:gd name="T61" fmla="*/ 1332 h 2775"/>
                <a:gd name="T62" fmla="*/ 388 w 1687"/>
                <a:gd name="T63" fmla="*/ 1103 h 2775"/>
                <a:gd name="T64" fmla="*/ 231 w 1687"/>
                <a:gd name="T65" fmla="*/ 985 h 2775"/>
                <a:gd name="T66" fmla="*/ 287 w 1687"/>
                <a:gd name="T67" fmla="*/ 897 h 2775"/>
                <a:gd name="T68" fmla="*/ 297 w 1687"/>
                <a:gd name="T69" fmla="*/ 871 h 2775"/>
                <a:gd name="T70" fmla="*/ 325 w 1687"/>
                <a:gd name="T71" fmla="*/ 750 h 2775"/>
                <a:gd name="T72" fmla="*/ 452 w 1687"/>
                <a:gd name="T73" fmla="*/ 312 h 2775"/>
                <a:gd name="T74" fmla="*/ 424 w 1687"/>
                <a:gd name="T75" fmla="*/ 228 h 2775"/>
                <a:gd name="T76" fmla="*/ 365 w 1687"/>
                <a:gd name="T77" fmla="*/ 176 h 2775"/>
                <a:gd name="T78" fmla="*/ 509 w 1687"/>
                <a:gd name="T79" fmla="*/ 212 h 2775"/>
                <a:gd name="T80" fmla="*/ 502 w 1687"/>
                <a:gd name="T81" fmla="*/ 109 h 2775"/>
                <a:gd name="T82" fmla="*/ 459 w 1687"/>
                <a:gd name="T83" fmla="*/ 82 h 2775"/>
                <a:gd name="T84" fmla="*/ 396 w 1687"/>
                <a:gd name="T85" fmla="*/ 90 h 2775"/>
                <a:gd name="T86" fmla="*/ 367 w 1687"/>
                <a:gd name="T87" fmla="*/ 126 h 2775"/>
                <a:gd name="T88" fmla="*/ 115 w 1687"/>
                <a:gd name="T89" fmla="*/ 681 h 2775"/>
                <a:gd name="T90" fmla="*/ 81 w 1687"/>
                <a:gd name="T91" fmla="*/ 824 h 2775"/>
                <a:gd name="T92" fmla="*/ 112 w 1687"/>
                <a:gd name="T93" fmla="*/ 1057 h 2775"/>
                <a:gd name="T94" fmla="*/ 209 w 1687"/>
                <a:gd name="T95" fmla="*/ 1172 h 2775"/>
                <a:gd name="T96" fmla="*/ 812 w 1687"/>
                <a:gd name="T97" fmla="*/ 1408 h 2775"/>
                <a:gd name="T98" fmla="*/ 1079 w 1687"/>
                <a:gd name="T99" fmla="*/ 1527 h 2775"/>
                <a:gd name="T100" fmla="*/ 1307 w 1687"/>
                <a:gd name="T101" fmla="*/ 1841 h 2775"/>
                <a:gd name="T102" fmla="*/ 1383 w 1687"/>
                <a:gd name="T103" fmla="*/ 2097 h 27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1687" h="2775">
                  <a:moveTo>
                    <a:pt x="1432" y="2774"/>
                  </a:moveTo>
                  <a:cubicBezTo>
                    <a:pt x="1412" y="2775"/>
                    <a:pt x="1394" y="2759"/>
                    <a:pt x="1391" y="2737"/>
                  </a:cubicBezTo>
                  <a:lnTo>
                    <a:pt x="1358" y="2410"/>
                  </a:lnTo>
                  <a:lnTo>
                    <a:pt x="1310" y="2108"/>
                  </a:lnTo>
                  <a:lnTo>
                    <a:pt x="1311" y="2114"/>
                  </a:lnTo>
                  <a:lnTo>
                    <a:pt x="1227" y="1849"/>
                  </a:lnTo>
                  <a:cubicBezTo>
                    <a:pt x="1221" y="1830"/>
                    <a:pt x="1229" y="1809"/>
                    <a:pt x="1247" y="1801"/>
                  </a:cubicBezTo>
                  <a:cubicBezTo>
                    <a:pt x="1264" y="1793"/>
                    <a:pt x="1285" y="1801"/>
                    <a:pt x="1294" y="1818"/>
                  </a:cubicBezTo>
                  <a:lnTo>
                    <a:pt x="1307" y="1841"/>
                  </a:lnTo>
                  <a:cubicBezTo>
                    <a:pt x="1318" y="1860"/>
                    <a:pt x="1312" y="1884"/>
                    <a:pt x="1295" y="1895"/>
                  </a:cubicBezTo>
                  <a:cubicBezTo>
                    <a:pt x="1278" y="1905"/>
                    <a:pt x="1255" y="1899"/>
                    <a:pt x="1244" y="1880"/>
                  </a:cubicBezTo>
                  <a:lnTo>
                    <a:pt x="1106" y="1643"/>
                  </a:lnTo>
                  <a:cubicBezTo>
                    <a:pt x="1095" y="1626"/>
                    <a:pt x="1100" y="1603"/>
                    <a:pt x="1115" y="1591"/>
                  </a:cubicBezTo>
                  <a:cubicBezTo>
                    <a:pt x="1131" y="1579"/>
                    <a:pt x="1153" y="1583"/>
                    <a:pt x="1166" y="1599"/>
                  </a:cubicBezTo>
                  <a:lnTo>
                    <a:pt x="1188" y="1627"/>
                  </a:lnTo>
                  <a:cubicBezTo>
                    <a:pt x="1200" y="1643"/>
                    <a:pt x="1200" y="1666"/>
                    <a:pt x="1186" y="1680"/>
                  </a:cubicBezTo>
                  <a:cubicBezTo>
                    <a:pt x="1172" y="1694"/>
                    <a:pt x="1150" y="1694"/>
                    <a:pt x="1135" y="1681"/>
                  </a:cubicBezTo>
                  <a:lnTo>
                    <a:pt x="1031" y="1586"/>
                  </a:lnTo>
                  <a:cubicBezTo>
                    <a:pt x="1016" y="1572"/>
                    <a:pt x="1014" y="1547"/>
                    <a:pt x="1027" y="1531"/>
                  </a:cubicBezTo>
                  <a:cubicBezTo>
                    <a:pt x="1039" y="1514"/>
                    <a:pt x="1063" y="1513"/>
                    <a:pt x="1079" y="1526"/>
                  </a:cubicBezTo>
                  <a:lnTo>
                    <a:pt x="1102" y="1546"/>
                  </a:lnTo>
                  <a:cubicBezTo>
                    <a:pt x="1117" y="1559"/>
                    <a:pt x="1120" y="1582"/>
                    <a:pt x="1110" y="1598"/>
                  </a:cubicBezTo>
                  <a:cubicBezTo>
                    <a:pt x="1100" y="1615"/>
                    <a:pt x="1079" y="1621"/>
                    <a:pt x="1062" y="1611"/>
                  </a:cubicBezTo>
                  <a:lnTo>
                    <a:pt x="926" y="1538"/>
                  </a:lnTo>
                  <a:lnTo>
                    <a:pt x="787" y="1481"/>
                  </a:lnTo>
                  <a:lnTo>
                    <a:pt x="633" y="1430"/>
                  </a:lnTo>
                  <a:lnTo>
                    <a:pt x="469" y="1377"/>
                  </a:lnTo>
                  <a:lnTo>
                    <a:pt x="325" y="1320"/>
                  </a:lnTo>
                  <a:lnTo>
                    <a:pt x="189" y="1250"/>
                  </a:lnTo>
                  <a:lnTo>
                    <a:pt x="172" y="1239"/>
                  </a:lnTo>
                  <a:lnTo>
                    <a:pt x="156" y="1226"/>
                  </a:lnTo>
                  <a:lnTo>
                    <a:pt x="78" y="1145"/>
                  </a:lnTo>
                  <a:lnTo>
                    <a:pt x="59" y="1119"/>
                  </a:lnTo>
                  <a:cubicBezTo>
                    <a:pt x="57" y="1116"/>
                    <a:pt x="56" y="1114"/>
                    <a:pt x="55" y="1111"/>
                  </a:cubicBezTo>
                  <a:lnTo>
                    <a:pt x="45" y="1088"/>
                  </a:lnTo>
                  <a:lnTo>
                    <a:pt x="10" y="989"/>
                  </a:lnTo>
                  <a:lnTo>
                    <a:pt x="3" y="964"/>
                  </a:lnTo>
                  <a:cubicBezTo>
                    <a:pt x="2" y="961"/>
                    <a:pt x="1" y="958"/>
                    <a:pt x="1" y="954"/>
                  </a:cubicBezTo>
                  <a:lnTo>
                    <a:pt x="0" y="931"/>
                  </a:lnTo>
                  <a:lnTo>
                    <a:pt x="6" y="817"/>
                  </a:lnTo>
                  <a:cubicBezTo>
                    <a:pt x="6" y="814"/>
                    <a:pt x="7" y="812"/>
                    <a:pt x="7" y="809"/>
                  </a:cubicBezTo>
                  <a:lnTo>
                    <a:pt x="12" y="789"/>
                  </a:lnTo>
                  <a:lnTo>
                    <a:pt x="41" y="670"/>
                  </a:lnTo>
                  <a:lnTo>
                    <a:pt x="44" y="656"/>
                  </a:lnTo>
                  <a:cubicBezTo>
                    <a:pt x="44" y="653"/>
                    <a:pt x="45" y="651"/>
                    <a:pt x="46" y="648"/>
                  </a:cubicBezTo>
                  <a:lnTo>
                    <a:pt x="95" y="527"/>
                  </a:lnTo>
                  <a:lnTo>
                    <a:pt x="212" y="291"/>
                  </a:lnTo>
                  <a:lnTo>
                    <a:pt x="256" y="202"/>
                  </a:lnTo>
                  <a:lnTo>
                    <a:pt x="283" y="144"/>
                  </a:lnTo>
                  <a:lnTo>
                    <a:pt x="296" y="99"/>
                  </a:lnTo>
                  <a:cubicBezTo>
                    <a:pt x="297" y="97"/>
                    <a:pt x="298" y="94"/>
                    <a:pt x="300" y="91"/>
                  </a:cubicBezTo>
                  <a:lnTo>
                    <a:pt x="321" y="55"/>
                  </a:lnTo>
                  <a:cubicBezTo>
                    <a:pt x="323" y="51"/>
                    <a:pt x="326" y="47"/>
                    <a:pt x="330" y="45"/>
                  </a:cubicBezTo>
                  <a:lnTo>
                    <a:pt x="361" y="21"/>
                  </a:lnTo>
                  <a:cubicBezTo>
                    <a:pt x="364" y="18"/>
                    <a:pt x="367" y="16"/>
                    <a:pt x="370" y="15"/>
                  </a:cubicBezTo>
                  <a:lnTo>
                    <a:pt x="406" y="2"/>
                  </a:lnTo>
                  <a:cubicBezTo>
                    <a:pt x="411" y="1"/>
                    <a:pt x="415" y="0"/>
                    <a:pt x="420" y="0"/>
                  </a:cubicBezTo>
                  <a:lnTo>
                    <a:pt x="459" y="2"/>
                  </a:lnTo>
                  <a:cubicBezTo>
                    <a:pt x="461" y="2"/>
                    <a:pt x="464" y="3"/>
                    <a:pt x="466" y="3"/>
                  </a:cubicBezTo>
                  <a:lnTo>
                    <a:pt x="474" y="5"/>
                  </a:lnTo>
                  <a:cubicBezTo>
                    <a:pt x="476" y="6"/>
                    <a:pt x="479" y="7"/>
                    <a:pt x="481" y="8"/>
                  </a:cubicBezTo>
                  <a:lnTo>
                    <a:pt x="521" y="27"/>
                  </a:lnTo>
                  <a:cubicBezTo>
                    <a:pt x="525" y="29"/>
                    <a:pt x="529" y="32"/>
                    <a:pt x="533" y="35"/>
                  </a:cubicBezTo>
                  <a:lnTo>
                    <a:pt x="563" y="67"/>
                  </a:lnTo>
                  <a:cubicBezTo>
                    <a:pt x="566" y="71"/>
                    <a:pt x="569" y="75"/>
                    <a:pt x="571" y="80"/>
                  </a:cubicBezTo>
                  <a:lnTo>
                    <a:pt x="587" y="120"/>
                  </a:lnTo>
                  <a:cubicBezTo>
                    <a:pt x="589" y="125"/>
                    <a:pt x="590" y="130"/>
                    <a:pt x="590" y="136"/>
                  </a:cubicBezTo>
                  <a:lnTo>
                    <a:pt x="590" y="182"/>
                  </a:lnTo>
                  <a:cubicBezTo>
                    <a:pt x="590" y="184"/>
                    <a:pt x="590" y="186"/>
                    <a:pt x="589" y="189"/>
                  </a:cubicBezTo>
                  <a:lnTo>
                    <a:pt x="582" y="229"/>
                  </a:lnTo>
                  <a:lnTo>
                    <a:pt x="575" y="281"/>
                  </a:lnTo>
                  <a:cubicBezTo>
                    <a:pt x="573" y="302"/>
                    <a:pt x="554" y="317"/>
                    <a:pt x="534" y="313"/>
                  </a:cubicBezTo>
                  <a:lnTo>
                    <a:pt x="315" y="278"/>
                  </a:lnTo>
                  <a:cubicBezTo>
                    <a:pt x="305" y="277"/>
                    <a:pt x="296" y="271"/>
                    <a:pt x="290" y="263"/>
                  </a:cubicBezTo>
                  <a:cubicBezTo>
                    <a:pt x="284" y="254"/>
                    <a:pt x="281" y="243"/>
                    <a:pt x="282" y="233"/>
                  </a:cubicBezTo>
                  <a:lnTo>
                    <a:pt x="291" y="163"/>
                  </a:lnTo>
                  <a:lnTo>
                    <a:pt x="300" y="120"/>
                  </a:lnTo>
                  <a:cubicBezTo>
                    <a:pt x="303" y="105"/>
                    <a:pt x="315" y="93"/>
                    <a:pt x="329" y="91"/>
                  </a:cubicBezTo>
                  <a:cubicBezTo>
                    <a:pt x="344" y="88"/>
                    <a:pt x="359" y="95"/>
                    <a:pt x="367" y="109"/>
                  </a:cubicBezTo>
                  <a:lnTo>
                    <a:pt x="453" y="247"/>
                  </a:lnTo>
                  <a:cubicBezTo>
                    <a:pt x="462" y="260"/>
                    <a:pt x="462" y="278"/>
                    <a:pt x="453" y="291"/>
                  </a:cubicBezTo>
                  <a:cubicBezTo>
                    <a:pt x="444" y="304"/>
                    <a:pt x="429" y="310"/>
                    <a:pt x="414" y="305"/>
                  </a:cubicBezTo>
                  <a:lnTo>
                    <a:pt x="407" y="303"/>
                  </a:lnTo>
                  <a:cubicBezTo>
                    <a:pt x="392" y="299"/>
                    <a:pt x="381" y="286"/>
                    <a:pt x="379" y="270"/>
                  </a:cubicBezTo>
                  <a:cubicBezTo>
                    <a:pt x="376" y="254"/>
                    <a:pt x="384" y="238"/>
                    <a:pt x="397" y="231"/>
                  </a:cubicBezTo>
                  <a:lnTo>
                    <a:pt x="523" y="160"/>
                  </a:lnTo>
                  <a:cubicBezTo>
                    <a:pt x="537" y="152"/>
                    <a:pt x="554" y="154"/>
                    <a:pt x="566" y="166"/>
                  </a:cubicBezTo>
                  <a:cubicBezTo>
                    <a:pt x="578" y="177"/>
                    <a:pt x="582" y="194"/>
                    <a:pt x="576" y="210"/>
                  </a:cubicBezTo>
                  <a:lnTo>
                    <a:pt x="551" y="277"/>
                  </a:lnTo>
                  <a:lnTo>
                    <a:pt x="519" y="347"/>
                  </a:lnTo>
                  <a:lnTo>
                    <a:pt x="475" y="438"/>
                  </a:lnTo>
                  <a:lnTo>
                    <a:pt x="369" y="653"/>
                  </a:lnTo>
                  <a:lnTo>
                    <a:pt x="320" y="772"/>
                  </a:lnTo>
                  <a:cubicBezTo>
                    <a:pt x="312" y="790"/>
                    <a:pt x="293" y="799"/>
                    <a:pt x="274" y="793"/>
                  </a:cubicBezTo>
                  <a:cubicBezTo>
                    <a:pt x="256" y="786"/>
                    <a:pt x="245" y="766"/>
                    <a:pt x="249" y="746"/>
                  </a:cubicBezTo>
                  <a:lnTo>
                    <a:pt x="252" y="731"/>
                  </a:lnTo>
                  <a:lnTo>
                    <a:pt x="325" y="751"/>
                  </a:lnTo>
                  <a:lnTo>
                    <a:pt x="297" y="870"/>
                  </a:lnTo>
                  <a:lnTo>
                    <a:pt x="224" y="848"/>
                  </a:lnTo>
                  <a:lnTo>
                    <a:pt x="229" y="828"/>
                  </a:lnTo>
                  <a:cubicBezTo>
                    <a:pt x="234" y="809"/>
                    <a:pt x="252" y="797"/>
                    <a:pt x="271" y="801"/>
                  </a:cubicBezTo>
                  <a:cubicBezTo>
                    <a:pt x="290" y="805"/>
                    <a:pt x="304" y="823"/>
                    <a:pt x="303" y="843"/>
                  </a:cubicBezTo>
                  <a:lnTo>
                    <a:pt x="297" y="953"/>
                  </a:lnTo>
                  <a:cubicBezTo>
                    <a:pt x="296" y="973"/>
                    <a:pt x="281" y="988"/>
                    <a:pt x="262" y="989"/>
                  </a:cubicBezTo>
                  <a:cubicBezTo>
                    <a:pt x="244" y="990"/>
                    <a:pt x="227" y="976"/>
                    <a:pt x="223" y="956"/>
                  </a:cubicBezTo>
                  <a:lnTo>
                    <a:pt x="214" y="910"/>
                  </a:lnTo>
                  <a:cubicBezTo>
                    <a:pt x="210" y="890"/>
                    <a:pt x="222" y="870"/>
                    <a:pt x="240" y="865"/>
                  </a:cubicBezTo>
                  <a:cubicBezTo>
                    <a:pt x="259" y="860"/>
                    <a:pt x="279" y="872"/>
                    <a:pt x="286" y="891"/>
                  </a:cubicBezTo>
                  <a:lnTo>
                    <a:pt x="318" y="987"/>
                  </a:lnTo>
                  <a:cubicBezTo>
                    <a:pt x="324" y="1006"/>
                    <a:pt x="316" y="1027"/>
                    <a:pt x="299" y="1035"/>
                  </a:cubicBezTo>
                  <a:cubicBezTo>
                    <a:pt x="282" y="1044"/>
                    <a:pt x="261" y="1037"/>
                    <a:pt x="251" y="1020"/>
                  </a:cubicBezTo>
                  <a:lnTo>
                    <a:pt x="226" y="978"/>
                  </a:lnTo>
                  <a:cubicBezTo>
                    <a:pt x="216" y="961"/>
                    <a:pt x="219" y="938"/>
                    <a:pt x="234" y="926"/>
                  </a:cubicBezTo>
                  <a:cubicBezTo>
                    <a:pt x="249" y="914"/>
                    <a:pt x="270" y="916"/>
                    <a:pt x="283" y="930"/>
                  </a:cubicBezTo>
                  <a:lnTo>
                    <a:pt x="357" y="1008"/>
                  </a:lnTo>
                  <a:cubicBezTo>
                    <a:pt x="372" y="1023"/>
                    <a:pt x="373" y="1047"/>
                    <a:pt x="360" y="1062"/>
                  </a:cubicBezTo>
                  <a:cubicBezTo>
                    <a:pt x="347" y="1077"/>
                    <a:pt x="324" y="1079"/>
                    <a:pt x="309" y="1066"/>
                  </a:cubicBezTo>
                  <a:lnTo>
                    <a:pt x="282" y="1043"/>
                  </a:lnTo>
                  <a:cubicBezTo>
                    <a:pt x="266" y="1030"/>
                    <a:pt x="263" y="1007"/>
                    <a:pt x="273" y="990"/>
                  </a:cubicBezTo>
                  <a:cubicBezTo>
                    <a:pt x="283" y="974"/>
                    <a:pt x="304" y="968"/>
                    <a:pt x="321" y="978"/>
                  </a:cubicBezTo>
                  <a:lnTo>
                    <a:pt x="421" y="1034"/>
                  </a:lnTo>
                  <a:lnTo>
                    <a:pt x="416" y="1031"/>
                  </a:lnTo>
                  <a:lnTo>
                    <a:pt x="557" y="1083"/>
                  </a:lnTo>
                  <a:lnTo>
                    <a:pt x="712" y="1135"/>
                  </a:lnTo>
                  <a:lnTo>
                    <a:pt x="884" y="1193"/>
                  </a:lnTo>
                  <a:lnTo>
                    <a:pt x="1052" y="1259"/>
                  </a:lnTo>
                  <a:lnTo>
                    <a:pt x="1192" y="1332"/>
                  </a:lnTo>
                  <a:lnTo>
                    <a:pt x="1208" y="1342"/>
                  </a:lnTo>
                  <a:cubicBezTo>
                    <a:pt x="1210" y="1344"/>
                    <a:pt x="1213" y="1346"/>
                    <a:pt x="1215" y="1349"/>
                  </a:cubicBezTo>
                  <a:lnTo>
                    <a:pt x="1226" y="1361"/>
                  </a:lnTo>
                  <a:lnTo>
                    <a:pt x="1327" y="1454"/>
                  </a:lnTo>
                  <a:lnTo>
                    <a:pt x="1352" y="1485"/>
                  </a:lnTo>
                  <a:cubicBezTo>
                    <a:pt x="1354" y="1487"/>
                    <a:pt x="1355" y="1489"/>
                    <a:pt x="1356" y="1491"/>
                  </a:cubicBezTo>
                  <a:lnTo>
                    <a:pt x="1493" y="1728"/>
                  </a:lnTo>
                  <a:lnTo>
                    <a:pt x="1505" y="1755"/>
                  </a:lnTo>
                  <a:lnTo>
                    <a:pt x="1598" y="2061"/>
                  </a:lnTo>
                  <a:lnTo>
                    <a:pt x="1651" y="2384"/>
                  </a:lnTo>
                  <a:lnTo>
                    <a:pt x="1686" y="2714"/>
                  </a:lnTo>
                  <a:cubicBezTo>
                    <a:pt x="1687" y="2725"/>
                    <a:pt x="1684" y="2735"/>
                    <a:pt x="1677" y="2743"/>
                  </a:cubicBezTo>
                  <a:cubicBezTo>
                    <a:pt x="1671" y="2751"/>
                    <a:pt x="1662" y="2756"/>
                    <a:pt x="1652" y="2757"/>
                  </a:cubicBezTo>
                  <a:lnTo>
                    <a:pt x="1432" y="2774"/>
                  </a:lnTo>
                  <a:close/>
                  <a:moveTo>
                    <a:pt x="1645" y="2678"/>
                  </a:moveTo>
                  <a:lnTo>
                    <a:pt x="1611" y="2721"/>
                  </a:lnTo>
                  <a:lnTo>
                    <a:pt x="1578" y="2395"/>
                  </a:lnTo>
                  <a:lnTo>
                    <a:pt x="1527" y="2082"/>
                  </a:lnTo>
                  <a:lnTo>
                    <a:pt x="1438" y="1786"/>
                  </a:lnTo>
                  <a:lnTo>
                    <a:pt x="1430" y="1767"/>
                  </a:lnTo>
                  <a:lnTo>
                    <a:pt x="1293" y="1530"/>
                  </a:lnTo>
                  <a:lnTo>
                    <a:pt x="1296" y="1536"/>
                  </a:lnTo>
                  <a:lnTo>
                    <a:pt x="1278" y="1513"/>
                  </a:lnTo>
                  <a:lnTo>
                    <a:pt x="1173" y="1414"/>
                  </a:lnTo>
                  <a:lnTo>
                    <a:pt x="1162" y="1402"/>
                  </a:lnTo>
                  <a:lnTo>
                    <a:pt x="1169" y="1409"/>
                  </a:lnTo>
                  <a:lnTo>
                    <a:pt x="1161" y="1403"/>
                  </a:lnTo>
                  <a:lnTo>
                    <a:pt x="1027" y="1332"/>
                  </a:lnTo>
                  <a:lnTo>
                    <a:pt x="863" y="1268"/>
                  </a:lnTo>
                  <a:lnTo>
                    <a:pt x="691" y="1210"/>
                  </a:lnTo>
                  <a:lnTo>
                    <a:pt x="534" y="1158"/>
                  </a:lnTo>
                  <a:lnTo>
                    <a:pt x="393" y="1106"/>
                  </a:lnTo>
                  <a:cubicBezTo>
                    <a:pt x="391" y="1105"/>
                    <a:pt x="389" y="1104"/>
                    <a:pt x="388" y="1103"/>
                  </a:cubicBezTo>
                  <a:lnTo>
                    <a:pt x="288" y="1047"/>
                  </a:lnTo>
                  <a:lnTo>
                    <a:pt x="327" y="982"/>
                  </a:lnTo>
                  <a:lnTo>
                    <a:pt x="354" y="1005"/>
                  </a:lnTo>
                  <a:lnTo>
                    <a:pt x="305" y="1063"/>
                  </a:lnTo>
                  <a:lnTo>
                    <a:pt x="231" y="985"/>
                  </a:lnTo>
                  <a:lnTo>
                    <a:pt x="289" y="937"/>
                  </a:lnTo>
                  <a:lnTo>
                    <a:pt x="314" y="979"/>
                  </a:lnTo>
                  <a:lnTo>
                    <a:pt x="247" y="1012"/>
                  </a:lnTo>
                  <a:lnTo>
                    <a:pt x="215" y="916"/>
                  </a:lnTo>
                  <a:lnTo>
                    <a:pt x="287" y="897"/>
                  </a:lnTo>
                  <a:lnTo>
                    <a:pt x="296" y="943"/>
                  </a:lnTo>
                  <a:lnTo>
                    <a:pt x="222" y="946"/>
                  </a:lnTo>
                  <a:lnTo>
                    <a:pt x="228" y="836"/>
                  </a:lnTo>
                  <a:lnTo>
                    <a:pt x="302" y="851"/>
                  </a:lnTo>
                  <a:lnTo>
                    <a:pt x="297" y="871"/>
                  </a:lnTo>
                  <a:cubicBezTo>
                    <a:pt x="291" y="891"/>
                    <a:pt x="271" y="903"/>
                    <a:pt x="251" y="897"/>
                  </a:cubicBezTo>
                  <a:cubicBezTo>
                    <a:pt x="231" y="891"/>
                    <a:pt x="219" y="870"/>
                    <a:pt x="224" y="849"/>
                  </a:cubicBezTo>
                  <a:lnTo>
                    <a:pt x="252" y="730"/>
                  </a:lnTo>
                  <a:cubicBezTo>
                    <a:pt x="257" y="709"/>
                    <a:pt x="277" y="697"/>
                    <a:pt x="297" y="702"/>
                  </a:cubicBezTo>
                  <a:cubicBezTo>
                    <a:pt x="317" y="708"/>
                    <a:pt x="329" y="729"/>
                    <a:pt x="325" y="750"/>
                  </a:cubicBezTo>
                  <a:lnTo>
                    <a:pt x="322" y="765"/>
                  </a:lnTo>
                  <a:lnTo>
                    <a:pt x="251" y="739"/>
                  </a:lnTo>
                  <a:lnTo>
                    <a:pt x="302" y="616"/>
                  </a:lnTo>
                  <a:lnTo>
                    <a:pt x="408" y="401"/>
                  </a:lnTo>
                  <a:lnTo>
                    <a:pt x="452" y="312"/>
                  </a:lnTo>
                  <a:lnTo>
                    <a:pt x="482" y="246"/>
                  </a:lnTo>
                  <a:lnTo>
                    <a:pt x="507" y="179"/>
                  </a:lnTo>
                  <a:lnTo>
                    <a:pt x="560" y="229"/>
                  </a:lnTo>
                  <a:lnTo>
                    <a:pt x="434" y="300"/>
                  </a:lnTo>
                  <a:lnTo>
                    <a:pt x="424" y="228"/>
                  </a:lnTo>
                  <a:lnTo>
                    <a:pt x="431" y="230"/>
                  </a:lnTo>
                  <a:lnTo>
                    <a:pt x="391" y="288"/>
                  </a:lnTo>
                  <a:lnTo>
                    <a:pt x="305" y="150"/>
                  </a:lnTo>
                  <a:lnTo>
                    <a:pt x="373" y="139"/>
                  </a:lnTo>
                  <a:lnTo>
                    <a:pt x="365" y="176"/>
                  </a:lnTo>
                  <a:lnTo>
                    <a:pt x="356" y="246"/>
                  </a:lnTo>
                  <a:lnTo>
                    <a:pt x="324" y="201"/>
                  </a:lnTo>
                  <a:lnTo>
                    <a:pt x="543" y="236"/>
                  </a:lnTo>
                  <a:lnTo>
                    <a:pt x="501" y="268"/>
                  </a:lnTo>
                  <a:lnTo>
                    <a:pt x="509" y="212"/>
                  </a:lnTo>
                  <a:lnTo>
                    <a:pt x="516" y="172"/>
                  </a:lnTo>
                  <a:lnTo>
                    <a:pt x="515" y="179"/>
                  </a:lnTo>
                  <a:lnTo>
                    <a:pt x="515" y="133"/>
                  </a:lnTo>
                  <a:lnTo>
                    <a:pt x="518" y="149"/>
                  </a:lnTo>
                  <a:lnTo>
                    <a:pt x="502" y="109"/>
                  </a:lnTo>
                  <a:lnTo>
                    <a:pt x="510" y="122"/>
                  </a:lnTo>
                  <a:lnTo>
                    <a:pt x="480" y="90"/>
                  </a:lnTo>
                  <a:lnTo>
                    <a:pt x="492" y="98"/>
                  </a:lnTo>
                  <a:lnTo>
                    <a:pt x="452" y="79"/>
                  </a:lnTo>
                  <a:lnTo>
                    <a:pt x="459" y="82"/>
                  </a:lnTo>
                  <a:lnTo>
                    <a:pt x="451" y="80"/>
                  </a:lnTo>
                  <a:lnTo>
                    <a:pt x="458" y="81"/>
                  </a:lnTo>
                  <a:lnTo>
                    <a:pt x="419" y="79"/>
                  </a:lnTo>
                  <a:lnTo>
                    <a:pt x="432" y="77"/>
                  </a:lnTo>
                  <a:lnTo>
                    <a:pt x="396" y="90"/>
                  </a:lnTo>
                  <a:lnTo>
                    <a:pt x="406" y="84"/>
                  </a:lnTo>
                  <a:lnTo>
                    <a:pt x="375" y="108"/>
                  </a:lnTo>
                  <a:lnTo>
                    <a:pt x="384" y="98"/>
                  </a:lnTo>
                  <a:lnTo>
                    <a:pt x="363" y="134"/>
                  </a:lnTo>
                  <a:lnTo>
                    <a:pt x="367" y="126"/>
                  </a:lnTo>
                  <a:lnTo>
                    <a:pt x="350" y="179"/>
                  </a:lnTo>
                  <a:lnTo>
                    <a:pt x="323" y="239"/>
                  </a:lnTo>
                  <a:lnTo>
                    <a:pt x="279" y="330"/>
                  </a:lnTo>
                  <a:lnTo>
                    <a:pt x="164" y="560"/>
                  </a:lnTo>
                  <a:lnTo>
                    <a:pt x="115" y="681"/>
                  </a:lnTo>
                  <a:lnTo>
                    <a:pt x="117" y="673"/>
                  </a:lnTo>
                  <a:lnTo>
                    <a:pt x="114" y="691"/>
                  </a:lnTo>
                  <a:lnTo>
                    <a:pt x="85" y="812"/>
                  </a:lnTo>
                  <a:lnTo>
                    <a:pt x="80" y="832"/>
                  </a:lnTo>
                  <a:lnTo>
                    <a:pt x="81" y="824"/>
                  </a:lnTo>
                  <a:lnTo>
                    <a:pt x="75" y="930"/>
                  </a:lnTo>
                  <a:lnTo>
                    <a:pt x="76" y="953"/>
                  </a:lnTo>
                  <a:lnTo>
                    <a:pt x="74" y="942"/>
                  </a:lnTo>
                  <a:lnTo>
                    <a:pt x="81" y="964"/>
                  </a:lnTo>
                  <a:lnTo>
                    <a:pt x="112" y="1057"/>
                  </a:lnTo>
                  <a:lnTo>
                    <a:pt x="122" y="1080"/>
                  </a:lnTo>
                  <a:lnTo>
                    <a:pt x="118" y="1072"/>
                  </a:lnTo>
                  <a:lnTo>
                    <a:pt x="130" y="1090"/>
                  </a:lnTo>
                  <a:lnTo>
                    <a:pt x="201" y="1165"/>
                  </a:lnTo>
                  <a:lnTo>
                    <a:pt x="209" y="1172"/>
                  </a:lnTo>
                  <a:lnTo>
                    <a:pt x="220" y="1179"/>
                  </a:lnTo>
                  <a:lnTo>
                    <a:pt x="350" y="1247"/>
                  </a:lnTo>
                  <a:lnTo>
                    <a:pt x="489" y="1302"/>
                  </a:lnTo>
                  <a:lnTo>
                    <a:pt x="654" y="1355"/>
                  </a:lnTo>
                  <a:lnTo>
                    <a:pt x="812" y="1408"/>
                  </a:lnTo>
                  <a:lnTo>
                    <a:pt x="959" y="1469"/>
                  </a:lnTo>
                  <a:lnTo>
                    <a:pt x="1095" y="1542"/>
                  </a:lnTo>
                  <a:lnTo>
                    <a:pt x="1055" y="1606"/>
                  </a:lnTo>
                  <a:lnTo>
                    <a:pt x="1032" y="1586"/>
                  </a:lnTo>
                  <a:lnTo>
                    <a:pt x="1079" y="1527"/>
                  </a:lnTo>
                  <a:lnTo>
                    <a:pt x="1183" y="1622"/>
                  </a:lnTo>
                  <a:lnTo>
                    <a:pt x="1131" y="1676"/>
                  </a:lnTo>
                  <a:lnTo>
                    <a:pt x="1109" y="1648"/>
                  </a:lnTo>
                  <a:lnTo>
                    <a:pt x="1169" y="1604"/>
                  </a:lnTo>
                  <a:lnTo>
                    <a:pt x="1307" y="1841"/>
                  </a:lnTo>
                  <a:lnTo>
                    <a:pt x="1244" y="1880"/>
                  </a:lnTo>
                  <a:lnTo>
                    <a:pt x="1231" y="1857"/>
                  </a:lnTo>
                  <a:lnTo>
                    <a:pt x="1298" y="1826"/>
                  </a:lnTo>
                  <a:lnTo>
                    <a:pt x="1382" y="2091"/>
                  </a:lnTo>
                  <a:cubicBezTo>
                    <a:pt x="1382" y="2093"/>
                    <a:pt x="1383" y="2095"/>
                    <a:pt x="1383" y="2097"/>
                  </a:cubicBezTo>
                  <a:lnTo>
                    <a:pt x="1433" y="2404"/>
                  </a:lnTo>
                  <a:lnTo>
                    <a:pt x="1466" y="2731"/>
                  </a:lnTo>
                  <a:lnTo>
                    <a:pt x="1425" y="2695"/>
                  </a:lnTo>
                  <a:lnTo>
                    <a:pt x="1645" y="2678"/>
                  </a:lnTo>
                  <a:close/>
                </a:path>
              </a:pathLst>
            </a:custGeom>
            <a:solidFill>
              <a:srgbClr val="C3D69B"/>
            </a:solidFill>
            <a:ln w="0" cap="flat">
              <a:solidFill>
                <a:srgbClr val="C3D69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" name="Freeform 222">
              <a:extLst>
                <a:ext uri="{FF2B5EF4-FFF2-40B4-BE49-F238E27FC236}">
                  <a16:creationId xmlns:a16="http://schemas.microsoft.com/office/drawing/2014/main" id="{F7733667-F0B0-4FC1-B45F-FA9B1F9ECE82}"/>
                </a:ext>
              </a:extLst>
            </p:cNvPr>
            <p:cNvSpPr>
              <a:spLocks/>
            </p:cNvSpPr>
            <p:nvPr/>
          </p:nvSpPr>
          <p:spPr bwMode="auto">
            <a:xfrm>
              <a:off x="500" y="2552"/>
              <a:ext cx="60" cy="121"/>
            </a:xfrm>
            <a:custGeom>
              <a:avLst/>
              <a:gdLst>
                <a:gd name="T0" fmla="*/ 268 w 1557"/>
                <a:gd name="T1" fmla="*/ 367 h 3108"/>
                <a:gd name="T2" fmla="*/ 424 w 1557"/>
                <a:gd name="T3" fmla="*/ 1021 h 3108"/>
                <a:gd name="T4" fmla="*/ 558 w 1557"/>
                <a:gd name="T5" fmla="*/ 1282 h 3108"/>
                <a:gd name="T6" fmla="*/ 637 w 1557"/>
                <a:gd name="T7" fmla="*/ 1368 h 3108"/>
                <a:gd name="T8" fmla="*/ 743 w 1557"/>
                <a:gd name="T9" fmla="*/ 1446 h 3108"/>
                <a:gd name="T10" fmla="*/ 1012 w 1557"/>
                <a:gd name="T11" fmla="*/ 1591 h 3108"/>
                <a:gd name="T12" fmla="*/ 1284 w 1557"/>
                <a:gd name="T13" fmla="*/ 1732 h 3108"/>
                <a:gd name="T14" fmla="*/ 1399 w 1557"/>
                <a:gd name="T15" fmla="*/ 1819 h 3108"/>
                <a:gd name="T16" fmla="*/ 1493 w 1557"/>
                <a:gd name="T17" fmla="*/ 1931 h 3108"/>
                <a:gd name="T18" fmla="*/ 1544 w 1557"/>
                <a:gd name="T19" fmla="*/ 2085 h 3108"/>
                <a:gd name="T20" fmla="*/ 1556 w 1557"/>
                <a:gd name="T21" fmla="*/ 2238 h 3108"/>
                <a:gd name="T22" fmla="*/ 1537 w 1557"/>
                <a:gd name="T23" fmla="*/ 2391 h 3108"/>
                <a:gd name="T24" fmla="*/ 1423 w 1557"/>
                <a:gd name="T25" fmla="*/ 2790 h 3108"/>
                <a:gd name="T26" fmla="*/ 1370 w 1557"/>
                <a:gd name="T27" fmla="*/ 2952 h 3108"/>
                <a:gd name="T28" fmla="*/ 1230 w 1557"/>
                <a:gd name="T29" fmla="*/ 3092 h 3108"/>
                <a:gd name="T30" fmla="*/ 1132 w 1557"/>
                <a:gd name="T31" fmla="*/ 2966 h 3108"/>
                <a:gd name="T32" fmla="*/ 1143 w 1557"/>
                <a:gd name="T33" fmla="*/ 2845 h 3108"/>
                <a:gd name="T34" fmla="*/ 1356 w 1557"/>
                <a:gd name="T35" fmla="*/ 2941 h 3108"/>
                <a:gd name="T36" fmla="*/ 1264 w 1557"/>
                <a:gd name="T37" fmla="*/ 2863 h 3108"/>
                <a:gd name="T38" fmla="*/ 1145 w 1557"/>
                <a:gd name="T39" fmla="*/ 2947 h 3108"/>
                <a:gd name="T40" fmla="*/ 1181 w 1557"/>
                <a:gd name="T41" fmla="*/ 2801 h 3108"/>
                <a:gd name="T42" fmla="*/ 1290 w 1557"/>
                <a:gd name="T43" fmla="*/ 2476 h 3108"/>
                <a:gd name="T44" fmla="*/ 1335 w 1557"/>
                <a:gd name="T45" fmla="*/ 2220 h 3108"/>
                <a:gd name="T46" fmla="*/ 1329 w 1557"/>
                <a:gd name="T47" fmla="*/ 2116 h 3108"/>
                <a:gd name="T48" fmla="*/ 1301 w 1557"/>
                <a:gd name="T49" fmla="*/ 2039 h 3108"/>
                <a:gd name="T50" fmla="*/ 1252 w 1557"/>
                <a:gd name="T51" fmla="*/ 1988 h 3108"/>
                <a:gd name="T52" fmla="*/ 1173 w 1557"/>
                <a:gd name="T53" fmla="*/ 1929 h 3108"/>
                <a:gd name="T54" fmla="*/ 1062 w 1557"/>
                <a:gd name="T55" fmla="*/ 1871 h 3108"/>
                <a:gd name="T56" fmla="*/ 633 w 1557"/>
                <a:gd name="T57" fmla="*/ 1646 h 3108"/>
                <a:gd name="T58" fmla="*/ 494 w 1557"/>
                <a:gd name="T59" fmla="*/ 1539 h 3108"/>
                <a:gd name="T60" fmla="*/ 378 w 1557"/>
                <a:gd name="T61" fmla="*/ 1410 h 3108"/>
                <a:gd name="T62" fmla="*/ 223 w 1557"/>
                <a:gd name="T63" fmla="*/ 1105 h 3108"/>
                <a:gd name="T64" fmla="*/ 119 w 1557"/>
                <a:gd name="T65" fmla="*/ 753 h 3108"/>
                <a:gd name="T66" fmla="*/ 0 w 1557"/>
                <a:gd name="T67" fmla="*/ 24 h 3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1557" h="3108">
                  <a:moveTo>
                    <a:pt x="217" y="0"/>
                  </a:moveTo>
                  <a:lnTo>
                    <a:pt x="268" y="367"/>
                  </a:lnTo>
                  <a:lnTo>
                    <a:pt x="332" y="715"/>
                  </a:lnTo>
                  <a:lnTo>
                    <a:pt x="424" y="1021"/>
                  </a:lnTo>
                  <a:lnTo>
                    <a:pt x="420" y="1003"/>
                  </a:lnTo>
                  <a:lnTo>
                    <a:pt x="558" y="1282"/>
                  </a:lnTo>
                  <a:lnTo>
                    <a:pt x="540" y="1257"/>
                  </a:lnTo>
                  <a:lnTo>
                    <a:pt x="637" y="1368"/>
                  </a:lnTo>
                  <a:lnTo>
                    <a:pt x="618" y="1350"/>
                  </a:lnTo>
                  <a:lnTo>
                    <a:pt x="743" y="1446"/>
                  </a:lnTo>
                  <a:lnTo>
                    <a:pt x="730" y="1438"/>
                  </a:lnTo>
                  <a:lnTo>
                    <a:pt x="1012" y="1591"/>
                  </a:lnTo>
                  <a:lnTo>
                    <a:pt x="1147" y="1658"/>
                  </a:lnTo>
                  <a:lnTo>
                    <a:pt x="1284" y="1732"/>
                  </a:lnTo>
                  <a:cubicBezTo>
                    <a:pt x="1288" y="1735"/>
                    <a:pt x="1292" y="1737"/>
                    <a:pt x="1297" y="1740"/>
                  </a:cubicBezTo>
                  <a:lnTo>
                    <a:pt x="1399" y="1819"/>
                  </a:lnTo>
                  <a:cubicBezTo>
                    <a:pt x="1408" y="1825"/>
                    <a:pt x="1417" y="1834"/>
                    <a:pt x="1423" y="1840"/>
                  </a:cubicBezTo>
                  <a:lnTo>
                    <a:pt x="1493" y="1931"/>
                  </a:lnTo>
                  <a:cubicBezTo>
                    <a:pt x="1500" y="1945"/>
                    <a:pt x="1507" y="1958"/>
                    <a:pt x="1512" y="1976"/>
                  </a:cubicBezTo>
                  <a:lnTo>
                    <a:pt x="1544" y="2085"/>
                  </a:lnTo>
                  <a:cubicBezTo>
                    <a:pt x="1550" y="2091"/>
                    <a:pt x="1549" y="2103"/>
                    <a:pt x="1552" y="2113"/>
                  </a:cubicBezTo>
                  <a:lnTo>
                    <a:pt x="1556" y="2238"/>
                  </a:lnTo>
                  <a:cubicBezTo>
                    <a:pt x="1555" y="2246"/>
                    <a:pt x="1557" y="2253"/>
                    <a:pt x="1555" y="2257"/>
                  </a:cubicBezTo>
                  <a:lnTo>
                    <a:pt x="1537" y="2391"/>
                  </a:lnTo>
                  <a:lnTo>
                    <a:pt x="1508" y="2536"/>
                  </a:lnTo>
                  <a:lnTo>
                    <a:pt x="1423" y="2790"/>
                  </a:lnTo>
                  <a:lnTo>
                    <a:pt x="1391" y="2886"/>
                  </a:lnTo>
                  <a:lnTo>
                    <a:pt x="1370" y="2952"/>
                  </a:lnTo>
                  <a:lnTo>
                    <a:pt x="1357" y="3009"/>
                  </a:lnTo>
                  <a:cubicBezTo>
                    <a:pt x="1344" y="3069"/>
                    <a:pt x="1287" y="3108"/>
                    <a:pt x="1230" y="3092"/>
                  </a:cubicBezTo>
                  <a:lnTo>
                    <a:pt x="1222" y="3091"/>
                  </a:lnTo>
                  <a:cubicBezTo>
                    <a:pt x="1169" y="3078"/>
                    <a:pt x="1131" y="3027"/>
                    <a:pt x="1132" y="2966"/>
                  </a:cubicBezTo>
                  <a:lnTo>
                    <a:pt x="1134" y="2920"/>
                  </a:lnTo>
                  <a:lnTo>
                    <a:pt x="1143" y="2845"/>
                  </a:lnTo>
                  <a:lnTo>
                    <a:pt x="1360" y="2875"/>
                  </a:lnTo>
                  <a:lnTo>
                    <a:pt x="1356" y="2941"/>
                  </a:lnTo>
                  <a:lnTo>
                    <a:pt x="1354" y="2987"/>
                  </a:lnTo>
                  <a:lnTo>
                    <a:pt x="1264" y="2863"/>
                  </a:lnTo>
                  <a:lnTo>
                    <a:pt x="1272" y="2864"/>
                  </a:lnTo>
                  <a:lnTo>
                    <a:pt x="1145" y="2947"/>
                  </a:lnTo>
                  <a:lnTo>
                    <a:pt x="1161" y="2875"/>
                  </a:lnTo>
                  <a:lnTo>
                    <a:pt x="1181" y="2801"/>
                  </a:lnTo>
                  <a:lnTo>
                    <a:pt x="1212" y="2705"/>
                  </a:lnTo>
                  <a:lnTo>
                    <a:pt x="1290" y="2476"/>
                  </a:lnTo>
                  <a:lnTo>
                    <a:pt x="1318" y="2354"/>
                  </a:lnTo>
                  <a:lnTo>
                    <a:pt x="1335" y="2220"/>
                  </a:lnTo>
                  <a:lnTo>
                    <a:pt x="1333" y="2240"/>
                  </a:lnTo>
                  <a:lnTo>
                    <a:pt x="1329" y="2116"/>
                  </a:lnTo>
                  <a:lnTo>
                    <a:pt x="1334" y="2148"/>
                  </a:lnTo>
                  <a:lnTo>
                    <a:pt x="1301" y="2039"/>
                  </a:lnTo>
                  <a:lnTo>
                    <a:pt x="1323" y="2079"/>
                  </a:lnTo>
                  <a:lnTo>
                    <a:pt x="1252" y="1988"/>
                  </a:lnTo>
                  <a:lnTo>
                    <a:pt x="1275" y="2008"/>
                  </a:lnTo>
                  <a:lnTo>
                    <a:pt x="1173" y="1929"/>
                  </a:lnTo>
                  <a:lnTo>
                    <a:pt x="1186" y="1937"/>
                  </a:lnTo>
                  <a:lnTo>
                    <a:pt x="1062" y="1871"/>
                  </a:lnTo>
                  <a:lnTo>
                    <a:pt x="915" y="1800"/>
                  </a:lnTo>
                  <a:lnTo>
                    <a:pt x="633" y="1646"/>
                  </a:lnTo>
                  <a:cubicBezTo>
                    <a:pt x="628" y="1640"/>
                    <a:pt x="623" y="1637"/>
                    <a:pt x="619" y="1635"/>
                  </a:cubicBezTo>
                  <a:lnTo>
                    <a:pt x="494" y="1539"/>
                  </a:lnTo>
                  <a:cubicBezTo>
                    <a:pt x="486" y="1533"/>
                    <a:pt x="480" y="1527"/>
                    <a:pt x="475" y="1521"/>
                  </a:cubicBezTo>
                  <a:lnTo>
                    <a:pt x="378" y="1410"/>
                  </a:lnTo>
                  <a:cubicBezTo>
                    <a:pt x="373" y="1404"/>
                    <a:pt x="367" y="1394"/>
                    <a:pt x="361" y="1384"/>
                  </a:cubicBezTo>
                  <a:lnTo>
                    <a:pt x="223" y="1105"/>
                  </a:lnTo>
                  <a:cubicBezTo>
                    <a:pt x="221" y="1098"/>
                    <a:pt x="220" y="1094"/>
                    <a:pt x="215" y="1088"/>
                  </a:cubicBezTo>
                  <a:lnTo>
                    <a:pt x="119" y="753"/>
                  </a:lnTo>
                  <a:lnTo>
                    <a:pt x="51" y="390"/>
                  </a:lnTo>
                  <a:lnTo>
                    <a:pt x="0" y="24"/>
                  </a:lnTo>
                  <a:lnTo>
                    <a:pt x="217" y="0"/>
                  </a:lnTo>
                  <a:close/>
                </a:path>
              </a:pathLst>
            </a:custGeom>
            <a:solidFill>
              <a:srgbClr val="8EB4E3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" name="Freeform 223">
              <a:extLst>
                <a:ext uri="{FF2B5EF4-FFF2-40B4-BE49-F238E27FC236}">
                  <a16:creationId xmlns:a16="http://schemas.microsoft.com/office/drawing/2014/main" id="{3A16C684-E7ED-4519-BDF6-5D9DDBAD88E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98" y="2550"/>
              <a:ext cx="64" cy="124"/>
            </a:xfrm>
            <a:custGeom>
              <a:avLst/>
              <a:gdLst>
                <a:gd name="T0" fmla="*/ 498 w 1632"/>
                <a:gd name="T1" fmla="*/ 1052 h 3175"/>
                <a:gd name="T2" fmla="*/ 629 w 1632"/>
                <a:gd name="T3" fmla="*/ 1306 h 3175"/>
                <a:gd name="T4" fmla="*/ 606 w 1632"/>
                <a:gd name="T5" fmla="*/ 1272 h 3175"/>
                <a:gd name="T6" fmla="*/ 627 w 1632"/>
                <a:gd name="T7" fmla="*/ 1366 h 3175"/>
                <a:gd name="T8" fmla="*/ 750 w 1632"/>
                <a:gd name="T9" fmla="*/ 1513 h 3175"/>
                <a:gd name="T10" fmla="*/ 1339 w 1632"/>
                <a:gd name="T11" fmla="*/ 1739 h 3175"/>
                <a:gd name="T12" fmla="*/ 1560 w 1632"/>
                <a:gd name="T13" fmla="*/ 1948 h 3175"/>
                <a:gd name="T14" fmla="*/ 1622 w 1632"/>
                <a:gd name="T15" fmla="*/ 2126 h 3175"/>
                <a:gd name="T16" fmla="*/ 1631 w 1632"/>
                <a:gd name="T17" fmla="*/ 2302 h 3175"/>
                <a:gd name="T18" fmla="*/ 1444 w 1632"/>
                <a:gd name="T19" fmla="*/ 3007 h 3175"/>
                <a:gd name="T20" fmla="*/ 1374 w 1632"/>
                <a:gd name="T21" fmla="*/ 3150 h 3175"/>
                <a:gd name="T22" fmla="*/ 1257 w 1632"/>
                <a:gd name="T23" fmla="*/ 3172 h 3175"/>
                <a:gd name="T24" fmla="*/ 1163 w 1632"/>
                <a:gd name="T25" fmla="*/ 3106 h 3175"/>
                <a:gd name="T26" fmla="*/ 1135 w 1632"/>
                <a:gd name="T27" fmla="*/ 2959 h 3175"/>
                <a:gd name="T28" fmla="*/ 1432 w 1632"/>
                <a:gd name="T29" fmla="*/ 2986 h 3175"/>
                <a:gd name="T30" fmla="*/ 1270 w 1632"/>
                <a:gd name="T31" fmla="*/ 2885 h 3175"/>
                <a:gd name="T32" fmla="*/ 1204 w 1632"/>
                <a:gd name="T33" fmla="*/ 3022 h 3175"/>
                <a:gd name="T34" fmla="*/ 1215 w 1632"/>
                <a:gd name="T35" fmla="*/ 2733 h 3175"/>
                <a:gd name="T36" fmla="*/ 1411 w 1632"/>
                <a:gd name="T37" fmla="*/ 2267 h 3175"/>
                <a:gd name="T38" fmla="*/ 1364 w 1632"/>
                <a:gd name="T39" fmla="*/ 2118 h 3175"/>
                <a:gd name="T40" fmla="*/ 1304 w 1632"/>
                <a:gd name="T41" fmla="*/ 2091 h 3175"/>
                <a:gd name="T42" fmla="*/ 1333 w 1632"/>
                <a:gd name="T43" fmla="*/ 2145 h 3175"/>
                <a:gd name="T44" fmla="*/ 1343 w 1632"/>
                <a:gd name="T45" fmla="*/ 2074 h 3175"/>
                <a:gd name="T46" fmla="*/ 1243 w 1632"/>
                <a:gd name="T47" fmla="*/ 1945 h 3175"/>
                <a:gd name="T48" fmla="*/ 655 w 1632"/>
                <a:gd name="T49" fmla="*/ 1722 h 3175"/>
                <a:gd name="T50" fmla="*/ 389 w 1632"/>
                <a:gd name="T51" fmla="*/ 1478 h 3175"/>
                <a:gd name="T52" fmla="*/ 218 w 1632"/>
                <a:gd name="T53" fmla="*/ 1140 h 3175"/>
                <a:gd name="T54" fmla="*/ 33 w 1632"/>
                <a:gd name="T55" fmla="*/ 26 h 3175"/>
                <a:gd name="T56" fmla="*/ 193 w 1632"/>
                <a:gd name="T57" fmla="*/ 784 h 3175"/>
                <a:gd name="T58" fmla="*/ 447 w 1632"/>
                <a:gd name="T59" fmla="*/ 1430 h 3175"/>
                <a:gd name="T60" fmla="*/ 693 w 1632"/>
                <a:gd name="T61" fmla="*/ 1656 h 3175"/>
                <a:gd name="T62" fmla="*/ 1206 w 1632"/>
                <a:gd name="T63" fmla="*/ 2012 h 3175"/>
                <a:gd name="T64" fmla="*/ 1267 w 1632"/>
                <a:gd name="T65" fmla="*/ 2059 h 3175"/>
                <a:gd name="T66" fmla="*/ 1375 w 1632"/>
                <a:gd name="T67" fmla="*/ 2070 h 3175"/>
                <a:gd name="T68" fmla="*/ 1409 w 1632"/>
                <a:gd name="T69" fmla="*/ 2281 h 3175"/>
                <a:gd name="T70" fmla="*/ 1364 w 1632"/>
                <a:gd name="T71" fmla="*/ 2532 h 3175"/>
                <a:gd name="T72" fmla="*/ 1163 w 1632"/>
                <a:gd name="T73" fmla="*/ 2955 h 3175"/>
                <a:gd name="T74" fmla="*/ 1422 w 1632"/>
                <a:gd name="T75" fmla="*/ 3005 h 3175"/>
                <a:gd name="T76" fmla="*/ 1178 w 1632"/>
                <a:gd name="T77" fmla="*/ 2925 h 3175"/>
                <a:gd name="T78" fmla="*/ 1213 w 1632"/>
                <a:gd name="T79" fmla="*/ 3046 h 3175"/>
                <a:gd name="T80" fmla="*/ 1237 w 1632"/>
                <a:gd name="T81" fmla="*/ 3080 h 3175"/>
                <a:gd name="T82" fmla="*/ 1296 w 1632"/>
                <a:gd name="T83" fmla="*/ 3099 h 3175"/>
                <a:gd name="T84" fmla="*/ 1361 w 1632"/>
                <a:gd name="T85" fmla="*/ 3034 h 3175"/>
                <a:gd name="T86" fmla="*/ 1510 w 1632"/>
                <a:gd name="T87" fmla="*/ 2568 h 3175"/>
                <a:gd name="T88" fmla="*/ 1554 w 1632"/>
                <a:gd name="T89" fmla="*/ 2161 h 3175"/>
                <a:gd name="T90" fmla="*/ 1508 w 1632"/>
                <a:gd name="T91" fmla="*/ 2010 h 3175"/>
                <a:gd name="T92" fmla="*/ 1416 w 1632"/>
                <a:gd name="T93" fmla="*/ 1892 h 3175"/>
                <a:gd name="T94" fmla="*/ 752 w 1632"/>
                <a:gd name="T95" fmla="*/ 1514 h 3175"/>
                <a:gd name="T96" fmla="*/ 681 w 1632"/>
                <a:gd name="T97" fmla="*/ 1363 h 3175"/>
                <a:gd name="T98" fmla="*/ 626 w 1632"/>
                <a:gd name="T99" fmla="*/ 1300 h 3175"/>
                <a:gd name="T100" fmla="*/ 472 w 1632"/>
                <a:gd name="T101" fmla="*/ 1101 h 3175"/>
                <a:gd name="T102" fmla="*/ 260 w 1632"/>
                <a:gd name="T103" fmla="*/ 81 h 3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1632" h="3175">
                  <a:moveTo>
                    <a:pt x="250" y="2"/>
                  </a:moveTo>
                  <a:cubicBezTo>
                    <a:pt x="271" y="0"/>
                    <a:pt x="289" y="16"/>
                    <a:pt x="292" y="37"/>
                  </a:cubicBezTo>
                  <a:lnTo>
                    <a:pt x="343" y="404"/>
                  </a:lnTo>
                  <a:lnTo>
                    <a:pt x="407" y="750"/>
                  </a:lnTo>
                  <a:lnTo>
                    <a:pt x="498" y="1052"/>
                  </a:lnTo>
                  <a:lnTo>
                    <a:pt x="426" y="1070"/>
                  </a:lnTo>
                  <a:lnTo>
                    <a:pt x="422" y="1052"/>
                  </a:lnTo>
                  <a:cubicBezTo>
                    <a:pt x="418" y="1033"/>
                    <a:pt x="428" y="1014"/>
                    <a:pt x="445" y="1007"/>
                  </a:cubicBezTo>
                  <a:cubicBezTo>
                    <a:pt x="463" y="1001"/>
                    <a:pt x="483" y="1009"/>
                    <a:pt x="491" y="1027"/>
                  </a:cubicBezTo>
                  <a:lnTo>
                    <a:pt x="629" y="1306"/>
                  </a:lnTo>
                  <a:cubicBezTo>
                    <a:pt x="639" y="1324"/>
                    <a:pt x="633" y="1347"/>
                    <a:pt x="617" y="1357"/>
                  </a:cubicBezTo>
                  <a:cubicBezTo>
                    <a:pt x="600" y="1368"/>
                    <a:pt x="579" y="1363"/>
                    <a:pt x="567" y="1347"/>
                  </a:cubicBezTo>
                  <a:lnTo>
                    <a:pt x="549" y="1322"/>
                  </a:lnTo>
                  <a:cubicBezTo>
                    <a:pt x="537" y="1305"/>
                    <a:pt x="539" y="1281"/>
                    <a:pt x="554" y="1268"/>
                  </a:cubicBezTo>
                  <a:cubicBezTo>
                    <a:pt x="569" y="1255"/>
                    <a:pt x="592" y="1257"/>
                    <a:pt x="606" y="1272"/>
                  </a:cubicBezTo>
                  <a:lnTo>
                    <a:pt x="703" y="1383"/>
                  </a:lnTo>
                  <a:cubicBezTo>
                    <a:pt x="716" y="1399"/>
                    <a:pt x="716" y="1423"/>
                    <a:pt x="702" y="1438"/>
                  </a:cubicBezTo>
                  <a:cubicBezTo>
                    <a:pt x="689" y="1452"/>
                    <a:pt x="666" y="1453"/>
                    <a:pt x="651" y="1438"/>
                  </a:cubicBezTo>
                  <a:lnTo>
                    <a:pt x="632" y="1420"/>
                  </a:lnTo>
                  <a:cubicBezTo>
                    <a:pt x="617" y="1406"/>
                    <a:pt x="615" y="1382"/>
                    <a:pt x="627" y="1366"/>
                  </a:cubicBezTo>
                  <a:cubicBezTo>
                    <a:pt x="639" y="1350"/>
                    <a:pt x="662" y="1347"/>
                    <a:pt x="678" y="1360"/>
                  </a:cubicBezTo>
                  <a:lnTo>
                    <a:pt x="803" y="1456"/>
                  </a:lnTo>
                  <a:cubicBezTo>
                    <a:pt x="819" y="1468"/>
                    <a:pt x="824" y="1492"/>
                    <a:pt x="813" y="1509"/>
                  </a:cubicBezTo>
                  <a:cubicBezTo>
                    <a:pt x="803" y="1527"/>
                    <a:pt x="781" y="1532"/>
                    <a:pt x="763" y="1521"/>
                  </a:cubicBezTo>
                  <a:lnTo>
                    <a:pt x="750" y="1513"/>
                  </a:lnTo>
                  <a:cubicBezTo>
                    <a:pt x="733" y="1502"/>
                    <a:pt x="726" y="1479"/>
                    <a:pt x="735" y="1460"/>
                  </a:cubicBezTo>
                  <a:cubicBezTo>
                    <a:pt x="745" y="1442"/>
                    <a:pt x="767" y="1435"/>
                    <a:pt x="785" y="1445"/>
                  </a:cubicBezTo>
                  <a:lnTo>
                    <a:pt x="1067" y="1598"/>
                  </a:lnTo>
                  <a:lnTo>
                    <a:pt x="1201" y="1664"/>
                  </a:lnTo>
                  <a:lnTo>
                    <a:pt x="1339" y="1739"/>
                  </a:lnTo>
                  <a:lnTo>
                    <a:pt x="1354" y="1748"/>
                  </a:lnTo>
                  <a:lnTo>
                    <a:pt x="1459" y="1829"/>
                  </a:lnTo>
                  <a:lnTo>
                    <a:pt x="1485" y="1852"/>
                  </a:lnTo>
                  <a:cubicBezTo>
                    <a:pt x="1487" y="1853"/>
                    <a:pt x="1489" y="1855"/>
                    <a:pt x="1490" y="1857"/>
                  </a:cubicBezTo>
                  <a:lnTo>
                    <a:pt x="1560" y="1948"/>
                  </a:lnTo>
                  <a:cubicBezTo>
                    <a:pt x="1562" y="1951"/>
                    <a:pt x="1563" y="1953"/>
                    <a:pt x="1565" y="1956"/>
                  </a:cubicBezTo>
                  <a:lnTo>
                    <a:pt x="1575" y="1977"/>
                  </a:lnTo>
                  <a:lnTo>
                    <a:pt x="1585" y="2004"/>
                  </a:lnTo>
                  <a:lnTo>
                    <a:pt x="1618" y="2116"/>
                  </a:lnTo>
                  <a:lnTo>
                    <a:pt x="1622" y="2126"/>
                  </a:lnTo>
                  <a:cubicBezTo>
                    <a:pt x="1623" y="2128"/>
                    <a:pt x="1624" y="2130"/>
                    <a:pt x="1624" y="2132"/>
                  </a:cubicBezTo>
                  <a:lnTo>
                    <a:pt x="1627" y="2147"/>
                  </a:lnTo>
                  <a:cubicBezTo>
                    <a:pt x="1627" y="2150"/>
                    <a:pt x="1628" y="2152"/>
                    <a:pt x="1628" y="2154"/>
                  </a:cubicBezTo>
                  <a:lnTo>
                    <a:pt x="1632" y="2279"/>
                  </a:lnTo>
                  <a:lnTo>
                    <a:pt x="1631" y="2302"/>
                  </a:lnTo>
                  <a:lnTo>
                    <a:pt x="1612" y="2439"/>
                  </a:lnTo>
                  <a:lnTo>
                    <a:pt x="1583" y="2587"/>
                  </a:lnTo>
                  <a:lnTo>
                    <a:pt x="1497" y="2846"/>
                  </a:lnTo>
                  <a:lnTo>
                    <a:pt x="1465" y="2941"/>
                  </a:lnTo>
                  <a:lnTo>
                    <a:pt x="1444" y="3007"/>
                  </a:lnTo>
                  <a:lnTo>
                    <a:pt x="1432" y="3061"/>
                  </a:lnTo>
                  <a:cubicBezTo>
                    <a:pt x="1431" y="3063"/>
                    <a:pt x="1431" y="3065"/>
                    <a:pt x="1430" y="3067"/>
                  </a:cubicBezTo>
                  <a:lnTo>
                    <a:pt x="1413" y="3108"/>
                  </a:lnTo>
                  <a:cubicBezTo>
                    <a:pt x="1411" y="3113"/>
                    <a:pt x="1408" y="3117"/>
                    <a:pt x="1404" y="3121"/>
                  </a:cubicBezTo>
                  <a:lnTo>
                    <a:pt x="1374" y="3150"/>
                  </a:lnTo>
                  <a:cubicBezTo>
                    <a:pt x="1371" y="3153"/>
                    <a:pt x="1367" y="3156"/>
                    <a:pt x="1362" y="3157"/>
                  </a:cubicBezTo>
                  <a:lnTo>
                    <a:pt x="1324" y="3172"/>
                  </a:lnTo>
                  <a:cubicBezTo>
                    <a:pt x="1320" y="3174"/>
                    <a:pt x="1315" y="3175"/>
                    <a:pt x="1310" y="3175"/>
                  </a:cubicBezTo>
                  <a:lnTo>
                    <a:pt x="1268" y="3173"/>
                  </a:lnTo>
                  <a:lnTo>
                    <a:pt x="1257" y="3172"/>
                  </a:lnTo>
                  <a:cubicBezTo>
                    <a:pt x="1254" y="3171"/>
                    <a:pt x="1250" y="3170"/>
                    <a:pt x="1247" y="3169"/>
                  </a:cubicBezTo>
                  <a:lnTo>
                    <a:pt x="1210" y="3153"/>
                  </a:lnTo>
                  <a:cubicBezTo>
                    <a:pt x="1206" y="3151"/>
                    <a:pt x="1202" y="3148"/>
                    <a:pt x="1198" y="3145"/>
                  </a:cubicBezTo>
                  <a:lnTo>
                    <a:pt x="1170" y="3117"/>
                  </a:lnTo>
                  <a:cubicBezTo>
                    <a:pt x="1167" y="3114"/>
                    <a:pt x="1165" y="3110"/>
                    <a:pt x="1163" y="3106"/>
                  </a:cubicBezTo>
                  <a:lnTo>
                    <a:pt x="1144" y="3068"/>
                  </a:lnTo>
                  <a:cubicBezTo>
                    <a:pt x="1142" y="3064"/>
                    <a:pt x="1140" y="3060"/>
                    <a:pt x="1140" y="3055"/>
                  </a:cubicBezTo>
                  <a:lnTo>
                    <a:pt x="1134" y="3012"/>
                  </a:lnTo>
                  <a:cubicBezTo>
                    <a:pt x="1133" y="3010"/>
                    <a:pt x="1133" y="3007"/>
                    <a:pt x="1133" y="3005"/>
                  </a:cubicBezTo>
                  <a:lnTo>
                    <a:pt x="1135" y="2959"/>
                  </a:lnTo>
                  <a:lnTo>
                    <a:pt x="1144" y="2880"/>
                  </a:lnTo>
                  <a:cubicBezTo>
                    <a:pt x="1147" y="2859"/>
                    <a:pt x="1165" y="2845"/>
                    <a:pt x="1185" y="2848"/>
                  </a:cubicBezTo>
                  <a:lnTo>
                    <a:pt x="1402" y="2877"/>
                  </a:lnTo>
                  <a:cubicBezTo>
                    <a:pt x="1422" y="2880"/>
                    <a:pt x="1437" y="2899"/>
                    <a:pt x="1436" y="2920"/>
                  </a:cubicBezTo>
                  <a:lnTo>
                    <a:pt x="1432" y="2986"/>
                  </a:lnTo>
                  <a:lnTo>
                    <a:pt x="1430" y="3031"/>
                  </a:lnTo>
                  <a:cubicBezTo>
                    <a:pt x="1429" y="3048"/>
                    <a:pt x="1419" y="3062"/>
                    <a:pt x="1404" y="3066"/>
                  </a:cubicBezTo>
                  <a:cubicBezTo>
                    <a:pt x="1389" y="3071"/>
                    <a:pt x="1373" y="3065"/>
                    <a:pt x="1363" y="3052"/>
                  </a:cubicBezTo>
                  <a:lnTo>
                    <a:pt x="1273" y="2928"/>
                  </a:lnTo>
                  <a:cubicBezTo>
                    <a:pt x="1264" y="2915"/>
                    <a:pt x="1263" y="2898"/>
                    <a:pt x="1270" y="2885"/>
                  </a:cubicBezTo>
                  <a:cubicBezTo>
                    <a:pt x="1277" y="2871"/>
                    <a:pt x="1291" y="2864"/>
                    <a:pt x="1306" y="2865"/>
                  </a:cubicBezTo>
                  <a:lnTo>
                    <a:pt x="1314" y="2866"/>
                  </a:lnTo>
                  <a:cubicBezTo>
                    <a:pt x="1330" y="2868"/>
                    <a:pt x="1343" y="2881"/>
                    <a:pt x="1347" y="2897"/>
                  </a:cubicBezTo>
                  <a:cubicBezTo>
                    <a:pt x="1351" y="2913"/>
                    <a:pt x="1344" y="2930"/>
                    <a:pt x="1331" y="2939"/>
                  </a:cubicBezTo>
                  <a:lnTo>
                    <a:pt x="1204" y="3022"/>
                  </a:lnTo>
                  <a:cubicBezTo>
                    <a:pt x="1191" y="3030"/>
                    <a:pt x="1175" y="3030"/>
                    <a:pt x="1162" y="3020"/>
                  </a:cubicBezTo>
                  <a:cubicBezTo>
                    <a:pt x="1150" y="3010"/>
                    <a:pt x="1144" y="2994"/>
                    <a:pt x="1147" y="2978"/>
                  </a:cubicBezTo>
                  <a:lnTo>
                    <a:pt x="1163" y="2906"/>
                  </a:lnTo>
                  <a:lnTo>
                    <a:pt x="1184" y="2831"/>
                  </a:lnTo>
                  <a:lnTo>
                    <a:pt x="1215" y="2733"/>
                  </a:lnTo>
                  <a:lnTo>
                    <a:pt x="1293" y="2503"/>
                  </a:lnTo>
                  <a:lnTo>
                    <a:pt x="1320" y="2385"/>
                  </a:lnTo>
                  <a:lnTo>
                    <a:pt x="1336" y="2255"/>
                  </a:lnTo>
                  <a:cubicBezTo>
                    <a:pt x="1339" y="2234"/>
                    <a:pt x="1358" y="2219"/>
                    <a:pt x="1378" y="2223"/>
                  </a:cubicBezTo>
                  <a:cubicBezTo>
                    <a:pt x="1398" y="2226"/>
                    <a:pt x="1413" y="2245"/>
                    <a:pt x="1411" y="2267"/>
                  </a:cubicBezTo>
                  <a:lnTo>
                    <a:pt x="1409" y="2287"/>
                  </a:lnTo>
                  <a:cubicBezTo>
                    <a:pt x="1407" y="2307"/>
                    <a:pt x="1390" y="2322"/>
                    <a:pt x="1370" y="2321"/>
                  </a:cubicBezTo>
                  <a:cubicBezTo>
                    <a:pt x="1351" y="2319"/>
                    <a:pt x="1335" y="2302"/>
                    <a:pt x="1334" y="2282"/>
                  </a:cubicBezTo>
                  <a:lnTo>
                    <a:pt x="1330" y="2158"/>
                  </a:lnTo>
                  <a:cubicBezTo>
                    <a:pt x="1330" y="2137"/>
                    <a:pt x="1344" y="2120"/>
                    <a:pt x="1364" y="2118"/>
                  </a:cubicBezTo>
                  <a:cubicBezTo>
                    <a:pt x="1383" y="2117"/>
                    <a:pt x="1401" y="2132"/>
                    <a:pt x="1404" y="2152"/>
                  </a:cubicBezTo>
                  <a:lnTo>
                    <a:pt x="1409" y="2184"/>
                  </a:lnTo>
                  <a:cubicBezTo>
                    <a:pt x="1412" y="2205"/>
                    <a:pt x="1400" y="2224"/>
                    <a:pt x="1381" y="2228"/>
                  </a:cubicBezTo>
                  <a:cubicBezTo>
                    <a:pt x="1362" y="2232"/>
                    <a:pt x="1343" y="2220"/>
                    <a:pt x="1337" y="2200"/>
                  </a:cubicBezTo>
                  <a:lnTo>
                    <a:pt x="1304" y="2091"/>
                  </a:lnTo>
                  <a:cubicBezTo>
                    <a:pt x="1298" y="2072"/>
                    <a:pt x="1307" y="2052"/>
                    <a:pt x="1324" y="2044"/>
                  </a:cubicBezTo>
                  <a:cubicBezTo>
                    <a:pt x="1342" y="2036"/>
                    <a:pt x="1362" y="2044"/>
                    <a:pt x="1372" y="2062"/>
                  </a:cubicBezTo>
                  <a:lnTo>
                    <a:pt x="1394" y="2102"/>
                  </a:lnTo>
                  <a:cubicBezTo>
                    <a:pt x="1403" y="2119"/>
                    <a:pt x="1399" y="2142"/>
                    <a:pt x="1383" y="2153"/>
                  </a:cubicBezTo>
                  <a:cubicBezTo>
                    <a:pt x="1367" y="2165"/>
                    <a:pt x="1345" y="2161"/>
                    <a:pt x="1333" y="2145"/>
                  </a:cubicBezTo>
                  <a:lnTo>
                    <a:pt x="1262" y="2054"/>
                  </a:lnTo>
                  <a:cubicBezTo>
                    <a:pt x="1250" y="2038"/>
                    <a:pt x="1250" y="2015"/>
                    <a:pt x="1264" y="2001"/>
                  </a:cubicBezTo>
                  <a:cubicBezTo>
                    <a:pt x="1277" y="1987"/>
                    <a:pt x="1299" y="1986"/>
                    <a:pt x="1314" y="1999"/>
                  </a:cubicBezTo>
                  <a:lnTo>
                    <a:pt x="1337" y="2019"/>
                  </a:lnTo>
                  <a:cubicBezTo>
                    <a:pt x="1353" y="2033"/>
                    <a:pt x="1355" y="2057"/>
                    <a:pt x="1343" y="2074"/>
                  </a:cubicBezTo>
                  <a:cubicBezTo>
                    <a:pt x="1331" y="2091"/>
                    <a:pt x="1308" y="2094"/>
                    <a:pt x="1292" y="2081"/>
                  </a:cubicBezTo>
                  <a:lnTo>
                    <a:pt x="1190" y="2002"/>
                  </a:lnTo>
                  <a:cubicBezTo>
                    <a:pt x="1174" y="1989"/>
                    <a:pt x="1169" y="1966"/>
                    <a:pt x="1180" y="1949"/>
                  </a:cubicBezTo>
                  <a:cubicBezTo>
                    <a:pt x="1190" y="1931"/>
                    <a:pt x="1212" y="1926"/>
                    <a:pt x="1230" y="1937"/>
                  </a:cubicBezTo>
                  <a:lnTo>
                    <a:pt x="1243" y="1945"/>
                  </a:lnTo>
                  <a:cubicBezTo>
                    <a:pt x="1260" y="1956"/>
                    <a:pt x="1267" y="1979"/>
                    <a:pt x="1258" y="1997"/>
                  </a:cubicBezTo>
                  <a:cubicBezTo>
                    <a:pt x="1248" y="2016"/>
                    <a:pt x="1227" y="2023"/>
                    <a:pt x="1208" y="2013"/>
                  </a:cubicBezTo>
                  <a:lnTo>
                    <a:pt x="1084" y="1947"/>
                  </a:lnTo>
                  <a:lnTo>
                    <a:pt x="939" y="1877"/>
                  </a:lnTo>
                  <a:lnTo>
                    <a:pt x="655" y="1722"/>
                  </a:lnTo>
                  <a:cubicBezTo>
                    <a:pt x="653" y="1721"/>
                    <a:pt x="651" y="1720"/>
                    <a:pt x="650" y="1719"/>
                  </a:cubicBezTo>
                  <a:lnTo>
                    <a:pt x="636" y="1708"/>
                  </a:lnTo>
                  <a:lnTo>
                    <a:pt x="511" y="1612"/>
                  </a:lnTo>
                  <a:lnTo>
                    <a:pt x="489" y="1591"/>
                  </a:lnTo>
                  <a:lnTo>
                    <a:pt x="389" y="1478"/>
                  </a:lnTo>
                  <a:cubicBezTo>
                    <a:pt x="388" y="1476"/>
                    <a:pt x="387" y="1475"/>
                    <a:pt x="386" y="1473"/>
                  </a:cubicBezTo>
                  <a:lnTo>
                    <a:pt x="369" y="1447"/>
                  </a:lnTo>
                  <a:lnTo>
                    <a:pt x="228" y="1164"/>
                  </a:lnTo>
                  <a:lnTo>
                    <a:pt x="220" y="1146"/>
                  </a:lnTo>
                  <a:cubicBezTo>
                    <a:pt x="219" y="1144"/>
                    <a:pt x="218" y="1142"/>
                    <a:pt x="218" y="1140"/>
                  </a:cubicBezTo>
                  <a:lnTo>
                    <a:pt x="122" y="805"/>
                  </a:lnTo>
                  <a:lnTo>
                    <a:pt x="53" y="438"/>
                  </a:lnTo>
                  <a:lnTo>
                    <a:pt x="2" y="70"/>
                  </a:lnTo>
                  <a:cubicBezTo>
                    <a:pt x="0" y="60"/>
                    <a:pt x="3" y="49"/>
                    <a:pt x="9" y="41"/>
                  </a:cubicBezTo>
                  <a:cubicBezTo>
                    <a:pt x="15" y="33"/>
                    <a:pt x="24" y="27"/>
                    <a:pt x="33" y="26"/>
                  </a:cubicBezTo>
                  <a:lnTo>
                    <a:pt x="250" y="2"/>
                  </a:lnTo>
                  <a:close/>
                  <a:moveTo>
                    <a:pt x="43" y="105"/>
                  </a:moveTo>
                  <a:lnTo>
                    <a:pt x="75" y="61"/>
                  </a:lnTo>
                  <a:lnTo>
                    <a:pt x="126" y="425"/>
                  </a:lnTo>
                  <a:lnTo>
                    <a:pt x="193" y="784"/>
                  </a:lnTo>
                  <a:lnTo>
                    <a:pt x="289" y="1119"/>
                  </a:lnTo>
                  <a:lnTo>
                    <a:pt x="287" y="1113"/>
                  </a:lnTo>
                  <a:lnTo>
                    <a:pt x="294" y="1129"/>
                  </a:lnTo>
                  <a:lnTo>
                    <a:pt x="430" y="1404"/>
                  </a:lnTo>
                  <a:lnTo>
                    <a:pt x="447" y="1430"/>
                  </a:lnTo>
                  <a:lnTo>
                    <a:pt x="444" y="1425"/>
                  </a:lnTo>
                  <a:lnTo>
                    <a:pt x="538" y="1534"/>
                  </a:lnTo>
                  <a:lnTo>
                    <a:pt x="554" y="1549"/>
                  </a:lnTo>
                  <a:lnTo>
                    <a:pt x="679" y="1645"/>
                  </a:lnTo>
                  <a:lnTo>
                    <a:pt x="693" y="1656"/>
                  </a:lnTo>
                  <a:lnTo>
                    <a:pt x="688" y="1653"/>
                  </a:lnTo>
                  <a:lnTo>
                    <a:pt x="968" y="1806"/>
                  </a:lnTo>
                  <a:lnTo>
                    <a:pt x="1117" y="1877"/>
                  </a:lnTo>
                  <a:lnTo>
                    <a:pt x="1241" y="1943"/>
                  </a:lnTo>
                  <a:lnTo>
                    <a:pt x="1206" y="2012"/>
                  </a:lnTo>
                  <a:lnTo>
                    <a:pt x="1193" y="2004"/>
                  </a:lnTo>
                  <a:lnTo>
                    <a:pt x="1233" y="1939"/>
                  </a:lnTo>
                  <a:lnTo>
                    <a:pt x="1335" y="2018"/>
                  </a:lnTo>
                  <a:lnTo>
                    <a:pt x="1290" y="2079"/>
                  </a:lnTo>
                  <a:lnTo>
                    <a:pt x="1267" y="2059"/>
                  </a:lnTo>
                  <a:lnTo>
                    <a:pt x="1319" y="2005"/>
                  </a:lnTo>
                  <a:lnTo>
                    <a:pt x="1390" y="2096"/>
                  </a:lnTo>
                  <a:lnTo>
                    <a:pt x="1329" y="2139"/>
                  </a:lnTo>
                  <a:lnTo>
                    <a:pt x="1307" y="2099"/>
                  </a:lnTo>
                  <a:lnTo>
                    <a:pt x="1375" y="2070"/>
                  </a:lnTo>
                  <a:lnTo>
                    <a:pt x="1408" y="2179"/>
                  </a:lnTo>
                  <a:lnTo>
                    <a:pt x="1336" y="2195"/>
                  </a:lnTo>
                  <a:lnTo>
                    <a:pt x="1331" y="2163"/>
                  </a:lnTo>
                  <a:lnTo>
                    <a:pt x="1405" y="2157"/>
                  </a:lnTo>
                  <a:lnTo>
                    <a:pt x="1409" y="2281"/>
                  </a:lnTo>
                  <a:lnTo>
                    <a:pt x="1334" y="2276"/>
                  </a:lnTo>
                  <a:lnTo>
                    <a:pt x="1336" y="2256"/>
                  </a:lnTo>
                  <a:lnTo>
                    <a:pt x="1410" y="2268"/>
                  </a:lnTo>
                  <a:lnTo>
                    <a:pt x="1393" y="2406"/>
                  </a:lnTo>
                  <a:lnTo>
                    <a:pt x="1364" y="2532"/>
                  </a:lnTo>
                  <a:lnTo>
                    <a:pt x="1286" y="2760"/>
                  </a:lnTo>
                  <a:lnTo>
                    <a:pt x="1255" y="2854"/>
                  </a:lnTo>
                  <a:lnTo>
                    <a:pt x="1236" y="2926"/>
                  </a:lnTo>
                  <a:lnTo>
                    <a:pt x="1220" y="2998"/>
                  </a:lnTo>
                  <a:lnTo>
                    <a:pt x="1163" y="2955"/>
                  </a:lnTo>
                  <a:lnTo>
                    <a:pt x="1290" y="2872"/>
                  </a:lnTo>
                  <a:lnTo>
                    <a:pt x="1307" y="2945"/>
                  </a:lnTo>
                  <a:lnTo>
                    <a:pt x="1299" y="2944"/>
                  </a:lnTo>
                  <a:lnTo>
                    <a:pt x="1332" y="2881"/>
                  </a:lnTo>
                  <a:lnTo>
                    <a:pt x="1422" y="3005"/>
                  </a:lnTo>
                  <a:lnTo>
                    <a:pt x="1355" y="3026"/>
                  </a:lnTo>
                  <a:lnTo>
                    <a:pt x="1357" y="2979"/>
                  </a:lnTo>
                  <a:lnTo>
                    <a:pt x="1361" y="2913"/>
                  </a:lnTo>
                  <a:lnTo>
                    <a:pt x="1395" y="2955"/>
                  </a:lnTo>
                  <a:lnTo>
                    <a:pt x="1178" y="2925"/>
                  </a:lnTo>
                  <a:lnTo>
                    <a:pt x="1218" y="2893"/>
                  </a:lnTo>
                  <a:lnTo>
                    <a:pt x="1210" y="2964"/>
                  </a:lnTo>
                  <a:lnTo>
                    <a:pt x="1208" y="3010"/>
                  </a:lnTo>
                  <a:lnTo>
                    <a:pt x="1207" y="3003"/>
                  </a:lnTo>
                  <a:lnTo>
                    <a:pt x="1213" y="3046"/>
                  </a:lnTo>
                  <a:lnTo>
                    <a:pt x="1209" y="3033"/>
                  </a:lnTo>
                  <a:lnTo>
                    <a:pt x="1228" y="3071"/>
                  </a:lnTo>
                  <a:lnTo>
                    <a:pt x="1221" y="3060"/>
                  </a:lnTo>
                  <a:lnTo>
                    <a:pt x="1249" y="3088"/>
                  </a:lnTo>
                  <a:lnTo>
                    <a:pt x="1237" y="3080"/>
                  </a:lnTo>
                  <a:lnTo>
                    <a:pt x="1274" y="3096"/>
                  </a:lnTo>
                  <a:lnTo>
                    <a:pt x="1264" y="3093"/>
                  </a:lnTo>
                  <a:lnTo>
                    <a:pt x="1269" y="3094"/>
                  </a:lnTo>
                  <a:lnTo>
                    <a:pt x="1311" y="3096"/>
                  </a:lnTo>
                  <a:lnTo>
                    <a:pt x="1296" y="3099"/>
                  </a:lnTo>
                  <a:lnTo>
                    <a:pt x="1334" y="3084"/>
                  </a:lnTo>
                  <a:lnTo>
                    <a:pt x="1323" y="3091"/>
                  </a:lnTo>
                  <a:lnTo>
                    <a:pt x="1353" y="3062"/>
                  </a:lnTo>
                  <a:lnTo>
                    <a:pt x="1344" y="3075"/>
                  </a:lnTo>
                  <a:lnTo>
                    <a:pt x="1361" y="3034"/>
                  </a:lnTo>
                  <a:lnTo>
                    <a:pt x="1359" y="3040"/>
                  </a:lnTo>
                  <a:lnTo>
                    <a:pt x="1373" y="2980"/>
                  </a:lnTo>
                  <a:lnTo>
                    <a:pt x="1394" y="2913"/>
                  </a:lnTo>
                  <a:lnTo>
                    <a:pt x="1426" y="2817"/>
                  </a:lnTo>
                  <a:lnTo>
                    <a:pt x="1510" y="2568"/>
                  </a:lnTo>
                  <a:lnTo>
                    <a:pt x="1539" y="2426"/>
                  </a:lnTo>
                  <a:lnTo>
                    <a:pt x="1556" y="2295"/>
                  </a:lnTo>
                  <a:lnTo>
                    <a:pt x="1557" y="2280"/>
                  </a:lnTo>
                  <a:lnTo>
                    <a:pt x="1553" y="2155"/>
                  </a:lnTo>
                  <a:lnTo>
                    <a:pt x="1554" y="2161"/>
                  </a:lnTo>
                  <a:lnTo>
                    <a:pt x="1551" y="2146"/>
                  </a:lnTo>
                  <a:lnTo>
                    <a:pt x="1553" y="2153"/>
                  </a:lnTo>
                  <a:lnTo>
                    <a:pt x="1547" y="2137"/>
                  </a:lnTo>
                  <a:lnTo>
                    <a:pt x="1516" y="2031"/>
                  </a:lnTo>
                  <a:lnTo>
                    <a:pt x="1508" y="2010"/>
                  </a:lnTo>
                  <a:lnTo>
                    <a:pt x="1498" y="1989"/>
                  </a:lnTo>
                  <a:lnTo>
                    <a:pt x="1503" y="1997"/>
                  </a:lnTo>
                  <a:lnTo>
                    <a:pt x="1433" y="1906"/>
                  </a:lnTo>
                  <a:lnTo>
                    <a:pt x="1438" y="1911"/>
                  </a:lnTo>
                  <a:lnTo>
                    <a:pt x="1416" y="1892"/>
                  </a:lnTo>
                  <a:lnTo>
                    <a:pt x="1317" y="1815"/>
                  </a:lnTo>
                  <a:lnTo>
                    <a:pt x="1306" y="1808"/>
                  </a:lnTo>
                  <a:lnTo>
                    <a:pt x="1170" y="1735"/>
                  </a:lnTo>
                  <a:lnTo>
                    <a:pt x="1034" y="1667"/>
                  </a:lnTo>
                  <a:lnTo>
                    <a:pt x="752" y="1514"/>
                  </a:lnTo>
                  <a:lnTo>
                    <a:pt x="787" y="1446"/>
                  </a:lnTo>
                  <a:lnTo>
                    <a:pt x="800" y="1454"/>
                  </a:lnTo>
                  <a:lnTo>
                    <a:pt x="760" y="1519"/>
                  </a:lnTo>
                  <a:lnTo>
                    <a:pt x="635" y="1423"/>
                  </a:lnTo>
                  <a:lnTo>
                    <a:pt x="681" y="1363"/>
                  </a:lnTo>
                  <a:lnTo>
                    <a:pt x="700" y="1381"/>
                  </a:lnTo>
                  <a:lnTo>
                    <a:pt x="648" y="1436"/>
                  </a:lnTo>
                  <a:lnTo>
                    <a:pt x="551" y="1325"/>
                  </a:lnTo>
                  <a:lnTo>
                    <a:pt x="608" y="1275"/>
                  </a:lnTo>
                  <a:lnTo>
                    <a:pt x="626" y="1300"/>
                  </a:lnTo>
                  <a:lnTo>
                    <a:pt x="563" y="1341"/>
                  </a:lnTo>
                  <a:lnTo>
                    <a:pt x="425" y="1062"/>
                  </a:lnTo>
                  <a:lnTo>
                    <a:pt x="495" y="1037"/>
                  </a:lnTo>
                  <a:lnTo>
                    <a:pt x="499" y="1055"/>
                  </a:lnTo>
                  <a:cubicBezTo>
                    <a:pt x="503" y="1075"/>
                    <a:pt x="492" y="1096"/>
                    <a:pt x="472" y="1101"/>
                  </a:cubicBezTo>
                  <a:cubicBezTo>
                    <a:pt x="453" y="1106"/>
                    <a:pt x="433" y="1094"/>
                    <a:pt x="427" y="1073"/>
                  </a:cubicBezTo>
                  <a:lnTo>
                    <a:pt x="334" y="763"/>
                  </a:lnTo>
                  <a:lnTo>
                    <a:pt x="270" y="413"/>
                  </a:lnTo>
                  <a:lnTo>
                    <a:pt x="219" y="46"/>
                  </a:lnTo>
                  <a:lnTo>
                    <a:pt x="260" y="81"/>
                  </a:lnTo>
                  <a:lnTo>
                    <a:pt x="43" y="105"/>
                  </a:lnTo>
                  <a:close/>
                </a:path>
              </a:pathLst>
            </a:custGeom>
            <a:solidFill>
              <a:srgbClr val="8EB4E3"/>
            </a:solidFill>
            <a:ln w="0" cap="flat">
              <a:solidFill>
                <a:srgbClr val="8EB4E3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" name="Freeform 224">
              <a:extLst>
                <a:ext uri="{FF2B5EF4-FFF2-40B4-BE49-F238E27FC236}">
                  <a16:creationId xmlns:a16="http://schemas.microsoft.com/office/drawing/2014/main" id="{2215A263-2694-45F2-A443-183E4C89163E}"/>
                </a:ext>
              </a:extLst>
            </p:cNvPr>
            <p:cNvSpPr>
              <a:spLocks/>
            </p:cNvSpPr>
            <p:nvPr/>
          </p:nvSpPr>
          <p:spPr bwMode="auto">
            <a:xfrm>
              <a:off x="580" y="2594"/>
              <a:ext cx="23" cy="101"/>
            </a:xfrm>
            <a:custGeom>
              <a:avLst/>
              <a:gdLst>
                <a:gd name="T0" fmla="*/ 14 w 23"/>
                <a:gd name="T1" fmla="*/ 101 h 101"/>
                <a:gd name="T2" fmla="*/ 0 w 23"/>
                <a:gd name="T3" fmla="*/ 1 h 101"/>
                <a:gd name="T4" fmla="*/ 9 w 23"/>
                <a:gd name="T5" fmla="*/ 0 h 101"/>
                <a:gd name="T6" fmla="*/ 23 w 23"/>
                <a:gd name="T7" fmla="*/ 100 h 101"/>
                <a:gd name="T8" fmla="*/ 14 w 23"/>
                <a:gd name="T9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3" h="101">
                  <a:moveTo>
                    <a:pt x="14" y="101"/>
                  </a:moveTo>
                  <a:lnTo>
                    <a:pt x="0" y="1"/>
                  </a:lnTo>
                  <a:lnTo>
                    <a:pt x="9" y="0"/>
                  </a:lnTo>
                  <a:lnTo>
                    <a:pt x="23" y="100"/>
                  </a:lnTo>
                  <a:lnTo>
                    <a:pt x="14" y="101"/>
                  </a:lnTo>
                  <a:close/>
                </a:path>
              </a:pathLst>
            </a:custGeom>
            <a:solidFill>
              <a:srgbClr val="948A54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" name="Freeform 225">
              <a:extLst>
                <a:ext uri="{FF2B5EF4-FFF2-40B4-BE49-F238E27FC236}">
                  <a16:creationId xmlns:a16="http://schemas.microsoft.com/office/drawing/2014/main" id="{380C66C6-029B-45C3-8B1A-886AA6B480E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79" y="2592"/>
              <a:ext cx="26" cy="104"/>
            </a:xfrm>
            <a:custGeom>
              <a:avLst/>
              <a:gdLst>
                <a:gd name="T0" fmla="*/ 408 w 664"/>
                <a:gd name="T1" fmla="*/ 2676 h 2677"/>
                <a:gd name="T2" fmla="*/ 380 w 664"/>
                <a:gd name="T3" fmla="*/ 2668 h 2677"/>
                <a:gd name="T4" fmla="*/ 365 w 664"/>
                <a:gd name="T5" fmla="*/ 2641 h 2677"/>
                <a:gd name="T6" fmla="*/ 3 w 664"/>
                <a:gd name="T7" fmla="*/ 73 h 2677"/>
                <a:gd name="T8" fmla="*/ 34 w 664"/>
                <a:gd name="T9" fmla="*/ 30 h 2677"/>
                <a:gd name="T10" fmla="*/ 244 w 664"/>
                <a:gd name="T11" fmla="*/ 1 h 2677"/>
                <a:gd name="T12" fmla="*/ 272 w 664"/>
                <a:gd name="T13" fmla="*/ 9 h 2677"/>
                <a:gd name="T14" fmla="*/ 287 w 664"/>
                <a:gd name="T15" fmla="*/ 35 h 2677"/>
                <a:gd name="T16" fmla="*/ 661 w 664"/>
                <a:gd name="T17" fmla="*/ 2600 h 2677"/>
                <a:gd name="T18" fmla="*/ 630 w 664"/>
                <a:gd name="T19" fmla="*/ 2644 h 2677"/>
                <a:gd name="T20" fmla="*/ 408 w 664"/>
                <a:gd name="T21" fmla="*/ 2676 h 2677"/>
                <a:gd name="T22" fmla="*/ 618 w 664"/>
                <a:gd name="T23" fmla="*/ 2566 h 2677"/>
                <a:gd name="T24" fmla="*/ 587 w 664"/>
                <a:gd name="T25" fmla="*/ 2610 h 2677"/>
                <a:gd name="T26" fmla="*/ 213 w 664"/>
                <a:gd name="T27" fmla="*/ 45 h 2677"/>
                <a:gd name="T28" fmla="*/ 256 w 664"/>
                <a:gd name="T29" fmla="*/ 79 h 2677"/>
                <a:gd name="T30" fmla="*/ 46 w 664"/>
                <a:gd name="T31" fmla="*/ 108 h 2677"/>
                <a:gd name="T32" fmla="*/ 77 w 664"/>
                <a:gd name="T33" fmla="*/ 64 h 2677"/>
                <a:gd name="T34" fmla="*/ 438 w 664"/>
                <a:gd name="T35" fmla="*/ 2632 h 2677"/>
                <a:gd name="T36" fmla="*/ 396 w 664"/>
                <a:gd name="T37" fmla="*/ 2598 h 2677"/>
                <a:gd name="T38" fmla="*/ 618 w 664"/>
                <a:gd name="T39" fmla="*/ 2566 h 26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664" h="2677">
                  <a:moveTo>
                    <a:pt x="408" y="2676"/>
                  </a:moveTo>
                  <a:cubicBezTo>
                    <a:pt x="398" y="2677"/>
                    <a:pt x="388" y="2674"/>
                    <a:pt x="380" y="2668"/>
                  </a:cubicBezTo>
                  <a:cubicBezTo>
                    <a:pt x="372" y="2661"/>
                    <a:pt x="366" y="2652"/>
                    <a:pt x="365" y="2641"/>
                  </a:cubicBezTo>
                  <a:lnTo>
                    <a:pt x="3" y="73"/>
                  </a:lnTo>
                  <a:cubicBezTo>
                    <a:pt x="0" y="52"/>
                    <a:pt x="14" y="32"/>
                    <a:pt x="34" y="30"/>
                  </a:cubicBezTo>
                  <a:lnTo>
                    <a:pt x="244" y="1"/>
                  </a:lnTo>
                  <a:cubicBezTo>
                    <a:pt x="254" y="0"/>
                    <a:pt x="264" y="3"/>
                    <a:pt x="272" y="9"/>
                  </a:cubicBezTo>
                  <a:cubicBezTo>
                    <a:pt x="280" y="16"/>
                    <a:pt x="286" y="25"/>
                    <a:pt x="287" y="35"/>
                  </a:cubicBezTo>
                  <a:lnTo>
                    <a:pt x="661" y="2600"/>
                  </a:lnTo>
                  <a:cubicBezTo>
                    <a:pt x="664" y="2622"/>
                    <a:pt x="650" y="2641"/>
                    <a:pt x="630" y="2644"/>
                  </a:cubicBezTo>
                  <a:lnTo>
                    <a:pt x="408" y="2676"/>
                  </a:lnTo>
                  <a:close/>
                  <a:moveTo>
                    <a:pt x="618" y="2566"/>
                  </a:moveTo>
                  <a:lnTo>
                    <a:pt x="587" y="2610"/>
                  </a:lnTo>
                  <a:lnTo>
                    <a:pt x="213" y="45"/>
                  </a:lnTo>
                  <a:lnTo>
                    <a:pt x="256" y="79"/>
                  </a:lnTo>
                  <a:lnTo>
                    <a:pt x="46" y="108"/>
                  </a:lnTo>
                  <a:lnTo>
                    <a:pt x="77" y="64"/>
                  </a:lnTo>
                  <a:lnTo>
                    <a:pt x="438" y="2632"/>
                  </a:lnTo>
                  <a:lnTo>
                    <a:pt x="396" y="2598"/>
                  </a:lnTo>
                  <a:lnTo>
                    <a:pt x="618" y="2566"/>
                  </a:lnTo>
                  <a:close/>
                </a:path>
              </a:pathLst>
            </a:custGeom>
            <a:solidFill>
              <a:srgbClr val="948A54"/>
            </a:solidFill>
            <a:ln w="0" cap="flat">
              <a:solidFill>
                <a:srgbClr val="948A54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" name="Freeform 226">
              <a:extLst>
                <a:ext uri="{FF2B5EF4-FFF2-40B4-BE49-F238E27FC236}">
                  <a16:creationId xmlns:a16="http://schemas.microsoft.com/office/drawing/2014/main" id="{18A9E765-8B43-4F7B-B187-34F7C5B630C9}"/>
                </a:ext>
              </a:extLst>
            </p:cNvPr>
            <p:cNvSpPr>
              <a:spLocks/>
            </p:cNvSpPr>
            <p:nvPr/>
          </p:nvSpPr>
          <p:spPr bwMode="auto">
            <a:xfrm>
              <a:off x="571" y="2555"/>
              <a:ext cx="83" cy="66"/>
            </a:xfrm>
            <a:custGeom>
              <a:avLst/>
              <a:gdLst>
                <a:gd name="T0" fmla="*/ 78 w 83"/>
                <a:gd name="T1" fmla="*/ 66 h 66"/>
                <a:gd name="T2" fmla="*/ 0 w 83"/>
                <a:gd name="T3" fmla="*/ 8 h 66"/>
                <a:gd name="T4" fmla="*/ 5 w 83"/>
                <a:gd name="T5" fmla="*/ 0 h 66"/>
                <a:gd name="T6" fmla="*/ 83 w 83"/>
                <a:gd name="T7" fmla="*/ 58 h 66"/>
                <a:gd name="T8" fmla="*/ 78 w 83"/>
                <a:gd name="T9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3" h="66">
                  <a:moveTo>
                    <a:pt x="78" y="66"/>
                  </a:moveTo>
                  <a:lnTo>
                    <a:pt x="0" y="8"/>
                  </a:lnTo>
                  <a:lnTo>
                    <a:pt x="5" y="0"/>
                  </a:lnTo>
                  <a:lnTo>
                    <a:pt x="83" y="58"/>
                  </a:lnTo>
                  <a:lnTo>
                    <a:pt x="78" y="66"/>
                  </a:lnTo>
                  <a:close/>
                </a:path>
              </a:pathLst>
            </a:custGeom>
            <a:solidFill>
              <a:srgbClr val="00206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" name="Freeform 227">
              <a:extLst>
                <a:ext uri="{FF2B5EF4-FFF2-40B4-BE49-F238E27FC236}">
                  <a16:creationId xmlns:a16="http://schemas.microsoft.com/office/drawing/2014/main" id="{4E5CD4E0-39AC-4DC7-BF94-E8D669BF056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70" y="2553"/>
              <a:ext cx="85" cy="70"/>
            </a:xfrm>
            <a:custGeom>
              <a:avLst/>
              <a:gdLst>
                <a:gd name="T0" fmla="*/ 2070 w 2198"/>
                <a:gd name="T1" fmla="*/ 1765 h 1784"/>
                <a:gd name="T2" fmla="*/ 2046 w 2198"/>
                <a:gd name="T3" fmla="*/ 1782 h 1784"/>
                <a:gd name="T4" fmla="*/ 2017 w 2198"/>
                <a:gd name="T5" fmla="*/ 1775 h 1784"/>
                <a:gd name="T6" fmla="*/ 21 w 2198"/>
                <a:gd name="T7" fmla="*/ 270 h 1784"/>
                <a:gd name="T8" fmla="*/ 10 w 2198"/>
                <a:gd name="T9" fmla="*/ 217 h 1784"/>
                <a:gd name="T10" fmla="*/ 127 w 2198"/>
                <a:gd name="T11" fmla="*/ 19 h 1784"/>
                <a:gd name="T12" fmla="*/ 151 w 2198"/>
                <a:gd name="T13" fmla="*/ 1 h 1784"/>
                <a:gd name="T14" fmla="*/ 180 w 2198"/>
                <a:gd name="T15" fmla="*/ 8 h 1784"/>
                <a:gd name="T16" fmla="*/ 2177 w 2198"/>
                <a:gd name="T17" fmla="*/ 1513 h 1784"/>
                <a:gd name="T18" fmla="*/ 2187 w 2198"/>
                <a:gd name="T19" fmla="*/ 1567 h 1784"/>
                <a:gd name="T20" fmla="*/ 2070 w 2198"/>
                <a:gd name="T21" fmla="*/ 1765 h 1784"/>
                <a:gd name="T22" fmla="*/ 2124 w 2198"/>
                <a:gd name="T23" fmla="*/ 1524 h 1784"/>
                <a:gd name="T24" fmla="*/ 2134 w 2198"/>
                <a:gd name="T25" fmla="*/ 1577 h 1784"/>
                <a:gd name="T26" fmla="*/ 138 w 2198"/>
                <a:gd name="T27" fmla="*/ 72 h 1784"/>
                <a:gd name="T28" fmla="*/ 191 w 2198"/>
                <a:gd name="T29" fmla="*/ 62 h 1784"/>
                <a:gd name="T30" fmla="*/ 74 w 2198"/>
                <a:gd name="T31" fmla="*/ 260 h 1784"/>
                <a:gd name="T32" fmla="*/ 63 w 2198"/>
                <a:gd name="T33" fmla="*/ 207 h 1784"/>
                <a:gd name="T34" fmla="*/ 2059 w 2198"/>
                <a:gd name="T35" fmla="*/ 1712 h 1784"/>
                <a:gd name="T36" fmla="*/ 2006 w 2198"/>
                <a:gd name="T37" fmla="*/ 1722 h 1784"/>
                <a:gd name="T38" fmla="*/ 2124 w 2198"/>
                <a:gd name="T39" fmla="*/ 1524 h 17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2198" h="1784">
                  <a:moveTo>
                    <a:pt x="2070" y="1765"/>
                  </a:moveTo>
                  <a:cubicBezTo>
                    <a:pt x="2064" y="1774"/>
                    <a:pt x="2056" y="1780"/>
                    <a:pt x="2046" y="1782"/>
                  </a:cubicBezTo>
                  <a:cubicBezTo>
                    <a:pt x="2036" y="1784"/>
                    <a:pt x="2025" y="1782"/>
                    <a:pt x="2017" y="1775"/>
                  </a:cubicBezTo>
                  <a:lnTo>
                    <a:pt x="21" y="270"/>
                  </a:lnTo>
                  <a:cubicBezTo>
                    <a:pt x="4" y="258"/>
                    <a:pt x="0" y="235"/>
                    <a:pt x="10" y="217"/>
                  </a:cubicBezTo>
                  <a:lnTo>
                    <a:pt x="127" y="19"/>
                  </a:lnTo>
                  <a:cubicBezTo>
                    <a:pt x="133" y="10"/>
                    <a:pt x="141" y="3"/>
                    <a:pt x="151" y="1"/>
                  </a:cubicBezTo>
                  <a:cubicBezTo>
                    <a:pt x="161" y="0"/>
                    <a:pt x="172" y="2"/>
                    <a:pt x="180" y="8"/>
                  </a:cubicBezTo>
                  <a:lnTo>
                    <a:pt x="2177" y="1513"/>
                  </a:lnTo>
                  <a:cubicBezTo>
                    <a:pt x="2193" y="1526"/>
                    <a:pt x="2198" y="1549"/>
                    <a:pt x="2187" y="1567"/>
                  </a:cubicBezTo>
                  <a:lnTo>
                    <a:pt x="2070" y="1765"/>
                  </a:lnTo>
                  <a:close/>
                  <a:moveTo>
                    <a:pt x="2124" y="1524"/>
                  </a:moveTo>
                  <a:lnTo>
                    <a:pt x="2134" y="1577"/>
                  </a:lnTo>
                  <a:lnTo>
                    <a:pt x="138" y="72"/>
                  </a:lnTo>
                  <a:lnTo>
                    <a:pt x="191" y="62"/>
                  </a:lnTo>
                  <a:lnTo>
                    <a:pt x="74" y="260"/>
                  </a:lnTo>
                  <a:lnTo>
                    <a:pt x="63" y="207"/>
                  </a:lnTo>
                  <a:lnTo>
                    <a:pt x="2059" y="1712"/>
                  </a:lnTo>
                  <a:lnTo>
                    <a:pt x="2006" y="1722"/>
                  </a:lnTo>
                  <a:lnTo>
                    <a:pt x="2124" y="1524"/>
                  </a:lnTo>
                  <a:close/>
                </a:path>
              </a:pathLst>
            </a:custGeom>
            <a:solidFill>
              <a:srgbClr val="002060"/>
            </a:solidFill>
            <a:ln w="0" cap="flat">
              <a:solidFill>
                <a:srgbClr val="00206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" name="Freeform 228">
              <a:extLst>
                <a:ext uri="{FF2B5EF4-FFF2-40B4-BE49-F238E27FC236}">
                  <a16:creationId xmlns:a16="http://schemas.microsoft.com/office/drawing/2014/main" id="{CD551A31-06B1-4CF9-A2E2-54D8117187C4}"/>
                </a:ext>
              </a:extLst>
            </p:cNvPr>
            <p:cNvSpPr>
              <a:spLocks/>
            </p:cNvSpPr>
            <p:nvPr/>
          </p:nvSpPr>
          <p:spPr bwMode="auto">
            <a:xfrm>
              <a:off x="559" y="2661"/>
              <a:ext cx="58" cy="106"/>
            </a:xfrm>
            <a:custGeom>
              <a:avLst/>
              <a:gdLst>
                <a:gd name="T0" fmla="*/ 1223 w 1481"/>
                <a:gd name="T1" fmla="*/ 2401 h 2726"/>
                <a:gd name="T2" fmla="*/ 1085 w 1481"/>
                <a:gd name="T3" fmla="*/ 1824 h 2726"/>
                <a:gd name="T4" fmla="*/ 967 w 1481"/>
                <a:gd name="T5" fmla="*/ 1609 h 2726"/>
                <a:gd name="T6" fmla="*/ 894 w 1481"/>
                <a:gd name="T7" fmla="*/ 1534 h 2726"/>
                <a:gd name="T8" fmla="*/ 794 w 1481"/>
                <a:gd name="T9" fmla="*/ 1479 h 2726"/>
                <a:gd name="T10" fmla="*/ 394 w 1481"/>
                <a:gd name="T11" fmla="*/ 1297 h 2726"/>
                <a:gd name="T12" fmla="*/ 252 w 1481"/>
                <a:gd name="T13" fmla="*/ 1230 h 2726"/>
                <a:gd name="T14" fmla="*/ 130 w 1481"/>
                <a:gd name="T15" fmla="*/ 1143 h 2726"/>
                <a:gd name="T16" fmla="*/ 42 w 1481"/>
                <a:gd name="T17" fmla="*/ 1024 h 2726"/>
                <a:gd name="T18" fmla="*/ 2 w 1481"/>
                <a:gd name="T19" fmla="*/ 889 h 2726"/>
                <a:gd name="T20" fmla="*/ 3 w 1481"/>
                <a:gd name="T21" fmla="*/ 758 h 2726"/>
                <a:gd name="T22" fmla="*/ 65 w 1481"/>
                <a:gd name="T23" fmla="*/ 509 h 2726"/>
                <a:gd name="T24" fmla="*/ 187 w 1481"/>
                <a:gd name="T25" fmla="*/ 196 h 2726"/>
                <a:gd name="T26" fmla="*/ 225 w 1481"/>
                <a:gd name="T27" fmla="*/ 85 h 2726"/>
                <a:gd name="T28" fmla="*/ 359 w 1481"/>
                <a:gd name="T29" fmla="*/ 12 h 2726"/>
                <a:gd name="T30" fmla="*/ 438 w 1481"/>
                <a:gd name="T31" fmla="*/ 190 h 2726"/>
                <a:gd name="T32" fmla="*/ 216 w 1481"/>
                <a:gd name="T33" fmla="*/ 211 h 2726"/>
                <a:gd name="T34" fmla="*/ 229 w 1481"/>
                <a:gd name="T35" fmla="*/ 99 h 2726"/>
                <a:gd name="T36" fmla="*/ 308 w 1481"/>
                <a:gd name="T37" fmla="*/ 235 h 2726"/>
                <a:gd name="T38" fmla="*/ 414 w 1481"/>
                <a:gd name="T39" fmla="*/ 222 h 2726"/>
                <a:gd name="T40" fmla="*/ 359 w 1481"/>
                <a:gd name="T41" fmla="*/ 375 h 2726"/>
                <a:gd name="T42" fmla="*/ 241 w 1481"/>
                <a:gd name="T43" fmla="*/ 691 h 2726"/>
                <a:gd name="T44" fmla="*/ 220 w 1481"/>
                <a:gd name="T45" fmla="*/ 786 h 2726"/>
                <a:gd name="T46" fmla="*/ 213 w 1481"/>
                <a:gd name="T47" fmla="*/ 855 h 2726"/>
                <a:gd name="T48" fmla="*/ 225 w 1481"/>
                <a:gd name="T49" fmla="*/ 912 h 2726"/>
                <a:gd name="T50" fmla="*/ 269 w 1481"/>
                <a:gd name="T51" fmla="*/ 971 h 2726"/>
                <a:gd name="T52" fmla="*/ 351 w 1481"/>
                <a:gd name="T53" fmla="*/ 1028 h 2726"/>
                <a:gd name="T54" fmla="*/ 617 w 1481"/>
                <a:gd name="T55" fmla="*/ 1144 h 2726"/>
                <a:gd name="T56" fmla="*/ 1025 w 1481"/>
                <a:gd name="T57" fmla="*/ 1358 h 2726"/>
                <a:gd name="T58" fmla="*/ 1141 w 1481"/>
                <a:gd name="T59" fmla="*/ 1476 h 2726"/>
                <a:gd name="T60" fmla="*/ 1289 w 1481"/>
                <a:gd name="T61" fmla="*/ 1740 h 2726"/>
                <a:gd name="T62" fmla="*/ 1381 w 1481"/>
                <a:gd name="T63" fmla="*/ 2059 h 2726"/>
                <a:gd name="T64" fmla="*/ 1481 w 1481"/>
                <a:gd name="T65" fmla="*/ 2702 h 27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481" h="2726">
                  <a:moveTo>
                    <a:pt x="1264" y="2726"/>
                  </a:moveTo>
                  <a:lnTo>
                    <a:pt x="1223" y="2401"/>
                  </a:lnTo>
                  <a:lnTo>
                    <a:pt x="1168" y="2097"/>
                  </a:lnTo>
                  <a:lnTo>
                    <a:pt x="1085" y="1824"/>
                  </a:lnTo>
                  <a:lnTo>
                    <a:pt x="1094" y="1848"/>
                  </a:lnTo>
                  <a:lnTo>
                    <a:pt x="967" y="1609"/>
                  </a:lnTo>
                  <a:lnTo>
                    <a:pt x="988" y="1633"/>
                  </a:lnTo>
                  <a:lnTo>
                    <a:pt x="894" y="1534"/>
                  </a:lnTo>
                  <a:lnTo>
                    <a:pt x="914" y="1555"/>
                  </a:lnTo>
                  <a:lnTo>
                    <a:pt x="794" y="1479"/>
                  </a:lnTo>
                  <a:lnTo>
                    <a:pt x="535" y="1357"/>
                  </a:lnTo>
                  <a:lnTo>
                    <a:pt x="394" y="1297"/>
                  </a:lnTo>
                  <a:lnTo>
                    <a:pt x="269" y="1240"/>
                  </a:lnTo>
                  <a:cubicBezTo>
                    <a:pt x="262" y="1239"/>
                    <a:pt x="258" y="1236"/>
                    <a:pt x="252" y="1230"/>
                  </a:cubicBezTo>
                  <a:lnTo>
                    <a:pt x="153" y="1163"/>
                  </a:lnTo>
                  <a:cubicBezTo>
                    <a:pt x="144" y="1158"/>
                    <a:pt x="136" y="1152"/>
                    <a:pt x="130" y="1143"/>
                  </a:cubicBezTo>
                  <a:lnTo>
                    <a:pt x="63" y="1063"/>
                  </a:lnTo>
                  <a:cubicBezTo>
                    <a:pt x="52" y="1051"/>
                    <a:pt x="45" y="1038"/>
                    <a:pt x="42" y="1024"/>
                  </a:cubicBezTo>
                  <a:lnTo>
                    <a:pt x="9" y="928"/>
                  </a:lnTo>
                  <a:cubicBezTo>
                    <a:pt x="2" y="915"/>
                    <a:pt x="2" y="904"/>
                    <a:pt x="2" y="889"/>
                  </a:cubicBezTo>
                  <a:lnTo>
                    <a:pt x="2" y="780"/>
                  </a:lnTo>
                  <a:cubicBezTo>
                    <a:pt x="0" y="773"/>
                    <a:pt x="1" y="765"/>
                    <a:pt x="3" y="758"/>
                  </a:cubicBezTo>
                  <a:lnTo>
                    <a:pt x="25" y="640"/>
                  </a:lnTo>
                  <a:lnTo>
                    <a:pt x="65" y="509"/>
                  </a:lnTo>
                  <a:lnTo>
                    <a:pt x="154" y="284"/>
                  </a:lnTo>
                  <a:lnTo>
                    <a:pt x="187" y="196"/>
                  </a:lnTo>
                  <a:lnTo>
                    <a:pt x="211" y="138"/>
                  </a:lnTo>
                  <a:lnTo>
                    <a:pt x="225" y="85"/>
                  </a:lnTo>
                  <a:cubicBezTo>
                    <a:pt x="239" y="29"/>
                    <a:pt x="295" y="0"/>
                    <a:pt x="351" y="11"/>
                  </a:cubicBezTo>
                  <a:lnTo>
                    <a:pt x="359" y="12"/>
                  </a:lnTo>
                  <a:cubicBezTo>
                    <a:pt x="419" y="26"/>
                    <a:pt x="457" y="87"/>
                    <a:pt x="445" y="150"/>
                  </a:cubicBezTo>
                  <a:lnTo>
                    <a:pt x="438" y="190"/>
                  </a:lnTo>
                  <a:lnTo>
                    <a:pt x="433" y="240"/>
                  </a:lnTo>
                  <a:lnTo>
                    <a:pt x="216" y="211"/>
                  </a:lnTo>
                  <a:lnTo>
                    <a:pt x="222" y="139"/>
                  </a:lnTo>
                  <a:lnTo>
                    <a:pt x="229" y="99"/>
                  </a:lnTo>
                  <a:lnTo>
                    <a:pt x="315" y="237"/>
                  </a:lnTo>
                  <a:lnTo>
                    <a:pt x="308" y="235"/>
                  </a:lnTo>
                  <a:lnTo>
                    <a:pt x="434" y="161"/>
                  </a:lnTo>
                  <a:lnTo>
                    <a:pt x="414" y="222"/>
                  </a:lnTo>
                  <a:lnTo>
                    <a:pt x="393" y="288"/>
                  </a:lnTo>
                  <a:lnTo>
                    <a:pt x="359" y="375"/>
                  </a:lnTo>
                  <a:lnTo>
                    <a:pt x="273" y="585"/>
                  </a:lnTo>
                  <a:lnTo>
                    <a:pt x="241" y="691"/>
                  </a:lnTo>
                  <a:lnTo>
                    <a:pt x="219" y="809"/>
                  </a:lnTo>
                  <a:lnTo>
                    <a:pt x="220" y="786"/>
                  </a:lnTo>
                  <a:lnTo>
                    <a:pt x="220" y="894"/>
                  </a:lnTo>
                  <a:lnTo>
                    <a:pt x="213" y="855"/>
                  </a:lnTo>
                  <a:lnTo>
                    <a:pt x="246" y="951"/>
                  </a:lnTo>
                  <a:lnTo>
                    <a:pt x="225" y="912"/>
                  </a:lnTo>
                  <a:lnTo>
                    <a:pt x="292" y="991"/>
                  </a:lnTo>
                  <a:lnTo>
                    <a:pt x="269" y="971"/>
                  </a:lnTo>
                  <a:lnTo>
                    <a:pt x="368" y="1038"/>
                  </a:lnTo>
                  <a:lnTo>
                    <a:pt x="351" y="1028"/>
                  </a:lnTo>
                  <a:lnTo>
                    <a:pt x="476" y="1084"/>
                  </a:lnTo>
                  <a:lnTo>
                    <a:pt x="617" y="1144"/>
                  </a:lnTo>
                  <a:lnTo>
                    <a:pt x="905" y="1281"/>
                  </a:lnTo>
                  <a:lnTo>
                    <a:pt x="1025" y="1358"/>
                  </a:lnTo>
                  <a:cubicBezTo>
                    <a:pt x="1033" y="1363"/>
                    <a:pt x="1042" y="1368"/>
                    <a:pt x="1048" y="1378"/>
                  </a:cubicBezTo>
                  <a:lnTo>
                    <a:pt x="1141" y="1476"/>
                  </a:lnTo>
                  <a:cubicBezTo>
                    <a:pt x="1150" y="1481"/>
                    <a:pt x="1156" y="1491"/>
                    <a:pt x="1162" y="1501"/>
                  </a:cubicBezTo>
                  <a:lnTo>
                    <a:pt x="1289" y="1740"/>
                  </a:lnTo>
                  <a:cubicBezTo>
                    <a:pt x="1291" y="1747"/>
                    <a:pt x="1293" y="1754"/>
                    <a:pt x="1296" y="1764"/>
                  </a:cubicBezTo>
                  <a:lnTo>
                    <a:pt x="1381" y="2059"/>
                  </a:lnTo>
                  <a:lnTo>
                    <a:pt x="1441" y="2377"/>
                  </a:lnTo>
                  <a:lnTo>
                    <a:pt x="1481" y="2702"/>
                  </a:lnTo>
                  <a:lnTo>
                    <a:pt x="1264" y="2726"/>
                  </a:lnTo>
                  <a:close/>
                </a:path>
              </a:pathLst>
            </a:custGeom>
            <a:solidFill>
              <a:srgbClr val="FFC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" name="Freeform 229">
              <a:extLst>
                <a:ext uri="{FF2B5EF4-FFF2-40B4-BE49-F238E27FC236}">
                  <a16:creationId xmlns:a16="http://schemas.microsoft.com/office/drawing/2014/main" id="{9A9EB93A-9702-4DE6-AA48-F78D1A95C2E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8" y="2660"/>
              <a:ext cx="60" cy="109"/>
            </a:xfrm>
            <a:custGeom>
              <a:avLst/>
              <a:gdLst>
                <a:gd name="T0" fmla="*/ 1221 w 1556"/>
                <a:gd name="T1" fmla="*/ 2435 h 2796"/>
                <a:gd name="T2" fmla="*/ 1155 w 1556"/>
                <a:gd name="T3" fmla="*/ 1840 h 2796"/>
                <a:gd name="T4" fmla="*/ 970 w 1556"/>
                <a:gd name="T5" fmla="*/ 1657 h 2796"/>
                <a:gd name="T6" fmla="*/ 1050 w 1556"/>
                <a:gd name="T7" fmla="*/ 1691 h 2796"/>
                <a:gd name="T8" fmla="*/ 955 w 1556"/>
                <a:gd name="T9" fmla="*/ 1536 h 2796"/>
                <a:gd name="T10" fmla="*/ 811 w 1556"/>
                <a:gd name="T11" fmla="*/ 1542 h 2796"/>
                <a:gd name="T12" fmla="*/ 270 w 1556"/>
                <a:gd name="T13" fmla="*/ 1294 h 2796"/>
                <a:gd name="T14" fmla="*/ 71 w 1556"/>
                <a:gd name="T15" fmla="*/ 1118 h 2796"/>
                <a:gd name="T16" fmla="*/ 9 w 1556"/>
                <a:gd name="T17" fmla="*/ 970 h 2796"/>
                <a:gd name="T18" fmla="*/ 0 w 1556"/>
                <a:gd name="T19" fmla="*/ 808 h 2796"/>
                <a:gd name="T20" fmla="*/ 65 w 1556"/>
                <a:gd name="T21" fmla="*/ 525 h 2796"/>
                <a:gd name="T22" fmla="*/ 224 w 1556"/>
                <a:gd name="T23" fmla="*/ 103 h 2796"/>
                <a:gd name="T24" fmla="*/ 283 w 1556"/>
                <a:gd name="T25" fmla="*/ 22 h 2796"/>
                <a:gd name="T26" fmla="*/ 386 w 1556"/>
                <a:gd name="T27" fmla="*/ 1 h 2796"/>
                <a:gd name="T28" fmla="*/ 461 w 1556"/>
                <a:gd name="T29" fmla="*/ 33 h 2796"/>
                <a:gd name="T30" fmla="*/ 518 w 1556"/>
                <a:gd name="T31" fmla="*/ 135 h 2796"/>
                <a:gd name="T32" fmla="*/ 506 w 1556"/>
                <a:gd name="T33" fmla="*/ 275 h 2796"/>
                <a:gd name="T34" fmla="*/ 220 w 1556"/>
                <a:gd name="T35" fmla="*/ 164 h 2796"/>
                <a:gd name="T36" fmla="*/ 381 w 1556"/>
                <a:gd name="T37" fmla="*/ 246 h 2796"/>
                <a:gd name="T38" fmla="*/ 307 w 1556"/>
                <a:gd name="T39" fmla="*/ 269 h 2796"/>
                <a:gd name="T40" fmla="*/ 505 w 1556"/>
                <a:gd name="T41" fmla="*/ 204 h 2796"/>
                <a:gd name="T42" fmla="*/ 343 w 1556"/>
                <a:gd name="T43" fmla="*/ 631 h 2796"/>
                <a:gd name="T44" fmla="*/ 217 w 1556"/>
                <a:gd name="T45" fmla="*/ 836 h 2796"/>
                <a:gd name="T46" fmla="*/ 293 w 1556"/>
                <a:gd name="T47" fmla="*/ 925 h 2796"/>
                <a:gd name="T48" fmla="*/ 239 w 1556"/>
                <a:gd name="T49" fmla="*/ 846 h 2796"/>
                <a:gd name="T50" fmla="*/ 249 w 1556"/>
                <a:gd name="T51" fmla="*/ 999 h 2796"/>
                <a:gd name="T52" fmla="*/ 355 w 1556"/>
                <a:gd name="T53" fmla="*/ 995 h 2796"/>
                <a:gd name="T54" fmla="*/ 274 w 1556"/>
                <a:gd name="T55" fmla="*/ 977 h 2796"/>
                <a:gd name="T56" fmla="*/ 386 w 1556"/>
                <a:gd name="T57" fmla="*/ 1102 h 2796"/>
                <a:gd name="T58" fmla="*/ 525 w 1556"/>
                <a:gd name="T59" fmla="*/ 1077 h 2796"/>
                <a:gd name="T60" fmla="*/ 1092 w 1556"/>
                <a:gd name="T61" fmla="*/ 1362 h 2796"/>
                <a:gd name="T62" fmla="*/ 1212 w 1556"/>
                <a:gd name="T63" fmla="*/ 1487 h 2796"/>
                <a:gd name="T64" fmla="*/ 1360 w 1556"/>
                <a:gd name="T65" fmla="*/ 1759 h 2796"/>
                <a:gd name="T66" fmla="*/ 1553 w 1556"/>
                <a:gd name="T67" fmla="*/ 2728 h 2796"/>
                <a:gd name="T68" fmla="*/ 1479 w 1556"/>
                <a:gd name="T69" fmla="*/ 2735 h 2796"/>
                <a:gd name="T70" fmla="*/ 1289 w 1556"/>
                <a:gd name="T71" fmla="*/ 1780 h 2796"/>
                <a:gd name="T72" fmla="*/ 1164 w 1556"/>
                <a:gd name="T73" fmla="*/ 1546 h 2796"/>
                <a:gd name="T74" fmla="*/ 1053 w 1556"/>
                <a:gd name="T75" fmla="*/ 1429 h 2796"/>
                <a:gd name="T76" fmla="*/ 498 w 1556"/>
                <a:gd name="T77" fmla="*/ 1150 h 2796"/>
                <a:gd name="T78" fmla="*/ 384 w 1556"/>
                <a:gd name="T79" fmla="*/ 1100 h 2796"/>
                <a:gd name="T80" fmla="*/ 300 w 1556"/>
                <a:gd name="T81" fmla="*/ 1046 h 2796"/>
                <a:gd name="T82" fmla="*/ 246 w 1556"/>
                <a:gd name="T83" fmla="*/ 993 h 2796"/>
                <a:gd name="T84" fmla="*/ 218 w 1556"/>
                <a:gd name="T85" fmla="*/ 922 h 2796"/>
                <a:gd name="T86" fmla="*/ 218 w 1556"/>
                <a:gd name="T87" fmla="*/ 830 h 2796"/>
                <a:gd name="T88" fmla="*/ 393 w 1556"/>
                <a:gd name="T89" fmla="*/ 304 h 2796"/>
                <a:gd name="T90" fmla="*/ 362 w 1556"/>
                <a:gd name="T91" fmla="*/ 299 h 2796"/>
                <a:gd name="T92" fmla="*/ 233 w 1556"/>
                <a:gd name="T93" fmla="*/ 149 h 2796"/>
                <a:gd name="T94" fmla="*/ 255 w 1556"/>
                <a:gd name="T95" fmla="*/ 201 h 2796"/>
                <a:gd name="T96" fmla="*/ 444 w 1556"/>
                <a:gd name="T97" fmla="*/ 171 h 2796"/>
                <a:gd name="T98" fmla="*/ 430 w 1556"/>
                <a:gd name="T99" fmla="*/ 106 h 2796"/>
                <a:gd name="T100" fmla="*/ 380 w 1556"/>
                <a:gd name="T101" fmla="*/ 77 h 2796"/>
                <a:gd name="T102" fmla="*/ 358 w 1556"/>
                <a:gd name="T103" fmla="*/ 77 h 2796"/>
                <a:gd name="T104" fmla="*/ 312 w 1556"/>
                <a:gd name="T105" fmla="*/ 96 h 2796"/>
                <a:gd name="T106" fmla="*/ 257 w 1556"/>
                <a:gd name="T107" fmla="*/ 241 h 2796"/>
                <a:gd name="T108" fmla="*/ 75 w 1556"/>
                <a:gd name="T109" fmla="*/ 796 h 2796"/>
                <a:gd name="T110" fmla="*/ 76 w 1556"/>
                <a:gd name="T111" fmla="*/ 938 h 2796"/>
                <a:gd name="T112" fmla="*/ 110 w 1556"/>
                <a:gd name="T113" fmla="*/ 1035 h 2796"/>
                <a:gd name="T114" fmla="*/ 189 w 1556"/>
                <a:gd name="T115" fmla="*/ 1142 h 2796"/>
                <a:gd name="T116" fmla="*/ 443 w 1556"/>
                <a:gd name="T117" fmla="*/ 1290 h 2796"/>
                <a:gd name="T118" fmla="*/ 924 w 1556"/>
                <a:gd name="T119" fmla="*/ 1612 h 2796"/>
                <a:gd name="T120" fmla="*/ 996 w 1556"/>
                <a:gd name="T121" fmla="*/ 1689 h 2796"/>
                <a:gd name="T122" fmla="*/ 1095 w 1556"/>
                <a:gd name="T123" fmla="*/ 1891 h 2796"/>
                <a:gd name="T124" fmla="*/ 1295 w 1556"/>
                <a:gd name="T125" fmla="*/ 2426 h 27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556" h="2796">
                  <a:moveTo>
                    <a:pt x="1304" y="2795"/>
                  </a:moveTo>
                  <a:cubicBezTo>
                    <a:pt x="1295" y="2796"/>
                    <a:pt x="1285" y="2793"/>
                    <a:pt x="1277" y="2786"/>
                  </a:cubicBezTo>
                  <a:cubicBezTo>
                    <a:pt x="1269" y="2779"/>
                    <a:pt x="1264" y="2770"/>
                    <a:pt x="1262" y="2760"/>
                  </a:cubicBezTo>
                  <a:lnTo>
                    <a:pt x="1221" y="2435"/>
                  </a:lnTo>
                  <a:lnTo>
                    <a:pt x="1167" y="2133"/>
                  </a:lnTo>
                  <a:lnTo>
                    <a:pt x="1085" y="1864"/>
                  </a:lnTo>
                  <a:cubicBezTo>
                    <a:pt x="1079" y="1844"/>
                    <a:pt x="1089" y="1823"/>
                    <a:pt x="1108" y="1816"/>
                  </a:cubicBezTo>
                  <a:cubicBezTo>
                    <a:pt x="1127" y="1810"/>
                    <a:pt x="1148" y="1820"/>
                    <a:pt x="1155" y="1840"/>
                  </a:cubicBezTo>
                  <a:lnTo>
                    <a:pt x="1164" y="1864"/>
                  </a:lnTo>
                  <a:cubicBezTo>
                    <a:pt x="1171" y="1883"/>
                    <a:pt x="1163" y="1905"/>
                    <a:pt x="1146" y="1913"/>
                  </a:cubicBezTo>
                  <a:cubicBezTo>
                    <a:pt x="1128" y="1922"/>
                    <a:pt x="1107" y="1914"/>
                    <a:pt x="1097" y="1896"/>
                  </a:cubicBezTo>
                  <a:lnTo>
                    <a:pt x="970" y="1657"/>
                  </a:lnTo>
                  <a:cubicBezTo>
                    <a:pt x="961" y="1639"/>
                    <a:pt x="965" y="1618"/>
                    <a:pt x="980" y="1606"/>
                  </a:cubicBezTo>
                  <a:cubicBezTo>
                    <a:pt x="995" y="1595"/>
                    <a:pt x="1017" y="1597"/>
                    <a:pt x="1030" y="1612"/>
                  </a:cubicBezTo>
                  <a:lnTo>
                    <a:pt x="1051" y="1636"/>
                  </a:lnTo>
                  <a:cubicBezTo>
                    <a:pt x="1065" y="1652"/>
                    <a:pt x="1064" y="1677"/>
                    <a:pt x="1050" y="1691"/>
                  </a:cubicBezTo>
                  <a:cubicBezTo>
                    <a:pt x="1035" y="1706"/>
                    <a:pt x="1012" y="1705"/>
                    <a:pt x="997" y="1690"/>
                  </a:cubicBezTo>
                  <a:lnTo>
                    <a:pt x="903" y="1591"/>
                  </a:lnTo>
                  <a:cubicBezTo>
                    <a:pt x="889" y="1575"/>
                    <a:pt x="888" y="1550"/>
                    <a:pt x="903" y="1535"/>
                  </a:cubicBezTo>
                  <a:cubicBezTo>
                    <a:pt x="917" y="1520"/>
                    <a:pt x="941" y="1521"/>
                    <a:pt x="955" y="1536"/>
                  </a:cubicBezTo>
                  <a:lnTo>
                    <a:pt x="975" y="1557"/>
                  </a:lnTo>
                  <a:cubicBezTo>
                    <a:pt x="989" y="1571"/>
                    <a:pt x="991" y="1594"/>
                    <a:pt x="979" y="1609"/>
                  </a:cubicBezTo>
                  <a:cubicBezTo>
                    <a:pt x="968" y="1624"/>
                    <a:pt x="947" y="1628"/>
                    <a:pt x="931" y="1618"/>
                  </a:cubicBezTo>
                  <a:lnTo>
                    <a:pt x="811" y="1542"/>
                  </a:lnTo>
                  <a:lnTo>
                    <a:pt x="556" y="1422"/>
                  </a:lnTo>
                  <a:lnTo>
                    <a:pt x="416" y="1363"/>
                  </a:lnTo>
                  <a:lnTo>
                    <a:pt x="291" y="1305"/>
                  </a:lnTo>
                  <a:lnTo>
                    <a:pt x="270" y="1294"/>
                  </a:lnTo>
                  <a:lnTo>
                    <a:pt x="169" y="1225"/>
                  </a:lnTo>
                  <a:lnTo>
                    <a:pt x="142" y="1202"/>
                  </a:lnTo>
                  <a:cubicBezTo>
                    <a:pt x="141" y="1201"/>
                    <a:pt x="139" y="1200"/>
                    <a:pt x="138" y="1198"/>
                  </a:cubicBezTo>
                  <a:lnTo>
                    <a:pt x="71" y="1118"/>
                  </a:lnTo>
                  <a:cubicBezTo>
                    <a:pt x="69" y="1116"/>
                    <a:pt x="67" y="1114"/>
                    <a:pt x="66" y="1111"/>
                  </a:cubicBezTo>
                  <a:lnTo>
                    <a:pt x="45" y="1072"/>
                  </a:lnTo>
                  <a:cubicBezTo>
                    <a:pt x="44" y="1070"/>
                    <a:pt x="43" y="1068"/>
                    <a:pt x="42" y="1066"/>
                  </a:cubicBezTo>
                  <a:lnTo>
                    <a:pt x="9" y="970"/>
                  </a:lnTo>
                  <a:lnTo>
                    <a:pt x="3" y="950"/>
                  </a:lnTo>
                  <a:cubicBezTo>
                    <a:pt x="2" y="946"/>
                    <a:pt x="1" y="943"/>
                    <a:pt x="1" y="939"/>
                  </a:cubicBezTo>
                  <a:lnTo>
                    <a:pt x="0" y="919"/>
                  </a:lnTo>
                  <a:lnTo>
                    <a:pt x="0" y="808"/>
                  </a:lnTo>
                  <a:lnTo>
                    <a:pt x="1" y="784"/>
                  </a:lnTo>
                  <a:cubicBezTo>
                    <a:pt x="1" y="783"/>
                    <a:pt x="1" y="781"/>
                    <a:pt x="2" y="779"/>
                  </a:cubicBezTo>
                  <a:lnTo>
                    <a:pt x="24" y="661"/>
                  </a:lnTo>
                  <a:lnTo>
                    <a:pt x="65" y="525"/>
                  </a:lnTo>
                  <a:lnTo>
                    <a:pt x="155" y="297"/>
                  </a:lnTo>
                  <a:lnTo>
                    <a:pt x="188" y="210"/>
                  </a:lnTo>
                  <a:lnTo>
                    <a:pt x="212" y="151"/>
                  </a:lnTo>
                  <a:lnTo>
                    <a:pt x="224" y="103"/>
                  </a:lnTo>
                  <a:cubicBezTo>
                    <a:pt x="225" y="100"/>
                    <a:pt x="226" y="98"/>
                    <a:pt x="227" y="96"/>
                  </a:cubicBezTo>
                  <a:lnTo>
                    <a:pt x="245" y="59"/>
                  </a:lnTo>
                  <a:cubicBezTo>
                    <a:pt x="247" y="54"/>
                    <a:pt x="251" y="50"/>
                    <a:pt x="254" y="47"/>
                  </a:cubicBezTo>
                  <a:lnTo>
                    <a:pt x="283" y="22"/>
                  </a:lnTo>
                  <a:cubicBezTo>
                    <a:pt x="287" y="19"/>
                    <a:pt x="291" y="17"/>
                    <a:pt x="295" y="15"/>
                  </a:cubicBezTo>
                  <a:lnTo>
                    <a:pt x="333" y="2"/>
                  </a:lnTo>
                  <a:cubicBezTo>
                    <a:pt x="337" y="1"/>
                    <a:pt x="341" y="0"/>
                    <a:pt x="345" y="0"/>
                  </a:cubicBezTo>
                  <a:lnTo>
                    <a:pt x="386" y="1"/>
                  </a:lnTo>
                  <a:lnTo>
                    <a:pt x="398" y="2"/>
                  </a:lnTo>
                  <a:cubicBezTo>
                    <a:pt x="402" y="3"/>
                    <a:pt x="405" y="4"/>
                    <a:pt x="409" y="6"/>
                  </a:cubicBezTo>
                  <a:lnTo>
                    <a:pt x="449" y="25"/>
                  </a:lnTo>
                  <a:cubicBezTo>
                    <a:pt x="453" y="27"/>
                    <a:pt x="457" y="30"/>
                    <a:pt x="461" y="33"/>
                  </a:cubicBezTo>
                  <a:lnTo>
                    <a:pt x="491" y="65"/>
                  </a:lnTo>
                  <a:cubicBezTo>
                    <a:pt x="494" y="69"/>
                    <a:pt x="497" y="74"/>
                    <a:pt x="499" y="78"/>
                  </a:cubicBezTo>
                  <a:lnTo>
                    <a:pt x="515" y="119"/>
                  </a:lnTo>
                  <a:cubicBezTo>
                    <a:pt x="517" y="124"/>
                    <a:pt x="518" y="129"/>
                    <a:pt x="518" y="135"/>
                  </a:cubicBezTo>
                  <a:lnTo>
                    <a:pt x="518" y="181"/>
                  </a:lnTo>
                  <a:cubicBezTo>
                    <a:pt x="518" y="183"/>
                    <a:pt x="518" y="185"/>
                    <a:pt x="517" y="188"/>
                  </a:cubicBezTo>
                  <a:lnTo>
                    <a:pt x="510" y="228"/>
                  </a:lnTo>
                  <a:lnTo>
                    <a:pt x="506" y="275"/>
                  </a:lnTo>
                  <a:cubicBezTo>
                    <a:pt x="503" y="296"/>
                    <a:pt x="485" y="311"/>
                    <a:pt x="465" y="308"/>
                  </a:cubicBezTo>
                  <a:lnTo>
                    <a:pt x="248" y="279"/>
                  </a:lnTo>
                  <a:cubicBezTo>
                    <a:pt x="227" y="277"/>
                    <a:pt x="213" y="257"/>
                    <a:pt x="214" y="236"/>
                  </a:cubicBezTo>
                  <a:lnTo>
                    <a:pt x="220" y="164"/>
                  </a:lnTo>
                  <a:lnTo>
                    <a:pt x="228" y="120"/>
                  </a:lnTo>
                  <a:cubicBezTo>
                    <a:pt x="230" y="105"/>
                    <a:pt x="242" y="93"/>
                    <a:pt x="257" y="90"/>
                  </a:cubicBezTo>
                  <a:cubicBezTo>
                    <a:pt x="272" y="87"/>
                    <a:pt x="287" y="94"/>
                    <a:pt x="295" y="108"/>
                  </a:cubicBezTo>
                  <a:lnTo>
                    <a:pt x="381" y="246"/>
                  </a:lnTo>
                  <a:cubicBezTo>
                    <a:pt x="390" y="259"/>
                    <a:pt x="390" y="277"/>
                    <a:pt x="381" y="290"/>
                  </a:cubicBezTo>
                  <a:cubicBezTo>
                    <a:pt x="372" y="303"/>
                    <a:pt x="357" y="309"/>
                    <a:pt x="342" y="304"/>
                  </a:cubicBezTo>
                  <a:lnTo>
                    <a:pt x="335" y="302"/>
                  </a:lnTo>
                  <a:cubicBezTo>
                    <a:pt x="320" y="298"/>
                    <a:pt x="309" y="285"/>
                    <a:pt x="307" y="269"/>
                  </a:cubicBezTo>
                  <a:cubicBezTo>
                    <a:pt x="304" y="253"/>
                    <a:pt x="311" y="238"/>
                    <a:pt x="325" y="230"/>
                  </a:cubicBezTo>
                  <a:lnTo>
                    <a:pt x="451" y="156"/>
                  </a:lnTo>
                  <a:cubicBezTo>
                    <a:pt x="464" y="148"/>
                    <a:pt x="481" y="150"/>
                    <a:pt x="493" y="161"/>
                  </a:cubicBezTo>
                  <a:cubicBezTo>
                    <a:pt x="505" y="172"/>
                    <a:pt x="510" y="189"/>
                    <a:pt x="505" y="204"/>
                  </a:cubicBezTo>
                  <a:lnTo>
                    <a:pt x="485" y="265"/>
                  </a:lnTo>
                  <a:lnTo>
                    <a:pt x="464" y="331"/>
                  </a:lnTo>
                  <a:lnTo>
                    <a:pt x="429" y="420"/>
                  </a:lnTo>
                  <a:lnTo>
                    <a:pt x="343" y="631"/>
                  </a:lnTo>
                  <a:lnTo>
                    <a:pt x="312" y="733"/>
                  </a:lnTo>
                  <a:lnTo>
                    <a:pt x="291" y="847"/>
                  </a:lnTo>
                  <a:cubicBezTo>
                    <a:pt x="287" y="867"/>
                    <a:pt x="269" y="880"/>
                    <a:pt x="250" y="877"/>
                  </a:cubicBezTo>
                  <a:cubicBezTo>
                    <a:pt x="231" y="874"/>
                    <a:pt x="216" y="856"/>
                    <a:pt x="217" y="836"/>
                  </a:cubicBezTo>
                  <a:lnTo>
                    <a:pt x="218" y="813"/>
                  </a:lnTo>
                  <a:cubicBezTo>
                    <a:pt x="219" y="791"/>
                    <a:pt x="236" y="775"/>
                    <a:pt x="256" y="776"/>
                  </a:cubicBezTo>
                  <a:cubicBezTo>
                    <a:pt x="277" y="777"/>
                    <a:pt x="293" y="795"/>
                    <a:pt x="293" y="817"/>
                  </a:cubicBezTo>
                  <a:lnTo>
                    <a:pt x="293" y="925"/>
                  </a:lnTo>
                  <a:cubicBezTo>
                    <a:pt x="293" y="945"/>
                    <a:pt x="278" y="961"/>
                    <a:pt x="259" y="963"/>
                  </a:cubicBezTo>
                  <a:cubicBezTo>
                    <a:pt x="240" y="964"/>
                    <a:pt x="222" y="950"/>
                    <a:pt x="219" y="930"/>
                  </a:cubicBezTo>
                  <a:lnTo>
                    <a:pt x="212" y="891"/>
                  </a:lnTo>
                  <a:cubicBezTo>
                    <a:pt x="208" y="870"/>
                    <a:pt x="220" y="851"/>
                    <a:pt x="239" y="846"/>
                  </a:cubicBezTo>
                  <a:cubicBezTo>
                    <a:pt x="257" y="841"/>
                    <a:pt x="277" y="853"/>
                    <a:pt x="284" y="872"/>
                  </a:cubicBezTo>
                  <a:lnTo>
                    <a:pt x="317" y="968"/>
                  </a:lnTo>
                  <a:cubicBezTo>
                    <a:pt x="323" y="987"/>
                    <a:pt x="315" y="1008"/>
                    <a:pt x="297" y="1017"/>
                  </a:cubicBezTo>
                  <a:cubicBezTo>
                    <a:pt x="280" y="1025"/>
                    <a:pt x="259" y="1017"/>
                    <a:pt x="249" y="999"/>
                  </a:cubicBezTo>
                  <a:lnTo>
                    <a:pt x="228" y="960"/>
                  </a:lnTo>
                  <a:cubicBezTo>
                    <a:pt x="219" y="942"/>
                    <a:pt x="223" y="920"/>
                    <a:pt x="238" y="909"/>
                  </a:cubicBezTo>
                  <a:cubicBezTo>
                    <a:pt x="254" y="898"/>
                    <a:pt x="275" y="901"/>
                    <a:pt x="288" y="916"/>
                  </a:cubicBezTo>
                  <a:lnTo>
                    <a:pt x="355" y="995"/>
                  </a:lnTo>
                  <a:cubicBezTo>
                    <a:pt x="368" y="1010"/>
                    <a:pt x="368" y="1034"/>
                    <a:pt x="355" y="1048"/>
                  </a:cubicBezTo>
                  <a:cubicBezTo>
                    <a:pt x="341" y="1063"/>
                    <a:pt x="319" y="1064"/>
                    <a:pt x="304" y="1050"/>
                  </a:cubicBezTo>
                  <a:lnTo>
                    <a:pt x="281" y="1030"/>
                  </a:lnTo>
                  <a:cubicBezTo>
                    <a:pt x="266" y="1017"/>
                    <a:pt x="263" y="994"/>
                    <a:pt x="274" y="977"/>
                  </a:cubicBezTo>
                  <a:cubicBezTo>
                    <a:pt x="285" y="960"/>
                    <a:pt x="307" y="956"/>
                    <a:pt x="324" y="968"/>
                  </a:cubicBezTo>
                  <a:lnTo>
                    <a:pt x="423" y="1035"/>
                  </a:lnTo>
                  <a:cubicBezTo>
                    <a:pt x="440" y="1046"/>
                    <a:pt x="446" y="1070"/>
                    <a:pt x="436" y="1088"/>
                  </a:cubicBezTo>
                  <a:cubicBezTo>
                    <a:pt x="426" y="1106"/>
                    <a:pt x="404" y="1112"/>
                    <a:pt x="386" y="1102"/>
                  </a:cubicBezTo>
                  <a:lnTo>
                    <a:pt x="369" y="1092"/>
                  </a:lnTo>
                  <a:cubicBezTo>
                    <a:pt x="351" y="1081"/>
                    <a:pt x="344" y="1059"/>
                    <a:pt x="353" y="1040"/>
                  </a:cubicBezTo>
                  <a:cubicBezTo>
                    <a:pt x="361" y="1021"/>
                    <a:pt x="382" y="1013"/>
                    <a:pt x="400" y="1021"/>
                  </a:cubicBezTo>
                  <a:lnTo>
                    <a:pt x="525" y="1077"/>
                  </a:lnTo>
                  <a:lnTo>
                    <a:pt x="666" y="1137"/>
                  </a:lnTo>
                  <a:lnTo>
                    <a:pt x="955" y="1275"/>
                  </a:lnTo>
                  <a:lnTo>
                    <a:pt x="1079" y="1354"/>
                  </a:lnTo>
                  <a:lnTo>
                    <a:pt x="1092" y="1362"/>
                  </a:lnTo>
                  <a:cubicBezTo>
                    <a:pt x="1094" y="1364"/>
                    <a:pt x="1097" y="1366"/>
                    <a:pt x="1099" y="1369"/>
                  </a:cubicBezTo>
                  <a:lnTo>
                    <a:pt x="1110" y="1381"/>
                  </a:lnTo>
                  <a:lnTo>
                    <a:pt x="1202" y="1478"/>
                  </a:lnTo>
                  <a:lnTo>
                    <a:pt x="1212" y="1487"/>
                  </a:lnTo>
                  <a:cubicBezTo>
                    <a:pt x="1215" y="1489"/>
                    <a:pt x="1217" y="1492"/>
                    <a:pt x="1219" y="1495"/>
                  </a:cubicBezTo>
                  <a:lnTo>
                    <a:pt x="1228" y="1509"/>
                  </a:lnTo>
                  <a:lnTo>
                    <a:pt x="1357" y="1751"/>
                  </a:lnTo>
                  <a:cubicBezTo>
                    <a:pt x="1358" y="1754"/>
                    <a:pt x="1359" y="1756"/>
                    <a:pt x="1360" y="1759"/>
                  </a:cubicBezTo>
                  <a:lnTo>
                    <a:pt x="1367" y="1783"/>
                  </a:lnTo>
                  <a:lnTo>
                    <a:pt x="1452" y="2078"/>
                  </a:lnTo>
                  <a:lnTo>
                    <a:pt x="1513" y="2400"/>
                  </a:lnTo>
                  <a:lnTo>
                    <a:pt x="1553" y="2728"/>
                  </a:lnTo>
                  <a:cubicBezTo>
                    <a:pt x="1556" y="2749"/>
                    <a:pt x="1542" y="2768"/>
                    <a:pt x="1521" y="2771"/>
                  </a:cubicBezTo>
                  <a:lnTo>
                    <a:pt x="1304" y="2795"/>
                  </a:lnTo>
                  <a:close/>
                  <a:moveTo>
                    <a:pt x="1511" y="2692"/>
                  </a:moveTo>
                  <a:lnTo>
                    <a:pt x="1479" y="2735"/>
                  </a:lnTo>
                  <a:lnTo>
                    <a:pt x="1440" y="2413"/>
                  </a:lnTo>
                  <a:lnTo>
                    <a:pt x="1381" y="2099"/>
                  </a:lnTo>
                  <a:lnTo>
                    <a:pt x="1296" y="1804"/>
                  </a:lnTo>
                  <a:lnTo>
                    <a:pt x="1289" y="1780"/>
                  </a:lnTo>
                  <a:lnTo>
                    <a:pt x="1292" y="1788"/>
                  </a:lnTo>
                  <a:lnTo>
                    <a:pt x="1167" y="1552"/>
                  </a:lnTo>
                  <a:lnTo>
                    <a:pt x="1158" y="1538"/>
                  </a:lnTo>
                  <a:lnTo>
                    <a:pt x="1164" y="1546"/>
                  </a:lnTo>
                  <a:lnTo>
                    <a:pt x="1150" y="1533"/>
                  </a:lnTo>
                  <a:lnTo>
                    <a:pt x="1057" y="1434"/>
                  </a:lnTo>
                  <a:lnTo>
                    <a:pt x="1046" y="1422"/>
                  </a:lnTo>
                  <a:lnTo>
                    <a:pt x="1053" y="1429"/>
                  </a:lnTo>
                  <a:lnTo>
                    <a:pt x="1042" y="1421"/>
                  </a:lnTo>
                  <a:lnTo>
                    <a:pt x="926" y="1346"/>
                  </a:lnTo>
                  <a:lnTo>
                    <a:pt x="639" y="1210"/>
                  </a:lnTo>
                  <a:lnTo>
                    <a:pt x="498" y="1150"/>
                  </a:lnTo>
                  <a:lnTo>
                    <a:pt x="373" y="1094"/>
                  </a:lnTo>
                  <a:lnTo>
                    <a:pt x="404" y="1023"/>
                  </a:lnTo>
                  <a:lnTo>
                    <a:pt x="421" y="1033"/>
                  </a:lnTo>
                  <a:lnTo>
                    <a:pt x="384" y="1100"/>
                  </a:lnTo>
                  <a:lnTo>
                    <a:pt x="285" y="1033"/>
                  </a:lnTo>
                  <a:lnTo>
                    <a:pt x="328" y="970"/>
                  </a:lnTo>
                  <a:lnTo>
                    <a:pt x="351" y="990"/>
                  </a:lnTo>
                  <a:lnTo>
                    <a:pt x="300" y="1046"/>
                  </a:lnTo>
                  <a:lnTo>
                    <a:pt x="233" y="967"/>
                  </a:lnTo>
                  <a:lnTo>
                    <a:pt x="293" y="923"/>
                  </a:lnTo>
                  <a:lnTo>
                    <a:pt x="314" y="962"/>
                  </a:lnTo>
                  <a:lnTo>
                    <a:pt x="246" y="993"/>
                  </a:lnTo>
                  <a:lnTo>
                    <a:pt x="213" y="897"/>
                  </a:lnTo>
                  <a:lnTo>
                    <a:pt x="285" y="878"/>
                  </a:lnTo>
                  <a:lnTo>
                    <a:pt x="292" y="917"/>
                  </a:lnTo>
                  <a:lnTo>
                    <a:pt x="218" y="922"/>
                  </a:lnTo>
                  <a:lnTo>
                    <a:pt x="218" y="814"/>
                  </a:lnTo>
                  <a:lnTo>
                    <a:pt x="293" y="818"/>
                  </a:lnTo>
                  <a:lnTo>
                    <a:pt x="292" y="841"/>
                  </a:lnTo>
                  <a:lnTo>
                    <a:pt x="218" y="830"/>
                  </a:lnTo>
                  <a:lnTo>
                    <a:pt x="241" y="708"/>
                  </a:lnTo>
                  <a:lnTo>
                    <a:pt x="274" y="598"/>
                  </a:lnTo>
                  <a:lnTo>
                    <a:pt x="360" y="389"/>
                  </a:lnTo>
                  <a:lnTo>
                    <a:pt x="393" y="304"/>
                  </a:lnTo>
                  <a:lnTo>
                    <a:pt x="414" y="238"/>
                  </a:lnTo>
                  <a:lnTo>
                    <a:pt x="434" y="177"/>
                  </a:lnTo>
                  <a:lnTo>
                    <a:pt x="488" y="225"/>
                  </a:lnTo>
                  <a:lnTo>
                    <a:pt x="362" y="299"/>
                  </a:lnTo>
                  <a:lnTo>
                    <a:pt x="352" y="227"/>
                  </a:lnTo>
                  <a:lnTo>
                    <a:pt x="359" y="229"/>
                  </a:lnTo>
                  <a:lnTo>
                    <a:pt x="319" y="287"/>
                  </a:lnTo>
                  <a:lnTo>
                    <a:pt x="233" y="149"/>
                  </a:lnTo>
                  <a:lnTo>
                    <a:pt x="301" y="137"/>
                  </a:lnTo>
                  <a:lnTo>
                    <a:pt x="295" y="173"/>
                  </a:lnTo>
                  <a:lnTo>
                    <a:pt x="289" y="245"/>
                  </a:lnTo>
                  <a:lnTo>
                    <a:pt x="255" y="201"/>
                  </a:lnTo>
                  <a:lnTo>
                    <a:pt x="472" y="230"/>
                  </a:lnTo>
                  <a:lnTo>
                    <a:pt x="431" y="264"/>
                  </a:lnTo>
                  <a:lnTo>
                    <a:pt x="437" y="211"/>
                  </a:lnTo>
                  <a:lnTo>
                    <a:pt x="444" y="171"/>
                  </a:lnTo>
                  <a:lnTo>
                    <a:pt x="443" y="178"/>
                  </a:lnTo>
                  <a:lnTo>
                    <a:pt x="443" y="132"/>
                  </a:lnTo>
                  <a:lnTo>
                    <a:pt x="446" y="147"/>
                  </a:lnTo>
                  <a:lnTo>
                    <a:pt x="430" y="106"/>
                  </a:lnTo>
                  <a:lnTo>
                    <a:pt x="438" y="120"/>
                  </a:lnTo>
                  <a:lnTo>
                    <a:pt x="408" y="88"/>
                  </a:lnTo>
                  <a:lnTo>
                    <a:pt x="420" y="96"/>
                  </a:lnTo>
                  <a:lnTo>
                    <a:pt x="380" y="77"/>
                  </a:lnTo>
                  <a:lnTo>
                    <a:pt x="391" y="81"/>
                  </a:lnTo>
                  <a:lnTo>
                    <a:pt x="387" y="80"/>
                  </a:lnTo>
                  <a:lnTo>
                    <a:pt x="346" y="79"/>
                  </a:lnTo>
                  <a:lnTo>
                    <a:pt x="358" y="77"/>
                  </a:lnTo>
                  <a:lnTo>
                    <a:pt x="320" y="90"/>
                  </a:lnTo>
                  <a:lnTo>
                    <a:pt x="332" y="83"/>
                  </a:lnTo>
                  <a:lnTo>
                    <a:pt x="303" y="108"/>
                  </a:lnTo>
                  <a:lnTo>
                    <a:pt x="312" y="96"/>
                  </a:lnTo>
                  <a:lnTo>
                    <a:pt x="294" y="133"/>
                  </a:lnTo>
                  <a:lnTo>
                    <a:pt x="296" y="126"/>
                  </a:lnTo>
                  <a:lnTo>
                    <a:pt x="281" y="184"/>
                  </a:lnTo>
                  <a:lnTo>
                    <a:pt x="257" y="241"/>
                  </a:lnTo>
                  <a:lnTo>
                    <a:pt x="224" y="329"/>
                  </a:lnTo>
                  <a:lnTo>
                    <a:pt x="136" y="552"/>
                  </a:lnTo>
                  <a:lnTo>
                    <a:pt x="97" y="678"/>
                  </a:lnTo>
                  <a:lnTo>
                    <a:pt x="75" y="796"/>
                  </a:lnTo>
                  <a:lnTo>
                    <a:pt x="76" y="791"/>
                  </a:lnTo>
                  <a:lnTo>
                    <a:pt x="75" y="811"/>
                  </a:lnTo>
                  <a:lnTo>
                    <a:pt x="75" y="918"/>
                  </a:lnTo>
                  <a:lnTo>
                    <a:pt x="76" y="938"/>
                  </a:lnTo>
                  <a:lnTo>
                    <a:pt x="74" y="927"/>
                  </a:lnTo>
                  <a:lnTo>
                    <a:pt x="80" y="945"/>
                  </a:lnTo>
                  <a:lnTo>
                    <a:pt x="113" y="1041"/>
                  </a:lnTo>
                  <a:lnTo>
                    <a:pt x="110" y="1035"/>
                  </a:lnTo>
                  <a:lnTo>
                    <a:pt x="131" y="1074"/>
                  </a:lnTo>
                  <a:lnTo>
                    <a:pt x="126" y="1067"/>
                  </a:lnTo>
                  <a:lnTo>
                    <a:pt x="193" y="1147"/>
                  </a:lnTo>
                  <a:lnTo>
                    <a:pt x="189" y="1142"/>
                  </a:lnTo>
                  <a:lnTo>
                    <a:pt x="208" y="1160"/>
                  </a:lnTo>
                  <a:lnTo>
                    <a:pt x="305" y="1225"/>
                  </a:lnTo>
                  <a:lnTo>
                    <a:pt x="318" y="1233"/>
                  </a:lnTo>
                  <a:lnTo>
                    <a:pt x="443" y="1290"/>
                  </a:lnTo>
                  <a:lnTo>
                    <a:pt x="585" y="1351"/>
                  </a:lnTo>
                  <a:lnTo>
                    <a:pt x="848" y="1475"/>
                  </a:lnTo>
                  <a:lnTo>
                    <a:pt x="968" y="1551"/>
                  </a:lnTo>
                  <a:lnTo>
                    <a:pt x="924" y="1612"/>
                  </a:lnTo>
                  <a:lnTo>
                    <a:pt x="904" y="1591"/>
                  </a:lnTo>
                  <a:lnTo>
                    <a:pt x="955" y="1536"/>
                  </a:lnTo>
                  <a:lnTo>
                    <a:pt x="1049" y="1635"/>
                  </a:lnTo>
                  <a:lnTo>
                    <a:pt x="996" y="1689"/>
                  </a:lnTo>
                  <a:lnTo>
                    <a:pt x="975" y="1665"/>
                  </a:lnTo>
                  <a:lnTo>
                    <a:pt x="1035" y="1620"/>
                  </a:lnTo>
                  <a:lnTo>
                    <a:pt x="1162" y="1859"/>
                  </a:lnTo>
                  <a:lnTo>
                    <a:pt x="1095" y="1891"/>
                  </a:lnTo>
                  <a:lnTo>
                    <a:pt x="1086" y="1867"/>
                  </a:lnTo>
                  <a:lnTo>
                    <a:pt x="1156" y="1842"/>
                  </a:lnTo>
                  <a:lnTo>
                    <a:pt x="1240" y="2120"/>
                  </a:lnTo>
                  <a:lnTo>
                    <a:pt x="1295" y="2426"/>
                  </a:lnTo>
                  <a:lnTo>
                    <a:pt x="1336" y="2751"/>
                  </a:lnTo>
                  <a:lnTo>
                    <a:pt x="1294" y="2716"/>
                  </a:lnTo>
                  <a:lnTo>
                    <a:pt x="1511" y="2692"/>
                  </a:lnTo>
                  <a:close/>
                </a:path>
              </a:pathLst>
            </a:custGeom>
            <a:solidFill>
              <a:srgbClr val="FFC000"/>
            </a:solidFill>
            <a:ln w="0" cap="flat">
              <a:solidFill>
                <a:srgbClr val="FFC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" name="Freeform 230">
              <a:extLst>
                <a:ext uri="{FF2B5EF4-FFF2-40B4-BE49-F238E27FC236}">
                  <a16:creationId xmlns:a16="http://schemas.microsoft.com/office/drawing/2014/main" id="{64A63027-724A-4C92-8514-88A90A315A89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82" y="2454"/>
              <a:ext cx="266" cy="365"/>
            </a:xfrm>
            <a:custGeom>
              <a:avLst/>
              <a:gdLst>
                <a:gd name="T0" fmla="*/ 154 w 266"/>
                <a:gd name="T1" fmla="*/ 365 h 365"/>
                <a:gd name="T2" fmla="*/ 122 w 266"/>
                <a:gd name="T3" fmla="*/ 358 h 365"/>
                <a:gd name="T4" fmla="*/ 90 w 266"/>
                <a:gd name="T5" fmla="*/ 342 h 365"/>
                <a:gd name="T6" fmla="*/ 62 w 266"/>
                <a:gd name="T7" fmla="*/ 316 h 365"/>
                <a:gd name="T8" fmla="*/ 37 w 266"/>
                <a:gd name="T9" fmla="*/ 283 h 365"/>
                <a:gd name="T10" fmla="*/ 17 w 266"/>
                <a:gd name="T11" fmla="*/ 242 h 365"/>
                <a:gd name="T12" fmla="*/ 4 w 266"/>
                <a:gd name="T13" fmla="*/ 197 h 365"/>
                <a:gd name="T14" fmla="*/ 0 w 266"/>
                <a:gd name="T15" fmla="*/ 152 h 365"/>
                <a:gd name="T16" fmla="*/ 3 w 266"/>
                <a:gd name="T17" fmla="*/ 110 h 365"/>
                <a:gd name="T18" fmla="*/ 14 w 266"/>
                <a:gd name="T19" fmla="*/ 72 h 365"/>
                <a:gd name="T20" fmla="*/ 32 w 266"/>
                <a:gd name="T21" fmla="*/ 41 h 365"/>
                <a:gd name="T22" fmla="*/ 56 w 266"/>
                <a:gd name="T23" fmla="*/ 17 h 365"/>
                <a:gd name="T24" fmla="*/ 85 w 266"/>
                <a:gd name="T25" fmla="*/ 3 h 365"/>
                <a:gd name="T26" fmla="*/ 118 w 266"/>
                <a:gd name="T27" fmla="*/ 0 h 365"/>
                <a:gd name="T28" fmla="*/ 150 w 266"/>
                <a:gd name="T29" fmla="*/ 9 h 365"/>
                <a:gd name="T30" fmla="*/ 181 w 266"/>
                <a:gd name="T31" fmla="*/ 28 h 365"/>
                <a:gd name="T32" fmla="*/ 209 w 266"/>
                <a:gd name="T33" fmla="*/ 55 h 365"/>
                <a:gd name="T34" fmla="*/ 233 w 266"/>
                <a:gd name="T35" fmla="*/ 90 h 365"/>
                <a:gd name="T36" fmla="*/ 252 w 266"/>
                <a:gd name="T37" fmla="*/ 131 h 365"/>
                <a:gd name="T38" fmla="*/ 263 w 266"/>
                <a:gd name="T39" fmla="*/ 177 h 365"/>
                <a:gd name="T40" fmla="*/ 266 w 266"/>
                <a:gd name="T41" fmla="*/ 222 h 365"/>
                <a:gd name="T42" fmla="*/ 261 w 266"/>
                <a:gd name="T43" fmla="*/ 263 h 365"/>
                <a:gd name="T44" fmla="*/ 249 w 266"/>
                <a:gd name="T45" fmla="*/ 300 h 365"/>
                <a:gd name="T46" fmla="*/ 230 w 266"/>
                <a:gd name="T47" fmla="*/ 330 h 365"/>
                <a:gd name="T48" fmla="*/ 205 w 266"/>
                <a:gd name="T49" fmla="*/ 351 h 365"/>
                <a:gd name="T50" fmla="*/ 186 w 266"/>
                <a:gd name="T51" fmla="*/ 357 h 365"/>
                <a:gd name="T52" fmla="*/ 214 w 266"/>
                <a:gd name="T53" fmla="*/ 341 h 365"/>
                <a:gd name="T54" fmla="*/ 236 w 266"/>
                <a:gd name="T55" fmla="*/ 317 h 365"/>
                <a:gd name="T56" fmla="*/ 252 w 266"/>
                <a:gd name="T57" fmla="*/ 285 h 365"/>
                <a:gd name="T58" fmla="*/ 261 w 266"/>
                <a:gd name="T59" fmla="*/ 247 h 365"/>
                <a:gd name="T60" fmla="*/ 263 w 266"/>
                <a:gd name="T61" fmla="*/ 204 h 365"/>
                <a:gd name="T62" fmla="*/ 257 w 266"/>
                <a:gd name="T63" fmla="*/ 159 h 365"/>
                <a:gd name="T64" fmla="*/ 242 w 266"/>
                <a:gd name="T65" fmla="*/ 115 h 365"/>
                <a:gd name="T66" fmla="*/ 222 w 266"/>
                <a:gd name="T67" fmla="*/ 77 h 365"/>
                <a:gd name="T68" fmla="*/ 197 w 266"/>
                <a:gd name="T69" fmla="*/ 45 h 365"/>
                <a:gd name="T70" fmla="*/ 168 w 266"/>
                <a:gd name="T71" fmla="*/ 22 h 365"/>
                <a:gd name="T72" fmla="*/ 137 w 266"/>
                <a:gd name="T73" fmla="*/ 7 h 365"/>
                <a:gd name="T74" fmla="*/ 105 w 266"/>
                <a:gd name="T75" fmla="*/ 3 h 365"/>
                <a:gd name="T76" fmla="*/ 74 w 266"/>
                <a:gd name="T77" fmla="*/ 10 h 365"/>
                <a:gd name="T78" fmla="*/ 47 w 266"/>
                <a:gd name="T79" fmla="*/ 28 h 365"/>
                <a:gd name="T80" fmla="*/ 26 w 266"/>
                <a:gd name="T81" fmla="*/ 54 h 365"/>
                <a:gd name="T82" fmla="*/ 12 w 266"/>
                <a:gd name="T83" fmla="*/ 87 h 365"/>
                <a:gd name="T84" fmla="*/ 4 w 266"/>
                <a:gd name="T85" fmla="*/ 127 h 365"/>
                <a:gd name="T86" fmla="*/ 3 w 266"/>
                <a:gd name="T87" fmla="*/ 169 h 365"/>
                <a:gd name="T88" fmla="*/ 11 w 266"/>
                <a:gd name="T89" fmla="*/ 215 h 365"/>
                <a:gd name="T90" fmla="*/ 27 w 266"/>
                <a:gd name="T91" fmla="*/ 258 h 365"/>
                <a:gd name="T92" fmla="*/ 48 w 266"/>
                <a:gd name="T93" fmla="*/ 295 h 365"/>
                <a:gd name="T94" fmla="*/ 75 w 266"/>
                <a:gd name="T95" fmla="*/ 325 h 365"/>
                <a:gd name="T96" fmla="*/ 104 w 266"/>
                <a:gd name="T97" fmla="*/ 347 h 365"/>
                <a:gd name="T98" fmla="*/ 135 w 266"/>
                <a:gd name="T99" fmla="*/ 359 h 365"/>
                <a:gd name="T100" fmla="*/ 167 w 266"/>
                <a:gd name="T101" fmla="*/ 361 h 3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266" h="365">
                  <a:moveTo>
                    <a:pt x="180" y="362"/>
                  </a:moveTo>
                  <a:lnTo>
                    <a:pt x="174" y="363"/>
                  </a:lnTo>
                  <a:lnTo>
                    <a:pt x="167" y="364"/>
                  </a:lnTo>
                  <a:lnTo>
                    <a:pt x="161" y="365"/>
                  </a:lnTo>
                  <a:lnTo>
                    <a:pt x="154" y="365"/>
                  </a:lnTo>
                  <a:lnTo>
                    <a:pt x="148" y="364"/>
                  </a:lnTo>
                  <a:lnTo>
                    <a:pt x="141" y="364"/>
                  </a:lnTo>
                  <a:lnTo>
                    <a:pt x="135" y="362"/>
                  </a:lnTo>
                  <a:lnTo>
                    <a:pt x="128" y="361"/>
                  </a:lnTo>
                  <a:lnTo>
                    <a:pt x="122" y="358"/>
                  </a:lnTo>
                  <a:lnTo>
                    <a:pt x="115" y="356"/>
                  </a:lnTo>
                  <a:lnTo>
                    <a:pt x="109" y="353"/>
                  </a:lnTo>
                  <a:lnTo>
                    <a:pt x="103" y="350"/>
                  </a:lnTo>
                  <a:lnTo>
                    <a:pt x="96" y="346"/>
                  </a:lnTo>
                  <a:lnTo>
                    <a:pt x="90" y="342"/>
                  </a:lnTo>
                  <a:lnTo>
                    <a:pt x="84" y="337"/>
                  </a:lnTo>
                  <a:lnTo>
                    <a:pt x="78" y="333"/>
                  </a:lnTo>
                  <a:lnTo>
                    <a:pt x="73" y="327"/>
                  </a:lnTo>
                  <a:lnTo>
                    <a:pt x="67" y="322"/>
                  </a:lnTo>
                  <a:lnTo>
                    <a:pt x="62" y="316"/>
                  </a:lnTo>
                  <a:lnTo>
                    <a:pt x="56" y="310"/>
                  </a:lnTo>
                  <a:lnTo>
                    <a:pt x="51" y="304"/>
                  </a:lnTo>
                  <a:lnTo>
                    <a:pt x="46" y="297"/>
                  </a:lnTo>
                  <a:lnTo>
                    <a:pt x="41" y="290"/>
                  </a:lnTo>
                  <a:lnTo>
                    <a:pt x="37" y="283"/>
                  </a:lnTo>
                  <a:lnTo>
                    <a:pt x="32" y="275"/>
                  </a:lnTo>
                  <a:lnTo>
                    <a:pt x="28" y="267"/>
                  </a:lnTo>
                  <a:lnTo>
                    <a:pt x="24" y="259"/>
                  </a:lnTo>
                  <a:lnTo>
                    <a:pt x="21" y="251"/>
                  </a:lnTo>
                  <a:lnTo>
                    <a:pt x="17" y="242"/>
                  </a:lnTo>
                  <a:lnTo>
                    <a:pt x="14" y="234"/>
                  </a:lnTo>
                  <a:lnTo>
                    <a:pt x="11" y="225"/>
                  </a:lnTo>
                  <a:lnTo>
                    <a:pt x="9" y="216"/>
                  </a:lnTo>
                  <a:lnTo>
                    <a:pt x="6" y="206"/>
                  </a:lnTo>
                  <a:lnTo>
                    <a:pt x="4" y="197"/>
                  </a:lnTo>
                  <a:lnTo>
                    <a:pt x="3" y="188"/>
                  </a:lnTo>
                  <a:lnTo>
                    <a:pt x="2" y="179"/>
                  </a:lnTo>
                  <a:lnTo>
                    <a:pt x="1" y="170"/>
                  </a:lnTo>
                  <a:lnTo>
                    <a:pt x="0" y="161"/>
                  </a:lnTo>
                  <a:lnTo>
                    <a:pt x="0" y="152"/>
                  </a:lnTo>
                  <a:lnTo>
                    <a:pt x="0" y="143"/>
                  </a:lnTo>
                  <a:lnTo>
                    <a:pt x="0" y="135"/>
                  </a:lnTo>
                  <a:lnTo>
                    <a:pt x="1" y="126"/>
                  </a:lnTo>
                  <a:lnTo>
                    <a:pt x="2" y="118"/>
                  </a:lnTo>
                  <a:lnTo>
                    <a:pt x="3" y="110"/>
                  </a:lnTo>
                  <a:lnTo>
                    <a:pt x="5" y="102"/>
                  </a:lnTo>
                  <a:lnTo>
                    <a:pt x="7" y="94"/>
                  </a:lnTo>
                  <a:lnTo>
                    <a:pt x="9" y="87"/>
                  </a:lnTo>
                  <a:lnTo>
                    <a:pt x="11" y="79"/>
                  </a:lnTo>
                  <a:lnTo>
                    <a:pt x="14" y="72"/>
                  </a:lnTo>
                  <a:lnTo>
                    <a:pt x="17" y="65"/>
                  </a:lnTo>
                  <a:lnTo>
                    <a:pt x="20" y="59"/>
                  </a:lnTo>
                  <a:lnTo>
                    <a:pt x="24" y="52"/>
                  </a:lnTo>
                  <a:lnTo>
                    <a:pt x="28" y="46"/>
                  </a:lnTo>
                  <a:lnTo>
                    <a:pt x="32" y="41"/>
                  </a:lnTo>
                  <a:lnTo>
                    <a:pt x="36" y="35"/>
                  </a:lnTo>
                  <a:lnTo>
                    <a:pt x="40" y="30"/>
                  </a:lnTo>
                  <a:lnTo>
                    <a:pt x="45" y="25"/>
                  </a:lnTo>
                  <a:lnTo>
                    <a:pt x="50" y="21"/>
                  </a:lnTo>
                  <a:lnTo>
                    <a:pt x="56" y="17"/>
                  </a:lnTo>
                  <a:lnTo>
                    <a:pt x="61" y="13"/>
                  </a:lnTo>
                  <a:lnTo>
                    <a:pt x="67" y="10"/>
                  </a:lnTo>
                  <a:lnTo>
                    <a:pt x="73" y="7"/>
                  </a:lnTo>
                  <a:lnTo>
                    <a:pt x="79" y="5"/>
                  </a:lnTo>
                  <a:lnTo>
                    <a:pt x="85" y="3"/>
                  </a:lnTo>
                  <a:lnTo>
                    <a:pt x="92" y="2"/>
                  </a:lnTo>
                  <a:lnTo>
                    <a:pt x="98" y="1"/>
                  </a:lnTo>
                  <a:lnTo>
                    <a:pt x="105" y="0"/>
                  </a:lnTo>
                  <a:lnTo>
                    <a:pt x="111" y="0"/>
                  </a:lnTo>
                  <a:lnTo>
                    <a:pt x="118" y="0"/>
                  </a:lnTo>
                  <a:lnTo>
                    <a:pt x="124" y="1"/>
                  </a:lnTo>
                  <a:lnTo>
                    <a:pt x="131" y="3"/>
                  </a:lnTo>
                  <a:lnTo>
                    <a:pt x="137" y="4"/>
                  </a:lnTo>
                  <a:lnTo>
                    <a:pt x="144" y="7"/>
                  </a:lnTo>
                  <a:lnTo>
                    <a:pt x="150" y="9"/>
                  </a:lnTo>
                  <a:lnTo>
                    <a:pt x="157" y="12"/>
                  </a:lnTo>
                  <a:lnTo>
                    <a:pt x="163" y="15"/>
                  </a:lnTo>
                  <a:lnTo>
                    <a:pt x="169" y="19"/>
                  </a:lnTo>
                  <a:lnTo>
                    <a:pt x="175" y="23"/>
                  </a:lnTo>
                  <a:lnTo>
                    <a:pt x="181" y="28"/>
                  </a:lnTo>
                  <a:lnTo>
                    <a:pt x="187" y="32"/>
                  </a:lnTo>
                  <a:lnTo>
                    <a:pt x="193" y="38"/>
                  </a:lnTo>
                  <a:lnTo>
                    <a:pt x="199" y="43"/>
                  </a:lnTo>
                  <a:lnTo>
                    <a:pt x="204" y="49"/>
                  </a:lnTo>
                  <a:lnTo>
                    <a:pt x="209" y="55"/>
                  </a:lnTo>
                  <a:lnTo>
                    <a:pt x="215" y="61"/>
                  </a:lnTo>
                  <a:lnTo>
                    <a:pt x="220" y="68"/>
                  </a:lnTo>
                  <a:lnTo>
                    <a:pt x="224" y="75"/>
                  </a:lnTo>
                  <a:lnTo>
                    <a:pt x="229" y="82"/>
                  </a:lnTo>
                  <a:lnTo>
                    <a:pt x="233" y="90"/>
                  </a:lnTo>
                  <a:lnTo>
                    <a:pt x="237" y="98"/>
                  </a:lnTo>
                  <a:lnTo>
                    <a:pt x="241" y="106"/>
                  </a:lnTo>
                  <a:lnTo>
                    <a:pt x="245" y="114"/>
                  </a:lnTo>
                  <a:lnTo>
                    <a:pt x="248" y="123"/>
                  </a:lnTo>
                  <a:lnTo>
                    <a:pt x="252" y="131"/>
                  </a:lnTo>
                  <a:lnTo>
                    <a:pt x="254" y="140"/>
                  </a:lnTo>
                  <a:lnTo>
                    <a:pt x="257" y="149"/>
                  </a:lnTo>
                  <a:lnTo>
                    <a:pt x="259" y="159"/>
                  </a:lnTo>
                  <a:lnTo>
                    <a:pt x="261" y="168"/>
                  </a:lnTo>
                  <a:lnTo>
                    <a:pt x="263" y="177"/>
                  </a:lnTo>
                  <a:lnTo>
                    <a:pt x="264" y="186"/>
                  </a:lnTo>
                  <a:lnTo>
                    <a:pt x="265" y="195"/>
                  </a:lnTo>
                  <a:lnTo>
                    <a:pt x="266" y="204"/>
                  </a:lnTo>
                  <a:lnTo>
                    <a:pt x="266" y="213"/>
                  </a:lnTo>
                  <a:lnTo>
                    <a:pt x="266" y="222"/>
                  </a:lnTo>
                  <a:lnTo>
                    <a:pt x="266" y="230"/>
                  </a:lnTo>
                  <a:lnTo>
                    <a:pt x="265" y="239"/>
                  </a:lnTo>
                  <a:lnTo>
                    <a:pt x="264" y="247"/>
                  </a:lnTo>
                  <a:lnTo>
                    <a:pt x="263" y="255"/>
                  </a:lnTo>
                  <a:lnTo>
                    <a:pt x="261" y="263"/>
                  </a:lnTo>
                  <a:lnTo>
                    <a:pt x="259" y="271"/>
                  </a:lnTo>
                  <a:lnTo>
                    <a:pt x="257" y="278"/>
                  </a:lnTo>
                  <a:lnTo>
                    <a:pt x="254" y="286"/>
                  </a:lnTo>
                  <a:lnTo>
                    <a:pt x="252" y="293"/>
                  </a:lnTo>
                  <a:lnTo>
                    <a:pt x="249" y="300"/>
                  </a:lnTo>
                  <a:lnTo>
                    <a:pt x="245" y="306"/>
                  </a:lnTo>
                  <a:lnTo>
                    <a:pt x="242" y="313"/>
                  </a:lnTo>
                  <a:lnTo>
                    <a:pt x="238" y="319"/>
                  </a:lnTo>
                  <a:lnTo>
                    <a:pt x="234" y="324"/>
                  </a:lnTo>
                  <a:lnTo>
                    <a:pt x="230" y="330"/>
                  </a:lnTo>
                  <a:lnTo>
                    <a:pt x="225" y="335"/>
                  </a:lnTo>
                  <a:lnTo>
                    <a:pt x="220" y="339"/>
                  </a:lnTo>
                  <a:lnTo>
                    <a:pt x="215" y="344"/>
                  </a:lnTo>
                  <a:lnTo>
                    <a:pt x="210" y="348"/>
                  </a:lnTo>
                  <a:lnTo>
                    <a:pt x="205" y="351"/>
                  </a:lnTo>
                  <a:lnTo>
                    <a:pt x="199" y="355"/>
                  </a:lnTo>
                  <a:lnTo>
                    <a:pt x="193" y="358"/>
                  </a:lnTo>
                  <a:lnTo>
                    <a:pt x="187" y="360"/>
                  </a:lnTo>
                  <a:lnTo>
                    <a:pt x="180" y="362"/>
                  </a:lnTo>
                  <a:close/>
                  <a:moveTo>
                    <a:pt x="186" y="357"/>
                  </a:moveTo>
                  <a:lnTo>
                    <a:pt x="192" y="355"/>
                  </a:lnTo>
                  <a:lnTo>
                    <a:pt x="197" y="352"/>
                  </a:lnTo>
                  <a:lnTo>
                    <a:pt x="203" y="349"/>
                  </a:lnTo>
                  <a:lnTo>
                    <a:pt x="208" y="345"/>
                  </a:lnTo>
                  <a:lnTo>
                    <a:pt x="214" y="341"/>
                  </a:lnTo>
                  <a:lnTo>
                    <a:pt x="218" y="337"/>
                  </a:lnTo>
                  <a:lnTo>
                    <a:pt x="223" y="333"/>
                  </a:lnTo>
                  <a:lnTo>
                    <a:pt x="228" y="328"/>
                  </a:lnTo>
                  <a:lnTo>
                    <a:pt x="232" y="322"/>
                  </a:lnTo>
                  <a:lnTo>
                    <a:pt x="236" y="317"/>
                  </a:lnTo>
                  <a:lnTo>
                    <a:pt x="239" y="311"/>
                  </a:lnTo>
                  <a:lnTo>
                    <a:pt x="243" y="305"/>
                  </a:lnTo>
                  <a:lnTo>
                    <a:pt x="246" y="298"/>
                  </a:lnTo>
                  <a:lnTo>
                    <a:pt x="249" y="292"/>
                  </a:lnTo>
                  <a:lnTo>
                    <a:pt x="252" y="285"/>
                  </a:lnTo>
                  <a:lnTo>
                    <a:pt x="254" y="277"/>
                  </a:lnTo>
                  <a:lnTo>
                    <a:pt x="256" y="270"/>
                  </a:lnTo>
                  <a:lnTo>
                    <a:pt x="258" y="262"/>
                  </a:lnTo>
                  <a:lnTo>
                    <a:pt x="260" y="255"/>
                  </a:lnTo>
                  <a:lnTo>
                    <a:pt x="261" y="247"/>
                  </a:lnTo>
                  <a:lnTo>
                    <a:pt x="262" y="238"/>
                  </a:lnTo>
                  <a:lnTo>
                    <a:pt x="263" y="230"/>
                  </a:lnTo>
                  <a:lnTo>
                    <a:pt x="263" y="222"/>
                  </a:lnTo>
                  <a:lnTo>
                    <a:pt x="263" y="213"/>
                  </a:lnTo>
                  <a:lnTo>
                    <a:pt x="263" y="204"/>
                  </a:lnTo>
                  <a:lnTo>
                    <a:pt x="262" y="195"/>
                  </a:lnTo>
                  <a:lnTo>
                    <a:pt x="261" y="187"/>
                  </a:lnTo>
                  <a:lnTo>
                    <a:pt x="260" y="178"/>
                  </a:lnTo>
                  <a:lnTo>
                    <a:pt x="258" y="169"/>
                  </a:lnTo>
                  <a:lnTo>
                    <a:pt x="257" y="159"/>
                  </a:lnTo>
                  <a:lnTo>
                    <a:pt x="254" y="150"/>
                  </a:lnTo>
                  <a:lnTo>
                    <a:pt x="252" y="141"/>
                  </a:lnTo>
                  <a:lnTo>
                    <a:pt x="249" y="132"/>
                  </a:lnTo>
                  <a:lnTo>
                    <a:pt x="246" y="124"/>
                  </a:lnTo>
                  <a:lnTo>
                    <a:pt x="242" y="115"/>
                  </a:lnTo>
                  <a:lnTo>
                    <a:pt x="239" y="107"/>
                  </a:lnTo>
                  <a:lnTo>
                    <a:pt x="235" y="99"/>
                  </a:lnTo>
                  <a:lnTo>
                    <a:pt x="231" y="91"/>
                  </a:lnTo>
                  <a:lnTo>
                    <a:pt x="227" y="84"/>
                  </a:lnTo>
                  <a:lnTo>
                    <a:pt x="222" y="77"/>
                  </a:lnTo>
                  <a:lnTo>
                    <a:pt x="217" y="70"/>
                  </a:lnTo>
                  <a:lnTo>
                    <a:pt x="212" y="63"/>
                  </a:lnTo>
                  <a:lnTo>
                    <a:pt x="207" y="57"/>
                  </a:lnTo>
                  <a:lnTo>
                    <a:pt x="202" y="51"/>
                  </a:lnTo>
                  <a:lnTo>
                    <a:pt x="197" y="45"/>
                  </a:lnTo>
                  <a:lnTo>
                    <a:pt x="191" y="40"/>
                  </a:lnTo>
                  <a:lnTo>
                    <a:pt x="185" y="35"/>
                  </a:lnTo>
                  <a:lnTo>
                    <a:pt x="180" y="30"/>
                  </a:lnTo>
                  <a:lnTo>
                    <a:pt x="174" y="26"/>
                  </a:lnTo>
                  <a:lnTo>
                    <a:pt x="168" y="22"/>
                  </a:lnTo>
                  <a:lnTo>
                    <a:pt x="162" y="18"/>
                  </a:lnTo>
                  <a:lnTo>
                    <a:pt x="156" y="15"/>
                  </a:lnTo>
                  <a:lnTo>
                    <a:pt x="149" y="12"/>
                  </a:lnTo>
                  <a:lnTo>
                    <a:pt x="143" y="9"/>
                  </a:lnTo>
                  <a:lnTo>
                    <a:pt x="137" y="7"/>
                  </a:lnTo>
                  <a:lnTo>
                    <a:pt x="131" y="6"/>
                  </a:lnTo>
                  <a:lnTo>
                    <a:pt x="124" y="4"/>
                  </a:lnTo>
                  <a:lnTo>
                    <a:pt x="118" y="4"/>
                  </a:lnTo>
                  <a:lnTo>
                    <a:pt x="111" y="3"/>
                  </a:lnTo>
                  <a:lnTo>
                    <a:pt x="105" y="3"/>
                  </a:lnTo>
                  <a:lnTo>
                    <a:pt x="99" y="4"/>
                  </a:lnTo>
                  <a:lnTo>
                    <a:pt x="92" y="5"/>
                  </a:lnTo>
                  <a:lnTo>
                    <a:pt x="86" y="6"/>
                  </a:lnTo>
                  <a:lnTo>
                    <a:pt x="80" y="8"/>
                  </a:lnTo>
                  <a:lnTo>
                    <a:pt x="74" y="10"/>
                  </a:lnTo>
                  <a:lnTo>
                    <a:pt x="68" y="13"/>
                  </a:lnTo>
                  <a:lnTo>
                    <a:pt x="63" y="16"/>
                  </a:lnTo>
                  <a:lnTo>
                    <a:pt x="57" y="20"/>
                  </a:lnTo>
                  <a:lnTo>
                    <a:pt x="52" y="23"/>
                  </a:lnTo>
                  <a:lnTo>
                    <a:pt x="47" y="28"/>
                  </a:lnTo>
                  <a:lnTo>
                    <a:pt x="43" y="32"/>
                  </a:lnTo>
                  <a:lnTo>
                    <a:pt x="38" y="37"/>
                  </a:lnTo>
                  <a:lnTo>
                    <a:pt x="34" y="43"/>
                  </a:lnTo>
                  <a:lnTo>
                    <a:pt x="30" y="48"/>
                  </a:lnTo>
                  <a:lnTo>
                    <a:pt x="26" y="54"/>
                  </a:lnTo>
                  <a:lnTo>
                    <a:pt x="23" y="60"/>
                  </a:lnTo>
                  <a:lnTo>
                    <a:pt x="20" y="67"/>
                  </a:lnTo>
                  <a:lnTo>
                    <a:pt x="17" y="73"/>
                  </a:lnTo>
                  <a:lnTo>
                    <a:pt x="14" y="80"/>
                  </a:lnTo>
                  <a:lnTo>
                    <a:pt x="12" y="87"/>
                  </a:lnTo>
                  <a:lnTo>
                    <a:pt x="9" y="95"/>
                  </a:lnTo>
                  <a:lnTo>
                    <a:pt x="8" y="103"/>
                  </a:lnTo>
                  <a:lnTo>
                    <a:pt x="6" y="110"/>
                  </a:lnTo>
                  <a:lnTo>
                    <a:pt x="5" y="118"/>
                  </a:lnTo>
                  <a:lnTo>
                    <a:pt x="4" y="127"/>
                  </a:lnTo>
                  <a:lnTo>
                    <a:pt x="3" y="135"/>
                  </a:lnTo>
                  <a:lnTo>
                    <a:pt x="3" y="143"/>
                  </a:lnTo>
                  <a:lnTo>
                    <a:pt x="3" y="152"/>
                  </a:lnTo>
                  <a:lnTo>
                    <a:pt x="3" y="161"/>
                  </a:lnTo>
                  <a:lnTo>
                    <a:pt x="3" y="169"/>
                  </a:lnTo>
                  <a:lnTo>
                    <a:pt x="4" y="178"/>
                  </a:lnTo>
                  <a:lnTo>
                    <a:pt x="6" y="187"/>
                  </a:lnTo>
                  <a:lnTo>
                    <a:pt x="7" y="196"/>
                  </a:lnTo>
                  <a:lnTo>
                    <a:pt x="9" y="206"/>
                  </a:lnTo>
                  <a:lnTo>
                    <a:pt x="11" y="215"/>
                  </a:lnTo>
                  <a:lnTo>
                    <a:pt x="14" y="224"/>
                  </a:lnTo>
                  <a:lnTo>
                    <a:pt x="17" y="233"/>
                  </a:lnTo>
                  <a:lnTo>
                    <a:pt x="20" y="241"/>
                  </a:lnTo>
                  <a:lnTo>
                    <a:pt x="23" y="250"/>
                  </a:lnTo>
                  <a:lnTo>
                    <a:pt x="27" y="258"/>
                  </a:lnTo>
                  <a:lnTo>
                    <a:pt x="31" y="266"/>
                  </a:lnTo>
                  <a:lnTo>
                    <a:pt x="35" y="273"/>
                  </a:lnTo>
                  <a:lnTo>
                    <a:pt x="39" y="281"/>
                  </a:lnTo>
                  <a:lnTo>
                    <a:pt x="44" y="288"/>
                  </a:lnTo>
                  <a:lnTo>
                    <a:pt x="48" y="295"/>
                  </a:lnTo>
                  <a:lnTo>
                    <a:pt x="53" y="302"/>
                  </a:lnTo>
                  <a:lnTo>
                    <a:pt x="58" y="308"/>
                  </a:lnTo>
                  <a:lnTo>
                    <a:pt x="64" y="314"/>
                  </a:lnTo>
                  <a:lnTo>
                    <a:pt x="69" y="320"/>
                  </a:lnTo>
                  <a:lnTo>
                    <a:pt x="75" y="325"/>
                  </a:lnTo>
                  <a:lnTo>
                    <a:pt x="80" y="330"/>
                  </a:lnTo>
                  <a:lnTo>
                    <a:pt x="86" y="335"/>
                  </a:lnTo>
                  <a:lnTo>
                    <a:pt x="92" y="339"/>
                  </a:lnTo>
                  <a:lnTo>
                    <a:pt x="98" y="343"/>
                  </a:lnTo>
                  <a:lnTo>
                    <a:pt x="104" y="347"/>
                  </a:lnTo>
                  <a:lnTo>
                    <a:pt x="110" y="350"/>
                  </a:lnTo>
                  <a:lnTo>
                    <a:pt x="116" y="353"/>
                  </a:lnTo>
                  <a:lnTo>
                    <a:pt x="123" y="356"/>
                  </a:lnTo>
                  <a:lnTo>
                    <a:pt x="129" y="358"/>
                  </a:lnTo>
                  <a:lnTo>
                    <a:pt x="135" y="359"/>
                  </a:lnTo>
                  <a:lnTo>
                    <a:pt x="142" y="361"/>
                  </a:lnTo>
                  <a:lnTo>
                    <a:pt x="148" y="361"/>
                  </a:lnTo>
                  <a:lnTo>
                    <a:pt x="154" y="362"/>
                  </a:lnTo>
                  <a:lnTo>
                    <a:pt x="161" y="362"/>
                  </a:lnTo>
                  <a:lnTo>
                    <a:pt x="167" y="361"/>
                  </a:lnTo>
                  <a:lnTo>
                    <a:pt x="173" y="360"/>
                  </a:lnTo>
                  <a:lnTo>
                    <a:pt x="180" y="359"/>
                  </a:lnTo>
                  <a:lnTo>
                    <a:pt x="186" y="357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" name="Freeform 231">
              <a:extLst>
                <a:ext uri="{FF2B5EF4-FFF2-40B4-BE49-F238E27FC236}">
                  <a16:creationId xmlns:a16="http://schemas.microsoft.com/office/drawing/2014/main" id="{AD8DEE4A-2968-4A0D-B9BD-8D1A94BF2566}"/>
                </a:ext>
              </a:extLst>
            </p:cNvPr>
            <p:cNvSpPr>
              <a:spLocks/>
            </p:cNvSpPr>
            <p:nvPr/>
          </p:nvSpPr>
          <p:spPr bwMode="auto">
            <a:xfrm>
              <a:off x="555" y="2481"/>
              <a:ext cx="105" cy="79"/>
            </a:xfrm>
            <a:custGeom>
              <a:avLst/>
              <a:gdLst>
                <a:gd name="T0" fmla="*/ 397 w 2682"/>
                <a:gd name="T1" fmla="*/ 279 h 2038"/>
                <a:gd name="T2" fmla="*/ 865 w 2682"/>
                <a:gd name="T3" fmla="*/ 740 h 2038"/>
                <a:gd name="T4" fmla="*/ 1110 w 2682"/>
                <a:gd name="T5" fmla="*/ 882 h 2038"/>
                <a:gd name="T6" fmla="*/ 1219 w 2682"/>
                <a:gd name="T7" fmla="*/ 907 h 2038"/>
                <a:gd name="T8" fmla="*/ 1346 w 2682"/>
                <a:gd name="T9" fmla="*/ 911 h 2038"/>
                <a:gd name="T10" fmla="*/ 1641 w 2682"/>
                <a:gd name="T11" fmla="*/ 876 h 2038"/>
                <a:gd name="T12" fmla="*/ 1936 w 2682"/>
                <a:gd name="T13" fmla="*/ 836 h 2038"/>
                <a:gd name="T14" fmla="*/ 2075 w 2682"/>
                <a:gd name="T15" fmla="*/ 842 h 2038"/>
                <a:gd name="T16" fmla="*/ 2210 w 2682"/>
                <a:gd name="T17" fmla="*/ 881 h 2038"/>
                <a:gd name="T18" fmla="*/ 2332 w 2682"/>
                <a:gd name="T19" fmla="*/ 981 h 2038"/>
                <a:gd name="T20" fmla="*/ 2421 w 2682"/>
                <a:gd name="T21" fmla="*/ 1102 h 2038"/>
                <a:gd name="T22" fmla="*/ 2485 w 2682"/>
                <a:gd name="T23" fmla="*/ 1243 h 2038"/>
                <a:gd name="T24" fmla="*/ 2600 w 2682"/>
                <a:gd name="T25" fmla="*/ 1647 h 2038"/>
                <a:gd name="T26" fmla="*/ 2642 w 2682"/>
                <a:gd name="T27" fmla="*/ 1814 h 2038"/>
                <a:gd name="T28" fmla="*/ 2601 w 2682"/>
                <a:gd name="T29" fmla="*/ 2015 h 2038"/>
                <a:gd name="T30" fmla="*/ 2456 w 2682"/>
                <a:gd name="T31" fmla="*/ 1965 h 2038"/>
                <a:gd name="T32" fmla="*/ 2401 w 2682"/>
                <a:gd name="T33" fmla="*/ 1857 h 2038"/>
                <a:gd name="T34" fmla="*/ 2625 w 2682"/>
                <a:gd name="T35" fmla="*/ 1813 h 2038"/>
                <a:gd name="T36" fmla="*/ 2509 w 2682"/>
                <a:gd name="T37" fmla="*/ 1800 h 2038"/>
                <a:gd name="T38" fmla="*/ 2456 w 2682"/>
                <a:gd name="T39" fmla="*/ 1942 h 2038"/>
                <a:gd name="T40" fmla="*/ 2409 w 2682"/>
                <a:gd name="T41" fmla="*/ 1798 h 2038"/>
                <a:gd name="T42" fmla="*/ 2328 w 2682"/>
                <a:gd name="T43" fmla="*/ 1459 h 2038"/>
                <a:gd name="T44" fmla="*/ 2232 w 2682"/>
                <a:gd name="T45" fmla="*/ 1217 h 2038"/>
                <a:gd name="T46" fmla="*/ 2172 w 2682"/>
                <a:gd name="T47" fmla="*/ 1133 h 2038"/>
                <a:gd name="T48" fmla="*/ 2110 w 2682"/>
                <a:gd name="T49" fmla="*/ 1084 h 2038"/>
                <a:gd name="T50" fmla="*/ 2043 w 2682"/>
                <a:gd name="T51" fmla="*/ 1070 h 2038"/>
                <a:gd name="T52" fmla="*/ 1948 w 2682"/>
                <a:gd name="T53" fmla="*/ 1067 h 2038"/>
                <a:gd name="T54" fmla="*/ 1827 w 2682"/>
                <a:gd name="T55" fmla="*/ 1083 h 2038"/>
                <a:gd name="T56" fmla="*/ 1361 w 2682"/>
                <a:gd name="T57" fmla="*/ 1145 h 2038"/>
                <a:gd name="T58" fmla="*/ 1192 w 2682"/>
                <a:gd name="T59" fmla="*/ 1135 h 2038"/>
                <a:gd name="T60" fmla="*/ 1030 w 2682"/>
                <a:gd name="T61" fmla="*/ 1094 h 2038"/>
                <a:gd name="T62" fmla="*/ 745 w 2682"/>
                <a:gd name="T63" fmla="*/ 928 h 2038"/>
                <a:gd name="T64" fmla="*/ 476 w 2682"/>
                <a:gd name="T65" fmla="*/ 692 h 2038"/>
                <a:gd name="T66" fmla="*/ 0 w 2682"/>
                <a:gd name="T67" fmla="*/ 147 h 20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2682" h="2038">
                  <a:moveTo>
                    <a:pt x="164" y="0"/>
                  </a:moveTo>
                  <a:lnTo>
                    <a:pt x="397" y="279"/>
                  </a:lnTo>
                  <a:lnTo>
                    <a:pt x="631" y="535"/>
                  </a:lnTo>
                  <a:lnTo>
                    <a:pt x="865" y="740"/>
                  </a:lnTo>
                  <a:lnTo>
                    <a:pt x="852" y="728"/>
                  </a:lnTo>
                  <a:lnTo>
                    <a:pt x="1110" y="882"/>
                  </a:lnTo>
                  <a:lnTo>
                    <a:pt x="1082" y="870"/>
                  </a:lnTo>
                  <a:lnTo>
                    <a:pt x="1219" y="907"/>
                  </a:lnTo>
                  <a:lnTo>
                    <a:pt x="1194" y="903"/>
                  </a:lnTo>
                  <a:lnTo>
                    <a:pt x="1346" y="911"/>
                  </a:lnTo>
                  <a:lnTo>
                    <a:pt x="1332" y="912"/>
                  </a:lnTo>
                  <a:lnTo>
                    <a:pt x="1641" y="876"/>
                  </a:lnTo>
                  <a:lnTo>
                    <a:pt x="1786" y="853"/>
                  </a:lnTo>
                  <a:lnTo>
                    <a:pt x="1936" y="836"/>
                  </a:lnTo>
                  <a:cubicBezTo>
                    <a:pt x="1941" y="835"/>
                    <a:pt x="1945" y="835"/>
                    <a:pt x="1950" y="835"/>
                  </a:cubicBezTo>
                  <a:lnTo>
                    <a:pt x="2075" y="842"/>
                  </a:lnTo>
                  <a:cubicBezTo>
                    <a:pt x="2085" y="841"/>
                    <a:pt x="2097" y="843"/>
                    <a:pt x="2105" y="845"/>
                  </a:cubicBezTo>
                  <a:lnTo>
                    <a:pt x="2210" y="881"/>
                  </a:lnTo>
                  <a:cubicBezTo>
                    <a:pt x="2222" y="888"/>
                    <a:pt x="2235" y="895"/>
                    <a:pt x="2248" y="908"/>
                  </a:cubicBezTo>
                  <a:lnTo>
                    <a:pt x="2332" y="981"/>
                  </a:lnTo>
                  <a:cubicBezTo>
                    <a:pt x="2339" y="983"/>
                    <a:pt x="2345" y="993"/>
                    <a:pt x="2353" y="1000"/>
                  </a:cubicBezTo>
                  <a:lnTo>
                    <a:pt x="2421" y="1102"/>
                  </a:lnTo>
                  <a:cubicBezTo>
                    <a:pt x="2424" y="1110"/>
                    <a:pt x="2429" y="1115"/>
                    <a:pt x="2430" y="1120"/>
                  </a:cubicBezTo>
                  <a:lnTo>
                    <a:pt x="2485" y="1243"/>
                  </a:lnTo>
                  <a:lnTo>
                    <a:pt x="2537" y="1382"/>
                  </a:lnTo>
                  <a:lnTo>
                    <a:pt x="2600" y="1647"/>
                  </a:lnTo>
                  <a:lnTo>
                    <a:pt x="2625" y="1746"/>
                  </a:lnTo>
                  <a:lnTo>
                    <a:pt x="2642" y="1814"/>
                  </a:lnTo>
                  <a:lnTo>
                    <a:pt x="2661" y="1870"/>
                  </a:lnTo>
                  <a:cubicBezTo>
                    <a:pt x="2682" y="1928"/>
                    <a:pt x="2655" y="1994"/>
                    <a:pt x="2601" y="2015"/>
                  </a:cubicBezTo>
                  <a:lnTo>
                    <a:pt x="2594" y="2017"/>
                  </a:lnTo>
                  <a:cubicBezTo>
                    <a:pt x="2544" y="2038"/>
                    <a:pt x="2486" y="2018"/>
                    <a:pt x="2456" y="1965"/>
                  </a:cubicBezTo>
                  <a:lnTo>
                    <a:pt x="2433" y="1925"/>
                  </a:lnTo>
                  <a:lnTo>
                    <a:pt x="2401" y="1857"/>
                  </a:lnTo>
                  <a:lnTo>
                    <a:pt x="2594" y="1755"/>
                  </a:lnTo>
                  <a:lnTo>
                    <a:pt x="2625" y="1813"/>
                  </a:lnTo>
                  <a:lnTo>
                    <a:pt x="2647" y="1853"/>
                  </a:lnTo>
                  <a:lnTo>
                    <a:pt x="2509" y="1800"/>
                  </a:lnTo>
                  <a:lnTo>
                    <a:pt x="2516" y="1797"/>
                  </a:lnTo>
                  <a:lnTo>
                    <a:pt x="2456" y="1942"/>
                  </a:lnTo>
                  <a:lnTo>
                    <a:pt x="2432" y="1871"/>
                  </a:lnTo>
                  <a:lnTo>
                    <a:pt x="2409" y="1798"/>
                  </a:lnTo>
                  <a:lnTo>
                    <a:pt x="2385" y="1698"/>
                  </a:lnTo>
                  <a:lnTo>
                    <a:pt x="2328" y="1459"/>
                  </a:lnTo>
                  <a:lnTo>
                    <a:pt x="2288" y="1340"/>
                  </a:lnTo>
                  <a:lnTo>
                    <a:pt x="2232" y="1217"/>
                  </a:lnTo>
                  <a:lnTo>
                    <a:pt x="2241" y="1235"/>
                  </a:lnTo>
                  <a:lnTo>
                    <a:pt x="2172" y="1133"/>
                  </a:lnTo>
                  <a:lnTo>
                    <a:pt x="2194" y="1157"/>
                  </a:lnTo>
                  <a:lnTo>
                    <a:pt x="2110" y="1084"/>
                  </a:lnTo>
                  <a:lnTo>
                    <a:pt x="2148" y="1106"/>
                  </a:lnTo>
                  <a:lnTo>
                    <a:pt x="2043" y="1070"/>
                  </a:lnTo>
                  <a:lnTo>
                    <a:pt x="2073" y="1073"/>
                  </a:lnTo>
                  <a:lnTo>
                    <a:pt x="1948" y="1067"/>
                  </a:lnTo>
                  <a:lnTo>
                    <a:pt x="1962" y="1066"/>
                  </a:lnTo>
                  <a:lnTo>
                    <a:pt x="1827" y="1083"/>
                  </a:lnTo>
                  <a:lnTo>
                    <a:pt x="1670" y="1109"/>
                  </a:lnTo>
                  <a:lnTo>
                    <a:pt x="1361" y="1145"/>
                  </a:lnTo>
                  <a:cubicBezTo>
                    <a:pt x="1353" y="1143"/>
                    <a:pt x="1349" y="1143"/>
                    <a:pt x="1344" y="1143"/>
                  </a:cubicBezTo>
                  <a:lnTo>
                    <a:pt x="1192" y="1135"/>
                  </a:lnTo>
                  <a:cubicBezTo>
                    <a:pt x="1182" y="1136"/>
                    <a:pt x="1175" y="1133"/>
                    <a:pt x="1167" y="1131"/>
                  </a:cubicBezTo>
                  <a:lnTo>
                    <a:pt x="1030" y="1094"/>
                  </a:lnTo>
                  <a:cubicBezTo>
                    <a:pt x="1023" y="1092"/>
                    <a:pt x="1013" y="1087"/>
                    <a:pt x="1003" y="1083"/>
                  </a:cubicBezTo>
                  <a:lnTo>
                    <a:pt x="745" y="928"/>
                  </a:lnTo>
                  <a:cubicBezTo>
                    <a:pt x="740" y="924"/>
                    <a:pt x="737" y="921"/>
                    <a:pt x="730" y="919"/>
                  </a:cubicBezTo>
                  <a:lnTo>
                    <a:pt x="476" y="692"/>
                  </a:lnTo>
                  <a:lnTo>
                    <a:pt x="232" y="426"/>
                  </a:lnTo>
                  <a:lnTo>
                    <a:pt x="0" y="147"/>
                  </a:lnTo>
                  <a:lnTo>
                    <a:pt x="164" y="0"/>
                  </a:lnTo>
                  <a:close/>
                </a:path>
              </a:pathLst>
            </a:custGeom>
            <a:solidFill>
              <a:srgbClr val="4F6228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" name="Freeform 232">
              <a:extLst>
                <a:ext uri="{FF2B5EF4-FFF2-40B4-BE49-F238E27FC236}">
                  <a16:creationId xmlns:a16="http://schemas.microsoft.com/office/drawing/2014/main" id="{01E43E0F-B7A3-45B9-8E0A-52C690E8E85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54" y="2479"/>
              <a:ext cx="107" cy="82"/>
            </a:xfrm>
            <a:custGeom>
              <a:avLst/>
              <a:gdLst>
                <a:gd name="T0" fmla="*/ 926 w 2743"/>
                <a:gd name="T1" fmla="*/ 755 h 2109"/>
                <a:gd name="T2" fmla="*/ 1165 w 2743"/>
                <a:gd name="T3" fmla="*/ 892 h 2109"/>
                <a:gd name="T4" fmla="*/ 1128 w 2743"/>
                <a:gd name="T5" fmla="*/ 876 h 2109"/>
                <a:gd name="T6" fmla="*/ 1194 w 2743"/>
                <a:gd name="T7" fmla="*/ 944 h 2109"/>
                <a:gd name="T8" fmla="*/ 1373 w 2743"/>
                <a:gd name="T9" fmla="*/ 996 h 2109"/>
                <a:gd name="T10" fmla="*/ 1968 w 2743"/>
                <a:gd name="T11" fmla="*/ 841 h 2109"/>
                <a:gd name="T12" fmla="*/ 2258 w 2743"/>
                <a:gd name="T13" fmla="*/ 888 h 2109"/>
                <a:gd name="T14" fmla="*/ 2393 w 2743"/>
                <a:gd name="T15" fmla="*/ 995 h 2109"/>
                <a:gd name="T16" fmla="*/ 2500 w 2743"/>
                <a:gd name="T17" fmla="*/ 1147 h 2109"/>
                <a:gd name="T18" fmla="*/ 2716 w 2743"/>
                <a:gd name="T19" fmla="*/ 1850 h 2109"/>
                <a:gd name="T20" fmla="*/ 2733 w 2743"/>
                <a:gd name="T21" fmla="*/ 2010 h 2109"/>
                <a:gd name="T22" fmla="*/ 2649 w 2743"/>
                <a:gd name="T23" fmla="*/ 2097 h 2109"/>
                <a:gd name="T24" fmla="*/ 2538 w 2743"/>
                <a:gd name="T25" fmla="*/ 2097 h 2109"/>
                <a:gd name="T26" fmla="*/ 2439 w 2743"/>
                <a:gd name="T27" fmla="*/ 1989 h 2109"/>
                <a:gd name="T28" fmla="*/ 2695 w 2743"/>
                <a:gd name="T29" fmla="*/ 1839 h 2109"/>
                <a:gd name="T30" fmla="*/ 2509 w 2743"/>
                <a:gd name="T31" fmla="*/ 1845 h 2109"/>
                <a:gd name="T32" fmla="*/ 2528 w 2743"/>
                <a:gd name="T33" fmla="*/ 2003 h 2109"/>
                <a:gd name="T34" fmla="*/ 2386 w 2743"/>
                <a:gd name="T35" fmla="*/ 1751 h 2109"/>
                <a:gd name="T36" fmla="*/ 2302 w 2743"/>
                <a:gd name="T37" fmla="*/ 1244 h 2109"/>
                <a:gd name="T38" fmla="*/ 2185 w 2743"/>
                <a:gd name="T39" fmla="*/ 1147 h 2109"/>
                <a:gd name="T40" fmla="*/ 2124 w 2743"/>
                <a:gd name="T41" fmla="*/ 1158 h 2109"/>
                <a:gd name="T42" fmla="*/ 2175 w 2743"/>
                <a:gd name="T43" fmla="*/ 1188 h 2109"/>
                <a:gd name="T44" fmla="*/ 2148 w 2743"/>
                <a:gd name="T45" fmla="*/ 1120 h 2109"/>
                <a:gd name="T46" fmla="*/ 1996 w 2743"/>
                <a:gd name="T47" fmla="*/ 1071 h 2109"/>
                <a:gd name="T48" fmla="*/ 1404 w 2743"/>
                <a:gd name="T49" fmla="*/ 1229 h 2109"/>
                <a:gd name="T50" fmla="*/ 1059 w 2743"/>
                <a:gd name="T51" fmla="*/ 1177 h 2109"/>
                <a:gd name="T52" fmla="*/ 744 w 2743"/>
                <a:gd name="T53" fmla="*/ 993 h 2109"/>
                <a:gd name="T54" fmla="*/ 13 w 2743"/>
                <a:gd name="T55" fmla="*/ 161 h 2109"/>
                <a:gd name="T56" fmla="*/ 537 w 2743"/>
                <a:gd name="T57" fmla="*/ 707 h 2109"/>
                <a:gd name="T58" fmla="*/ 1053 w 2743"/>
                <a:gd name="T59" fmla="*/ 1091 h 2109"/>
                <a:gd name="T60" fmla="*/ 1402 w 2743"/>
                <a:gd name="T61" fmla="*/ 1150 h 2109"/>
                <a:gd name="T62" fmla="*/ 2003 w 2743"/>
                <a:gd name="T63" fmla="*/ 1150 h 2109"/>
                <a:gd name="T64" fmla="*/ 2078 w 2743"/>
                <a:gd name="T65" fmla="*/ 1154 h 2109"/>
                <a:gd name="T66" fmla="*/ 2171 w 2743"/>
                <a:gd name="T67" fmla="*/ 1098 h 2109"/>
                <a:gd name="T68" fmla="*/ 2309 w 2743"/>
                <a:gd name="T69" fmla="*/ 1257 h 2109"/>
                <a:gd name="T70" fmla="*/ 2402 w 2743"/>
                <a:gd name="T71" fmla="*/ 1495 h 2109"/>
                <a:gd name="T72" fmla="*/ 2459 w 2743"/>
                <a:gd name="T73" fmla="*/ 1970 h 2109"/>
                <a:gd name="T74" fmla="*/ 2696 w 2743"/>
                <a:gd name="T75" fmla="*/ 1861 h 2109"/>
                <a:gd name="T76" fmla="*/ 2456 w 2743"/>
                <a:gd name="T77" fmla="*/ 1937 h 2109"/>
                <a:gd name="T78" fmla="*/ 2548 w 2743"/>
                <a:gd name="T79" fmla="*/ 2017 h 2109"/>
                <a:gd name="T80" fmla="*/ 2585 w 2743"/>
                <a:gd name="T81" fmla="*/ 2031 h 2109"/>
                <a:gd name="T82" fmla="*/ 2642 w 2743"/>
                <a:gd name="T83" fmla="*/ 2014 h 2109"/>
                <a:gd name="T84" fmla="*/ 2662 w 2743"/>
                <a:gd name="T85" fmla="*/ 1920 h 2109"/>
                <a:gd name="T86" fmla="*/ 2540 w 2743"/>
                <a:gd name="T87" fmla="*/ 1440 h 2109"/>
                <a:gd name="T88" fmla="*/ 2365 w 2743"/>
                <a:gd name="T89" fmla="*/ 1073 h 2109"/>
                <a:gd name="T90" fmla="*/ 2249 w 2743"/>
                <a:gd name="T91" fmla="*/ 971 h 2109"/>
                <a:gd name="T92" fmla="*/ 2112 w 2743"/>
                <a:gd name="T93" fmla="*/ 926 h 2109"/>
                <a:gd name="T94" fmla="*/ 1375 w 2743"/>
                <a:gd name="T95" fmla="*/ 996 h 2109"/>
                <a:gd name="T96" fmla="*/ 1236 w 2743"/>
                <a:gd name="T97" fmla="*/ 909 h 2109"/>
                <a:gd name="T98" fmla="*/ 1161 w 2743"/>
                <a:gd name="T99" fmla="*/ 890 h 2109"/>
                <a:gd name="T100" fmla="*/ 931 w 2743"/>
                <a:gd name="T101" fmla="*/ 810 h 2109"/>
                <a:gd name="T102" fmla="*/ 226 w 2743"/>
                <a:gd name="T103" fmla="*/ 75 h 2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2743" h="2109">
                  <a:moveTo>
                    <a:pt x="177" y="14"/>
                  </a:moveTo>
                  <a:cubicBezTo>
                    <a:pt x="192" y="0"/>
                    <a:pt x="215" y="3"/>
                    <a:pt x="229" y="19"/>
                  </a:cubicBezTo>
                  <a:lnTo>
                    <a:pt x="462" y="298"/>
                  </a:lnTo>
                  <a:lnTo>
                    <a:pt x="695" y="553"/>
                  </a:lnTo>
                  <a:lnTo>
                    <a:pt x="926" y="755"/>
                  </a:lnTo>
                  <a:lnTo>
                    <a:pt x="878" y="814"/>
                  </a:lnTo>
                  <a:lnTo>
                    <a:pt x="865" y="802"/>
                  </a:lnTo>
                  <a:cubicBezTo>
                    <a:pt x="851" y="788"/>
                    <a:pt x="848" y="766"/>
                    <a:pt x="859" y="749"/>
                  </a:cubicBezTo>
                  <a:cubicBezTo>
                    <a:pt x="869" y="733"/>
                    <a:pt x="890" y="728"/>
                    <a:pt x="907" y="738"/>
                  </a:cubicBezTo>
                  <a:lnTo>
                    <a:pt x="1165" y="892"/>
                  </a:lnTo>
                  <a:cubicBezTo>
                    <a:pt x="1182" y="903"/>
                    <a:pt x="1190" y="925"/>
                    <a:pt x="1181" y="944"/>
                  </a:cubicBezTo>
                  <a:cubicBezTo>
                    <a:pt x="1173" y="962"/>
                    <a:pt x="1153" y="971"/>
                    <a:pt x="1134" y="963"/>
                  </a:cubicBezTo>
                  <a:lnTo>
                    <a:pt x="1106" y="951"/>
                  </a:lnTo>
                  <a:cubicBezTo>
                    <a:pt x="1088" y="943"/>
                    <a:pt x="1078" y="922"/>
                    <a:pt x="1084" y="902"/>
                  </a:cubicBezTo>
                  <a:cubicBezTo>
                    <a:pt x="1089" y="882"/>
                    <a:pt x="1109" y="871"/>
                    <a:pt x="1128" y="876"/>
                  </a:cubicBezTo>
                  <a:lnTo>
                    <a:pt x="1265" y="913"/>
                  </a:lnTo>
                  <a:cubicBezTo>
                    <a:pt x="1284" y="919"/>
                    <a:pt x="1297" y="939"/>
                    <a:pt x="1293" y="959"/>
                  </a:cubicBezTo>
                  <a:cubicBezTo>
                    <a:pt x="1290" y="980"/>
                    <a:pt x="1272" y="993"/>
                    <a:pt x="1252" y="990"/>
                  </a:cubicBezTo>
                  <a:lnTo>
                    <a:pt x="1227" y="986"/>
                  </a:lnTo>
                  <a:cubicBezTo>
                    <a:pt x="1207" y="983"/>
                    <a:pt x="1193" y="964"/>
                    <a:pt x="1194" y="944"/>
                  </a:cubicBezTo>
                  <a:cubicBezTo>
                    <a:pt x="1196" y="923"/>
                    <a:pt x="1212" y="907"/>
                    <a:pt x="1232" y="908"/>
                  </a:cubicBezTo>
                  <a:lnTo>
                    <a:pt x="1384" y="916"/>
                  </a:lnTo>
                  <a:cubicBezTo>
                    <a:pt x="1404" y="917"/>
                    <a:pt x="1420" y="934"/>
                    <a:pt x="1421" y="955"/>
                  </a:cubicBezTo>
                  <a:cubicBezTo>
                    <a:pt x="1422" y="976"/>
                    <a:pt x="1407" y="993"/>
                    <a:pt x="1387" y="995"/>
                  </a:cubicBezTo>
                  <a:lnTo>
                    <a:pt x="1373" y="996"/>
                  </a:lnTo>
                  <a:cubicBezTo>
                    <a:pt x="1353" y="997"/>
                    <a:pt x="1335" y="981"/>
                    <a:pt x="1332" y="960"/>
                  </a:cubicBezTo>
                  <a:cubicBezTo>
                    <a:pt x="1330" y="939"/>
                    <a:pt x="1344" y="920"/>
                    <a:pt x="1364" y="917"/>
                  </a:cubicBezTo>
                  <a:lnTo>
                    <a:pt x="1673" y="881"/>
                  </a:lnTo>
                  <a:lnTo>
                    <a:pt x="1817" y="859"/>
                  </a:lnTo>
                  <a:lnTo>
                    <a:pt x="1968" y="841"/>
                  </a:lnTo>
                  <a:lnTo>
                    <a:pt x="1984" y="840"/>
                  </a:lnTo>
                  <a:lnTo>
                    <a:pt x="2113" y="847"/>
                  </a:lnTo>
                  <a:lnTo>
                    <a:pt x="2145" y="850"/>
                  </a:lnTo>
                  <a:cubicBezTo>
                    <a:pt x="2148" y="851"/>
                    <a:pt x="2150" y="851"/>
                    <a:pt x="2153" y="852"/>
                  </a:cubicBezTo>
                  <a:lnTo>
                    <a:pt x="2258" y="888"/>
                  </a:lnTo>
                  <a:cubicBezTo>
                    <a:pt x="2260" y="889"/>
                    <a:pt x="2263" y="890"/>
                    <a:pt x="2265" y="891"/>
                  </a:cubicBezTo>
                  <a:lnTo>
                    <a:pt x="2284" y="902"/>
                  </a:lnTo>
                  <a:cubicBezTo>
                    <a:pt x="2286" y="903"/>
                    <a:pt x="2287" y="905"/>
                    <a:pt x="2289" y="906"/>
                  </a:cubicBezTo>
                  <a:lnTo>
                    <a:pt x="2308" y="922"/>
                  </a:lnTo>
                  <a:lnTo>
                    <a:pt x="2393" y="995"/>
                  </a:lnTo>
                  <a:lnTo>
                    <a:pt x="2401" y="1002"/>
                  </a:lnTo>
                  <a:lnTo>
                    <a:pt x="2416" y="1016"/>
                  </a:lnTo>
                  <a:cubicBezTo>
                    <a:pt x="2418" y="1018"/>
                    <a:pt x="2419" y="1020"/>
                    <a:pt x="2421" y="1023"/>
                  </a:cubicBezTo>
                  <a:lnTo>
                    <a:pt x="2489" y="1125"/>
                  </a:lnTo>
                  <a:lnTo>
                    <a:pt x="2500" y="1147"/>
                  </a:lnTo>
                  <a:lnTo>
                    <a:pt x="2556" y="1272"/>
                  </a:lnTo>
                  <a:lnTo>
                    <a:pt x="2609" y="1413"/>
                  </a:lnTo>
                  <a:lnTo>
                    <a:pt x="2674" y="1683"/>
                  </a:lnTo>
                  <a:lnTo>
                    <a:pt x="2699" y="1781"/>
                  </a:lnTo>
                  <a:lnTo>
                    <a:pt x="2716" y="1850"/>
                  </a:lnTo>
                  <a:lnTo>
                    <a:pt x="2734" y="1902"/>
                  </a:lnTo>
                  <a:cubicBezTo>
                    <a:pt x="2734" y="1904"/>
                    <a:pt x="2735" y="1907"/>
                    <a:pt x="2735" y="1909"/>
                  </a:cubicBezTo>
                  <a:lnTo>
                    <a:pt x="2742" y="1953"/>
                  </a:lnTo>
                  <a:cubicBezTo>
                    <a:pt x="2743" y="1958"/>
                    <a:pt x="2743" y="1963"/>
                    <a:pt x="2742" y="1968"/>
                  </a:cubicBezTo>
                  <a:lnTo>
                    <a:pt x="2733" y="2010"/>
                  </a:lnTo>
                  <a:cubicBezTo>
                    <a:pt x="2732" y="2015"/>
                    <a:pt x="2730" y="2019"/>
                    <a:pt x="2728" y="2023"/>
                  </a:cubicBezTo>
                  <a:lnTo>
                    <a:pt x="2705" y="2059"/>
                  </a:lnTo>
                  <a:cubicBezTo>
                    <a:pt x="2702" y="2063"/>
                    <a:pt x="2698" y="2067"/>
                    <a:pt x="2694" y="2070"/>
                  </a:cubicBezTo>
                  <a:lnTo>
                    <a:pt x="2659" y="2093"/>
                  </a:lnTo>
                  <a:cubicBezTo>
                    <a:pt x="2656" y="2095"/>
                    <a:pt x="2653" y="2096"/>
                    <a:pt x="2649" y="2097"/>
                  </a:cubicBezTo>
                  <a:lnTo>
                    <a:pt x="2642" y="2099"/>
                  </a:lnTo>
                  <a:lnTo>
                    <a:pt x="2602" y="2108"/>
                  </a:lnTo>
                  <a:cubicBezTo>
                    <a:pt x="2598" y="2109"/>
                    <a:pt x="2593" y="2109"/>
                    <a:pt x="2589" y="2108"/>
                  </a:cubicBezTo>
                  <a:lnTo>
                    <a:pt x="2551" y="2102"/>
                  </a:lnTo>
                  <a:cubicBezTo>
                    <a:pt x="2546" y="2102"/>
                    <a:pt x="2542" y="2100"/>
                    <a:pt x="2538" y="2097"/>
                  </a:cubicBezTo>
                  <a:lnTo>
                    <a:pt x="2503" y="2076"/>
                  </a:lnTo>
                  <a:cubicBezTo>
                    <a:pt x="2499" y="2074"/>
                    <a:pt x="2495" y="2071"/>
                    <a:pt x="2493" y="2068"/>
                  </a:cubicBezTo>
                  <a:lnTo>
                    <a:pt x="2466" y="2035"/>
                  </a:lnTo>
                  <a:cubicBezTo>
                    <a:pt x="2464" y="2033"/>
                    <a:pt x="2463" y="2031"/>
                    <a:pt x="2462" y="2029"/>
                  </a:cubicBezTo>
                  <a:lnTo>
                    <a:pt x="2439" y="1989"/>
                  </a:lnTo>
                  <a:lnTo>
                    <a:pt x="2405" y="1918"/>
                  </a:lnTo>
                  <a:cubicBezTo>
                    <a:pt x="2396" y="1899"/>
                    <a:pt x="2403" y="1876"/>
                    <a:pt x="2421" y="1866"/>
                  </a:cubicBezTo>
                  <a:lnTo>
                    <a:pt x="2614" y="1764"/>
                  </a:lnTo>
                  <a:cubicBezTo>
                    <a:pt x="2632" y="1755"/>
                    <a:pt x="2654" y="1762"/>
                    <a:pt x="2664" y="1781"/>
                  </a:cubicBezTo>
                  <a:lnTo>
                    <a:pt x="2695" y="1839"/>
                  </a:lnTo>
                  <a:lnTo>
                    <a:pt x="2717" y="1879"/>
                  </a:lnTo>
                  <a:cubicBezTo>
                    <a:pt x="2725" y="1893"/>
                    <a:pt x="2723" y="1911"/>
                    <a:pt x="2713" y="1923"/>
                  </a:cubicBezTo>
                  <a:cubicBezTo>
                    <a:pt x="2704" y="1936"/>
                    <a:pt x="2687" y="1940"/>
                    <a:pt x="2673" y="1934"/>
                  </a:cubicBezTo>
                  <a:lnTo>
                    <a:pt x="2535" y="1881"/>
                  </a:lnTo>
                  <a:cubicBezTo>
                    <a:pt x="2520" y="1876"/>
                    <a:pt x="2510" y="1861"/>
                    <a:pt x="2509" y="1845"/>
                  </a:cubicBezTo>
                  <a:cubicBezTo>
                    <a:pt x="2509" y="1829"/>
                    <a:pt x="2517" y="1814"/>
                    <a:pt x="2532" y="1808"/>
                  </a:cubicBezTo>
                  <a:lnTo>
                    <a:pt x="2539" y="1805"/>
                  </a:lnTo>
                  <a:cubicBezTo>
                    <a:pt x="2553" y="1799"/>
                    <a:pt x="2569" y="1803"/>
                    <a:pt x="2580" y="1814"/>
                  </a:cubicBezTo>
                  <a:cubicBezTo>
                    <a:pt x="2591" y="1826"/>
                    <a:pt x="2594" y="1843"/>
                    <a:pt x="2588" y="1858"/>
                  </a:cubicBezTo>
                  <a:lnTo>
                    <a:pt x="2528" y="2003"/>
                  </a:lnTo>
                  <a:cubicBezTo>
                    <a:pt x="2522" y="2018"/>
                    <a:pt x="2508" y="2027"/>
                    <a:pt x="2492" y="2026"/>
                  </a:cubicBezTo>
                  <a:cubicBezTo>
                    <a:pt x="2477" y="2025"/>
                    <a:pt x="2464" y="2014"/>
                    <a:pt x="2458" y="1999"/>
                  </a:cubicBezTo>
                  <a:lnTo>
                    <a:pt x="2434" y="1928"/>
                  </a:lnTo>
                  <a:lnTo>
                    <a:pt x="2411" y="1854"/>
                  </a:lnTo>
                  <a:lnTo>
                    <a:pt x="2386" y="1751"/>
                  </a:lnTo>
                  <a:lnTo>
                    <a:pt x="2329" y="1512"/>
                  </a:lnTo>
                  <a:lnTo>
                    <a:pt x="2290" y="1397"/>
                  </a:lnTo>
                  <a:lnTo>
                    <a:pt x="2236" y="1278"/>
                  </a:lnTo>
                  <a:cubicBezTo>
                    <a:pt x="2227" y="1258"/>
                    <a:pt x="2234" y="1235"/>
                    <a:pt x="2253" y="1226"/>
                  </a:cubicBezTo>
                  <a:cubicBezTo>
                    <a:pt x="2271" y="1217"/>
                    <a:pt x="2293" y="1225"/>
                    <a:pt x="2302" y="1244"/>
                  </a:cubicBezTo>
                  <a:lnTo>
                    <a:pt x="2311" y="1262"/>
                  </a:lnTo>
                  <a:cubicBezTo>
                    <a:pt x="2321" y="1280"/>
                    <a:pt x="2315" y="1303"/>
                    <a:pt x="2298" y="1313"/>
                  </a:cubicBezTo>
                  <a:cubicBezTo>
                    <a:pt x="2282" y="1324"/>
                    <a:pt x="2260" y="1319"/>
                    <a:pt x="2248" y="1302"/>
                  </a:cubicBezTo>
                  <a:lnTo>
                    <a:pt x="2179" y="1200"/>
                  </a:lnTo>
                  <a:cubicBezTo>
                    <a:pt x="2168" y="1183"/>
                    <a:pt x="2170" y="1160"/>
                    <a:pt x="2185" y="1147"/>
                  </a:cubicBezTo>
                  <a:cubicBezTo>
                    <a:pt x="2200" y="1134"/>
                    <a:pt x="2222" y="1136"/>
                    <a:pt x="2236" y="1151"/>
                  </a:cubicBezTo>
                  <a:lnTo>
                    <a:pt x="2258" y="1175"/>
                  </a:lnTo>
                  <a:cubicBezTo>
                    <a:pt x="2272" y="1190"/>
                    <a:pt x="2272" y="1213"/>
                    <a:pt x="2259" y="1229"/>
                  </a:cubicBezTo>
                  <a:cubicBezTo>
                    <a:pt x="2246" y="1244"/>
                    <a:pt x="2224" y="1245"/>
                    <a:pt x="2208" y="1231"/>
                  </a:cubicBezTo>
                  <a:lnTo>
                    <a:pt x="2124" y="1158"/>
                  </a:lnTo>
                  <a:cubicBezTo>
                    <a:pt x="2109" y="1145"/>
                    <a:pt x="2106" y="1123"/>
                    <a:pt x="2116" y="1106"/>
                  </a:cubicBezTo>
                  <a:cubicBezTo>
                    <a:pt x="2127" y="1089"/>
                    <a:pt x="2148" y="1084"/>
                    <a:pt x="2165" y="1094"/>
                  </a:cubicBezTo>
                  <a:lnTo>
                    <a:pt x="2203" y="1116"/>
                  </a:lnTo>
                  <a:cubicBezTo>
                    <a:pt x="2220" y="1126"/>
                    <a:pt x="2227" y="1148"/>
                    <a:pt x="2220" y="1166"/>
                  </a:cubicBezTo>
                  <a:cubicBezTo>
                    <a:pt x="2213" y="1185"/>
                    <a:pt x="2193" y="1194"/>
                    <a:pt x="2175" y="1188"/>
                  </a:cubicBezTo>
                  <a:lnTo>
                    <a:pt x="2070" y="1152"/>
                  </a:lnTo>
                  <a:cubicBezTo>
                    <a:pt x="2052" y="1146"/>
                    <a:pt x="2040" y="1126"/>
                    <a:pt x="2044" y="1106"/>
                  </a:cubicBezTo>
                  <a:cubicBezTo>
                    <a:pt x="2047" y="1087"/>
                    <a:pt x="2064" y="1073"/>
                    <a:pt x="2083" y="1075"/>
                  </a:cubicBezTo>
                  <a:lnTo>
                    <a:pt x="2113" y="1078"/>
                  </a:lnTo>
                  <a:cubicBezTo>
                    <a:pt x="2133" y="1080"/>
                    <a:pt x="2149" y="1099"/>
                    <a:pt x="2148" y="1120"/>
                  </a:cubicBezTo>
                  <a:cubicBezTo>
                    <a:pt x="2147" y="1142"/>
                    <a:pt x="2130" y="1158"/>
                    <a:pt x="2110" y="1157"/>
                  </a:cubicBezTo>
                  <a:lnTo>
                    <a:pt x="1985" y="1151"/>
                  </a:lnTo>
                  <a:cubicBezTo>
                    <a:pt x="1965" y="1150"/>
                    <a:pt x="1949" y="1133"/>
                    <a:pt x="1948" y="1112"/>
                  </a:cubicBezTo>
                  <a:cubicBezTo>
                    <a:pt x="1947" y="1091"/>
                    <a:pt x="1962" y="1074"/>
                    <a:pt x="1982" y="1072"/>
                  </a:cubicBezTo>
                  <a:lnTo>
                    <a:pt x="1996" y="1071"/>
                  </a:lnTo>
                  <a:cubicBezTo>
                    <a:pt x="2016" y="1070"/>
                    <a:pt x="2034" y="1086"/>
                    <a:pt x="2037" y="1107"/>
                  </a:cubicBezTo>
                  <a:cubicBezTo>
                    <a:pt x="2039" y="1128"/>
                    <a:pt x="2025" y="1147"/>
                    <a:pt x="2005" y="1150"/>
                  </a:cubicBezTo>
                  <a:lnTo>
                    <a:pt x="1870" y="1167"/>
                  </a:lnTo>
                  <a:lnTo>
                    <a:pt x="1714" y="1192"/>
                  </a:lnTo>
                  <a:lnTo>
                    <a:pt x="1404" y="1229"/>
                  </a:lnTo>
                  <a:cubicBezTo>
                    <a:pt x="1401" y="1229"/>
                    <a:pt x="1398" y="1229"/>
                    <a:pt x="1395" y="1229"/>
                  </a:cubicBezTo>
                  <a:lnTo>
                    <a:pt x="1378" y="1227"/>
                  </a:lnTo>
                  <a:lnTo>
                    <a:pt x="1229" y="1219"/>
                  </a:lnTo>
                  <a:lnTo>
                    <a:pt x="1200" y="1214"/>
                  </a:lnTo>
                  <a:lnTo>
                    <a:pt x="1059" y="1177"/>
                  </a:lnTo>
                  <a:lnTo>
                    <a:pt x="1028" y="1164"/>
                  </a:lnTo>
                  <a:cubicBezTo>
                    <a:pt x="1026" y="1163"/>
                    <a:pt x="1024" y="1162"/>
                    <a:pt x="1023" y="1161"/>
                  </a:cubicBezTo>
                  <a:lnTo>
                    <a:pt x="765" y="1006"/>
                  </a:lnTo>
                  <a:lnTo>
                    <a:pt x="750" y="997"/>
                  </a:lnTo>
                  <a:cubicBezTo>
                    <a:pt x="748" y="996"/>
                    <a:pt x="746" y="995"/>
                    <a:pt x="744" y="993"/>
                  </a:cubicBezTo>
                  <a:lnTo>
                    <a:pt x="490" y="766"/>
                  </a:lnTo>
                  <a:lnTo>
                    <a:pt x="243" y="497"/>
                  </a:lnTo>
                  <a:lnTo>
                    <a:pt x="10" y="217"/>
                  </a:lnTo>
                  <a:cubicBezTo>
                    <a:pt x="3" y="209"/>
                    <a:pt x="0" y="198"/>
                    <a:pt x="0" y="188"/>
                  </a:cubicBezTo>
                  <a:cubicBezTo>
                    <a:pt x="1" y="178"/>
                    <a:pt x="5" y="168"/>
                    <a:pt x="13" y="161"/>
                  </a:cubicBezTo>
                  <a:lnTo>
                    <a:pt x="177" y="14"/>
                  </a:lnTo>
                  <a:close/>
                  <a:moveTo>
                    <a:pt x="62" y="222"/>
                  </a:moveTo>
                  <a:lnTo>
                    <a:pt x="65" y="166"/>
                  </a:lnTo>
                  <a:lnTo>
                    <a:pt x="296" y="444"/>
                  </a:lnTo>
                  <a:lnTo>
                    <a:pt x="537" y="707"/>
                  </a:lnTo>
                  <a:lnTo>
                    <a:pt x="791" y="934"/>
                  </a:lnTo>
                  <a:lnTo>
                    <a:pt x="785" y="929"/>
                  </a:lnTo>
                  <a:lnTo>
                    <a:pt x="800" y="938"/>
                  </a:lnTo>
                  <a:lnTo>
                    <a:pt x="1058" y="1093"/>
                  </a:lnTo>
                  <a:lnTo>
                    <a:pt x="1053" y="1091"/>
                  </a:lnTo>
                  <a:lnTo>
                    <a:pt x="1076" y="1100"/>
                  </a:lnTo>
                  <a:lnTo>
                    <a:pt x="1209" y="1137"/>
                  </a:lnTo>
                  <a:lnTo>
                    <a:pt x="1230" y="1140"/>
                  </a:lnTo>
                  <a:lnTo>
                    <a:pt x="1385" y="1148"/>
                  </a:lnTo>
                  <a:lnTo>
                    <a:pt x="1402" y="1150"/>
                  </a:lnTo>
                  <a:lnTo>
                    <a:pt x="1393" y="1150"/>
                  </a:lnTo>
                  <a:lnTo>
                    <a:pt x="1701" y="1115"/>
                  </a:lnTo>
                  <a:lnTo>
                    <a:pt x="1859" y="1088"/>
                  </a:lnTo>
                  <a:lnTo>
                    <a:pt x="1994" y="1071"/>
                  </a:lnTo>
                  <a:lnTo>
                    <a:pt x="2003" y="1150"/>
                  </a:lnTo>
                  <a:lnTo>
                    <a:pt x="1989" y="1151"/>
                  </a:lnTo>
                  <a:lnTo>
                    <a:pt x="1986" y="1072"/>
                  </a:lnTo>
                  <a:lnTo>
                    <a:pt x="2111" y="1078"/>
                  </a:lnTo>
                  <a:lnTo>
                    <a:pt x="2108" y="1157"/>
                  </a:lnTo>
                  <a:lnTo>
                    <a:pt x="2078" y="1154"/>
                  </a:lnTo>
                  <a:lnTo>
                    <a:pt x="2091" y="1077"/>
                  </a:lnTo>
                  <a:lnTo>
                    <a:pt x="2196" y="1113"/>
                  </a:lnTo>
                  <a:lnTo>
                    <a:pt x="2168" y="1185"/>
                  </a:lnTo>
                  <a:lnTo>
                    <a:pt x="2130" y="1163"/>
                  </a:lnTo>
                  <a:lnTo>
                    <a:pt x="2171" y="1098"/>
                  </a:lnTo>
                  <a:lnTo>
                    <a:pt x="2255" y="1171"/>
                  </a:lnTo>
                  <a:lnTo>
                    <a:pt x="2205" y="1228"/>
                  </a:lnTo>
                  <a:lnTo>
                    <a:pt x="2183" y="1204"/>
                  </a:lnTo>
                  <a:lnTo>
                    <a:pt x="2240" y="1155"/>
                  </a:lnTo>
                  <a:lnTo>
                    <a:pt x="2309" y="1257"/>
                  </a:lnTo>
                  <a:lnTo>
                    <a:pt x="2246" y="1297"/>
                  </a:lnTo>
                  <a:lnTo>
                    <a:pt x="2237" y="1279"/>
                  </a:lnTo>
                  <a:lnTo>
                    <a:pt x="2303" y="1245"/>
                  </a:lnTo>
                  <a:lnTo>
                    <a:pt x="2361" y="1372"/>
                  </a:lnTo>
                  <a:lnTo>
                    <a:pt x="2402" y="1495"/>
                  </a:lnTo>
                  <a:lnTo>
                    <a:pt x="2459" y="1734"/>
                  </a:lnTo>
                  <a:lnTo>
                    <a:pt x="2482" y="1831"/>
                  </a:lnTo>
                  <a:lnTo>
                    <a:pt x="2505" y="1903"/>
                  </a:lnTo>
                  <a:lnTo>
                    <a:pt x="2529" y="1974"/>
                  </a:lnTo>
                  <a:lnTo>
                    <a:pt x="2459" y="1970"/>
                  </a:lnTo>
                  <a:lnTo>
                    <a:pt x="2519" y="1825"/>
                  </a:lnTo>
                  <a:lnTo>
                    <a:pt x="2568" y="1878"/>
                  </a:lnTo>
                  <a:lnTo>
                    <a:pt x="2561" y="1881"/>
                  </a:lnTo>
                  <a:lnTo>
                    <a:pt x="2558" y="1808"/>
                  </a:lnTo>
                  <a:lnTo>
                    <a:pt x="2696" y="1861"/>
                  </a:lnTo>
                  <a:lnTo>
                    <a:pt x="2652" y="1916"/>
                  </a:lnTo>
                  <a:lnTo>
                    <a:pt x="2630" y="1876"/>
                  </a:lnTo>
                  <a:lnTo>
                    <a:pt x="2599" y="1818"/>
                  </a:lnTo>
                  <a:lnTo>
                    <a:pt x="2649" y="1835"/>
                  </a:lnTo>
                  <a:lnTo>
                    <a:pt x="2456" y="1937"/>
                  </a:lnTo>
                  <a:lnTo>
                    <a:pt x="2472" y="1885"/>
                  </a:lnTo>
                  <a:lnTo>
                    <a:pt x="2502" y="1950"/>
                  </a:lnTo>
                  <a:lnTo>
                    <a:pt x="2525" y="1990"/>
                  </a:lnTo>
                  <a:lnTo>
                    <a:pt x="2521" y="1984"/>
                  </a:lnTo>
                  <a:lnTo>
                    <a:pt x="2548" y="2017"/>
                  </a:lnTo>
                  <a:lnTo>
                    <a:pt x="2538" y="2008"/>
                  </a:lnTo>
                  <a:lnTo>
                    <a:pt x="2573" y="2029"/>
                  </a:lnTo>
                  <a:lnTo>
                    <a:pt x="2560" y="2025"/>
                  </a:lnTo>
                  <a:lnTo>
                    <a:pt x="2598" y="2031"/>
                  </a:lnTo>
                  <a:lnTo>
                    <a:pt x="2585" y="2031"/>
                  </a:lnTo>
                  <a:lnTo>
                    <a:pt x="2621" y="2024"/>
                  </a:lnTo>
                  <a:lnTo>
                    <a:pt x="2628" y="2022"/>
                  </a:lnTo>
                  <a:lnTo>
                    <a:pt x="2618" y="2026"/>
                  </a:lnTo>
                  <a:lnTo>
                    <a:pt x="2653" y="2003"/>
                  </a:lnTo>
                  <a:lnTo>
                    <a:pt x="2642" y="2014"/>
                  </a:lnTo>
                  <a:lnTo>
                    <a:pt x="2665" y="1978"/>
                  </a:lnTo>
                  <a:lnTo>
                    <a:pt x="2660" y="1991"/>
                  </a:lnTo>
                  <a:lnTo>
                    <a:pt x="2669" y="1949"/>
                  </a:lnTo>
                  <a:lnTo>
                    <a:pt x="2669" y="1964"/>
                  </a:lnTo>
                  <a:lnTo>
                    <a:pt x="2662" y="1920"/>
                  </a:lnTo>
                  <a:lnTo>
                    <a:pt x="2663" y="1927"/>
                  </a:lnTo>
                  <a:lnTo>
                    <a:pt x="2643" y="1867"/>
                  </a:lnTo>
                  <a:lnTo>
                    <a:pt x="2626" y="1800"/>
                  </a:lnTo>
                  <a:lnTo>
                    <a:pt x="2601" y="1700"/>
                  </a:lnTo>
                  <a:lnTo>
                    <a:pt x="2540" y="1440"/>
                  </a:lnTo>
                  <a:lnTo>
                    <a:pt x="2489" y="1303"/>
                  </a:lnTo>
                  <a:lnTo>
                    <a:pt x="2435" y="1182"/>
                  </a:lnTo>
                  <a:lnTo>
                    <a:pt x="2428" y="1168"/>
                  </a:lnTo>
                  <a:lnTo>
                    <a:pt x="2360" y="1066"/>
                  </a:lnTo>
                  <a:lnTo>
                    <a:pt x="2365" y="1073"/>
                  </a:lnTo>
                  <a:lnTo>
                    <a:pt x="2357" y="1065"/>
                  </a:lnTo>
                  <a:lnTo>
                    <a:pt x="2346" y="1055"/>
                  </a:lnTo>
                  <a:lnTo>
                    <a:pt x="2263" y="983"/>
                  </a:lnTo>
                  <a:lnTo>
                    <a:pt x="2244" y="967"/>
                  </a:lnTo>
                  <a:lnTo>
                    <a:pt x="2249" y="971"/>
                  </a:lnTo>
                  <a:lnTo>
                    <a:pt x="2230" y="960"/>
                  </a:lnTo>
                  <a:lnTo>
                    <a:pt x="2237" y="963"/>
                  </a:lnTo>
                  <a:lnTo>
                    <a:pt x="2132" y="927"/>
                  </a:lnTo>
                  <a:lnTo>
                    <a:pt x="2140" y="929"/>
                  </a:lnTo>
                  <a:lnTo>
                    <a:pt x="2112" y="926"/>
                  </a:lnTo>
                  <a:lnTo>
                    <a:pt x="1991" y="919"/>
                  </a:lnTo>
                  <a:lnTo>
                    <a:pt x="1979" y="920"/>
                  </a:lnTo>
                  <a:lnTo>
                    <a:pt x="1830" y="936"/>
                  </a:lnTo>
                  <a:lnTo>
                    <a:pt x="1684" y="960"/>
                  </a:lnTo>
                  <a:lnTo>
                    <a:pt x="1375" y="996"/>
                  </a:lnTo>
                  <a:lnTo>
                    <a:pt x="1366" y="917"/>
                  </a:lnTo>
                  <a:lnTo>
                    <a:pt x="1380" y="916"/>
                  </a:lnTo>
                  <a:lnTo>
                    <a:pt x="1383" y="995"/>
                  </a:lnTo>
                  <a:lnTo>
                    <a:pt x="1231" y="987"/>
                  </a:lnTo>
                  <a:lnTo>
                    <a:pt x="1236" y="909"/>
                  </a:lnTo>
                  <a:lnTo>
                    <a:pt x="1261" y="913"/>
                  </a:lnTo>
                  <a:lnTo>
                    <a:pt x="1248" y="990"/>
                  </a:lnTo>
                  <a:lnTo>
                    <a:pt x="1111" y="953"/>
                  </a:lnTo>
                  <a:lnTo>
                    <a:pt x="1133" y="878"/>
                  </a:lnTo>
                  <a:lnTo>
                    <a:pt x="1161" y="890"/>
                  </a:lnTo>
                  <a:lnTo>
                    <a:pt x="1130" y="961"/>
                  </a:lnTo>
                  <a:lnTo>
                    <a:pt x="872" y="807"/>
                  </a:lnTo>
                  <a:lnTo>
                    <a:pt x="914" y="743"/>
                  </a:lnTo>
                  <a:lnTo>
                    <a:pt x="927" y="755"/>
                  </a:lnTo>
                  <a:cubicBezTo>
                    <a:pt x="942" y="770"/>
                    <a:pt x="944" y="794"/>
                    <a:pt x="931" y="810"/>
                  </a:cubicBezTo>
                  <a:cubicBezTo>
                    <a:pt x="918" y="827"/>
                    <a:pt x="895" y="828"/>
                    <a:pt x="879" y="814"/>
                  </a:cubicBezTo>
                  <a:lnTo>
                    <a:pt x="642" y="606"/>
                  </a:lnTo>
                  <a:lnTo>
                    <a:pt x="407" y="349"/>
                  </a:lnTo>
                  <a:lnTo>
                    <a:pt x="174" y="70"/>
                  </a:lnTo>
                  <a:lnTo>
                    <a:pt x="226" y="75"/>
                  </a:lnTo>
                  <a:lnTo>
                    <a:pt x="62" y="222"/>
                  </a:lnTo>
                  <a:close/>
                </a:path>
              </a:pathLst>
            </a:custGeom>
            <a:solidFill>
              <a:srgbClr val="4F6228"/>
            </a:solidFill>
            <a:ln w="0" cap="flat">
              <a:solidFill>
                <a:srgbClr val="4F6228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" name="Rectangle 233">
              <a:extLst>
                <a:ext uri="{FF2B5EF4-FFF2-40B4-BE49-F238E27FC236}">
                  <a16:creationId xmlns:a16="http://schemas.microsoft.com/office/drawing/2014/main" id="{20D19303-F781-4A2F-9D38-5E88EF9E96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9" y="2320"/>
              <a:ext cx="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K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Rectangle 234">
              <a:extLst>
                <a:ext uri="{FF2B5EF4-FFF2-40B4-BE49-F238E27FC236}">
                  <a16:creationId xmlns:a16="http://schemas.microsoft.com/office/drawing/2014/main" id="{19671843-5D13-48FE-A54D-F33622CEE1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" y="1830"/>
              <a:ext cx="2156" cy="1495"/>
            </a:xfrm>
            <a:prstGeom prst="rect">
              <a:avLst/>
            </a:prstGeom>
            <a:noFill/>
            <a:ln w="6350" cap="flat">
              <a:solidFill>
                <a:srgbClr val="A6A6A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" name="Rectangle 235">
              <a:extLst>
                <a:ext uri="{FF2B5EF4-FFF2-40B4-BE49-F238E27FC236}">
                  <a16:creationId xmlns:a16="http://schemas.microsoft.com/office/drawing/2014/main" id="{C3642F39-E019-4FAE-91D0-FD5A9D76B7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27" y="4755"/>
              <a:ext cx="878" cy="1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atabase searc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pic>
          <p:nvPicPr>
            <p:cNvPr id="98" name="Picture 236">
              <a:extLst>
                <a:ext uri="{FF2B5EF4-FFF2-40B4-BE49-F238E27FC236}">
                  <a16:creationId xmlns:a16="http://schemas.microsoft.com/office/drawing/2014/main" id="{71BEFAD4-825C-4FEA-8C36-7A819C2B72D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88" y="3758"/>
              <a:ext cx="894" cy="3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9" name="Picture 237">
              <a:extLst>
                <a:ext uri="{FF2B5EF4-FFF2-40B4-BE49-F238E27FC236}">
                  <a16:creationId xmlns:a16="http://schemas.microsoft.com/office/drawing/2014/main" id="{90FB9676-A7F6-4F3F-B9C7-A69E24FA84C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93" y="4114"/>
              <a:ext cx="928" cy="6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0" name="Rectangle 238">
              <a:extLst>
                <a:ext uri="{FF2B5EF4-FFF2-40B4-BE49-F238E27FC236}">
                  <a16:creationId xmlns:a16="http://schemas.microsoft.com/office/drawing/2014/main" id="{89245B36-BF8B-44A8-992F-FB401BA23F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94" y="3611"/>
              <a:ext cx="1120" cy="1326"/>
            </a:xfrm>
            <a:prstGeom prst="rect">
              <a:avLst/>
            </a:prstGeom>
            <a:noFill/>
            <a:ln w="6350" cap="flat">
              <a:solidFill>
                <a:srgbClr val="A6A6A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" name="Rectangle 239">
              <a:extLst>
                <a:ext uri="{FF2B5EF4-FFF2-40B4-BE49-F238E27FC236}">
                  <a16:creationId xmlns:a16="http://schemas.microsoft.com/office/drawing/2014/main" id="{A4166BD1-C2AC-4FFF-9F48-FC5A1785AC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" y="3616"/>
              <a:ext cx="3584" cy="1327"/>
            </a:xfrm>
            <a:prstGeom prst="rect">
              <a:avLst/>
            </a:prstGeom>
            <a:noFill/>
            <a:ln w="6350" cap="flat">
              <a:solidFill>
                <a:srgbClr val="A6A6A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240" name="Rectangle 239">
            <a:extLst>
              <a:ext uri="{FF2B5EF4-FFF2-40B4-BE49-F238E27FC236}">
                <a16:creationId xmlns:a16="http://schemas.microsoft.com/office/drawing/2014/main" id="{80CDF6B9-D33A-4166-BBAA-953E38342643}"/>
              </a:ext>
            </a:extLst>
          </p:cNvPr>
          <p:cNvSpPr/>
          <p:nvPr/>
        </p:nvSpPr>
        <p:spPr>
          <a:xfrm>
            <a:off x="117475" y="5778556"/>
            <a:ext cx="8909050" cy="8585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S2.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agrammatic representation of the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KiC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ssay employed for CSS kinases clients identification.. Each pool was phosphorylated </a:t>
            </a:r>
            <a:r>
              <a:rPr lang="en-US" sz="1100" i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vitro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y individual CSS kinases and subsequently analyzed by an LTQ Orbitrap XL ETD mass spectrometer (Thermo Fisher, CA). For identification and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osphosite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ocalization, MS raw files were searched against a custom made decoy database consisting of random complement of sequences comprising the peptide library, using SEQUEST (Proteome Discoverer, v. 1.0.3, Thermo Fisher).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US" sz="11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46494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9755B865-BB7A-49A4-9014-79CBAC28A510}"/>
              </a:ext>
            </a:extLst>
          </p:cNvPr>
          <p:cNvSpPr txBox="1"/>
          <p:nvPr/>
        </p:nvSpPr>
        <p:spPr>
          <a:xfrm>
            <a:off x="7081982" y="76200"/>
            <a:ext cx="2057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Supplemental Figure S3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A8CCA134-C174-461A-BBCE-9B99DF7D610E}"/>
              </a:ext>
            </a:extLst>
          </p:cNvPr>
          <p:cNvSpPr/>
          <p:nvPr/>
        </p:nvSpPr>
        <p:spPr>
          <a:xfrm>
            <a:off x="266700" y="5851997"/>
            <a:ext cx="8610600" cy="4691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S3.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Kinase client relationship between PPCKs and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nRKs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Venn diagram analysis showed the unique and overlapped clients between PPCKs (A) and among the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nRKs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B). </a:t>
            </a:r>
            <a:endParaRPr lang="en-US" sz="11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506BC05B-A3BB-4E84-4553-4EE3A45E78BA}"/>
              </a:ext>
            </a:extLst>
          </p:cNvPr>
          <p:cNvGrpSpPr/>
          <p:nvPr/>
        </p:nvGrpSpPr>
        <p:grpSpPr>
          <a:xfrm>
            <a:off x="1411671" y="800847"/>
            <a:ext cx="3033059" cy="4553128"/>
            <a:chOff x="838200" y="1371600"/>
            <a:chExt cx="3033059" cy="4553128"/>
          </a:xfrm>
        </p:grpSpPr>
        <p:pic>
          <p:nvPicPr>
            <p:cNvPr id="28" name="Picture 2">
              <a:extLst>
                <a:ext uri="{FF2B5EF4-FFF2-40B4-BE49-F238E27FC236}">
                  <a16:creationId xmlns:a16="http://schemas.microsoft.com/office/drawing/2014/main" id="{28589C5B-4E34-1B54-AF5B-F1CC83673E7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111" t="17778" r="11111" b="25555"/>
            <a:stretch/>
          </p:blipFill>
          <p:spPr bwMode="auto">
            <a:xfrm>
              <a:off x="838200" y="1371600"/>
              <a:ext cx="3033059" cy="22098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6753338-E75E-F7E1-1787-B51680162EB4}"/>
                </a:ext>
              </a:extLst>
            </p:cNvPr>
            <p:cNvSpPr txBox="1"/>
            <p:nvPr/>
          </p:nvSpPr>
          <p:spPr>
            <a:xfrm>
              <a:off x="1935113" y="3708737"/>
              <a:ext cx="749643" cy="1015663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square">
              <a:spAutoFit/>
            </a:bodyPr>
            <a:lstStyle/>
            <a:p>
              <a:r>
                <a:rPr lang="nn-NO" sz="1000" dirty="0">
                  <a:latin typeface="Arial" panose="020B0604020202020204" pitchFamily="34" charset="0"/>
                  <a:cs typeface="Arial" panose="020B0604020202020204" pitchFamily="34" charset="0"/>
                </a:rPr>
                <a:t>2g21150</a:t>
              </a:r>
            </a:p>
            <a:p>
              <a:r>
                <a:rPr lang="nn-NO" sz="1000" dirty="0">
                  <a:latin typeface="Arial" panose="020B0604020202020204" pitchFamily="34" charset="0"/>
                  <a:cs typeface="Arial" panose="020B0604020202020204" pitchFamily="34" charset="0"/>
                </a:rPr>
                <a:t>3g53230</a:t>
              </a:r>
            </a:p>
            <a:p>
              <a:r>
                <a:rPr lang="nn-NO" sz="1000" dirty="0">
                  <a:latin typeface="Arial" panose="020B0604020202020204" pitchFamily="34" charset="0"/>
                  <a:cs typeface="Arial" panose="020B0604020202020204" pitchFamily="34" charset="0"/>
                </a:rPr>
                <a:t>3g19510</a:t>
              </a:r>
            </a:p>
            <a:p>
              <a:r>
                <a:rPr lang="nn-NO" sz="1000" dirty="0">
                  <a:latin typeface="Arial" panose="020B0604020202020204" pitchFamily="34" charset="0"/>
                  <a:cs typeface="Arial" panose="020B0604020202020204" pitchFamily="34" charset="0"/>
                </a:rPr>
                <a:t>5g45930</a:t>
              </a:r>
            </a:p>
            <a:p>
              <a:r>
                <a:rPr lang="nn-NO" sz="1000" dirty="0">
                  <a:latin typeface="Arial" panose="020B0604020202020204" pitchFamily="34" charset="0"/>
                  <a:cs typeface="Arial" panose="020B0604020202020204" pitchFamily="34" charset="0"/>
                </a:rPr>
                <a:t>2g38410</a:t>
              </a:r>
            </a:p>
            <a:p>
              <a:r>
                <a:rPr lang="nn-NO" sz="1000" dirty="0">
                  <a:latin typeface="Arial" panose="020B0604020202020204" pitchFamily="34" charset="0"/>
                  <a:cs typeface="Arial" panose="020B0604020202020204" pitchFamily="34" charset="0"/>
                </a:rPr>
                <a:t>1g15400</a:t>
              </a:r>
            </a:p>
          </p:txBody>
        </p: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4CF2DC9E-6E69-0099-6BE4-630EF266C781}"/>
                </a:ext>
              </a:extLst>
            </p:cNvPr>
            <p:cNvCxnSpPr>
              <a:cxnSpLocks/>
            </p:cNvCxnSpPr>
            <p:nvPr/>
          </p:nvCxnSpPr>
          <p:spPr>
            <a:xfrm>
              <a:off x="2362200" y="2743200"/>
              <a:ext cx="1" cy="9144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B526F88-A1F6-A23E-542A-1B03462E69BF}"/>
                </a:ext>
              </a:extLst>
            </p:cNvPr>
            <p:cNvSpPr txBox="1"/>
            <p:nvPr/>
          </p:nvSpPr>
          <p:spPr>
            <a:xfrm>
              <a:off x="1143000" y="3522956"/>
              <a:ext cx="749643" cy="1938992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g0805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g3828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g26935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g0154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g0763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g1850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g1863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g1600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g0482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g1098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g0509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g2440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4B181C8-03E2-D183-54CA-0F3707B3534D}"/>
                </a:ext>
              </a:extLst>
            </p:cNvPr>
            <p:cNvSpPr txBox="1"/>
            <p:nvPr/>
          </p:nvSpPr>
          <p:spPr>
            <a:xfrm>
              <a:off x="2729550" y="3524071"/>
              <a:ext cx="749643" cy="2400657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g7599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g5965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g1947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g3016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g3424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g5303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g3575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g19485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g64813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g0308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g6747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g5240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g6270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g5060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g38640</a:t>
              </a:r>
            </a:p>
          </p:txBody>
        </p: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56E730D4-007A-9B9C-9A82-E85A90E9D485}"/>
              </a:ext>
            </a:extLst>
          </p:cNvPr>
          <p:cNvGrpSpPr/>
          <p:nvPr/>
        </p:nvGrpSpPr>
        <p:grpSpPr>
          <a:xfrm>
            <a:off x="4708166" y="800847"/>
            <a:ext cx="3572569" cy="3927701"/>
            <a:chOff x="4708166" y="1306572"/>
            <a:chExt cx="3572569" cy="3927701"/>
          </a:xfrm>
        </p:grpSpPr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12DA888A-1C6B-C064-017C-B7363A93A3A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445" t="7777" r="4445" b="16667"/>
            <a:stretch/>
          </p:blipFill>
          <p:spPr>
            <a:xfrm>
              <a:off x="4708166" y="1306572"/>
              <a:ext cx="3140434" cy="2604262"/>
            </a:xfrm>
            <a:prstGeom prst="rect">
              <a:avLst/>
            </a:prstGeom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4759BDAA-4B7B-092C-4910-8B6171A36117}"/>
                </a:ext>
              </a:extLst>
            </p:cNvPr>
            <p:cNvSpPr txBox="1"/>
            <p:nvPr/>
          </p:nvSpPr>
          <p:spPr>
            <a:xfrm>
              <a:off x="5410200" y="3910834"/>
              <a:ext cx="749643" cy="1323439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g3159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g2968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g59453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g1951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g6595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g1863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g4767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g38410</a:t>
              </a:r>
            </a:p>
          </p:txBody>
        </p: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3E828C32-DEC5-6C4B-A8F6-5BE90D733A0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13034" y="2268244"/>
              <a:ext cx="715782" cy="162483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CAD16A45-935C-EB94-2F6D-5D3C00F8D64C}"/>
                </a:ext>
              </a:extLst>
            </p:cNvPr>
            <p:cNvSpPr txBox="1"/>
            <p:nvPr/>
          </p:nvSpPr>
          <p:spPr>
            <a:xfrm>
              <a:off x="6254578" y="3982490"/>
              <a:ext cx="749643" cy="553998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g2939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g7216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g45930</a:t>
              </a:r>
            </a:p>
          </p:txBody>
        </p: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2FA94706-4976-37E5-662A-F4E6D0B31D98}"/>
                </a:ext>
              </a:extLst>
            </p:cNvPr>
            <p:cNvCxnSpPr>
              <a:cxnSpLocks/>
            </p:cNvCxnSpPr>
            <p:nvPr/>
          </p:nvCxnSpPr>
          <p:spPr>
            <a:xfrm>
              <a:off x="6705600" y="2762105"/>
              <a:ext cx="0" cy="120029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F833744B-4390-6C69-BFC4-E361ECA4CAFB}"/>
                </a:ext>
              </a:extLst>
            </p:cNvPr>
            <p:cNvSpPr txBox="1"/>
            <p:nvPr/>
          </p:nvSpPr>
          <p:spPr>
            <a:xfrm>
              <a:off x="7531092" y="3103602"/>
              <a:ext cx="749643" cy="553998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g4516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g1057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g75990</a:t>
              </a:r>
            </a:p>
          </p:txBody>
        </p: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9813E249-830D-D71D-5198-91A6C92F8EF1}"/>
                </a:ext>
              </a:extLst>
            </p:cNvPr>
            <p:cNvCxnSpPr>
              <a:cxnSpLocks/>
            </p:cNvCxnSpPr>
            <p:nvPr/>
          </p:nvCxnSpPr>
          <p:spPr>
            <a:xfrm>
              <a:off x="7004221" y="3200400"/>
              <a:ext cx="526871" cy="16185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819C7B6-12F9-F028-C95B-1B3BC8745528}"/>
                </a:ext>
              </a:extLst>
            </p:cNvPr>
            <p:cNvSpPr txBox="1"/>
            <p:nvPr/>
          </p:nvSpPr>
          <p:spPr>
            <a:xfrm>
              <a:off x="7508288" y="1306572"/>
              <a:ext cx="749643" cy="553998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g4516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g10570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g75990</a:t>
              </a:r>
            </a:p>
          </p:txBody>
        </p:sp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EE88E8F6-CD4F-EDB3-99F9-56CFE4B9F9E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122401" y="1685278"/>
              <a:ext cx="385887" cy="50243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A1FA5050-ADEA-440F-C889-D47B013E8EBC}"/>
              </a:ext>
            </a:extLst>
          </p:cNvPr>
          <p:cNvSpPr txBox="1"/>
          <p:nvPr/>
        </p:nvSpPr>
        <p:spPr>
          <a:xfrm>
            <a:off x="1219200" y="637275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E5D2D74-DD1E-5D7F-6505-978213BD5B61}"/>
              </a:ext>
            </a:extLst>
          </p:cNvPr>
          <p:cNvSpPr txBox="1"/>
          <p:nvPr/>
        </p:nvSpPr>
        <p:spPr>
          <a:xfrm>
            <a:off x="4516374" y="637275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632489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1</TotalTime>
  <Words>392</Words>
  <Application>Microsoft Office PowerPoint</Application>
  <PresentationFormat>On-screen Show (4:3)</PresentationFormat>
  <Paragraphs>15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ourier New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ab Meeting  March 19, 2014</dc:title>
  <dc:creator>Ahsan, Nagib</dc:creator>
  <cp:lastModifiedBy>Ahsan, Nagib</cp:lastModifiedBy>
  <cp:revision>56</cp:revision>
  <dcterms:created xsi:type="dcterms:W3CDTF">2014-03-18T21:25:38Z</dcterms:created>
  <dcterms:modified xsi:type="dcterms:W3CDTF">2024-05-08T17:12:16Z</dcterms:modified>
</cp:coreProperties>
</file>